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officedocument.obfuscatedFont" Extension="odttf"/>
  <Default ContentType="application/vnd.openxmlformats-package.relationships+xml" Extension="rels"/>
  <Override ContentType="application/vnd.openxmlformats-officedocument.presentationml.notesSlide+xml" PartName="/ppt/notesSlides/notesSlide37.xml"/>
  <Override ContentType="application/vnd.openxmlformats-officedocument.presentationml.notesSlide+xml" PartName="/ppt/notesSlides/notesSlide29.xml"/>
  <Override ContentType="application/vnd.openxmlformats-officedocument.presentationml.notesSlide+xml" PartName="/ppt/notesSlides/notesSlide32.xml"/>
  <Override ContentType="application/vnd.openxmlformats-officedocument.presentationml.notesSlide+xml" PartName="/ppt/notesSlides/notesSlide45.xml"/>
  <Override ContentType="application/vnd.openxmlformats-officedocument.presentationml.notesSlide+xml" PartName="/ppt/notesSlides/notesSlide3.xml"/>
  <Override ContentType="application/vnd.openxmlformats-officedocument.presentationml.notesSlide+xml" PartName="/ppt/notesSlides/notesSlide46.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33.xml"/>
  <Override ContentType="application/vnd.openxmlformats-officedocument.presentationml.notesSlide+xml" PartName="/ppt/notesSlides/notesSlide41.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47.xml"/>
  <Override ContentType="application/vnd.openxmlformats-officedocument.presentationml.notesSlide+xml" PartName="/ppt/notesSlides/notesSlide17.xml"/>
  <Override ContentType="application/vnd.openxmlformats-officedocument.presentationml.notesSlide+xml" PartName="/ppt/notesSlides/notesSlide42.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34.xml"/>
  <Override ContentType="application/vnd.openxmlformats-officedocument.presentationml.notesSlide+xml" PartName="/ppt/notesSlides/notesSlide3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43.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48.xml"/>
  <Override ContentType="application/vnd.openxmlformats-officedocument.presentationml.notesSlide+xml" PartName="/ppt/notesSlides/notesSlide30.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35.xml"/>
  <Override ContentType="application/vnd.openxmlformats-officedocument.presentationml.notesSlide+xml" PartName="/ppt/notesSlides/notesSlide5.xml"/>
  <Override ContentType="application/vnd.openxmlformats-officedocument.presentationml.notesSlide+xml" PartName="/ppt/notesSlides/notesSlide39.xml"/>
  <Override ContentType="application/vnd.openxmlformats-officedocument.presentationml.notesSlide+xml" PartName="/ppt/notesSlides/notesSlide31.xml"/>
  <Override ContentType="application/vnd.openxmlformats-officedocument.presentationml.notesSlide+xml" PartName="/ppt/notesSlides/notesSlide36.xml"/>
  <Override ContentType="application/vnd.openxmlformats-officedocument.presentationml.notesSlide+xml" PartName="/ppt/notesSlides/notesSlide19.xml"/>
  <Override ContentType="application/vnd.openxmlformats-officedocument.presentationml.notesSlide+xml" PartName="/ppt/notesSlides/notesSlide44.xml"/>
  <Override ContentType="application/vnd.openxmlformats-officedocument.presentationml.notesSlide+xml" PartName="/ppt/notesSlides/notesSlide27.xml"/>
  <Override ContentType="application/vnd.openxmlformats-officedocument.presentationml.notesSlide+xml" PartName="/ppt/notesSlides/notesSlide40.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48.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43.xml"/>
  <Override ContentType="application/vnd.openxmlformats-officedocument.presentationml.slide+xml" PartName="/ppt/slides/slide30.xml"/>
  <Override ContentType="application/vnd.openxmlformats-officedocument.presentationml.slide+xml" PartName="/ppt/slides/slide22.xml"/>
  <Override ContentType="application/vnd.openxmlformats-officedocument.presentationml.slide+xml" PartName="/ppt/slides/slide35.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42.xml"/>
  <Override ContentType="application/vnd.openxmlformats-officedocument.presentationml.slide+xml" PartName="/ppt/slides/slide25.xml"/>
  <Override ContentType="application/vnd.openxmlformats-officedocument.presentationml.slide+xml" PartName="/ppt/slides/slide47.xml"/>
  <Override ContentType="application/vnd.openxmlformats-officedocument.presentationml.slide+xml" PartName="/ppt/slides/slide34.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33.xml"/>
  <Override ContentType="application/vnd.openxmlformats-officedocument.presentationml.slide+xml" PartName="/ppt/slides/slide38.xml"/>
  <Override ContentType="application/vnd.openxmlformats-officedocument.presentationml.slide+xml" PartName="/ppt/slides/slide46.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32.xml"/>
  <Override ContentType="application/vnd.openxmlformats-officedocument.presentationml.slide+xml" PartName="/ppt/slides/slide37.xml"/>
  <Override ContentType="application/vnd.openxmlformats-officedocument.presentationml.slide+xml" PartName="/ppt/slides/slide1.xml"/>
  <Override ContentType="application/vnd.openxmlformats-officedocument.presentationml.slide+xml" PartName="/ppt/slides/slide45.xml"/>
  <Override ContentType="application/vnd.openxmlformats-officedocument.presentationml.slide+xml" PartName="/ppt/slides/slide28.xml"/>
  <Override ContentType="application/vnd.openxmlformats-officedocument.presentationml.slide+xml" PartName="/ppt/slides/slide41.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36.xml"/>
  <Override ContentType="application/vnd.openxmlformats-officedocument.presentationml.slide+xml" PartName="/ppt/slides/slide31.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44.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slide+xml" PartName="/ppt/slides/slide40.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4"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 id="281" r:id="rId32"/>
    <p:sldId id="282" r:id="rId33"/>
    <p:sldId id="283" r:id="rId34"/>
    <p:sldId id="284" r:id="rId35"/>
    <p:sldId id="285" r:id="rId36"/>
    <p:sldId id="286" r:id="rId37"/>
    <p:sldId id="287" r:id="rId38"/>
    <p:sldId id="288" r:id="rId39"/>
    <p:sldId id="289" r:id="rId40"/>
    <p:sldId id="290" r:id="rId41"/>
    <p:sldId id="291" r:id="rId42"/>
    <p:sldId id="292" r:id="rId43"/>
    <p:sldId id="293" r:id="rId44"/>
    <p:sldId id="294" r:id="rId45"/>
    <p:sldId id="295" r:id="rId46"/>
    <p:sldId id="296" r:id="rId47"/>
    <p:sldId id="297" r:id="rId48"/>
    <p:sldId id="298" r:id="rId49"/>
    <p:sldId id="299" r:id="rId50"/>
    <p:sldId id="300" r:id="rId51"/>
    <p:sldId id="301" r:id="rId52"/>
    <p:sldId id="302" r:id="rId53"/>
    <p:sldId id="303" r:id="rId54"/>
  </p:sldIdLst>
  <p:sldSz cy="5143500" cx="9144000"/>
  <p:notesSz cx="6858000" cy="9144000"/>
  <p:embeddedFontLst>
    <p:embeddedFont>
      <p:font typeface="Yusei Magic"/>
      <p:regular r:id="rId55"/>
    </p:embeddedFont>
    <p:embeddedFont>
      <p:font typeface="Hind"/>
      <p:regular r:id="rId56"/>
      <p:bold r:id="rId57"/>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747775"/>
          </p15:clr>
        </p15:guide>
        <p15:guide id="2" pos="3129">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F59E6EC8-69AF-4ADF-80BC-D3E07FA3DD24}">
  <a:tblStyle styleId="{F59E6EC8-69AF-4ADF-80BC-D3E07FA3DD24}" styleName="Table_0">
    <a:wholeTbl>
      <a:tcTxStyle>
        <a:font>
          <a:latin typeface="Arial"/>
          <a:ea typeface="Arial"/>
          <a:cs typeface="Arial"/>
        </a:font>
        <a:srgbClr val="000000"/>
      </a:tcTx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3129"/>
      </p:guideLst>
    </p:cSldViewPr>
  </p:slideViewPr>
</p:viewPr>
</file>

<file path=ppt/_rels/presentation.xml.rels><?xml version="1.0" encoding="UTF-8" standalone="yes"?><Relationships xmlns="http://schemas.openxmlformats.org/package/2006/relationships"><Relationship Id="rId40" Type="http://schemas.openxmlformats.org/officeDocument/2006/relationships/slide" Target="slides/slide34.xml"/><Relationship Id="rId42" Type="http://schemas.openxmlformats.org/officeDocument/2006/relationships/slide" Target="slides/slide36.xml"/><Relationship Id="rId41" Type="http://schemas.openxmlformats.org/officeDocument/2006/relationships/slide" Target="slides/slide35.xml"/><Relationship Id="rId44" Type="http://schemas.openxmlformats.org/officeDocument/2006/relationships/slide" Target="slides/slide38.xml"/><Relationship Id="rId43" Type="http://schemas.openxmlformats.org/officeDocument/2006/relationships/slide" Target="slides/slide37.xml"/><Relationship Id="rId46" Type="http://schemas.openxmlformats.org/officeDocument/2006/relationships/slide" Target="slides/slide40.xml"/><Relationship Id="rId45" Type="http://schemas.openxmlformats.org/officeDocument/2006/relationships/slide" Target="slides/slide39.xml"/><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48" Type="http://schemas.openxmlformats.org/officeDocument/2006/relationships/slide" Target="slides/slide42.xml"/><Relationship Id="rId47" Type="http://schemas.openxmlformats.org/officeDocument/2006/relationships/slide" Target="slides/slide41.xml"/><Relationship Id="rId49" Type="http://schemas.openxmlformats.org/officeDocument/2006/relationships/slide" Target="slides/slide43.xml"/><Relationship Id="rId5" Type="http://schemas.openxmlformats.org/officeDocument/2006/relationships/slideMaster" Target="slideMasters/slideMaster1.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33" Type="http://schemas.openxmlformats.org/officeDocument/2006/relationships/slide" Target="slides/slide27.xml"/><Relationship Id="rId32" Type="http://schemas.openxmlformats.org/officeDocument/2006/relationships/slide" Target="slides/slide26.xml"/><Relationship Id="rId35" Type="http://schemas.openxmlformats.org/officeDocument/2006/relationships/slide" Target="slides/slide29.xml"/><Relationship Id="rId34" Type="http://schemas.openxmlformats.org/officeDocument/2006/relationships/slide" Target="slides/slide28.xml"/><Relationship Id="rId37" Type="http://schemas.openxmlformats.org/officeDocument/2006/relationships/slide" Target="slides/slide31.xml"/><Relationship Id="rId36" Type="http://schemas.openxmlformats.org/officeDocument/2006/relationships/slide" Target="slides/slide30.xml"/><Relationship Id="rId39" Type="http://schemas.openxmlformats.org/officeDocument/2006/relationships/slide" Target="slides/slide33.xml"/><Relationship Id="rId38" Type="http://schemas.openxmlformats.org/officeDocument/2006/relationships/slide" Target="slides/slide32.xml"/><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29" Type="http://schemas.openxmlformats.org/officeDocument/2006/relationships/slide" Target="slides/slide23.xml"/><Relationship Id="rId51" Type="http://schemas.openxmlformats.org/officeDocument/2006/relationships/slide" Target="slides/slide45.xml"/><Relationship Id="rId50" Type="http://schemas.openxmlformats.org/officeDocument/2006/relationships/slide" Target="slides/slide44.xml"/><Relationship Id="rId53" Type="http://schemas.openxmlformats.org/officeDocument/2006/relationships/slide" Target="slides/slide47.xml"/><Relationship Id="rId52" Type="http://schemas.openxmlformats.org/officeDocument/2006/relationships/slide" Target="slides/slide46.xml"/><Relationship Id="rId11" Type="http://schemas.openxmlformats.org/officeDocument/2006/relationships/slide" Target="slides/slide5.xml"/><Relationship Id="rId55" Type="http://schemas.openxmlformats.org/officeDocument/2006/relationships/font" Target="fonts/YuseiMagic-regular.fntdata"/><Relationship Id="rId10" Type="http://schemas.openxmlformats.org/officeDocument/2006/relationships/slide" Target="slides/slide4.xml"/><Relationship Id="rId54" Type="http://schemas.openxmlformats.org/officeDocument/2006/relationships/slide" Target="slides/slide48.xml"/><Relationship Id="rId13" Type="http://schemas.openxmlformats.org/officeDocument/2006/relationships/slide" Target="slides/slide7.xml"/><Relationship Id="rId57" Type="http://schemas.openxmlformats.org/officeDocument/2006/relationships/font" Target="fonts/Hind-bold.fntdata"/><Relationship Id="rId12" Type="http://schemas.openxmlformats.org/officeDocument/2006/relationships/slide" Target="slides/slide6.xml"/><Relationship Id="rId56" Type="http://schemas.openxmlformats.org/officeDocument/2006/relationships/font" Target="fonts/Hind-regular.fntdata"/><Relationship Id="rId15" Type="http://schemas.openxmlformats.org/officeDocument/2006/relationships/slide" Target="slides/slide9.xml"/><Relationship Id="rId14" Type="http://schemas.openxmlformats.org/officeDocument/2006/relationships/slide" Target="slides/slide8.xml"/><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doi.org/10.1371/journal.pone.0127760" TargetMode="Externa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legacy.npr.org/assets/news/2017/12/discriminationpollasianamericans.pdf" TargetMode="External"/><Relationship Id="rId3" Type="http://schemas.openxmlformats.org/officeDocument/2006/relationships/hyperlink" Target="https://aspe.hhs.gov/sites/default/files/private/pdf/265581/aspe-uninsured-trends-aapi-ib.pdf" TargetMode="Externa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hhs.gov/aanhpi-heritage-month/reading-list/index.html#neighborhood-built" TargetMode="External"/><Relationship Id="rId3" Type="http://schemas.openxmlformats.org/officeDocument/2006/relationships/hyperlink" Target="https://www.pewresearch.org/short-reads/2021/04/29/key-facts-about-asian-americans/" TargetMode="Externa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ensus.gov/library/stories/2022/05/aanhpi-population-diverse-geographically-dispersed.html" TargetMode="External"/><Relationship Id="rId3" Type="http://schemas.openxmlformats.org/officeDocument/2006/relationships/hyperlink" Target="https://www.nami.org/your-journey/identity-and-cultural-dimensions/asian-american-and-pacific-islander/#:~:text=AANHPI%20communities%20consist%20of%20approximately,Asian%20and%20Pacific%20Islander%20ancestries" TargetMode="Externa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apa.org/pi/oema/resources/ethnicity-health/asian-american/psychological-treatment" TargetMode="Externa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ncbi.nlm.nih.gov/pmc/articles/PMC5643212/" TargetMode="Externa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ncbi.nlm.nih.gov/pmc/articles/PMC5643212/" TargetMode="External"/></Relationships>
</file>

<file path=ppt/notesSlides/_rels/notesSlide3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ncbi.nlm.nih.gov/pmc/articles/PMC5643212/" TargetMode="Externa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ncbi.nlm.nih.gov/pmc/articles/PMC3705710/" TargetMode="External"/></Relationships>
</file>

<file path=ppt/notesSlides/_rels/notesSlide4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ncbi.nlm.nih.gov/pmc/articles/PMC3181649/#:~:text=The%20experience%20of%20schizophrenia%20in%20China&amp;text=Traditionally%2C%20family%20members%20in%20China,family%2C%20not%20of%20the%20individual" TargetMode="External"/><Relationship Id="rId3" Type="http://schemas.openxmlformats.org/officeDocument/2006/relationships/hyperlink" Target="https://pubmed.ncbi.nlm.nih.gov/10945083/" TargetMode="External"/><Relationship Id="rId4" Type="http://schemas.openxmlformats.org/officeDocument/2006/relationships/hyperlink" Target="https://www.ncbi.nlm.nih.gov/pmc/articles/PMC3181649/#:~:text=The%20experience%20of%20schizophrenia%20in%20China&amp;text=Traditionally%2C%20family%20members%20in%20China,family%2C%20not%20of%20the%20individual" TargetMode="External"/></Relationships>
</file>

<file path=ppt/notesSlides/_rels/notesSlide4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who.int/news-room/fact-sheets/detail/mental-health-strengthening-our-response" TargetMode="Externa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pubmed.ncbi.nlm.nih.gov/35320122/" TargetMode="Externa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ajph.aphapublications.org/doi/full/10.2105/AJPH.93.12.2093" TargetMode="Externa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7" name="Shape 217"/>
        <p:cNvGrpSpPr/>
        <p:nvPr/>
      </p:nvGrpSpPr>
      <p:grpSpPr>
        <a:xfrm>
          <a:off x="0" y="0"/>
          <a:ext cx="0" cy="0"/>
          <a:chOff x="0" y="0"/>
          <a:chExt cx="0" cy="0"/>
        </a:xfrm>
      </p:grpSpPr>
      <p:sp>
        <p:nvSpPr>
          <p:cNvPr id="218" name="Google Shape;218;p:notes"/>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p:spPr>
      </p:sp>
      <p:sp>
        <p:nvSpPr>
          <p:cNvPr id="219" name="Google Shape;219;p: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b="1" lang="en"/>
              <a:t>Write facilitator notes!!</a:t>
            </a:r>
            <a:endParaRPr b="1"/>
          </a:p>
          <a:p>
            <a:pPr indent="0" lvl="0" marL="0" rtl="0" algn="l">
              <a:spcBef>
                <a:spcPts val="0"/>
              </a:spcBef>
              <a:spcAft>
                <a:spcPts val="0"/>
              </a:spcAft>
              <a:buNone/>
            </a:pPr>
            <a:r>
              <a:t/>
            </a:r>
            <a:endParaRPr b="1"/>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8" name="Shape 288"/>
        <p:cNvGrpSpPr/>
        <p:nvPr/>
      </p:nvGrpSpPr>
      <p:grpSpPr>
        <a:xfrm>
          <a:off x="0" y="0"/>
          <a:ext cx="0" cy="0"/>
          <a:chOff x="0" y="0"/>
          <a:chExt cx="0" cy="0"/>
        </a:xfrm>
      </p:grpSpPr>
      <p:sp>
        <p:nvSpPr>
          <p:cNvPr id="289" name="Google Shape;289;g3d2262edf5f_0_135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90" name="Google Shape;290;g3d2262edf5f_0_135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0" name="Shape 300"/>
        <p:cNvGrpSpPr/>
        <p:nvPr/>
      </p:nvGrpSpPr>
      <p:grpSpPr>
        <a:xfrm>
          <a:off x="0" y="0"/>
          <a:ext cx="0" cy="0"/>
          <a:chOff x="0" y="0"/>
          <a:chExt cx="0" cy="0"/>
        </a:xfrm>
      </p:grpSpPr>
      <p:sp>
        <p:nvSpPr>
          <p:cNvPr id="301" name="Google Shape;301;g2e128b68758_0_130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02" name="Google Shape;302;g2e128b68758_0_130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sz="700">
                <a:solidFill>
                  <a:schemeClr val="dk1"/>
                </a:solidFill>
              </a:rPr>
              <a:t>Vahratian A, Blumberg SJ, Terlizzi EP, Schiller JS. Symptoms of Anxiety or Depressive Disorder and Use of Mental Health Care Among Adults During the COVID19 Pandemic — United States, August 2020–February 2021. MMWR Morb Mortal Wkly Rep 2021;70:490–494.</a:t>
            </a:r>
            <a:endParaRPr sz="700">
              <a:solidFill>
                <a:srgbClr val="332C27"/>
              </a:solidFill>
              <a:latin typeface="Hind"/>
              <a:ea typeface="Hind"/>
              <a:cs typeface="Hind"/>
              <a:sym typeface="Hind"/>
            </a:endParaRPr>
          </a:p>
          <a:p>
            <a:pPr indent="0" lvl="0" marL="0" rtl="0" algn="l">
              <a:spcBef>
                <a:spcPts val="0"/>
              </a:spcBef>
              <a:spcAft>
                <a:spcPts val="0"/>
              </a:spcAft>
              <a:buNone/>
            </a:pPr>
            <a:r>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13" name="Shape 313"/>
        <p:cNvGrpSpPr/>
        <p:nvPr/>
      </p:nvGrpSpPr>
      <p:grpSpPr>
        <a:xfrm>
          <a:off x="0" y="0"/>
          <a:ext cx="0" cy="0"/>
          <a:chOff x="0" y="0"/>
          <a:chExt cx="0" cy="0"/>
        </a:xfrm>
      </p:grpSpPr>
      <p:sp>
        <p:nvSpPr>
          <p:cNvPr id="314" name="Google Shape;314;g2ebd403dafb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15" name="Google Shape;315;g2ebd403dafb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0" name="Shape 320"/>
        <p:cNvGrpSpPr/>
        <p:nvPr/>
      </p:nvGrpSpPr>
      <p:grpSpPr>
        <a:xfrm>
          <a:off x="0" y="0"/>
          <a:ext cx="0" cy="0"/>
          <a:chOff x="0" y="0"/>
          <a:chExt cx="0" cy="0"/>
        </a:xfrm>
      </p:grpSpPr>
      <p:sp>
        <p:nvSpPr>
          <p:cNvPr id="321" name="Google Shape;321;g3d2262edf5f_0_147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22" name="Google Shape;322;g3d2262edf5f_0_147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8" name="Shape 348"/>
        <p:cNvGrpSpPr/>
        <p:nvPr/>
      </p:nvGrpSpPr>
      <p:grpSpPr>
        <a:xfrm>
          <a:off x="0" y="0"/>
          <a:ext cx="0" cy="0"/>
          <a:chOff x="0" y="0"/>
          <a:chExt cx="0" cy="0"/>
        </a:xfrm>
      </p:grpSpPr>
      <p:sp>
        <p:nvSpPr>
          <p:cNvPr id="349" name="Google Shape;349;g2e0f5c72b50_2_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50" name="Google Shape;350;g2e0f5c72b50_2_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Facilitator</a:t>
            </a:r>
            <a:r>
              <a:rPr lang="en"/>
              <a:t> guide: read slide and emphasize that subgroups experience mental health differently</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Kim HJ, Park E, Storr CL, Tran K, Juon HS (2015) Depression among AsianAmerican Adults in the Community: Systematic Review and MetaAnalysis. PLoS ONE 10(6): e0127760. </a:t>
            </a:r>
            <a:r>
              <a:rPr lang="en" u="sng">
                <a:solidFill>
                  <a:schemeClr val="hlink"/>
                </a:solidFill>
                <a:hlinkClick r:id="rId2"/>
              </a:rPr>
              <a:t>https://doi.org/10.1371/journal.pone.0127760</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Maxwell, Connor and Lisa Kwon. "4 Ways to Improve Access to Mental Health Services in Asian American Communities." Center for American Progress, 10 Oct. 2018, americanprogress.org/article/4waysimproveaccessmentalhealthservicesasianamericancommunities.</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5" name="Shape 395"/>
        <p:cNvGrpSpPr/>
        <p:nvPr/>
      </p:nvGrpSpPr>
      <p:grpSpPr>
        <a:xfrm>
          <a:off x="0" y="0"/>
          <a:ext cx="0" cy="0"/>
          <a:chOff x="0" y="0"/>
          <a:chExt cx="0" cy="0"/>
        </a:xfrm>
      </p:grpSpPr>
      <p:sp>
        <p:nvSpPr>
          <p:cNvPr id="396" name="Google Shape;396;g2e0f5c72b50_2_4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97" name="Google Shape;397;g2e0f5c72b50_2_4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Facilitator guide: read the slide</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None/>
            </a:pPr>
            <a:r>
              <a:rPr lang="en">
                <a:solidFill>
                  <a:schemeClr val="dk1"/>
                </a:solidFill>
              </a:rPr>
              <a:t>Tan, C., Lo, F., Ocampo, C., Galán, M., &amp; Ponce, N. A. (February 2024). "Piecing the Puzzle of AANHPI Mental Health: A Community Analysis of Mental Health Experiences of Asian Americans, Native Hawaiians, and Pacific Islanders in California." Report prepared by AAPI Data and UCLA Center for Health Policy Research.</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Clr>
                <a:schemeClr val="dk1"/>
              </a:buClr>
              <a:buSzPts val="1100"/>
              <a:buFont typeface="Arial"/>
              <a:buNone/>
            </a:pPr>
            <a:r>
              <a:t/>
            </a:r>
            <a:endParaRPr>
              <a:solidFill>
                <a:schemeClr val="dk1"/>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42" name="Shape 442"/>
        <p:cNvGrpSpPr/>
        <p:nvPr/>
      </p:nvGrpSpPr>
      <p:grpSpPr>
        <a:xfrm>
          <a:off x="0" y="0"/>
          <a:ext cx="0" cy="0"/>
          <a:chOff x="0" y="0"/>
          <a:chExt cx="0" cy="0"/>
        </a:xfrm>
      </p:grpSpPr>
      <p:sp>
        <p:nvSpPr>
          <p:cNvPr id="443" name="Google Shape;443;g30999c3c65b_1_13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44" name="Google Shape;444;g30999c3c65b_1_13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Facilitator guide: read the slide</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None/>
            </a:pPr>
            <a:r>
              <a:rPr lang="en">
                <a:solidFill>
                  <a:schemeClr val="dk1"/>
                </a:solidFill>
              </a:rPr>
              <a:t>Tan, C., Lo, F., Ocampo, C., Galán, M., &amp; Ponce, N. A. (February 2024). "Piecing the Puzzle of AANHPI Mental Health: A Community Analysis of Mental Health Experiences of Asian Americans, Native Hawaiians, and Pacific Islanders in California." Report prepared by AAPI Data and UCLA Center for Health Policy Research.</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Clr>
                <a:schemeClr val="dk1"/>
              </a:buClr>
              <a:buSzPts val="1100"/>
              <a:buFont typeface="Arial"/>
              <a:buNone/>
            </a:pPr>
            <a:r>
              <a:t/>
            </a:r>
            <a:endParaRPr>
              <a:solidFill>
                <a:schemeClr val="dk1"/>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95" name="Shape 495"/>
        <p:cNvGrpSpPr/>
        <p:nvPr/>
      </p:nvGrpSpPr>
      <p:grpSpPr>
        <a:xfrm>
          <a:off x="0" y="0"/>
          <a:ext cx="0" cy="0"/>
          <a:chOff x="0" y="0"/>
          <a:chExt cx="0" cy="0"/>
        </a:xfrm>
      </p:grpSpPr>
      <p:sp>
        <p:nvSpPr>
          <p:cNvPr id="496" name="Google Shape;496;g2e128b68758_4_2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97" name="Google Shape;497;g2e128b68758_4_2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1" name="Shape 501"/>
        <p:cNvGrpSpPr/>
        <p:nvPr/>
      </p:nvGrpSpPr>
      <p:grpSpPr>
        <a:xfrm>
          <a:off x="0" y="0"/>
          <a:ext cx="0" cy="0"/>
          <a:chOff x="0" y="0"/>
          <a:chExt cx="0" cy="0"/>
        </a:xfrm>
      </p:grpSpPr>
      <p:sp>
        <p:nvSpPr>
          <p:cNvPr id="502" name="Google Shape;502;g2ee9f1955fe_0_1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03" name="Google Shape;503;g2ee9f1955fe_0_1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8" name="Shape 508"/>
        <p:cNvGrpSpPr/>
        <p:nvPr/>
      </p:nvGrpSpPr>
      <p:grpSpPr>
        <a:xfrm>
          <a:off x="0" y="0"/>
          <a:ext cx="0" cy="0"/>
          <a:chOff x="0" y="0"/>
          <a:chExt cx="0" cy="0"/>
        </a:xfrm>
      </p:grpSpPr>
      <p:sp>
        <p:nvSpPr>
          <p:cNvPr id="509" name="Google Shape;509;g30a00e86d3b_0_3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10" name="Google Shape;510;g30a00e86d3b_0_3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Facilitator guide: read the slide, overall emphasizing that AANHPIs that need mental health services are unable to receive them</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National Alliance on Mental Illness. (2021). Communities of color face greater challenges finding effective therapy, national survey finds [News release]. Available from https://www.nami.org/PressMedia/PressReleases/2021/ CommunitiesofColorFaceGreaterChallengesFindingEffectiveTherapyNationalSurveyFinds</a:t>
            </a:r>
            <a:endParaRPr/>
          </a:p>
          <a:p>
            <a:pPr indent="0" lvl="0" marL="0" rtl="0" algn="l">
              <a:lnSpc>
                <a:spcPct val="115000"/>
              </a:lnSpc>
              <a:spcBef>
                <a:spcPts val="1200"/>
              </a:spcBef>
              <a:spcAft>
                <a:spcPts val="0"/>
              </a:spcAft>
              <a:buClr>
                <a:schemeClr val="dk1"/>
              </a:buClr>
              <a:buSzPts val="1100"/>
              <a:buFont typeface="Arial"/>
              <a:buNone/>
            </a:pPr>
            <a:r>
              <a:rPr lang="en"/>
              <a:t>NPR. (2017, December). "Discrimination in America: Experiences and Views of Asian Americans." Retrieved from: https://legacy.npr.org/assets/news/2017/12/discriminationpollasianamericans.pdf</a:t>
            </a:r>
            <a:endParaRPr/>
          </a:p>
          <a:p>
            <a:pPr indent="0" lvl="0" marL="0" rtl="0" algn="l">
              <a:spcBef>
                <a:spcPts val="1200"/>
              </a:spcBef>
              <a:spcAft>
                <a:spcPts val="0"/>
              </a:spcAft>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5" name="Shape 225"/>
        <p:cNvGrpSpPr/>
        <p:nvPr/>
      </p:nvGrpSpPr>
      <p:grpSpPr>
        <a:xfrm>
          <a:off x="0" y="0"/>
          <a:ext cx="0" cy="0"/>
          <a:chOff x="0" y="0"/>
          <a:chExt cx="0" cy="0"/>
        </a:xfrm>
      </p:grpSpPr>
      <p:sp>
        <p:nvSpPr>
          <p:cNvPr id="226" name="Google Shape;226;g2df46830332_0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7" name="Google Shape;227;g2df46830332_0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29" name="Shape 529"/>
        <p:cNvGrpSpPr/>
        <p:nvPr/>
      </p:nvGrpSpPr>
      <p:grpSpPr>
        <a:xfrm>
          <a:off x="0" y="0"/>
          <a:ext cx="0" cy="0"/>
          <a:chOff x="0" y="0"/>
          <a:chExt cx="0" cy="0"/>
        </a:xfrm>
      </p:grpSpPr>
      <p:sp>
        <p:nvSpPr>
          <p:cNvPr id="530" name="Google Shape;530;g30a00e86d3b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31" name="Google Shape;531;g30a00e86d3b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Facilitator guide: read the slide, overall emphasizing that AANHPIs that need mental health services are unable to receive them</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National Alliance on Mental Illness. (2021). Communities of color face greater challenges finding effective therapy, national survey finds [News release]. Available from https://www.nami.org/PressMedia/PressReleases/2021/ CommunitiesofColorFaceGreaterChallengesFindingEffectiveTherapyNationalSurveyFinds</a:t>
            </a:r>
            <a:endParaRPr/>
          </a:p>
          <a:p>
            <a:pPr indent="0" lvl="0" marL="0" rtl="0" algn="l">
              <a:lnSpc>
                <a:spcPct val="115000"/>
              </a:lnSpc>
              <a:spcBef>
                <a:spcPts val="1200"/>
              </a:spcBef>
              <a:spcAft>
                <a:spcPts val="0"/>
              </a:spcAft>
              <a:buClr>
                <a:schemeClr val="dk1"/>
              </a:buClr>
              <a:buSzPts val="1100"/>
              <a:buFont typeface="Arial"/>
              <a:buNone/>
            </a:pPr>
            <a:r>
              <a:rPr lang="en"/>
              <a:t>NPR. (2017, December). "Discrimination in America: Experiences and Views of Asian Americans." Retrieved from: </a:t>
            </a:r>
            <a:r>
              <a:rPr lang="en" u="sng">
                <a:solidFill>
                  <a:schemeClr val="hlink"/>
                </a:solidFill>
                <a:hlinkClick r:id="rId2"/>
              </a:rPr>
              <a:t>https://legacy.npr.org/assets/news/2017/12/discriminationpollasianamericans.pdf</a:t>
            </a:r>
            <a:endParaRPr/>
          </a:p>
          <a:p>
            <a:pPr indent="0" lvl="0" marL="0" rtl="0" algn="l">
              <a:lnSpc>
                <a:spcPct val="115000"/>
              </a:lnSpc>
              <a:spcBef>
                <a:spcPts val="1200"/>
              </a:spcBef>
              <a:spcAft>
                <a:spcPts val="0"/>
              </a:spcAft>
              <a:buClr>
                <a:schemeClr val="dk1"/>
              </a:buClr>
              <a:buSzPts val="1100"/>
              <a:buFont typeface="Arial"/>
              <a:buNone/>
            </a:pPr>
            <a:r>
              <a:t/>
            </a:r>
            <a:endParaRPr/>
          </a:p>
          <a:p>
            <a:pPr indent="0" lvl="0" marL="0" rtl="0" algn="l">
              <a:lnSpc>
                <a:spcPct val="115000"/>
              </a:lnSpc>
              <a:spcBef>
                <a:spcPts val="1200"/>
              </a:spcBef>
              <a:spcAft>
                <a:spcPts val="0"/>
              </a:spcAft>
              <a:buClr>
                <a:schemeClr val="dk1"/>
              </a:buClr>
              <a:buSzPts val="1100"/>
              <a:buFont typeface="Arial"/>
              <a:buNone/>
            </a:pPr>
            <a:r>
              <a:rPr lang="en" u="sng">
                <a:solidFill>
                  <a:schemeClr val="hlink"/>
                </a:solidFill>
                <a:hlinkClick r:id="rId3"/>
              </a:rPr>
              <a:t>https://aspe.hhs.gov/sites/default/files/private/pdf/265581/aspe-uninsured-trends-aapi-ib.pdf</a:t>
            </a:r>
            <a:endParaRPr/>
          </a:p>
          <a:p>
            <a:pPr indent="0" lvl="0" marL="0" rtl="0" algn="l">
              <a:lnSpc>
                <a:spcPct val="115000"/>
              </a:lnSpc>
              <a:spcBef>
                <a:spcPts val="1200"/>
              </a:spcBef>
              <a:spcAft>
                <a:spcPts val="0"/>
              </a:spcAft>
              <a:buClr>
                <a:schemeClr val="dk1"/>
              </a:buClr>
              <a:buSzPts val="1100"/>
              <a:buFont typeface="Arial"/>
              <a:buNone/>
            </a:pPr>
            <a:r>
              <a:t/>
            </a:r>
            <a:endParaRPr/>
          </a:p>
          <a:p>
            <a:pPr indent="0" lvl="0" marL="0" rtl="0" algn="l">
              <a:spcBef>
                <a:spcPts val="1200"/>
              </a:spcBef>
              <a:spcAft>
                <a:spcPts val="0"/>
              </a:spcAft>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48" name="Shape 548"/>
        <p:cNvGrpSpPr/>
        <p:nvPr/>
      </p:nvGrpSpPr>
      <p:grpSpPr>
        <a:xfrm>
          <a:off x="0" y="0"/>
          <a:ext cx="0" cy="0"/>
          <a:chOff x="0" y="0"/>
          <a:chExt cx="0" cy="0"/>
        </a:xfrm>
      </p:grpSpPr>
      <p:sp>
        <p:nvSpPr>
          <p:cNvPr id="549" name="Google Shape;549;g30999c3c65b_1_143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50" name="Google Shape;550;g30999c3c65b_1_143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Even if an individual has the financial means to access mental health care, there are a number of barriers to actively seeking it out.</a:t>
            </a:r>
            <a:endParaRPr>
              <a:solidFill>
                <a:schemeClr val="dk1"/>
              </a:solidFill>
            </a:endParaRPr>
          </a:p>
          <a:p>
            <a:pPr indent="0" lvl="0" marL="0" rtl="0" algn="l">
              <a:spcBef>
                <a:spcPts val="0"/>
              </a:spcBef>
              <a:spcAft>
                <a:spcPts val="0"/>
              </a:spcAft>
              <a:buNone/>
            </a:pPr>
            <a:r>
              <a:t/>
            </a:r>
            <a:endParaRPr>
              <a:solidFill>
                <a:schemeClr val="dk1"/>
              </a:solidFill>
            </a:endParaRPr>
          </a:p>
          <a:p>
            <a:pPr indent="0" lvl="0" marL="0" rtl="0" algn="l">
              <a:spcBef>
                <a:spcPts val="0"/>
              </a:spcBef>
              <a:spcAft>
                <a:spcPts val="0"/>
              </a:spcAft>
              <a:buNone/>
            </a:pPr>
            <a:r>
              <a:rPr lang="en">
                <a:solidFill>
                  <a:schemeClr val="dk1"/>
                </a:solidFill>
              </a:rPr>
              <a:t>Facilitator guide: read the slide, elaborate on points below – </a:t>
            </a:r>
            <a:endParaRPr>
              <a:solidFill>
                <a:schemeClr val="dk1"/>
              </a:solidFill>
            </a:endParaRPr>
          </a:p>
          <a:p>
            <a:pPr indent="0" lvl="0" marL="0" rtl="0" algn="l">
              <a:spcBef>
                <a:spcPts val="0"/>
              </a:spcBef>
              <a:spcAft>
                <a:spcPts val="0"/>
              </a:spcAft>
              <a:buNone/>
            </a:pPr>
            <a:r>
              <a:rPr b="1" lang="en">
                <a:solidFill>
                  <a:schemeClr val="dk1"/>
                </a:solidFill>
              </a:rPr>
              <a:t>Discussions of feelings and mental health are not culturally normative in AANHPI families</a:t>
            </a:r>
            <a:r>
              <a:rPr lang="en">
                <a:solidFill>
                  <a:schemeClr val="dk1"/>
                </a:solidFill>
              </a:rPr>
              <a:t>, </a:t>
            </a:r>
            <a:endParaRPr>
              <a:solidFill>
                <a:schemeClr val="dk1"/>
              </a:solidFill>
            </a:endParaRPr>
          </a:p>
          <a:p>
            <a:pPr indent="0" lvl="0" marL="0" rtl="0" algn="l">
              <a:spcBef>
                <a:spcPts val="0"/>
              </a:spcBef>
              <a:spcAft>
                <a:spcPts val="0"/>
              </a:spcAft>
              <a:buNone/>
            </a:pPr>
            <a:r>
              <a:rPr lang="en">
                <a:solidFill>
                  <a:schemeClr val="dk1"/>
                </a:solidFill>
              </a:rPr>
              <a:t>Vietnamese Culture: Mental health viewed as a consequence of past misdeeds or ancestral sins; concerns can bring disgrace and shame to the family </a:t>
            </a:r>
            <a:endParaRPr>
              <a:solidFill>
                <a:schemeClr val="dk1"/>
              </a:solidFill>
            </a:endParaRPr>
          </a:p>
          <a:p>
            <a:pPr indent="0" lvl="0" marL="0" rtl="0" algn="l">
              <a:spcBef>
                <a:spcPts val="0"/>
              </a:spcBef>
              <a:spcAft>
                <a:spcPts val="0"/>
              </a:spcAft>
              <a:buNone/>
            </a:pPr>
            <a:r>
              <a:rPr lang="en">
                <a:solidFill>
                  <a:schemeClr val="dk1"/>
                </a:solidFill>
              </a:rPr>
              <a:t>Model Minority Stereotype: pressure to meet the model minority stereotype promotes distress amongst AA youth</a:t>
            </a:r>
            <a:endParaRPr>
              <a:solidFill>
                <a:schemeClr val="dk1"/>
              </a:solidFill>
            </a:endParaRPr>
          </a:p>
          <a:p>
            <a:pPr indent="0" lvl="0" marL="0" rtl="0" algn="l">
              <a:spcBef>
                <a:spcPts val="0"/>
              </a:spcBef>
              <a:spcAft>
                <a:spcPts val="0"/>
              </a:spcAft>
              <a:buNone/>
            </a:pPr>
            <a:r>
              <a:rPr lang="en">
                <a:solidFill>
                  <a:schemeClr val="dk1"/>
                </a:solidFill>
              </a:rPr>
              <a:t>Survivor Mentality: War Induced trauma and colonization → development of a “survivor mentality” that promotes resilience and contradicts help seeking behavior</a:t>
            </a:r>
            <a:endParaRPr>
              <a:solidFill>
                <a:schemeClr val="dk1"/>
              </a:solidFill>
            </a:endParaRPr>
          </a:p>
          <a:p>
            <a:pPr indent="0" lvl="0" marL="0" rtl="0" algn="l">
              <a:spcBef>
                <a:spcPts val="0"/>
              </a:spcBef>
              <a:spcAft>
                <a:spcPts val="0"/>
              </a:spcAft>
              <a:buClr>
                <a:schemeClr val="dk1"/>
              </a:buClr>
              <a:buSzPts val="1100"/>
              <a:buFont typeface="Arial"/>
              <a:buNone/>
            </a:pPr>
            <a:r>
              <a:rPr lang="en">
                <a:solidFill>
                  <a:schemeClr val="dk1"/>
                </a:solidFill>
              </a:rPr>
              <a:t>Samoan Culture: Less frequently perceive mental health as serious, endorse stigma, and commonly seek to distance oneself from someone with depression</a:t>
            </a:r>
            <a:endParaRPr>
              <a:solidFill>
                <a:schemeClr val="dk1"/>
              </a:solidFill>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Huang, E.R., Hall, G.C.N. (2020). The Invisibility of Asian Americans in the United States: Impact on Mental and Physical Health. In: Benuto, L., Duckworth, M., Masuda, A., O'Donohue, W. (eds) Prejudice, Stigma, Privilege, and Oppression. Springer, Cham. https://doi.org/10.1007/9783030355173_6</a:t>
            </a:r>
            <a:endParaRPr/>
          </a:p>
          <a:p>
            <a:pPr indent="0" lvl="0" marL="0" rtl="0" algn="l">
              <a:spcBef>
                <a:spcPts val="0"/>
              </a:spcBef>
              <a:spcAft>
                <a:spcPts val="0"/>
              </a:spcAft>
              <a:buNone/>
            </a:pPr>
            <a:r>
              <a:t/>
            </a:r>
            <a:endParaRPr/>
          </a:p>
          <a:p>
            <a:pPr indent="0" lvl="0" marL="0" rtl="0" algn="l">
              <a:spcBef>
                <a:spcPts val="0"/>
              </a:spcBef>
              <a:spcAft>
                <a:spcPts val="0"/>
              </a:spcAft>
              <a:buClr>
                <a:schemeClr val="dk1"/>
              </a:buClr>
              <a:buSzPts val="1100"/>
              <a:buFont typeface="Arial"/>
              <a:buNone/>
            </a:pPr>
            <a:r>
              <a:rPr lang="en">
                <a:solidFill>
                  <a:schemeClr val="dk1"/>
                </a:solidFill>
              </a:rPr>
              <a:t>Tan, C., Lo, F., Ocampo, C., Galán, M., &amp; Ponce, N. A. (February 2024). "Piecing the Puzzle of AANHPI Mental Health: A Community Analysis of Mental Health Experiences of Asian Americans, Native Hawaiians, and Pacific Islanders in California." Report prepared by AAPI Data and UCLA Center for Health Policy Research.</a:t>
            </a:r>
            <a:endParaRPr>
              <a:solidFill>
                <a:schemeClr val="dk1"/>
              </a:solidFill>
            </a:endParaRPr>
          </a:p>
          <a:p>
            <a:pPr indent="0" lvl="0" marL="0" rtl="0" algn="l">
              <a:spcBef>
                <a:spcPts val="0"/>
              </a:spcBef>
              <a:spcAft>
                <a:spcPts val="0"/>
              </a:spcAft>
              <a:buNone/>
            </a:pPr>
            <a:r>
              <a:t/>
            </a:r>
            <a:endParaRPr/>
          </a:p>
          <a:p>
            <a:pPr indent="0" lvl="0" marL="0" rtl="0" algn="l">
              <a:spcBef>
                <a:spcPts val="0"/>
              </a:spcBef>
              <a:spcAft>
                <a:spcPts val="0"/>
              </a:spcAft>
              <a:buNone/>
            </a:pPr>
            <a:r>
              <a:rPr lang="en"/>
              <a:t>Solano County and University of California, Davis. (2018). FilipinoAmerican voices: Community narratives about mental health in Solano County. University of California, Davis, Center for Reducing Health Disparities. Available from https://health.ucdavis.edu/mediaresources/crhd/documents/pdfs/narrativefilamenglish.pdf</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45 Huff, C. (2023, July 1). How to promote mental health among Asian American teens. American Psychological Association Monitor on Psychology 54(5), 40. Available from https://www.apa.org/monitor/2023/07/mentalhealthasianamericanteens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Subica, A. M., Aitaoto, N., Sullivan, J. G., Henwood, B. F., Yamada, A. M., &amp; Link, B. G. (2019). Mental illness stigma among Pacific Islanders. Psychiatry Research, 273, 578585. doi:10.1016/j.psychres.2019.01.077</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63" name="Shape 563"/>
        <p:cNvGrpSpPr/>
        <p:nvPr/>
      </p:nvGrpSpPr>
      <p:grpSpPr>
        <a:xfrm>
          <a:off x="0" y="0"/>
          <a:ext cx="0" cy="0"/>
          <a:chOff x="0" y="0"/>
          <a:chExt cx="0" cy="0"/>
        </a:xfrm>
      </p:grpSpPr>
      <p:sp>
        <p:nvSpPr>
          <p:cNvPr id="564" name="Google Shape;564;g30999c3c65b_1_22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65" name="Google Shape;565;g30999c3c65b_1_22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u="sng">
                <a:solidFill>
                  <a:schemeClr val="hlink"/>
                </a:solidFill>
                <a:hlinkClick r:id="rId2"/>
              </a:rPr>
              <a:t>https://www.hhs.gov/aanhpi-heritage-month/reading-list/index.html#neighborhood-built</a:t>
            </a:r>
            <a:endParaRPr/>
          </a:p>
          <a:p>
            <a:pPr indent="0" lvl="0" marL="0" rtl="0" algn="l">
              <a:spcBef>
                <a:spcPts val="0"/>
              </a:spcBef>
              <a:spcAft>
                <a:spcPts val="0"/>
              </a:spcAft>
              <a:buNone/>
            </a:pPr>
            <a:r>
              <a:rPr lang="en" u="sng">
                <a:solidFill>
                  <a:schemeClr val="hlink"/>
                </a:solidFill>
                <a:hlinkClick r:id="rId3"/>
              </a:rPr>
              <a:t>https://www.pewresearch.org/short-reads/2021/04/29/key-facts-about-asian-americans/</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83" name="Shape 583"/>
        <p:cNvGrpSpPr/>
        <p:nvPr/>
      </p:nvGrpSpPr>
      <p:grpSpPr>
        <a:xfrm>
          <a:off x="0" y="0"/>
          <a:ext cx="0" cy="0"/>
          <a:chOff x="0" y="0"/>
          <a:chExt cx="0" cy="0"/>
        </a:xfrm>
      </p:grpSpPr>
      <p:sp>
        <p:nvSpPr>
          <p:cNvPr id="584" name="Google Shape;584;g2e128b68758_4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85" name="Google Shape;585;g2e128b68758_4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89" name="Shape 589"/>
        <p:cNvGrpSpPr/>
        <p:nvPr/>
      </p:nvGrpSpPr>
      <p:grpSpPr>
        <a:xfrm>
          <a:off x="0" y="0"/>
          <a:ext cx="0" cy="0"/>
          <a:chOff x="0" y="0"/>
          <a:chExt cx="0" cy="0"/>
        </a:xfrm>
      </p:grpSpPr>
      <p:sp>
        <p:nvSpPr>
          <p:cNvPr id="590" name="Google Shape;590;g2dfc5df97ce_2_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91" name="Google Shape;591;g2dfc5df97ce_2_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0"/>
              </a:spcBef>
              <a:spcAft>
                <a:spcPts val="0"/>
              </a:spcAft>
              <a:buNone/>
            </a:pPr>
            <a:r>
              <a:rPr lang="en"/>
              <a:t>Misra S, Wyatt LC, Wong JA, Huang CY, Ali SH, Trinh-Shevrin C, Islam NS, Yi SS, Kwon SC. Determinants of Depression Risk among Three Asian American Subgroups in New York City. Ethn Dis. 2020 Sep 24;30(4):553-562. doi: 10.18865/ed.30.4.553. PMID: 32989355; PMCID: PMC7518536.</a:t>
            </a:r>
            <a:endParaRPr/>
          </a:p>
          <a:p>
            <a:pPr indent="0" lvl="0" marL="0" rtl="0" algn="l">
              <a:lnSpc>
                <a:spcPct val="150000"/>
              </a:lnSpc>
              <a:spcBef>
                <a:spcPts val="0"/>
              </a:spcBef>
              <a:spcAft>
                <a:spcPts val="0"/>
              </a:spcAft>
              <a:buClr>
                <a:schemeClr val="dk1"/>
              </a:buClr>
              <a:buSzPts val="1100"/>
              <a:buFont typeface="Arial"/>
              <a:buNone/>
            </a:pPr>
            <a:r>
              <a:rPr lang="en"/>
              <a:t>Subica AM, Aitaoto N, Sullivan JG, Henwood BF, Yamada AM, Link BG. Mental illness stigma among Pacific Islanders. Psychiatry Res. 2019 Mar;273:578-585. doi: 10.1016/j.psychres.2019.01.077. Epub 2019 Jan 26. PMID: 30716597; PMCID: PMC6561790.</a:t>
            </a:r>
            <a:endParaRPr/>
          </a:p>
          <a:p>
            <a:pPr indent="0" lvl="0" marL="0" rtl="0" algn="l">
              <a:lnSpc>
                <a:spcPct val="115000"/>
              </a:lnSpc>
              <a:spcBef>
                <a:spcPts val="0"/>
              </a:spcBef>
              <a:spcAft>
                <a:spcPts val="0"/>
              </a:spcAft>
              <a:buClr>
                <a:schemeClr val="dk1"/>
              </a:buClr>
              <a:buSzPts val="1100"/>
              <a:buFont typeface="Arial"/>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00" name="Shape 600"/>
        <p:cNvGrpSpPr/>
        <p:nvPr/>
      </p:nvGrpSpPr>
      <p:grpSpPr>
        <a:xfrm>
          <a:off x="0" y="0"/>
          <a:ext cx="0" cy="0"/>
          <a:chOff x="0" y="0"/>
          <a:chExt cx="0" cy="0"/>
        </a:xfrm>
      </p:grpSpPr>
      <p:sp>
        <p:nvSpPr>
          <p:cNvPr id="601" name="Google Shape;601;g30999c3c65b_0_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02" name="Google Shape;602;g30999c3c65b_0_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0"/>
              </a:spcBef>
              <a:spcAft>
                <a:spcPts val="0"/>
              </a:spcAft>
              <a:buNone/>
            </a:pPr>
            <a:r>
              <a:rPr lang="en"/>
              <a:t>Reyes MP, Song I, Bhatt A. Breaking the Silence: An Epidemiological Report on Asian American and Pacific Islander Youth Mental Health and Suicide (1999-2021). Child Adolesc Ment Health. 2024 May;29(2):136-144. doi: 10.1111/camh.12708. Epub 2024 Mar 25. PMID: 38525866.</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11" name="Shape 611"/>
        <p:cNvGrpSpPr/>
        <p:nvPr/>
      </p:nvGrpSpPr>
      <p:grpSpPr>
        <a:xfrm>
          <a:off x="0" y="0"/>
          <a:ext cx="0" cy="0"/>
          <a:chOff x="0" y="0"/>
          <a:chExt cx="0" cy="0"/>
        </a:xfrm>
      </p:grpSpPr>
      <p:sp>
        <p:nvSpPr>
          <p:cNvPr id="612" name="Google Shape;612;g2e0d8931947_0_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13" name="Google Shape;613;g2e0d8931947_0_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19" name="Shape 619"/>
        <p:cNvGrpSpPr/>
        <p:nvPr/>
      </p:nvGrpSpPr>
      <p:grpSpPr>
        <a:xfrm>
          <a:off x="0" y="0"/>
          <a:ext cx="0" cy="0"/>
          <a:chOff x="0" y="0"/>
          <a:chExt cx="0" cy="0"/>
        </a:xfrm>
      </p:grpSpPr>
      <p:sp>
        <p:nvSpPr>
          <p:cNvPr id="620" name="Google Shape;620;g30999c3c65b_0_41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21" name="Google Shape;621;g30999c3c65b_0_41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0"/>
              </a:spcBef>
              <a:spcAft>
                <a:spcPts val="0"/>
              </a:spcAft>
              <a:buNone/>
            </a:pPr>
            <a:r>
              <a:rPr lang="en"/>
              <a:t>Lau AS, Fung J, Wang SW, Kang SM. Explaining elevated social anxiety among Asian Americans: emotional attunement and a cultural double bind. Cultur Divers Ethnic Minor Psychol. 2009 Jan;15(1):77-85. doi: 10.1037/a0012819. PMID: 19209982; PMCID: PMC7055480.</a:t>
            </a:r>
            <a:endParaRPr/>
          </a:p>
          <a:p>
            <a:pPr indent="0" lvl="0" marL="0" rtl="0" algn="l">
              <a:lnSpc>
                <a:spcPct val="150000"/>
              </a:lnSpc>
              <a:spcBef>
                <a:spcPts val="0"/>
              </a:spcBef>
              <a:spcAft>
                <a:spcPts val="0"/>
              </a:spcAft>
              <a:buNone/>
            </a:pPr>
            <a:r>
              <a:rPr lang="en"/>
              <a:t>Krieg A, Xu Y, Cicero DC. Comparing Social Anxiety Between Asian Americans and European Americans: An Examination of Measurement Invariance. Assessment. 2018 Jul;25(5):564-577. doi: 10.1177/1073191116656438. Epub 2016 Jun 29. PMID: 27364002.</a:t>
            </a:r>
            <a:endParaRPr/>
          </a:p>
          <a:p>
            <a:pPr indent="0" lvl="0" marL="0" rtl="0" algn="l">
              <a:lnSpc>
                <a:spcPct val="150000"/>
              </a:lnSpc>
              <a:spcBef>
                <a:spcPts val="0"/>
              </a:spcBef>
              <a:spcAft>
                <a:spcPts val="0"/>
              </a:spcAft>
              <a:buClr>
                <a:schemeClr val="dk1"/>
              </a:buClr>
              <a:buSzPts val="1100"/>
              <a:buFont typeface="Arial"/>
              <a:buNone/>
            </a:pPr>
            <a:r>
              <a:rPr lang="en"/>
              <a:t>Lee J, Howard JT. Increased Self-Reported Mental Health Problems Among Asian-Americans During the COVID-19 Pandemic in the United States: Evidence from a Nationally Representative Database. J Racial Ethn Health Disparities. 2023 Oct;10(5):2344-2353. doi: 10.1007/s40615-022-01414-3. Epub 2022 Sep 21. PMID: 36129608; PMCID: PMC9491255.</a:t>
            </a:r>
            <a:endParaRPr/>
          </a:p>
          <a:p>
            <a:pPr indent="0" lvl="0" marL="0" rtl="0" algn="l">
              <a:lnSpc>
                <a:spcPct val="115000"/>
              </a:lnSpc>
              <a:spcBef>
                <a:spcPts val="0"/>
              </a:spcBef>
              <a:spcAft>
                <a:spcPts val="0"/>
              </a:spcAft>
              <a:buClr>
                <a:schemeClr val="dk1"/>
              </a:buClr>
              <a:buSzPts val="1100"/>
              <a:buFont typeface="Arial"/>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30" name="Shape 630"/>
        <p:cNvGrpSpPr/>
        <p:nvPr/>
      </p:nvGrpSpPr>
      <p:grpSpPr>
        <a:xfrm>
          <a:off x="0" y="0"/>
          <a:ext cx="0" cy="0"/>
          <a:chOff x="0" y="0"/>
          <a:chExt cx="0" cy="0"/>
        </a:xfrm>
      </p:grpSpPr>
      <p:sp>
        <p:nvSpPr>
          <p:cNvPr id="631" name="Google Shape;631;g30999c3c65b_0_426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32" name="Google Shape;632;g30999c3c65b_0_426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0"/>
              </a:spcBef>
              <a:spcAft>
                <a:spcPts val="0"/>
              </a:spcAft>
              <a:buNone/>
            </a:pPr>
            <a:r>
              <a:rPr lang="en"/>
              <a:t>Li H, Friedman-Yakoobian M, Min G, Granato AG, Seidman LJ. Working with Asian American youth at clinical high risk for psychosis: a case illustration. J Nerv Ment Dis. 2013 Jun;201(6):484-9. doi: 10.1097/NMD.0b013e3182948084. PMID: 23689196; PMCID: PMC3705710.</a:t>
            </a:r>
            <a:endParaRPr/>
          </a:p>
          <a:p>
            <a:pPr indent="0" lvl="0" marL="0" rtl="0" algn="l">
              <a:lnSpc>
                <a:spcPct val="150000"/>
              </a:lnSpc>
              <a:spcBef>
                <a:spcPts val="0"/>
              </a:spcBef>
              <a:spcAft>
                <a:spcPts val="0"/>
              </a:spcAft>
              <a:buNone/>
            </a:pPr>
            <a:r>
              <a:rPr lang="en"/>
              <a:t>Oh H, Verdugo JL, Karcher NR, van der Ven E, Koyanagi A, Smith L, DeVylder JE. Ethno-racial variation in psychotic experiences in the United States: Findings from the National Latino and Asian American Survey and the National Survey of American Life. Schizophr Res. 2023 Dec;262:55-59. doi: 10.1016/j.schres.2023.10.037. Epub 2023 Nov 3. PMID: 37925751.</a:t>
            </a:r>
            <a:endParaRPr/>
          </a:p>
          <a:p>
            <a:pPr indent="0" lvl="0" marL="0" rtl="0" algn="l">
              <a:lnSpc>
                <a:spcPct val="150000"/>
              </a:lnSpc>
              <a:spcBef>
                <a:spcPts val="0"/>
              </a:spcBef>
              <a:spcAft>
                <a:spcPts val="0"/>
              </a:spcAft>
              <a:buNone/>
            </a:pPr>
            <a:r>
              <a:rPr lang="en"/>
              <a:t>Lim C, Hernandez M, Gaona L, Barrio C. Recruitment of Asian Americans with Schizophrenia Spectrum Disorder for Research Participation: Barriers, Strategies, and Outcomes. Community Ment Health J. 2021 Apr;57(3):490-501. doi: 10.1007/s10597-020-00670-z. Epub 2020 Jun 25. PMID: 32588227.</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41" name="Shape 641"/>
        <p:cNvGrpSpPr/>
        <p:nvPr/>
      </p:nvGrpSpPr>
      <p:grpSpPr>
        <a:xfrm>
          <a:off x="0" y="0"/>
          <a:ext cx="0" cy="0"/>
          <a:chOff x="0" y="0"/>
          <a:chExt cx="0" cy="0"/>
        </a:xfrm>
      </p:grpSpPr>
      <p:sp>
        <p:nvSpPr>
          <p:cNvPr id="642" name="Google Shape;642;g2e128b68758_4_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43" name="Google Shape;643;g2e128b68758_4_2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2" name="Shape 232"/>
        <p:cNvGrpSpPr/>
        <p:nvPr/>
      </p:nvGrpSpPr>
      <p:grpSpPr>
        <a:xfrm>
          <a:off x="0" y="0"/>
          <a:ext cx="0" cy="0"/>
          <a:chOff x="0" y="0"/>
          <a:chExt cx="0" cy="0"/>
        </a:xfrm>
      </p:grpSpPr>
      <p:sp>
        <p:nvSpPr>
          <p:cNvPr id="233" name="Google Shape;233;g2e0f5c72b50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4" name="Google Shape;234;g2e0f5c72b50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Source: </a:t>
            </a:r>
            <a:r>
              <a:rPr lang="en" u="sng">
                <a:solidFill>
                  <a:schemeClr val="hlink"/>
                </a:solidFill>
                <a:hlinkClick r:id="rId2"/>
              </a:rPr>
              <a:t>https://www.census.gov/library/stories/2022/05/aanhpipopulationdiversegeographicallydispersed.html</a:t>
            </a:r>
            <a:endParaRPr/>
          </a:p>
          <a:p>
            <a:pPr indent="0" lvl="0" marL="0" rtl="0" algn="l">
              <a:spcBef>
                <a:spcPts val="0"/>
              </a:spcBef>
              <a:spcAft>
                <a:spcPts val="0"/>
              </a:spcAft>
              <a:buNone/>
            </a:pPr>
            <a:r>
              <a:rPr lang="en" u="sng">
                <a:solidFill>
                  <a:schemeClr val="hlink"/>
                </a:solidFill>
                <a:hlinkClick r:id="rId3"/>
              </a:rPr>
              <a:t>https://www.nami.org/your-journey/identity-and-cultural-dimensions/asian-american-and-pacific-islander/#:~:text=AANHPI%20communities%20consist%20of%20approximately,Asian%20and%20Pacific%20Islander%20ancestries</a:t>
            </a:r>
            <a:r>
              <a:rPr lang="en"/>
              <a:t>.</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Facilitator guide: Review the slides and the figure, emphasizing the large number of AANHPI people in the United States and that it is an incredibly diverse group that can’t be generalized into one term</a:t>
            </a: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47" name="Shape 647"/>
        <p:cNvGrpSpPr/>
        <p:nvPr/>
      </p:nvGrpSpPr>
      <p:grpSpPr>
        <a:xfrm>
          <a:off x="0" y="0"/>
          <a:ext cx="0" cy="0"/>
          <a:chOff x="0" y="0"/>
          <a:chExt cx="0" cy="0"/>
        </a:xfrm>
      </p:grpSpPr>
      <p:sp>
        <p:nvSpPr>
          <p:cNvPr id="648" name="Google Shape;648;g2e0f5c72b50_2_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49" name="Google Shape;649;g2e0f5c72b50_2_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Facilitator guide: read the slide</a:t>
            </a:r>
            <a:endParaRPr>
              <a:solidFill>
                <a:schemeClr val="dk1"/>
              </a:solidFill>
            </a:endParaRPr>
          </a:p>
          <a:p>
            <a:pPr indent="0" lvl="0" marL="0" rtl="0" algn="l">
              <a:spcBef>
                <a:spcPts val="0"/>
              </a:spcBef>
              <a:spcAft>
                <a:spcPts val="0"/>
              </a:spcAft>
              <a:buNone/>
            </a:pPr>
            <a:r>
              <a:rPr lang="en">
                <a:solidFill>
                  <a:schemeClr val="dk1"/>
                </a:solidFill>
              </a:rPr>
              <a:t>Reiterate the model minority myth and survival mentality when mentioning historical and current racism</a:t>
            </a:r>
            <a:endParaRPr>
              <a:solidFill>
                <a:schemeClr val="dk1"/>
              </a:solidFill>
            </a:endParaRPr>
          </a:p>
          <a:p>
            <a:pPr indent="0" lvl="0" marL="0" rtl="0" algn="l">
              <a:spcBef>
                <a:spcPts val="0"/>
              </a:spcBef>
              <a:spcAft>
                <a:spcPts val="0"/>
              </a:spcAft>
              <a:buNone/>
            </a:pPr>
            <a:r>
              <a:rPr lang="en">
                <a:solidFill>
                  <a:schemeClr val="dk1"/>
                </a:solidFill>
              </a:rPr>
              <a:t>Reiterate that mental health is viewed as and should be treated holistically in some cultures when mentioning indigenous healing practices</a:t>
            </a:r>
            <a:endParaRPr>
              <a:solidFill>
                <a:schemeClr val="dk1"/>
              </a:solidFill>
            </a:endParaRPr>
          </a:p>
          <a:p>
            <a:pPr indent="0" lvl="0" marL="0" rtl="0" algn="l">
              <a:spcBef>
                <a:spcPts val="0"/>
              </a:spcBef>
              <a:spcAft>
                <a:spcPts val="0"/>
              </a:spcAft>
              <a:buNone/>
            </a:pPr>
            <a:r>
              <a:t/>
            </a:r>
            <a:endParaRPr/>
          </a:p>
          <a:p>
            <a:pPr indent="0" lvl="0" marL="0" rtl="0" algn="l">
              <a:spcBef>
                <a:spcPts val="0"/>
              </a:spcBef>
              <a:spcAft>
                <a:spcPts val="0"/>
              </a:spcAft>
              <a:buNone/>
            </a:pPr>
            <a:r>
              <a:rPr lang="en" u="sng">
                <a:solidFill>
                  <a:schemeClr val="hlink"/>
                </a:solidFill>
                <a:hlinkClick r:id="rId2"/>
              </a:rPr>
              <a:t>https://www.apa.org/pi/oema/resources/ethnicityhealth/asianamerican/psychologicaltreatment</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Yamada, A.M., Vaivao, D.E.S., &amp; Subica, A. (2019). Addressing mental health challenges of Samoan Americans in Southern California: Perspectives of Samoan Community Providers. Asian American Journal of Psychology, 10(3), 227238.</a:t>
            </a: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55" name="Shape 655"/>
        <p:cNvGrpSpPr/>
        <p:nvPr/>
      </p:nvGrpSpPr>
      <p:grpSpPr>
        <a:xfrm>
          <a:off x="0" y="0"/>
          <a:ext cx="0" cy="0"/>
          <a:chOff x="0" y="0"/>
          <a:chExt cx="0" cy="0"/>
        </a:xfrm>
      </p:grpSpPr>
      <p:sp>
        <p:nvSpPr>
          <p:cNvPr id="656" name="Google Shape;656;g2e128b68758_4_2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57" name="Google Shape;657;g2e128b68758_4_2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62" name="Shape 662"/>
        <p:cNvGrpSpPr/>
        <p:nvPr/>
      </p:nvGrpSpPr>
      <p:grpSpPr>
        <a:xfrm>
          <a:off x="0" y="0"/>
          <a:ext cx="0" cy="0"/>
          <a:chOff x="0" y="0"/>
          <a:chExt cx="0" cy="0"/>
        </a:xfrm>
      </p:grpSpPr>
      <p:sp>
        <p:nvSpPr>
          <p:cNvPr id="663" name="Google Shape;663;g2e128b68758_4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64" name="Google Shape;664;g2e128b68758_4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68" name="Shape 668"/>
        <p:cNvGrpSpPr/>
        <p:nvPr/>
      </p:nvGrpSpPr>
      <p:grpSpPr>
        <a:xfrm>
          <a:off x="0" y="0"/>
          <a:ext cx="0" cy="0"/>
          <a:chOff x="0" y="0"/>
          <a:chExt cx="0" cy="0"/>
        </a:xfrm>
      </p:grpSpPr>
      <p:sp>
        <p:nvSpPr>
          <p:cNvPr id="669" name="Google Shape;669;g6d8e93416b89e99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70" name="Google Shape;670;g6d8e93416b89e99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We will now present two cases that simulate clinical experiences that you all may face during </a:t>
            </a:r>
            <a:r>
              <a:rPr lang="en"/>
              <a:t>medical</a:t>
            </a:r>
            <a:r>
              <a:rPr lang="en"/>
              <a:t> student rotations. </a:t>
            </a: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74" name="Shape 674"/>
        <p:cNvGrpSpPr/>
        <p:nvPr/>
      </p:nvGrpSpPr>
      <p:grpSpPr>
        <a:xfrm>
          <a:off x="0" y="0"/>
          <a:ext cx="0" cy="0"/>
          <a:chOff x="0" y="0"/>
          <a:chExt cx="0" cy="0"/>
        </a:xfrm>
      </p:grpSpPr>
      <p:sp>
        <p:nvSpPr>
          <p:cNvPr id="675" name="Google Shape;675;g2e0d8931947_7_1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76" name="Google Shape;676;g2e0d8931947_7_1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While you are on your Obstetrics &amp; Gynecology rotation, you are assigned to a patient named </a:t>
            </a:r>
            <a:r>
              <a:rPr lang="en"/>
              <a:t>Leila</a:t>
            </a:r>
            <a:r>
              <a:rPr lang="en"/>
              <a:t> Singh. She is a 27yearold woman in her second trimester who is presenting for a check up and describes “feeling off” recently.</a:t>
            </a: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82" name="Shape 682"/>
        <p:cNvGrpSpPr/>
        <p:nvPr/>
      </p:nvGrpSpPr>
      <p:grpSpPr>
        <a:xfrm>
          <a:off x="0" y="0"/>
          <a:ext cx="0" cy="0"/>
          <a:chOff x="0" y="0"/>
          <a:chExt cx="0" cy="0"/>
        </a:xfrm>
      </p:grpSpPr>
      <p:sp>
        <p:nvSpPr>
          <p:cNvPr id="683" name="Google Shape;683;g2e128b68758_0_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84" name="Google Shape;684;g2e128b68758_0_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What are some cultural considerations to keep in mind when treating Leila? (ask audience.) Family Dynamics Traditional Medicine Spirituality Work/Home duties Stigma</a:t>
            </a: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89" name="Shape 689"/>
        <p:cNvGrpSpPr/>
        <p:nvPr/>
      </p:nvGrpSpPr>
      <p:grpSpPr>
        <a:xfrm>
          <a:off x="0" y="0"/>
          <a:ext cx="0" cy="0"/>
          <a:chOff x="0" y="0"/>
          <a:chExt cx="0" cy="0"/>
        </a:xfrm>
      </p:grpSpPr>
      <p:sp>
        <p:nvSpPr>
          <p:cNvPr id="690" name="Google Shape;690;g2e0d8931947_7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91" name="Google Shape;691;g2e0d8931947_7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Leila</a:t>
            </a:r>
            <a:r>
              <a:rPr lang="en"/>
              <a:t> reports feeling increasingly tired and lacking energy for the past month. She describes persistent headaches, body aches, and digestive issues such as loss of appetite and occasional stomach discomfort. She also mentions feeling "down" and less interested in social activities or hobbies she once enjoyed. </a:t>
            </a:r>
            <a:r>
              <a:rPr lang="en"/>
              <a:t>Leila</a:t>
            </a:r>
            <a:r>
              <a:rPr lang="en"/>
              <a:t> initially attributed these symptoms to work stress and to her pregnancy but is now concerned as they have persisted despite trying to rest and manage her workload better. What would you want to get a better sense of next? Social History</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SAs with mental health issues commonly interpret their symptoms as physical illnesses and often do not seek needed psychological help.” (</a:t>
            </a:r>
            <a:r>
              <a:rPr lang="en" u="sng">
                <a:solidFill>
                  <a:schemeClr val="hlink"/>
                </a:solidFill>
                <a:hlinkClick r:id="rId2"/>
              </a:rPr>
              <a:t>https://www.ncbi.nlm.nih.gov/pmc/articles/PMC5643212/</a:t>
            </a:r>
            <a:r>
              <a:rPr lang="en"/>
              <a:t>)</a:t>
            </a:r>
            <a:endParaRPr/>
          </a:p>
          <a:p>
            <a:pPr indent="0" lvl="0" marL="0" rtl="0" algn="l">
              <a:spcBef>
                <a:spcPts val="0"/>
              </a:spcBef>
              <a:spcAft>
                <a:spcPts val="0"/>
              </a:spcAft>
              <a:buNone/>
            </a:pPr>
            <a:r>
              <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96" name="Shape 696"/>
        <p:cNvGrpSpPr/>
        <p:nvPr/>
      </p:nvGrpSpPr>
      <p:grpSpPr>
        <a:xfrm>
          <a:off x="0" y="0"/>
          <a:ext cx="0" cy="0"/>
          <a:chOff x="0" y="0"/>
          <a:chExt cx="0" cy="0"/>
        </a:xfrm>
      </p:grpSpPr>
      <p:sp>
        <p:nvSpPr>
          <p:cNvPr id="697" name="Google Shape;697;g2e128b68758_0_119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98" name="Google Shape;698;g2e128b68758_0_119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You would want to get a better sense of her social history, such as her living situation, her work/education status, her social supports. </a:t>
            </a: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04" name="Shape 704"/>
        <p:cNvGrpSpPr/>
        <p:nvPr/>
      </p:nvGrpSpPr>
      <p:grpSpPr>
        <a:xfrm>
          <a:off x="0" y="0"/>
          <a:ext cx="0" cy="0"/>
          <a:chOff x="0" y="0"/>
          <a:chExt cx="0" cy="0"/>
        </a:xfrm>
      </p:grpSpPr>
      <p:sp>
        <p:nvSpPr>
          <p:cNvPr id="705" name="Google Shape;705;g2e0d8931947_7_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06" name="Google Shape;706;g2e0d8931947_7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Leila</a:t>
            </a:r>
            <a:r>
              <a:rPr lang="en"/>
              <a:t> currently lives with her husband and his parents, who are very involved in her life. She has not brought up her feelings to them because she thinks they “would get mad.” As a practicing Hindu, </a:t>
            </a:r>
            <a:r>
              <a:rPr lang="en"/>
              <a:t>Leila</a:t>
            </a:r>
            <a:r>
              <a:rPr lang="en"/>
              <a:t> engages in daily prayers and meditation, which are integral to her routine and coping mechanisms. </a:t>
            </a:r>
            <a:r>
              <a:rPr lang="en"/>
              <a:t>Leila</a:t>
            </a:r>
            <a:r>
              <a:rPr lang="en"/>
              <a:t> balances a demanding job with household responsibilities, feeling pressure to perform well in both areas. When you mention depression, </a:t>
            </a:r>
            <a:r>
              <a:rPr lang="en"/>
              <a:t>Leila</a:t>
            </a:r>
            <a:r>
              <a:rPr lang="en"/>
              <a:t> becomes very nervous and apprehensive. What would you say next?</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It is often believed that disclosure of a mental illness will bring shame upon the family, and is a sign of weakness.” (</a:t>
            </a:r>
            <a:r>
              <a:rPr lang="en" u="sng">
                <a:solidFill>
                  <a:schemeClr val="hlink"/>
                </a:solidFill>
                <a:hlinkClick r:id="rId2"/>
              </a:rPr>
              <a:t>https://www.ncbi.nlm.nih.gov/pmc/articles/PMC5643212/</a:t>
            </a:r>
            <a:r>
              <a:rPr lang="en"/>
              <a:t>)</a:t>
            </a:r>
            <a:endParaRPr/>
          </a:p>
          <a:p>
            <a:pPr indent="0" lvl="0" marL="0" rtl="0" algn="l">
              <a:spcBef>
                <a:spcPts val="0"/>
              </a:spcBef>
              <a:spcAft>
                <a:spcPts val="0"/>
              </a:spcAft>
              <a:buNone/>
            </a:pPr>
            <a:r>
              <a:rPr lang="en"/>
              <a:t>“Religion can provide a valuable way of dealing with mental health concerns, but in some cases, it may deter those who require professional help from seeking it.”</a:t>
            </a: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11" name="Shape 711"/>
        <p:cNvGrpSpPr/>
        <p:nvPr/>
      </p:nvGrpSpPr>
      <p:grpSpPr>
        <a:xfrm>
          <a:off x="0" y="0"/>
          <a:ext cx="0" cy="0"/>
          <a:chOff x="0" y="0"/>
          <a:chExt cx="0" cy="0"/>
        </a:xfrm>
      </p:grpSpPr>
      <p:sp>
        <p:nvSpPr>
          <p:cNvPr id="712" name="Google Shape;712;g2e128b68758_0_1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13" name="Google Shape;713;g2e128b68758_0_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After having a thoughtful and respectful conversation about depression with Leila, she begins to open up to the possibility about having a conversation with her husband and family regarding social supports and her balancing her work and home life alongside the pregnancy.</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Emphasize importance of speaking with Leila and understanding her </a:t>
            </a:r>
            <a:r>
              <a:rPr lang="en"/>
              <a:t>cultural</a:t>
            </a:r>
            <a:r>
              <a:rPr lang="en"/>
              <a:t> background and beliefs: “A lack of cultural responsiveness among providers may also prevent SAs in the U.S. from utilizing health services, particularly for mental health issues.” </a:t>
            </a:r>
            <a:r>
              <a:rPr lang="en">
                <a:solidFill>
                  <a:schemeClr val="dk1"/>
                </a:solidFill>
              </a:rPr>
              <a:t>(</a:t>
            </a:r>
            <a:r>
              <a:rPr lang="en" u="sng">
                <a:solidFill>
                  <a:schemeClr val="hlink"/>
                </a:solidFill>
                <a:hlinkClick r:id="rId2"/>
              </a:rPr>
              <a:t>https://www.ncbi.nlm.nih.gov/pmc/articles/PMC5643212/</a:t>
            </a:r>
            <a:r>
              <a:rPr lang="en">
                <a:solidFill>
                  <a:schemeClr val="dk1"/>
                </a:solidFill>
              </a:rPr>
              <a:t>)</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5" name="Shape 245"/>
        <p:cNvGrpSpPr/>
        <p:nvPr/>
      </p:nvGrpSpPr>
      <p:grpSpPr>
        <a:xfrm>
          <a:off x="0" y="0"/>
          <a:ext cx="0" cy="0"/>
          <a:chOff x="0" y="0"/>
          <a:chExt cx="0" cy="0"/>
        </a:xfrm>
      </p:grpSpPr>
      <p:sp>
        <p:nvSpPr>
          <p:cNvPr id="246" name="Google Shape;246;g2ee9f1955fe_0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7" name="Google Shape;247;g2ee9f1955fe_0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18" name="Shape 718"/>
        <p:cNvGrpSpPr/>
        <p:nvPr/>
      </p:nvGrpSpPr>
      <p:grpSpPr>
        <a:xfrm>
          <a:off x="0" y="0"/>
          <a:ext cx="0" cy="0"/>
          <a:chOff x="0" y="0"/>
          <a:chExt cx="0" cy="0"/>
        </a:xfrm>
      </p:grpSpPr>
      <p:sp>
        <p:nvSpPr>
          <p:cNvPr id="719" name="Google Shape;719;g2dfc5df97ce_1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20" name="Google Shape;720;g2dfc5df97ce_1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24" name="Shape 724"/>
        <p:cNvGrpSpPr/>
        <p:nvPr/>
      </p:nvGrpSpPr>
      <p:grpSpPr>
        <a:xfrm>
          <a:off x="0" y="0"/>
          <a:ext cx="0" cy="0"/>
          <a:chOff x="0" y="0"/>
          <a:chExt cx="0" cy="0"/>
        </a:xfrm>
      </p:grpSpPr>
      <p:sp>
        <p:nvSpPr>
          <p:cNvPr id="725" name="Google Shape;725;g2e0451e9b9d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26" name="Google Shape;726;g2e0451e9b9d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Asian Americans have been found to have a longer duration of untreated psychosis than other ethnic groups, and their families have less favorable help-seeking attitudes than their White counterparts. (</a:t>
            </a:r>
            <a:r>
              <a:rPr lang="en" u="sng">
                <a:solidFill>
                  <a:schemeClr val="hlink"/>
                </a:solidFill>
                <a:hlinkClick r:id="rId2"/>
              </a:rPr>
              <a:t>https://www.ncbi.nlm.nih.gov/pmc/articles/PMC3705710/</a:t>
            </a:r>
            <a:r>
              <a:rPr lang="en"/>
              <a:t>)</a:t>
            </a:r>
            <a:endParaRPr/>
          </a:p>
          <a:p>
            <a:pPr indent="0" lvl="0" marL="0" rtl="0" algn="l">
              <a:spcBef>
                <a:spcPts val="0"/>
              </a:spcBef>
              <a:spcAft>
                <a:spcPts val="0"/>
              </a:spcAft>
              <a:buNone/>
            </a:pPr>
            <a:r>
              <a:t/>
            </a: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31" name="Shape 731"/>
        <p:cNvGrpSpPr/>
        <p:nvPr/>
      </p:nvGrpSpPr>
      <p:grpSpPr>
        <a:xfrm>
          <a:off x="0" y="0"/>
          <a:ext cx="0" cy="0"/>
          <a:chOff x="0" y="0"/>
          <a:chExt cx="0" cy="0"/>
        </a:xfrm>
      </p:grpSpPr>
      <p:sp>
        <p:nvSpPr>
          <p:cNvPr id="732" name="Google Shape;732;g2e0d8931947_8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33" name="Google Shape;733;g2e0d8931947_8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Stigma  </a:t>
            </a:r>
            <a:r>
              <a:rPr lang="en"/>
              <a:t>patients</a:t>
            </a:r>
            <a:r>
              <a:rPr lang="en"/>
              <a:t> with schizophrenia may occasionally act in ways that disrupt the social order and/or social harmony, which are considered serious transgressions of social norms. The community approach to mental illness therefore has been primarily focused on control and secondarily on treatment (</a:t>
            </a:r>
            <a:r>
              <a:rPr lang="en" u="sng">
                <a:solidFill>
                  <a:schemeClr val="hlink"/>
                </a:solidFill>
                <a:hlinkClick r:id="rId2"/>
              </a:rPr>
              <a:t>https://www.ncbi.nlm.nih.gov/pmc/articles/PMC3181649/#:~:text=The%20experience%20of%20schizophrenia%20in%20China&amp;text=Traditionally%2C%20family%20members%20in%20China,family%2C%20not%20of%20the%20individual</a:t>
            </a:r>
            <a:r>
              <a:rPr lang="en"/>
              <a:t>.)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Behavioral rather than biological problem  one study in Suzhou and Siping found that “245 family members of 135 schizophrenic patients attributed 84% of the cause of schizophrenia to social, interpersonal, and </a:t>
            </a:r>
            <a:r>
              <a:rPr lang="en"/>
              <a:t>psychological</a:t>
            </a:r>
            <a:r>
              <a:rPr lang="en"/>
              <a:t> problems; even when prompted, none of the respondents considered schizophrenia a ‘disease of the brain’” (</a:t>
            </a:r>
            <a:r>
              <a:rPr lang="en" u="sng">
                <a:solidFill>
                  <a:schemeClr val="hlink"/>
                </a:solidFill>
                <a:hlinkClick r:id="rId3"/>
              </a:rPr>
              <a:t>https://pubmed.ncbi.nlm.nih.gov/10945083/</a:t>
            </a:r>
            <a:r>
              <a:rPr lang="en"/>
              <a:t>)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Decision making  for schizophrenia, the decision of when and where to seek care lies primarily with the </a:t>
            </a:r>
            <a:r>
              <a:rPr lang="en"/>
              <a:t>family rather than the individual (</a:t>
            </a:r>
            <a:r>
              <a:rPr lang="en" u="sng">
                <a:solidFill>
                  <a:schemeClr val="hlink"/>
                </a:solidFill>
                <a:hlinkClick r:id="rId4"/>
              </a:rPr>
              <a:t>https://www.ncbi.nlm.nih.gov/pmc/articles/PMC3181649/#:~:text=The%20experience%20of%20schizophrenia%20in%20China&amp;text=Traditionally%2C%20family%20members%20in%20China,family%2C%20not%20of%20the%20individual</a:t>
            </a:r>
            <a:r>
              <a:rPr lang="en"/>
              <a:t>) </a:t>
            </a: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39" name="Shape 739"/>
        <p:cNvGrpSpPr/>
        <p:nvPr/>
      </p:nvGrpSpPr>
      <p:grpSpPr>
        <a:xfrm>
          <a:off x="0" y="0"/>
          <a:ext cx="0" cy="0"/>
          <a:chOff x="0" y="0"/>
          <a:chExt cx="0" cy="0"/>
        </a:xfrm>
      </p:grpSpPr>
      <p:sp>
        <p:nvSpPr>
          <p:cNvPr id="740" name="Google Shape;740;g2e0d8931947_8_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41" name="Google Shape;741;g2e0d8931947_8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The big takeaway is to be </a:t>
            </a:r>
            <a:r>
              <a:rPr b="1" lang="en"/>
              <a:t>non-judgemental</a:t>
            </a:r>
            <a:r>
              <a:rPr lang="en"/>
              <a:t> and ask </a:t>
            </a:r>
            <a:r>
              <a:rPr lang="en"/>
              <a:t>questions</a:t>
            </a:r>
            <a:r>
              <a:rPr lang="en"/>
              <a:t> to further understand their beliefs and where they are coming from.</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In Asian culture, seeking mental health services is often regarded as a violation of Asian family hierarchy as it indicates family inadequacy (Sue, 1994) and a loss of ‘face.’” </a:t>
            </a: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46" name="Shape 746"/>
        <p:cNvGrpSpPr/>
        <p:nvPr/>
      </p:nvGrpSpPr>
      <p:grpSpPr>
        <a:xfrm>
          <a:off x="0" y="0"/>
          <a:ext cx="0" cy="0"/>
          <a:chOff x="0" y="0"/>
          <a:chExt cx="0" cy="0"/>
        </a:xfrm>
      </p:grpSpPr>
      <p:sp>
        <p:nvSpPr>
          <p:cNvPr id="747" name="Google Shape;747;g2e0fdb17696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48" name="Google Shape;748;g2e0fdb17696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This is tricky because from a cultural perspective, his parents likely believe that decisions regarding treatment and hospitalization are theirs to make, while </a:t>
            </a:r>
            <a:r>
              <a:rPr lang="en"/>
              <a:t>Michael</a:t>
            </a:r>
            <a:r>
              <a:rPr lang="en"/>
              <a:t> may feel differently as he has grown up in the U.S. While your responsibility is to your patient, it is important to try to come to a consensus that the family feels comfortable with as well. </a:t>
            </a: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53" name="Shape 753"/>
        <p:cNvGrpSpPr/>
        <p:nvPr/>
      </p:nvGrpSpPr>
      <p:grpSpPr>
        <a:xfrm>
          <a:off x="0" y="0"/>
          <a:ext cx="0" cy="0"/>
          <a:chOff x="0" y="0"/>
          <a:chExt cx="0" cy="0"/>
        </a:xfrm>
      </p:grpSpPr>
      <p:sp>
        <p:nvSpPr>
          <p:cNvPr id="754" name="Google Shape;754;g2e0fdb17696_0_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55" name="Google Shape;755;g2e0fdb17696_0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60" name="Shape 760"/>
        <p:cNvGrpSpPr/>
        <p:nvPr/>
      </p:nvGrpSpPr>
      <p:grpSpPr>
        <a:xfrm>
          <a:off x="0" y="0"/>
          <a:ext cx="0" cy="0"/>
          <a:chOff x="0" y="0"/>
          <a:chExt cx="0" cy="0"/>
        </a:xfrm>
      </p:grpSpPr>
      <p:sp>
        <p:nvSpPr>
          <p:cNvPr id="761" name="Google Shape;761;g2e743085dfc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62" name="Google Shape;762;g2e743085dfc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67" name="Shape 767"/>
        <p:cNvGrpSpPr/>
        <p:nvPr/>
      </p:nvGrpSpPr>
      <p:grpSpPr>
        <a:xfrm>
          <a:off x="0" y="0"/>
          <a:ext cx="0" cy="0"/>
          <a:chOff x="0" y="0"/>
          <a:chExt cx="0" cy="0"/>
        </a:xfrm>
      </p:grpSpPr>
      <p:sp>
        <p:nvSpPr>
          <p:cNvPr id="768" name="Google Shape;768;g2e743085dfc_0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69" name="Google Shape;769;g2e743085dfc_0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73" name="Shape 773"/>
        <p:cNvGrpSpPr/>
        <p:nvPr/>
      </p:nvGrpSpPr>
      <p:grpSpPr>
        <a:xfrm>
          <a:off x="0" y="0"/>
          <a:ext cx="0" cy="0"/>
          <a:chOff x="0" y="0"/>
          <a:chExt cx="0" cy="0"/>
        </a:xfrm>
      </p:grpSpPr>
      <p:sp>
        <p:nvSpPr>
          <p:cNvPr id="774" name="Google Shape;774;g2e128b68758_0_121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75" name="Google Shape;775;g2e128b68758_0_121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2" name="Shape 252"/>
        <p:cNvGrpSpPr/>
        <p:nvPr/>
      </p:nvGrpSpPr>
      <p:grpSpPr>
        <a:xfrm>
          <a:off x="0" y="0"/>
          <a:ext cx="0" cy="0"/>
          <a:chOff x="0" y="0"/>
          <a:chExt cx="0" cy="0"/>
        </a:xfrm>
      </p:grpSpPr>
      <p:sp>
        <p:nvSpPr>
          <p:cNvPr id="253" name="Google Shape;253;g2e112c9385f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54" name="Google Shape;254;g2e112c9385f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Source: </a:t>
            </a:r>
            <a:r>
              <a:rPr lang="en" u="sng">
                <a:solidFill>
                  <a:schemeClr val="hlink"/>
                </a:solidFill>
                <a:hlinkClick r:id="rId2"/>
              </a:rPr>
              <a:t>https://www.who.int/newsroom/factsheets/detail/mentalhealthstrengtheningourresponse</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Facilitator guide: Read over the points above and establish the importance of mental health. (It’s a basic human right!)</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9" name="Shape 259"/>
        <p:cNvGrpSpPr/>
        <p:nvPr/>
      </p:nvGrpSpPr>
      <p:grpSpPr>
        <a:xfrm>
          <a:off x="0" y="0"/>
          <a:ext cx="0" cy="0"/>
          <a:chOff x="0" y="0"/>
          <a:chExt cx="0" cy="0"/>
        </a:xfrm>
      </p:grpSpPr>
      <p:sp>
        <p:nvSpPr>
          <p:cNvPr id="260" name="Google Shape;260;g2e0f5c72b50_2_7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61" name="Google Shape;261;g2e0f5c72b50_2_7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Source: </a:t>
            </a:r>
            <a:r>
              <a:rPr lang="en" u="sng">
                <a:solidFill>
                  <a:schemeClr val="hlink"/>
                </a:solidFill>
                <a:hlinkClick r:id="rId2"/>
              </a:rPr>
              <a:t>https://pubmed.ncbi.nlm.nih.gov/35320122/</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Facilitator guide: read the quote and emphasize the need for medical schools and the healthcare system to focus on AANHPI specific care</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6" name="Shape 266"/>
        <p:cNvGrpSpPr/>
        <p:nvPr/>
      </p:nvGrpSpPr>
      <p:grpSpPr>
        <a:xfrm>
          <a:off x="0" y="0"/>
          <a:ext cx="0" cy="0"/>
          <a:chOff x="0" y="0"/>
          <a:chExt cx="0" cy="0"/>
        </a:xfrm>
      </p:grpSpPr>
      <p:sp>
        <p:nvSpPr>
          <p:cNvPr id="267" name="Google Shape;267;g2e0f5c72b50_0_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68" name="Google Shape;268;g2e0f5c72b50_0_1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Source for 1: </a:t>
            </a:r>
            <a:r>
              <a:rPr lang="en" u="sng">
                <a:solidFill>
                  <a:schemeClr val="hlink"/>
                </a:solidFill>
                <a:hlinkClick r:id="rId2"/>
              </a:rPr>
              <a:t>https://ajph.aphapublications.org/doi/full/10.2105/AJPH.93.12.2093</a:t>
            </a:r>
            <a:endParaRPr/>
          </a:p>
          <a:p>
            <a:pPr indent="0" lvl="0" marL="0" rtl="0" algn="l">
              <a:spcBef>
                <a:spcPts val="0"/>
              </a:spcBef>
              <a:spcAft>
                <a:spcPts val="0"/>
              </a:spcAft>
              <a:buNone/>
            </a:pPr>
            <a:r>
              <a:rPr lang="en"/>
              <a:t>Facilitator Guide: First focus on AANHPI populations being incredibly understudied in medical education, then pivot the discussion to specifically mental health scholarship with AANHPI populations</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4" name="Shape 274"/>
        <p:cNvGrpSpPr/>
        <p:nvPr/>
      </p:nvGrpSpPr>
      <p:grpSpPr>
        <a:xfrm>
          <a:off x="0" y="0"/>
          <a:ext cx="0" cy="0"/>
          <a:chOff x="0" y="0"/>
          <a:chExt cx="0" cy="0"/>
        </a:xfrm>
      </p:grpSpPr>
      <p:sp>
        <p:nvSpPr>
          <p:cNvPr id="275" name="Google Shape;275;g2e128b68758_4_1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76" name="Google Shape;276;g2e128b68758_4_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0" name="Shape 280"/>
        <p:cNvGrpSpPr/>
        <p:nvPr/>
      </p:nvGrpSpPr>
      <p:grpSpPr>
        <a:xfrm>
          <a:off x="0" y="0"/>
          <a:ext cx="0" cy="0"/>
          <a:chOff x="0" y="0"/>
          <a:chExt cx="0" cy="0"/>
        </a:xfrm>
      </p:grpSpPr>
      <p:sp>
        <p:nvSpPr>
          <p:cNvPr id="281" name="Google Shape;281;g2ee9f1955fe_0_1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82" name="Google Shape;282;g2ee9f1955fe_0_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hyperlink" Target="http://bit.ly/2Tynxth" TargetMode="External"/><Relationship Id="rId3" Type="http://schemas.openxmlformats.org/officeDocument/2006/relationships/hyperlink" Target="http://bit.ly/2TyoMsr" TargetMode="External"/><Relationship Id="rId4" Type="http://schemas.openxmlformats.org/officeDocument/2006/relationships/hyperlink" Target="http://bit.ly/2TtBDfr" TargetMode="Externa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1">
  <p:cSld name="TITLE_AND_TWO_COLUMNS_1">
    <p:spTree>
      <p:nvGrpSpPr>
        <p:cNvPr id="50" name="Shape 50"/>
        <p:cNvGrpSpPr/>
        <p:nvPr/>
      </p:nvGrpSpPr>
      <p:grpSpPr>
        <a:xfrm>
          <a:off x="0" y="0"/>
          <a:ext cx="0" cy="0"/>
          <a:chOff x="0" y="0"/>
          <a:chExt cx="0" cy="0"/>
        </a:xfrm>
      </p:grpSpPr>
      <p:sp>
        <p:nvSpPr>
          <p:cNvPr id="51" name="Google Shape;51;p13"/>
          <p:cNvSpPr txBox="1"/>
          <p:nvPr>
            <p:ph type="title"/>
          </p:nvPr>
        </p:nvSpPr>
        <p:spPr>
          <a:xfrm>
            <a:off x="720000" y="445025"/>
            <a:ext cx="7704000" cy="572700"/>
          </a:xfrm>
          <a:prstGeom prst="rect">
            <a:avLst/>
          </a:prstGeom>
        </p:spPr>
        <p:txBody>
          <a:bodyPr anchorCtr="0" anchor="t" bIns="91425" lIns="91425" spcFirstLastPara="1" rIns="91425" wrap="square" tIns="91425">
            <a:normAutofit/>
          </a:bodyPr>
          <a:lstStyle>
            <a:lvl1pPr lvl="0" algn="ctr">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52" name="Google Shape;52;p13"/>
          <p:cNvSpPr txBox="1"/>
          <p:nvPr>
            <p:ph idx="2" type="title"/>
          </p:nvPr>
        </p:nvSpPr>
        <p:spPr>
          <a:xfrm>
            <a:off x="1784025" y="2798625"/>
            <a:ext cx="2585100" cy="476100"/>
          </a:xfrm>
          <a:prstGeom prst="rect">
            <a:avLst/>
          </a:prstGeom>
        </p:spPr>
        <p:txBody>
          <a:bodyPr anchorCtr="0" anchor="t" bIns="91425" lIns="91425" spcFirstLastPara="1" rIns="91425" wrap="square" tIns="91425">
            <a:normAutofit/>
          </a:bodyPr>
          <a:lstStyle>
            <a:lvl1pPr lvl="0" algn="ctr">
              <a:spcBef>
                <a:spcPts val="0"/>
              </a:spcBef>
              <a:spcAft>
                <a:spcPts val="0"/>
              </a:spcAft>
              <a:buSzPts val="2800"/>
              <a:buNone/>
              <a:defRPr sz="2000">
                <a:solidFill>
                  <a:schemeClr val="accent1"/>
                </a:solidFill>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53" name="Google Shape;53;p13"/>
          <p:cNvSpPr txBox="1"/>
          <p:nvPr>
            <p:ph idx="3" type="title"/>
          </p:nvPr>
        </p:nvSpPr>
        <p:spPr>
          <a:xfrm>
            <a:off x="4774325" y="2798625"/>
            <a:ext cx="2585700" cy="476100"/>
          </a:xfrm>
          <a:prstGeom prst="rect">
            <a:avLst/>
          </a:prstGeom>
        </p:spPr>
        <p:txBody>
          <a:bodyPr anchorCtr="0" anchor="t" bIns="91425" lIns="91425" spcFirstLastPara="1" rIns="91425" wrap="square" tIns="91425">
            <a:normAutofit/>
          </a:bodyPr>
          <a:lstStyle>
            <a:lvl1pPr lvl="0" algn="ctr">
              <a:spcBef>
                <a:spcPts val="0"/>
              </a:spcBef>
              <a:spcAft>
                <a:spcPts val="0"/>
              </a:spcAft>
              <a:buSzPts val="2800"/>
              <a:buNone/>
              <a:defRPr sz="2000">
                <a:solidFill>
                  <a:schemeClr val="accent1"/>
                </a:solidFill>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54" name="Google Shape;54;p13"/>
          <p:cNvSpPr txBox="1"/>
          <p:nvPr>
            <p:ph idx="1" type="subTitle"/>
          </p:nvPr>
        </p:nvSpPr>
        <p:spPr>
          <a:xfrm>
            <a:off x="4774332" y="3279049"/>
            <a:ext cx="2585700" cy="1046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b="0" sz="14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55" name="Google Shape;55;p13"/>
          <p:cNvSpPr txBox="1"/>
          <p:nvPr>
            <p:ph idx="4" type="subTitle"/>
          </p:nvPr>
        </p:nvSpPr>
        <p:spPr>
          <a:xfrm>
            <a:off x="1784200" y="3279049"/>
            <a:ext cx="2585100" cy="1046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b="0" sz="14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grpSp>
        <p:nvGrpSpPr>
          <p:cNvPr id="56" name="Google Shape;56;p13"/>
          <p:cNvGrpSpPr/>
          <p:nvPr/>
        </p:nvGrpSpPr>
        <p:grpSpPr>
          <a:xfrm flipH="1" rot="-1707809">
            <a:off x="-565970" y="-611855"/>
            <a:ext cx="1340703" cy="1721669"/>
            <a:chOff x="2659350" y="1746500"/>
            <a:chExt cx="379350" cy="487125"/>
          </a:xfrm>
        </p:grpSpPr>
        <p:sp>
          <p:nvSpPr>
            <p:cNvPr id="57" name="Google Shape;57;p13"/>
            <p:cNvSpPr/>
            <p:nvPr/>
          </p:nvSpPr>
          <p:spPr>
            <a:xfrm>
              <a:off x="2659350" y="1746500"/>
              <a:ext cx="379350" cy="487125"/>
            </a:xfrm>
            <a:custGeom>
              <a:rect b="b" l="l" r="r" t="t"/>
              <a:pathLst>
                <a:path extrusionOk="0" h="19485" w="15174">
                  <a:moveTo>
                    <a:pt x="14116" y="1"/>
                  </a:moveTo>
                  <a:lnTo>
                    <a:pt x="14034" y="42"/>
                  </a:lnTo>
                  <a:lnTo>
                    <a:pt x="13261" y="774"/>
                  </a:lnTo>
                  <a:lnTo>
                    <a:pt x="12448" y="1465"/>
                  </a:lnTo>
                  <a:lnTo>
                    <a:pt x="11634" y="2116"/>
                  </a:lnTo>
                  <a:lnTo>
                    <a:pt x="10821" y="2767"/>
                  </a:lnTo>
                  <a:lnTo>
                    <a:pt x="9112" y="4028"/>
                  </a:lnTo>
                  <a:lnTo>
                    <a:pt x="7404" y="5248"/>
                  </a:lnTo>
                  <a:lnTo>
                    <a:pt x="5899" y="6428"/>
                  </a:lnTo>
                  <a:lnTo>
                    <a:pt x="5167" y="7079"/>
                  </a:lnTo>
                  <a:lnTo>
                    <a:pt x="4435" y="7729"/>
                  </a:lnTo>
                  <a:lnTo>
                    <a:pt x="3743" y="8380"/>
                  </a:lnTo>
                  <a:lnTo>
                    <a:pt x="3133" y="9072"/>
                  </a:lnTo>
                  <a:lnTo>
                    <a:pt x="2482" y="9844"/>
                  </a:lnTo>
                  <a:lnTo>
                    <a:pt x="1953" y="10617"/>
                  </a:lnTo>
                  <a:lnTo>
                    <a:pt x="1425" y="11390"/>
                  </a:lnTo>
                  <a:lnTo>
                    <a:pt x="1018" y="12204"/>
                  </a:lnTo>
                  <a:lnTo>
                    <a:pt x="652" y="13058"/>
                  </a:lnTo>
                  <a:lnTo>
                    <a:pt x="326" y="13912"/>
                  </a:lnTo>
                  <a:lnTo>
                    <a:pt x="123" y="14766"/>
                  </a:lnTo>
                  <a:lnTo>
                    <a:pt x="82" y="15173"/>
                  </a:lnTo>
                  <a:lnTo>
                    <a:pt x="42" y="15620"/>
                  </a:lnTo>
                  <a:lnTo>
                    <a:pt x="1" y="16068"/>
                  </a:lnTo>
                  <a:lnTo>
                    <a:pt x="42" y="16475"/>
                  </a:lnTo>
                  <a:lnTo>
                    <a:pt x="82" y="16922"/>
                  </a:lnTo>
                  <a:lnTo>
                    <a:pt x="164" y="17329"/>
                  </a:lnTo>
                  <a:lnTo>
                    <a:pt x="326" y="17736"/>
                  </a:lnTo>
                  <a:lnTo>
                    <a:pt x="489" y="18102"/>
                  </a:lnTo>
                  <a:lnTo>
                    <a:pt x="733" y="18468"/>
                  </a:lnTo>
                  <a:lnTo>
                    <a:pt x="977" y="18753"/>
                  </a:lnTo>
                  <a:lnTo>
                    <a:pt x="1303" y="18997"/>
                  </a:lnTo>
                  <a:lnTo>
                    <a:pt x="1669" y="19200"/>
                  </a:lnTo>
                  <a:lnTo>
                    <a:pt x="2035" y="19363"/>
                  </a:lnTo>
                  <a:lnTo>
                    <a:pt x="2442" y="19444"/>
                  </a:lnTo>
                  <a:lnTo>
                    <a:pt x="2930" y="19485"/>
                  </a:lnTo>
                  <a:lnTo>
                    <a:pt x="3418" y="19485"/>
                  </a:lnTo>
                  <a:lnTo>
                    <a:pt x="3906" y="19444"/>
                  </a:lnTo>
                  <a:lnTo>
                    <a:pt x="4394" y="19363"/>
                  </a:lnTo>
                  <a:lnTo>
                    <a:pt x="5370" y="19159"/>
                  </a:lnTo>
                  <a:lnTo>
                    <a:pt x="6306" y="18915"/>
                  </a:lnTo>
                  <a:lnTo>
                    <a:pt x="7323" y="18631"/>
                  </a:lnTo>
                  <a:lnTo>
                    <a:pt x="8340" y="18305"/>
                  </a:lnTo>
                  <a:lnTo>
                    <a:pt x="9356" y="17980"/>
                  </a:lnTo>
                  <a:lnTo>
                    <a:pt x="10333" y="17614"/>
                  </a:lnTo>
                  <a:lnTo>
                    <a:pt x="11309" y="17166"/>
                  </a:lnTo>
                  <a:lnTo>
                    <a:pt x="12285" y="16719"/>
                  </a:lnTo>
                  <a:lnTo>
                    <a:pt x="13221" y="16271"/>
                  </a:lnTo>
                  <a:lnTo>
                    <a:pt x="14156" y="15743"/>
                  </a:lnTo>
                  <a:lnTo>
                    <a:pt x="15051" y="15214"/>
                  </a:lnTo>
                  <a:lnTo>
                    <a:pt x="15132" y="15173"/>
                  </a:lnTo>
                  <a:lnTo>
                    <a:pt x="15173" y="15092"/>
                  </a:lnTo>
                  <a:lnTo>
                    <a:pt x="15173" y="15051"/>
                  </a:lnTo>
                  <a:lnTo>
                    <a:pt x="15132" y="14970"/>
                  </a:lnTo>
                  <a:lnTo>
                    <a:pt x="15092" y="14929"/>
                  </a:lnTo>
                  <a:lnTo>
                    <a:pt x="15010" y="14888"/>
                  </a:lnTo>
                  <a:lnTo>
                    <a:pt x="14888" y="14888"/>
                  </a:lnTo>
                  <a:lnTo>
                    <a:pt x="13994" y="15417"/>
                  </a:lnTo>
                  <a:lnTo>
                    <a:pt x="13099" y="15905"/>
                  </a:lnTo>
                  <a:lnTo>
                    <a:pt x="12163" y="16393"/>
                  </a:lnTo>
                  <a:lnTo>
                    <a:pt x="11228" y="16800"/>
                  </a:lnTo>
                  <a:lnTo>
                    <a:pt x="10292" y="17207"/>
                  </a:lnTo>
                  <a:lnTo>
                    <a:pt x="9316" y="17573"/>
                  </a:lnTo>
                  <a:lnTo>
                    <a:pt x="8340" y="17939"/>
                  </a:lnTo>
                  <a:lnTo>
                    <a:pt x="7363" y="18224"/>
                  </a:lnTo>
                  <a:lnTo>
                    <a:pt x="6387" y="18508"/>
                  </a:lnTo>
                  <a:lnTo>
                    <a:pt x="5452" y="18753"/>
                  </a:lnTo>
                  <a:lnTo>
                    <a:pt x="4475" y="18956"/>
                  </a:lnTo>
                  <a:lnTo>
                    <a:pt x="3987" y="19037"/>
                  </a:lnTo>
                  <a:lnTo>
                    <a:pt x="3499" y="19119"/>
                  </a:lnTo>
                  <a:lnTo>
                    <a:pt x="3052" y="19119"/>
                  </a:lnTo>
                  <a:lnTo>
                    <a:pt x="2604" y="19078"/>
                  </a:lnTo>
                  <a:lnTo>
                    <a:pt x="2157" y="18997"/>
                  </a:lnTo>
                  <a:lnTo>
                    <a:pt x="1750" y="18834"/>
                  </a:lnTo>
                  <a:lnTo>
                    <a:pt x="1425" y="18631"/>
                  </a:lnTo>
                  <a:lnTo>
                    <a:pt x="1140" y="18386"/>
                  </a:lnTo>
                  <a:lnTo>
                    <a:pt x="896" y="18061"/>
                  </a:lnTo>
                  <a:lnTo>
                    <a:pt x="692" y="17695"/>
                  </a:lnTo>
                  <a:lnTo>
                    <a:pt x="530" y="17329"/>
                  </a:lnTo>
                  <a:lnTo>
                    <a:pt x="448" y="16922"/>
                  </a:lnTo>
                  <a:lnTo>
                    <a:pt x="408" y="16475"/>
                  </a:lnTo>
                  <a:lnTo>
                    <a:pt x="367" y="16068"/>
                  </a:lnTo>
                  <a:lnTo>
                    <a:pt x="408" y="15661"/>
                  </a:lnTo>
                  <a:lnTo>
                    <a:pt x="448" y="15214"/>
                  </a:lnTo>
                  <a:lnTo>
                    <a:pt x="611" y="14400"/>
                  </a:lnTo>
                  <a:lnTo>
                    <a:pt x="855" y="13546"/>
                  </a:lnTo>
                  <a:lnTo>
                    <a:pt x="1181" y="12732"/>
                  </a:lnTo>
                  <a:lnTo>
                    <a:pt x="1587" y="11919"/>
                  </a:lnTo>
                  <a:lnTo>
                    <a:pt x="2035" y="11146"/>
                  </a:lnTo>
                  <a:lnTo>
                    <a:pt x="2564" y="10373"/>
                  </a:lnTo>
                  <a:lnTo>
                    <a:pt x="3133" y="9641"/>
                  </a:lnTo>
                  <a:lnTo>
                    <a:pt x="3743" y="8950"/>
                  </a:lnTo>
                  <a:lnTo>
                    <a:pt x="4394" y="8299"/>
                  </a:lnTo>
                  <a:lnTo>
                    <a:pt x="5045" y="7648"/>
                  </a:lnTo>
                  <a:lnTo>
                    <a:pt x="5736" y="7038"/>
                  </a:lnTo>
                  <a:lnTo>
                    <a:pt x="6468" y="6428"/>
                  </a:lnTo>
                  <a:lnTo>
                    <a:pt x="7201" y="5858"/>
                  </a:lnTo>
                  <a:lnTo>
                    <a:pt x="9031" y="4557"/>
                  </a:lnTo>
                  <a:lnTo>
                    <a:pt x="10821" y="3214"/>
                  </a:lnTo>
                  <a:lnTo>
                    <a:pt x="11756" y="2523"/>
                  </a:lnTo>
                  <a:lnTo>
                    <a:pt x="12611" y="1831"/>
                  </a:lnTo>
                  <a:lnTo>
                    <a:pt x="13465" y="1058"/>
                  </a:lnTo>
                  <a:lnTo>
                    <a:pt x="14278" y="286"/>
                  </a:lnTo>
                  <a:lnTo>
                    <a:pt x="14319" y="245"/>
                  </a:lnTo>
                  <a:lnTo>
                    <a:pt x="14360" y="164"/>
                  </a:lnTo>
                  <a:lnTo>
                    <a:pt x="14319" y="82"/>
                  </a:lnTo>
                  <a:lnTo>
                    <a:pt x="14278" y="42"/>
                  </a:lnTo>
                  <a:lnTo>
                    <a:pt x="14238"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58" name="Google Shape;58;p13"/>
            <p:cNvSpPr/>
            <p:nvPr/>
          </p:nvSpPr>
          <p:spPr>
            <a:xfrm>
              <a:off x="2701050" y="1843125"/>
              <a:ext cx="309175" cy="322375"/>
            </a:xfrm>
            <a:custGeom>
              <a:rect b="b" l="l" r="r" t="t"/>
              <a:pathLst>
                <a:path extrusionOk="0" h="12895" w="12367">
                  <a:moveTo>
                    <a:pt x="12163" y="0"/>
                  </a:moveTo>
                  <a:lnTo>
                    <a:pt x="12081" y="41"/>
                  </a:lnTo>
                  <a:lnTo>
                    <a:pt x="9600" y="1831"/>
                  </a:lnTo>
                  <a:lnTo>
                    <a:pt x="7160" y="3702"/>
                  </a:lnTo>
                  <a:lnTo>
                    <a:pt x="5939" y="4637"/>
                  </a:lnTo>
                  <a:lnTo>
                    <a:pt x="4760" y="5613"/>
                  </a:lnTo>
                  <a:lnTo>
                    <a:pt x="3580" y="6630"/>
                  </a:lnTo>
                  <a:lnTo>
                    <a:pt x="2441" y="7647"/>
                  </a:lnTo>
                  <a:lnTo>
                    <a:pt x="1872" y="8135"/>
                  </a:lnTo>
                  <a:lnTo>
                    <a:pt x="1343" y="8664"/>
                  </a:lnTo>
                  <a:lnTo>
                    <a:pt x="855" y="9193"/>
                  </a:lnTo>
                  <a:lnTo>
                    <a:pt x="611" y="9478"/>
                  </a:lnTo>
                  <a:lnTo>
                    <a:pt x="407" y="9762"/>
                  </a:lnTo>
                  <a:lnTo>
                    <a:pt x="285" y="10047"/>
                  </a:lnTo>
                  <a:lnTo>
                    <a:pt x="163" y="10332"/>
                  </a:lnTo>
                  <a:lnTo>
                    <a:pt x="82" y="10617"/>
                  </a:lnTo>
                  <a:lnTo>
                    <a:pt x="1" y="10901"/>
                  </a:lnTo>
                  <a:lnTo>
                    <a:pt x="1" y="11227"/>
                  </a:lnTo>
                  <a:lnTo>
                    <a:pt x="41" y="11511"/>
                  </a:lnTo>
                  <a:lnTo>
                    <a:pt x="123" y="11796"/>
                  </a:lnTo>
                  <a:lnTo>
                    <a:pt x="285" y="12081"/>
                  </a:lnTo>
                  <a:lnTo>
                    <a:pt x="448" y="12284"/>
                  </a:lnTo>
                  <a:lnTo>
                    <a:pt x="651" y="12488"/>
                  </a:lnTo>
                  <a:lnTo>
                    <a:pt x="896" y="12610"/>
                  </a:lnTo>
                  <a:lnTo>
                    <a:pt x="1140" y="12732"/>
                  </a:lnTo>
                  <a:lnTo>
                    <a:pt x="1384" y="12813"/>
                  </a:lnTo>
                  <a:lnTo>
                    <a:pt x="1668" y="12854"/>
                  </a:lnTo>
                  <a:lnTo>
                    <a:pt x="2238" y="12894"/>
                  </a:lnTo>
                  <a:lnTo>
                    <a:pt x="2929" y="12813"/>
                  </a:lnTo>
                  <a:lnTo>
                    <a:pt x="3621" y="12691"/>
                  </a:lnTo>
                  <a:lnTo>
                    <a:pt x="5004" y="12366"/>
                  </a:lnTo>
                  <a:lnTo>
                    <a:pt x="6712" y="11918"/>
                  </a:lnTo>
                  <a:lnTo>
                    <a:pt x="8380" y="11389"/>
                  </a:lnTo>
                  <a:lnTo>
                    <a:pt x="10048" y="10820"/>
                  </a:lnTo>
                  <a:lnTo>
                    <a:pt x="11715" y="10210"/>
                  </a:lnTo>
                  <a:lnTo>
                    <a:pt x="11756" y="10128"/>
                  </a:lnTo>
                  <a:lnTo>
                    <a:pt x="11797" y="10088"/>
                  </a:lnTo>
                  <a:lnTo>
                    <a:pt x="11837" y="9966"/>
                  </a:lnTo>
                  <a:lnTo>
                    <a:pt x="11797" y="9884"/>
                  </a:lnTo>
                  <a:lnTo>
                    <a:pt x="11756" y="9844"/>
                  </a:lnTo>
                  <a:lnTo>
                    <a:pt x="11675" y="9803"/>
                  </a:lnTo>
                  <a:lnTo>
                    <a:pt x="11593" y="9844"/>
                  </a:lnTo>
                  <a:lnTo>
                    <a:pt x="10210" y="10373"/>
                  </a:lnTo>
                  <a:lnTo>
                    <a:pt x="8827" y="10861"/>
                  </a:lnTo>
                  <a:lnTo>
                    <a:pt x="7444" y="11308"/>
                  </a:lnTo>
                  <a:lnTo>
                    <a:pt x="6021" y="11715"/>
                  </a:lnTo>
                  <a:lnTo>
                    <a:pt x="4597" y="12081"/>
                  </a:lnTo>
                  <a:lnTo>
                    <a:pt x="3173" y="12366"/>
                  </a:lnTo>
                  <a:lnTo>
                    <a:pt x="2604" y="12488"/>
                  </a:lnTo>
                  <a:lnTo>
                    <a:pt x="2034" y="12528"/>
                  </a:lnTo>
                  <a:lnTo>
                    <a:pt x="1709" y="12488"/>
                  </a:lnTo>
                  <a:lnTo>
                    <a:pt x="1424" y="12447"/>
                  </a:lnTo>
                  <a:lnTo>
                    <a:pt x="1180" y="12366"/>
                  </a:lnTo>
                  <a:lnTo>
                    <a:pt x="936" y="12244"/>
                  </a:lnTo>
                  <a:lnTo>
                    <a:pt x="692" y="12040"/>
                  </a:lnTo>
                  <a:lnTo>
                    <a:pt x="529" y="11796"/>
                  </a:lnTo>
                  <a:lnTo>
                    <a:pt x="448" y="11511"/>
                  </a:lnTo>
                  <a:lnTo>
                    <a:pt x="407" y="11227"/>
                  </a:lnTo>
                  <a:lnTo>
                    <a:pt x="407" y="10942"/>
                  </a:lnTo>
                  <a:lnTo>
                    <a:pt x="448" y="10657"/>
                  </a:lnTo>
                  <a:lnTo>
                    <a:pt x="529" y="10373"/>
                  </a:lnTo>
                  <a:lnTo>
                    <a:pt x="651" y="10088"/>
                  </a:lnTo>
                  <a:lnTo>
                    <a:pt x="855" y="9803"/>
                  </a:lnTo>
                  <a:lnTo>
                    <a:pt x="1058" y="9518"/>
                  </a:lnTo>
                  <a:lnTo>
                    <a:pt x="1546" y="8990"/>
                  </a:lnTo>
                  <a:lnTo>
                    <a:pt x="2034" y="8501"/>
                  </a:lnTo>
                  <a:lnTo>
                    <a:pt x="2563" y="8013"/>
                  </a:lnTo>
                  <a:lnTo>
                    <a:pt x="3621" y="7037"/>
                  </a:lnTo>
                  <a:lnTo>
                    <a:pt x="4719" y="6102"/>
                  </a:lnTo>
                  <a:lnTo>
                    <a:pt x="5858" y="5207"/>
                  </a:lnTo>
                  <a:lnTo>
                    <a:pt x="6956" y="4271"/>
                  </a:lnTo>
                  <a:lnTo>
                    <a:pt x="8299" y="3295"/>
                  </a:lnTo>
                  <a:lnTo>
                    <a:pt x="9600" y="2278"/>
                  </a:lnTo>
                  <a:lnTo>
                    <a:pt x="12285" y="366"/>
                  </a:lnTo>
                  <a:lnTo>
                    <a:pt x="12326" y="285"/>
                  </a:lnTo>
                  <a:lnTo>
                    <a:pt x="12366" y="203"/>
                  </a:lnTo>
                  <a:lnTo>
                    <a:pt x="12326" y="81"/>
                  </a:lnTo>
                  <a:lnTo>
                    <a:pt x="12285" y="41"/>
                  </a:lnTo>
                  <a:lnTo>
                    <a:pt x="1224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59" name="Google Shape;59;p13"/>
            <p:cNvSpPr/>
            <p:nvPr/>
          </p:nvSpPr>
          <p:spPr>
            <a:xfrm>
              <a:off x="2756975" y="1978375"/>
              <a:ext cx="183075" cy="133225"/>
            </a:xfrm>
            <a:custGeom>
              <a:rect b="b" l="l" r="r" t="t"/>
              <a:pathLst>
                <a:path extrusionOk="0" h="5329" w="7323">
                  <a:moveTo>
                    <a:pt x="5980" y="366"/>
                  </a:moveTo>
                  <a:lnTo>
                    <a:pt x="6306" y="407"/>
                  </a:lnTo>
                  <a:lnTo>
                    <a:pt x="6428" y="407"/>
                  </a:lnTo>
                  <a:lnTo>
                    <a:pt x="6550" y="488"/>
                  </a:lnTo>
                  <a:lnTo>
                    <a:pt x="6672" y="569"/>
                  </a:lnTo>
                  <a:lnTo>
                    <a:pt x="6753" y="651"/>
                  </a:lnTo>
                  <a:lnTo>
                    <a:pt x="6834" y="814"/>
                  </a:lnTo>
                  <a:lnTo>
                    <a:pt x="6875" y="936"/>
                  </a:lnTo>
                  <a:lnTo>
                    <a:pt x="6956" y="1302"/>
                  </a:lnTo>
                  <a:lnTo>
                    <a:pt x="6916" y="1586"/>
                  </a:lnTo>
                  <a:lnTo>
                    <a:pt x="6834" y="1912"/>
                  </a:lnTo>
                  <a:lnTo>
                    <a:pt x="6672" y="2197"/>
                  </a:lnTo>
                  <a:lnTo>
                    <a:pt x="6468" y="2522"/>
                  </a:lnTo>
                  <a:lnTo>
                    <a:pt x="6184" y="2766"/>
                  </a:lnTo>
                  <a:lnTo>
                    <a:pt x="5858" y="3010"/>
                  </a:lnTo>
                  <a:lnTo>
                    <a:pt x="5533" y="3213"/>
                  </a:lnTo>
                  <a:lnTo>
                    <a:pt x="4841" y="3580"/>
                  </a:lnTo>
                  <a:lnTo>
                    <a:pt x="4109" y="3864"/>
                  </a:lnTo>
                  <a:lnTo>
                    <a:pt x="3092" y="4271"/>
                  </a:lnTo>
                  <a:lnTo>
                    <a:pt x="2075" y="4637"/>
                  </a:lnTo>
                  <a:lnTo>
                    <a:pt x="1709" y="4800"/>
                  </a:lnTo>
                  <a:lnTo>
                    <a:pt x="1180" y="4963"/>
                  </a:lnTo>
                  <a:lnTo>
                    <a:pt x="692" y="4963"/>
                  </a:lnTo>
                  <a:lnTo>
                    <a:pt x="530" y="4881"/>
                  </a:lnTo>
                  <a:lnTo>
                    <a:pt x="448" y="4840"/>
                  </a:lnTo>
                  <a:lnTo>
                    <a:pt x="408" y="4759"/>
                  </a:lnTo>
                  <a:lnTo>
                    <a:pt x="367" y="4637"/>
                  </a:lnTo>
                  <a:lnTo>
                    <a:pt x="367" y="4515"/>
                  </a:lnTo>
                  <a:lnTo>
                    <a:pt x="448" y="4312"/>
                  </a:lnTo>
                  <a:lnTo>
                    <a:pt x="570" y="4108"/>
                  </a:lnTo>
                  <a:lnTo>
                    <a:pt x="733" y="3946"/>
                  </a:lnTo>
                  <a:lnTo>
                    <a:pt x="1384" y="3335"/>
                  </a:lnTo>
                  <a:lnTo>
                    <a:pt x="2075" y="2685"/>
                  </a:lnTo>
                  <a:lnTo>
                    <a:pt x="2848" y="2034"/>
                  </a:lnTo>
                  <a:lnTo>
                    <a:pt x="3621" y="1424"/>
                  </a:lnTo>
                  <a:lnTo>
                    <a:pt x="4068" y="1180"/>
                  </a:lnTo>
                  <a:lnTo>
                    <a:pt x="4475" y="936"/>
                  </a:lnTo>
                  <a:lnTo>
                    <a:pt x="4841" y="732"/>
                  </a:lnTo>
                  <a:lnTo>
                    <a:pt x="5207" y="569"/>
                  </a:lnTo>
                  <a:lnTo>
                    <a:pt x="5614" y="447"/>
                  </a:lnTo>
                  <a:lnTo>
                    <a:pt x="5980" y="366"/>
                  </a:lnTo>
                  <a:close/>
                  <a:moveTo>
                    <a:pt x="6021" y="0"/>
                  </a:moveTo>
                  <a:lnTo>
                    <a:pt x="5614" y="81"/>
                  </a:lnTo>
                  <a:lnTo>
                    <a:pt x="5207" y="203"/>
                  </a:lnTo>
                  <a:lnTo>
                    <a:pt x="4841" y="366"/>
                  </a:lnTo>
                  <a:lnTo>
                    <a:pt x="4353" y="569"/>
                  </a:lnTo>
                  <a:lnTo>
                    <a:pt x="3865" y="854"/>
                  </a:lnTo>
                  <a:lnTo>
                    <a:pt x="3377" y="1180"/>
                  </a:lnTo>
                  <a:lnTo>
                    <a:pt x="2930" y="1505"/>
                  </a:lnTo>
                  <a:lnTo>
                    <a:pt x="2035" y="2237"/>
                  </a:lnTo>
                  <a:lnTo>
                    <a:pt x="1180" y="2969"/>
                  </a:lnTo>
                  <a:lnTo>
                    <a:pt x="814" y="3295"/>
                  </a:lnTo>
                  <a:lnTo>
                    <a:pt x="448" y="3702"/>
                  </a:lnTo>
                  <a:lnTo>
                    <a:pt x="245" y="3905"/>
                  </a:lnTo>
                  <a:lnTo>
                    <a:pt x="123" y="4108"/>
                  </a:lnTo>
                  <a:lnTo>
                    <a:pt x="42" y="4352"/>
                  </a:lnTo>
                  <a:lnTo>
                    <a:pt x="1" y="4596"/>
                  </a:lnTo>
                  <a:lnTo>
                    <a:pt x="42" y="4840"/>
                  </a:lnTo>
                  <a:lnTo>
                    <a:pt x="164" y="5044"/>
                  </a:lnTo>
                  <a:lnTo>
                    <a:pt x="326" y="5207"/>
                  </a:lnTo>
                  <a:lnTo>
                    <a:pt x="530" y="5288"/>
                  </a:lnTo>
                  <a:lnTo>
                    <a:pt x="774" y="5329"/>
                  </a:lnTo>
                  <a:lnTo>
                    <a:pt x="1018" y="5329"/>
                  </a:lnTo>
                  <a:lnTo>
                    <a:pt x="1262" y="5288"/>
                  </a:lnTo>
                  <a:lnTo>
                    <a:pt x="1465" y="5247"/>
                  </a:lnTo>
                  <a:lnTo>
                    <a:pt x="2157" y="5003"/>
                  </a:lnTo>
                  <a:lnTo>
                    <a:pt x="2848" y="4759"/>
                  </a:lnTo>
                  <a:lnTo>
                    <a:pt x="4139" y="4266"/>
                  </a:lnTo>
                  <a:lnTo>
                    <a:pt x="4139" y="4266"/>
                  </a:lnTo>
                  <a:lnTo>
                    <a:pt x="4150" y="4271"/>
                  </a:lnTo>
                  <a:lnTo>
                    <a:pt x="4231" y="4230"/>
                  </a:lnTo>
                  <a:lnTo>
                    <a:pt x="4963" y="3905"/>
                  </a:lnTo>
                  <a:lnTo>
                    <a:pt x="5696" y="3539"/>
                  </a:lnTo>
                  <a:lnTo>
                    <a:pt x="6021" y="3335"/>
                  </a:lnTo>
                  <a:lnTo>
                    <a:pt x="6346" y="3091"/>
                  </a:lnTo>
                  <a:lnTo>
                    <a:pt x="6672" y="2847"/>
                  </a:lnTo>
                  <a:lnTo>
                    <a:pt x="6916" y="2522"/>
                  </a:lnTo>
                  <a:lnTo>
                    <a:pt x="7119" y="2197"/>
                  </a:lnTo>
                  <a:lnTo>
                    <a:pt x="7241" y="1871"/>
                  </a:lnTo>
                  <a:lnTo>
                    <a:pt x="7323" y="1505"/>
                  </a:lnTo>
                  <a:lnTo>
                    <a:pt x="7323" y="1098"/>
                  </a:lnTo>
                  <a:lnTo>
                    <a:pt x="7201" y="732"/>
                  </a:lnTo>
                  <a:lnTo>
                    <a:pt x="7119" y="569"/>
                  </a:lnTo>
                  <a:lnTo>
                    <a:pt x="7038" y="407"/>
                  </a:lnTo>
                  <a:lnTo>
                    <a:pt x="6916" y="285"/>
                  </a:lnTo>
                  <a:lnTo>
                    <a:pt x="6794" y="163"/>
                  </a:lnTo>
                  <a:lnTo>
                    <a:pt x="6631" y="81"/>
                  </a:lnTo>
                  <a:lnTo>
                    <a:pt x="6428" y="41"/>
                  </a:lnTo>
                  <a:lnTo>
                    <a:pt x="622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60" name="Google Shape;60;p13"/>
          <p:cNvSpPr/>
          <p:nvPr/>
        </p:nvSpPr>
        <p:spPr>
          <a:xfrm>
            <a:off x="7734425" y="-692675"/>
            <a:ext cx="3656709" cy="2101870"/>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1" name="Google Shape;61;p13"/>
          <p:cNvSpPr/>
          <p:nvPr/>
        </p:nvSpPr>
        <p:spPr>
          <a:xfrm>
            <a:off x="7371478" y="206147"/>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62" name="Google Shape;62;p13"/>
          <p:cNvGrpSpPr/>
          <p:nvPr/>
        </p:nvGrpSpPr>
        <p:grpSpPr>
          <a:xfrm>
            <a:off x="8202131" y="525790"/>
            <a:ext cx="307124" cy="305294"/>
            <a:chOff x="1026043" y="1162815"/>
            <a:chExt cx="307124" cy="305294"/>
          </a:xfrm>
        </p:grpSpPr>
        <p:sp>
          <p:nvSpPr>
            <p:cNvPr id="63" name="Google Shape;63;p13"/>
            <p:cNvSpPr/>
            <p:nvPr/>
          </p:nvSpPr>
          <p:spPr>
            <a:xfrm>
              <a:off x="1026043" y="1162815"/>
              <a:ext cx="307124" cy="305294"/>
            </a:xfrm>
            <a:custGeom>
              <a:rect b="b" l="l" r="r" t="t"/>
              <a:pathLst>
                <a:path extrusionOk="0" h="6672" w="6712">
                  <a:moveTo>
                    <a:pt x="2766" y="1"/>
                  </a:moveTo>
                  <a:lnTo>
                    <a:pt x="2644" y="41"/>
                  </a:lnTo>
                  <a:lnTo>
                    <a:pt x="2563" y="82"/>
                  </a:lnTo>
                  <a:lnTo>
                    <a:pt x="2441" y="163"/>
                  </a:lnTo>
                  <a:lnTo>
                    <a:pt x="2359" y="245"/>
                  </a:lnTo>
                  <a:lnTo>
                    <a:pt x="2319" y="367"/>
                  </a:lnTo>
                  <a:lnTo>
                    <a:pt x="2237" y="651"/>
                  </a:lnTo>
                  <a:lnTo>
                    <a:pt x="2197" y="936"/>
                  </a:lnTo>
                  <a:lnTo>
                    <a:pt x="2197" y="1221"/>
                  </a:lnTo>
                  <a:lnTo>
                    <a:pt x="2237" y="1506"/>
                  </a:lnTo>
                  <a:lnTo>
                    <a:pt x="2075" y="1343"/>
                  </a:lnTo>
                  <a:lnTo>
                    <a:pt x="1871" y="1221"/>
                  </a:lnTo>
                  <a:lnTo>
                    <a:pt x="1546" y="1139"/>
                  </a:lnTo>
                  <a:lnTo>
                    <a:pt x="1424" y="1099"/>
                  </a:lnTo>
                  <a:lnTo>
                    <a:pt x="1261" y="1139"/>
                  </a:lnTo>
                  <a:lnTo>
                    <a:pt x="1139" y="1180"/>
                  </a:lnTo>
                  <a:lnTo>
                    <a:pt x="1017" y="1262"/>
                  </a:lnTo>
                  <a:lnTo>
                    <a:pt x="895" y="1343"/>
                  </a:lnTo>
                  <a:lnTo>
                    <a:pt x="814" y="1506"/>
                  </a:lnTo>
                  <a:lnTo>
                    <a:pt x="773" y="1790"/>
                  </a:lnTo>
                  <a:lnTo>
                    <a:pt x="773" y="2075"/>
                  </a:lnTo>
                  <a:lnTo>
                    <a:pt x="854" y="2360"/>
                  </a:lnTo>
                  <a:lnTo>
                    <a:pt x="1017" y="2604"/>
                  </a:lnTo>
                  <a:lnTo>
                    <a:pt x="1180" y="2807"/>
                  </a:lnTo>
                  <a:lnTo>
                    <a:pt x="1383" y="3011"/>
                  </a:lnTo>
                  <a:lnTo>
                    <a:pt x="1017" y="2970"/>
                  </a:lnTo>
                  <a:lnTo>
                    <a:pt x="814" y="3011"/>
                  </a:lnTo>
                  <a:lnTo>
                    <a:pt x="651" y="3051"/>
                  </a:lnTo>
                  <a:lnTo>
                    <a:pt x="407" y="3214"/>
                  </a:lnTo>
                  <a:lnTo>
                    <a:pt x="204" y="3377"/>
                  </a:lnTo>
                  <a:lnTo>
                    <a:pt x="82" y="3621"/>
                  </a:lnTo>
                  <a:lnTo>
                    <a:pt x="0" y="3865"/>
                  </a:lnTo>
                  <a:lnTo>
                    <a:pt x="0" y="4109"/>
                  </a:lnTo>
                  <a:lnTo>
                    <a:pt x="82" y="4353"/>
                  </a:lnTo>
                  <a:lnTo>
                    <a:pt x="244" y="4516"/>
                  </a:lnTo>
                  <a:lnTo>
                    <a:pt x="488" y="4678"/>
                  </a:lnTo>
                  <a:lnTo>
                    <a:pt x="692" y="4719"/>
                  </a:lnTo>
                  <a:lnTo>
                    <a:pt x="936" y="4760"/>
                  </a:lnTo>
                  <a:lnTo>
                    <a:pt x="1424" y="4719"/>
                  </a:lnTo>
                  <a:lnTo>
                    <a:pt x="1180" y="5004"/>
                  </a:lnTo>
                  <a:lnTo>
                    <a:pt x="1098" y="5166"/>
                  </a:lnTo>
                  <a:lnTo>
                    <a:pt x="1058" y="5370"/>
                  </a:lnTo>
                  <a:lnTo>
                    <a:pt x="1017" y="5655"/>
                  </a:lnTo>
                  <a:lnTo>
                    <a:pt x="1098" y="5939"/>
                  </a:lnTo>
                  <a:lnTo>
                    <a:pt x="1139" y="6061"/>
                  </a:lnTo>
                  <a:lnTo>
                    <a:pt x="1220" y="6143"/>
                  </a:lnTo>
                  <a:lnTo>
                    <a:pt x="1342" y="6265"/>
                  </a:lnTo>
                  <a:lnTo>
                    <a:pt x="1464" y="6305"/>
                  </a:lnTo>
                  <a:lnTo>
                    <a:pt x="1709" y="6387"/>
                  </a:lnTo>
                  <a:lnTo>
                    <a:pt x="1993" y="6387"/>
                  </a:lnTo>
                  <a:lnTo>
                    <a:pt x="2237" y="6346"/>
                  </a:lnTo>
                  <a:lnTo>
                    <a:pt x="2481" y="6224"/>
                  </a:lnTo>
                  <a:lnTo>
                    <a:pt x="2685" y="6021"/>
                  </a:lnTo>
                  <a:lnTo>
                    <a:pt x="2888" y="5777"/>
                  </a:lnTo>
                  <a:lnTo>
                    <a:pt x="3010" y="6102"/>
                  </a:lnTo>
                  <a:lnTo>
                    <a:pt x="3092" y="6265"/>
                  </a:lnTo>
                  <a:lnTo>
                    <a:pt x="3173" y="6387"/>
                  </a:lnTo>
                  <a:lnTo>
                    <a:pt x="3295" y="6509"/>
                  </a:lnTo>
                  <a:lnTo>
                    <a:pt x="3417" y="6590"/>
                  </a:lnTo>
                  <a:lnTo>
                    <a:pt x="3580" y="6671"/>
                  </a:lnTo>
                  <a:lnTo>
                    <a:pt x="3905" y="6671"/>
                  </a:lnTo>
                  <a:lnTo>
                    <a:pt x="4108" y="6590"/>
                  </a:lnTo>
                  <a:lnTo>
                    <a:pt x="4312" y="6468"/>
                  </a:lnTo>
                  <a:lnTo>
                    <a:pt x="4475" y="6305"/>
                  </a:lnTo>
                  <a:lnTo>
                    <a:pt x="4597" y="6102"/>
                  </a:lnTo>
                  <a:lnTo>
                    <a:pt x="4678" y="5777"/>
                  </a:lnTo>
                  <a:lnTo>
                    <a:pt x="4678" y="5451"/>
                  </a:lnTo>
                  <a:lnTo>
                    <a:pt x="4841" y="5533"/>
                  </a:lnTo>
                  <a:lnTo>
                    <a:pt x="5003" y="5573"/>
                  </a:lnTo>
                  <a:lnTo>
                    <a:pt x="5166" y="5614"/>
                  </a:lnTo>
                  <a:lnTo>
                    <a:pt x="5329" y="5573"/>
                  </a:lnTo>
                  <a:lnTo>
                    <a:pt x="5491" y="5533"/>
                  </a:lnTo>
                  <a:lnTo>
                    <a:pt x="5654" y="5492"/>
                  </a:lnTo>
                  <a:lnTo>
                    <a:pt x="5817" y="5370"/>
                  </a:lnTo>
                  <a:lnTo>
                    <a:pt x="5939" y="5248"/>
                  </a:lnTo>
                  <a:lnTo>
                    <a:pt x="6061" y="5085"/>
                  </a:lnTo>
                  <a:lnTo>
                    <a:pt x="6142" y="4922"/>
                  </a:lnTo>
                  <a:lnTo>
                    <a:pt x="6183" y="4760"/>
                  </a:lnTo>
                  <a:lnTo>
                    <a:pt x="6224" y="4597"/>
                  </a:lnTo>
                  <a:lnTo>
                    <a:pt x="6224" y="4434"/>
                  </a:lnTo>
                  <a:lnTo>
                    <a:pt x="6183" y="4231"/>
                  </a:lnTo>
                  <a:lnTo>
                    <a:pt x="6102" y="4068"/>
                  </a:lnTo>
                  <a:lnTo>
                    <a:pt x="6020" y="3946"/>
                  </a:lnTo>
                  <a:lnTo>
                    <a:pt x="6183" y="3865"/>
                  </a:lnTo>
                  <a:lnTo>
                    <a:pt x="6346" y="3783"/>
                  </a:lnTo>
                  <a:lnTo>
                    <a:pt x="6468" y="3702"/>
                  </a:lnTo>
                  <a:lnTo>
                    <a:pt x="6549" y="3539"/>
                  </a:lnTo>
                  <a:lnTo>
                    <a:pt x="6630" y="3417"/>
                  </a:lnTo>
                  <a:lnTo>
                    <a:pt x="6712" y="3255"/>
                  </a:lnTo>
                  <a:lnTo>
                    <a:pt x="6712" y="3051"/>
                  </a:lnTo>
                  <a:lnTo>
                    <a:pt x="6712" y="2889"/>
                  </a:lnTo>
                  <a:lnTo>
                    <a:pt x="6671" y="2685"/>
                  </a:lnTo>
                  <a:lnTo>
                    <a:pt x="6590" y="2522"/>
                  </a:lnTo>
                  <a:lnTo>
                    <a:pt x="6468" y="2360"/>
                  </a:lnTo>
                  <a:lnTo>
                    <a:pt x="6346" y="2238"/>
                  </a:lnTo>
                  <a:lnTo>
                    <a:pt x="6183" y="2156"/>
                  </a:lnTo>
                  <a:lnTo>
                    <a:pt x="6020" y="2116"/>
                  </a:lnTo>
                  <a:lnTo>
                    <a:pt x="5858" y="2075"/>
                  </a:lnTo>
                  <a:lnTo>
                    <a:pt x="5654" y="2075"/>
                  </a:lnTo>
                  <a:lnTo>
                    <a:pt x="5776" y="1750"/>
                  </a:lnTo>
                  <a:lnTo>
                    <a:pt x="5817" y="1546"/>
                  </a:lnTo>
                  <a:lnTo>
                    <a:pt x="5817" y="1384"/>
                  </a:lnTo>
                  <a:lnTo>
                    <a:pt x="5776" y="1099"/>
                  </a:lnTo>
                  <a:lnTo>
                    <a:pt x="5654" y="855"/>
                  </a:lnTo>
                  <a:lnTo>
                    <a:pt x="5491" y="651"/>
                  </a:lnTo>
                  <a:lnTo>
                    <a:pt x="5369" y="570"/>
                  </a:lnTo>
                  <a:lnTo>
                    <a:pt x="5247" y="489"/>
                  </a:lnTo>
                  <a:lnTo>
                    <a:pt x="4963" y="448"/>
                  </a:lnTo>
                  <a:lnTo>
                    <a:pt x="4678" y="489"/>
                  </a:lnTo>
                  <a:lnTo>
                    <a:pt x="4434" y="570"/>
                  </a:lnTo>
                  <a:lnTo>
                    <a:pt x="4190" y="733"/>
                  </a:lnTo>
                  <a:lnTo>
                    <a:pt x="3946" y="977"/>
                  </a:lnTo>
                  <a:lnTo>
                    <a:pt x="3783" y="1262"/>
                  </a:lnTo>
                  <a:lnTo>
                    <a:pt x="3661" y="895"/>
                  </a:lnTo>
                  <a:lnTo>
                    <a:pt x="3458" y="448"/>
                  </a:lnTo>
                  <a:lnTo>
                    <a:pt x="3336" y="245"/>
                  </a:lnTo>
                  <a:lnTo>
                    <a:pt x="3132" y="82"/>
                  </a:lnTo>
                  <a:lnTo>
                    <a:pt x="3010" y="41"/>
                  </a:lnTo>
                  <a:lnTo>
                    <a:pt x="2888"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4" name="Google Shape;64;p13"/>
            <p:cNvSpPr/>
            <p:nvPr/>
          </p:nvSpPr>
          <p:spPr>
            <a:xfrm>
              <a:off x="1109780" y="1246551"/>
              <a:ext cx="169440" cy="158275"/>
            </a:xfrm>
            <a:custGeom>
              <a:rect b="b" l="l" r="r" t="t"/>
              <a:pathLst>
                <a:path extrusionOk="0" h="3459" w="3703">
                  <a:moveTo>
                    <a:pt x="1668" y="1"/>
                  </a:moveTo>
                  <a:lnTo>
                    <a:pt x="1424" y="82"/>
                  </a:lnTo>
                  <a:lnTo>
                    <a:pt x="1140" y="164"/>
                  </a:lnTo>
                  <a:lnTo>
                    <a:pt x="936" y="286"/>
                  </a:lnTo>
                  <a:lnTo>
                    <a:pt x="692" y="448"/>
                  </a:lnTo>
                  <a:lnTo>
                    <a:pt x="489" y="652"/>
                  </a:lnTo>
                  <a:lnTo>
                    <a:pt x="285" y="896"/>
                  </a:lnTo>
                  <a:lnTo>
                    <a:pt x="163" y="1140"/>
                  </a:lnTo>
                  <a:lnTo>
                    <a:pt x="41" y="1425"/>
                  </a:lnTo>
                  <a:lnTo>
                    <a:pt x="1" y="1709"/>
                  </a:lnTo>
                  <a:lnTo>
                    <a:pt x="1" y="1994"/>
                  </a:lnTo>
                  <a:lnTo>
                    <a:pt x="82" y="2320"/>
                  </a:lnTo>
                  <a:lnTo>
                    <a:pt x="204" y="2604"/>
                  </a:lnTo>
                  <a:lnTo>
                    <a:pt x="367" y="2848"/>
                  </a:lnTo>
                  <a:lnTo>
                    <a:pt x="570" y="3052"/>
                  </a:lnTo>
                  <a:lnTo>
                    <a:pt x="814" y="3214"/>
                  </a:lnTo>
                  <a:lnTo>
                    <a:pt x="1058" y="3336"/>
                  </a:lnTo>
                  <a:lnTo>
                    <a:pt x="1302" y="3418"/>
                  </a:lnTo>
                  <a:lnTo>
                    <a:pt x="1587" y="3458"/>
                  </a:lnTo>
                  <a:lnTo>
                    <a:pt x="1912" y="3458"/>
                  </a:lnTo>
                  <a:lnTo>
                    <a:pt x="2197" y="3377"/>
                  </a:lnTo>
                  <a:lnTo>
                    <a:pt x="2441" y="3255"/>
                  </a:lnTo>
                  <a:lnTo>
                    <a:pt x="2726" y="3092"/>
                  </a:lnTo>
                  <a:lnTo>
                    <a:pt x="2970" y="2889"/>
                  </a:lnTo>
                  <a:lnTo>
                    <a:pt x="3173" y="2686"/>
                  </a:lnTo>
                  <a:lnTo>
                    <a:pt x="3377" y="2401"/>
                  </a:lnTo>
                  <a:lnTo>
                    <a:pt x="3539" y="2157"/>
                  </a:lnTo>
                  <a:lnTo>
                    <a:pt x="3621" y="1831"/>
                  </a:lnTo>
                  <a:lnTo>
                    <a:pt x="3702" y="1547"/>
                  </a:lnTo>
                  <a:lnTo>
                    <a:pt x="3702" y="1303"/>
                  </a:lnTo>
                  <a:lnTo>
                    <a:pt x="3661" y="1059"/>
                  </a:lnTo>
                  <a:lnTo>
                    <a:pt x="3580" y="815"/>
                  </a:lnTo>
                  <a:lnTo>
                    <a:pt x="3458" y="611"/>
                  </a:lnTo>
                  <a:lnTo>
                    <a:pt x="3336" y="448"/>
                  </a:lnTo>
                  <a:lnTo>
                    <a:pt x="3173" y="286"/>
                  </a:lnTo>
                  <a:lnTo>
                    <a:pt x="2929" y="164"/>
                  </a:lnTo>
                  <a:lnTo>
                    <a:pt x="2726" y="82"/>
                  </a:lnTo>
                  <a:lnTo>
                    <a:pt x="2441"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5" name="Google Shape;65;p13"/>
            <p:cNvSpPr/>
            <p:nvPr/>
          </p:nvSpPr>
          <p:spPr>
            <a:xfrm>
              <a:off x="1200974" y="1274509"/>
              <a:ext cx="18669" cy="18623"/>
            </a:xfrm>
            <a:custGeom>
              <a:rect b="b" l="l" r="r" t="t"/>
              <a:pathLst>
                <a:path extrusionOk="0" h="407" w="408">
                  <a:moveTo>
                    <a:pt x="204" y="0"/>
                  </a:moveTo>
                  <a:lnTo>
                    <a:pt x="123" y="41"/>
                  </a:lnTo>
                  <a:lnTo>
                    <a:pt x="82" y="81"/>
                  </a:lnTo>
                  <a:lnTo>
                    <a:pt x="41" y="122"/>
                  </a:lnTo>
                  <a:lnTo>
                    <a:pt x="1" y="204"/>
                  </a:lnTo>
                  <a:lnTo>
                    <a:pt x="41" y="285"/>
                  </a:lnTo>
                  <a:lnTo>
                    <a:pt x="82" y="326"/>
                  </a:lnTo>
                  <a:lnTo>
                    <a:pt x="123" y="366"/>
                  </a:lnTo>
                  <a:lnTo>
                    <a:pt x="204" y="407"/>
                  </a:lnTo>
                  <a:lnTo>
                    <a:pt x="285" y="366"/>
                  </a:lnTo>
                  <a:lnTo>
                    <a:pt x="367" y="326"/>
                  </a:lnTo>
                  <a:lnTo>
                    <a:pt x="407" y="285"/>
                  </a:lnTo>
                  <a:lnTo>
                    <a:pt x="407" y="204"/>
                  </a:lnTo>
                  <a:lnTo>
                    <a:pt x="407" y="122"/>
                  </a:lnTo>
                  <a:lnTo>
                    <a:pt x="367" y="81"/>
                  </a:lnTo>
                  <a:lnTo>
                    <a:pt x="285" y="41"/>
                  </a:lnTo>
                  <a:lnTo>
                    <a:pt x="204"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6" name="Google Shape;66;p13"/>
            <p:cNvSpPr/>
            <p:nvPr/>
          </p:nvSpPr>
          <p:spPr>
            <a:xfrm>
              <a:off x="1158191" y="1281922"/>
              <a:ext cx="18623" cy="16793"/>
            </a:xfrm>
            <a:custGeom>
              <a:rect b="b" l="l" r="r" t="t"/>
              <a:pathLst>
                <a:path extrusionOk="0" h="367" w="407">
                  <a:moveTo>
                    <a:pt x="122" y="1"/>
                  </a:moveTo>
                  <a:lnTo>
                    <a:pt x="41" y="42"/>
                  </a:lnTo>
                  <a:lnTo>
                    <a:pt x="0" y="123"/>
                  </a:lnTo>
                  <a:lnTo>
                    <a:pt x="0" y="164"/>
                  </a:lnTo>
                  <a:lnTo>
                    <a:pt x="0" y="245"/>
                  </a:lnTo>
                  <a:lnTo>
                    <a:pt x="41" y="326"/>
                  </a:lnTo>
                  <a:lnTo>
                    <a:pt x="82" y="367"/>
                  </a:lnTo>
                  <a:lnTo>
                    <a:pt x="285" y="367"/>
                  </a:lnTo>
                  <a:lnTo>
                    <a:pt x="366" y="326"/>
                  </a:lnTo>
                  <a:lnTo>
                    <a:pt x="407" y="245"/>
                  </a:lnTo>
                  <a:lnTo>
                    <a:pt x="407" y="164"/>
                  </a:lnTo>
                  <a:lnTo>
                    <a:pt x="407" y="123"/>
                  </a:lnTo>
                  <a:lnTo>
                    <a:pt x="366" y="42"/>
                  </a:lnTo>
                  <a:lnTo>
                    <a:pt x="32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7" name="Google Shape;67;p13"/>
            <p:cNvSpPr/>
            <p:nvPr/>
          </p:nvSpPr>
          <p:spPr>
            <a:xfrm>
              <a:off x="1186103" y="1309834"/>
              <a:ext cx="18669" cy="18669"/>
            </a:xfrm>
            <a:custGeom>
              <a:rect b="b" l="l" r="r" t="t"/>
              <a:pathLst>
                <a:path extrusionOk="0" h="408" w="408">
                  <a:moveTo>
                    <a:pt x="204" y="1"/>
                  </a:moveTo>
                  <a:lnTo>
                    <a:pt x="122" y="42"/>
                  </a:lnTo>
                  <a:lnTo>
                    <a:pt x="82" y="82"/>
                  </a:lnTo>
                  <a:lnTo>
                    <a:pt x="41" y="123"/>
                  </a:lnTo>
                  <a:lnTo>
                    <a:pt x="0" y="204"/>
                  </a:lnTo>
                  <a:lnTo>
                    <a:pt x="41" y="286"/>
                  </a:lnTo>
                  <a:lnTo>
                    <a:pt x="82" y="367"/>
                  </a:lnTo>
                  <a:lnTo>
                    <a:pt x="122" y="408"/>
                  </a:lnTo>
                  <a:lnTo>
                    <a:pt x="285" y="408"/>
                  </a:lnTo>
                  <a:lnTo>
                    <a:pt x="366" y="367"/>
                  </a:lnTo>
                  <a:lnTo>
                    <a:pt x="407" y="286"/>
                  </a:lnTo>
                  <a:lnTo>
                    <a:pt x="407" y="204"/>
                  </a:lnTo>
                  <a:lnTo>
                    <a:pt x="407" y="123"/>
                  </a:lnTo>
                  <a:lnTo>
                    <a:pt x="366" y="82"/>
                  </a:lnTo>
                  <a:lnTo>
                    <a:pt x="285" y="42"/>
                  </a:lnTo>
                  <a:lnTo>
                    <a:pt x="2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8" name="Google Shape;68;p13"/>
            <p:cNvSpPr/>
            <p:nvPr/>
          </p:nvSpPr>
          <p:spPr>
            <a:xfrm>
              <a:off x="1225180" y="1319168"/>
              <a:ext cx="18669" cy="18669"/>
            </a:xfrm>
            <a:custGeom>
              <a:rect b="b" l="l" r="r" t="t"/>
              <a:pathLst>
                <a:path extrusionOk="0" h="408" w="408">
                  <a:moveTo>
                    <a:pt x="123" y="0"/>
                  </a:moveTo>
                  <a:lnTo>
                    <a:pt x="82" y="41"/>
                  </a:lnTo>
                  <a:lnTo>
                    <a:pt x="41" y="122"/>
                  </a:lnTo>
                  <a:lnTo>
                    <a:pt x="1" y="204"/>
                  </a:lnTo>
                  <a:lnTo>
                    <a:pt x="41" y="244"/>
                  </a:lnTo>
                  <a:lnTo>
                    <a:pt x="82" y="326"/>
                  </a:lnTo>
                  <a:lnTo>
                    <a:pt x="123" y="366"/>
                  </a:lnTo>
                  <a:lnTo>
                    <a:pt x="204" y="407"/>
                  </a:lnTo>
                  <a:lnTo>
                    <a:pt x="285" y="366"/>
                  </a:lnTo>
                  <a:lnTo>
                    <a:pt x="367" y="326"/>
                  </a:lnTo>
                  <a:lnTo>
                    <a:pt x="407" y="244"/>
                  </a:lnTo>
                  <a:lnTo>
                    <a:pt x="407" y="204"/>
                  </a:lnTo>
                  <a:lnTo>
                    <a:pt x="407" y="122"/>
                  </a:lnTo>
                  <a:lnTo>
                    <a:pt x="367"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69" name="Google Shape;69;p13"/>
            <p:cNvSpPr/>
            <p:nvPr/>
          </p:nvSpPr>
          <p:spPr>
            <a:xfrm>
              <a:off x="1143274" y="1328457"/>
              <a:ext cx="16793" cy="18669"/>
            </a:xfrm>
            <a:custGeom>
              <a:rect b="b" l="l" r="r" t="t"/>
              <a:pathLst>
                <a:path extrusionOk="0" h="408" w="367">
                  <a:moveTo>
                    <a:pt x="123" y="1"/>
                  </a:moveTo>
                  <a:lnTo>
                    <a:pt x="41" y="82"/>
                  </a:lnTo>
                  <a:lnTo>
                    <a:pt x="1" y="123"/>
                  </a:lnTo>
                  <a:lnTo>
                    <a:pt x="1" y="204"/>
                  </a:lnTo>
                  <a:lnTo>
                    <a:pt x="1" y="285"/>
                  </a:lnTo>
                  <a:lnTo>
                    <a:pt x="41" y="326"/>
                  </a:lnTo>
                  <a:lnTo>
                    <a:pt x="123" y="367"/>
                  </a:lnTo>
                  <a:lnTo>
                    <a:pt x="204" y="407"/>
                  </a:lnTo>
                  <a:lnTo>
                    <a:pt x="285" y="367"/>
                  </a:lnTo>
                  <a:lnTo>
                    <a:pt x="326" y="326"/>
                  </a:lnTo>
                  <a:lnTo>
                    <a:pt x="367" y="285"/>
                  </a:lnTo>
                  <a:lnTo>
                    <a:pt x="367" y="204"/>
                  </a:lnTo>
                  <a:lnTo>
                    <a:pt x="367" y="123"/>
                  </a:lnTo>
                  <a:lnTo>
                    <a:pt x="326" y="82"/>
                  </a:lnTo>
                  <a:lnTo>
                    <a:pt x="28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70" name="Google Shape;70;p13"/>
            <p:cNvSpPr/>
            <p:nvPr/>
          </p:nvSpPr>
          <p:spPr>
            <a:xfrm>
              <a:off x="1182351" y="1356369"/>
              <a:ext cx="16839" cy="18669"/>
            </a:xfrm>
            <a:custGeom>
              <a:rect b="b" l="l" r="r" t="t"/>
              <a:pathLst>
                <a:path extrusionOk="0" h="408" w="368">
                  <a:moveTo>
                    <a:pt x="123" y="1"/>
                  </a:moveTo>
                  <a:lnTo>
                    <a:pt x="42" y="42"/>
                  </a:lnTo>
                  <a:lnTo>
                    <a:pt x="1" y="123"/>
                  </a:lnTo>
                  <a:lnTo>
                    <a:pt x="1" y="204"/>
                  </a:lnTo>
                  <a:lnTo>
                    <a:pt x="1" y="286"/>
                  </a:lnTo>
                  <a:lnTo>
                    <a:pt x="42" y="326"/>
                  </a:lnTo>
                  <a:lnTo>
                    <a:pt x="123" y="367"/>
                  </a:lnTo>
                  <a:lnTo>
                    <a:pt x="204" y="408"/>
                  </a:lnTo>
                  <a:lnTo>
                    <a:pt x="286" y="367"/>
                  </a:lnTo>
                  <a:lnTo>
                    <a:pt x="326" y="326"/>
                  </a:lnTo>
                  <a:lnTo>
                    <a:pt x="367" y="286"/>
                  </a:lnTo>
                  <a:lnTo>
                    <a:pt x="367" y="204"/>
                  </a:lnTo>
                  <a:lnTo>
                    <a:pt x="367" y="123"/>
                  </a:lnTo>
                  <a:lnTo>
                    <a:pt x="326" y="42"/>
                  </a:lnTo>
                  <a:lnTo>
                    <a:pt x="28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71" name="Google Shape;71;p13"/>
          <p:cNvSpPr/>
          <p:nvPr/>
        </p:nvSpPr>
        <p:spPr>
          <a:xfrm>
            <a:off x="1600987" y="587168"/>
            <a:ext cx="85658" cy="85658"/>
          </a:xfrm>
          <a:custGeom>
            <a:rect b="b" l="l" r="r" t="t"/>
            <a:pathLst>
              <a:path extrusionOk="0" h="1872" w="1872">
                <a:moveTo>
                  <a:pt x="733" y="1"/>
                </a:moveTo>
                <a:lnTo>
                  <a:pt x="489" y="82"/>
                </a:lnTo>
                <a:lnTo>
                  <a:pt x="286" y="245"/>
                </a:lnTo>
                <a:lnTo>
                  <a:pt x="123" y="448"/>
                </a:lnTo>
                <a:lnTo>
                  <a:pt x="1" y="692"/>
                </a:lnTo>
                <a:lnTo>
                  <a:pt x="1" y="936"/>
                </a:lnTo>
                <a:lnTo>
                  <a:pt x="41" y="1221"/>
                </a:lnTo>
                <a:lnTo>
                  <a:pt x="164" y="1424"/>
                </a:lnTo>
                <a:lnTo>
                  <a:pt x="245" y="1587"/>
                </a:lnTo>
                <a:lnTo>
                  <a:pt x="367" y="1668"/>
                </a:lnTo>
                <a:lnTo>
                  <a:pt x="489" y="1750"/>
                </a:lnTo>
                <a:lnTo>
                  <a:pt x="652" y="1831"/>
                </a:lnTo>
                <a:lnTo>
                  <a:pt x="774" y="1872"/>
                </a:lnTo>
                <a:lnTo>
                  <a:pt x="1099" y="1872"/>
                </a:lnTo>
                <a:lnTo>
                  <a:pt x="1262" y="1831"/>
                </a:lnTo>
                <a:lnTo>
                  <a:pt x="1384" y="1790"/>
                </a:lnTo>
                <a:lnTo>
                  <a:pt x="1546" y="1709"/>
                </a:lnTo>
                <a:lnTo>
                  <a:pt x="1628" y="1587"/>
                </a:lnTo>
                <a:lnTo>
                  <a:pt x="1750" y="1465"/>
                </a:lnTo>
                <a:lnTo>
                  <a:pt x="1831" y="1302"/>
                </a:lnTo>
                <a:lnTo>
                  <a:pt x="1872" y="1140"/>
                </a:lnTo>
                <a:lnTo>
                  <a:pt x="1872" y="977"/>
                </a:lnTo>
                <a:lnTo>
                  <a:pt x="1872" y="773"/>
                </a:lnTo>
                <a:lnTo>
                  <a:pt x="1831" y="651"/>
                </a:lnTo>
                <a:lnTo>
                  <a:pt x="1750" y="489"/>
                </a:lnTo>
                <a:lnTo>
                  <a:pt x="1669" y="367"/>
                </a:lnTo>
                <a:lnTo>
                  <a:pt x="1546" y="245"/>
                </a:lnTo>
                <a:lnTo>
                  <a:pt x="1302" y="82"/>
                </a:lnTo>
                <a:lnTo>
                  <a:pt x="977"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72" name="Google Shape;72;p13"/>
          <p:cNvGrpSpPr/>
          <p:nvPr/>
        </p:nvGrpSpPr>
        <p:grpSpPr>
          <a:xfrm>
            <a:off x="435493" y="1215742"/>
            <a:ext cx="474643" cy="299712"/>
            <a:chOff x="7729218" y="1694205"/>
            <a:chExt cx="474643" cy="299712"/>
          </a:xfrm>
        </p:grpSpPr>
        <p:sp>
          <p:nvSpPr>
            <p:cNvPr id="73" name="Google Shape;73;p13"/>
            <p:cNvSpPr/>
            <p:nvPr/>
          </p:nvSpPr>
          <p:spPr>
            <a:xfrm>
              <a:off x="7729218" y="1694205"/>
              <a:ext cx="474643" cy="299712"/>
            </a:xfrm>
            <a:custGeom>
              <a:rect b="b" l="l" r="r" t="t"/>
              <a:pathLst>
                <a:path extrusionOk="0" h="6550" w="10373">
                  <a:moveTo>
                    <a:pt x="5451" y="366"/>
                  </a:moveTo>
                  <a:lnTo>
                    <a:pt x="5654" y="407"/>
                  </a:lnTo>
                  <a:lnTo>
                    <a:pt x="5858" y="489"/>
                  </a:lnTo>
                  <a:lnTo>
                    <a:pt x="6102" y="570"/>
                  </a:lnTo>
                  <a:lnTo>
                    <a:pt x="6264" y="651"/>
                  </a:lnTo>
                  <a:lnTo>
                    <a:pt x="6468" y="814"/>
                  </a:lnTo>
                  <a:lnTo>
                    <a:pt x="6752" y="1099"/>
                  </a:lnTo>
                  <a:lnTo>
                    <a:pt x="6996" y="1465"/>
                  </a:lnTo>
                  <a:lnTo>
                    <a:pt x="7159" y="1871"/>
                  </a:lnTo>
                  <a:lnTo>
                    <a:pt x="7281" y="2278"/>
                  </a:lnTo>
                  <a:lnTo>
                    <a:pt x="7322" y="2726"/>
                  </a:lnTo>
                  <a:lnTo>
                    <a:pt x="7281" y="3173"/>
                  </a:lnTo>
                  <a:lnTo>
                    <a:pt x="7322" y="3295"/>
                  </a:lnTo>
                  <a:lnTo>
                    <a:pt x="7363" y="3336"/>
                  </a:lnTo>
                  <a:lnTo>
                    <a:pt x="7485" y="3377"/>
                  </a:lnTo>
                  <a:lnTo>
                    <a:pt x="7566" y="3336"/>
                  </a:lnTo>
                  <a:lnTo>
                    <a:pt x="7851" y="3214"/>
                  </a:lnTo>
                  <a:lnTo>
                    <a:pt x="8095" y="3132"/>
                  </a:lnTo>
                  <a:lnTo>
                    <a:pt x="8379" y="3092"/>
                  </a:lnTo>
                  <a:lnTo>
                    <a:pt x="8664" y="3092"/>
                  </a:lnTo>
                  <a:lnTo>
                    <a:pt x="8949" y="3132"/>
                  </a:lnTo>
                  <a:lnTo>
                    <a:pt x="9193" y="3254"/>
                  </a:lnTo>
                  <a:lnTo>
                    <a:pt x="9437" y="3417"/>
                  </a:lnTo>
                  <a:lnTo>
                    <a:pt x="9640" y="3621"/>
                  </a:lnTo>
                  <a:lnTo>
                    <a:pt x="9762" y="3824"/>
                  </a:lnTo>
                  <a:lnTo>
                    <a:pt x="9885" y="4027"/>
                  </a:lnTo>
                  <a:lnTo>
                    <a:pt x="9925" y="4271"/>
                  </a:lnTo>
                  <a:lnTo>
                    <a:pt x="9966" y="4515"/>
                  </a:lnTo>
                  <a:lnTo>
                    <a:pt x="9966" y="4759"/>
                  </a:lnTo>
                  <a:lnTo>
                    <a:pt x="9925" y="5004"/>
                  </a:lnTo>
                  <a:lnTo>
                    <a:pt x="9844" y="5207"/>
                  </a:lnTo>
                  <a:lnTo>
                    <a:pt x="9762" y="5410"/>
                  </a:lnTo>
                  <a:lnTo>
                    <a:pt x="9600" y="5614"/>
                  </a:lnTo>
                  <a:lnTo>
                    <a:pt x="9396" y="5776"/>
                  </a:lnTo>
                  <a:lnTo>
                    <a:pt x="9193" y="5898"/>
                  </a:lnTo>
                  <a:lnTo>
                    <a:pt x="8949" y="5980"/>
                  </a:lnTo>
                  <a:lnTo>
                    <a:pt x="8461" y="6102"/>
                  </a:lnTo>
                  <a:lnTo>
                    <a:pt x="7932" y="6142"/>
                  </a:lnTo>
                  <a:lnTo>
                    <a:pt x="5654" y="6142"/>
                  </a:lnTo>
                  <a:lnTo>
                    <a:pt x="3946" y="6061"/>
                  </a:lnTo>
                  <a:lnTo>
                    <a:pt x="2278" y="5898"/>
                  </a:lnTo>
                  <a:lnTo>
                    <a:pt x="1709" y="5817"/>
                  </a:lnTo>
                  <a:lnTo>
                    <a:pt x="1424" y="5736"/>
                  </a:lnTo>
                  <a:lnTo>
                    <a:pt x="1139" y="5654"/>
                  </a:lnTo>
                  <a:lnTo>
                    <a:pt x="895" y="5532"/>
                  </a:lnTo>
                  <a:lnTo>
                    <a:pt x="651" y="5370"/>
                  </a:lnTo>
                  <a:lnTo>
                    <a:pt x="488" y="5126"/>
                  </a:lnTo>
                  <a:lnTo>
                    <a:pt x="407" y="4882"/>
                  </a:lnTo>
                  <a:lnTo>
                    <a:pt x="407" y="4719"/>
                  </a:lnTo>
                  <a:lnTo>
                    <a:pt x="407" y="4556"/>
                  </a:lnTo>
                  <a:lnTo>
                    <a:pt x="448" y="4393"/>
                  </a:lnTo>
                  <a:lnTo>
                    <a:pt x="529" y="4231"/>
                  </a:lnTo>
                  <a:lnTo>
                    <a:pt x="732" y="3987"/>
                  </a:lnTo>
                  <a:lnTo>
                    <a:pt x="976" y="3824"/>
                  </a:lnTo>
                  <a:lnTo>
                    <a:pt x="1139" y="3743"/>
                  </a:lnTo>
                  <a:lnTo>
                    <a:pt x="1343" y="3702"/>
                  </a:lnTo>
                  <a:lnTo>
                    <a:pt x="1709" y="3702"/>
                  </a:lnTo>
                  <a:lnTo>
                    <a:pt x="2075" y="3783"/>
                  </a:lnTo>
                  <a:lnTo>
                    <a:pt x="2400" y="3946"/>
                  </a:lnTo>
                  <a:lnTo>
                    <a:pt x="2481" y="3987"/>
                  </a:lnTo>
                  <a:lnTo>
                    <a:pt x="2522" y="3987"/>
                  </a:lnTo>
                  <a:lnTo>
                    <a:pt x="2644" y="3905"/>
                  </a:lnTo>
                  <a:lnTo>
                    <a:pt x="2685" y="3824"/>
                  </a:lnTo>
                  <a:lnTo>
                    <a:pt x="2685" y="3743"/>
                  </a:lnTo>
                  <a:lnTo>
                    <a:pt x="2685" y="3661"/>
                  </a:lnTo>
                  <a:lnTo>
                    <a:pt x="2563" y="3417"/>
                  </a:lnTo>
                  <a:lnTo>
                    <a:pt x="2563" y="3173"/>
                  </a:lnTo>
                  <a:lnTo>
                    <a:pt x="2644" y="2970"/>
                  </a:lnTo>
                  <a:lnTo>
                    <a:pt x="2766" y="2766"/>
                  </a:lnTo>
                  <a:lnTo>
                    <a:pt x="2929" y="2644"/>
                  </a:lnTo>
                  <a:lnTo>
                    <a:pt x="3173" y="2563"/>
                  </a:lnTo>
                  <a:lnTo>
                    <a:pt x="3417" y="2522"/>
                  </a:lnTo>
                  <a:lnTo>
                    <a:pt x="3661" y="2604"/>
                  </a:lnTo>
                  <a:lnTo>
                    <a:pt x="3783" y="2604"/>
                  </a:lnTo>
                  <a:lnTo>
                    <a:pt x="3864" y="2522"/>
                  </a:lnTo>
                  <a:lnTo>
                    <a:pt x="3905" y="2400"/>
                  </a:lnTo>
                  <a:lnTo>
                    <a:pt x="3864" y="2278"/>
                  </a:lnTo>
                  <a:lnTo>
                    <a:pt x="3824" y="2116"/>
                  </a:lnTo>
                  <a:lnTo>
                    <a:pt x="3783" y="1912"/>
                  </a:lnTo>
                  <a:lnTo>
                    <a:pt x="3783" y="1749"/>
                  </a:lnTo>
                  <a:lnTo>
                    <a:pt x="3824" y="1546"/>
                  </a:lnTo>
                  <a:lnTo>
                    <a:pt x="3864" y="1383"/>
                  </a:lnTo>
                  <a:lnTo>
                    <a:pt x="3946" y="1180"/>
                  </a:lnTo>
                  <a:lnTo>
                    <a:pt x="4149" y="895"/>
                  </a:lnTo>
                  <a:lnTo>
                    <a:pt x="4312" y="733"/>
                  </a:lnTo>
                  <a:lnTo>
                    <a:pt x="4475" y="611"/>
                  </a:lnTo>
                  <a:lnTo>
                    <a:pt x="4637" y="529"/>
                  </a:lnTo>
                  <a:lnTo>
                    <a:pt x="4841" y="448"/>
                  </a:lnTo>
                  <a:lnTo>
                    <a:pt x="5044" y="407"/>
                  </a:lnTo>
                  <a:lnTo>
                    <a:pt x="5247" y="366"/>
                  </a:lnTo>
                  <a:close/>
                  <a:moveTo>
                    <a:pt x="5003" y="0"/>
                  </a:moveTo>
                  <a:lnTo>
                    <a:pt x="4759" y="41"/>
                  </a:lnTo>
                  <a:lnTo>
                    <a:pt x="4515" y="122"/>
                  </a:lnTo>
                  <a:lnTo>
                    <a:pt x="4312" y="244"/>
                  </a:lnTo>
                  <a:lnTo>
                    <a:pt x="4108" y="366"/>
                  </a:lnTo>
                  <a:lnTo>
                    <a:pt x="3946" y="529"/>
                  </a:lnTo>
                  <a:lnTo>
                    <a:pt x="3783" y="692"/>
                  </a:lnTo>
                  <a:lnTo>
                    <a:pt x="3661" y="895"/>
                  </a:lnTo>
                  <a:lnTo>
                    <a:pt x="3539" y="1139"/>
                  </a:lnTo>
                  <a:lnTo>
                    <a:pt x="3458" y="1343"/>
                  </a:lnTo>
                  <a:lnTo>
                    <a:pt x="3417" y="1587"/>
                  </a:lnTo>
                  <a:lnTo>
                    <a:pt x="3417" y="1790"/>
                  </a:lnTo>
                  <a:lnTo>
                    <a:pt x="3417" y="2034"/>
                  </a:lnTo>
                  <a:lnTo>
                    <a:pt x="3431" y="2119"/>
                  </a:lnTo>
                  <a:lnTo>
                    <a:pt x="3431" y="2119"/>
                  </a:lnTo>
                  <a:lnTo>
                    <a:pt x="3417" y="2116"/>
                  </a:lnTo>
                  <a:lnTo>
                    <a:pt x="3254" y="2116"/>
                  </a:lnTo>
                  <a:lnTo>
                    <a:pt x="3051" y="2156"/>
                  </a:lnTo>
                  <a:lnTo>
                    <a:pt x="2888" y="2197"/>
                  </a:lnTo>
                  <a:lnTo>
                    <a:pt x="2725" y="2278"/>
                  </a:lnTo>
                  <a:lnTo>
                    <a:pt x="2603" y="2360"/>
                  </a:lnTo>
                  <a:lnTo>
                    <a:pt x="2441" y="2482"/>
                  </a:lnTo>
                  <a:lnTo>
                    <a:pt x="2359" y="2644"/>
                  </a:lnTo>
                  <a:lnTo>
                    <a:pt x="2237" y="2807"/>
                  </a:lnTo>
                  <a:lnTo>
                    <a:pt x="2197" y="2970"/>
                  </a:lnTo>
                  <a:lnTo>
                    <a:pt x="2156" y="3173"/>
                  </a:lnTo>
                  <a:lnTo>
                    <a:pt x="2156" y="3336"/>
                  </a:lnTo>
                  <a:lnTo>
                    <a:pt x="2170" y="3407"/>
                  </a:lnTo>
                  <a:lnTo>
                    <a:pt x="1993" y="3336"/>
                  </a:lnTo>
                  <a:lnTo>
                    <a:pt x="1749" y="3295"/>
                  </a:lnTo>
                  <a:lnTo>
                    <a:pt x="1302" y="3295"/>
                  </a:lnTo>
                  <a:lnTo>
                    <a:pt x="1098" y="3336"/>
                  </a:lnTo>
                  <a:lnTo>
                    <a:pt x="854" y="3417"/>
                  </a:lnTo>
                  <a:lnTo>
                    <a:pt x="692" y="3499"/>
                  </a:lnTo>
                  <a:lnTo>
                    <a:pt x="529" y="3621"/>
                  </a:lnTo>
                  <a:lnTo>
                    <a:pt x="366" y="3783"/>
                  </a:lnTo>
                  <a:lnTo>
                    <a:pt x="244" y="3946"/>
                  </a:lnTo>
                  <a:lnTo>
                    <a:pt x="122" y="4109"/>
                  </a:lnTo>
                  <a:lnTo>
                    <a:pt x="41" y="4312"/>
                  </a:lnTo>
                  <a:lnTo>
                    <a:pt x="0" y="4515"/>
                  </a:lnTo>
                  <a:lnTo>
                    <a:pt x="0" y="4719"/>
                  </a:lnTo>
                  <a:lnTo>
                    <a:pt x="0" y="4922"/>
                  </a:lnTo>
                  <a:lnTo>
                    <a:pt x="41" y="5126"/>
                  </a:lnTo>
                  <a:lnTo>
                    <a:pt x="122" y="5288"/>
                  </a:lnTo>
                  <a:lnTo>
                    <a:pt x="204" y="5451"/>
                  </a:lnTo>
                  <a:lnTo>
                    <a:pt x="488" y="5695"/>
                  </a:lnTo>
                  <a:lnTo>
                    <a:pt x="773" y="5898"/>
                  </a:lnTo>
                  <a:lnTo>
                    <a:pt x="1139" y="6061"/>
                  </a:lnTo>
                  <a:lnTo>
                    <a:pt x="1505" y="6183"/>
                  </a:lnTo>
                  <a:lnTo>
                    <a:pt x="1912" y="6265"/>
                  </a:lnTo>
                  <a:lnTo>
                    <a:pt x="2278" y="6305"/>
                  </a:lnTo>
                  <a:lnTo>
                    <a:pt x="4027" y="6427"/>
                  </a:lnTo>
                  <a:lnTo>
                    <a:pt x="5776" y="6509"/>
                  </a:lnTo>
                  <a:lnTo>
                    <a:pt x="7119" y="6549"/>
                  </a:lnTo>
                  <a:lnTo>
                    <a:pt x="7769" y="6549"/>
                  </a:lnTo>
                  <a:lnTo>
                    <a:pt x="8420" y="6509"/>
                  </a:lnTo>
                  <a:lnTo>
                    <a:pt x="8990" y="6387"/>
                  </a:lnTo>
                  <a:lnTo>
                    <a:pt x="9234" y="6305"/>
                  </a:lnTo>
                  <a:lnTo>
                    <a:pt x="9478" y="6183"/>
                  </a:lnTo>
                  <a:lnTo>
                    <a:pt x="9722" y="6020"/>
                  </a:lnTo>
                  <a:lnTo>
                    <a:pt x="9925" y="5858"/>
                  </a:lnTo>
                  <a:lnTo>
                    <a:pt x="10088" y="5654"/>
                  </a:lnTo>
                  <a:lnTo>
                    <a:pt x="10210" y="5370"/>
                  </a:lnTo>
                  <a:lnTo>
                    <a:pt x="10291" y="5126"/>
                  </a:lnTo>
                  <a:lnTo>
                    <a:pt x="10373" y="4882"/>
                  </a:lnTo>
                  <a:lnTo>
                    <a:pt x="10373" y="4597"/>
                  </a:lnTo>
                  <a:lnTo>
                    <a:pt x="10332" y="4312"/>
                  </a:lnTo>
                  <a:lnTo>
                    <a:pt x="10291" y="4068"/>
                  </a:lnTo>
                  <a:lnTo>
                    <a:pt x="10210" y="3783"/>
                  </a:lnTo>
                  <a:lnTo>
                    <a:pt x="10088" y="3539"/>
                  </a:lnTo>
                  <a:lnTo>
                    <a:pt x="9925" y="3336"/>
                  </a:lnTo>
                  <a:lnTo>
                    <a:pt x="9681" y="3092"/>
                  </a:lnTo>
                  <a:lnTo>
                    <a:pt x="9396" y="2888"/>
                  </a:lnTo>
                  <a:lnTo>
                    <a:pt x="9071" y="2766"/>
                  </a:lnTo>
                  <a:lnTo>
                    <a:pt x="8705" y="2685"/>
                  </a:lnTo>
                  <a:lnTo>
                    <a:pt x="8379" y="2685"/>
                  </a:lnTo>
                  <a:lnTo>
                    <a:pt x="8013" y="2726"/>
                  </a:lnTo>
                  <a:lnTo>
                    <a:pt x="7688" y="2848"/>
                  </a:lnTo>
                  <a:lnTo>
                    <a:pt x="7688" y="2644"/>
                  </a:lnTo>
                  <a:lnTo>
                    <a:pt x="7647" y="2075"/>
                  </a:lnTo>
                  <a:lnTo>
                    <a:pt x="7485" y="1587"/>
                  </a:lnTo>
                  <a:lnTo>
                    <a:pt x="7363" y="1343"/>
                  </a:lnTo>
                  <a:lnTo>
                    <a:pt x="7241" y="1099"/>
                  </a:lnTo>
                  <a:lnTo>
                    <a:pt x="7078" y="895"/>
                  </a:lnTo>
                  <a:lnTo>
                    <a:pt x="6915" y="692"/>
                  </a:lnTo>
                  <a:lnTo>
                    <a:pt x="6712" y="489"/>
                  </a:lnTo>
                  <a:lnTo>
                    <a:pt x="6508" y="366"/>
                  </a:lnTo>
                  <a:lnTo>
                    <a:pt x="6264" y="204"/>
                  </a:lnTo>
                  <a:lnTo>
                    <a:pt x="6020" y="122"/>
                  </a:lnTo>
                  <a:lnTo>
                    <a:pt x="5776" y="41"/>
                  </a:lnTo>
                  <a:lnTo>
                    <a:pt x="5491" y="0"/>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74" name="Google Shape;74;p13"/>
            <p:cNvSpPr/>
            <p:nvPr/>
          </p:nvSpPr>
          <p:spPr>
            <a:xfrm>
              <a:off x="7738507" y="1703494"/>
              <a:ext cx="456065" cy="281088"/>
            </a:xfrm>
            <a:custGeom>
              <a:rect b="b" l="l" r="r" t="t"/>
              <a:pathLst>
                <a:path extrusionOk="0" h="6143" w="9967">
                  <a:moveTo>
                    <a:pt x="4963" y="1"/>
                  </a:moveTo>
                  <a:lnTo>
                    <a:pt x="4638" y="41"/>
                  </a:lnTo>
                  <a:lnTo>
                    <a:pt x="4353" y="123"/>
                  </a:lnTo>
                  <a:lnTo>
                    <a:pt x="4068" y="286"/>
                  </a:lnTo>
                  <a:lnTo>
                    <a:pt x="3865" y="489"/>
                  </a:lnTo>
                  <a:lnTo>
                    <a:pt x="3661" y="733"/>
                  </a:lnTo>
                  <a:lnTo>
                    <a:pt x="3499" y="1018"/>
                  </a:lnTo>
                  <a:lnTo>
                    <a:pt x="3417" y="1302"/>
                  </a:lnTo>
                  <a:lnTo>
                    <a:pt x="3377" y="1587"/>
                  </a:lnTo>
                  <a:lnTo>
                    <a:pt x="3417" y="1913"/>
                  </a:lnTo>
                  <a:lnTo>
                    <a:pt x="3499" y="2197"/>
                  </a:lnTo>
                  <a:lnTo>
                    <a:pt x="3377" y="2157"/>
                  </a:lnTo>
                  <a:lnTo>
                    <a:pt x="3214" y="2116"/>
                  </a:lnTo>
                  <a:lnTo>
                    <a:pt x="2929" y="2157"/>
                  </a:lnTo>
                  <a:lnTo>
                    <a:pt x="2645" y="2238"/>
                  </a:lnTo>
                  <a:lnTo>
                    <a:pt x="2482" y="2319"/>
                  </a:lnTo>
                  <a:lnTo>
                    <a:pt x="2400" y="2441"/>
                  </a:lnTo>
                  <a:lnTo>
                    <a:pt x="2319" y="2563"/>
                  </a:lnTo>
                  <a:lnTo>
                    <a:pt x="2238" y="2685"/>
                  </a:lnTo>
                  <a:lnTo>
                    <a:pt x="2156" y="3011"/>
                  </a:lnTo>
                  <a:lnTo>
                    <a:pt x="2197" y="3296"/>
                  </a:lnTo>
                  <a:lnTo>
                    <a:pt x="2238" y="3458"/>
                  </a:lnTo>
                  <a:lnTo>
                    <a:pt x="2278" y="3580"/>
                  </a:lnTo>
                  <a:lnTo>
                    <a:pt x="1912" y="3377"/>
                  </a:lnTo>
                  <a:lnTo>
                    <a:pt x="1546" y="3296"/>
                  </a:lnTo>
                  <a:lnTo>
                    <a:pt x="1140" y="3296"/>
                  </a:lnTo>
                  <a:lnTo>
                    <a:pt x="936" y="3336"/>
                  </a:lnTo>
                  <a:lnTo>
                    <a:pt x="733" y="3418"/>
                  </a:lnTo>
                  <a:lnTo>
                    <a:pt x="570" y="3499"/>
                  </a:lnTo>
                  <a:lnTo>
                    <a:pt x="407" y="3621"/>
                  </a:lnTo>
                  <a:lnTo>
                    <a:pt x="245" y="3784"/>
                  </a:lnTo>
                  <a:lnTo>
                    <a:pt x="123" y="3946"/>
                  </a:lnTo>
                  <a:lnTo>
                    <a:pt x="41" y="4109"/>
                  </a:lnTo>
                  <a:lnTo>
                    <a:pt x="1" y="4312"/>
                  </a:lnTo>
                  <a:lnTo>
                    <a:pt x="1" y="4516"/>
                  </a:lnTo>
                  <a:lnTo>
                    <a:pt x="1" y="4719"/>
                  </a:lnTo>
                  <a:lnTo>
                    <a:pt x="123" y="5004"/>
                  </a:lnTo>
                  <a:lnTo>
                    <a:pt x="285" y="5248"/>
                  </a:lnTo>
                  <a:lnTo>
                    <a:pt x="529" y="5451"/>
                  </a:lnTo>
                  <a:lnTo>
                    <a:pt x="773" y="5573"/>
                  </a:lnTo>
                  <a:lnTo>
                    <a:pt x="1099" y="5695"/>
                  </a:lnTo>
                  <a:lnTo>
                    <a:pt x="1424" y="5777"/>
                  </a:lnTo>
                  <a:lnTo>
                    <a:pt x="2075" y="5899"/>
                  </a:lnTo>
                  <a:lnTo>
                    <a:pt x="3133" y="5980"/>
                  </a:lnTo>
                  <a:lnTo>
                    <a:pt x="4231" y="6062"/>
                  </a:lnTo>
                  <a:lnTo>
                    <a:pt x="5288" y="6102"/>
                  </a:lnTo>
                  <a:lnTo>
                    <a:pt x="6387" y="6143"/>
                  </a:lnTo>
                  <a:lnTo>
                    <a:pt x="7973" y="6143"/>
                  </a:lnTo>
                  <a:lnTo>
                    <a:pt x="8380" y="6062"/>
                  </a:lnTo>
                  <a:lnTo>
                    <a:pt x="8787" y="5980"/>
                  </a:lnTo>
                  <a:lnTo>
                    <a:pt x="9112" y="5858"/>
                  </a:lnTo>
                  <a:lnTo>
                    <a:pt x="9437" y="5655"/>
                  </a:lnTo>
                  <a:lnTo>
                    <a:pt x="9559" y="5533"/>
                  </a:lnTo>
                  <a:lnTo>
                    <a:pt x="9682" y="5370"/>
                  </a:lnTo>
                  <a:lnTo>
                    <a:pt x="9844" y="5004"/>
                  </a:lnTo>
                  <a:lnTo>
                    <a:pt x="9966" y="4638"/>
                  </a:lnTo>
                  <a:lnTo>
                    <a:pt x="9966" y="4272"/>
                  </a:lnTo>
                  <a:lnTo>
                    <a:pt x="9885" y="3865"/>
                  </a:lnTo>
                  <a:lnTo>
                    <a:pt x="9763" y="3540"/>
                  </a:lnTo>
                  <a:lnTo>
                    <a:pt x="9519" y="3214"/>
                  </a:lnTo>
                  <a:lnTo>
                    <a:pt x="9397" y="3092"/>
                  </a:lnTo>
                  <a:lnTo>
                    <a:pt x="9234" y="2970"/>
                  </a:lnTo>
                  <a:lnTo>
                    <a:pt x="9031" y="2807"/>
                  </a:lnTo>
                  <a:lnTo>
                    <a:pt x="8787" y="2726"/>
                  </a:lnTo>
                  <a:lnTo>
                    <a:pt x="8502" y="2685"/>
                  </a:lnTo>
                  <a:lnTo>
                    <a:pt x="8014" y="2685"/>
                  </a:lnTo>
                  <a:lnTo>
                    <a:pt x="7729" y="2726"/>
                  </a:lnTo>
                  <a:lnTo>
                    <a:pt x="7485" y="2848"/>
                  </a:lnTo>
                  <a:lnTo>
                    <a:pt x="7282" y="2970"/>
                  </a:lnTo>
                  <a:lnTo>
                    <a:pt x="7322" y="2685"/>
                  </a:lnTo>
                  <a:lnTo>
                    <a:pt x="7322" y="2360"/>
                  </a:lnTo>
                  <a:lnTo>
                    <a:pt x="7282" y="2035"/>
                  </a:lnTo>
                  <a:lnTo>
                    <a:pt x="7200" y="1750"/>
                  </a:lnTo>
                  <a:lnTo>
                    <a:pt x="7119" y="1424"/>
                  </a:lnTo>
                  <a:lnTo>
                    <a:pt x="6997" y="1180"/>
                  </a:lnTo>
                  <a:lnTo>
                    <a:pt x="6834" y="896"/>
                  </a:lnTo>
                  <a:lnTo>
                    <a:pt x="6631" y="652"/>
                  </a:lnTo>
                  <a:lnTo>
                    <a:pt x="6387" y="448"/>
                  </a:lnTo>
                  <a:lnTo>
                    <a:pt x="6143" y="286"/>
                  </a:lnTo>
                  <a:lnTo>
                    <a:pt x="5858" y="123"/>
                  </a:lnTo>
                  <a:lnTo>
                    <a:pt x="5573" y="41"/>
                  </a:lnTo>
                  <a:lnTo>
                    <a:pt x="5248"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75" name="Google Shape;75;p13"/>
          <p:cNvSpPr/>
          <p:nvPr/>
        </p:nvSpPr>
        <p:spPr>
          <a:xfrm>
            <a:off x="8592129" y="2049342"/>
            <a:ext cx="85704" cy="85658"/>
          </a:xfrm>
          <a:custGeom>
            <a:rect b="b" l="l" r="r" t="t"/>
            <a:pathLst>
              <a:path extrusionOk="0" h="1872" w="1873">
                <a:moveTo>
                  <a:pt x="733" y="1"/>
                </a:moveTo>
                <a:lnTo>
                  <a:pt x="489" y="82"/>
                </a:lnTo>
                <a:lnTo>
                  <a:pt x="245" y="245"/>
                </a:lnTo>
                <a:lnTo>
                  <a:pt x="82" y="448"/>
                </a:lnTo>
                <a:lnTo>
                  <a:pt x="1" y="692"/>
                </a:lnTo>
                <a:lnTo>
                  <a:pt x="1" y="936"/>
                </a:lnTo>
                <a:lnTo>
                  <a:pt x="42" y="1180"/>
                </a:lnTo>
                <a:lnTo>
                  <a:pt x="123" y="1424"/>
                </a:lnTo>
                <a:lnTo>
                  <a:pt x="245" y="1546"/>
                </a:lnTo>
                <a:lnTo>
                  <a:pt x="367" y="1668"/>
                </a:lnTo>
                <a:lnTo>
                  <a:pt x="489" y="1750"/>
                </a:lnTo>
                <a:lnTo>
                  <a:pt x="611" y="1831"/>
                </a:lnTo>
                <a:lnTo>
                  <a:pt x="774" y="1872"/>
                </a:lnTo>
                <a:lnTo>
                  <a:pt x="1099" y="1872"/>
                </a:lnTo>
                <a:lnTo>
                  <a:pt x="1221" y="1831"/>
                </a:lnTo>
                <a:lnTo>
                  <a:pt x="1384" y="1750"/>
                </a:lnTo>
                <a:lnTo>
                  <a:pt x="1506" y="1668"/>
                </a:lnTo>
                <a:lnTo>
                  <a:pt x="1628" y="1587"/>
                </a:lnTo>
                <a:lnTo>
                  <a:pt x="1750" y="1465"/>
                </a:lnTo>
                <a:lnTo>
                  <a:pt x="1831" y="1302"/>
                </a:lnTo>
                <a:lnTo>
                  <a:pt x="1872" y="1140"/>
                </a:lnTo>
                <a:lnTo>
                  <a:pt x="1872" y="936"/>
                </a:lnTo>
                <a:lnTo>
                  <a:pt x="1831" y="774"/>
                </a:lnTo>
                <a:lnTo>
                  <a:pt x="1791" y="611"/>
                </a:lnTo>
                <a:lnTo>
                  <a:pt x="1750" y="489"/>
                </a:lnTo>
                <a:lnTo>
                  <a:pt x="1628" y="367"/>
                </a:lnTo>
                <a:lnTo>
                  <a:pt x="1547" y="245"/>
                </a:lnTo>
                <a:lnTo>
                  <a:pt x="1262" y="82"/>
                </a:lnTo>
                <a:lnTo>
                  <a:pt x="97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76" name="Google Shape;76;p13"/>
          <p:cNvGrpSpPr/>
          <p:nvPr/>
        </p:nvGrpSpPr>
        <p:grpSpPr>
          <a:xfrm>
            <a:off x="8842893" y="3018742"/>
            <a:ext cx="474643" cy="299712"/>
            <a:chOff x="7729218" y="1694205"/>
            <a:chExt cx="474643" cy="299712"/>
          </a:xfrm>
        </p:grpSpPr>
        <p:sp>
          <p:nvSpPr>
            <p:cNvPr id="77" name="Google Shape;77;p13"/>
            <p:cNvSpPr/>
            <p:nvPr/>
          </p:nvSpPr>
          <p:spPr>
            <a:xfrm>
              <a:off x="7729218" y="1694205"/>
              <a:ext cx="474643" cy="299712"/>
            </a:xfrm>
            <a:custGeom>
              <a:rect b="b" l="l" r="r" t="t"/>
              <a:pathLst>
                <a:path extrusionOk="0" h="6550" w="10373">
                  <a:moveTo>
                    <a:pt x="5451" y="366"/>
                  </a:moveTo>
                  <a:lnTo>
                    <a:pt x="5654" y="407"/>
                  </a:lnTo>
                  <a:lnTo>
                    <a:pt x="5858" y="489"/>
                  </a:lnTo>
                  <a:lnTo>
                    <a:pt x="6102" y="570"/>
                  </a:lnTo>
                  <a:lnTo>
                    <a:pt x="6264" y="651"/>
                  </a:lnTo>
                  <a:lnTo>
                    <a:pt x="6468" y="814"/>
                  </a:lnTo>
                  <a:lnTo>
                    <a:pt x="6752" y="1099"/>
                  </a:lnTo>
                  <a:lnTo>
                    <a:pt x="6996" y="1465"/>
                  </a:lnTo>
                  <a:lnTo>
                    <a:pt x="7159" y="1871"/>
                  </a:lnTo>
                  <a:lnTo>
                    <a:pt x="7281" y="2278"/>
                  </a:lnTo>
                  <a:lnTo>
                    <a:pt x="7322" y="2726"/>
                  </a:lnTo>
                  <a:lnTo>
                    <a:pt x="7281" y="3173"/>
                  </a:lnTo>
                  <a:lnTo>
                    <a:pt x="7322" y="3295"/>
                  </a:lnTo>
                  <a:lnTo>
                    <a:pt x="7363" y="3336"/>
                  </a:lnTo>
                  <a:lnTo>
                    <a:pt x="7485" y="3377"/>
                  </a:lnTo>
                  <a:lnTo>
                    <a:pt x="7566" y="3336"/>
                  </a:lnTo>
                  <a:lnTo>
                    <a:pt x="7851" y="3214"/>
                  </a:lnTo>
                  <a:lnTo>
                    <a:pt x="8095" y="3132"/>
                  </a:lnTo>
                  <a:lnTo>
                    <a:pt x="8379" y="3092"/>
                  </a:lnTo>
                  <a:lnTo>
                    <a:pt x="8664" y="3092"/>
                  </a:lnTo>
                  <a:lnTo>
                    <a:pt x="8949" y="3132"/>
                  </a:lnTo>
                  <a:lnTo>
                    <a:pt x="9193" y="3254"/>
                  </a:lnTo>
                  <a:lnTo>
                    <a:pt x="9437" y="3417"/>
                  </a:lnTo>
                  <a:lnTo>
                    <a:pt x="9640" y="3621"/>
                  </a:lnTo>
                  <a:lnTo>
                    <a:pt x="9762" y="3824"/>
                  </a:lnTo>
                  <a:lnTo>
                    <a:pt x="9885" y="4027"/>
                  </a:lnTo>
                  <a:lnTo>
                    <a:pt x="9925" y="4271"/>
                  </a:lnTo>
                  <a:lnTo>
                    <a:pt x="9966" y="4515"/>
                  </a:lnTo>
                  <a:lnTo>
                    <a:pt x="9966" y="4759"/>
                  </a:lnTo>
                  <a:lnTo>
                    <a:pt x="9925" y="5004"/>
                  </a:lnTo>
                  <a:lnTo>
                    <a:pt x="9844" y="5207"/>
                  </a:lnTo>
                  <a:lnTo>
                    <a:pt x="9762" y="5410"/>
                  </a:lnTo>
                  <a:lnTo>
                    <a:pt x="9600" y="5614"/>
                  </a:lnTo>
                  <a:lnTo>
                    <a:pt x="9396" y="5776"/>
                  </a:lnTo>
                  <a:lnTo>
                    <a:pt x="9193" y="5898"/>
                  </a:lnTo>
                  <a:lnTo>
                    <a:pt x="8949" y="5980"/>
                  </a:lnTo>
                  <a:lnTo>
                    <a:pt x="8461" y="6102"/>
                  </a:lnTo>
                  <a:lnTo>
                    <a:pt x="7932" y="6142"/>
                  </a:lnTo>
                  <a:lnTo>
                    <a:pt x="5654" y="6142"/>
                  </a:lnTo>
                  <a:lnTo>
                    <a:pt x="3946" y="6061"/>
                  </a:lnTo>
                  <a:lnTo>
                    <a:pt x="2278" y="5898"/>
                  </a:lnTo>
                  <a:lnTo>
                    <a:pt x="1709" y="5817"/>
                  </a:lnTo>
                  <a:lnTo>
                    <a:pt x="1424" y="5736"/>
                  </a:lnTo>
                  <a:lnTo>
                    <a:pt x="1139" y="5654"/>
                  </a:lnTo>
                  <a:lnTo>
                    <a:pt x="895" y="5532"/>
                  </a:lnTo>
                  <a:lnTo>
                    <a:pt x="651" y="5370"/>
                  </a:lnTo>
                  <a:lnTo>
                    <a:pt x="488" y="5126"/>
                  </a:lnTo>
                  <a:lnTo>
                    <a:pt x="407" y="4882"/>
                  </a:lnTo>
                  <a:lnTo>
                    <a:pt x="407" y="4719"/>
                  </a:lnTo>
                  <a:lnTo>
                    <a:pt x="407" y="4556"/>
                  </a:lnTo>
                  <a:lnTo>
                    <a:pt x="448" y="4393"/>
                  </a:lnTo>
                  <a:lnTo>
                    <a:pt x="529" y="4231"/>
                  </a:lnTo>
                  <a:lnTo>
                    <a:pt x="732" y="3987"/>
                  </a:lnTo>
                  <a:lnTo>
                    <a:pt x="976" y="3824"/>
                  </a:lnTo>
                  <a:lnTo>
                    <a:pt x="1139" y="3743"/>
                  </a:lnTo>
                  <a:lnTo>
                    <a:pt x="1343" y="3702"/>
                  </a:lnTo>
                  <a:lnTo>
                    <a:pt x="1709" y="3702"/>
                  </a:lnTo>
                  <a:lnTo>
                    <a:pt x="2075" y="3783"/>
                  </a:lnTo>
                  <a:lnTo>
                    <a:pt x="2400" y="3946"/>
                  </a:lnTo>
                  <a:lnTo>
                    <a:pt x="2481" y="3987"/>
                  </a:lnTo>
                  <a:lnTo>
                    <a:pt x="2522" y="3987"/>
                  </a:lnTo>
                  <a:lnTo>
                    <a:pt x="2644" y="3905"/>
                  </a:lnTo>
                  <a:lnTo>
                    <a:pt x="2685" y="3824"/>
                  </a:lnTo>
                  <a:lnTo>
                    <a:pt x="2685" y="3743"/>
                  </a:lnTo>
                  <a:lnTo>
                    <a:pt x="2685" y="3661"/>
                  </a:lnTo>
                  <a:lnTo>
                    <a:pt x="2563" y="3417"/>
                  </a:lnTo>
                  <a:lnTo>
                    <a:pt x="2563" y="3173"/>
                  </a:lnTo>
                  <a:lnTo>
                    <a:pt x="2644" y="2970"/>
                  </a:lnTo>
                  <a:lnTo>
                    <a:pt x="2766" y="2766"/>
                  </a:lnTo>
                  <a:lnTo>
                    <a:pt x="2929" y="2644"/>
                  </a:lnTo>
                  <a:lnTo>
                    <a:pt x="3173" y="2563"/>
                  </a:lnTo>
                  <a:lnTo>
                    <a:pt x="3417" y="2522"/>
                  </a:lnTo>
                  <a:lnTo>
                    <a:pt x="3661" y="2604"/>
                  </a:lnTo>
                  <a:lnTo>
                    <a:pt x="3783" y="2604"/>
                  </a:lnTo>
                  <a:lnTo>
                    <a:pt x="3864" y="2522"/>
                  </a:lnTo>
                  <a:lnTo>
                    <a:pt x="3905" y="2400"/>
                  </a:lnTo>
                  <a:lnTo>
                    <a:pt x="3864" y="2278"/>
                  </a:lnTo>
                  <a:lnTo>
                    <a:pt x="3824" y="2116"/>
                  </a:lnTo>
                  <a:lnTo>
                    <a:pt x="3783" y="1912"/>
                  </a:lnTo>
                  <a:lnTo>
                    <a:pt x="3783" y="1749"/>
                  </a:lnTo>
                  <a:lnTo>
                    <a:pt x="3824" y="1546"/>
                  </a:lnTo>
                  <a:lnTo>
                    <a:pt x="3864" y="1383"/>
                  </a:lnTo>
                  <a:lnTo>
                    <a:pt x="3946" y="1180"/>
                  </a:lnTo>
                  <a:lnTo>
                    <a:pt x="4149" y="895"/>
                  </a:lnTo>
                  <a:lnTo>
                    <a:pt x="4312" y="733"/>
                  </a:lnTo>
                  <a:lnTo>
                    <a:pt x="4475" y="611"/>
                  </a:lnTo>
                  <a:lnTo>
                    <a:pt x="4637" y="529"/>
                  </a:lnTo>
                  <a:lnTo>
                    <a:pt x="4841" y="448"/>
                  </a:lnTo>
                  <a:lnTo>
                    <a:pt x="5044" y="407"/>
                  </a:lnTo>
                  <a:lnTo>
                    <a:pt x="5247" y="366"/>
                  </a:lnTo>
                  <a:close/>
                  <a:moveTo>
                    <a:pt x="5003" y="0"/>
                  </a:moveTo>
                  <a:lnTo>
                    <a:pt x="4759" y="41"/>
                  </a:lnTo>
                  <a:lnTo>
                    <a:pt x="4515" y="122"/>
                  </a:lnTo>
                  <a:lnTo>
                    <a:pt x="4312" y="244"/>
                  </a:lnTo>
                  <a:lnTo>
                    <a:pt x="4108" y="366"/>
                  </a:lnTo>
                  <a:lnTo>
                    <a:pt x="3946" y="529"/>
                  </a:lnTo>
                  <a:lnTo>
                    <a:pt x="3783" y="692"/>
                  </a:lnTo>
                  <a:lnTo>
                    <a:pt x="3661" y="895"/>
                  </a:lnTo>
                  <a:lnTo>
                    <a:pt x="3539" y="1139"/>
                  </a:lnTo>
                  <a:lnTo>
                    <a:pt x="3458" y="1343"/>
                  </a:lnTo>
                  <a:lnTo>
                    <a:pt x="3417" y="1587"/>
                  </a:lnTo>
                  <a:lnTo>
                    <a:pt x="3417" y="1790"/>
                  </a:lnTo>
                  <a:lnTo>
                    <a:pt x="3417" y="2034"/>
                  </a:lnTo>
                  <a:lnTo>
                    <a:pt x="3431" y="2119"/>
                  </a:lnTo>
                  <a:lnTo>
                    <a:pt x="3431" y="2119"/>
                  </a:lnTo>
                  <a:lnTo>
                    <a:pt x="3417" y="2116"/>
                  </a:lnTo>
                  <a:lnTo>
                    <a:pt x="3254" y="2116"/>
                  </a:lnTo>
                  <a:lnTo>
                    <a:pt x="3051" y="2156"/>
                  </a:lnTo>
                  <a:lnTo>
                    <a:pt x="2888" y="2197"/>
                  </a:lnTo>
                  <a:lnTo>
                    <a:pt x="2725" y="2278"/>
                  </a:lnTo>
                  <a:lnTo>
                    <a:pt x="2603" y="2360"/>
                  </a:lnTo>
                  <a:lnTo>
                    <a:pt x="2441" y="2482"/>
                  </a:lnTo>
                  <a:lnTo>
                    <a:pt x="2359" y="2644"/>
                  </a:lnTo>
                  <a:lnTo>
                    <a:pt x="2237" y="2807"/>
                  </a:lnTo>
                  <a:lnTo>
                    <a:pt x="2197" y="2970"/>
                  </a:lnTo>
                  <a:lnTo>
                    <a:pt x="2156" y="3173"/>
                  </a:lnTo>
                  <a:lnTo>
                    <a:pt x="2156" y="3336"/>
                  </a:lnTo>
                  <a:lnTo>
                    <a:pt x="2170" y="3407"/>
                  </a:lnTo>
                  <a:lnTo>
                    <a:pt x="1993" y="3336"/>
                  </a:lnTo>
                  <a:lnTo>
                    <a:pt x="1749" y="3295"/>
                  </a:lnTo>
                  <a:lnTo>
                    <a:pt x="1302" y="3295"/>
                  </a:lnTo>
                  <a:lnTo>
                    <a:pt x="1098" y="3336"/>
                  </a:lnTo>
                  <a:lnTo>
                    <a:pt x="854" y="3417"/>
                  </a:lnTo>
                  <a:lnTo>
                    <a:pt x="692" y="3499"/>
                  </a:lnTo>
                  <a:lnTo>
                    <a:pt x="529" y="3621"/>
                  </a:lnTo>
                  <a:lnTo>
                    <a:pt x="366" y="3783"/>
                  </a:lnTo>
                  <a:lnTo>
                    <a:pt x="244" y="3946"/>
                  </a:lnTo>
                  <a:lnTo>
                    <a:pt x="122" y="4109"/>
                  </a:lnTo>
                  <a:lnTo>
                    <a:pt x="41" y="4312"/>
                  </a:lnTo>
                  <a:lnTo>
                    <a:pt x="0" y="4515"/>
                  </a:lnTo>
                  <a:lnTo>
                    <a:pt x="0" y="4719"/>
                  </a:lnTo>
                  <a:lnTo>
                    <a:pt x="0" y="4922"/>
                  </a:lnTo>
                  <a:lnTo>
                    <a:pt x="41" y="5126"/>
                  </a:lnTo>
                  <a:lnTo>
                    <a:pt x="122" y="5288"/>
                  </a:lnTo>
                  <a:lnTo>
                    <a:pt x="204" y="5451"/>
                  </a:lnTo>
                  <a:lnTo>
                    <a:pt x="488" y="5695"/>
                  </a:lnTo>
                  <a:lnTo>
                    <a:pt x="773" y="5898"/>
                  </a:lnTo>
                  <a:lnTo>
                    <a:pt x="1139" y="6061"/>
                  </a:lnTo>
                  <a:lnTo>
                    <a:pt x="1505" y="6183"/>
                  </a:lnTo>
                  <a:lnTo>
                    <a:pt x="1912" y="6265"/>
                  </a:lnTo>
                  <a:lnTo>
                    <a:pt x="2278" y="6305"/>
                  </a:lnTo>
                  <a:lnTo>
                    <a:pt x="4027" y="6427"/>
                  </a:lnTo>
                  <a:lnTo>
                    <a:pt x="5776" y="6509"/>
                  </a:lnTo>
                  <a:lnTo>
                    <a:pt x="7119" y="6549"/>
                  </a:lnTo>
                  <a:lnTo>
                    <a:pt x="7769" y="6549"/>
                  </a:lnTo>
                  <a:lnTo>
                    <a:pt x="8420" y="6509"/>
                  </a:lnTo>
                  <a:lnTo>
                    <a:pt x="8990" y="6387"/>
                  </a:lnTo>
                  <a:lnTo>
                    <a:pt x="9234" y="6305"/>
                  </a:lnTo>
                  <a:lnTo>
                    <a:pt x="9478" y="6183"/>
                  </a:lnTo>
                  <a:lnTo>
                    <a:pt x="9722" y="6020"/>
                  </a:lnTo>
                  <a:lnTo>
                    <a:pt x="9925" y="5858"/>
                  </a:lnTo>
                  <a:lnTo>
                    <a:pt x="10088" y="5654"/>
                  </a:lnTo>
                  <a:lnTo>
                    <a:pt x="10210" y="5370"/>
                  </a:lnTo>
                  <a:lnTo>
                    <a:pt x="10291" y="5126"/>
                  </a:lnTo>
                  <a:lnTo>
                    <a:pt x="10373" y="4882"/>
                  </a:lnTo>
                  <a:lnTo>
                    <a:pt x="10373" y="4597"/>
                  </a:lnTo>
                  <a:lnTo>
                    <a:pt x="10332" y="4312"/>
                  </a:lnTo>
                  <a:lnTo>
                    <a:pt x="10291" y="4068"/>
                  </a:lnTo>
                  <a:lnTo>
                    <a:pt x="10210" y="3783"/>
                  </a:lnTo>
                  <a:lnTo>
                    <a:pt x="10088" y="3539"/>
                  </a:lnTo>
                  <a:lnTo>
                    <a:pt x="9925" y="3336"/>
                  </a:lnTo>
                  <a:lnTo>
                    <a:pt x="9681" y="3092"/>
                  </a:lnTo>
                  <a:lnTo>
                    <a:pt x="9396" y="2888"/>
                  </a:lnTo>
                  <a:lnTo>
                    <a:pt x="9071" y="2766"/>
                  </a:lnTo>
                  <a:lnTo>
                    <a:pt x="8705" y="2685"/>
                  </a:lnTo>
                  <a:lnTo>
                    <a:pt x="8379" y="2685"/>
                  </a:lnTo>
                  <a:lnTo>
                    <a:pt x="8013" y="2726"/>
                  </a:lnTo>
                  <a:lnTo>
                    <a:pt x="7688" y="2848"/>
                  </a:lnTo>
                  <a:lnTo>
                    <a:pt x="7688" y="2644"/>
                  </a:lnTo>
                  <a:lnTo>
                    <a:pt x="7647" y="2075"/>
                  </a:lnTo>
                  <a:lnTo>
                    <a:pt x="7485" y="1587"/>
                  </a:lnTo>
                  <a:lnTo>
                    <a:pt x="7363" y="1343"/>
                  </a:lnTo>
                  <a:lnTo>
                    <a:pt x="7241" y="1099"/>
                  </a:lnTo>
                  <a:lnTo>
                    <a:pt x="7078" y="895"/>
                  </a:lnTo>
                  <a:lnTo>
                    <a:pt x="6915" y="692"/>
                  </a:lnTo>
                  <a:lnTo>
                    <a:pt x="6712" y="489"/>
                  </a:lnTo>
                  <a:lnTo>
                    <a:pt x="6508" y="366"/>
                  </a:lnTo>
                  <a:lnTo>
                    <a:pt x="6264" y="204"/>
                  </a:lnTo>
                  <a:lnTo>
                    <a:pt x="6020" y="122"/>
                  </a:lnTo>
                  <a:lnTo>
                    <a:pt x="5776" y="41"/>
                  </a:lnTo>
                  <a:lnTo>
                    <a:pt x="5491" y="0"/>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78" name="Google Shape;78;p13"/>
            <p:cNvSpPr/>
            <p:nvPr/>
          </p:nvSpPr>
          <p:spPr>
            <a:xfrm>
              <a:off x="7738507" y="1703494"/>
              <a:ext cx="456065" cy="281088"/>
            </a:xfrm>
            <a:custGeom>
              <a:rect b="b" l="l" r="r" t="t"/>
              <a:pathLst>
                <a:path extrusionOk="0" h="6143" w="9967">
                  <a:moveTo>
                    <a:pt x="4963" y="1"/>
                  </a:moveTo>
                  <a:lnTo>
                    <a:pt x="4638" y="41"/>
                  </a:lnTo>
                  <a:lnTo>
                    <a:pt x="4353" y="123"/>
                  </a:lnTo>
                  <a:lnTo>
                    <a:pt x="4068" y="286"/>
                  </a:lnTo>
                  <a:lnTo>
                    <a:pt x="3865" y="489"/>
                  </a:lnTo>
                  <a:lnTo>
                    <a:pt x="3661" y="733"/>
                  </a:lnTo>
                  <a:lnTo>
                    <a:pt x="3499" y="1018"/>
                  </a:lnTo>
                  <a:lnTo>
                    <a:pt x="3417" y="1302"/>
                  </a:lnTo>
                  <a:lnTo>
                    <a:pt x="3377" y="1587"/>
                  </a:lnTo>
                  <a:lnTo>
                    <a:pt x="3417" y="1913"/>
                  </a:lnTo>
                  <a:lnTo>
                    <a:pt x="3499" y="2197"/>
                  </a:lnTo>
                  <a:lnTo>
                    <a:pt x="3377" y="2157"/>
                  </a:lnTo>
                  <a:lnTo>
                    <a:pt x="3214" y="2116"/>
                  </a:lnTo>
                  <a:lnTo>
                    <a:pt x="2929" y="2157"/>
                  </a:lnTo>
                  <a:lnTo>
                    <a:pt x="2645" y="2238"/>
                  </a:lnTo>
                  <a:lnTo>
                    <a:pt x="2482" y="2319"/>
                  </a:lnTo>
                  <a:lnTo>
                    <a:pt x="2400" y="2441"/>
                  </a:lnTo>
                  <a:lnTo>
                    <a:pt x="2319" y="2563"/>
                  </a:lnTo>
                  <a:lnTo>
                    <a:pt x="2238" y="2685"/>
                  </a:lnTo>
                  <a:lnTo>
                    <a:pt x="2156" y="3011"/>
                  </a:lnTo>
                  <a:lnTo>
                    <a:pt x="2197" y="3296"/>
                  </a:lnTo>
                  <a:lnTo>
                    <a:pt x="2238" y="3458"/>
                  </a:lnTo>
                  <a:lnTo>
                    <a:pt x="2278" y="3580"/>
                  </a:lnTo>
                  <a:lnTo>
                    <a:pt x="1912" y="3377"/>
                  </a:lnTo>
                  <a:lnTo>
                    <a:pt x="1546" y="3296"/>
                  </a:lnTo>
                  <a:lnTo>
                    <a:pt x="1140" y="3296"/>
                  </a:lnTo>
                  <a:lnTo>
                    <a:pt x="936" y="3336"/>
                  </a:lnTo>
                  <a:lnTo>
                    <a:pt x="733" y="3418"/>
                  </a:lnTo>
                  <a:lnTo>
                    <a:pt x="570" y="3499"/>
                  </a:lnTo>
                  <a:lnTo>
                    <a:pt x="407" y="3621"/>
                  </a:lnTo>
                  <a:lnTo>
                    <a:pt x="245" y="3784"/>
                  </a:lnTo>
                  <a:lnTo>
                    <a:pt x="123" y="3946"/>
                  </a:lnTo>
                  <a:lnTo>
                    <a:pt x="41" y="4109"/>
                  </a:lnTo>
                  <a:lnTo>
                    <a:pt x="1" y="4312"/>
                  </a:lnTo>
                  <a:lnTo>
                    <a:pt x="1" y="4516"/>
                  </a:lnTo>
                  <a:lnTo>
                    <a:pt x="1" y="4719"/>
                  </a:lnTo>
                  <a:lnTo>
                    <a:pt x="123" y="5004"/>
                  </a:lnTo>
                  <a:lnTo>
                    <a:pt x="285" y="5248"/>
                  </a:lnTo>
                  <a:lnTo>
                    <a:pt x="529" y="5451"/>
                  </a:lnTo>
                  <a:lnTo>
                    <a:pt x="773" y="5573"/>
                  </a:lnTo>
                  <a:lnTo>
                    <a:pt x="1099" y="5695"/>
                  </a:lnTo>
                  <a:lnTo>
                    <a:pt x="1424" y="5777"/>
                  </a:lnTo>
                  <a:lnTo>
                    <a:pt x="2075" y="5899"/>
                  </a:lnTo>
                  <a:lnTo>
                    <a:pt x="3133" y="5980"/>
                  </a:lnTo>
                  <a:lnTo>
                    <a:pt x="4231" y="6062"/>
                  </a:lnTo>
                  <a:lnTo>
                    <a:pt x="5288" y="6102"/>
                  </a:lnTo>
                  <a:lnTo>
                    <a:pt x="6387" y="6143"/>
                  </a:lnTo>
                  <a:lnTo>
                    <a:pt x="7973" y="6143"/>
                  </a:lnTo>
                  <a:lnTo>
                    <a:pt x="8380" y="6062"/>
                  </a:lnTo>
                  <a:lnTo>
                    <a:pt x="8787" y="5980"/>
                  </a:lnTo>
                  <a:lnTo>
                    <a:pt x="9112" y="5858"/>
                  </a:lnTo>
                  <a:lnTo>
                    <a:pt x="9437" y="5655"/>
                  </a:lnTo>
                  <a:lnTo>
                    <a:pt x="9559" y="5533"/>
                  </a:lnTo>
                  <a:lnTo>
                    <a:pt x="9682" y="5370"/>
                  </a:lnTo>
                  <a:lnTo>
                    <a:pt x="9844" y="5004"/>
                  </a:lnTo>
                  <a:lnTo>
                    <a:pt x="9966" y="4638"/>
                  </a:lnTo>
                  <a:lnTo>
                    <a:pt x="9966" y="4272"/>
                  </a:lnTo>
                  <a:lnTo>
                    <a:pt x="9885" y="3865"/>
                  </a:lnTo>
                  <a:lnTo>
                    <a:pt x="9763" y="3540"/>
                  </a:lnTo>
                  <a:lnTo>
                    <a:pt x="9519" y="3214"/>
                  </a:lnTo>
                  <a:lnTo>
                    <a:pt x="9397" y="3092"/>
                  </a:lnTo>
                  <a:lnTo>
                    <a:pt x="9234" y="2970"/>
                  </a:lnTo>
                  <a:lnTo>
                    <a:pt x="9031" y="2807"/>
                  </a:lnTo>
                  <a:lnTo>
                    <a:pt x="8787" y="2726"/>
                  </a:lnTo>
                  <a:lnTo>
                    <a:pt x="8502" y="2685"/>
                  </a:lnTo>
                  <a:lnTo>
                    <a:pt x="8014" y="2685"/>
                  </a:lnTo>
                  <a:lnTo>
                    <a:pt x="7729" y="2726"/>
                  </a:lnTo>
                  <a:lnTo>
                    <a:pt x="7485" y="2848"/>
                  </a:lnTo>
                  <a:lnTo>
                    <a:pt x="7282" y="2970"/>
                  </a:lnTo>
                  <a:lnTo>
                    <a:pt x="7322" y="2685"/>
                  </a:lnTo>
                  <a:lnTo>
                    <a:pt x="7322" y="2360"/>
                  </a:lnTo>
                  <a:lnTo>
                    <a:pt x="7282" y="2035"/>
                  </a:lnTo>
                  <a:lnTo>
                    <a:pt x="7200" y="1750"/>
                  </a:lnTo>
                  <a:lnTo>
                    <a:pt x="7119" y="1424"/>
                  </a:lnTo>
                  <a:lnTo>
                    <a:pt x="6997" y="1180"/>
                  </a:lnTo>
                  <a:lnTo>
                    <a:pt x="6834" y="896"/>
                  </a:lnTo>
                  <a:lnTo>
                    <a:pt x="6631" y="652"/>
                  </a:lnTo>
                  <a:lnTo>
                    <a:pt x="6387" y="448"/>
                  </a:lnTo>
                  <a:lnTo>
                    <a:pt x="6143" y="286"/>
                  </a:lnTo>
                  <a:lnTo>
                    <a:pt x="5858" y="123"/>
                  </a:lnTo>
                  <a:lnTo>
                    <a:pt x="5573" y="41"/>
                  </a:lnTo>
                  <a:lnTo>
                    <a:pt x="5248"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79" name="Google Shape;79;p13"/>
          <p:cNvSpPr/>
          <p:nvPr/>
        </p:nvSpPr>
        <p:spPr>
          <a:xfrm>
            <a:off x="278996" y="3091338"/>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0" name="Google Shape;80;p13"/>
          <p:cNvSpPr/>
          <p:nvPr/>
        </p:nvSpPr>
        <p:spPr>
          <a:xfrm>
            <a:off x="521097" y="4210084"/>
            <a:ext cx="303418" cy="303418"/>
          </a:xfrm>
          <a:custGeom>
            <a:rect b="b" l="l" r="r" t="t"/>
            <a:pathLst>
              <a:path extrusionOk="0" h="6631" w="6631">
                <a:moveTo>
                  <a:pt x="2685" y="1"/>
                </a:moveTo>
                <a:lnTo>
                  <a:pt x="2604" y="41"/>
                </a:lnTo>
                <a:lnTo>
                  <a:pt x="2563" y="123"/>
                </a:lnTo>
                <a:lnTo>
                  <a:pt x="2563" y="204"/>
                </a:lnTo>
                <a:lnTo>
                  <a:pt x="2604" y="2604"/>
                </a:lnTo>
                <a:lnTo>
                  <a:pt x="204" y="2645"/>
                </a:lnTo>
                <a:lnTo>
                  <a:pt x="123" y="2645"/>
                </a:lnTo>
                <a:lnTo>
                  <a:pt x="41" y="2685"/>
                </a:lnTo>
                <a:lnTo>
                  <a:pt x="1" y="2767"/>
                </a:lnTo>
                <a:lnTo>
                  <a:pt x="1" y="2807"/>
                </a:lnTo>
                <a:lnTo>
                  <a:pt x="1" y="3865"/>
                </a:lnTo>
                <a:lnTo>
                  <a:pt x="1" y="3946"/>
                </a:lnTo>
                <a:lnTo>
                  <a:pt x="82" y="4028"/>
                </a:lnTo>
                <a:lnTo>
                  <a:pt x="285" y="4028"/>
                </a:lnTo>
                <a:lnTo>
                  <a:pt x="367" y="3987"/>
                </a:lnTo>
                <a:lnTo>
                  <a:pt x="529" y="3987"/>
                </a:lnTo>
                <a:lnTo>
                  <a:pt x="1099" y="3946"/>
                </a:lnTo>
                <a:lnTo>
                  <a:pt x="2604" y="3946"/>
                </a:lnTo>
                <a:lnTo>
                  <a:pt x="2645" y="6427"/>
                </a:lnTo>
                <a:lnTo>
                  <a:pt x="2645" y="6509"/>
                </a:lnTo>
                <a:lnTo>
                  <a:pt x="2685" y="6549"/>
                </a:lnTo>
                <a:lnTo>
                  <a:pt x="2767" y="6590"/>
                </a:lnTo>
                <a:lnTo>
                  <a:pt x="2848" y="6631"/>
                </a:lnTo>
                <a:lnTo>
                  <a:pt x="3865" y="6631"/>
                </a:lnTo>
                <a:lnTo>
                  <a:pt x="3946" y="6590"/>
                </a:lnTo>
                <a:lnTo>
                  <a:pt x="3987" y="6590"/>
                </a:lnTo>
                <a:lnTo>
                  <a:pt x="4068" y="6468"/>
                </a:lnTo>
                <a:lnTo>
                  <a:pt x="4028" y="6305"/>
                </a:lnTo>
                <a:lnTo>
                  <a:pt x="4028" y="6224"/>
                </a:lnTo>
                <a:lnTo>
                  <a:pt x="3987" y="6061"/>
                </a:lnTo>
                <a:lnTo>
                  <a:pt x="3987" y="5451"/>
                </a:lnTo>
                <a:lnTo>
                  <a:pt x="3946" y="3946"/>
                </a:lnTo>
                <a:lnTo>
                  <a:pt x="6509" y="3946"/>
                </a:lnTo>
                <a:lnTo>
                  <a:pt x="6550" y="3906"/>
                </a:lnTo>
                <a:lnTo>
                  <a:pt x="6590" y="3824"/>
                </a:lnTo>
                <a:lnTo>
                  <a:pt x="6631" y="3743"/>
                </a:lnTo>
                <a:lnTo>
                  <a:pt x="6631" y="2767"/>
                </a:lnTo>
                <a:lnTo>
                  <a:pt x="6590" y="2685"/>
                </a:lnTo>
                <a:lnTo>
                  <a:pt x="6550" y="2604"/>
                </a:lnTo>
                <a:lnTo>
                  <a:pt x="6509" y="2563"/>
                </a:lnTo>
                <a:lnTo>
                  <a:pt x="3946" y="2563"/>
                </a:lnTo>
                <a:lnTo>
                  <a:pt x="3946" y="163"/>
                </a:lnTo>
                <a:lnTo>
                  <a:pt x="3946" y="123"/>
                </a:lnTo>
                <a:lnTo>
                  <a:pt x="3906" y="41"/>
                </a:lnTo>
                <a:lnTo>
                  <a:pt x="3824"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1" name="Google Shape;81;p13"/>
          <p:cNvSpPr/>
          <p:nvPr/>
        </p:nvSpPr>
        <p:spPr>
          <a:xfrm>
            <a:off x="-1922700" y="4267362"/>
            <a:ext cx="3656709" cy="2101870"/>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82" name="Google Shape;82;p13"/>
          <p:cNvGrpSpPr/>
          <p:nvPr/>
        </p:nvGrpSpPr>
        <p:grpSpPr>
          <a:xfrm rot="10800000">
            <a:off x="7371465" y="3831622"/>
            <a:ext cx="2299701" cy="1685267"/>
            <a:chOff x="238125" y="896375"/>
            <a:chExt cx="635575" cy="465775"/>
          </a:xfrm>
        </p:grpSpPr>
        <p:sp>
          <p:nvSpPr>
            <p:cNvPr id="83" name="Google Shape;83;p13"/>
            <p:cNvSpPr/>
            <p:nvPr/>
          </p:nvSpPr>
          <p:spPr>
            <a:xfrm>
              <a:off x="258450" y="937050"/>
              <a:ext cx="615250" cy="425100"/>
            </a:xfrm>
            <a:custGeom>
              <a:rect b="b" l="l" r="r" t="t"/>
              <a:pathLst>
                <a:path extrusionOk="0" h="17004" w="24610">
                  <a:moveTo>
                    <a:pt x="24366" y="1"/>
                  </a:moveTo>
                  <a:lnTo>
                    <a:pt x="24325" y="41"/>
                  </a:lnTo>
                  <a:lnTo>
                    <a:pt x="19891" y="4394"/>
                  </a:lnTo>
                  <a:lnTo>
                    <a:pt x="15457" y="8705"/>
                  </a:lnTo>
                  <a:lnTo>
                    <a:pt x="14441" y="9682"/>
                  </a:lnTo>
                  <a:lnTo>
                    <a:pt x="13383" y="10658"/>
                  </a:lnTo>
                  <a:lnTo>
                    <a:pt x="12325" y="11593"/>
                  </a:lnTo>
                  <a:lnTo>
                    <a:pt x="11227" y="12488"/>
                  </a:lnTo>
                  <a:lnTo>
                    <a:pt x="10048" y="13342"/>
                  </a:lnTo>
                  <a:lnTo>
                    <a:pt x="8868" y="14115"/>
                  </a:lnTo>
                  <a:lnTo>
                    <a:pt x="8258" y="14481"/>
                  </a:lnTo>
                  <a:lnTo>
                    <a:pt x="7648" y="14807"/>
                  </a:lnTo>
                  <a:lnTo>
                    <a:pt x="6997" y="15132"/>
                  </a:lnTo>
                  <a:lnTo>
                    <a:pt x="6346" y="15417"/>
                  </a:lnTo>
                  <a:lnTo>
                    <a:pt x="5614" y="15702"/>
                  </a:lnTo>
                  <a:lnTo>
                    <a:pt x="4841" y="15986"/>
                  </a:lnTo>
                  <a:lnTo>
                    <a:pt x="4109" y="16190"/>
                  </a:lnTo>
                  <a:lnTo>
                    <a:pt x="3336" y="16352"/>
                  </a:lnTo>
                  <a:lnTo>
                    <a:pt x="2563" y="16515"/>
                  </a:lnTo>
                  <a:lnTo>
                    <a:pt x="1750" y="16597"/>
                  </a:lnTo>
                  <a:lnTo>
                    <a:pt x="977" y="16637"/>
                  </a:lnTo>
                  <a:lnTo>
                    <a:pt x="204" y="16597"/>
                  </a:lnTo>
                  <a:lnTo>
                    <a:pt x="123" y="16637"/>
                  </a:lnTo>
                  <a:lnTo>
                    <a:pt x="41" y="16678"/>
                  </a:lnTo>
                  <a:lnTo>
                    <a:pt x="1" y="16719"/>
                  </a:lnTo>
                  <a:lnTo>
                    <a:pt x="1" y="16800"/>
                  </a:lnTo>
                  <a:lnTo>
                    <a:pt x="1" y="16841"/>
                  </a:lnTo>
                  <a:lnTo>
                    <a:pt x="41" y="16922"/>
                  </a:lnTo>
                  <a:lnTo>
                    <a:pt x="123" y="16963"/>
                  </a:lnTo>
                  <a:lnTo>
                    <a:pt x="204" y="17003"/>
                  </a:lnTo>
                  <a:lnTo>
                    <a:pt x="895" y="17003"/>
                  </a:lnTo>
                  <a:lnTo>
                    <a:pt x="1587" y="16963"/>
                  </a:lnTo>
                  <a:lnTo>
                    <a:pt x="2319" y="16922"/>
                  </a:lnTo>
                  <a:lnTo>
                    <a:pt x="3011" y="16800"/>
                  </a:lnTo>
                  <a:lnTo>
                    <a:pt x="3661" y="16678"/>
                  </a:lnTo>
                  <a:lnTo>
                    <a:pt x="4353" y="16515"/>
                  </a:lnTo>
                  <a:lnTo>
                    <a:pt x="5044" y="16312"/>
                  </a:lnTo>
                  <a:lnTo>
                    <a:pt x="5695" y="16068"/>
                  </a:lnTo>
                  <a:lnTo>
                    <a:pt x="6346" y="15824"/>
                  </a:lnTo>
                  <a:lnTo>
                    <a:pt x="6997" y="15539"/>
                  </a:lnTo>
                  <a:lnTo>
                    <a:pt x="7648" y="15214"/>
                  </a:lnTo>
                  <a:lnTo>
                    <a:pt x="8258" y="14888"/>
                  </a:lnTo>
                  <a:lnTo>
                    <a:pt x="9478" y="14156"/>
                  </a:lnTo>
                  <a:lnTo>
                    <a:pt x="10617" y="13383"/>
                  </a:lnTo>
                  <a:lnTo>
                    <a:pt x="11797" y="12488"/>
                  </a:lnTo>
                  <a:lnTo>
                    <a:pt x="12895" y="11593"/>
                  </a:lnTo>
                  <a:lnTo>
                    <a:pt x="13993" y="10617"/>
                  </a:lnTo>
                  <a:lnTo>
                    <a:pt x="15051" y="9641"/>
                  </a:lnTo>
                  <a:lnTo>
                    <a:pt x="17247" y="7485"/>
                  </a:lnTo>
                  <a:lnTo>
                    <a:pt x="19444" y="5370"/>
                  </a:lnTo>
                  <a:lnTo>
                    <a:pt x="24569" y="326"/>
                  </a:lnTo>
                  <a:lnTo>
                    <a:pt x="24610" y="245"/>
                  </a:lnTo>
                  <a:lnTo>
                    <a:pt x="24610" y="163"/>
                  </a:lnTo>
                  <a:lnTo>
                    <a:pt x="24610" y="123"/>
                  </a:lnTo>
                  <a:lnTo>
                    <a:pt x="24569" y="82"/>
                  </a:lnTo>
                  <a:lnTo>
                    <a:pt x="24528" y="41"/>
                  </a:lnTo>
                  <a:lnTo>
                    <a:pt x="2444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4" name="Google Shape;84;p13"/>
            <p:cNvSpPr/>
            <p:nvPr/>
          </p:nvSpPr>
          <p:spPr>
            <a:xfrm>
              <a:off x="277775" y="921800"/>
              <a:ext cx="404750" cy="281700"/>
            </a:xfrm>
            <a:custGeom>
              <a:rect b="b" l="l" r="r" t="t"/>
              <a:pathLst>
                <a:path extrusionOk="0" h="11268" w="16190">
                  <a:moveTo>
                    <a:pt x="15945" y="1"/>
                  </a:moveTo>
                  <a:lnTo>
                    <a:pt x="15864" y="41"/>
                  </a:lnTo>
                  <a:lnTo>
                    <a:pt x="12895" y="2319"/>
                  </a:lnTo>
                  <a:lnTo>
                    <a:pt x="9844" y="4516"/>
                  </a:lnTo>
                  <a:lnTo>
                    <a:pt x="6793" y="6631"/>
                  </a:lnTo>
                  <a:lnTo>
                    <a:pt x="3661" y="8705"/>
                  </a:lnTo>
                  <a:lnTo>
                    <a:pt x="1871" y="9804"/>
                  </a:lnTo>
                  <a:lnTo>
                    <a:pt x="82" y="10942"/>
                  </a:lnTo>
                  <a:lnTo>
                    <a:pt x="41" y="10983"/>
                  </a:lnTo>
                  <a:lnTo>
                    <a:pt x="0" y="11064"/>
                  </a:lnTo>
                  <a:lnTo>
                    <a:pt x="0" y="11105"/>
                  </a:lnTo>
                  <a:lnTo>
                    <a:pt x="41" y="11186"/>
                  </a:lnTo>
                  <a:lnTo>
                    <a:pt x="82" y="11227"/>
                  </a:lnTo>
                  <a:lnTo>
                    <a:pt x="122" y="11268"/>
                  </a:lnTo>
                  <a:lnTo>
                    <a:pt x="285" y="11268"/>
                  </a:lnTo>
                  <a:lnTo>
                    <a:pt x="3458" y="9275"/>
                  </a:lnTo>
                  <a:lnTo>
                    <a:pt x="6631" y="7200"/>
                  </a:lnTo>
                  <a:lnTo>
                    <a:pt x="9722" y="5044"/>
                  </a:lnTo>
                  <a:lnTo>
                    <a:pt x="12773" y="2848"/>
                  </a:lnTo>
                  <a:lnTo>
                    <a:pt x="14440" y="1587"/>
                  </a:lnTo>
                  <a:lnTo>
                    <a:pt x="16108" y="326"/>
                  </a:lnTo>
                  <a:lnTo>
                    <a:pt x="16149" y="245"/>
                  </a:lnTo>
                  <a:lnTo>
                    <a:pt x="16189" y="204"/>
                  </a:lnTo>
                  <a:lnTo>
                    <a:pt x="16149" y="123"/>
                  </a:lnTo>
                  <a:lnTo>
                    <a:pt x="16108" y="82"/>
                  </a:lnTo>
                  <a:lnTo>
                    <a:pt x="15986"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5" name="Google Shape;85;p13"/>
            <p:cNvSpPr/>
            <p:nvPr/>
          </p:nvSpPr>
          <p:spPr>
            <a:xfrm>
              <a:off x="238125" y="918750"/>
              <a:ext cx="596925" cy="409850"/>
            </a:xfrm>
            <a:custGeom>
              <a:rect b="b" l="l" r="r" t="t"/>
              <a:pathLst>
                <a:path extrusionOk="0" h="16394" w="23877">
                  <a:moveTo>
                    <a:pt x="23714" y="1"/>
                  </a:moveTo>
                  <a:lnTo>
                    <a:pt x="23633" y="41"/>
                  </a:lnTo>
                  <a:lnTo>
                    <a:pt x="23592" y="82"/>
                  </a:lnTo>
                  <a:lnTo>
                    <a:pt x="22697" y="1139"/>
                  </a:lnTo>
                  <a:lnTo>
                    <a:pt x="21762" y="2197"/>
                  </a:lnTo>
                  <a:lnTo>
                    <a:pt x="20786" y="3214"/>
                  </a:lnTo>
                  <a:lnTo>
                    <a:pt x="19809" y="4231"/>
                  </a:lnTo>
                  <a:lnTo>
                    <a:pt x="18792" y="5166"/>
                  </a:lnTo>
                  <a:lnTo>
                    <a:pt x="17775" y="6143"/>
                  </a:lnTo>
                  <a:lnTo>
                    <a:pt x="16718" y="7038"/>
                  </a:lnTo>
                  <a:lnTo>
                    <a:pt x="15620" y="7892"/>
                  </a:lnTo>
                  <a:lnTo>
                    <a:pt x="14481" y="8746"/>
                  </a:lnTo>
                  <a:lnTo>
                    <a:pt x="13342" y="9559"/>
                  </a:lnTo>
                  <a:lnTo>
                    <a:pt x="12162" y="10332"/>
                  </a:lnTo>
                  <a:lnTo>
                    <a:pt x="10983" y="11105"/>
                  </a:lnTo>
                  <a:lnTo>
                    <a:pt x="9762" y="11797"/>
                  </a:lnTo>
                  <a:lnTo>
                    <a:pt x="8542" y="12488"/>
                  </a:lnTo>
                  <a:lnTo>
                    <a:pt x="7322" y="13139"/>
                  </a:lnTo>
                  <a:lnTo>
                    <a:pt x="6061" y="13749"/>
                  </a:lnTo>
                  <a:lnTo>
                    <a:pt x="4596" y="14400"/>
                  </a:lnTo>
                  <a:lnTo>
                    <a:pt x="3132" y="14969"/>
                  </a:lnTo>
                  <a:lnTo>
                    <a:pt x="1627" y="15539"/>
                  </a:lnTo>
                  <a:lnTo>
                    <a:pt x="122" y="16027"/>
                  </a:lnTo>
                  <a:lnTo>
                    <a:pt x="81" y="16068"/>
                  </a:lnTo>
                  <a:lnTo>
                    <a:pt x="0" y="16108"/>
                  </a:lnTo>
                  <a:lnTo>
                    <a:pt x="0" y="16190"/>
                  </a:lnTo>
                  <a:lnTo>
                    <a:pt x="0" y="16271"/>
                  </a:lnTo>
                  <a:lnTo>
                    <a:pt x="41" y="16312"/>
                  </a:lnTo>
                  <a:lnTo>
                    <a:pt x="81" y="16393"/>
                  </a:lnTo>
                  <a:lnTo>
                    <a:pt x="244" y="16393"/>
                  </a:lnTo>
                  <a:lnTo>
                    <a:pt x="1586" y="15946"/>
                  </a:lnTo>
                  <a:lnTo>
                    <a:pt x="2888" y="15457"/>
                  </a:lnTo>
                  <a:lnTo>
                    <a:pt x="4230" y="14929"/>
                  </a:lnTo>
                  <a:lnTo>
                    <a:pt x="5532" y="14400"/>
                  </a:lnTo>
                  <a:lnTo>
                    <a:pt x="6793" y="13790"/>
                  </a:lnTo>
                  <a:lnTo>
                    <a:pt x="8095" y="13180"/>
                  </a:lnTo>
                  <a:lnTo>
                    <a:pt x="9315" y="12488"/>
                  </a:lnTo>
                  <a:lnTo>
                    <a:pt x="10535" y="11797"/>
                  </a:lnTo>
                  <a:lnTo>
                    <a:pt x="11755" y="11064"/>
                  </a:lnTo>
                  <a:lnTo>
                    <a:pt x="12935" y="10292"/>
                  </a:lnTo>
                  <a:lnTo>
                    <a:pt x="14074" y="9478"/>
                  </a:lnTo>
                  <a:lnTo>
                    <a:pt x="15213" y="8665"/>
                  </a:lnTo>
                  <a:lnTo>
                    <a:pt x="16352" y="7810"/>
                  </a:lnTo>
                  <a:lnTo>
                    <a:pt x="17409" y="6915"/>
                  </a:lnTo>
                  <a:lnTo>
                    <a:pt x="18467" y="5980"/>
                  </a:lnTo>
                  <a:lnTo>
                    <a:pt x="19525" y="5044"/>
                  </a:lnTo>
                  <a:lnTo>
                    <a:pt x="20663" y="3905"/>
                  </a:lnTo>
                  <a:lnTo>
                    <a:pt x="21762" y="2767"/>
                  </a:lnTo>
                  <a:lnTo>
                    <a:pt x="22819" y="1546"/>
                  </a:lnTo>
                  <a:lnTo>
                    <a:pt x="23836" y="326"/>
                  </a:lnTo>
                  <a:lnTo>
                    <a:pt x="23877" y="285"/>
                  </a:lnTo>
                  <a:lnTo>
                    <a:pt x="23877" y="204"/>
                  </a:lnTo>
                  <a:lnTo>
                    <a:pt x="23836" y="82"/>
                  </a:lnTo>
                  <a:lnTo>
                    <a:pt x="23755" y="41"/>
                  </a:lnTo>
                  <a:lnTo>
                    <a:pt x="23714"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6" name="Google Shape;86;p13"/>
            <p:cNvSpPr/>
            <p:nvPr/>
          </p:nvSpPr>
          <p:spPr>
            <a:xfrm>
              <a:off x="261500" y="916725"/>
              <a:ext cx="477975" cy="336600"/>
            </a:xfrm>
            <a:custGeom>
              <a:rect b="b" l="l" r="r" t="t"/>
              <a:pathLst>
                <a:path extrusionOk="0" h="13464" w="19119">
                  <a:moveTo>
                    <a:pt x="18915" y="0"/>
                  </a:moveTo>
                  <a:lnTo>
                    <a:pt x="18834" y="41"/>
                  </a:lnTo>
                  <a:lnTo>
                    <a:pt x="18793" y="82"/>
                  </a:lnTo>
                  <a:lnTo>
                    <a:pt x="18101" y="1017"/>
                  </a:lnTo>
                  <a:lnTo>
                    <a:pt x="17410" y="1912"/>
                  </a:lnTo>
                  <a:lnTo>
                    <a:pt x="16678" y="2766"/>
                  </a:lnTo>
                  <a:lnTo>
                    <a:pt x="15946" y="3620"/>
                  </a:lnTo>
                  <a:lnTo>
                    <a:pt x="15132" y="4434"/>
                  </a:lnTo>
                  <a:lnTo>
                    <a:pt x="14319" y="5247"/>
                  </a:lnTo>
                  <a:lnTo>
                    <a:pt x="13505" y="5980"/>
                  </a:lnTo>
                  <a:lnTo>
                    <a:pt x="12610" y="6712"/>
                  </a:lnTo>
                  <a:lnTo>
                    <a:pt x="11756" y="7403"/>
                  </a:lnTo>
                  <a:lnTo>
                    <a:pt x="10820" y="8095"/>
                  </a:lnTo>
                  <a:lnTo>
                    <a:pt x="9885" y="8746"/>
                  </a:lnTo>
                  <a:lnTo>
                    <a:pt x="8949" y="9315"/>
                  </a:lnTo>
                  <a:lnTo>
                    <a:pt x="7973" y="9925"/>
                  </a:lnTo>
                  <a:lnTo>
                    <a:pt x="6997" y="10454"/>
                  </a:lnTo>
                  <a:lnTo>
                    <a:pt x="5980" y="10942"/>
                  </a:lnTo>
                  <a:lnTo>
                    <a:pt x="4963" y="11430"/>
                  </a:lnTo>
                  <a:lnTo>
                    <a:pt x="3783" y="11918"/>
                  </a:lnTo>
                  <a:lnTo>
                    <a:pt x="2563" y="12366"/>
                  </a:lnTo>
                  <a:lnTo>
                    <a:pt x="1343" y="12772"/>
                  </a:lnTo>
                  <a:lnTo>
                    <a:pt x="123" y="13098"/>
                  </a:lnTo>
                  <a:lnTo>
                    <a:pt x="41" y="13139"/>
                  </a:lnTo>
                  <a:lnTo>
                    <a:pt x="1" y="13220"/>
                  </a:lnTo>
                  <a:lnTo>
                    <a:pt x="1" y="13261"/>
                  </a:lnTo>
                  <a:lnTo>
                    <a:pt x="1" y="13342"/>
                  </a:lnTo>
                  <a:lnTo>
                    <a:pt x="41" y="13383"/>
                  </a:lnTo>
                  <a:lnTo>
                    <a:pt x="82" y="13464"/>
                  </a:lnTo>
                  <a:lnTo>
                    <a:pt x="245" y="13464"/>
                  </a:lnTo>
                  <a:lnTo>
                    <a:pt x="1343" y="13179"/>
                  </a:lnTo>
                  <a:lnTo>
                    <a:pt x="2400" y="12813"/>
                  </a:lnTo>
                  <a:lnTo>
                    <a:pt x="3499" y="12406"/>
                  </a:lnTo>
                  <a:lnTo>
                    <a:pt x="4556" y="12000"/>
                  </a:lnTo>
                  <a:lnTo>
                    <a:pt x="5614" y="11552"/>
                  </a:lnTo>
                  <a:lnTo>
                    <a:pt x="6631" y="11023"/>
                  </a:lnTo>
                  <a:lnTo>
                    <a:pt x="7648" y="10495"/>
                  </a:lnTo>
                  <a:lnTo>
                    <a:pt x="8665" y="9925"/>
                  </a:lnTo>
                  <a:lnTo>
                    <a:pt x="9641" y="9356"/>
                  </a:lnTo>
                  <a:lnTo>
                    <a:pt x="10576" y="8705"/>
                  </a:lnTo>
                  <a:lnTo>
                    <a:pt x="11512" y="8054"/>
                  </a:lnTo>
                  <a:lnTo>
                    <a:pt x="12447" y="7363"/>
                  </a:lnTo>
                  <a:lnTo>
                    <a:pt x="13342" y="6630"/>
                  </a:lnTo>
                  <a:lnTo>
                    <a:pt x="14197" y="5858"/>
                  </a:lnTo>
                  <a:lnTo>
                    <a:pt x="15010" y="5085"/>
                  </a:lnTo>
                  <a:lnTo>
                    <a:pt x="15824" y="4271"/>
                  </a:lnTo>
                  <a:lnTo>
                    <a:pt x="16718" y="3295"/>
                  </a:lnTo>
                  <a:lnTo>
                    <a:pt x="17532" y="2319"/>
                  </a:lnTo>
                  <a:lnTo>
                    <a:pt x="18345" y="1302"/>
                  </a:lnTo>
                  <a:lnTo>
                    <a:pt x="19078" y="285"/>
                  </a:lnTo>
                  <a:lnTo>
                    <a:pt x="19118" y="204"/>
                  </a:lnTo>
                  <a:lnTo>
                    <a:pt x="19118" y="122"/>
                  </a:lnTo>
                  <a:lnTo>
                    <a:pt x="19078" y="82"/>
                  </a:lnTo>
                  <a:lnTo>
                    <a:pt x="19037" y="41"/>
                  </a:lnTo>
                  <a:lnTo>
                    <a:pt x="18915"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7" name="Google Shape;87;p13"/>
            <p:cNvSpPr/>
            <p:nvPr/>
          </p:nvSpPr>
          <p:spPr>
            <a:xfrm>
              <a:off x="329625" y="896375"/>
              <a:ext cx="264425" cy="187150"/>
            </a:xfrm>
            <a:custGeom>
              <a:rect b="b" l="l" r="r" t="t"/>
              <a:pathLst>
                <a:path extrusionOk="0" h="7486" w="10577">
                  <a:moveTo>
                    <a:pt x="7038" y="1"/>
                  </a:moveTo>
                  <a:lnTo>
                    <a:pt x="6956" y="41"/>
                  </a:lnTo>
                  <a:lnTo>
                    <a:pt x="5940" y="651"/>
                  </a:lnTo>
                  <a:lnTo>
                    <a:pt x="4963" y="1262"/>
                  </a:lnTo>
                  <a:lnTo>
                    <a:pt x="4028" y="1953"/>
                  </a:lnTo>
                  <a:lnTo>
                    <a:pt x="3133" y="2645"/>
                  </a:lnTo>
                  <a:lnTo>
                    <a:pt x="2197" y="3417"/>
                  </a:lnTo>
                  <a:lnTo>
                    <a:pt x="1343" y="4231"/>
                  </a:lnTo>
                  <a:lnTo>
                    <a:pt x="936" y="4597"/>
                  </a:lnTo>
                  <a:lnTo>
                    <a:pt x="570" y="5004"/>
                  </a:lnTo>
                  <a:lnTo>
                    <a:pt x="408" y="5207"/>
                  </a:lnTo>
                  <a:lnTo>
                    <a:pt x="286" y="5451"/>
                  </a:lnTo>
                  <a:lnTo>
                    <a:pt x="164" y="5655"/>
                  </a:lnTo>
                  <a:lnTo>
                    <a:pt x="82" y="5899"/>
                  </a:lnTo>
                  <a:lnTo>
                    <a:pt x="42" y="6143"/>
                  </a:lnTo>
                  <a:lnTo>
                    <a:pt x="1" y="6346"/>
                  </a:lnTo>
                  <a:lnTo>
                    <a:pt x="42" y="6550"/>
                  </a:lnTo>
                  <a:lnTo>
                    <a:pt x="82" y="6753"/>
                  </a:lnTo>
                  <a:lnTo>
                    <a:pt x="164" y="6956"/>
                  </a:lnTo>
                  <a:lnTo>
                    <a:pt x="286" y="7119"/>
                  </a:lnTo>
                  <a:lnTo>
                    <a:pt x="448" y="7282"/>
                  </a:lnTo>
                  <a:lnTo>
                    <a:pt x="652" y="7404"/>
                  </a:lnTo>
                  <a:lnTo>
                    <a:pt x="896" y="7485"/>
                  </a:lnTo>
                  <a:lnTo>
                    <a:pt x="1140" y="7485"/>
                  </a:lnTo>
                  <a:lnTo>
                    <a:pt x="1384" y="7444"/>
                  </a:lnTo>
                  <a:lnTo>
                    <a:pt x="1669" y="7404"/>
                  </a:lnTo>
                  <a:lnTo>
                    <a:pt x="2157" y="7160"/>
                  </a:lnTo>
                  <a:lnTo>
                    <a:pt x="2604" y="6916"/>
                  </a:lnTo>
                  <a:lnTo>
                    <a:pt x="3621" y="6346"/>
                  </a:lnTo>
                  <a:lnTo>
                    <a:pt x="4638" y="5777"/>
                  </a:lnTo>
                  <a:lnTo>
                    <a:pt x="5614" y="5126"/>
                  </a:lnTo>
                  <a:lnTo>
                    <a:pt x="6550" y="4475"/>
                  </a:lnTo>
                  <a:lnTo>
                    <a:pt x="7607" y="3662"/>
                  </a:lnTo>
                  <a:lnTo>
                    <a:pt x="8584" y="2848"/>
                  </a:lnTo>
                  <a:lnTo>
                    <a:pt x="9600" y="1953"/>
                  </a:lnTo>
                  <a:lnTo>
                    <a:pt x="10536" y="1058"/>
                  </a:lnTo>
                  <a:lnTo>
                    <a:pt x="10577" y="977"/>
                  </a:lnTo>
                  <a:lnTo>
                    <a:pt x="10577" y="936"/>
                  </a:lnTo>
                  <a:lnTo>
                    <a:pt x="10577" y="855"/>
                  </a:lnTo>
                  <a:lnTo>
                    <a:pt x="10536" y="814"/>
                  </a:lnTo>
                  <a:lnTo>
                    <a:pt x="10455" y="774"/>
                  </a:lnTo>
                  <a:lnTo>
                    <a:pt x="10414" y="733"/>
                  </a:lnTo>
                  <a:lnTo>
                    <a:pt x="10333" y="774"/>
                  </a:lnTo>
                  <a:lnTo>
                    <a:pt x="10251" y="814"/>
                  </a:lnTo>
                  <a:lnTo>
                    <a:pt x="9478" y="1546"/>
                  </a:lnTo>
                  <a:lnTo>
                    <a:pt x="8706" y="2238"/>
                  </a:lnTo>
                  <a:lnTo>
                    <a:pt x="7892" y="2929"/>
                  </a:lnTo>
                  <a:lnTo>
                    <a:pt x="7079" y="3621"/>
                  </a:lnTo>
                  <a:lnTo>
                    <a:pt x="6224" y="4231"/>
                  </a:lnTo>
                  <a:lnTo>
                    <a:pt x="5329" y="4841"/>
                  </a:lnTo>
                  <a:lnTo>
                    <a:pt x="4435" y="5451"/>
                  </a:lnTo>
                  <a:lnTo>
                    <a:pt x="3540" y="5980"/>
                  </a:lnTo>
                  <a:lnTo>
                    <a:pt x="2604" y="6550"/>
                  </a:lnTo>
                  <a:lnTo>
                    <a:pt x="2116" y="6794"/>
                  </a:lnTo>
                  <a:lnTo>
                    <a:pt x="1628" y="6997"/>
                  </a:lnTo>
                  <a:lnTo>
                    <a:pt x="1384" y="7078"/>
                  </a:lnTo>
                  <a:lnTo>
                    <a:pt x="1140" y="7119"/>
                  </a:lnTo>
                  <a:lnTo>
                    <a:pt x="855" y="7078"/>
                  </a:lnTo>
                  <a:lnTo>
                    <a:pt x="733" y="7038"/>
                  </a:lnTo>
                  <a:lnTo>
                    <a:pt x="652" y="6956"/>
                  </a:lnTo>
                  <a:lnTo>
                    <a:pt x="489" y="6794"/>
                  </a:lnTo>
                  <a:lnTo>
                    <a:pt x="408" y="6590"/>
                  </a:lnTo>
                  <a:lnTo>
                    <a:pt x="408" y="6387"/>
                  </a:lnTo>
                  <a:lnTo>
                    <a:pt x="408" y="6183"/>
                  </a:lnTo>
                  <a:lnTo>
                    <a:pt x="448" y="5939"/>
                  </a:lnTo>
                  <a:lnTo>
                    <a:pt x="530" y="5695"/>
                  </a:lnTo>
                  <a:lnTo>
                    <a:pt x="652" y="5492"/>
                  </a:lnTo>
                  <a:lnTo>
                    <a:pt x="814" y="5289"/>
                  </a:lnTo>
                  <a:lnTo>
                    <a:pt x="1180" y="4882"/>
                  </a:lnTo>
                  <a:lnTo>
                    <a:pt x="1547" y="4556"/>
                  </a:lnTo>
                  <a:lnTo>
                    <a:pt x="2319" y="3824"/>
                  </a:lnTo>
                  <a:lnTo>
                    <a:pt x="3133" y="3133"/>
                  </a:lnTo>
                  <a:lnTo>
                    <a:pt x="4068" y="2360"/>
                  </a:lnTo>
                  <a:lnTo>
                    <a:pt x="5085" y="1668"/>
                  </a:lnTo>
                  <a:lnTo>
                    <a:pt x="6102" y="977"/>
                  </a:lnTo>
                  <a:lnTo>
                    <a:pt x="7160" y="367"/>
                  </a:lnTo>
                  <a:lnTo>
                    <a:pt x="7201" y="326"/>
                  </a:lnTo>
                  <a:lnTo>
                    <a:pt x="7241" y="245"/>
                  </a:lnTo>
                  <a:lnTo>
                    <a:pt x="7241" y="163"/>
                  </a:lnTo>
                  <a:lnTo>
                    <a:pt x="7201" y="123"/>
                  </a:lnTo>
                  <a:lnTo>
                    <a:pt x="7160" y="82"/>
                  </a:lnTo>
                  <a:lnTo>
                    <a:pt x="7119" y="41"/>
                  </a:lnTo>
                  <a:lnTo>
                    <a:pt x="7038"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88" name="Google Shape;88;p13"/>
          <p:cNvSpPr txBox="1"/>
          <p:nvPr>
            <p:ph idx="12" type="sldNum"/>
          </p:nvPr>
        </p:nvSpPr>
        <p:spPr>
          <a:xfrm>
            <a:off x="8556784" y="4749851"/>
            <a:ext cx="548700" cy="393600"/>
          </a:xfrm>
          <a:prstGeom prst="rect">
            <a:avLst/>
          </a:prstGeom>
        </p:spPr>
        <p:txBody>
          <a:bodyPr anchorCtr="0" anchor="t"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able of contents">
  <p:cSld name="BLANK_1_1_1_1_1_1">
    <p:spTree>
      <p:nvGrpSpPr>
        <p:cNvPr id="89" name="Shape 89"/>
        <p:cNvGrpSpPr/>
        <p:nvPr/>
      </p:nvGrpSpPr>
      <p:grpSpPr>
        <a:xfrm>
          <a:off x="0" y="0"/>
          <a:ext cx="0" cy="0"/>
          <a:chOff x="0" y="0"/>
          <a:chExt cx="0" cy="0"/>
        </a:xfrm>
      </p:grpSpPr>
      <p:sp>
        <p:nvSpPr>
          <p:cNvPr id="90" name="Google Shape;90;p14"/>
          <p:cNvSpPr txBox="1"/>
          <p:nvPr>
            <p:ph type="title"/>
          </p:nvPr>
        </p:nvSpPr>
        <p:spPr>
          <a:xfrm>
            <a:off x="1927125" y="1442375"/>
            <a:ext cx="2297400" cy="527700"/>
          </a:xfrm>
          <a:prstGeom prst="rect">
            <a:avLst/>
          </a:prstGeom>
        </p:spPr>
        <p:txBody>
          <a:bodyPr anchorCtr="0" anchor="ctr" bIns="91425" lIns="91425" spcFirstLastPara="1" rIns="91425" wrap="square" tIns="91425">
            <a:normAutofit/>
          </a:bodyPr>
          <a:lstStyle>
            <a:lvl1pPr lvl="0">
              <a:spcBef>
                <a:spcPts val="0"/>
              </a:spcBef>
              <a:spcAft>
                <a:spcPts val="0"/>
              </a:spcAft>
              <a:buSzPts val="2400"/>
              <a:buNone/>
              <a:defRPr sz="2000">
                <a:solidFill>
                  <a:schemeClr val="accent1"/>
                </a:solidFill>
              </a:defRPr>
            </a:lvl1pPr>
            <a:lvl2pPr lvl="1" algn="ctr">
              <a:spcBef>
                <a:spcPts val="0"/>
              </a:spcBef>
              <a:spcAft>
                <a:spcPts val="0"/>
              </a:spcAft>
              <a:buSzPts val="2400"/>
              <a:buNone/>
              <a:defRPr sz="2400"/>
            </a:lvl2pPr>
            <a:lvl3pPr lvl="2" algn="ctr">
              <a:spcBef>
                <a:spcPts val="0"/>
              </a:spcBef>
              <a:spcAft>
                <a:spcPts val="0"/>
              </a:spcAft>
              <a:buSzPts val="2400"/>
              <a:buNone/>
              <a:defRPr sz="2400"/>
            </a:lvl3pPr>
            <a:lvl4pPr lvl="3" algn="ctr">
              <a:spcBef>
                <a:spcPts val="0"/>
              </a:spcBef>
              <a:spcAft>
                <a:spcPts val="0"/>
              </a:spcAft>
              <a:buSzPts val="2400"/>
              <a:buNone/>
              <a:defRPr sz="2400"/>
            </a:lvl4pPr>
            <a:lvl5pPr lvl="4" algn="ctr">
              <a:spcBef>
                <a:spcPts val="0"/>
              </a:spcBef>
              <a:spcAft>
                <a:spcPts val="0"/>
              </a:spcAft>
              <a:buSzPts val="2400"/>
              <a:buNone/>
              <a:defRPr sz="2400"/>
            </a:lvl5pPr>
            <a:lvl6pPr lvl="5" algn="ctr">
              <a:spcBef>
                <a:spcPts val="0"/>
              </a:spcBef>
              <a:spcAft>
                <a:spcPts val="0"/>
              </a:spcAft>
              <a:buSzPts val="2400"/>
              <a:buNone/>
              <a:defRPr sz="2400"/>
            </a:lvl6pPr>
            <a:lvl7pPr lvl="6" algn="ctr">
              <a:spcBef>
                <a:spcPts val="0"/>
              </a:spcBef>
              <a:spcAft>
                <a:spcPts val="0"/>
              </a:spcAft>
              <a:buSzPts val="2400"/>
              <a:buNone/>
              <a:defRPr sz="2400"/>
            </a:lvl7pPr>
            <a:lvl8pPr lvl="7" algn="ctr">
              <a:spcBef>
                <a:spcPts val="0"/>
              </a:spcBef>
              <a:spcAft>
                <a:spcPts val="0"/>
              </a:spcAft>
              <a:buSzPts val="2400"/>
              <a:buNone/>
              <a:defRPr sz="2400"/>
            </a:lvl8pPr>
            <a:lvl9pPr lvl="8" algn="ctr">
              <a:spcBef>
                <a:spcPts val="0"/>
              </a:spcBef>
              <a:spcAft>
                <a:spcPts val="0"/>
              </a:spcAft>
              <a:buSzPts val="2400"/>
              <a:buNone/>
              <a:defRPr sz="2400"/>
            </a:lvl9pPr>
          </a:lstStyle>
          <a:p/>
        </p:txBody>
      </p:sp>
      <p:sp>
        <p:nvSpPr>
          <p:cNvPr id="91" name="Google Shape;91;p14"/>
          <p:cNvSpPr txBox="1"/>
          <p:nvPr>
            <p:ph idx="1" type="subTitle"/>
          </p:nvPr>
        </p:nvSpPr>
        <p:spPr>
          <a:xfrm>
            <a:off x="1927125" y="1970069"/>
            <a:ext cx="2297400" cy="525900"/>
          </a:xfrm>
          <a:prstGeom prst="rect">
            <a:avLst/>
          </a:prstGeom>
        </p:spPr>
        <p:txBody>
          <a:bodyPr anchorCtr="0" anchor="ctr" bIns="91425" lIns="91425" spcFirstLastPara="1" rIns="91425" wrap="square" tIns="91425">
            <a:norm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400"/>
              <a:buNone/>
              <a:defRPr/>
            </a:lvl2pPr>
            <a:lvl3pPr lvl="2" algn="ctr">
              <a:lnSpc>
                <a:spcPct val="100000"/>
              </a:lnSpc>
              <a:spcBef>
                <a:spcPts val="0"/>
              </a:spcBef>
              <a:spcAft>
                <a:spcPts val="0"/>
              </a:spcAft>
              <a:buSzPts val="1400"/>
              <a:buNone/>
              <a:defRPr/>
            </a:lvl3pPr>
            <a:lvl4pPr lvl="3" algn="ctr">
              <a:lnSpc>
                <a:spcPct val="100000"/>
              </a:lnSpc>
              <a:spcBef>
                <a:spcPts val="0"/>
              </a:spcBef>
              <a:spcAft>
                <a:spcPts val="0"/>
              </a:spcAft>
              <a:buSzPts val="1400"/>
              <a:buNone/>
              <a:defRPr/>
            </a:lvl4pPr>
            <a:lvl5pPr lvl="4" algn="ctr">
              <a:lnSpc>
                <a:spcPct val="100000"/>
              </a:lnSpc>
              <a:spcBef>
                <a:spcPts val="0"/>
              </a:spcBef>
              <a:spcAft>
                <a:spcPts val="0"/>
              </a:spcAft>
              <a:buSzPts val="1400"/>
              <a:buNone/>
              <a:defRPr/>
            </a:lvl5pPr>
            <a:lvl6pPr lvl="5" algn="ctr">
              <a:lnSpc>
                <a:spcPct val="100000"/>
              </a:lnSpc>
              <a:spcBef>
                <a:spcPts val="0"/>
              </a:spcBef>
              <a:spcAft>
                <a:spcPts val="0"/>
              </a:spcAft>
              <a:buSzPts val="1400"/>
              <a:buNone/>
              <a:defRPr/>
            </a:lvl6pPr>
            <a:lvl7pPr lvl="6" algn="ctr">
              <a:lnSpc>
                <a:spcPct val="100000"/>
              </a:lnSpc>
              <a:spcBef>
                <a:spcPts val="0"/>
              </a:spcBef>
              <a:spcAft>
                <a:spcPts val="0"/>
              </a:spcAft>
              <a:buSzPts val="1400"/>
              <a:buNone/>
              <a:defRPr/>
            </a:lvl7pPr>
            <a:lvl8pPr lvl="7" algn="ctr">
              <a:lnSpc>
                <a:spcPct val="100000"/>
              </a:lnSpc>
              <a:spcBef>
                <a:spcPts val="0"/>
              </a:spcBef>
              <a:spcAft>
                <a:spcPts val="0"/>
              </a:spcAft>
              <a:buSzPts val="1400"/>
              <a:buNone/>
              <a:defRPr/>
            </a:lvl8pPr>
            <a:lvl9pPr lvl="8" algn="ctr">
              <a:lnSpc>
                <a:spcPct val="100000"/>
              </a:lnSpc>
              <a:spcBef>
                <a:spcPts val="0"/>
              </a:spcBef>
              <a:spcAft>
                <a:spcPts val="0"/>
              </a:spcAft>
              <a:buSzPts val="1400"/>
              <a:buNone/>
              <a:defRPr/>
            </a:lvl9pPr>
          </a:lstStyle>
          <a:p/>
        </p:txBody>
      </p:sp>
      <p:sp>
        <p:nvSpPr>
          <p:cNvPr id="92" name="Google Shape;92;p14"/>
          <p:cNvSpPr txBox="1"/>
          <p:nvPr>
            <p:ph idx="2" type="title"/>
          </p:nvPr>
        </p:nvSpPr>
        <p:spPr>
          <a:xfrm>
            <a:off x="5780475" y="1442375"/>
            <a:ext cx="2297400" cy="527700"/>
          </a:xfrm>
          <a:prstGeom prst="rect">
            <a:avLst/>
          </a:prstGeom>
        </p:spPr>
        <p:txBody>
          <a:bodyPr anchorCtr="0" anchor="ctr" bIns="91425" lIns="91425" spcFirstLastPara="1" rIns="91425" wrap="square" tIns="91425">
            <a:normAutofit/>
          </a:bodyPr>
          <a:lstStyle>
            <a:lvl1pPr lvl="0">
              <a:spcBef>
                <a:spcPts val="0"/>
              </a:spcBef>
              <a:spcAft>
                <a:spcPts val="0"/>
              </a:spcAft>
              <a:buSzPts val="2400"/>
              <a:buNone/>
              <a:defRPr sz="2000">
                <a:solidFill>
                  <a:schemeClr val="accent1"/>
                </a:solidFill>
              </a:defRPr>
            </a:lvl1pPr>
            <a:lvl2pPr lvl="1" algn="ctr">
              <a:spcBef>
                <a:spcPts val="0"/>
              </a:spcBef>
              <a:spcAft>
                <a:spcPts val="0"/>
              </a:spcAft>
              <a:buSzPts val="2400"/>
              <a:buNone/>
              <a:defRPr sz="2400"/>
            </a:lvl2pPr>
            <a:lvl3pPr lvl="2" algn="ctr">
              <a:spcBef>
                <a:spcPts val="0"/>
              </a:spcBef>
              <a:spcAft>
                <a:spcPts val="0"/>
              </a:spcAft>
              <a:buSzPts val="2400"/>
              <a:buNone/>
              <a:defRPr sz="2400"/>
            </a:lvl3pPr>
            <a:lvl4pPr lvl="3" algn="ctr">
              <a:spcBef>
                <a:spcPts val="0"/>
              </a:spcBef>
              <a:spcAft>
                <a:spcPts val="0"/>
              </a:spcAft>
              <a:buSzPts val="2400"/>
              <a:buNone/>
              <a:defRPr sz="2400"/>
            </a:lvl4pPr>
            <a:lvl5pPr lvl="4" algn="ctr">
              <a:spcBef>
                <a:spcPts val="0"/>
              </a:spcBef>
              <a:spcAft>
                <a:spcPts val="0"/>
              </a:spcAft>
              <a:buSzPts val="2400"/>
              <a:buNone/>
              <a:defRPr sz="2400"/>
            </a:lvl5pPr>
            <a:lvl6pPr lvl="5" algn="ctr">
              <a:spcBef>
                <a:spcPts val="0"/>
              </a:spcBef>
              <a:spcAft>
                <a:spcPts val="0"/>
              </a:spcAft>
              <a:buSzPts val="2400"/>
              <a:buNone/>
              <a:defRPr sz="2400"/>
            </a:lvl6pPr>
            <a:lvl7pPr lvl="6" algn="ctr">
              <a:spcBef>
                <a:spcPts val="0"/>
              </a:spcBef>
              <a:spcAft>
                <a:spcPts val="0"/>
              </a:spcAft>
              <a:buSzPts val="2400"/>
              <a:buNone/>
              <a:defRPr sz="2400"/>
            </a:lvl7pPr>
            <a:lvl8pPr lvl="7" algn="ctr">
              <a:spcBef>
                <a:spcPts val="0"/>
              </a:spcBef>
              <a:spcAft>
                <a:spcPts val="0"/>
              </a:spcAft>
              <a:buSzPts val="2400"/>
              <a:buNone/>
              <a:defRPr sz="2400"/>
            </a:lvl8pPr>
            <a:lvl9pPr lvl="8" algn="ctr">
              <a:spcBef>
                <a:spcPts val="0"/>
              </a:spcBef>
              <a:spcAft>
                <a:spcPts val="0"/>
              </a:spcAft>
              <a:buSzPts val="2400"/>
              <a:buNone/>
              <a:defRPr sz="2400"/>
            </a:lvl9pPr>
          </a:lstStyle>
          <a:p/>
        </p:txBody>
      </p:sp>
      <p:sp>
        <p:nvSpPr>
          <p:cNvPr id="93" name="Google Shape;93;p14"/>
          <p:cNvSpPr txBox="1"/>
          <p:nvPr>
            <p:ph idx="3" type="subTitle"/>
          </p:nvPr>
        </p:nvSpPr>
        <p:spPr>
          <a:xfrm>
            <a:off x="5780477" y="1970069"/>
            <a:ext cx="2297400" cy="525900"/>
          </a:xfrm>
          <a:prstGeom prst="rect">
            <a:avLst/>
          </a:prstGeom>
        </p:spPr>
        <p:txBody>
          <a:bodyPr anchorCtr="0" anchor="ctr" bIns="91425" lIns="91425" spcFirstLastPara="1" rIns="91425" wrap="square" tIns="91425">
            <a:norm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400"/>
              <a:buNone/>
              <a:defRPr/>
            </a:lvl2pPr>
            <a:lvl3pPr lvl="2" algn="ctr">
              <a:lnSpc>
                <a:spcPct val="100000"/>
              </a:lnSpc>
              <a:spcBef>
                <a:spcPts val="0"/>
              </a:spcBef>
              <a:spcAft>
                <a:spcPts val="0"/>
              </a:spcAft>
              <a:buSzPts val="1400"/>
              <a:buNone/>
              <a:defRPr/>
            </a:lvl3pPr>
            <a:lvl4pPr lvl="3" algn="ctr">
              <a:lnSpc>
                <a:spcPct val="100000"/>
              </a:lnSpc>
              <a:spcBef>
                <a:spcPts val="0"/>
              </a:spcBef>
              <a:spcAft>
                <a:spcPts val="0"/>
              </a:spcAft>
              <a:buSzPts val="1400"/>
              <a:buNone/>
              <a:defRPr/>
            </a:lvl4pPr>
            <a:lvl5pPr lvl="4" algn="ctr">
              <a:lnSpc>
                <a:spcPct val="100000"/>
              </a:lnSpc>
              <a:spcBef>
                <a:spcPts val="0"/>
              </a:spcBef>
              <a:spcAft>
                <a:spcPts val="0"/>
              </a:spcAft>
              <a:buSzPts val="1400"/>
              <a:buNone/>
              <a:defRPr/>
            </a:lvl5pPr>
            <a:lvl6pPr lvl="5" algn="ctr">
              <a:lnSpc>
                <a:spcPct val="100000"/>
              </a:lnSpc>
              <a:spcBef>
                <a:spcPts val="0"/>
              </a:spcBef>
              <a:spcAft>
                <a:spcPts val="0"/>
              </a:spcAft>
              <a:buSzPts val="1400"/>
              <a:buNone/>
              <a:defRPr/>
            </a:lvl6pPr>
            <a:lvl7pPr lvl="6" algn="ctr">
              <a:lnSpc>
                <a:spcPct val="100000"/>
              </a:lnSpc>
              <a:spcBef>
                <a:spcPts val="0"/>
              </a:spcBef>
              <a:spcAft>
                <a:spcPts val="0"/>
              </a:spcAft>
              <a:buSzPts val="1400"/>
              <a:buNone/>
              <a:defRPr/>
            </a:lvl7pPr>
            <a:lvl8pPr lvl="7" algn="ctr">
              <a:lnSpc>
                <a:spcPct val="100000"/>
              </a:lnSpc>
              <a:spcBef>
                <a:spcPts val="0"/>
              </a:spcBef>
              <a:spcAft>
                <a:spcPts val="0"/>
              </a:spcAft>
              <a:buSzPts val="1400"/>
              <a:buNone/>
              <a:defRPr/>
            </a:lvl8pPr>
            <a:lvl9pPr lvl="8" algn="ctr">
              <a:lnSpc>
                <a:spcPct val="100000"/>
              </a:lnSpc>
              <a:spcBef>
                <a:spcPts val="0"/>
              </a:spcBef>
              <a:spcAft>
                <a:spcPts val="0"/>
              </a:spcAft>
              <a:buSzPts val="1400"/>
              <a:buNone/>
              <a:defRPr/>
            </a:lvl9pPr>
          </a:lstStyle>
          <a:p/>
        </p:txBody>
      </p:sp>
      <p:sp>
        <p:nvSpPr>
          <p:cNvPr id="94" name="Google Shape;94;p14"/>
          <p:cNvSpPr txBox="1"/>
          <p:nvPr>
            <p:ph idx="4" type="title"/>
          </p:nvPr>
        </p:nvSpPr>
        <p:spPr>
          <a:xfrm>
            <a:off x="1927125" y="3074271"/>
            <a:ext cx="2297400" cy="527700"/>
          </a:xfrm>
          <a:prstGeom prst="rect">
            <a:avLst/>
          </a:prstGeom>
        </p:spPr>
        <p:txBody>
          <a:bodyPr anchorCtr="0" anchor="ctr" bIns="91425" lIns="91425" spcFirstLastPara="1" rIns="91425" wrap="square" tIns="91425">
            <a:normAutofit/>
          </a:bodyPr>
          <a:lstStyle>
            <a:lvl1pPr lvl="0">
              <a:spcBef>
                <a:spcPts val="0"/>
              </a:spcBef>
              <a:spcAft>
                <a:spcPts val="0"/>
              </a:spcAft>
              <a:buSzPts val="2400"/>
              <a:buNone/>
              <a:defRPr sz="2000">
                <a:solidFill>
                  <a:schemeClr val="accent1"/>
                </a:solidFill>
              </a:defRPr>
            </a:lvl1pPr>
            <a:lvl2pPr lvl="1" algn="ctr">
              <a:spcBef>
                <a:spcPts val="0"/>
              </a:spcBef>
              <a:spcAft>
                <a:spcPts val="0"/>
              </a:spcAft>
              <a:buSzPts val="2400"/>
              <a:buNone/>
              <a:defRPr sz="2400"/>
            </a:lvl2pPr>
            <a:lvl3pPr lvl="2" algn="ctr">
              <a:spcBef>
                <a:spcPts val="0"/>
              </a:spcBef>
              <a:spcAft>
                <a:spcPts val="0"/>
              </a:spcAft>
              <a:buSzPts val="2400"/>
              <a:buNone/>
              <a:defRPr sz="2400"/>
            </a:lvl3pPr>
            <a:lvl4pPr lvl="3" algn="ctr">
              <a:spcBef>
                <a:spcPts val="0"/>
              </a:spcBef>
              <a:spcAft>
                <a:spcPts val="0"/>
              </a:spcAft>
              <a:buSzPts val="2400"/>
              <a:buNone/>
              <a:defRPr sz="2400"/>
            </a:lvl4pPr>
            <a:lvl5pPr lvl="4" algn="ctr">
              <a:spcBef>
                <a:spcPts val="0"/>
              </a:spcBef>
              <a:spcAft>
                <a:spcPts val="0"/>
              </a:spcAft>
              <a:buSzPts val="2400"/>
              <a:buNone/>
              <a:defRPr sz="2400"/>
            </a:lvl5pPr>
            <a:lvl6pPr lvl="5" algn="ctr">
              <a:spcBef>
                <a:spcPts val="0"/>
              </a:spcBef>
              <a:spcAft>
                <a:spcPts val="0"/>
              </a:spcAft>
              <a:buSzPts val="2400"/>
              <a:buNone/>
              <a:defRPr sz="2400"/>
            </a:lvl6pPr>
            <a:lvl7pPr lvl="6" algn="ctr">
              <a:spcBef>
                <a:spcPts val="0"/>
              </a:spcBef>
              <a:spcAft>
                <a:spcPts val="0"/>
              </a:spcAft>
              <a:buSzPts val="2400"/>
              <a:buNone/>
              <a:defRPr sz="2400"/>
            </a:lvl7pPr>
            <a:lvl8pPr lvl="7" algn="ctr">
              <a:spcBef>
                <a:spcPts val="0"/>
              </a:spcBef>
              <a:spcAft>
                <a:spcPts val="0"/>
              </a:spcAft>
              <a:buSzPts val="2400"/>
              <a:buNone/>
              <a:defRPr sz="2400"/>
            </a:lvl8pPr>
            <a:lvl9pPr lvl="8" algn="ctr">
              <a:spcBef>
                <a:spcPts val="0"/>
              </a:spcBef>
              <a:spcAft>
                <a:spcPts val="0"/>
              </a:spcAft>
              <a:buSzPts val="2400"/>
              <a:buNone/>
              <a:defRPr sz="2400"/>
            </a:lvl9pPr>
          </a:lstStyle>
          <a:p/>
        </p:txBody>
      </p:sp>
      <p:sp>
        <p:nvSpPr>
          <p:cNvPr id="95" name="Google Shape;95;p14"/>
          <p:cNvSpPr txBox="1"/>
          <p:nvPr>
            <p:ph idx="5" type="subTitle"/>
          </p:nvPr>
        </p:nvSpPr>
        <p:spPr>
          <a:xfrm>
            <a:off x="1927125" y="3601976"/>
            <a:ext cx="2297400" cy="525900"/>
          </a:xfrm>
          <a:prstGeom prst="rect">
            <a:avLst/>
          </a:prstGeom>
        </p:spPr>
        <p:txBody>
          <a:bodyPr anchorCtr="0" anchor="ctr" bIns="91425" lIns="91425" spcFirstLastPara="1" rIns="91425" wrap="square" tIns="91425">
            <a:norm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400"/>
              <a:buNone/>
              <a:defRPr/>
            </a:lvl2pPr>
            <a:lvl3pPr lvl="2" algn="ctr">
              <a:lnSpc>
                <a:spcPct val="100000"/>
              </a:lnSpc>
              <a:spcBef>
                <a:spcPts val="0"/>
              </a:spcBef>
              <a:spcAft>
                <a:spcPts val="0"/>
              </a:spcAft>
              <a:buSzPts val="1400"/>
              <a:buNone/>
              <a:defRPr/>
            </a:lvl3pPr>
            <a:lvl4pPr lvl="3" algn="ctr">
              <a:lnSpc>
                <a:spcPct val="100000"/>
              </a:lnSpc>
              <a:spcBef>
                <a:spcPts val="0"/>
              </a:spcBef>
              <a:spcAft>
                <a:spcPts val="0"/>
              </a:spcAft>
              <a:buSzPts val="1400"/>
              <a:buNone/>
              <a:defRPr/>
            </a:lvl4pPr>
            <a:lvl5pPr lvl="4" algn="ctr">
              <a:lnSpc>
                <a:spcPct val="100000"/>
              </a:lnSpc>
              <a:spcBef>
                <a:spcPts val="0"/>
              </a:spcBef>
              <a:spcAft>
                <a:spcPts val="0"/>
              </a:spcAft>
              <a:buSzPts val="1400"/>
              <a:buNone/>
              <a:defRPr/>
            </a:lvl5pPr>
            <a:lvl6pPr lvl="5" algn="ctr">
              <a:lnSpc>
                <a:spcPct val="100000"/>
              </a:lnSpc>
              <a:spcBef>
                <a:spcPts val="0"/>
              </a:spcBef>
              <a:spcAft>
                <a:spcPts val="0"/>
              </a:spcAft>
              <a:buSzPts val="1400"/>
              <a:buNone/>
              <a:defRPr/>
            </a:lvl6pPr>
            <a:lvl7pPr lvl="6" algn="ctr">
              <a:lnSpc>
                <a:spcPct val="100000"/>
              </a:lnSpc>
              <a:spcBef>
                <a:spcPts val="0"/>
              </a:spcBef>
              <a:spcAft>
                <a:spcPts val="0"/>
              </a:spcAft>
              <a:buSzPts val="1400"/>
              <a:buNone/>
              <a:defRPr/>
            </a:lvl7pPr>
            <a:lvl8pPr lvl="7" algn="ctr">
              <a:lnSpc>
                <a:spcPct val="100000"/>
              </a:lnSpc>
              <a:spcBef>
                <a:spcPts val="0"/>
              </a:spcBef>
              <a:spcAft>
                <a:spcPts val="0"/>
              </a:spcAft>
              <a:buSzPts val="1400"/>
              <a:buNone/>
              <a:defRPr/>
            </a:lvl8pPr>
            <a:lvl9pPr lvl="8" algn="ctr">
              <a:lnSpc>
                <a:spcPct val="100000"/>
              </a:lnSpc>
              <a:spcBef>
                <a:spcPts val="0"/>
              </a:spcBef>
              <a:spcAft>
                <a:spcPts val="0"/>
              </a:spcAft>
              <a:buSzPts val="1400"/>
              <a:buNone/>
              <a:defRPr/>
            </a:lvl9pPr>
          </a:lstStyle>
          <a:p/>
        </p:txBody>
      </p:sp>
      <p:sp>
        <p:nvSpPr>
          <p:cNvPr id="96" name="Google Shape;96;p14"/>
          <p:cNvSpPr txBox="1"/>
          <p:nvPr>
            <p:ph idx="6" type="title"/>
          </p:nvPr>
        </p:nvSpPr>
        <p:spPr>
          <a:xfrm>
            <a:off x="5780475" y="3074271"/>
            <a:ext cx="2297400" cy="527700"/>
          </a:xfrm>
          <a:prstGeom prst="rect">
            <a:avLst/>
          </a:prstGeom>
        </p:spPr>
        <p:txBody>
          <a:bodyPr anchorCtr="0" anchor="ctr" bIns="91425" lIns="91425" spcFirstLastPara="1" rIns="91425" wrap="square" tIns="91425">
            <a:normAutofit/>
          </a:bodyPr>
          <a:lstStyle>
            <a:lvl1pPr lvl="0">
              <a:spcBef>
                <a:spcPts val="0"/>
              </a:spcBef>
              <a:spcAft>
                <a:spcPts val="0"/>
              </a:spcAft>
              <a:buSzPts val="2400"/>
              <a:buNone/>
              <a:defRPr sz="2000">
                <a:solidFill>
                  <a:schemeClr val="accent1"/>
                </a:solidFill>
              </a:defRPr>
            </a:lvl1pPr>
            <a:lvl2pPr lvl="1" algn="ctr">
              <a:spcBef>
                <a:spcPts val="0"/>
              </a:spcBef>
              <a:spcAft>
                <a:spcPts val="0"/>
              </a:spcAft>
              <a:buSzPts val="2400"/>
              <a:buNone/>
              <a:defRPr sz="2400"/>
            </a:lvl2pPr>
            <a:lvl3pPr lvl="2" algn="ctr">
              <a:spcBef>
                <a:spcPts val="0"/>
              </a:spcBef>
              <a:spcAft>
                <a:spcPts val="0"/>
              </a:spcAft>
              <a:buSzPts val="2400"/>
              <a:buNone/>
              <a:defRPr sz="2400"/>
            </a:lvl3pPr>
            <a:lvl4pPr lvl="3" algn="ctr">
              <a:spcBef>
                <a:spcPts val="0"/>
              </a:spcBef>
              <a:spcAft>
                <a:spcPts val="0"/>
              </a:spcAft>
              <a:buSzPts val="2400"/>
              <a:buNone/>
              <a:defRPr sz="2400"/>
            </a:lvl4pPr>
            <a:lvl5pPr lvl="4" algn="ctr">
              <a:spcBef>
                <a:spcPts val="0"/>
              </a:spcBef>
              <a:spcAft>
                <a:spcPts val="0"/>
              </a:spcAft>
              <a:buSzPts val="2400"/>
              <a:buNone/>
              <a:defRPr sz="2400"/>
            </a:lvl5pPr>
            <a:lvl6pPr lvl="5" algn="ctr">
              <a:spcBef>
                <a:spcPts val="0"/>
              </a:spcBef>
              <a:spcAft>
                <a:spcPts val="0"/>
              </a:spcAft>
              <a:buSzPts val="2400"/>
              <a:buNone/>
              <a:defRPr sz="2400"/>
            </a:lvl6pPr>
            <a:lvl7pPr lvl="6" algn="ctr">
              <a:spcBef>
                <a:spcPts val="0"/>
              </a:spcBef>
              <a:spcAft>
                <a:spcPts val="0"/>
              </a:spcAft>
              <a:buSzPts val="2400"/>
              <a:buNone/>
              <a:defRPr sz="2400"/>
            </a:lvl7pPr>
            <a:lvl8pPr lvl="7" algn="ctr">
              <a:spcBef>
                <a:spcPts val="0"/>
              </a:spcBef>
              <a:spcAft>
                <a:spcPts val="0"/>
              </a:spcAft>
              <a:buSzPts val="2400"/>
              <a:buNone/>
              <a:defRPr sz="2400"/>
            </a:lvl8pPr>
            <a:lvl9pPr lvl="8" algn="ctr">
              <a:spcBef>
                <a:spcPts val="0"/>
              </a:spcBef>
              <a:spcAft>
                <a:spcPts val="0"/>
              </a:spcAft>
              <a:buSzPts val="2400"/>
              <a:buNone/>
              <a:defRPr sz="2400"/>
            </a:lvl9pPr>
          </a:lstStyle>
          <a:p/>
        </p:txBody>
      </p:sp>
      <p:sp>
        <p:nvSpPr>
          <p:cNvPr id="97" name="Google Shape;97;p14"/>
          <p:cNvSpPr txBox="1"/>
          <p:nvPr>
            <p:ph idx="7" type="subTitle"/>
          </p:nvPr>
        </p:nvSpPr>
        <p:spPr>
          <a:xfrm>
            <a:off x="5780477" y="3601976"/>
            <a:ext cx="2297400" cy="525900"/>
          </a:xfrm>
          <a:prstGeom prst="rect">
            <a:avLst/>
          </a:prstGeom>
        </p:spPr>
        <p:txBody>
          <a:bodyPr anchorCtr="0" anchor="ctr" bIns="91425" lIns="91425" spcFirstLastPara="1" rIns="91425" wrap="square" tIns="91425">
            <a:norm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400"/>
              <a:buNone/>
              <a:defRPr/>
            </a:lvl2pPr>
            <a:lvl3pPr lvl="2" algn="ctr">
              <a:lnSpc>
                <a:spcPct val="100000"/>
              </a:lnSpc>
              <a:spcBef>
                <a:spcPts val="0"/>
              </a:spcBef>
              <a:spcAft>
                <a:spcPts val="0"/>
              </a:spcAft>
              <a:buSzPts val="1400"/>
              <a:buNone/>
              <a:defRPr/>
            </a:lvl3pPr>
            <a:lvl4pPr lvl="3" algn="ctr">
              <a:lnSpc>
                <a:spcPct val="100000"/>
              </a:lnSpc>
              <a:spcBef>
                <a:spcPts val="0"/>
              </a:spcBef>
              <a:spcAft>
                <a:spcPts val="0"/>
              </a:spcAft>
              <a:buSzPts val="1400"/>
              <a:buNone/>
              <a:defRPr/>
            </a:lvl4pPr>
            <a:lvl5pPr lvl="4" algn="ctr">
              <a:lnSpc>
                <a:spcPct val="100000"/>
              </a:lnSpc>
              <a:spcBef>
                <a:spcPts val="0"/>
              </a:spcBef>
              <a:spcAft>
                <a:spcPts val="0"/>
              </a:spcAft>
              <a:buSzPts val="1400"/>
              <a:buNone/>
              <a:defRPr/>
            </a:lvl5pPr>
            <a:lvl6pPr lvl="5" algn="ctr">
              <a:lnSpc>
                <a:spcPct val="100000"/>
              </a:lnSpc>
              <a:spcBef>
                <a:spcPts val="0"/>
              </a:spcBef>
              <a:spcAft>
                <a:spcPts val="0"/>
              </a:spcAft>
              <a:buSzPts val="1400"/>
              <a:buNone/>
              <a:defRPr/>
            </a:lvl6pPr>
            <a:lvl7pPr lvl="6" algn="ctr">
              <a:lnSpc>
                <a:spcPct val="100000"/>
              </a:lnSpc>
              <a:spcBef>
                <a:spcPts val="0"/>
              </a:spcBef>
              <a:spcAft>
                <a:spcPts val="0"/>
              </a:spcAft>
              <a:buSzPts val="1400"/>
              <a:buNone/>
              <a:defRPr/>
            </a:lvl7pPr>
            <a:lvl8pPr lvl="7" algn="ctr">
              <a:lnSpc>
                <a:spcPct val="100000"/>
              </a:lnSpc>
              <a:spcBef>
                <a:spcPts val="0"/>
              </a:spcBef>
              <a:spcAft>
                <a:spcPts val="0"/>
              </a:spcAft>
              <a:buSzPts val="1400"/>
              <a:buNone/>
              <a:defRPr/>
            </a:lvl8pPr>
            <a:lvl9pPr lvl="8" algn="ctr">
              <a:lnSpc>
                <a:spcPct val="100000"/>
              </a:lnSpc>
              <a:spcBef>
                <a:spcPts val="0"/>
              </a:spcBef>
              <a:spcAft>
                <a:spcPts val="0"/>
              </a:spcAft>
              <a:buSzPts val="1400"/>
              <a:buNone/>
              <a:defRPr/>
            </a:lvl9pPr>
          </a:lstStyle>
          <a:p/>
        </p:txBody>
      </p:sp>
      <p:sp>
        <p:nvSpPr>
          <p:cNvPr id="98" name="Google Shape;98;p14"/>
          <p:cNvSpPr txBox="1"/>
          <p:nvPr>
            <p:ph hasCustomPrompt="1" idx="8" type="title"/>
          </p:nvPr>
        </p:nvSpPr>
        <p:spPr>
          <a:xfrm>
            <a:off x="878925" y="1521275"/>
            <a:ext cx="1048200" cy="1048200"/>
          </a:xfrm>
          <a:prstGeom prst="rect">
            <a:avLst/>
          </a:prstGeom>
          <a:noFill/>
          <a:ln>
            <a:noFill/>
          </a:ln>
        </p:spPr>
        <p:txBody>
          <a:bodyPr anchorCtr="0" anchor="ctr" bIns="91425" lIns="91425" spcFirstLastPara="1" rIns="91425" wrap="square" tIns="91425">
            <a:normAutofit/>
          </a:bodyPr>
          <a:lstStyle>
            <a:lvl1pPr lvl="0" algn="r">
              <a:spcBef>
                <a:spcPts val="0"/>
              </a:spcBef>
              <a:spcAft>
                <a:spcPts val="0"/>
              </a:spcAft>
              <a:buSzPts val="6000"/>
              <a:buNone/>
              <a:defRPr sz="4700">
                <a:solidFill>
                  <a:schemeClr val="lt1"/>
                </a:solidFill>
              </a:defRPr>
            </a:lvl1pPr>
            <a:lvl2pPr lvl="1" algn="ctr">
              <a:spcBef>
                <a:spcPts val="0"/>
              </a:spcBef>
              <a:spcAft>
                <a:spcPts val="0"/>
              </a:spcAft>
              <a:buSzPts val="6000"/>
              <a:buNone/>
              <a:defRPr sz="6000"/>
            </a:lvl2pPr>
            <a:lvl3pPr lvl="2" algn="ctr">
              <a:spcBef>
                <a:spcPts val="0"/>
              </a:spcBef>
              <a:spcAft>
                <a:spcPts val="0"/>
              </a:spcAft>
              <a:buSzPts val="6000"/>
              <a:buNone/>
              <a:defRPr sz="6000"/>
            </a:lvl3pPr>
            <a:lvl4pPr lvl="3" algn="ctr">
              <a:spcBef>
                <a:spcPts val="0"/>
              </a:spcBef>
              <a:spcAft>
                <a:spcPts val="0"/>
              </a:spcAft>
              <a:buSzPts val="6000"/>
              <a:buNone/>
              <a:defRPr sz="6000"/>
            </a:lvl4pPr>
            <a:lvl5pPr lvl="4" algn="ctr">
              <a:spcBef>
                <a:spcPts val="0"/>
              </a:spcBef>
              <a:spcAft>
                <a:spcPts val="0"/>
              </a:spcAft>
              <a:buSzPts val="6000"/>
              <a:buNone/>
              <a:defRPr sz="6000"/>
            </a:lvl5pPr>
            <a:lvl6pPr lvl="5" algn="ctr">
              <a:spcBef>
                <a:spcPts val="0"/>
              </a:spcBef>
              <a:spcAft>
                <a:spcPts val="0"/>
              </a:spcAft>
              <a:buSzPts val="6000"/>
              <a:buNone/>
              <a:defRPr sz="6000"/>
            </a:lvl6pPr>
            <a:lvl7pPr lvl="6" algn="ctr">
              <a:spcBef>
                <a:spcPts val="0"/>
              </a:spcBef>
              <a:spcAft>
                <a:spcPts val="0"/>
              </a:spcAft>
              <a:buSzPts val="6000"/>
              <a:buNone/>
              <a:defRPr sz="6000"/>
            </a:lvl7pPr>
            <a:lvl8pPr lvl="7" algn="ctr">
              <a:spcBef>
                <a:spcPts val="0"/>
              </a:spcBef>
              <a:spcAft>
                <a:spcPts val="0"/>
              </a:spcAft>
              <a:buSzPts val="6000"/>
              <a:buNone/>
              <a:defRPr sz="6000"/>
            </a:lvl8pPr>
            <a:lvl9pPr lvl="8" algn="ctr">
              <a:spcBef>
                <a:spcPts val="0"/>
              </a:spcBef>
              <a:spcAft>
                <a:spcPts val="0"/>
              </a:spcAft>
              <a:buSzPts val="6000"/>
              <a:buNone/>
              <a:defRPr sz="6000"/>
            </a:lvl9pPr>
          </a:lstStyle>
          <a:p>
            <a:r>
              <a:t>xx%</a:t>
            </a:r>
          </a:p>
        </p:txBody>
      </p:sp>
      <p:sp>
        <p:nvSpPr>
          <p:cNvPr id="99" name="Google Shape;99;p14"/>
          <p:cNvSpPr txBox="1"/>
          <p:nvPr>
            <p:ph hasCustomPrompt="1" idx="9" type="title"/>
          </p:nvPr>
        </p:nvSpPr>
        <p:spPr>
          <a:xfrm>
            <a:off x="878925" y="3153175"/>
            <a:ext cx="1048200" cy="1048200"/>
          </a:xfrm>
          <a:prstGeom prst="rect">
            <a:avLst/>
          </a:prstGeom>
          <a:noFill/>
          <a:ln>
            <a:noFill/>
          </a:ln>
        </p:spPr>
        <p:txBody>
          <a:bodyPr anchorCtr="0" anchor="ctr" bIns="91425" lIns="91425" spcFirstLastPara="1" rIns="91425" wrap="square" tIns="91425">
            <a:normAutofit/>
          </a:bodyPr>
          <a:lstStyle>
            <a:lvl1pPr lvl="0" algn="r">
              <a:spcBef>
                <a:spcPts val="0"/>
              </a:spcBef>
              <a:spcAft>
                <a:spcPts val="0"/>
              </a:spcAft>
              <a:buSzPts val="6000"/>
              <a:buNone/>
              <a:defRPr sz="4700">
                <a:solidFill>
                  <a:schemeClr val="lt1"/>
                </a:solidFill>
              </a:defRPr>
            </a:lvl1pPr>
            <a:lvl2pPr lvl="1" algn="ctr">
              <a:spcBef>
                <a:spcPts val="0"/>
              </a:spcBef>
              <a:spcAft>
                <a:spcPts val="0"/>
              </a:spcAft>
              <a:buSzPts val="6000"/>
              <a:buNone/>
              <a:defRPr sz="6000"/>
            </a:lvl2pPr>
            <a:lvl3pPr lvl="2" algn="ctr">
              <a:spcBef>
                <a:spcPts val="0"/>
              </a:spcBef>
              <a:spcAft>
                <a:spcPts val="0"/>
              </a:spcAft>
              <a:buSzPts val="6000"/>
              <a:buNone/>
              <a:defRPr sz="6000"/>
            </a:lvl3pPr>
            <a:lvl4pPr lvl="3" algn="ctr">
              <a:spcBef>
                <a:spcPts val="0"/>
              </a:spcBef>
              <a:spcAft>
                <a:spcPts val="0"/>
              </a:spcAft>
              <a:buSzPts val="6000"/>
              <a:buNone/>
              <a:defRPr sz="6000"/>
            </a:lvl4pPr>
            <a:lvl5pPr lvl="4" algn="ctr">
              <a:spcBef>
                <a:spcPts val="0"/>
              </a:spcBef>
              <a:spcAft>
                <a:spcPts val="0"/>
              </a:spcAft>
              <a:buSzPts val="6000"/>
              <a:buNone/>
              <a:defRPr sz="6000"/>
            </a:lvl5pPr>
            <a:lvl6pPr lvl="5" algn="ctr">
              <a:spcBef>
                <a:spcPts val="0"/>
              </a:spcBef>
              <a:spcAft>
                <a:spcPts val="0"/>
              </a:spcAft>
              <a:buSzPts val="6000"/>
              <a:buNone/>
              <a:defRPr sz="6000"/>
            </a:lvl6pPr>
            <a:lvl7pPr lvl="6" algn="ctr">
              <a:spcBef>
                <a:spcPts val="0"/>
              </a:spcBef>
              <a:spcAft>
                <a:spcPts val="0"/>
              </a:spcAft>
              <a:buSzPts val="6000"/>
              <a:buNone/>
              <a:defRPr sz="6000"/>
            </a:lvl7pPr>
            <a:lvl8pPr lvl="7" algn="ctr">
              <a:spcBef>
                <a:spcPts val="0"/>
              </a:spcBef>
              <a:spcAft>
                <a:spcPts val="0"/>
              </a:spcAft>
              <a:buSzPts val="6000"/>
              <a:buNone/>
              <a:defRPr sz="6000"/>
            </a:lvl8pPr>
            <a:lvl9pPr lvl="8" algn="ctr">
              <a:spcBef>
                <a:spcPts val="0"/>
              </a:spcBef>
              <a:spcAft>
                <a:spcPts val="0"/>
              </a:spcAft>
              <a:buSzPts val="6000"/>
              <a:buNone/>
              <a:defRPr sz="6000"/>
            </a:lvl9pPr>
          </a:lstStyle>
          <a:p>
            <a:r>
              <a:t>xx%</a:t>
            </a:r>
          </a:p>
        </p:txBody>
      </p:sp>
      <p:sp>
        <p:nvSpPr>
          <p:cNvPr id="100" name="Google Shape;100;p14"/>
          <p:cNvSpPr txBox="1"/>
          <p:nvPr>
            <p:ph hasCustomPrompt="1" idx="13" type="title"/>
          </p:nvPr>
        </p:nvSpPr>
        <p:spPr>
          <a:xfrm>
            <a:off x="4732275" y="1521275"/>
            <a:ext cx="1048200" cy="1048200"/>
          </a:xfrm>
          <a:prstGeom prst="rect">
            <a:avLst/>
          </a:prstGeom>
          <a:noFill/>
          <a:ln>
            <a:noFill/>
          </a:ln>
        </p:spPr>
        <p:txBody>
          <a:bodyPr anchorCtr="0" anchor="ctr" bIns="91425" lIns="91425" spcFirstLastPara="1" rIns="91425" wrap="square" tIns="91425">
            <a:normAutofit/>
          </a:bodyPr>
          <a:lstStyle>
            <a:lvl1pPr lvl="0" algn="r">
              <a:spcBef>
                <a:spcPts val="0"/>
              </a:spcBef>
              <a:spcAft>
                <a:spcPts val="0"/>
              </a:spcAft>
              <a:buSzPts val="6000"/>
              <a:buNone/>
              <a:defRPr sz="4700">
                <a:solidFill>
                  <a:schemeClr val="lt1"/>
                </a:solidFill>
              </a:defRPr>
            </a:lvl1pPr>
            <a:lvl2pPr lvl="1" algn="ctr">
              <a:spcBef>
                <a:spcPts val="0"/>
              </a:spcBef>
              <a:spcAft>
                <a:spcPts val="0"/>
              </a:spcAft>
              <a:buSzPts val="6000"/>
              <a:buNone/>
              <a:defRPr sz="6000"/>
            </a:lvl2pPr>
            <a:lvl3pPr lvl="2" algn="ctr">
              <a:spcBef>
                <a:spcPts val="0"/>
              </a:spcBef>
              <a:spcAft>
                <a:spcPts val="0"/>
              </a:spcAft>
              <a:buSzPts val="6000"/>
              <a:buNone/>
              <a:defRPr sz="6000"/>
            </a:lvl3pPr>
            <a:lvl4pPr lvl="3" algn="ctr">
              <a:spcBef>
                <a:spcPts val="0"/>
              </a:spcBef>
              <a:spcAft>
                <a:spcPts val="0"/>
              </a:spcAft>
              <a:buSzPts val="6000"/>
              <a:buNone/>
              <a:defRPr sz="6000"/>
            </a:lvl4pPr>
            <a:lvl5pPr lvl="4" algn="ctr">
              <a:spcBef>
                <a:spcPts val="0"/>
              </a:spcBef>
              <a:spcAft>
                <a:spcPts val="0"/>
              </a:spcAft>
              <a:buSzPts val="6000"/>
              <a:buNone/>
              <a:defRPr sz="6000"/>
            </a:lvl5pPr>
            <a:lvl6pPr lvl="5" algn="ctr">
              <a:spcBef>
                <a:spcPts val="0"/>
              </a:spcBef>
              <a:spcAft>
                <a:spcPts val="0"/>
              </a:spcAft>
              <a:buSzPts val="6000"/>
              <a:buNone/>
              <a:defRPr sz="6000"/>
            </a:lvl6pPr>
            <a:lvl7pPr lvl="6" algn="ctr">
              <a:spcBef>
                <a:spcPts val="0"/>
              </a:spcBef>
              <a:spcAft>
                <a:spcPts val="0"/>
              </a:spcAft>
              <a:buSzPts val="6000"/>
              <a:buNone/>
              <a:defRPr sz="6000"/>
            </a:lvl7pPr>
            <a:lvl8pPr lvl="7" algn="ctr">
              <a:spcBef>
                <a:spcPts val="0"/>
              </a:spcBef>
              <a:spcAft>
                <a:spcPts val="0"/>
              </a:spcAft>
              <a:buSzPts val="6000"/>
              <a:buNone/>
              <a:defRPr sz="6000"/>
            </a:lvl8pPr>
            <a:lvl9pPr lvl="8" algn="ctr">
              <a:spcBef>
                <a:spcPts val="0"/>
              </a:spcBef>
              <a:spcAft>
                <a:spcPts val="0"/>
              </a:spcAft>
              <a:buSzPts val="6000"/>
              <a:buNone/>
              <a:defRPr sz="6000"/>
            </a:lvl9pPr>
          </a:lstStyle>
          <a:p>
            <a:r>
              <a:t>xx%</a:t>
            </a:r>
          </a:p>
        </p:txBody>
      </p:sp>
      <p:sp>
        <p:nvSpPr>
          <p:cNvPr id="101" name="Google Shape;101;p14"/>
          <p:cNvSpPr txBox="1"/>
          <p:nvPr>
            <p:ph hasCustomPrompt="1" idx="14" type="title"/>
          </p:nvPr>
        </p:nvSpPr>
        <p:spPr>
          <a:xfrm>
            <a:off x="4732275" y="3153175"/>
            <a:ext cx="1048200" cy="1048200"/>
          </a:xfrm>
          <a:prstGeom prst="rect">
            <a:avLst/>
          </a:prstGeom>
          <a:noFill/>
          <a:ln>
            <a:noFill/>
          </a:ln>
        </p:spPr>
        <p:txBody>
          <a:bodyPr anchorCtr="0" anchor="ctr" bIns="91425" lIns="91425" spcFirstLastPara="1" rIns="91425" wrap="square" tIns="91425">
            <a:normAutofit/>
          </a:bodyPr>
          <a:lstStyle>
            <a:lvl1pPr lvl="0" algn="r">
              <a:spcBef>
                <a:spcPts val="0"/>
              </a:spcBef>
              <a:spcAft>
                <a:spcPts val="0"/>
              </a:spcAft>
              <a:buSzPts val="6000"/>
              <a:buNone/>
              <a:defRPr sz="4700">
                <a:solidFill>
                  <a:schemeClr val="lt1"/>
                </a:solidFill>
              </a:defRPr>
            </a:lvl1pPr>
            <a:lvl2pPr lvl="1" algn="ctr">
              <a:spcBef>
                <a:spcPts val="0"/>
              </a:spcBef>
              <a:spcAft>
                <a:spcPts val="0"/>
              </a:spcAft>
              <a:buSzPts val="6000"/>
              <a:buNone/>
              <a:defRPr sz="6000"/>
            </a:lvl2pPr>
            <a:lvl3pPr lvl="2" algn="ctr">
              <a:spcBef>
                <a:spcPts val="0"/>
              </a:spcBef>
              <a:spcAft>
                <a:spcPts val="0"/>
              </a:spcAft>
              <a:buSzPts val="6000"/>
              <a:buNone/>
              <a:defRPr sz="6000"/>
            </a:lvl3pPr>
            <a:lvl4pPr lvl="3" algn="ctr">
              <a:spcBef>
                <a:spcPts val="0"/>
              </a:spcBef>
              <a:spcAft>
                <a:spcPts val="0"/>
              </a:spcAft>
              <a:buSzPts val="6000"/>
              <a:buNone/>
              <a:defRPr sz="6000"/>
            </a:lvl4pPr>
            <a:lvl5pPr lvl="4" algn="ctr">
              <a:spcBef>
                <a:spcPts val="0"/>
              </a:spcBef>
              <a:spcAft>
                <a:spcPts val="0"/>
              </a:spcAft>
              <a:buSzPts val="6000"/>
              <a:buNone/>
              <a:defRPr sz="6000"/>
            </a:lvl5pPr>
            <a:lvl6pPr lvl="5" algn="ctr">
              <a:spcBef>
                <a:spcPts val="0"/>
              </a:spcBef>
              <a:spcAft>
                <a:spcPts val="0"/>
              </a:spcAft>
              <a:buSzPts val="6000"/>
              <a:buNone/>
              <a:defRPr sz="6000"/>
            </a:lvl6pPr>
            <a:lvl7pPr lvl="6" algn="ctr">
              <a:spcBef>
                <a:spcPts val="0"/>
              </a:spcBef>
              <a:spcAft>
                <a:spcPts val="0"/>
              </a:spcAft>
              <a:buSzPts val="6000"/>
              <a:buNone/>
              <a:defRPr sz="6000"/>
            </a:lvl7pPr>
            <a:lvl8pPr lvl="7" algn="ctr">
              <a:spcBef>
                <a:spcPts val="0"/>
              </a:spcBef>
              <a:spcAft>
                <a:spcPts val="0"/>
              </a:spcAft>
              <a:buSzPts val="6000"/>
              <a:buNone/>
              <a:defRPr sz="6000"/>
            </a:lvl8pPr>
            <a:lvl9pPr lvl="8" algn="ctr">
              <a:spcBef>
                <a:spcPts val="0"/>
              </a:spcBef>
              <a:spcAft>
                <a:spcPts val="0"/>
              </a:spcAft>
              <a:buSzPts val="6000"/>
              <a:buNone/>
              <a:defRPr sz="6000"/>
            </a:lvl9pPr>
          </a:lstStyle>
          <a:p>
            <a:r>
              <a:t>xx%</a:t>
            </a:r>
          </a:p>
        </p:txBody>
      </p:sp>
      <p:sp>
        <p:nvSpPr>
          <p:cNvPr id="102" name="Google Shape;102;p14"/>
          <p:cNvSpPr txBox="1"/>
          <p:nvPr>
            <p:ph idx="15" type="title"/>
          </p:nvPr>
        </p:nvSpPr>
        <p:spPr>
          <a:xfrm>
            <a:off x="720000" y="445025"/>
            <a:ext cx="7704000" cy="572700"/>
          </a:xfrm>
          <a:prstGeom prst="rect">
            <a:avLst/>
          </a:prstGeom>
        </p:spPr>
        <p:txBody>
          <a:bodyPr anchorCtr="0" anchor="t" bIns="91425" lIns="91425" spcFirstLastPara="1" rIns="91425" wrap="square" tIns="91425">
            <a:normAutofit/>
          </a:bodyPr>
          <a:lstStyle>
            <a:lvl1pPr lvl="0" algn="ctr">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03" name="Google Shape;103;p14"/>
          <p:cNvSpPr/>
          <p:nvPr/>
        </p:nvSpPr>
        <p:spPr>
          <a:xfrm>
            <a:off x="8649796" y="2155763"/>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04" name="Google Shape;104;p14"/>
          <p:cNvGrpSpPr/>
          <p:nvPr/>
        </p:nvGrpSpPr>
        <p:grpSpPr>
          <a:xfrm>
            <a:off x="353535" y="4510712"/>
            <a:ext cx="309000" cy="305294"/>
            <a:chOff x="8360310" y="1124637"/>
            <a:chExt cx="309000" cy="305294"/>
          </a:xfrm>
        </p:grpSpPr>
        <p:sp>
          <p:nvSpPr>
            <p:cNvPr id="105" name="Google Shape;105;p14"/>
            <p:cNvSpPr/>
            <p:nvPr/>
          </p:nvSpPr>
          <p:spPr>
            <a:xfrm>
              <a:off x="8360310" y="1124637"/>
              <a:ext cx="309000" cy="305294"/>
            </a:xfrm>
            <a:custGeom>
              <a:rect b="b" l="l" r="r" t="t"/>
              <a:pathLst>
                <a:path extrusionOk="0" h="6672" w="6753">
                  <a:moveTo>
                    <a:pt x="2767" y="1"/>
                  </a:moveTo>
                  <a:lnTo>
                    <a:pt x="2645" y="42"/>
                  </a:lnTo>
                  <a:lnTo>
                    <a:pt x="2563" y="82"/>
                  </a:lnTo>
                  <a:lnTo>
                    <a:pt x="2441" y="164"/>
                  </a:lnTo>
                  <a:lnTo>
                    <a:pt x="2360" y="245"/>
                  </a:lnTo>
                  <a:lnTo>
                    <a:pt x="2319" y="367"/>
                  </a:lnTo>
                  <a:lnTo>
                    <a:pt x="2238" y="652"/>
                  </a:lnTo>
                  <a:lnTo>
                    <a:pt x="2197" y="937"/>
                  </a:lnTo>
                  <a:lnTo>
                    <a:pt x="2197" y="1221"/>
                  </a:lnTo>
                  <a:lnTo>
                    <a:pt x="2238" y="1506"/>
                  </a:lnTo>
                  <a:lnTo>
                    <a:pt x="2075" y="1343"/>
                  </a:lnTo>
                  <a:lnTo>
                    <a:pt x="1872" y="1221"/>
                  </a:lnTo>
                  <a:lnTo>
                    <a:pt x="1546" y="1099"/>
                  </a:lnTo>
                  <a:lnTo>
                    <a:pt x="1262" y="1099"/>
                  </a:lnTo>
                  <a:lnTo>
                    <a:pt x="1140" y="1140"/>
                  </a:lnTo>
                  <a:lnTo>
                    <a:pt x="1018" y="1221"/>
                  </a:lnTo>
                  <a:lnTo>
                    <a:pt x="895" y="1343"/>
                  </a:lnTo>
                  <a:lnTo>
                    <a:pt x="855" y="1506"/>
                  </a:lnTo>
                  <a:lnTo>
                    <a:pt x="773" y="1791"/>
                  </a:lnTo>
                  <a:lnTo>
                    <a:pt x="814" y="2075"/>
                  </a:lnTo>
                  <a:lnTo>
                    <a:pt x="855" y="2360"/>
                  </a:lnTo>
                  <a:lnTo>
                    <a:pt x="1018" y="2604"/>
                  </a:lnTo>
                  <a:lnTo>
                    <a:pt x="1180" y="2808"/>
                  </a:lnTo>
                  <a:lnTo>
                    <a:pt x="1384" y="2970"/>
                  </a:lnTo>
                  <a:lnTo>
                    <a:pt x="1018" y="2970"/>
                  </a:lnTo>
                  <a:lnTo>
                    <a:pt x="814" y="3011"/>
                  </a:lnTo>
                  <a:lnTo>
                    <a:pt x="651" y="3052"/>
                  </a:lnTo>
                  <a:lnTo>
                    <a:pt x="407" y="3174"/>
                  </a:lnTo>
                  <a:lnTo>
                    <a:pt x="204" y="3377"/>
                  </a:lnTo>
                  <a:lnTo>
                    <a:pt x="82" y="3621"/>
                  </a:lnTo>
                  <a:lnTo>
                    <a:pt x="1" y="3865"/>
                  </a:lnTo>
                  <a:lnTo>
                    <a:pt x="1" y="4109"/>
                  </a:lnTo>
                  <a:lnTo>
                    <a:pt x="82" y="4353"/>
                  </a:lnTo>
                  <a:lnTo>
                    <a:pt x="245" y="4516"/>
                  </a:lnTo>
                  <a:lnTo>
                    <a:pt x="489" y="4638"/>
                  </a:lnTo>
                  <a:lnTo>
                    <a:pt x="692" y="4719"/>
                  </a:lnTo>
                  <a:lnTo>
                    <a:pt x="936" y="4719"/>
                  </a:lnTo>
                  <a:lnTo>
                    <a:pt x="1424" y="4679"/>
                  </a:lnTo>
                  <a:lnTo>
                    <a:pt x="1424" y="4679"/>
                  </a:lnTo>
                  <a:lnTo>
                    <a:pt x="1180" y="5004"/>
                  </a:lnTo>
                  <a:lnTo>
                    <a:pt x="1099" y="5167"/>
                  </a:lnTo>
                  <a:lnTo>
                    <a:pt x="1058" y="5370"/>
                  </a:lnTo>
                  <a:lnTo>
                    <a:pt x="1018" y="5655"/>
                  </a:lnTo>
                  <a:lnTo>
                    <a:pt x="1099" y="5899"/>
                  </a:lnTo>
                  <a:lnTo>
                    <a:pt x="1140" y="6021"/>
                  </a:lnTo>
                  <a:lnTo>
                    <a:pt x="1221" y="6143"/>
                  </a:lnTo>
                  <a:lnTo>
                    <a:pt x="1343" y="6224"/>
                  </a:lnTo>
                  <a:lnTo>
                    <a:pt x="1465" y="6306"/>
                  </a:lnTo>
                  <a:lnTo>
                    <a:pt x="1709" y="6387"/>
                  </a:lnTo>
                  <a:lnTo>
                    <a:pt x="1994" y="6387"/>
                  </a:lnTo>
                  <a:lnTo>
                    <a:pt x="2238" y="6346"/>
                  </a:lnTo>
                  <a:lnTo>
                    <a:pt x="2482" y="6224"/>
                  </a:lnTo>
                  <a:lnTo>
                    <a:pt x="2726" y="6021"/>
                  </a:lnTo>
                  <a:lnTo>
                    <a:pt x="2889" y="5777"/>
                  </a:lnTo>
                  <a:lnTo>
                    <a:pt x="3011" y="6102"/>
                  </a:lnTo>
                  <a:lnTo>
                    <a:pt x="3092" y="6265"/>
                  </a:lnTo>
                  <a:lnTo>
                    <a:pt x="3173" y="6387"/>
                  </a:lnTo>
                  <a:lnTo>
                    <a:pt x="3295" y="6509"/>
                  </a:lnTo>
                  <a:lnTo>
                    <a:pt x="3417" y="6590"/>
                  </a:lnTo>
                  <a:lnTo>
                    <a:pt x="3580" y="6631"/>
                  </a:lnTo>
                  <a:lnTo>
                    <a:pt x="3743" y="6672"/>
                  </a:lnTo>
                  <a:lnTo>
                    <a:pt x="3906" y="6672"/>
                  </a:lnTo>
                  <a:lnTo>
                    <a:pt x="4109" y="6590"/>
                  </a:lnTo>
                  <a:lnTo>
                    <a:pt x="4312" y="6468"/>
                  </a:lnTo>
                  <a:lnTo>
                    <a:pt x="4475" y="6306"/>
                  </a:lnTo>
                  <a:lnTo>
                    <a:pt x="4597" y="6102"/>
                  </a:lnTo>
                  <a:lnTo>
                    <a:pt x="4678" y="5777"/>
                  </a:lnTo>
                  <a:lnTo>
                    <a:pt x="4678" y="5452"/>
                  </a:lnTo>
                  <a:lnTo>
                    <a:pt x="4841" y="5533"/>
                  </a:lnTo>
                  <a:lnTo>
                    <a:pt x="5004" y="5574"/>
                  </a:lnTo>
                  <a:lnTo>
                    <a:pt x="5329" y="5574"/>
                  </a:lnTo>
                  <a:lnTo>
                    <a:pt x="5492" y="5533"/>
                  </a:lnTo>
                  <a:lnTo>
                    <a:pt x="5655" y="5492"/>
                  </a:lnTo>
                  <a:lnTo>
                    <a:pt x="5817" y="5370"/>
                  </a:lnTo>
                  <a:lnTo>
                    <a:pt x="5939" y="5248"/>
                  </a:lnTo>
                  <a:lnTo>
                    <a:pt x="6061" y="5085"/>
                  </a:lnTo>
                  <a:lnTo>
                    <a:pt x="6143" y="4923"/>
                  </a:lnTo>
                  <a:lnTo>
                    <a:pt x="6183" y="4760"/>
                  </a:lnTo>
                  <a:lnTo>
                    <a:pt x="6224" y="4597"/>
                  </a:lnTo>
                  <a:lnTo>
                    <a:pt x="6224" y="4394"/>
                  </a:lnTo>
                  <a:lnTo>
                    <a:pt x="6183" y="4231"/>
                  </a:lnTo>
                  <a:lnTo>
                    <a:pt x="6102" y="4069"/>
                  </a:lnTo>
                  <a:lnTo>
                    <a:pt x="6021" y="3947"/>
                  </a:lnTo>
                  <a:lnTo>
                    <a:pt x="6183" y="3865"/>
                  </a:lnTo>
                  <a:lnTo>
                    <a:pt x="6346" y="3784"/>
                  </a:lnTo>
                  <a:lnTo>
                    <a:pt x="6468" y="3662"/>
                  </a:lnTo>
                  <a:lnTo>
                    <a:pt x="6590" y="3540"/>
                  </a:lnTo>
                  <a:lnTo>
                    <a:pt x="6672" y="3418"/>
                  </a:lnTo>
                  <a:lnTo>
                    <a:pt x="6712" y="3255"/>
                  </a:lnTo>
                  <a:lnTo>
                    <a:pt x="6753" y="3052"/>
                  </a:lnTo>
                  <a:lnTo>
                    <a:pt x="6712" y="2848"/>
                  </a:lnTo>
                  <a:lnTo>
                    <a:pt x="6672" y="2686"/>
                  </a:lnTo>
                  <a:lnTo>
                    <a:pt x="6590" y="2523"/>
                  </a:lnTo>
                  <a:lnTo>
                    <a:pt x="6468" y="2360"/>
                  </a:lnTo>
                  <a:lnTo>
                    <a:pt x="6346" y="2238"/>
                  </a:lnTo>
                  <a:lnTo>
                    <a:pt x="6183" y="2157"/>
                  </a:lnTo>
                  <a:lnTo>
                    <a:pt x="6021" y="2116"/>
                  </a:lnTo>
                  <a:lnTo>
                    <a:pt x="5858" y="2075"/>
                  </a:lnTo>
                  <a:lnTo>
                    <a:pt x="5695" y="2075"/>
                  </a:lnTo>
                  <a:lnTo>
                    <a:pt x="5817" y="1750"/>
                  </a:lnTo>
                  <a:lnTo>
                    <a:pt x="5817" y="1547"/>
                  </a:lnTo>
                  <a:lnTo>
                    <a:pt x="5817" y="1384"/>
                  </a:lnTo>
                  <a:lnTo>
                    <a:pt x="5777" y="1099"/>
                  </a:lnTo>
                  <a:lnTo>
                    <a:pt x="5655" y="855"/>
                  </a:lnTo>
                  <a:lnTo>
                    <a:pt x="5492" y="652"/>
                  </a:lnTo>
                  <a:lnTo>
                    <a:pt x="5370" y="570"/>
                  </a:lnTo>
                  <a:lnTo>
                    <a:pt x="5248" y="489"/>
                  </a:lnTo>
                  <a:lnTo>
                    <a:pt x="4963" y="448"/>
                  </a:lnTo>
                  <a:lnTo>
                    <a:pt x="4678" y="489"/>
                  </a:lnTo>
                  <a:lnTo>
                    <a:pt x="4434" y="570"/>
                  </a:lnTo>
                  <a:lnTo>
                    <a:pt x="4190" y="733"/>
                  </a:lnTo>
                  <a:lnTo>
                    <a:pt x="3946" y="977"/>
                  </a:lnTo>
                  <a:lnTo>
                    <a:pt x="3784" y="1262"/>
                  </a:lnTo>
                  <a:lnTo>
                    <a:pt x="3661" y="896"/>
                  </a:lnTo>
                  <a:lnTo>
                    <a:pt x="3458" y="448"/>
                  </a:lnTo>
                  <a:lnTo>
                    <a:pt x="3336" y="245"/>
                  </a:lnTo>
                  <a:lnTo>
                    <a:pt x="3133" y="82"/>
                  </a:lnTo>
                  <a:lnTo>
                    <a:pt x="3011" y="42"/>
                  </a:lnTo>
                  <a:lnTo>
                    <a:pt x="2889"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06" name="Google Shape;106;p14"/>
            <p:cNvSpPr/>
            <p:nvPr/>
          </p:nvSpPr>
          <p:spPr>
            <a:xfrm>
              <a:off x="8444093" y="1206543"/>
              <a:ext cx="169394" cy="160105"/>
            </a:xfrm>
            <a:custGeom>
              <a:rect b="b" l="l" r="r" t="t"/>
              <a:pathLst>
                <a:path extrusionOk="0" h="3499" w="3702">
                  <a:moveTo>
                    <a:pt x="2197" y="1"/>
                  </a:moveTo>
                  <a:lnTo>
                    <a:pt x="1912" y="41"/>
                  </a:lnTo>
                  <a:lnTo>
                    <a:pt x="1668" y="41"/>
                  </a:lnTo>
                  <a:lnTo>
                    <a:pt x="1424" y="123"/>
                  </a:lnTo>
                  <a:lnTo>
                    <a:pt x="1180" y="204"/>
                  </a:lnTo>
                  <a:lnTo>
                    <a:pt x="936" y="326"/>
                  </a:lnTo>
                  <a:lnTo>
                    <a:pt x="692" y="489"/>
                  </a:lnTo>
                  <a:lnTo>
                    <a:pt x="488" y="692"/>
                  </a:lnTo>
                  <a:lnTo>
                    <a:pt x="285" y="936"/>
                  </a:lnTo>
                  <a:lnTo>
                    <a:pt x="163" y="1180"/>
                  </a:lnTo>
                  <a:lnTo>
                    <a:pt x="41" y="1465"/>
                  </a:lnTo>
                  <a:lnTo>
                    <a:pt x="0" y="1750"/>
                  </a:lnTo>
                  <a:lnTo>
                    <a:pt x="41" y="2035"/>
                  </a:lnTo>
                  <a:lnTo>
                    <a:pt x="81" y="2360"/>
                  </a:lnTo>
                  <a:lnTo>
                    <a:pt x="203" y="2645"/>
                  </a:lnTo>
                  <a:lnTo>
                    <a:pt x="366" y="2889"/>
                  </a:lnTo>
                  <a:lnTo>
                    <a:pt x="570" y="3092"/>
                  </a:lnTo>
                  <a:lnTo>
                    <a:pt x="814" y="3255"/>
                  </a:lnTo>
                  <a:lnTo>
                    <a:pt x="1058" y="3377"/>
                  </a:lnTo>
                  <a:lnTo>
                    <a:pt x="1342" y="3458"/>
                  </a:lnTo>
                  <a:lnTo>
                    <a:pt x="1627" y="3499"/>
                  </a:lnTo>
                  <a:lnTo>
                    <a:pt x="1912" y="3499"/>
                  </a:lnTo>
                  <a:lnTo>
                    <a:pt x="2197" y="3417"/>
                  </a:lnTo>
                  <a:lnTo>
                    <a:pt x="2481" y="3295"/>
                  </a:lnTo>
                  <a:lnTo>
                    <a:pt x="2725" y="3133"/>
                  </a:lnTo>
                  <a:lnTo>
                    <a:pt x="2969" y="2929"/>
                  </a:lnTo>
                  <a:lnTo>
                    <a:pt x="3173" y="2726"/>
                  </a:lnTo>
                  <a:lnTo>
                    <a:pt x="3376" y="2441"/>
                  </a:lnTo>
                  <a:lnTo>
                    <a:pt x="3539" y="2157"/>
                  </a:lnTo>
                  <a:lnTo>
                    <a:pt x="3620" y="1872"/>
                  </a:lnTo>
                  <a:lnTo>
                    <a:pt x="3702" y="1587"/>
                  </a:lnTo>
                  <a:lnTo>
                    <a:pt x="3702" y="1343"/>
                  </a:lnTo>
                  <a:lnTo>
                    <a:pt x="3661" y="1099"/>
                  </a:lnTo>
                  <a:lnTo>
                    <a:pt x="3580" y="855"/>
                  </a:lnTo>
                  <a:lnTo>
                    <a:pt x="3498" y="652"/>
                  </a:lnTo>
                  <a:lnTo>
                    <a:pt x="3335" y="489"/>
                  </a:lnTo>
                  <a:lnTo>
                    <a:pt x="3173" y="326"/>
                  </a:lnTo>
                  <a:lnTo>
                    <a:pt x="2969" y="204"/>
                  </a:lnTo>
                  <a:lnTo>
                    <a:pt x="2725" y="123"/>
                  </a:lnTo>
                  <a:lnTo>
                    <a:pt x="2441" y="41"/>
                  </a:lnTo>
                  <a:lnTo>
                    <a:pt x="219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07" name="Google Shape;107;p14"/>
            <p:cNvSpPr/>
            <p:nvPr/>
          </p:nvSpPr>
          <p:spPr>
            <a:xfrm>
              <a:off x="8535287" y="1236332"/>
              <a:ext cx="18623" cy="18669"/>
            </a:xfrm>
            <a:custGeom>
              <a:rect b="b" l="l" r="r" t="t"/>
              <a:pathLst>
                <a:path extrusionOk="0" h="408" w="407">
                  <a:moveTo>
                    <a:pt x="122" y="1"/>
                  </a:moveTo>
                  <a:lnTo>
                    <a:pt x="82" y="41"/>
                  </a:lnTo>
                  <a:lnTo>
                    <a:pt x="41" y="123"/>
                  </a:lnTo>
                  <a:lnTo>
                    <a:pt x="0" y="204"/>
                  </a:lnTo>
                  <a:lnTo>
                    <a:pt x="41" y="285"/>
                  </a:lnTo>
                  <a:lnTo>
                    <a:pt x="82" y="326"/>
                  </a:lnTo>
                  <a:lnTo>
                    <a:pt x="122" y="367"/>
                  </a:lnTo>
                  <a:lnTo>
                    <a:pt x="204" y="407"/>
                  </a:lnTo>
                  <a:lnTo>
                    <a:pt x="285" y="367"/>
                  </a:lnTo>
                  <a:lnTo>
                    <a:pt x="366" y="326"/>
                  </a:lnTo>
                  <a:lnTo>
                    <a:pt x="407" y="285"/>
                  </a:lnTo>
                  <a:lnTo>
                    <a:pt x="407" y="204"/>
                  </a:lnTo>
                  <a:lnTo>
                    <a:pt x="407" y="123"/>
                  </a:lnTo>
                  <a:lnTo>
                    <a:pt x="366" y="41"/>
                  </a:lnTo>
                  <a:lnTo>
                    <a:pt x="28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08" name="Google Shape;108;p14"/>
            <p:cNvSpPr/>
            <p:nvPr/>
          </p:nvSpPr>
          <p:spPr>
            <a:xfrm>
              <a:off x="8492458" y="1241914"/>
              <a:ext cx="18669" cy="18669"/>
            </a:xfrm>
            <a:custGeom>
              <a:rect b="b" l="l" r="r" t="t"/>
              <a:pathLst>
                <a:path extrusionOk="0" h="408" w="408">
                  <a:moveTo>
                    <a:pt x="204" y="1"/>
                  </a:moveTo>
                  <a:lnTo>
                    <a:pt x="123" y="41"/>
                  </a:lnTo>
                  <a:lnTo>
                    <a:pt x="41" y="82"/>
                  </a:lnTo>
                  <a:lnTo>
                    <a:pt x="1" y="123"/>
                  </a:lnTo>
                  <a:lnTo>
                    <a:pt x="1" y="204"/>
                  </a:lnTo>
                  <a:lnTo>
                    <a:pt x="1" y="285"/>
                  </a:lnTo>
                  <a:lnTo>
                    <a:pt x="41" y="367"/>
                  </a:lnTo>
                  <a:lnTo>
                    <a:pt x="82" y="407"/>
                  </a:lnTo>
                  <a:lnTo>
                    <a:pt x="285" y="407"/>
                  </a:lnTo>
                  <a:lnTo>
                    <a:pt x="367" y="367"/>
                  </a:lnTo>
                  <a:lnTo>
                    <a:pt x="407" y="285"/>
                  </a:lnTo>
                  <a:lnTo>
                    <a:pt x="407" y="204"/>
                  </a:lnTo>
                  <a:lnTo>
                    <a:pt x="407" y="163"/>
                  </a:lnTo>
                  <a:lnTo>
                    <a:pt x="367" y="82"/>
                  </a:lnTo>
                  <a:lnTo>
                    <a:pt x="326" y="41"/>
                  </a:lnTo>
                  <a:lnTo>
                    <a:pt x="2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09" name="Google Shape;109;p14"/>
            <p:cNvSpPr/>
            <p:nvPr/>
          </p:nvSpPr>
          <p:spPr>
            <a:xfrm>
              <a:off x="8477587" y="1290326"/>
              <a:ext cx="16793" cy="18623"/>
            </a:xfrm>
            <a:custGeom>
              <a:rect b="b" l="l" r="r" t="t"/>
              <a:pathLst>
                <a:path extrusionOk="0" h="407" w="367">
                  <a:moveTo>
                    <a:pt x="122" y="0"/>
                  </a:moveTo>
                  <a:lnTo>
                    <a:pt x="41" y="41"/>
                  </a:lnTo>
                  <a:lnTo>
                    <a:pt x="0" y="122"/>
                  </a:lnTo>
                  <a:lnTo>
                    <a:pt x="0" y="204"/>
                  </a:lnTo>
                  <a:lnTo>
                    <a:pt x="0" y="285"/>
                  </a:lnTo>
                  <a:lnTo>
                    <a:pt x="41" y="326"/>
                  </a:lnTo>
                  <a:lnTo>
                    <a:pt x="122" y="366"/>
                  </a:lnTo>
                  <a:lnTo>
                    <a:pt x="204" y="407"/>
                  </a:lnTo>
                  <a:lnTo>
                    <a:pt x="285" y="366"/>
                  </a:lnTo>
                  <a:lnTo>
                    <a:pt x="326" y="326"/>
                  </a:lnTo>
                  <a:lnTo>
                    <a:pt x="366" y="285"/>
                  </a:lnTo>
                  <a:lnTo>
                    <a:pt x="366" y="204"/>
                  </a:lnTo>
                  <a:lnTo>
                    <a:pt x="366" y="122"/>
                  </a:lnTo>
                  <a:lnTo>
                    <a:pt x="326"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10" name="Google Shape;110;p14"/>
            <p:cNvSpPr/>
            <p:nvPr/>
          </p:nvSpPr>
          <p:spPr>
            <a:xfrm>
              <a:off x="8516664" y="1318238"/>
              <a:ext cx="16793" cy="18669"/>
            </a:xfrm>
            <a:custGeom>
              <a:rect b="b" l="l" r="r" t="t"/>
              <a:pathLst>
                <a:path extrusionOk="0" h="408" w="367">
                  <a:moveTo>
                    <a:pt x="122" y="0"/>
                  </a:moveTo>
                  <a:lnTo>
                    <a:pt x="41" y="41"/>
                  </a:lnTo>
                  <a:lnTo>
                    <a:pt x="0" y="122"/>
                  </a:lnTo>
                  <a:lnTo>
                    <a:pt x="0" y="204"/>
                  </a:lnTo>
                  <a:lnTo>
                    <a:pt x="0" y="244"/>
                  </a:lnTo>
                  <a:lnTo>
                    <a:pt x="41" y="326"/>
                  </a:lnTo>
                  <a:lnTo>
                    <a:pt x="122" y="366"/>
                  </a:lnTo>
                  <a:lnTo>
                    <a:pt x="204" y="407"/>
                  </a:lnTo>
                  <a:lnTo>
                    <a:pt x="285" y="366"/>
                  </a:lnTo>
                  <a:lnTo>
                    <a:pt x="326" y="326"/>
                  </a:lnTo>
                  <a:lnTo>
                    <a:pt x="367" y="244"/>
                  </a:lnTo>
                  <a:lnTo>
                    <a:pt x="367" y="204"/>
                  </a:lnTo>
                  <a:lnTo>
                    <a:pt x="367" y="122"/>
                  </a:lnTo>
                  <a:lnTo>
                    <a:pt x="326"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11" name="Google Shape;111;p14"/>
            <p:cNvSpPr/>
            <p:nvPr/>
          </p:nvSpPr>
          <p:spPr>
            <a:xfrm>
              <a:off x="8561324" y="1280991"/>
              <a:ext cx="16793" cy="16793"/>
            </a:xfrm>
            <a:custGeom>
              <a:rect b="b" l="l" r="r" t="t"/>
              <a:pathLst>
                <a:path extrusionOk="0" h="367" w="367">
                  <a:moveTo>
                    <a:pt x="82" y="1"/>
                  </a:moveTo>
                  <a:lnTo>
                    <a:pt x="41" y="41"/>
                  </a:lnTo>
                  <a:lnTo>
                    <a:pt x="1" y="123"/>
                  </a:lnTo>
                  <a:lnTo>
                    <a:pt x="1" y="163"/>
                  </a:lnTo>
                  <a:lnTo>
                    <a:pt x="1" y="245"/>
                  </a:lnTo>
                  <a:lnTo>
                    <a:pt x="41" y="326"/>
                  </a:lnTo>
                  <a:lnTo>
                    <a:pt x="82" y="367"/>
                  </a:lnTo>
                  <a:lnTo>
                    <a:pt x="245" y="367"/>
                  </a:lnTo>
                  <a:lnTo>
                    <a:pt x="326" y="326"/>
                  </a:lnTo>
                  <a:lnTo>
                    <a:pt x="367" y="245"/>
                  </a:lnTo>
                  <a:lnTo>
                    <a:pt x="367" y="163"/>
                  </a:lnTo>
                  <a:lnTo>
                    <a:pt x="367" y="123"/>
                  </a:lnTo>
                  <a:lnTo>
                    <a:pt x="326" y="41"/>
                  </a:lnTo>
                  <a:lnTo>
                    <a:pt x="24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12" name="Google Shape;112;p14"/>
            <p:cNvSpPr/>
            <p:nvPr/>
          </p:nvSpPr>
          <p:spPr>
            <a:xfrm>
              <a:off x="8522247" y="1271702"/>
              <a:ext cx="16793" cy="18669"/>
            </a:xfrm>
            <a:custGeom>
              <a:rect b="b" l="l" r="r" t="t"/>
              <a:pathLst>
                <a:path extrusionOk="0" h="408" w="367">
                  <a:moveTo>
                    <a:pt x="163" y="0"/>
                  </a:moveTo>
                  <a:lnTo>
                    <a:pt x="82" y="41"/>
                  </a:lnTo>
                  <a:lnTo>
                    <a:pt x="41" y="82"/>
                  </a:lnTo>
                  <a:lnTo>
                    <a:pt x="0" y="122"/>
                  </a:lnTo>
                  <a:lnTo>
                    <a:pt x="0" y="204"/>
                  </a:lnTo>
                  <a:lnTo>
                    <a:pt x="0" y="285"/>
                  </a:lnTo>
                  <a:lnTo>
                    <a:pt x="41" y="326"/>
                  </a:lnTo>
                  <a:lnTo>
                    <a:pt x="82" y="407"/>
                  </a:lnTo>
                  <a:lnTo>
                    <a:pt x="245" y="407"/>
                  </a:lnTo>
                  <a:lnTo>
                    <a:pt x="326" y="326"/>
                  </a:lnTo>
                  <a:lnTo>
                    <a:pt x="367" y="285"/>
                  </a:lnTo>
                  <a:lnTo>
                    <a:pt x="367" y="204"/>
                  </a:lnTo>
                  <a:lnTo>
                    <a:pt x="367" y="122"/>
                  </a:lnTo>
                  <a:lnTo>
                    <a:pt x="326" y="82"/>
                  </a:lnTo>
                  <a:lnTo>
                    <a:pt x="245" y="41"/>
                  </a:lnTo>
                  <a:lnTo>
                    <a:pt x="163"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113" name="Google Shape;113;p14"/>
          <p:cNvGrpSpPr/>
          <p:nvPr/>
        </p:nvGrpSpPr>
        <p:grpSpPr>
          <a:xfrm>
            <a:off x="1272319" y="559784"/>
            <a:ext cx="474643" cy="301588"/>
            <a:chOff x="7593894" y="395296"/>
            <a:chExt cx="474643" cy="301588"/>
          </a:xfrm>
        </p:grpSpPr>
        <p:sp>
          <p:nvSpPr>
            <p:cNvPr id="114" name="Google Shape;114;p14"/>
            <p:cNvSpPr/>
            <p:nvPr/>
          </p:nvSpPr>
          <p:spPr>
            <a:xfrm>
              <a:off x="7603183" y="404585"/>
              <a:ext cx="456065" cy="282964"/>
            </a:xfrm>
            <a:custGeom>
              <a:rect b="b" l="l" r="r" t="t"/>
              <a:pathLst>
                <a:path extrusionOk="0" h="6184" w="9967">
                  <a:moveTo>
                    <a:pt x="4678" y="1"/>
                  </a:moveTo>
                  <a:lnTo>
                    <a:pt x="4394" y="42"/>
                  </a:lnTo>
                  <a:lnTo>
                    <a:pt x="4109" y="164"/>
                  </a:lnTo>
                  <a:lnTo>
                    <a:pt x="3824" y="286"/>
                  </a:lnTo>
                  <a:lnTo>
                    <a:pt x="3540" y="448"/>
                  </a:lnTo>
                  <a:lnTo>
                    <a:pt x="3336" y="692"/>
                  </a:lnTo>
                  <a:lnTo>
                    <a:pt x="3133" y="936"/>
                  </a:lnTo>
                  <a:lnTo>
                    <a:pt x="2970" y="1181"/>
                  </a:lnTo>
                  <a:lnTo>
                    <a:pt x="2848" y="1465"/>
                  </a:lnTo>
                  <a:lnTo>
                    <a:pt x="2767" y="1750"/>
                  </a:lnTo>
                  <a:lnTo>
                    <a:pt x="2685" y="2075"/>
                  </a:lnTo>
                  <a:lnTo>
                    <a:pt x="2645" y="2360"/>
                  </a:lnTo>
                  <a:lnTo>
                    <a:pt x="2645" y="2686"/>
                  </a:lnTo>
                  <a:lnTo>
                    <a:pt x="2685" y="3011"/>
                  </a:lnTo>
                  <a:lnTo>
                    <a:pt x="2441" y="2848"/>
                  </a:lnTo>
                  <a:lnTo>
                    <a:pt x="2197" y="2767"/>
                  </a:lnTo>
                  <a:lnTo>
                    <a:pt x="1953" y="2686"/>
                  </a:lnTo>
                  <a:lnTo>
                    <a:pt x="1424" y="2686"/>
                  </a:lnTo>
                  <a:lnTo>
                    <a:pt x="1180" y="2767"/>
                  </a:lnTo>
                  <a:lnTo>
                    <a:pt x="936" y="2848"/>
                  </a:lnTo>
                  <a:lnTo>
                    <a:pt x="692" y="2970"/>
                  </a:lnTo>
                  <a:lnTo>
                    <a:pt x="570" y="3092"/>
                  </a:lnTo>
                  <a:lnTo>
                    <a:pt x="407" y="3214"/>
                  </a:lnTo>
                  <a:lnTo>
                    <a:pt x="204" y="3540"/>
                  </a:lnTo>
                  <a:lnTo>
                    <a:pt x="41" y="3906"/>
                  </a:lnTo>
                  <a:lnTo>
                    <a:pt x="1" y="4272"/>
                  </a:lnTo>
                  <a:lnTo>
                    <a:pt x="1" y="4679"/>
                  </a:lnTo>
                  <a:lnTo>
                    <a:pt x="82" y="5045"/>
                  </a:lnTo>
                  <a:lnTo>
                    <a:pt x="285" y="5370"/>
                  </a:lnTo>
                  <a:lnTo>
                    <a:pt x="407" y="5533"/>
                  </a:lnTo>
                  <a:lnTo>
                    <a:pt x="529" y="5655"/>
                  </a:lnTo>
                  <a:lnTo>
                    <a:pt x="814" y="5858"/>
                  </a:lnTo>
                  <a:lnTo>
                    <a:pt x="1180" y="6021"/>
                  </a:lnTo>
                  <a:lnTo>
                    <a:pt x="1587" y="6102"/>
                  </a:lnTo>
                  <a:lnTo>
                    <a:pt x="1994" y="6143"/>
                  </a:lnTo>
                  <a:lnTo>
                    <a:pt x="2848" y="6184"/>
                  </a:lnTo>
                  <a:lnTo>
                    <a:pt x="3580" y="6143"/>
                  </a:lnTo>
                  <a:lnTo>
                    <a:pt x="4678" y="6143"/>
                  </a:lnTo>
                  <a:lnTo>
                    <a:pt x="5736" y="6102"/>
                  </a:lnTo>
                  <a:lnTo>
                    <a:pt x="6834" y="6021"/>
                  </a:lnTo>
                  <a:lnTo>
                    <a:pt x="7892" y="5899"/>
                  </a:lnTo>
                  <a:lnTo>
                    <a:pt x="8543" y="5818"/>
                  </a:lnTo>
                  <a:lnTo>
                    <a:pt x="8868" y="5736"/>
                  </a:lnTo>
                  <a:lnTo>
                    <a:pt x="9153" y="5614"/>
                  </a:lnTo>
                  <a:lnTo>
                    <a:pt x="9438" y="5452"/>
                  </a:lnTo>
                  <a:lnTo>
                    <a:pt x="9682" y="5248"/>
                  </a:lnTo>
                  <a:lnTo>
                    <a:pt x="9844" y="5045"/>
                  </a:lnTo>
                  <a:lnTo>
                    <a:pt x="9926" y="4760"/>
                  </a:lnTo>
                  <a:lnTo>
                    <a:pt x="9966" y="4557"/>
                  </a:lnTo>
                  <a:lnTo>
                    <a:pt x="9966" y="4353"/>
                  </a:lnTo>
                  <a:lnTo>
                    <a:pt x="9885" y="4150"/>
                  </a:lnTo>
                  <a:lnTo>
                    <a:pt x="9804" y="3946"/>
                  </a:lnTo>
                  <a:lnTo>
                    <a:pt x="9682" y="3784"/>
                  </a:lnTo>
                  <a:lnTo>
                    <a:pt x="9560" y="3662"/>
                  </a:lnTo>
                  <a:lnTo>
                    <a:pt x="9397" y="3499"/>
                  </a:lnTo>
                  <a:lnTo>
                    <a:pt x="9234" y="3418"/>
                  </a:lnTo>
                  <a:lnTo>
                    <a:pt x="9031" y="3336"/>
                  </a:lnTo>
                  <a:lnTo>
                    <a:pt x="8827" y="3296"/>
                  </a:lnTo>
                  <a:lnTo>
                    <a:pt x="8421" y="3296"/>
                  </a:lnTo>
                  <a:lnTo>
                    <a:pt x="8014" y="3418"/>
                  </a:lnTo>
                  <a:lnTo>
                    <a:pt x="7648" y="3580"/>
                  </a:lnTo>
                  <a:lnTo>
                    <a:pt x="7729" y="3458"/>
                  </a:lnTo>
                  <a:lnTo>
                    <a:pt x="7770" y="3296"/>
                  </a:lnTo>
                  <a:lnTo>
                    <a:pt x="7811" y="3011"/>
                  </a:lnTo>
                  <a:lnTo>
                    <a:pt x="7729" y="2726"/>
                  </a:lnTo>
                  <a:lnTo>
                    <a:pt x="7648" y="2564"/>
                  </a:lnTo>
                  <a:lnTo>
                    <a:pt x="7566" y="2441"/>
                  </a:lnTo>
                  <a:lnTo>
                    <a:pt x="7444" y="2360"/>
                  </a:lnTo>
                  <a:lnTo>
                    <a:pt x="7322" y="2279"/>
                  </a:lnTo>
                  <a:lnTo>
                    <a:pt x="7038" y="2157"/>
                  </a:lnTo>
                  <a:lnTo>
                    <a:pt x="6590" y="2157"/>
                  </a:lnTo>
                  <a:lnTo>
                    <a:pt x="6428" y="2197"/>
                  </a:lnTo>
                  <a:lnTo>
                    <a:pt x="6550" y="1913"/>
                  </a:lnTo>
                  <a:lnTo>
                    <a:pt x="6550" y="1628"/>
                  </a:lnTo>
                  <a:lnTo>
                    <a:pt x="6550" y="1303"/>
                  </a:lnTo>
                  <a:lnTo>
                    <a:pt x="6428" y="1018"/>
                  </a:lnTo>
                  <a:lnTo>
                    <a:pt x="6306" y="733"/>
                  </a:lnTo>
                  <a:lnTo>
                    <a:pt x="6102" y="489"/>
                  </a:lnTo>
                  <a:lnTo>
                    <a:pt x="5858" y="286"/>
                  </a:lnTo>
                  <a:lnTo>
                    <a:pt x="5614" y="164"/>
                  </a:lnTo>
                  <a:lnTo>
                    <a:pt x="5289" y="42"/>
                  </a:lnTo>
                  <a:lnTo>
                    <a:pt x="50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15" name="Google Shape;115;p14"/>
            <p:cNvSpPr/>
            <p:nvPr/>
          </p:nvSpPr>
          <p:spPr>
            <a:xfrm>
              <a:off x="7593894" y="395296"/>
              <a:ext cx="474643" cy="301588"/>
            </a:xfrm>
            <a:custGeom>
              <a:rect b="b" l="l" r="r" t="t"/>
              <a:pathLst>
                <a:path extrusionOk="0" h="6591" w="10373">
                  <a:moveTo>
                    <a:pt x="5329" y="407"/>
                  </a:moveTo>
                  <a:lnTo>
                    <a:pt x="5532" y="448"/>
                  </a:lnTo>
                  <a:lnTo>
                    <a:pt x="5695" y="529"/>
                  </a:lnTo>
                  <a:lnTo>
                    <a:pt x="5858" y="611"/>
                  </a:lnTo>
                  <a:lnTo>
                    <a:pt x="6020" y="733"/>
                  </a:lnTo>
                  <a:lnTo>
                    <a:pt x="6183" y="855"/>
                  </a:lnTo>
                  <a:lnTo>
                    <a:pt x="6305" y="1017"/>
                  </a:lnTo>
                  <a:lnTo>
                    <a:pt x="6386" y="1180"/>
                  </a:lnTo>
                  <a:lnTo>
                    <a:pt x="6468" y="1384"/>
                  </a:lnTo>
                  <a:lnTo>
                    <a:pt x="6549" y="1546"/>
                  </a:lnTo>
                  <a:lnTo>
                    <a:pt x="6549" y="1750"/>
                  </a:lnTo>
                  <a:lnTo>
                    <a:pt x="6549" y="1953"/>
                  </a:lnTo>
                  <a:lnTo>
                    <a:pt x="6549" y="2116"/>
                  </a:lnTo>
                  <a:lnTo>
                    <a:pt x="6468" y="2319"/>
                  </a:lnTo>
                  <a:lnTo>
                    <a:pt x="6468" y="2441"/>
                  </a:lnTo>
                  <a:lnTo>
                    <a:pt x="6509" y="2522"/>
                  </a:lnTo>
                  <a:lnTo>
                    <a:pt x="6590" y="2604"/>
                  </a:lnTo>
                  <a:lnTo>
                    <a:pt x="6712" y="2604"/>
                  </a:lnTo>
                  <a:lnTo>
                    <a:pt x="6956" y="2563"/>
                  </a:lnTo>
                  <a:lnTo>
                    <a:pt x="7200" y="2563"/>
                  </a:lnTo>
                  <a:lnTo>
                    <a:pt x="7403" y="2644"/>
                  </a:lnTo>
                  <a:lnTo>
                    <a:pt x="7607" y="2807"/>
                  </a:lnTo>
                  <a:lnTo>
                    <a:pt x="7729" y="2970"/>
                  </a:lnTo>
                  <a:lnTo>
                    <a:pt x="7810" y="3214"/>
                  </a:lnTo>
                  <a:lnTo>
                    <a:pt x="7769" y="3458"/>
                  </a:lnTo>
                  <a:lnTo>
                    <a:pt x="7688" y="3702"/>
                  </a:lnTo>
                  <a:lnTo>
                    <a:pt x="7647" y="3783"/>
                  </a:lnTo>
                  <a:lnTo>
                    <a:pt x="7647" y="3824"/>
                  </a:lnTo>
                  <a:lnTo>
                    <a:pt x="7729" y="3946"/>
                  </a:lnTo>
                  <a:lnTo>
                    <a:pt x="7851" y="3987"/>
                  </a:lnTo>
                  <a:lnTo>
                    <a:pt x="7973" y="3987"/>
                  </a:lnTo>
                  <a:lnTo>
                    <a:pt x="8298" y="3824"/>
                  </a:lnTo>
                  <a:lnTo>
                    <a:pt x="8624" y="3702"/>
                  </a:lnTo>
                  <a:lnTo>
                    <a:pt x="8990" y="3702"/>
                  </a:lnTo>
                  <a:lnTo>
                    <a:pt x="9152" y="3743"/>
                  </a:lnTo>
                  <a:lnTo>
                    <a:pt x="9356" y="3824"/>
                  </a:lnTo>
                  <a:lnTo>
                    <a:pt x="9478" y="3865"/>
                  </a:lnTo>
                  <a:lnTo>
                    <a:pt x="9641" y="3987"/>
                  </a:lnTo>
                  <a:lnTo>
                    <a:pt x="9722" y="4109"/>
                  </a:lnTo>
                  <a:lnTo>
                    <a:pt x="9844" y="4231"/>
                  </a:lnTo>
                  <a:lnTo>
                    <a:pt x="9925" y="4394"/>
                  </a:lnTo>
                  <a:lnTo>
                    <a:pt x="9966" y="4556"/>
                  </a:lnTo>
                  <a:lnTo>
                    <a:pt x="9966" y="4719"/>
                  </a:lnTo>
                  <a:lnTo>
                    <a:pt x="9966" y="4882"/>
                  </a:lnTo>
                  <a:lnTo>
                    <a:pt x="9844" y="5166"/>
                  </a:lnTo>
                  <a:lnTo>
                    <a:pt x="9681" y="5370"/>
                  </a:lnTo>
                  <a:lnTo>
                    <a:pt x="9478" y="5532"/>
                  </a:lnTo>
                  <a:lnTo>
                    <a:pt x="9193" y="5655"/>
                  </a:lnTo>
                  <a:lnTo>
                    <a:pt x="8949" y="5777"/>
                  </a:lnTo>
                  <a:lnTo>
                    <a:pt x="8624" y="5858"/>
                  </a:lnTo>
                  <a:lnTo>
                    <a:pt x="8095" y="5939"/>
                  </a:lnTo>
                  <a:lnTo>
                    <a:pt x="8014" y="5939"/>
                  </a:lnTo>
                  <a:lnTo>
                    <a:pt x="8005" y="5947"/>
                  </a:lnTo>
                  <a:lnTo>
                    <a:pt x="8005" y="5947"/>
                  </a:lnTo>
                  <a:lnTo>
                    <a:pt x="6753" y="6061"/>
                  </a:lnTo>
                  <a:lnTo>
                    <a:pt x="5410" y="6143"/>
                  </a:lnTo>
                  <a:lnTo>
                    <a:pt x="4068" y="6183"/>
                  </a:lnTo>
                  <a:lnTo>
                    <a:pt x="2685" y="6183"/>
                  </a:lnTo>
                  <a:lnTo>
                    <a:pt x="2197" y="6143"/>
                  </a:lnTo>
                  <a:lnTo>
                    <a:pt x="1668" y="6102"/>
                  </a:lnTo>
                  <a:lnTo>
                    <a:pt x="1424" y="6021"/>
                  </a:lnTo>
                  <a:lnTo>
                    <a:pt x="1180" y="5939"/>
                  </a:lnTo>
                  <a:lnTo>
                    <a:pt x="977" y="5817"/>
                  </a:lnTo>
                  <a:lnTo>
                    <a:pt x="773" y="5655"/>
                  </a:lnTo>
                  <a:lnTo>
                    <a:pt x="610" y="5451"/>
                  </a:lnTo>
                  <a:lnTo>
                    <a:pt x="529" y="5248"/>
                  </a:lnTo>
                  <a:lnTo>
                    <a:pt x="448" y="5004"/>
                  </a:lnTo>
                  <a:lnTo>
                    <a:pt x="407" y="4800"/>
                  </a:lnTo>
                  <a:lnTo>
                    <a:pt x="407" y="4556"/>
                  </a:lnTo>
                  <a:lnTo>
                    <a:pt x="407" y="4312"/>
                  </a:lnTo>
                  <a:lnTo>
                    <a:pt x="488" y="4068"/>
                  </a:lnTo>
                  <a:lnTo>
                    <a:pt x="570" y="3865"/>
                  </a:lnTo>
                  <a:lnTo>
                    <a:pt x="773" y="3580"/>
                  </a:lnTo>
                  <a:lnTo>
                    <a:pt x="1017" y="3377"/>
                  </a:lnTo>
                  <a:lnTo>
                    <a:pt x="1261" y="3214"/>
                  </a:lnTo>
                  <a:lnTo>
                    <a:pt x="1587" y="3133"/>
                  </a:lnTo>
                  <a:lnTo>
                    <a:pt x="1871" y="3092"/>
                  </a:lnTo>
                  <a:lnTo>
                    <a:pt x="2197" y="3133"/>
                  </a:lnTo>
                  <a:lnTo>
                    <a:pt x="2482" y="3214"/>
                  </a:lnTo>
                  <a:lnTo>
                    <a:pt x="2766" y="3377"/>
                  </a:lnTo>
                  <a:lnTo>
                    <a:pt x="2970" y="3377"/>
                  </a:lnTo>
                  <a:lnTo>
                    <a:pt x="3051" y="3295"/>
                  </a:lnTo>
                  <a:lnTo>
                    <a:pt x="3092" y="3214"/>
                  </a:lnTo>
                  <a:lnTo>
                    <a:pt x="3051" y="2767"/>
                  </a:lnTo>
                  <a:lnTo>
                    <a:pt x="3092" y="2319"/>
                  </a:lnTo>
                  <a:lnTo>
                    <a:pt x="3214" y="1872"/>
                  </a:lnTo>
                  <a:lnTo>
                    <a:pt x="3376" y="1465"/>
                  </a:lnTo>
                  <a:lnTo>
                    <a:pt x="3621" y="1099"/>
                  </a:lnTo>
                  <a:lnTo>
                    <a:pt x="3905" y="814"/>
                  </a:lnTo>
                  <a:lnTo>
                    <a:pt x="4068" y="692"/>
                  </a:lnTo>
                  <a:lnTo>
                    <a:pt x="4271" y="570"/>
                  </a:lnTo>
                  <a:lnTo>
                    <a:pt x="4475" y="489"/>
                  </a:lnTo>
                  <a:lnTo>
                    <a:pt x="4719" y="448"/>
                  </a:lnTo>
                  <a:lnTo>
                    <a:pt x="5126" y="407"/>
                  </a:lnTo>
                  <a:close/>
                  <a:moveTo>
                    <a:pt x="4881" y="1"/>
                  </a:moveTo>
                  <a:lnTo>
                    <a:pt x="4597" y="41"/>
                  </a:lnTo>
                  <a:lnTo>
                    <a:pt x="4312" y="123"/>
                  </a:lnTo>
                  <a:lnTo>
                    <a:pt x="4068" y="245"/>
                  </a:lnTo>
                  <a:lnTo>
                    <a:pt x="3865" y="367"/>
                  </a:lnTo>
                  <a:lnTo>
                    <a:pt x="3621" y="529"/>
                  </a:lnTo>
                  <a:lnTo>
                    <a:pt x="3458" y="692"/>
                  </a:lnTo>
                  <a:lnTo>
                    <a:pt x="3254" y="895"/>
                  </a:lnTo>
                  <a:lnTo>
                    <a:pt x="3132" y="1099"/>
                  </a:lnTo>
                  <a:lnTo>
                    <a:pt x="3010" y="1343"/>
                  </a:lnTo>
                  <a:lnTo>
                    <a:pt x="2888" y="1587"/>
                  </a:lnTo>
                  <a:lnTo>
                    <a:pt x="2726" y="2116"/>
                  </a:lnTo>
                  <a:lnTo>
                    <a:pt x="2644" y="2644"/>
                  </a:lnTo>
                  <a:lnTo>
                    <a:pt x="2661" y="2878"/>
                  </a:lnTo>
                  <a:lnTo>
                    <a:pt x="2661" y="2878"/>
                  </a:lnTo>
                  <a:lnTo>
                    <a:pt x="2400" y="2767"/>
                  </a:lnTo>
                  <a:lnTo>
                    <a:pt x="2115" y="2685"/>
                  </a:lnTo>
                  <a:lnTo>
                    <a:pt x="1790" y="2685"/>
                  </a:lnTo>
                  <a:lnTo>
                    <a:pt x="1465" y="2726"/>
                  </a:lnTo>
                  <a:lnTo>
                    <a:pt x="1180" y="2807"/>
                  </a:lnTo>
                  <a:lnTo>
                    <a:pt x="895" y="2970"/>
                  </a:lnTo>
                  <a:lnTo>
                    <a:pt x="610" y="3133"/>
                  </a:lnTo>
                  <a:lnTo>
                    <a:pt x="448" y="3336"/>
                  </a:lnTo>
                  <a:lnTo>
                    <a:pt x="285" y="3580"/>
                  </a:lnTo>
                  <a:lnTo>
                    <a:pt x="163" y="3824"/>
                  </a:lnTo>
                  <a:lnTo>
                    <a:pt x="82" y="4068"/>
                  </a:lnTo>
                  <a:lnTo>
                    <a:pt x="0" y="4353"/>
                  </a:lnTo>
                  <a:lnTo>
                    <a:pt x="0" y="4597"/>
                  </a:lnTo>
                  <a:lnTo>
                    <a:pt x="0" y="4882"/>
                  </a:lnTo>
                  <a:lnTo>
                    <a:pt x="41" y="5166"/>
                  </a:lnTo>
                  <a:lnTo>
                    <a:pt x="163" y="5451"/>
                  </a:lnTo>
                  <a:lnTo>
                    <a:pt x="326" y="5695"/>
                  </a:lnTo>
                  <a:lnTo>
                    <a:pt x="488" y="5939"/>
                  </a:lnTo>
                  <a:lnTo>
                    <a:pt x="692" y="6102"/>
                  </a:lnTo>
                  <a:lnTo>
                    <a:pt x="936" y="6224"/>
                  </a:lnTo>
                  <a:lnTo>
                    <a:pt x="1180" y="6346"/>
                  </a:lnTo>
                  <a:lnTo>
                    <a:pt x="1465" y="6427"/>
                  </a:lnTo>
                  <a:lnTo>
                    <a:pt x="1749" y="6509"/>
                  </a:lnTo>
                  <a:lnTo>
                    <a:pt x="2360" y="6590"/>
                  </a:lnTo>
                  <a:lnTo>
                    <a:pt x="2970" y="6590"/>
                  </a:lnTo>
                  <a:lnTo>
                    <a:pt x="4149" y="6549"/>
                  </a:lnTo>
                  <a:lnTo>
                    <a:pt x="6102" y="6468"/>
                  </a:lnTo>
                  <a:lnTo>
                    <a:pt x="8095" y="6305"/>
                  </a:lnTo>
                  <a:lnTo>
                    <a:pt x="8176" y="6305"/>
                  </a:lnTo>
                  <a:lnTo>
                    <a:pt x="8186" y="6295"/>
                  </a:lnTo>
                  <a:lnTo>
                    <a:pt x="8186" y="6295"/>
                  </a:lnTo>
                  <a:lnTo>
                    <a:pt x="8461" y="6265"/>
                  </a:lnTo>
                  <a:lnTo>
                    <a:pt x="8827" y="6183"/>
                  </a:lnTo>
                  <a:lnTo>
                    <a:pt x="9234" y="6061"/>
                  </a:lnTo>
                  <a:lnTo>
                    <a:pt x="9559" y="5939"/>
                  </a:lnTo>
                  <a:lnTo>
                    <a:pt x="9885" y="5736"/>
                  </a:lnTo>
                  <a:lnTo>
                    <a:pt x="10007" y="5614"/>
                  </a:lnTo>
                  <a:lnTo>
                    <a:pt x="10129" y="5451"/>
                  </a:lnTo>
                  <a:lnTo>
                    <a:pt x="10251" y="5288"/>
                  </a:lnTo>
                  <a:lnTo>
                    <a:pt x="10291" y="5126"/>
                  </a:lnTo>
                  <a:lnTo>
                    <a:pt x="10373" y="4922"/>
                  </a:lnTo>
                  <a:lnTo>
                    <a:pt x="10373" y="4719"/>
                  </a:lnTo>
                  <a:lnTo>
                    <a:pt x="10373" y="4516"/>
                  </a:lnTo>
                  <a:lnTo>
                    <a:pt x="10291" y="4353"/>
                  </a:lnTo>
                  <a:lnTo>
                    <a:pt x="10251" y="4149"/>
                  </a:lnTo>
                  <a:lnTo>
                    <a:pt x="10129" y="3987"/>
                  </a:lnTo>
                  <a:lnTo>
                    <a:pt x="10007" y="3824"/>
                  </a:lnTo>
                  <a:lnTo>
                    <a:pt x="9844" y="3661"/>
                  </a:lnTo>
                  <a:lnTo>
                    <a:pt x="9681" y="3539"/>
                  </a:lnTo>
                  <a:lnTo>
                    <a:pt x="9519" y="3458"/>
                  </a:lnTo>
                  <a:lnTo>
                    <a:pt x="9315" y="3377"/>
                  </a:lnTo>
                  <a:lnTo>
                    <a:pt x="9071" y="3336"/>
                  </a:lnTo>
                  <a:lnTo>
                    <a:pt x="8868" y="3295"/>
                  </a:lnTo>
                  <a:lnTo>
                    <a:pt x="8624" y="3336"/>
                  </a:lnTo>
                  <a:lnTo>
                    <a:pt x="8380" y="3377"/>
                  </a:lnTo>
                  <a:lnTo>
                    <a:pt x="8176" y="3417"/>
                  </a:lnTo>
                  <a:lnTo>
                    <a:pt x="8176" y="3377"/>
                  </a:lnTo>
                  <a:lnTo>
                    <a:pt x="8176" y="3173"/>
                  </a:lnTo>
                  <a:lnTo>
                    <a:pt x="8176" y="3011"/>
                  </a:lnTo>
                  <a:lnTo>
                    <a:pt x="8095" y="2848"/>
                  </a:lnTo>
                  <a:lnTo>
                    <a:pt x="8014" y="2685"/>
                  </a:lnTo>
                  <a:lnTo>
                    <a:pt x="7891" y="2522"/>
                  </a:lnTo>
                  <a:lnTo>
                    <a:pt x="7769" y="2400"/>
                  </a:lnTo>
                  <a:lnTo>
                    <a:pt x="7647" y="2278"/>
                  </a:lnTo>
                  <a:lnTo>
                    <a:pt x="7485" y="2238"/>
                  </a:lnTo>
                  <a:lnTo>
                    <a:pt x="7281" y="2156"/>
                  </a:lnTo>
                  <a:lnTo>
                    <a:pt x="6940" y="2156"/>
                  </a:lnTo>
                  <a:lnTo>
                    <a:pt x="6956" y="2075"/>
                  </a:lnTo>
                  <a:lnTo>
                    <a:pt x="6956" y="1831"/>
                  </a:lnTo>
                  <a:lnTo>
                    <a:pt x="6956" y="1587"/>
                  </a:lnTo>
                  <a:lnTo>
                    <a:pt x="6915" y="1384"/>
                  </a:lnTo>
                  <a:lnTo>
                    <a:pt x="6834" y="1139"/>
                  </a:lnTo>
                  <a:lnTo>
                    <a:pt x="6712" y="936"/>
                  </a:lnTo>
                  <a:lnTo>
                    <a:pt x="6590" y="733"/>
                  </a:lnTo>
                  <a:lnTo>
                    <a:pt x="6427" y="529"/>
                  </a:lnTo>
                  <a:lnTo>
                    <a:pt x="6224" y="367"/>
                  </a:lnTo>
                  <a:lnTo>
                    <a:pt x="6061" y="245"/>
                  </a:lnTo>
                  <a:lnTo>
                    <a:pt x="5817" y="163"/>
                  </a:lnTo>
                  <a:lnTo>
                    <a:pt x="5614" y="82"/>
                  </a:lnTo>
                  <a:lnTo>
                    <a:pt x="5370" y="41"/>
                  </a:lnTo>
                  <a:lnTo>
                    <a:pt x="5126"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116" name="Google Shape;116;p14"/>
          <p:cNvGrpSpPr/>
          <p:nvPr/>
        </p:nvGrpSpPr>
        <p:grpSpPr>
          <a:xfrm>
            <a:off x="8341181" y="4513505"/>
            <a:ext cx="474643" cy="299712"/>
            <a:chOff x="7729218" y="1694205"/>
            <a:chExt cx="474643" cy="299712"/>
          </a:xfrm>
        </p:grpSpPr>
        <p:sp>
          <p:nvSpPr>
            <p:cNvPr id="117" name="Google Shape;117;p14"/>
            <p:cNvSpPr/>
            <p:nvPr/>
          </p:nvSpPr>
          <p:spPr>
            <a:xfrm>
              <a:off x="7738507" y="1703494"/>
              <a:ext cx="456065" cy="281088"/>
            </a:xfrm>
            <a:custGeom>
              <a:rect b="b" l="l" r="r" t="t"/>
              <a:pathLst>
                <a:path extrusionOk="0" h="6143" w="9967">
                  <a:moveTo>
                    <a:pt x="4963" y="1"/>
                  </a:moveTo>
                  <a:lnTo>
                    <a:pt x="4638" y="41"/>
                  </a:lnTo>
                  <a:lnTo>
                    <a:pt x="4353" y="123"/>
                  </a:lnTo>
                  <a:lnTo>
                    <a:pt x="4068" y="286"/>
                  </a:lnTo>
                  <a:lnTo>
                    <a:pt x="3865" y="489"/>
                  </a:lnTo>
                  <a:lnTo>
                    <a:pt x="3661" y="733"/>
                  </a:lnTo>
                  <a:lnTo>
                    <a:pt x="3499" y="1018"/>
                  </a:lnTo>
                  <a:lnTo>
                    <a:pt x="3417" y="1302"/>
                  </a:lnTo>
                  <a:lnTo>
                    <a:pt x="3377" y="1587"/>
                  </a:lnTo>
                  <a:lnTo>
                    <a:pt x="3417" y="1913"/>
                  </a:lnTo>
                  <a:lnTo>
                    <a:pt x="3499" y="2197"/>
                  </a:lnTo>
                  <a:lnTo>
                    <a:pt x="3377" y="2157"/>
                  </a:lnTo>
                  <a:lnTo>
                    <a:pt x="3214" y="2116"/>
                  </a:lnTo>
                  <a:lnTo>
                    <a:pt x="2929" y="2157"/>
                  </a:lnTo>
                  <a:lnTo>
                    <a:pt x="2645" y="2238"/>
                  </a:lnTo>
                  <a:lnTo>
                    <a:pt x="2482" y="2319"/>
                  </a:lnTo>
                  <a:lnTo>
                    <a:pt x="2400" y="2441"/>
                  </a:lnTo>
                  <a:lnTo>
                    <a:pt x="2319" y="2563"/>
                  </a:lnTo>
                  <a:lnTo>
                    <a:pt x="2238" y="2685"/>
                  </a:lnTo>
                  <a:lnTo>
                    <a:pt x="2156" y="3011"/>
                  </a:lnTo>
                  <a:lnTo>
                    <a:pt x="2197" y="3296"/>
                  </a:lnTo>
                  <a:lnTo>
                    <a:pt x="2238" y="3458"/>
                  </a:lnTo>
                  <a:lnTo>
                    <a:pt x="2278" y="3580"/>
                  </a:lnTo>
                  <a:lnTo>
                    <a:pt x="1912" y="3377"/>
                  </a:lnTo>
                  <a:lnTo>
                    <a:pt x="1546" y="3296"/>
                  </a:lnTo>
                  <a:lnTo>
                    <a:pt x="1140" y="3296"/>
                  </a:lnTo>
                  <a:lnTo>
                    <a:pt x="936" y="3336"/>
                  </a:lnTo>
                  <a:lnTo>
                    <a:pt x="733" y="3418"/>
                  </a:lnTo>
                  <a:lnTo>
                    <a:pt x="570" y="3499"/>
                  </a:lnTo>
                  <a:lnTo>
                    <a:pt x="407" y="3621"/>
                  </a:lnTo>
                  <a:lnTo>
                    <a:pt x="245" y="3784"/>
                  </a:lnTo>
                  <a:lnTo>
                    <a:pt x="123" y="3946"/>
                  </a:lnTo>
                  <a:lnTo>
                    <a:pt x="41" y="4109"/>
                  </a:lnTo>
                  <a:lnTo>
                    <a:pt x="1" y="4312"/>
                  </a:lnTo>
                  <a:lnTo>
                    <a:pt x="1" y="4516"/>
                  </a:lnTo>
                  <a:lnTo>
                    <a:pt x="1" y="4719"/>
                  </a:lnTo>
                  <a:lnTo>
                    <a:pt x="123" y="5004"/>
                  </a:lnTo>
                  <a:lnTo>
                    <a:pt x="285" y="5248"/>
                  </a:lnTo>
                  <a:lnTo>
                    <a:pt x="529" y="5451"/>
                  </a:lnTo>
                  <a:lnTo>
                    <a:pt x="773" y="5573"/>
                  </a:lnTo>
                  <a:lnTo>
                    <a:pt x="1099" y="5695"/>
                  </a:lnTo>
                  <a:lnTo>
                    <a:pt x="1424" y="5777"/>
                  </a:lnTo>
                  <a:lnTo>
                    <a:pt x="2075" y="5899"/>
                  </a:lnTo>
                  <a:lnTo>
                    <a:pt x="3133" y="5980"/>
                  </a:lnTo>
                  <a:lnTo>
                    <a:pt x="4231" y="6062"/>
                  </a:lnTo>
                  <a:lnTo>
                    <a:pt x="5288" y="6102"/>
                  </a:lnTo>
                  <a:lnTo>
                    <a:pt x="6387" y="6143"/>
                  </a:lnTo>
                  <a:lnTo>
                    <a:pt x="7973" y="6143"/>
                  </a:lnTo>
                  <a:lnTo>
                    <a:pt x="8380" y="6062"/>
                  </a:lnTo>
                  <a:lnTo>
                    <a:pt x="8787" y="5980"/>
                  </a:lnTo>
                  <a:lnTo>
                    <a:pt x="9112" y="5858"/>
                  </a:lnTo>
                  <a:lnTo>
                    <a:pt x="9437" y="5655"/>
                  </a:lnTo>
                  <a:lnTo>
                    <a:pt x="9559" y="5533"/>
                  </a:lnTo>
                  <a:lnTo>
                    <a:pt x="9682" y="5370"/>
                  </a:lnTo>
                  <a:lnTo>
                    <a:pt x="9844" y="5004"/>
                  </a:lnTo>
                  <a:lnTo>
                    <a:pt x="9966" y="4638"/>
                  </a:lnTo>
                  <a:lnTo>
                    <a:pt x="9966" y="4272"/>
                  </a:lnTo>
                  <a:lnTo>
                    <a:pt x="9885" y="3865"/>
                  </a:lnTo>
                  <a:lnTo>
                    <a:pt x="9763" y="3540"/>
                  </a:lnTo>
                  <a:lnTo>
                    <a:pt x="9519" y="3214"/>
                  </a:lnTo>
                  <a:lnTo>
                    <a:pt x="9397" y="3092"/>
                  </a:lnTo>
                  <a:lnTo>
                    <a:pt x="9234" y="2970"/>
                  </a:lnTo>
                  <a:lnTo>
                    <a:pt x="9031" y="2807"/>
                  </a:lnTo>
                  <a:lnTo>
                    <a:pt x="8787" y="2726"/>
                  </a:lnTo>
                  <a:lnTo>
                    <a:pt x="8502" y="2685"/>
                  </a:lnTo>
                  <a:lnTo>
                    <a:pt x="8014" y="2685"/>
                  </a:lnTo>
                  <a:lnTo>
                    <a:pt x="7729" y="2726"/>
                  </a:lnTo>
                  <a:lnTo>
                    <a:pt x="7485" y="2848"/>
                  </a:lnTo>
                  <a:lnTo>
                    <a:pt x="7282" y="2970"/>
                  </a:lnTo>
                  <a:lnTo>
                    <a:pt x="7322" y="2685"/>
                  </a:lnTo>
                  <a:lnTo>
                    <a:pt x="7322" y="2360"/>
                  </a:lnTo>
                  <a:lnTo>
                    <a:pt x="7282" y="2035"/>
                  </a:lnTo>
                  <a:lnTo>
                    <a:pt x="7200" y="1750"/>
                  </a:lnTo>
                  <a:lnTo>
                    <a:pt x="7119" y="1424"/>
                  </a:lnTo>
                  <a:lnTo>
                    <a:pt x="6997" y="1180"/>
                  </a:lnTo>
                  <a:lnTo>
                    <a:pt x="6834" y="896"/>
                  </a:lnTo>
                  <a:lnTo>
                    <a:pt x="6631" y="652"/>
                  </a:lnTo>
                  <a:lnTo>
                    <a:pt x="6387" y="448"/>
                  </a:lnTo>
                  <a:lnTo>
                    <a:pt x="6143" y="286"/>
                  </a:lnTo>
                  <a:lnTo>
                    <a:pt x="5858" y="123"/>
                  </a:lnTo>
                  <a:lnTo>
                    <a:pt x="5573" y="41"/>
                  </a:lnTo>
                  <a:lnTo>
                    <a:pt x="5248"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18" name="Google Shape;118;p14"/>
            <p:cNvSpPr/>
            <p:nvPr/>
          </p:nvSpPr>
          <p:spPr>
            <a:xfrm>
              <a:off x="7729218" y="1694205"/>
              <a:ext cx="474643" cy="299712"/>
            </a:xfrm>
            <a:custGeom>
              <a:rect b="b" l="l" r="r" t="t"/>
              <a:pathLst>
                <a:path extrusionOk="0" h="6550" w="10373">
                  <a:moveTo>
                    <a:pt x="5451" y="366"/>
                  </a:moveTo>
                  <a:lnTo>
                    <a:pt x="5654" y="407"/>
                  </a:lnTo>
                  <a:lnTo>
                    <a:pt x="5858" y="489"/>
                  </a:lnTo>
                  <a:lnTo>
                    <a:pt x="6102" y="570"/>
                  </a:lnTo>
                  <a:lnTo>
                    <a:pt x="6264" y="651"/>
                  </a:lnTo>
                  <a:lnTo>
                    <a:pt x="6468" y="814"/>
                  </a:lnTo>
                  <a:lnTo>
                    <a:pt x="6752" y="1099"/>
                  </a:lnTo>
                  <a:lnTo>
                    <a:pt x="6996" y="1465"/>
                  </a:lnTo>
                  <a:lnTo>
                    <a:pt x="7159" y="1871"/>
                  </a:lnTo>
                  <a:lnTo>
                    <a:pt x="7281" y="2278"/>
                  </a:lnTo>
                  <a:lnTo>
                    <a:pt x="7322" y="2726"/>
                  </a:lnTo>
                  <a:lnTo>
                    <a:pt x="7281" y="3173"/>
                  </a:lnTo>
                  <a:lnTo>
                    <a:pt x="7322" y="3295"/>
                  </a:lnTo>
                  <a:lnTo>
                    <a:pt x="7363" y="3336"/>
                  </a:lnTo>
                  <a:lnTo>
                    <a:pt x="7485" y="3377"/>
                  </a:lnTo>
                  <a:lnTo>
                    <a:pt x="7566" y="3336"/>
                  </a:lnTo>
                  <a:lnTo>
                    <a:pt x="7851" y="3214"/>
                  </a:lnTo>
                  <a:lnTo>
                    <a:pt x="8095" y="3132"/>
                  </a:lnTo>
                  <a:lnTo>
                    <a:pt x="8379" y="3092"/>
                  </a:lnTo>
                  <a:lnTo>
                    <a:pt x="8664" y="3092"/>
                  </a:lnTo>
                  <a:lnTo>
                    <a:pt x="8949" y="3132"/>
                  </a:lnTo>
                  <a:lnTo>
                    <a:pt x="9193" y="3254"/>
                  </a:lnTo>
                  <a:lnTo>
                    <a:pt x="9437" y="3417"/>
                  </a:lnTo>
                  <a:lnTo>
                    <a:pt x="9640" y="3621"/>
                  </a:lnTo>
                  <a:lnTo>
                    <a:pt x="9762" y="3824"/>
                  </a:lnTo>
                  <a:lnTo>
                    <a:pt x="9885" y="4027"/>
                  </a:lnTo>
                  <a:lnTo>
                    <a:pt x="9925" y="4271"/>
                  </a:lnTo>
                  <a:lnTo>
                    <a:pt x="9966" y="4515"/>
                  </a:lnTo>
                  <a:lnTo>
                    <a:pt x="9966" y="4759"/>
                  </a:lnTo>
                  <a:lnTo>
                    <a:pt x="9925" y="5004"/>
                  </a:lnTo>
                  <a:lnTo>
                    <a:pt x="9844" y="5207"/>
                  </a:lnTo>
                  <a:lnTo>
                    <a:pt x="9762" y="5410"/>
                  </a:lnTo>
                  <a:lnTo>
                    <a:pt x="9600" y="5614"/>
                  </a:lnTo>
                  <a:lnTo>
                    <a:pt x="9396" y="5776"/>
                  </a:lnTo>
                  <a:lnTo>
                    <a:pt x="9193" y="5898"/>
                  </a:lnTo>
                  <a:lnTo>
                    <a:pt x="8949" y="5980"/>
                  </a:lnTo>
                  <a:lnTo>
                    <a:pt x="8461" y="6102"/>
                  </a:lnTo>
                  <a:lnTo>
                    <a:pt x="7932" y="6142"/>
                  </a:lnTo>
                  <a:lnTo>
                    <a:pt x="5654" y="6142"/>
                  </a:lnTo>
                  <a:lnTo>
                    <a:pt x="3946" y="6061"/>
                  </a:lnTo>
                  <a:lnTo>
                    <a:pt x="2278" y="5898"/>
                  </a:lnTo>
                  <a:lnTo>
                    <a:pt x="1709" y="5817"/>
                  </a:lnTo>
                  <a:lnTo>
                    <a:pt x="1424" y="5736"/>
                  </a:lnTo>
                  <a:lnTo>
                    <a:pt x="1139" y="5654"/>
                  </a:lnTo>
                  <a:lnTo>
                    <a:pt x="895" y="5532"/>
                  </a:lnTo>
                  <a:lnTo>
                    <a:pt x="651" y="5370"/>
                  </a:lnTo>
                  <a:lnTo>
                    <a:pt x="488" y="5126"/>
                  </a:lnTo>
                  <a:lnTo>
                    <a:pt x="407" y="4882"/>
                  </a:lnTo>
                  <a:lnTo>
                    <a:pt x="407" y="4719"/>
                  </a:lnTo>
                  <a:lnTo>
                    <a:pt x="407" y="4556"/>
                  </a:lnTo>
                  <a:lnTo>
                    <a:pt x="448" y="4393"/>
                  </a:lnTo>
                  <a:lnTo>
                    <a:pt x="529" y="4231"/>
                  </a:lnTo>
                  <a:lnTo>
                    <a:pt x="732" y="3987"/>
                  </a:lnTo>
                  <a:lnTo>
                    <a:pt x="976" y="3824"/>
                  </a:lnTo>
                  <a:lnTo>
                    <a:pt x="1139" y="3743"/>
                  </a:lnTo>
                  <a:lnTo>
                    <a:pt x="1343" y="3702"/>
                  </a:lnTo>
                  <a:lnTo>
                    <a:pt x="1709" y="3702"/>
                  </a:lnTo>
                  <a:lnTo>
                    <a:pt x="2075" y="3783"/>
                  </a:lnTo>
                  <a:lnTo>
                    <a:pt x="2400" y="3946"/>
                  </a:lnTo>
                  <a:lnTo>
                    <a:pt x="2481" y="3987"/>
                  </a:lnTo>
                  <a:lnTo>
                    <a:pt x="2522" y="3987"/>
                  </a:lnTo>
                  <a:lnTo>
                    <a:pt x="2644" y="3905"/>
                  </a:lnTo>
                  <a:lnTo>
                    <a:pt x="2685" y="3824"/>
                  </a:lnTo>
                  <a:lnTo>
                    <a:pt x="2685" y="3743"/>
                  </a:lnTo>
                  <a:lnTo>
                    <a:pt x="2685" y="3661"/>
                  </a:lnTo>
                  <a:lnTo>
                    <a:pt x="2563" y="3417"/>
                  </a:lnTo>
                  <a:lnTo>
                    <a:pt x="2563" y="3173"/>
                  </a:lnTo>
                  <a:lnTo>
                    <a:pt x="2644" y="2970"/>
                  </a:lnTo>
                  <a:lnTo>
                    <a:pt x="2766" y="2766"/>
                  </a:lnTo>
                  <a:lnTo>
                    <a:pt x="2929" y="2644"/>
                  </a:lnTo>
                  <a:lnTo>
                    <a:pt x="3173" y="2563"/>
                  </a:lnTo>
                  <a:lnTo>
                    <a:pt x="3417" y="2522"/>
                  </a:lnTo>
                  <a:lnTo>
                    <a:pt x="3661" y="2604"/>
                  </a:lnTo>
                  <a:lnTo>
                    <a:pt x="3783" y="2604"/>
                  </a:lnTo>
                  <a:lnTo>
                    <a:pt x="3864" y="2522"/>
                  </a:lnTo>
                  <a:lnTo>
                    <a:pt x="3905" y="2400"/>
                  </a:lnTo>
                  <a:lnTo>
                    <a:pt x="3864" y="2278"/>
                  </a:lnTo>
                  <a:lnTo>
                    <a:pt x="3824" y="2116"/>
                  </a:lnTo>
                  <a:lnTo>
                    <a:pt x="3783" y="1912"/>
                  </a:lnTo>
                  <a:lnTo>
                    <a:pt x="3783" y="1749"/>
                  </a:lnTo>
                  <a:lnTo>
                    <a:pt x="3824" y="1546"/>
                  </a:lnTo>
                  <a:lnTo>
                    <a:pt x="3864" y="1383"/>
                  </a:lnTo>
                  <a:lnTo>
                    <a:pt x="3946" y="1180"/>
                  </a:lnTo>
                  <a:lnTo>
                    <a:pt x="4149" y="895"/>
                  </a:lnTo>
                  <a:lnTo>
                    <a:pt x="4312" y="733"/>
                  </a:lnTo>
                  <a:lnTo>
                    <a:pt x="4475" y="611"/>
                  </a:lnTo>
                  <a:lnTo>
                    <a:pt x="4637" y="529"/>
                  </a:lnTo>
                  <a:lnTo>
                    <a:pt x="4841" y="448"/>
                  </a:lnTo>
                  <a:lnTo>
                    <a:pt x="5044" y="407"/>
                  </a:lnTo>
                  <a:lnTo>
                    <a:pt x="5247" y="366"/>
                  </a:lnTo>
                  <a:close/>
                  <a:moveTo>
                    <a:pt x="5003" y="0"/>
                  </a:moveTo>
                  <a:lnTo>
                    <a:pt x="4759" y="41"/>
                  </a:lnTo>
                  <a:lnTo>
                    <a:pt x="4515" y="122"/>
                  </a:lnTo>
                  <a:lnTo>
                    <a:pt x="4312" y="244"/>
                  </a:lnTo>
                  <a:lnTo>
                    <a:pt x="4108" y="366"/>
                  </a:lnTo>
                  <a:lnTo>
                    <a:pt x="3946" y="529"/>
                  </a:lnTo>
                  <a:lnTo>
                    <a:pt x="3783" y="692"/>
                  </a:lnTo>
                  <a:lnTo>
                    <a:pt x="3661" y="895"/>
                  </a:lnTo>
                  <a:lnTo>
                    <a:pt x="3539" y="1139"/>
                  </a:lnTo>
                  <a:lnTo>
                    <a:pt x="3458" y="1343"/>
                  </a:lnTo>
                  <a:lnTo>
                    <a:pt x="3417" y="1587"/>
                  </a:lnTo>
                  <a:lnTo>
                    <a:pt x="3417" y="1790"/>
                  </a:lnTo>
                  <a:lnTo>
                    <a:pt x="3417" y="2034"/>
                  </a:lnTo>
                  <a:lnTo>
                    <a:pt x="3431" y="2119"/>
                  </a:lnTo>
                  <a:lnTo>
                    <a:pt x="3431" y="2119"/>
                  </a:lnTo>
                  <a:lnTo>
                    <a:pt x="3417" y="2116"/>
                  </a:lnTo>
                  <a:lnTo>
                    <a:pt x="3254" y="2116"/>
                  </a:lnTo>
                  <a:lnTo>
                    <a:pt x="3051" y="2156"/>
                  </a:lnTo>
                  <a:lnTo>
                    <a:pt x="2888" y="2197"/>
                  </a:lnTo>
                  <a:lnTo>
                    <a:pt x="2725" y="2278"/>
                  </a:lnTo>
                  <a:lnTo>
                    <a:pt x="2603" y="2360"/>
                  </a:lnTo>
                  <a:lnTo>
                    <a:pt x="2441" y="2482"/>
                  </a:lnTo>
                  <a:lnTo>
                    <a:pt x="2359" y="2644"/>
                  </a:lnTo>
                  <a:lnTo>
                    <a:pt x="2237" y="2807"/>
                  </a:lnTo>
                  <a:lnTo>
                    <a:pt x="2197" y="2970"/>
                  </a:lnTo>
                  <a:lnTo>
                    <a:pt x="2156" y="3173"/>
                  </a:lnTo>
                  <a:lnTo>
                    <a:pt x="2156" y="3336"/>
                  </a:lnTo>
                  <a:lnTo>
                    <a:pt x="2170" y="3407"/>
                  </a:lnTo>
                  <a:lnTo>
                    <a:pt x="1993" y="3336"/>
                  </a:lnTo>
                  <a:lnTo>
                    <a:pt x="1749" y="3295"/>
                  </a:lnTo>
                  <a:lnTo>
                    <a:pt x="1302" y="3295"/>
                  </a:lnTo>
                  <a:lnTo>
                    <a:pt x="1098" y="3336"/>
                  </a:lnTo>
                  <a:lnTo>
                    <a:pt x="854" y="3417"/>
                  </a:lnTo>
                  <a:lnTo>
                    <a:pt x="692" y="3499"/>
                  </a:lnTo>
                  <a:lnTo>
                    <a:pt x="529" y="3621"/>
                  </a:lnTo>
                  <a:lnTo>
                    <a:pt x="366" y="3783"/>
                  </a:lnTo>
                  <a:lnTo>
                    <a:pt x="244" y="3946"/>
                  </a:lnTo>
                  <a:lnTo>
                    <a:pt x="122" y="4109"/>
                  </a:lnTo>
                  <a:lnTo>
                    <a:pt x="41" y="4312"/>
                  </a:lnTo>
                  <a:lnTo>
                    <a:pt x="0" y="4515"/>
                  </a:lnTo>
                  <a:lnTo>
                    <a:pt x="0" y="4719"/>
                  </a:lnTo>
                  <a:lnTo>
                    <a:pt x="0" y="4922"/>
                  </a:lnTo>
                  <a:lnTo>
                    <a:pt x="41" y="5126"/>
                  </a:lnTo>
                  <a:lnTo>
                    <a:pt x="122" y="5288"/>
                  </a:lnTo>
                  <a:lnTo>
                    <a:pt x="204" y="5451"/>
                  </a:lnTo>
                  <a:lnTo>
                    <a:pt x="488" y="5695"/>
                  </a:lnTo>
                  <a:lnTo>
                    <a:pt x="773" y="5898"/>
                  </a:lnTo>
                  <a:lnTo>
                    <a:pt x="1139" y="6061"/>
                  </a:lnTo>
                  <a:lnTo>
                    <a:pt x="1505" y="6183"/>
                  </a:lnTo>
                  <a:lnTo>
                    <a:pt x="1912" y="6265"/>
                  </a:lnTo>
                  <a:lnTo>
                    <a:pt x="2278" y="6305"/>
                  </a:lnTo>
                  <a:lnTo>
                    <a:pt x="4027" y="6427"/>
                  </a:lnTo>
                  <a:lnTo>
                    <a:pt x="5776" y="6509"/>
                  </a:lnTo>
                  <a:lnTo>
                    <a:pt x="7119" y="6549"/>
                  </a:lnTo>
                  <a:lnTo>
                    <a:pt x="7769" y="6549"/>
                  </a:lnTo>
                  <a:lnTo>
                    <a:pt x="8420" y="6509"/>
                  </a:lnTo>
                  <a:lnTo>
                    <a:pt x="8990" y="6387"/>
                  </a:lnTo>
                  <a:lnTo>
                    <a:pt x="9234" y="6305"/>
                  </a:lnTo>
                  <a:lnTo>
                    <a:pt x="9478" y="6183"/>
                  </a:lnTo>
                  <a:lnTo>
                    <a:pt x="9722" y="6020"/>
                  </a:lnTo>
                  <a:lnTo>
                    <a:pt x="9925" y="5858"/>
                  </a:lnTo>
                  <a:lnTo>
                    <a:pt x="10088" y="5654"/>
                  </a:lnTo>
                  <a:lnTo>
                    <a:pt x="10210" y="5370"/>
                  </a:lnTo>
                  <a:lnTo>
                    <a:pt x="10291" y="5126"/>
                  </a:lnTo>
                  <a:lnTo>
                    <a:pt x="10373" y="4882"/>
                  </a:lnTo>
                  <a:lnTo>
                    <a:pt x="10373" y="4597"/>
                  </a:lnTo>
                  <a:lnTo>
                    <a:pt x="10332" y="4312"/>
                  </a:lnTo>
                  <a:lnTo>
                    <a:pt x="10291" y="4068"/>
                  </a:lnTo>
                  <a:lnTo>
                    <a:pt x="10210" y="3783"/>
                  </a:lnTo>
                  <a:lnTo>
                    <a:pt x="10088" y="3539"/>
                  </a:lnTo>
                  <a:lnTo>
                    <a:pt x="9925" y="3336"/>
                  </a:lnTo>
                  <a:lnTo>
                    <a:pt x="9681" y="3092"/>
                  </a:lnTo>
                  <a:lnTo>
                    <a:pt x="9396" y="2888"/>
                  </a:lnTo>
                  <a:lnTo>
                    <a:pt x="9071" y="2766"/>
                  </a:lnTo>
                  <a:lnTo>
                    <a:pt x="8705" y="2685"/>
                  </a:lnTo>
                  <a:lnTo>
                    <a:pt x="8379" y="2685"/>
                  </a:lnTo>
                  <a:lnTo>
                    <a:pt x="8013" y="2726"/>
                  </a:lnTo>
                  <a:lnTo>
                    <a:pt x="7688" y="2848"/>
                  </a:lnTo>
                  <a:lnTo>
                    <a:pt x="7688" y="2644"/>
                  </a:lnTo>
                  <a:lnTo>
                    <a:pt x="7647" y="2075"/>
                  </a:lnTo>
                  <a:lnTo>
                    <a:pt x="7485" y="1587"/>
                  </a:lnTo>
                  <a:lnTo>
                    <a:pt x="7363" y="1343"/>
                  </a:lnTo>
                  <a:lnTo>
                    <a:pt x="7241" y="1099"/>
                  </a:lnTo>
                  <a:lnTo>
                    <a:pt x="7078" y="895"/>
                  </a:lnTo>
                  <a:lnTo>
                    <a:pt x="6915" y="692"/>
                  </a:lnTo>
                  <a:lnTo>
                    <a:pt x="6712" y="489"/>
                  </a:lnTo>
                  <a:lnTo>
                    <a:pt x="6508" y="366"/>
                  </a:lnTo>
                  <a:lnTo>
                    <a:pt x="6264" y="204"/>
                  </a:lnTo>
                  <a:lnTo>
                    <a:pt x="6020" y="122"/>
                  </a:lnTo>
                  <a:lnTo>
                    <a:pt x="5776" y="41"/>
                  </a:lnTo>
                  <a:lnTo>
                    <a:pt x="5491" y="0"/>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19" name="Google Shape;119;p14"/>
          <p:cNvSpPr/>
          <p:nvPr/>
        </p:nvSpPr>
        <p:spPr>
          <a:xfrm>
            <a:off x="7493953" y="544347"/>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20" name="Google Shape;120;p14"/>
          <p:cNvGrpSpPr/>
          <p:nvPr/>
        </p:nvGrpSpPr>
        <p:grpSpPr>
          <a:xfrm>
            <a:off x="-421852" y="-181433"/>
            <a:ext cx="1985536" cy="1455081"/>
            <a:chOff x="238125" y="896375"/>
            <a:chExt cx="635575" cy="465775"/>
          </a:xfrm>
        </p:grpSpPr>
        <p:sp>
          <p:nvSpPr>
            <p:cNvPr id="121" name="Google Shape;121;p14"/>
            <p:cNvSpPr/>
            <p:nvPr/>
          </p:nvSpPr>
          <p:spPr>
            <a:xfrm>
              <a:off x="258450" y="937050"/>
              <a:ext cx="615250" cy="425100"/>
            </a:xfrm>
            <a:custGeom>
              <a:rect b="b" l="l" r="r" t="t"/>
              <a:pathLst>
                <a:path extrusionOk="0" h="17004" w="24610">
                  <a:moveTo>
                    <a:pt x="24366" y="1"/>
                  </a:moveTo>
                  <a:lnTo>
                    <a:pt x="24325" y="41"/>
                  </a:lnTo>
                  <a:lnTo>
                    <a:pt x="19891" y="4394"/>
                  </a:lnTo>
                  <a:lnTo>
                    <a:pt x="15457" y="8705"/>
                  </a:lnTo>
                  <a:lnTo>
                    <a:pt x="14441" y="9682"/>
                  </a:lnTo>
                  <a:lnTo>
                    <a:pt x="13383" y="10658"/>
                  </a:lnTo>
                  <a:lnTo>
                    <a:pt x="12325" y="11593"/>
                  </a:lnTo>
                  <a:lnTo>
                    <a:pt x="11227" y="12488"/>
                  </a:lnTo>
                  <a:lnTo>
                    <a:pt x="10048" y="13342"/>
                  </a:lnTo>
                  <a:lnTo>
                    <a:pt x="8868" y="14115"/>
                  </a:lnTo>
                  <a:lnTo>
                    <a:pt x="8258" y="14481"/>
                  </a:lnTo>
                  <a:lnTo>
                    <a:pt x="7648" y="14807"/>
                  </a:lnTo>
                  <a:lnTo>
                    <a:pt x="6997" y="15132"/>
                  </a:lnTo>
                  <a:lnTo>
                    <a:pt x="6346" y="15417"/>
                  </a:lnTo>
                  <a:lnTo>
                    <a:pt x="5614" y="15702"/>
                  </a:lnTo>
                  <a:lnTo>
                    <a:pt x="4841" y="15986"/>
                  </a:lnTo>
                  <a:lnTo>
                    <a:pt x="4109" y="16190"/>
                  </a:lnTo>
                  <a:lnTo>
                    <a:pt x="3336" y="16352"/>
                  </a:lnTo>
                  <a:lnTo>
                    <a:pt x="2563" y="16515"/>
                  </a:lnTo>
                  <a:lnTo>
                    <a:pt x="1750" y="16597"/>
                  </a:lnTo>
                  <a:lnTo>
                    <a:pt x="977" y="16637"/>
                  </a:lnTo>
                  <a:lnTo>
                    <a:pt x="204" y="16597"/>
                  </a:lnTo>
                  <a:lnTo>
                    <a:pt x="123" y="16637"/>
                  </a:lnTo>
                  <a:lnTo>
                    <a:pt x="41" y="16678"/>
                  </a:lnTo>
                  <a:lnTo>
                    <a:pt x="1" y="16719"/>
                  </a:lnTo>
                  <a:lnTo>
                    <a:pt x="1" y="16800"/>
                  </a:lnTo>
                  <a:lnTo>
                    <a:pt x="1" y="16841"/>
                  </a:lnTo>
                  <a:lnTo>
                    <a:pt x="41" y="16922"/>
                  </a:lnTo>
                  <a:lnTo>
                    <a:pt x="123" y="16963"/>
                  </a:lnTo>
                  <a:lnTo>
                    <a:pt x="204" y="17003"/>
                  </a:lnTo>
                  <a:lnTo>
                    <a:pt x="895" y="17003"/>
                  </a:lnTo>
                  <a:lnTo>
                    <a:pt x="1587" y="16963"/>
                  </a:lnTo>
                  <a:lnTo>
                    <a:pt x="2319" y="16922"/>
                  </a:lnTo>
                  <a:lnTo>
                    <a:pt x="3011" y="16800"/>
                  </a:lnTo>
                  <a:lnTo>
                    <a:pt x="3661" y="16678"/>
                  </a:lnTo>
                  <a:lnTo>
                    <a:pt x="4353" y="16515"/>
                  </a:lnTo>
                  <a:lnTo>
                    <a:pt x="5044" y="16312"/>
                  </a:lnTo>
                  <a:lnTo>
                    <a:pt x="5695" y="16068"/>
                  </a:lnTo>
                  <a:lnTo>
                    <a:pt x="6346" y="15824"/>
                  </a:lnTo>
                  <a:lnTo>
                    <a:pt x="6997" y="15539"/>
                  </a:lnTo>
                  <a:lnTo>
                    <a:pt x="7648" y="15214"/>
                  </a:lnTo>
                  <a:lnTo>
                    <a:pt x="8258" y="14888"/>
                  </a:lnTo>
                  <a:lnTo>
                    <a:pt x="9478" y="14156"/>
                  </a:lnTo>
                  <a:lnTo>
                    <a:pt x="10617" y="13383"/>
                  </a:lnTo>
                  <a:lnTo>
                    <a:pt x="11797" y="12488"/>
                  </a:lnTo>
                  <a:lnTo>
                    <a:pt x="12895" y="11593"/>
                  </a:lnTo>
                  <a:lnTo>
                    <a:pt x="13993" y="10617"/>
                  </a:lnTo>
                  <a:lnTo>
                    <a:pt x="15051" y="9641"/>
                  </a:lnTo>
                  <a:lnTo>
                    <a:pt x="17247" y="7485"/>
                  </a:lnTo>
                  <a:lnTo>
                    <a:pt x="19444" y="5370"/>
                  </a:lnTo>
                  <a:lnTo>
                    <a:pt x="24569" y="326"/>
                  </a:lnTo>
                  <a:lnTo>
                    <a:pt x="24610" y="245"/>
                  </a:lnTo>
                  <a:lnTo>
                    <a:pt x="24610" y="163"/>
                  </a:lnTo>
                  <a:lnTo>
                    <a:pt x="24610" y="123"/>
                  </a:lnTo>
                  <a:lnTo>
                    <a:pt x="24569" y="82"/>
                  </a:lnTo>
                  <a:lnTo>
                    <a:pt x="24528" y="41"/>
                  </a:lnTo>
                  <a:lnTo>
                    <a:pt x="24447"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2" name="Google Shape;122;p14"/>
            <p:cNvSpPr/>
            <p:nvPr/>
          </p:nvSpPr>
          <p:spPr>
            <a:xfrm>
              <a:off x="238125" y="918750"/>
              <a:ext cx="596925" cy="409850"/>
            </a:xfrm>
            <a:custGeom>
              <a:rect b="b" l="l" r="r" t="t"/>
              <a:pathLst>
                <a:path extrusionOk="0" h="16394" w="23877">
                  <a:moveTo>
                    <a:pt x="23714" y="1"/>
                  </a:moveTo>
                  <a:lnTo>
                    <a:pt x="23633" y="41"/>
                  </a:lnTo>
                  <a:lnTo>
                    <a:pt x="23592" y="82"/>
                  </a:lnTo>
                  <a:lnTo>
                    <a:pt x="22697" y="1139"/>
                  </a:lnTo>
                  <a:lnTo>
                    <a:pt x="21762" y="2197"/>
                  </a:lnTo>
                  <a:lnTo>
                    <a:pt x="20786" y="3214"/>
                  </a:lnTo>
                  <a:lnTo>
                    <a:pt x="19809" y="4231"/>
                  </a:lnTo>
                  <a:lnTo>
                    <a:pt x="18792" y="5166"/>
                  </a:lnTo>
                  <a:lnTo>
                    <a:pt x="17775" y="6143"/>
                  </a:lnTo>
                  <a:lnTo>
                    <a:pt x="16718" y="7038"/>
                  </a:lnTo>
                  <a:lnTo>
                    <a:pt x="15620" y="7892"/>
                  </a:lnTo>
                  <a:lnTo>
                    <a:pt x="14481" y="8746"/>
                  </a:lnTo>
                  <a:lnTo>
                    <a:pt x="13342" y="9559"/>
                  </a:lnTo>
                  <a:lnTo>
                    <a:pt x="12162" y="10332"/>
                  </a:lnTo>
                  <a:lnTo>
                    <a:pt x="10983" y="11105"/>
                  </a:lnTo>
                  <a:lnTo>
                    <a:pt x="9762" y="11797"/>
                  </a:lnTo>
                  <a:lnTo>
                    <a:pt x="8542" y="12488"/>
                  </a:lnTo>
                  <a:lnTo>
                    <a:pt x="7322" y="13139"/>
                  </a:lnTo>
                  <a:lnTo>
                    <a:pt x="6061" y="13749"/>
                  </a:lnTo>
                  <a:lnTo>
                    <a:pt x="4596" y="14400"/>
                  </a:lnTo>
                  <a:lnTo>
                    <a:pt x="3132" y="14969"/>
                  </a:lnTo>
                  <a:lnTo>
                    <a:pt x="1627" y="15539"/>
                  </a:lnTo>
                  <a:lnTo>
                    <a:pt x="122" y="16027"/>
                  </a:lnTo>
                  <a:lnTo>
                    <a:pt x="81" y="16068"/>
                  </a:lnTo>
                  <a:lnTo>
                    <a:pt x="0" y="16108"/>
                  </a:lnTo>
                  <a:lnTo>
                    <a:pt x="0" y="16190"/>
                  </a:lnTo>
                  <a:lnTo>
                    <a:pt x="0" y="16271"/>
                  </a:lnTo>
                  <a:lnTo>
                    <a:pt x="41" y="16312"/>
                  </a:lnTo>
                  <a:lnTo>
                    <a:pt x="81" y="16393"/>
                  </a:lnTo>
                  <a:lnTo>
                    <a:pt x="244" y="16393"/>
                  </a:lnTo>
                  <a:lnTo>
                    <a:pt x="1586" y="15946"/>
                  </a:lnTo>
                  <a:lnTo>
                    <a:pt x="2888" y="15457"/>
                  </a:lnTo>
                  <a:lnTo>
                    <a:pt x="4230" y="14929"/>
                  </a:lnTo>
                  <a:lnTo>
                    <a:pt x="5532" y="14400"/>
                  </a:lnTo>
                  <a:lnTo>
                    <a:pt x="6793" y="13790"/>
                  </a:lnTo>
                  <a:lnTo>
                    <a:pt x="8095" y="13180"/>
                  </a:lnTo>
                  <a:lnTo>
                    <a:pt x="9315" y="12488"/>
                  </a:lnTo>
                  <a:lnTo>
                    <a:pt x="10535" y="11797"/>
                  </a:lnTo>
                  <a:lnTo>
                    <a:pt x="11755" y="11064"/>
                  </a:lnTo>
                  <a:lnTo>
                    <a:pt x="12935" y="10292"/>
                  </a:lnTo>
                  <a:lnTo>
                    <a:pt x="14074" y="9478"/>
                  </a:lnTo>
                  <a:lnTo>
                    <a:pt x="15213" y="8665"/>
                  </a:lnTo>
                  <a:lnTo>
                    <a:pt x="16352" y="7810"/>
                  </a:lnTo>
                  <a:lnTo>
                    <a:pt x="17409" y="6915"/>
                  </a:lnTo>
                  <a:lnTo>
                    <a:pt x="18467" y="5980"/>
                  </a:lnTo>
                  <a:lnTo>
                    <a:pt x="19525" y="5044"/>
                  </a:lnTo>
                  <a:lnTo>
                    <a:pt x="20663" y="3905"/>
                  </a:lnTo>
                  <a:lnTo>
                    <a:pt x="21762" y="2767"/>
                  </a:lnTo>
                  <a:lnTo>
                    <a:pt x="22819" y="1546"/>
                  </a:lnTo>
                  <a:lnTo>
                    <a:pt x="23836" y="326"/>
                  </a:lnTo>
                  <a:lnTo>
                    <a:pt x="23877" y="285"/>
                  </a:lnTo>
                  <a:lnTo>
                    <a:pt x="23877" y="204"/>
                  </a:lnTo>
                  <a:lnTo>
                    <a:pt x="23836" y="82"/>
                  </a:lnTo>
                  <a:lnTo>
                    <a:pt x="23755" y="41"/>
                  </a:lnTo>
                  <a:lnTo>
                    <a:pt x="23714"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3" name="Google Shape;123;p14"/>
            <p:cNvSpPr/>
            <p:nvPr/>
          </p:nvSpPr>
          <p:spPr>
            <a:xfrm>
              <a:off x="261500" y="916725"/>
              <a:ext cx="477975" cy="336600"/>
            </a:xfrm>
            <a:custGeom>
              <a:rect b="b" l="l" r="r" t="t"/>
              <a:pathLst>
                <a:path extrusionOk="0" h="13464" w="19119">
                  <a:moveTo>
                    <a:pt x="18915" y="0"/>
                  </a:moveTo>
                  <a:lnTo>
                    <a:pt x="18834" y="41"/>
                  </a:lnTo>
                  <a:lnTo>
                    <a:pt x="18793" y="82"/>
                  </a:lnTo>
                  <a:lnTo>
                    <a:pt x="18101" y="1017"/>
                  </a:lnTo>
                  <a:lnTo>
                    <a:pt x="17410" y="1912"/>
                  </a:lnTo>
                  <a:lnTo>
                    <a:pt x="16678" y="2766"/>
                  </a:lnTo>
                  <a:lnTo>
                    <a:pt x="15946" y="3620"/>
                  </a:lnTo>
                  <a:lnTo>
                    <a:pt x="15132" y="4434"/>
                  </a:lnTo>
                  <a:lnTo>
                    <a:pt x="14319" y="5247"/>
                  </a:lnTo>
                  <a:lnTo>
                    <a:pt x="13505" y="5980"/>
                  </a:lnTo>
                  <a:lnTo>
                    <a:pt x="12610" y="6712"/>
                  </a:lnTo>
                  <a:lnTo>
                    <a:pt x="11756" y="7403"/>
                  </a:lnTo>
                  <a:lnTo>
                    <a:pt x="10820" y="8095"/>
                  </a:lnTo>
                  <a:lnTo>
                    <a:pt x="9885" y="8746"/>
                  </a:lnTo>
                  <a:lnTo>
                    <a:pt x="8949" y="9315"/>
                  </a:lnTo>
                  <a:lnTo>
                    <a:pt x="7973" y="9925"/>
                  </a:lnTo>
                  <a:lnTo>
                    <a:pt x="6997" y="10454"/>
                  </a:lnTo>
                  <a:lnTo>
                    <a:pt x="5980" y="10942"/>
                  </a:lnTo>
                  <a:lnTo>
                    <a:pt x="4963" y="11430"/>
                  </a:lnTo>
                  <a:lnTo>
                    <a:pt x="3783" y="11918"/>
                  </a:lnTo>
                  <a:lnTo>
                    <a:pt x="2563" y="12366"/>
                  </a:lnTo>
                  <a:lnTo>
                    <a:pt x="1343" y="12772"/>
                  </a:lnTo>
                  <a:lnTo>
                    <a:pt x="123" y="13098"/>
                  </a:lnTo>
                  <a:lnTo>
                    <a:pt x="41" y="13139"/>
                  </a:lnTo>
                  <a:lnTo>
                    <a:pt x="1" y="13220"/>
                  </a:lnTo>
                  <a:lnTo>
                    <a:pt x="1" y="13261"/>
                  </a:lnTo>
                  <a:lnTo>
                    <a:pt x="1" y="13342"/>
                  </a:lnTo>
                  <a:lnTo>
                    <a:pt x="41" y="13383"/>
                  </a:lnTo>
                  <a:lnTo>
                    <a:pt x="82" y="13464"/>
                  </a:lnTo>
                  <a:lnTo>
                    <a:pt x="245" y="13464"/>
                  </a:lnTo>
                  <a:lnTo>
                    <a:pt x="1343" y="13179"/>
                  </a:lnTo>
                  <a:lnTo>
                    <a:pt x="2400" y="12813"/>
                  </a:lnTo>
                  <a:lnTo>
                    <a:pt x="3499" y="12406"/>
                  </a:lnTo>
                  <a:lnTo>
                    <a:pt x="4556" y="12000"/>
                  </a:lnTo>
                  <a:lnTo>
                    <a:pt x="5614" y="11552"/>
                  </a:lnTo>
                  <a:lnTo>
                    <a:pt x="6631" y="11023"/>
                  </a:lnTo>
                  <a:lnTo>
                    <a:pt x="7648" y="10495"/>
                  </a:lnTo>
                  <a:lnTo>
                    <a:pt x="8665" y="9925"/>
                  </a:lnTo>
                  <a:lnTo>
                    <a:pt x="9641" y="9356"/>
                  </a:lnTo>
                  <a:lnTo>
                    <a:pt x="10576" y="8705"/>
                  </a:lnTo>
                  <a:lnTo>
                    <a:pt x="11512" y="8054"/>
                  </a:lnTo>
                  <a:lnTo>
                    <a:pt x="12447" y="7363"/>
                  </a:lnTo>
                  <a:lnTo>
                    <a:pt x="13342" y="6630"/>
                  </a:lnTo>
                  <a:lnTo>
                    <a:pt x="14197" y="5858"/>
                  </a:lnTo>
                  <a:lnTo>
                    <a:pt x="15010" y="5085"/>
                  </a:lnTo>
                  <a:lnTo>
                    <a:pt x="15824" y="4271"/>
                  </a:lnTo>
                  <a:lnTo>
                    <a:pt x="16718" y="3295"/>
                  </a:lnTo>
                  <a:lnTo>
                    <a:pt x="17532" y="2319"/>
                  </a:lnTo>
                  <a:lnTo>
                    <a:pt x="18345" y="1302"/>
                  </a:lnTo>
                  <a:lnTo>
                    <a:pt x="19078" y="285"/>
                  </a:lnTo>
                  <a:lnTo>
                    <a:pt x="19118" y="204"/>
                  </a:lnTo>
                  <a:lnTo>
                    <a:pt x="19118" y="122"/>
                  </a:lnTo>
                  <a:lnTo>
                    <a:pt x="19078" y="82"/>
                  </a:lnTo>
                  <a:lnTo>
                    <a:pt x="19037" y="41"/>
                  </a:lnTo>
                  <a:lnTo>
                    <a:pt x="18915"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4" name="Google Shape;124;p14"/>
            <p:cNvSpPr/>
            <p:nvPr/>
          </p:nvSpPr>
          <p:spPr>
            <a:xfrm>
              <a:off x="277775" y="921800"/>
              <a:ext cx="404750" cy="281700"/>
            </a:xfrm>
            <a:custGeom>
              <a:rect b="b" l="l" r="r" t="t"/>
              <a:pathLst>
                <a:path extrusionOk="0" h="11268" w="16190">
                  <a:moveTo>
                    <a:pt x="15945" y="1"/>
                  </a:moveTo>
                  <a:lnTo>
                    <a:pt x="15864" y="41"/>
                  </a:lnTo>
                  <a:lnTo>
                    <a:pt x="12895" y="2319"/>
                  </a:lnTo>
                  <a:lnTo>
                    <a:pt x="9844" y="4516"/>
                  </a:lnTo>
                  <a:lnTo>
                    <a:pt x="6793" y="6631"/>
                  </a:lnTo>
                  <a:lnTo>
                    <a:pt x="3661" y="8705"/>
                  </a:lnTo>
                  <a:lnTo>
                    <a:pt x="1871" y="9804"/>
                  </a:lnTo>
                  <a:lnTo>
                    <a:pt x="82" y="10942"/>
                  </a:lnTo>
                  <a:lnTo>
                    <a:pt x="41" y="10983"/>
                  </a:lnTo>
                  <a:lnTo>
                    <a:pt x="0" y="11064"/>
                  </a:lnTo>
                  <a:lnTo>
                    <a:pt x="0" y="11105"/>
                  </a:lnTo>
                  <a:lnTo>
                    <a:pt x="41" y="11186"/>
                  </a:lnTo>
                  <a:lnTo>
                    <a:pt x="82" y="11227"/>
                  </a:lnTo>
                  <a:lnTo>
                    <a:pt x="122" y="11268"/>
                  </a:lnTo>
                  <a:lnTo>
                    <a:pt x="285" y="11268"/>
                  </a:lnTo>
                  <a:lnTo>
                    <a:pt x="3458" y="9275"/>
                  </a:lnTo>
                  <a:lnTo>
                    <a:pt x="6631" y="7200"/>
                  </a:lnTo>
                  <a:lnTo>
                    <a:pt x="9722" y="5044"/>
                  </a:lnTo>
                  <a:lnTo>
                    <a:pt x="12773" y="2848"/>
                  </a:lnTo>
                  <a:lnTo>
                    <a:pt x="14440" y="1587"/>
                  </a:lnTo>
                  <a:lnTo>
                    <a:pt x="16108" y="326"/>
                  </a:lnTo>
                  <a:lnTo>
                    <a:pt x="16149" y="245"/>
                  </a:lnTo>
                  <a:lnTo>
                    <a:pt x="16189" y="204"/>
                  </a:lnTo>
                  <a:lnTo>
                    <a:pt x="16149" y="123"/>
                  </a:lnTo>
                  <a:lnTo>
                    <a:pt x="16108" y="82"/>
                  </a:lnTo>
                  <a:lnTo>
                    <a:pt x="15986"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5" name="Google Shape;125;p14"/>
            <p:cNvSpPr/>
            <p:nvPr/>
          </p:nvSpPr>
          <p:spPr>
            <a:xfrm>
              <a:off x="329625" y="896375"/>
              <a:ext cx="264425" cy="187150"/>
            </a:xfrm>
            <a:custGeom>
              <a:rect b="b" l="l" r="r" t="t"/>
              <a:pathLst>
                <a:path extrusionOk="0" h="7486" w="10577">
                  <a:moveTo>
                    <a:pt x="7038" y="1"/>
                  </a:moveTo>
                  <a:lnTo>
                    <a:pt x="6956" y="41"/>
                  </a:lnTo>
                  <a:lnTo>
                    <a:pt x="5940" y="651"/>
                  </a:lnTo>
                  <a:lnTo>
                    <a:pt x="4963" y="1262"/>
                  </a:lnTo>
                  <a:lnTo>
                    <a:pt x="4028" y="1953"/>
                  </a:lnTo>
                  <a:lnTo>
                    <a:pt x="3133" y="2645"/>
                  </a:lnTo>
                  <a:lnTo>
                    <a:pt x="2197" y="3417"/>
                  </a:lnTo>
                  <a:lnTo>
                    <a:pt x="1343" y="4231"/>
                  </a:lnTo>
                  <a:lnTo>
                    <a:pt x="936" y="4597"/>
                  </a:lnTo>
                  <a:lnTo>
                    <a:pt x="570" y="5004"/>
                  </a:lnTo>
                  <a:lnTo>
                    <a:pt x="408" y="5207"/>
                  </a:lnTo>
                  <a:lnTo>
                    <a:pt x="286" y="5451"/>
                  </a:lnTo>
                  <a:lnTo>
                    <a:pt x="164" y="5655"/>
                  </a:lnTo>
                  <a:lnTo>
                    <a:pt x="82" y="5899"/>
                  </a:lnTo>
                  <a:lnTo>
                    <a:pt x="42" y="6143"/>
                  </a:lnTo>
                  <a:lnTo>
                    <a:pt x="1" y="6346"/>
                  </a:lnTo>
                  <a:lnTo>
                    <a:pt x="42" y="6550"/>
                  </a:lnTo>
                  <a:lnTo>
                    <a:pt x="82" y="6753"/>
                  </a:lnTo>
                  <a:lnTo>
                    <a:pt x="164" y="6956"/>
                  </a:lnTo>
                  <a:lnTo>
                    <a:pt x="286" y="7119"/>
                  </a:lnTo>
                  <a:lnTo>
                    <a:pt x="448" y="7282"/>
                  </a:lnTo>
                  <a:lnTo>
                    <a:pt x="652" y="7404"/>
                  </a:lnTo>
                  <a:lnTo>
                    <a:pt x="896" y="7485"/>
                  </a:lnTo>
                  <a:lnTo>
                    <a:pt x="1140" y="7485"/>
                  </a:lnTo>
                  <a:lnTo>
                    <a:pt x="1384" y="7444"/>
                  </a:lnTo>
                  <a:lnTo>
                    <a:pt x="1669" y="7404"/>
                  </a:lnTo>
                  <a:lnTo>
                    <a:pt x="2157" y="7160"/>
                  </a:lnTo>
                  <a:lnTo>
                    <a:pt x="2604" y="6916"/>
                  </a:lnTo>
                  <a:lnTo>
                    <a:pt x="3621" y="6346"/>
                  </a:lnTo>
                  <a:lnTo>
                    <a:pt x="4638" y="5777"/>
                  </a:lnTo>
                  <a:lnTo>
                    <a:pt x="5614" y="5126"/>
                  </a:lnTo>
                  <a:lnTo>
                    <a:pt x="6550" y="4475"/>
                  </a:lnTo>
                  <a:lnTo>
                    <a:pt x="7607" y="3662"/>
                  </a:lnTo>
                  <a:lnTo>
                    <a:pt x="8584" y="2848"/>
                  </a:lnTo>
                  <a:lnTo>
                    <a:pt x="9600" y="1953"/>
                  </a:lnTo>
                  <a:lnTo>
                    <a:pt x="10536" y="1058"/>
                  </a:lnTo>
                  <a:lnTo>
                    <a:pt x="10577" y="977"/>
                  </a:lnTo>
                  <a:lnTo>
                    <a:pt x="10577" y="936"/>
                  </a:lnTo>
                  <a:lnTo>
                    <a:pt x="10577" y="855"/>
                  </a:lnTo>
                  <a:lnTo>
                    <a:pt x="10536" y="814"/>
                  </a:lnTo>
                  <a:lnTo>
                    <a:pt x="10455" y="774"/>
                  </a:lnTo>
                  <a:lnTo>
                    <a:pt x="10414" y="733"/>
                  </a:lnTo>
                  <a:lnTo>
                    <a:pt x="10333" y="774"/>
                  </a:lnTo>
                  <a:lnTo>
                    <a:pt x="10251" y="814"/>
                  </a:lnTo>
                  <a:lnTo>
                    <a:pt x="9478" y="1546"/>
                  </a:lnTo>
                  <a:lnTo>
                    <a:pt x="8706" y="2238"/>
                  </a:lnTo>
                  <a:lnTo>
                    <a:pt x="7892" y="2929"/>
                  </a:lnTo>
                  <a:lnTo>
                    <a:pt x="7079" y="3621"/>
                  </a:lnTo>
                  <a:lnTo>
                    <a:pt x="6224" y="4231"/>
                  </a:lnTo>
                  <a:lnTo>
                    <a:pt x="5329" y="4841"/>
                  </a:lnTo>
                  <a:lnTo>
                    <a:pt x="4435" y="5451"/>
                  </a:lnTo>
                  <a:lnTo>
                    <a:pt x="3540" y="5980"/>
                  </a:lnTo>
                  <a:lnTo>
                    <a:pt x="2604" y="6550"/>
                  </a:lnTo>
                  <a:lnTo>
                    <a:pt x="2116" y="6794"/>
                  </a:lnTo>
                  <a:lnTo>
                    <a:pt x="1628" y="6997"/>
                  </a:lnTo>
                  <a:lnTo>
                    <a:pt x="1384" y="7078"/>
                  </a:lnTo>
                  <a:lnTo>
                    <a:pt x="1140" y="7119"/>
                  </a:lnTo>
                  <a:lnTo>
                    <a:pt x="855" y="7078"/>
                  </a:lnTo>
                  <a:lnTo>
                    <a:pt x="733" y="7038"/>
                  </a:lnTo>
                  <a:lnTo>
                    <a:pt x="652" y="6956"/>
                  </a:lnTo>
                  <a:lnTo>
                    <a:pt x="489" y="6794"/>
                  </a:lnTo>
                  <a:lnTo>
                    <a:pt x="408" y="6590"/>
                  </a:lnTo>
                  <a:lnTo>
                    <a:pt x="408" y="6387"/>
                  </a:lnTo>
                  <a:lnTo>
                    <a:pt x="408" y="6183"/>
                  </a:lnTo>
                  <a:lnTo>
                    <a:pt x="448" y="5939"/>
                  </a:lnTo>
                  <a:lnTo>
                    <a:pt x="530" y="5695"/>
                  </a:lnTo>
                  <a:lnTo>
                    <a:pt x="652" y="5492"/>
                  </a:lnTo>
                  <a:lnTo>
                    <a:pt x="814" y="5289"/>
                  </a:lnTo>
                  <a:lnTo>
                    <a:pt x="1180" y="4882"/>
                  </a:lnTo>
                  <a:lnTo>
                    <a:pt x="1547" y="4556"/>
                  </a:lnTo>
                  <a:lnTo>
                    <a:pt x="2319" y="3824"/>
                  </a:lnTo>
                  <a:lnTo>
                    <a:pt x="3133" y="3133"/>
                  </a:lnTo>
                  <a:lnTo>
                    <a:pt x="4068" y="2360"/>
                  </a:lnTo>
                  <a:lnTo>
                    <a:pt x="5085" y="1668"/>
                  </a:lnTo>
                  <a:lnTo>
                    <a:pt x="6102" y="977"/>
                  </a:lnTo>
                  <a:lnTo>
                    <a:pt x="7160" y="367"/>
                  </a:lnTo>
                  <a:lnTo>
                    <a:pt x="7201" y="326"/>
                  </a:lnTo>
                  <a:lnTo>
                    <a:pt x="7241" y="245"/>
                  </a:lnTo>
                  <a:lnTo>
                    <a:pt x="7241" y="163"/>
                  </a:lnTo>
                  <a:lnTo>
                    <a:pt x="7201" y="123"/>
                  </a:lnTo>
                  <a:lnTo>
                    <a:pt x="7160" y="82"/>
                  </a:lnTo>
                  <a:lnTo>
                    <a:pt x="7119" y="41"/>
                  </a:lnTo>
                  <a:lnTo>
                    <a:pt x="7038"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126" name="Google Shape;126;p14"/>
          <p:cNvGrpSpPr/>
          <p:nvPr/>
        </p:nvGrpSpPr>
        <p:grpSpPr>
          <a:xfrm>
            <a:off x="8151930" y="-741100"/>
            <a:ext cx="1340699" cy="1721646"/>
            <a:chOff x="2659350" y="1746500"/>
            <a:chExt cx="379350" cy="487125"/>
          </a:xfrm>
        </p:grpSpPr>
        <p:sp>
          <p:nvSpPr>
            <p:cNvPr id="127" name="Google Shape;127;p14"/>
            <p:cNvSpPr/>
            <p:nvPr/>
          </p:nvSpPr>
          <p:spPr>
            <a:xfrm>
              <a:off x="2659350" y="1746500"/>
              <a:ext cx="379350" cy="487125"/>
            </a:xfrm>
            <a:custGeom>
              <a:rect b="b" l="l" r="r" t="t"/>
              <a:pathLst>
                <a:path extrusionOk="0" h="19485" w="15174">
                  <a:moveTo>
                    <a:pt x="14116" y="1"/>
                  </a:moveTo>
                  <a:lnTo>
                    <a:pt x="14034" y="42"/>
                  </a:lnTo>
                  <a:lnTo>
                    <a:pt x="13261" y="774"/>
                  </a:lnTo>
                  <a:lnTo>
                    <a:pt x="12448" y="1465"/>
                  </a:lnTo>
                  <a:lnTo>
                    <a:pt x="11634" y="2116"/>
                  </a:lnTo>
                  <a:lnTo>
                    <a:pt x="10821" y="2767"/>
                  </a:lnTo>
                  <a:lnTo>
                    <a:pt x="9112" y="4028"/>
                  </a:lnTo>
                  <a:lnTo>
                    <a:pt x="7404" y="5248"/>
                  </a:lnTo>
                  <a:lnTo>
                    <a:pt x="5899" y="6428"/>
                  </a:lnTo>
                  <a:lnTo>
                    <a:pt x="5167" y="7079"/>
                  </a:lnTo>
                  <a:lnTo>
                    <a:pt x="4435" y="7729"/>
                  </a:lnTo>
                  <a:lnTo>
                    <a:pt x="3743" y="8380"/>
                  </a:lnTo>
                  <a:lnTo>
                    <a:pt x="3133" y="9072"/>
                  </a:lnTo>
                  <a:lnTo>
                    <a:pt x="2482" y="9844"/>
                  </a:lnTo>
                  <a:lnTo>
                    <a:pt x="1953" y="10617"/>
                  </a:lnTo>
                  <a:lnTo>
                    <a:pt x="1425" y="11390"/>
                  </a:lnTo>
                  <a:lnTo>
                    <a:pt x="1018" y="12204"/>
                  </a:lnTo>
                  <a:lnTo>
                    <a:pt x="652" y="13058"/>
                  </a:lnTo>
                  <a:lnTo>
                    <a:pt x="326" y="13912"/>
                  </a:lnTo>
                  <a:lnTo>
                    <a:pt x="123" y="14766"/>
                  </a:lnTo>
                  <a:lnTo>
                    <a:pt x="82" y="15173"/>
                  </a:lnTo>
                  <a:lnTo>
                    <a:pt x="42" y="15620"/>
                  </a:lnTo>
                  <a:lnTo>
                    <a:pt x="1" y="16068"/>
                  </a:lnTo>
                  <a:lnTo>
                    <a:pt x="42" y="16475"/>
                  </a:lnTo>
                  <a:lnTo>
                    <a:pt x="82" y="16922"/>
                  </a:lnTo>
                  <a:lnTo>
                    <a:pt x="164" y="17329"/>
                  </a:lnTo>
                  <a:lnTo>
                    <a:pt x="326" y="17736"/>
                  </a:lnTo>
                  <a:lnTo>
                    <a:pt x="489" y="18102"/>
                  </a:lnTo>
                  <a:lnTo>
                    <a:pt x="733" y="18468"/>
                  </a:lnTo>
                  <a:lnTo>
                    <a:pt x="977" y="18753"/>
                  </a:lnTo>
                  <a:lnTo>
                    <a:pt x="1303" y="18997"/>
                  </a:lnTo>
                  <a:lnTo>
                    <a:pt x="1669" y="19200"/>
                  </a:lnTo>
                  <a:lnTo>
                    <a:pt x="2035" y="19363"/>
                  </a:lnTo>
                  <a:lnTo>
                    <a:pt x="2442" y="19444"/>
                  </a:lnTo>
                  <a:lnTo>
                    <a:pt x="2930" y="19485"/>
                  </a:lnTo>
                  <a:lnTo>
                    <a:pt x="3418" y="19485"/>
                  </a:lnTo>
                  <a:lnTo>
                    <a:pt x="3906" y="19444"/>
                  </a:lnTo>
                  <a:lnTo>
                    <a:pt x="4394" y="19363"/>
                  </a:lnTo>
                  <a:lnTo>
                    <a:pt x="5370" y="19159"/>
                  </a:lnTo>
                  <a:lnTo>
                    <a:pt x="6306" y="18915"/>
                  </a:lnTo>
                  <a:lnTo>
                    <a:pt x="7323" y="18631"/>
                  </a:lnTo>
                  <a:lnTo>
                    <a:pt x="8340" y="18305"/>
                  </a:lnTo>
                  <a:lnTo>
                    <a:pt x="9356" y="17980"/>
                  </a:lnTo>
                  <a:lnTo>
                    <a:pt x="10333" y="17614"/>
                  </a:lnTo>
                  <a:lnTo>
                    <a:pt x="11309" y="17166"/>
                  </a:lnTo>
                  <a:lnTo>
                    <a:pt x="12285" y="16719"/>
                  </a:lnTo>
                  <a:lnTo>
                    <a:pt x="13221" y="16271"/>
                  </a:lnTo>
                  <a:lnTo>
                    <a:pt x="14156" y="15743"/>
                  </a:lnTo>
                  <a:lnTo>
                    <a:pt x="15051" y="15214"/>
                  </a:lnTo>
                  <a:lnTo>
                    <a:pt x="15132" y="15173"/>
                  </a:lnTo>
                  <a:lnTo>
                    <a:pt x="15173" y="15092"/>
                  </a:lnTo>
                  <a:lnTo>
                    <a:pt x="15173" y="15051"/>
                  </a:lnTo>
                  <a:lnTo>
                    <a:pt x="15132" y="14970"/>
                  </a:lnTo>
                  <a:lnTo>
                    <a:pt x="15092" y="14929"/>
                  </a:lnTo>
                  <a:lnTo>
                    <a:pt x="15010" y="14888"/>
                  </a:lnTo>
                  <a:lnTo>
                    <a:pt x="14888" y="14888"/>
                  </a:lnTo>
                  <a:lnTo>
                    <a:pt x="13994" y="15417"/>
                  </a:lnTo>
                  <a:lnTo>
                    <a:pt x="13099" y="15905"/>
                  </a:lnTo>
                  <a:lnTo>
                    <a:pt x="12163" y="16393"/>
                  </a:lnTo>
                  <a:lnTo>
                    <a:pt x="11228" y="16800"/>
                  </a:lnTo>
                  <a:lnTo>
                    <a:pt x="10292" y="17207"/>
                  </a:lnTo>
                  <a:lnTo>
                    <a:pt x="9316" y="17573"/>
                  </a:lnTo>
                  <a:lnTo>
                    <a:pt x="8340" y="17939"/>
                  </a:lnTo>
                  <a:lnTo>
                    <a:pt x="7363" y="18224"/>
                  </a:lnTo>
                  <a:lnTo>
                    <a:pt x="6387" y="18508"/>
                  </a:lnTo>
                  <a:lnTo>
                    <a:pt x="5452" y="18753"/>
                  </a:lnTo>
                  <a:lnTo>
                    <a:pt x="4475" y="18956"/>
                  </a:lnTo>
                  <a:lnTo>
                    <a:pt x="3987" y="19037"/>
                  </a:lnTo>
                  <a:lnTo>
                    <a:pt x="3499" y="19119"/>
                  </a:lnTo>
                  <a:lnTo>
                    <a:pt x="3052" y="19119"/>
                  </a:lnTo>
                  <a:lnTo>
                    <a:pt x="2604" y="19078"/>
                  </a:lnTo>
                  <a:lnTo>
                    <a:pt x="2157" y="18997"/>
                  </a:lnTo>
                  <a:lnTo>
                    <a:pt x="1750" y="18834"/>
                  </a:lnTo>
                  <a:lnTo>
                    <a:pt x="1425" y="18631"/>
                  </a:lnTo>
                  <a:lnTo>
                    <a:pt x="1140" y="18386"/>
                  </a:lnTo>
                  <a:lnTo>
                    <a:pt x="896" y="18061"/>
                  </a:lnTo>
                  <a:lnTo>
                    <a:pt x="692" y="17695"/>
                  </a:lnTo>
                  <a:lnTo>
                    <a:pt x="530" y="17329"/>
                  </a:lnTo>
                  <a:lnTo>
                    <a:pt x="448" y="16922"/>
                  </a:lnTo>
                  <a:lnTo>
                    <a:pt x="408" y="16475"/>
                  </a:lnTo>
                  <a:lnTo>
                    <a:pt x="367" y="16068"/>
                  </a:lnTo>
                  <a:lnTo>
                    <a:pt x="408" y="15661"/>
                  </a:lnTo>
                  <a:lnTo>
                    <a:pt x="448" y="15214"/>
                  </a:lnTo>
                  <a:lnTo>
                    <a:pt x="611" y="14400"/>
                  </a:lnTo>
                  <a:lnTo>
                    <a:pt x="855" y="13546"/>
                  </a:lnTo>
                  <a:lnTo>
                    <a:pt x="1181" y="12732"/>
                  </a:lnTo>
                  <a:lnTo>
                    <a:pt x="1587" y="11919"/>
                  </a:lnTo>
                  <a:lnTo>
                    <a:pt x="2035" y="11146"/>
                  </a:lnTo>
                  <a:lnTo>
                    <a:pt x="2564" y="10373"/>
                  </a:lnTo>
                  <a:lnTo>
                    <a:pt x="3133" y="9641"/>
                  </a:lnTo>
                  <a:lnTo>
                    <a:pt x="3743" y="8950"/>
                  </a:lnTo>
                  <a:lnTo>
                    <a:pt x="4394" y="8299"/>
                  </a:lnTo>
                  <a:lnTo>
                    <a:pt x="5045" y="7648"/>
                  </a:lnTo>
                  <a:lnTo>
                    <a:pt x="5736" y="7038"/>
                  </a:lnTo>
                  <a:lnTo>
                    <a:pt x="6468" y="6428"/>
                  </a:lnTo>
                  <a:lnTo>
                    <a:pt x="7201" y="5858"/>
                  </a:lnTo>
                  <a:lnTo>
                    <a:pt x="9031" y="4557"/>
                  </a:lnTo>
                  <a:lnTo>
                    <a:pt x="10821" y="3214"/>
                  </a:lnTo>
                  <a:lnTo>
                    <a:pt x="11756" y="2523"/>
                  </a:lnTo>
                  <a:lnTo>
                    <a:pt x="12611" y="1831"/>
                  </a:lnTo>
                  <a:lnTo>
                    <a:pt x="13465" y="1058"/>
                  </a:lnTo>
                  <a:lnTo>
                    <a:pt x="14278" y="286"/>
                  </a:lnTo>
                  <a:lnTo>
                    <a:pt x="14319" y="245"/>
                  </a:lnTo>
                  <a:lnTo>
                    <a:pt x="14360" y="164"/>
                  </a:lnTo>
                  <a:lnTo>
                    <a:pt x="14319" y="82"/>
                  </a:lnTo>
                  <a:lnTo>
                    <a:pt x="14278" y="42"/>
                  </a:lnTo>
                  <a:lnTo>
                    <a:pt x="14238"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8" name="Google Shape;128;p14"/>
            <p:cNvSpPr/>
            <p:nvPr/>
          </p:nvSpPr>
          <p:spPr>
            <a:xfrm>
              <a:off x="2701050" y="1843125"/>
              <a:ext cx="309175" cy="322375"/>
            </a:xfrm>
            <a:custGeom>
              <a:rect b="b" l="l" r="r" t="t"/>
              <a:pathLst>
                <a:path extrusionOk="0" h="12895" w="12367">
                  <a:moveTo>
                    <a:pt x="12163" y="0"/>
                  </a:moveTo>
                  <a:lnTo>
                    <a:pt x="12081" y="41"/>
                  </a:lnTo>
                  <a:lnTo>
                    <a:pt x="9600" y="1831"/>
                  </a:lnTo>
                  <a:lnTo>
                    <a:pt x="7160" y="3702"/>
                  </a:lnTo>
                  <a:lnTo>
                    <a:pt x="5939" y="4637"/>
                  </a:lnTo>
                  <a:lnTo>
                    <a:pt x="4760" y="5613"/>
                  </a:lnTo>
                  <a:lnTo>
                    <a:pt x="3580" y="6630"/>
                  </a:lnTo>
                  <a:lnTo>
                    <a:pt x="2441" y="7647"/>
                  </a:lnTo>
                  <a:lnTo>
                    <a:pt x="1872" y="8135"/>
                  </a:lnTo>
                  <a:lnTo>
                    <a:pt x="1343" y="8664"/>
                  </a:lnTo>
                  <a:lnTo>
                    <a:pt x="855" y="9193"/>
                  </a:lnTo>
                  <a:lnTo>
                    <a:pt x="611" y="9478"/>
                  </a:lnTo>
                  <a:lnTo>
                    <a:pt x="407" y="9762"/>
                  </a:lnTo>
                  <a:lnTo>
                    <a:pt x="285" y="10047"/>
                  </a:lnTo>
                  <a:lnTo>
                    <a:pt x="163" y="10332"/>
                  </a:lnTo>
                  <a:lnTo>
                    <a:pt x="82" y="10617"/>
                  </a:lnTo>
                  <a:lnTo>
                    <a:pt x="1" y="10901"/>
                  </a:lnTo>
                  <a:lnTo>
                    <a:pt x="1" y="11227"/>
                  </a:lnTo>
                  <a:lnTo>
                    <a:pt x="41" y="11511"/>
                  </a:lnTo>
                  <a:lnTo>
                    <a:pt x="123" y="11796"/>
                  </a:lnTo>
                  <a:lnTo>
                    <a:pt x="285" y="12081"/>
                  </a:lnTo>
                  <a:lnTo>
                    <a:pt x="448" y="12284"/>
                  </a:lnTo>
                  <a:lnTo>
                    <a:pt x="651" y="12488"/>
                  </a:lnTo>
                  <a:lnTo>
                    <a:pt x="896" y="12610"/>
                  </a:lnTo>
                  <a:lnTo>
                    <a:pt x="1140" y="12732"/>
                  </a:lnTo>
                  <a:lnTo>
                    <a:pt x="1384" y="12813"/>
                  </a:lnTo>
                  <a:lnTo>
                    <a:pt x="1668" y="12854"/>
                  </a:lnTo>
                  <a:lnTo>
                    <a:pt x="2238" y="12894"/>
                  </a:lnTo>
                  <a:lnTo>
                    <a:pt x="2929" y="12813"/>
                  </a:lnTo>
                  <a:lnTo>
                    <a:pt x="3621" y="12691"/>
                  </a:lnTo>
                  <a:lnTo>
                    <a:pt x="5004" y="12366"/>
                  </a:lnTo>
                  <a:lnTo>
                    <a:pt x="6712" y="11918"/>
                  </a:lnTo>
                  <a:lnTo>
                    <a:pt x="8380" y="11389"/>
                  </a:lnTo>
                  <a:lnTo>
                    <a:pt x="10048" y="10820"/>
                  </a:lnTo>
                  <a:lnTo>
                    <a:pt x="11715" y="10210"/>
                  </a:lnTo>
                  <a:lnTo>
                    <a:pt x="11756" y="10128"/>
                  </a:lnTo>
                  <a:lnTo>
                    <a:pt x="11797" y="10088"/>
                  </a:lnTo>
                  <a:lnTo>
                    <a:pt x="11837" y="9966"/>
                  </a:lnTo>
                  <a:lnTo>
                    <a:pt x="11797" y="9884"/>
                  </a:lnTo>
                  <a:lnTo>
                    <a:pt x="11756" y="9844"/>
                  </a:lnTo>
                  <a:lnTo>
                    <a:pt x="11675" y="9803"/>
                  </a:lnTo>
                  <a:lnTo>
                    <a:pt x="11593" y="9844"/>
                  </a:lnTo>
                  <a:lnTo>
                    <a:pt x="10210" y="10373"/>
                  </a:lnTo>
                  <a:lnTo>
                    <a:pt x="8827" y="10861"/>
                  </a:lnTo>
                  <a:lnTo>
                    <a:pt x="7444" y="11308"/>
                  </a:lnTo>
                  <a:lnTo>
                    <a:pt x="6021" y="11715"/>
                  </a:lnTo>
                  <a:lnTo>
                    <a:pt x="4597" y="12081"/>
                  </a:lnTo>
                  <a:lnTo>
                    <a:pt x="3173" y="12366"/>
                  </a:lnTo>
                  <a:lnTo>
                    <a:pt x="2604" y="12488"/>
                  </a:lnTo>
                  <a:lnTo>
                    <a:pt x="2034" y="12528"/>
                  </a:lnTo>
                  <a:lnTo>
                    <a:pt x="1709" y="12488"/>
                  </a:lnTo>
                  <a:lnTo>
                    <a:pt x="1424" y="12447"/>
                  </a:lnTo>
                  <a:lnTo>
                    <a:pt x="1180" y="12366"/>
                  </a:lnTo>
                  <a:lnTo>
                    <a:pt x="936" y="12244"/>
                  </a:lnTo>
                  <a:lnTo>
                    <a:pt x="692" y="12040"/>
                  </a:lnTo>
                  <a:lnTo>
                    <a:pt x="529" y="11796"/>
                  </a:lnTo>
                  <a:lnTo>
                    <a:pt x="448" y="11511"/>
                  </a:lnTo>
                  <a:lnTo>
                    <a:pt x="407" y="11227"/>
                  </a:lnTo>
                  <a:lnTo>
                    <a:pt x="407" y="10942"/>
                  </a:lnTo>
                  <a:lnTo>
                    <a:pt x="448" y="10657"/>
                  </a:lnTo>
                  <a:lnTo>
                    <a:pt x="529" y="10373"/>
                  </a:lnTo>
                  <a:lnTo>
                    <a:pt x="651" y="10088"/>
                  </a:lnTo>
                  <a:lnTo>
                    <a:pt x="855" y="9803"/>
                  </a:lnTo>
                  <a:lnTo>
                    <a:pt x="1058" y="9518"/>
                  </a:lnTo>
                  <a:lnTo>
                    <a:pt x="1546" y="8990"/>
                  </a:lnTo>
                  <a:lnTo>
                    <a:pt x="2034" y="8501"/>
                  </a:lnTo>
                  <a:lnTo>
                    <a:pt x="2563" y="8013"/>
                  </a:lnTo>
                  <a:lnTo>
                    <a:pt x="3621" y="7037"/>
                  </a:lnTo>
                  <a:lnTo>
                    <a:pt x="4719" y="6102"/>
                  </a:lnTo>
                  <a:lnTo>
                    <a:pt x="5858" y="5207"/>
                  </a:lnTo>
                  <a:lnTo>
                    <a:pt x="6956" y="4271"/>
                  </a:lnTo>
                  <a:lnTo>
                    <a:pt x="8299" y="3295"/>
                  </a:lnTo>
                  <a:lnTo>
                    <a:pt x="9600" y="2278"/>
                  </a:lnTo>
                  <a:lnTo>
                    <a:pt x="12285" y="366"/>
                  </a:lnTo>
                  <a:lnTo>
                    <a:pt x="12326" y="285"/>
                  </a:lnTo>
                  <a:lnTo>
                    <a:pt x="12366" y="203"/>
                  </a:lnTo>
                  <a:lnTo>
                    <a:pt x="12326" y="81"/>
                  </a:lnTo>
                  <a:lnTo>
                    <a:pt x="12285" y="41"/>
                  </a:lnTo>
                  <a:lnTo>
                    <a:pt x="1224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9" name="Google Shape;129;p14"/>
            <p:cNvSpPr/>
            <p:nvPr/>
          </p:nvSpPr>
          <p:spPr>
            <a:xfrm>
              <a:off x="2756975" y="1978375"/>
              <a:ext cx="183075" cy="133225"/>
            </a:xfrm>
            <a:custGeom>
              <a:rect b="b" l="l" r="r" t="t"/>
              <a:pathLst>
                <a:path extrusionOk="0" h="5329" w="7323">
                  <a:moveTo>
                    <a:pt x="5980" y="366"/>
                  </a:moveTo>
                  <a:lnTo>
                    <a:pt x="6306" y="407"/>
                  </a:lnTo>
                  <a:lnTo>
                    <a:pt x="6428" y="407"/>
                  </a:lnTo>
                  <a:lnTo>
                    <a:pt x="6550" y="488"/>
                  </a:lnTo>
                  <a:lnTo>
                    <a:pt x="6672" y="569"/>
                  </a:lnTo>
                  <a:lnTo>
                    <a:pt x="6753" y="651"/>
                  </a:lnTo>
                  <a:lnTo>
                    <a:pt x="6834" y="814"/>
                  </a:lnTo>
                  <a:lnTo>
                    <a:pt x="6875" y="936"/>
                  </a:lnTo>
                  <a:lnTo>
                    <a:pt x="6956" y="1302"/>
                  </a:lnTo>
                  <a:lnTo>
                    <a:pt x="6916" y="1586"/>
                  </a:lnTo>
                  <a:lnTo>
                    <a:pt x="6834" y="1912"/>
                  </a:lnTo>
                  <a:lnTo>
                    <a:pt x="6672" y="2197"/>
                  </a:lnTo>
                  <a:lnTo>
                    <a:pt x="6468" y="2522"/>
                  </a:lnTo>
                  <a:lnTo>
                    <a:pt x="6184" y="2766"/>
                  </a:lnTo>
                  <a:lnTo>
                    <a:pt x="5858" y="3010"/>
                  </a:lnTo>
                  <a:lnTo>
                    <a:pt x="5533" y="3213"/>
                  </a:lnTo>
                  <a:lnTo>
                    <a:pt x="4841" y="3580"/>
                  </a:lnTo>
                  <a:lnTo>
                    <a:pt x="4109" y="3864"/>
                  </a:lnTo>
                  <a:lnTo>
                    <a:pt x="3092" y="4271"/>
                  </a:lnTo>
                  <a:lnTo>
                    <a:pt x="2075" y="4637"/>
                  </a:lnTo>
                  <a:lnTo>
                    <a:pt x="1709" y="4800"/>
                  </a:lnTo>
                  <a:lnTo>
                    <a:pt x="1180" y="4963"/>
                  </a:lnTo>
                  <a:lnTo>
                    <a:pt x="692" y="4963"/>
                  </a:lnTo>
                  <a:lnTo>
                    <a:pt x="530" y="4881"/>
                  </a:lnTo>
                  <a:lnTo>
                    <a:pt x="448" y="4840"/>
                  </a:lnTo>
                  <a:lnTo>
                    <a:pt x="408" y="4759"/>
                  </a:lnTo>
                  <a:lnTo>
                    <a:pt x="367" y="4637"/>
                  </a:lnTo>
                  <a:lnTo>
                    <a:pt x="367" y="4515"/>
                  </a:lnTo>
                  <a:lnTo>
                    <a:pt x="448" y="4312"/>
                  </a:lnTo>
                  <a:lnTo>
                    <a:pt x="570" y="4108"/>
                  </a:lnTo>
                  <a:lnTo>
                    <a:pt x="733" y="3946"/>
                  </a:lnTo>
                  <a:lnTo>
                    <a:pt x="1384" y="3335"/>
                  </a:lnTo>
                  <a:lnTo>
                    <a:pt x="2075" y="2685"/>
                  </a:lnTo>
                  <a:lnTo>
                    <a:pt x="2848" y="2034"/>
                  </a:lnTo>
                  <a:lnTo>
                    <a:pt x="3621" y="1424"/>
                  </a:lnTo>
                  <a:lnTo>
                    <a:pt x="4068" y="1180"/>
                  </a:lnTo>
                  <a:lnTo>
                    <a:pt x="4475" y="936"/>
                  </a:lnTo>
                  <a:lnTo>
                    <a:pt x="4841" y="732"/>
                  </a:lnTo>
                  <a:lnTo>
                    <a:pt x="5207" y="569"/>
                  </a:lnTo>
                  <a:lnTo>
                    <a:pt x="5614" y="447"/>
                  </a:lnTo>
                  <a:lnTo>
                    <a:pt x="5980" y="366"/>
                  </a:lnTo>
                  <a:close/>
                  <a:moveTo>
                    <a:pt x="6021" y="0"/>
                  </a:moveTo>
                  <a:lnTo>
                    <a:pt x="5614" y="81"/>
                  </a:lnTo>
                  <a:lnTo>
                    <a:pt x="5207" y="203"/>
                  </a:lnTo>
                  <a:lnTo>
                    <a:pt x="4841" y="366"/>
                  </a:lnTo>
                  <a:lnTo>
                    <a:pt x="4353" y="569"/>
                  </a:lnTo>
                  <a:lnTo>
                    <a:pt x="3865" y="854"/>
                  </a:lnTo>
                  <a:lnTo>
                    <a:pt x="3377" y="1180"/>
                  </a:lnTo>
                  <a:lnTo>
                    <a:pt x="2930" y="1505"/>
                  </a:lnTo>
                  <a:lnTo>
                    <a:pt x="2035" y="2237"/>
                  </a:lnTo>
                  <a:lnTo>
                    <a:pt x="1180" y="2969"/>
                  </a:lnTo>
                  <a:lnTo>
                    <a:pt x="814" y="3295"/>
                  </a:lnTo>
                  <a:lnTo>
                    <a:pt x="448" y="3702"/>
                  </a:lnTo>
                  <a:lnTo>
                    <a:pt x="245" y="3905"/>
                  </a:lnTo>
                  <a:lnTo>
                    <a:pt x="123" y="4108"/>
                  </a:lnTo>
                  <a:lnTo>
                    <a:pt x="42" y="4352"/>
                  </a:lnTo>
                  <a:lnTo>
                    <a:pt x="1" y="4596"/>
                  </a:lnTo>
                  <a:lnTo>
                    <a:pt x="42" y="4840"/>
                  </a:lnTo>
                  <a:lnTo>
                    <a:pt x="164" y="5044"/>
                  </a:lnTo>
                  <a:lnTo>
                    <a:pt x="326" y="5207"/>
                  </a:lnTo>
                  <a:lnTo>
                    <a:pt x="530" y="5288"/>
                  </a:lnTo>
                  <a:lnTo>
                    <a:pt x="774" y="5329"/>
                  </a:lnTo>
                  <a:lnTo>
                    <a:pt x="1018" y="5329"/>
                  </a:lnTo>
                  <a:lnTo>
                    <a:pt x="1262" y="5288"/>
                  </a:lnTo>
                  <a:lnTo>
                    <a:pt x="1465" y="5247"/>
                  </a:lnTo>
                  <a:lnTo>
                    <a:pt x="2157" y="5003"/>
                  </a:lnTo>
                  <a:lnTo>
                    <a:pt x="2848" y="4759"/>
                  </a:lnTo>
                  <a:lnTo>
                    <a:pt x="4139" y="4266"/>
                  </a:lnTo>
                  <a:lnTo>
                    <a:pt x="4139" y="4266"/>
                  </a:lnTo>
                  <a:lnTo>
                    <a:pt x="4150" y="4271"/>
                  </a:lnTo>
                  <a:lnTo>
                    <a:pt x="4231" y="4230"/>
                  </a:lnTo>
                  <a:lnTo>
                    <a:pt x="4963" y="3905"/>
                  </a:lnTo>
                  <a:lnTo>
                    <a:pt x="5696" y="3539"/>
                  </a:lnTo>
                  <a:lnTo>
                    <a:pt x="6021" y="3335"/>
                  </a:lnTo>
                  <a:lnTo>
                    <a:pt x="6346" y="3091"/>
                  </a:lnTo>
                  <a:lnTo>
                    <a:pt x="6672" y="2847"/>
                  </a:lnTo>
                  <a:lnTo>
                    <a:pt x="6916" y="2522"/>
                  </a:lnTo>
                  <a:lnTo>
                    <a:pt x="7119" y="2197"/>
                  </a:lnTo>
                  <a:lnTo>
                    <a:pt x="7241" y="1871"/>
                  </a:lnTo>
                  <a:lnTo>
                    <a:pt x="7323" y="1505"/>
                  </a:lnTo>
                  <a:lnTo>
                    <a:pt x="7323" y="1098"/>
                  </a:lnTo>
                  <a:lnTo>
                    <a:pt x="7201" y="732"/>
                  </a:lnTo>
                  <a:lnTo>
                    <a:pt x="7119" y="569"/>
                  </a:lnTo>
                  <a:lnTo>
                    <a:pt x="7038" y="407"/>
                  </a:lnTo>
                  <a:lnTo>
                    <a:pt x="6916" y="285"/>
                  </a:lnTo>
                  <a:lnTo>
                    <a:pt x="6794" y="163"/>
                  </a:lnTo>
                  <a:lnTo>
                    <a:pt x="6631" y="81"/>
                  </a:lnTo>
                  <a:lnTo>
                    <a:pt x="6428" y="41"/>
                  </a:lnTo>
                  <a:lnTo>
                    <a:pt x="622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30" name="Google Shape;130;p14"/>
          <p:cNvSpPr/>
          <p:nvPr/>
        </p:nvSpPr>
        <p:spPr>
          <a:xfrm>
            <a:off x="192328" y="1728397"/>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1" name="Google Shape;131;p14"/>
          <p:cNvSpPr/>
          <p:nvPr/>
        </p:nvSpPr>
        <p:spPr>
          <a:xfrm>
            <a:off x="8779428" y="3574872"/>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2" name="Google Shape;132;p14"/>
          <p:cNvSpPr/>
          <p:nvPr/>
        </p:nvSpPr>
        <p:spPr>
          <a:xfrm>
            <a:off x="353529" y="3868042"/>
            <a:ext cx="85704" cy="85658"/>
          </a:xfrm>
          <a:custGeom>
            <a:rect b="b" l="l" r="r" t="t"/>
            <a:pathLst>
              <a:path extrusionOk="0" h="1872" w="1873">
                <a:moveTo>
                  <a:pt x="733" y="1"/>
                </a:moveTo>
                <a:lnTo>
                  <a:pt x="489" y="82"/>
                </a:lnTo>
                <a:lnTo>
                  <a:pt x="245" y="245"/>
                </a:lnTo>
                <a:lnTo>
                  <a:pt x="82" y="448"/>
                </a:lnTo>
                <a:lnTo>
                  <a:pt x="1" y="692"/>
                </a:lnTo>
                <a:lnTo>
                  <a:pt x="1" y="936"/>
                </a:lnTo>
                <a:lnTo>
                  <a:pt x="42" y="1180"/>
                </a:lnTo>
                <a:lnTo>
                  <a:pt x="123" y="1424"/>
                </a:lnTo>
                <a:lnTo>
                  <a:pt x="245" y="1546"/>
                </a:lnTo>
                <a:lnTo>
                  <a:pt x="367" y="1668"/>
                </a:lnTo>
                <a:lnTo>
                  <a:pt x="489" y="1750"/>
                </a:lnTo>
                <a:lnTo>
                  <a:pt x="611" y="1831"/>
                </a:lnTo>
                <a:lnTo>
                  <a:pt x="774" y="1872"/>
                </a:lnTo>
                <a:lnTo>
                  <a:pt x="1099" y="1872"/>
                </a:lnTo>
                <a:lnTo>
                  <a:pt x="1221" y="1831"/>
                </a:lnTo>
                <a:lnTo>
                  <a:pt x="1384" y="1750"/>
                </a:lnTo>
                <a:lnTo>
                  <a:pt x="1506" y="1668"/>
                </a:lnTo>
                <a:lnTo>
                  <a:pt x="1628" y="1587"/>
                </a:lnTo>
                <a:lnTo>
                  <a:pt x="1750" y="1465"/>
                </a:lnTo>
                <a:lnTo>
                  <a:pt x="1831" y="1302"/>
                </a:lnTo>
                <a:lnTo>
                  <a:pt x="1872" y="1140"/>
                </a:lnTo>
                <a:lnTo>
                  <a:pt x="1872" y="936"/>
                </a:lnTo>
                <a:lnTo>
                  <a:pt x="1831" y="774"/>
                </a:lnTo>
                <a:lnTo>
                  <a:pt x="1791" y="611"/>
                </a:lnTo>
                <a:lnTo>
                  <a:pt x="1750" y="489"/>
                </a:lnTo>
                <a:lnTo>
                  <a:pt x="1628" y="367"/>
                </a:lnTo>
                <a:lnTo>
                  <a:pt x="1547" y="245"/>
                </a:lnTo>
                <a:lnTo>
                  <a:pt x="1262" y="82"/>
                </a:lnTo>
                <a:lnTo>
                  <a:pt x="97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3" name="Google Shape;133;p14"/>
          <p:cNvSpPr/>
          <p:nvPr/>
        </p:nvSpPr>
        <p:spPr>
          <a:xfrm>
            <a:off x="4349721" y="4617688"/>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4" name="Google Shape;134;p14"/>
          <p:cNvSpPr/>
          <p:nvPr/>
        </p:nvSpPr>
        <p:spPr>
          <a:xfrm>
            <a:off x="6850353" y="4772197"/>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5" name="Google Shape;135;p14"/>
          <p:cNvSpPr/>
          <p:nvPr/>
        </p:nvSpPr>
        <p:spPr>
          <a:xfrm>
            <a:off x="2463266" y="4739422"/>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6" name="Google Shape;136;p14"/>
          <p:cNvSpPr txBox="1"/>
          <p:nvPr>
            <p:ph idx="12" type="sldNum"/>
          </p:nvPr>
        </p:nvSpPr>
        <p:spPr>
          <a:xfrm>
            <a:off x="8556784" y="4749851"/>
            <a:ext cx="548700" cy="393600"/>
          </a:xfrm>
          <a:prstGeom prst="rect">
            <a:avLst/>
          </a:prstGeom>
        </p:spPr>
        <p:txBody>
          <a:bodyPr anchorCtr="0" anchor="t"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2">
  <p:cSld name="SECTION_HEADER_2">
    <p:bg>
      <p:bgPr>
        <a:solidFill>
          <a:schemeClr val="dk1"/>
        </a:solidFill>
      </p:bgPr>
    </p:bg>
    <p:spTree>
      <p:nvGrpSpPr>
        <p:cNvPr id="137" name="Shape 137"/>
        <p:cNvGrpSpPr/>
        <p:nvPr/>
      </p:nvGrpSpPr>
      <p:grpSpPr>
        <a:xfrm>
          <a:off x="0" y="0"/>
          <a:ext cx="0" cy="0"/>
          <a:chOff x="0" y="0"/>
          <a:chExt cx="0" cy="0"/>
        </a:xfrm>
      </p:grpSpPr>
      <p:sp>
        <p:nvSpPr>
          <p:cNvPr id="138" name="Google Shape;138;p15"/>
          <p:cNvSpPr txBox="1"/>
          <p:nvPr>
            <p:ph type="title"/>
          </p:nvPr>
        </p:nvSpPr>
        <p:spPr>
          <a:xfrm>
            <a:off x="311700" y="2480550"/>
            <a:ext cx="8114400" cy="2445900"/>
          </a:xfrm>
          <a:prstGeom prst="rect">
            <a:avLst/>
          </a:prstGeom>
        </p:spPr>
        <p:txBody>
          <a:bodyPr anchorCtr="0" anchor="b" bIns="91425" lIns="91425" spcFirstLastPara="1" rIns="91425" wrap="square" tIns="91425">
            <a:normAutofit/>
          </a:bodyPr>
          <a:lstStyle>
            <a:lvl1pPr lvl="0">
              <a:spcBef>
                <a:spcPts val="0"/>
              </a:spcBef>
              <a:spcAft>
                <a:spcPts val="0"/>
              </a:spcAft>
              <a:buClr>
                <a:schemeClr val="lt1"/>
              </a:buClr>
              <a:buSzPts val="6800"/>
              <a:buNone/>
              <a:defRPr sz="6800">
                <a:solidFill>
                  <a:schemeClr val="lt1"/>
                </a:solidFill>
              </a:defRPr>
            </a:lvl1pPr>
            <a:lvl2pPr lvl="1">
              <a:spcBef>
                <a:spcPts val="0"/>
              </a:spcBef>
              <a:spcAft>
                <a:spcPts val="0"/>
              </a:spcAft>
              <a:buClr>
                <a:schemeClr val="lt1"/>
              </a:buClr>
              <a:buSzPts val="6800"/>
              <a:buNone/>
              <a:defRPr sz="6800">
                <a:solidFill>
                  <a:schemeClr val="lt1"/>
                </a:solidFill>
              </a:defRPr>
            </a:lvl2pPr>
            <a:lvl3pPr lvl="2">
              <a:spcBef>
                <a:spcPts val="0"/>
              </a:spcBef>
              <a:spcAft>
                <a:spcPts val="0"/>
              </a:spcAft>
              <a:buClr>
                <a:schemeClr val="lt1"/>
              </a:buClr>
              <a:buSzPts val="6800"/>
              <a:buNone/>
              <a:defRPr sz="6800">
                <a:solidFill>
                  <a:schemeClr val="lt1"/>
                </a:solidFill>
              </a:defRPr>
            </a:lvl3pPr>
            <a:lvl4pPr lvl="3">
              <a:spcBef>
                <a:spcPts val="0"/>
              </a:spcBef>
              <a:spcAft>
                <a:spcPts val="0"/>
              </a:spcAft>
              <a:buClr>
                <a:schemeClr val="lt1"/>
              </a:buClr>
              <a:buSzPts val="6800"/>
              <a:buNone/>
              <a:defRPr sz="6800">
                <a:solidFill>
                  <a:schemeClr val="lt1"/>
                </a:solidFill>
              </a:defRPr>
            </a:lvl4pPr>
            <a:lvl5pPr lvl="4">
              <a:spcBef>
                <a:spcPts val="0"/>
              </a:spcBef>
              <a:spcAft>
                <a:spcPts val="0"/>
              </a:spcAft>
              <a:buClr>
                <a:schemeClr val="lt1"/>
              </a:buClr>
              <a:buSzPts val="6800"/>
              <a:buNone/>
              <a:defRPr sz="6800">
                <a:solidFill>
                  <a:schemeClr val="lt1"/>
                </a:solidFill>
              </a:defRPr>
            </a:lvl5pPr>
            <a:lvl6pPr lvl="5">
              <a:spcBef>
                <a:spcPts val="0"/>
              </a:spcBef>
              <a:spcAft>
                <a:spcPts val="0"/>
              </a:spcAft>
              <a:buClr>
                <a:schemeClr val="lt1"/>
              </a:buClr>
              <a:buSzPts val="6800"/>
              <a:buNone/>
              <a:defRPr sz="6800">
                <a:solidFill>
                  <a:schemeClr val="lt1"/>
                </a:solidFill>
              </a:defRPr>
            </a:lvl6pPr>
            <a:lvl7pPr lvl="6">
              <a:spcBef>
                <a:spcPts val="0"/>
              </a:spcBef>
              <a:spcAft>
                <a:spcPts val="0"/>
              </a:spcAft>
              <a:buClr>
                <a:schemeClr val="lt1"/>
              </a:buClr>
              <a:buSzPts val="6800"/>
              <a:buNone/>
              <a:defRPr sz="6800">
                <a:solidFill>
                  <a:schemeClr val="lt1"/>
                </a:solidFill>
              </a:defRPr>
            </a:lvl7pPr>
            <a:lvl8pPr lvl="7">
              <a:spcBef>
                <a:spcPts val="0"/>
              </a:spcBef>
              <a:spcAft>
                <a:spcPts val="0"/>
              </a:spcAft>
              <a:buClr>
                <a:schemeClr val="lt1"/>
              </a:buClr>
              <a:buSzPts val="6800"/>
              <a:buNone/>
              <a:defRPr sz="6800">
                <a:solidFill>
                  <a:schemeClr val="lt1"/>
                </a:solidFill>
              </a:defRPr>
            </a:lvl8pPr>
            <a:lvl9pPr lvl="8">
              <a:spcBef>
                <a:spcPts val="0"/>
              </a:spcBef>
              <a:spcAft>
                <a:spcPts val="0"/>
              </a:spcAft>
              <a:buClr>
                <a:schemeClr val="lt1"/>
              </a:buClr>
              <a:buSzPts val="6800"/>
              <a:buNone/>
              <a:defRPr sz="6800">
                <a:solidFill>
                  <a:schemeClr val="lt1"/>
                </a:solidFill>
              </a:defRPr>
            </a:lvl9pPr>
          </a:lstStyle>
          <a:p/>
        </p:txBody>
      </p:sp>
      <p:sp>
        <p:nvSpPr>
          <p:cNvPr id="139" name="Google Shape;139;p1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1">
  <p:cSld name="SECTION_TITLE_AND_DESCRIPTION_1">
    <p:spTree>
      <p:nvGrpSpPr>
        <p:cNvPr id="140" name="Shape 140"/>
        <p:cNvGrpSpPr/>
        <p:nvPr/>
      </p:nvGrpSpPr>
      <p:grpSpPr>
        <a:xfrm>
          <a:off x="0" y="0"/>
          <a:ext cx="0" cy="0"/>
          <a:chOff x="0" y="0"/>
          <a:chExt cx="0" cy="0"/>
        </a:xfrm>
      </p:grpSpPr>
      <p:sp>
        <p:nvSpPr>
          <p:cNvPr id="141" name="Google Shape;141;p16"/>
          <p:cNvSpPr/>
          <p:nvPr/>
        </p:nvSpPr>
        <p:spPr>
          <a:xfrm flipH="1">
            <a:off x="4980018" y="1257073"/>
            <a:ext cx="6248884" cy="3591762"/>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2" name="Google Shape;142;p16"/>
          <p:cNvSpPr txBox="1"/>
          <p:nvPr>
            <p:ph idx="1" type="subTitle"/>
          </p:nvPr>
        </p:nvSpPr>
        <p:spPr>
          <a:xfrm>
            <a:off x="4353425" y="2391750"/>
            <a:ext cx="4070700" cy="13224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1900"/>
              <a:buNone/>
              <a:defRPr sz="1500"/>
            </a:lvl1pPr>
            <a:lvl2pPr lvl="1" algn="ctr">
              <a:lnSpc>
                <a:spcPct val="100000"/>
              </a:lnSpc>
              <a:spcBef>
                <a:spcPts val="0"/>
              </a:spcBef>
              <a:spcAft>
                <a:spcPts val="0"/>
              </a:spcAft>
              <a:buSzPts val="1900"/>
              <a:buNone/>
              <a:defRPr sz="1900"/>
            </a:lvl2pPr>
            <a:lvl3pPr lvl="2" algn="ctr">
              <a:lnSpc>
                <a:spcPct val="100000"/>
              </a:lnSpc>
              <a:spcBef>
                <a:spcPts val="0"/>
              </a:spcBef>
              <a:spcAft>
                <a:spcPts val="0"/>
              </a:spcAft>
              <a:buSzPts val="1900"/>
              <a:buNone/>
              <a:defRPr sz="1900"/>
            </a:lvl3pPr>
            <a:lvl4pPr lvl="3" algn="ctr">
              <a:lnSpc>
                <a:spcPct val="100000"/>
              </a:lnSpc>
              <a:spcBef>
                <a:spcPts val="0"/>
              </a:spcBef>
              <a:spcAft>
                <a:spcPts val="0"/>
              </a:spcAft>
              <a:buSzPts val="1900"/>
              <a:buNone/>
              <a:defRPr sz="1900"/>
            </a:lvl4pPr>
            <a:lvl5pPr lvl="4" algn="ctr">
              <a:lnSpc>
                <a:spcPct val="100000"/>
              </a:lnSpc>
              <a:spcBef>
                <a:spcPts val="0"/>
              </a:spcBef>
              <a:spcAft>
                <a:spcPts val="0"/>
              </a:spcAft>
              <a:buSzPts val="1900"/>
              <a:buNone/>
              <a:defRPr sz="1900"/>
            </a:lvl5pPr>
            <a:lvl6pPr lvl="5" algn="ctr">
              <a:lnSpc>
                <a:spcPct val="100000"/>
              </a:lnSpc>
              <a:spcBef>
                <a:spcPts val="0"/>
              </a:spcBef>
              <a:spcAft>
                <a:spcPts val="0"/>
              </a:spcAft>
              <a:buSzPts val="1900"/>
              <a:buNone/>
              <a:defRPr sz="1900"/>
            </a:lvl6pPr>
            <a:lvl7pPr lvl="6" algn="ctr">
              <a:lnSpc>
                <a:spcPct val="100000"/>
              </a:lnSpc>
              <a:spcBef>
                <a:spcPts val="0"/>
              </a:spcBef>
              <a:spcAft>
                <a:spcPts val="0"/>
              </a:spcAft>
              <a:buSzPts val="1900"/>
              <a:buNone/>
              <a:defRPr sz="1900"/>
            </a:lvl7pPr>
            <a:lvl8pPr lvl="7" algn="ctr">
              <a:lnSpc>
                <a:spcPct val="100000"/>
              </a:lnSpc>
              <a:spcBef>
                <a:spcPts val="0"/>
              </a:spcBef>
              <a:spcAft>
                <a:spcPts val="0"/>
              </a:spcAft>
              <a:buSzPts val="1900"/>
              <a:buNone/>
              <a:defRPr sz="1900"/>
            </a:lvl8pPr>
            <a:lvl9pPr lvl="8" algn="ctr">
              <a:lnSpc>
                <a:spcPct val="100000"/>
              </a:lnSpc>
              <a:spcBef>
                <a:spcPts val="0"/>
              </a:spcBef>
              <a:spcAft>
                <a:spcPts val="0"/>
              </a:spcAft>
              <a:buSzPts val="1900"/>
              <a:buNone/>
              <a:defRPr sz="1900"/>
            </a:lvl9pPr>
          </a:lstStyle>
          <a:p/>
        </p:txBody>
      </p:sp>
      <p:sp>
        <p:nvSpPr>
          <p:cNvPr id="143" name="Google Shape;143;p16"/>
          <p:cNvSpPr txBox="1"/>
          <p:nvPr>
            <p:ph type="title"/>
          </p:nvPr>
        </p:nvSpPr>
        <p:spPr>
          <a:xfrm>
            <a:off x="4353450" y="1629175"/>
            <a:ext cx="4070700" cy="629400"/>
          </a:xfrm>
          <a:prstGeom prst="rect">
            <a:avLst/>
          </a:prstGeom>
        </p:spPr>
        <p:txBody>
          <a:bodyPr anchorCtr="0" anchor="t" bIns="91425" lIns="91425" spcFirstLastPara="1" rIns="91425" wrap="square" tIns="91425">
            <a:normAutofit/>
          </a:bodyPr>
          <a:lstStyle>
            <a:lvl1pPr lvl="0" algn="ctr">
              <a:spcBef>
                <a:spcPts val="0"/>
              </a:spcBef>
              <a:spcAft>
                <a:spcPts val="0"/>
              </a:spcAft>
              <a:buSzPts val="3900"/>
              <a:buNone/>
              <a:defRPr sz="4200"/>
            </a:lvl1pPr>
            <a:lvl2pPr lvl="1">
              <a:spcBef>
                <a:spcPts val="0"/>
              </a:spcBef>
              <a:spcAft>
                <a:spcPts val="0"/>
              </a:spcAft>
              <a:buSzPts val="3900"/>
              <a:buNone/>
              <a:defRPr sz="3900"/>
            </a:lvl2pPr>
            <a:lvl3pPr lvl="2">
              <a:spcBef>
                <a:spcPts val="0"/>
              </a:spcBef>
              <a:spcAft>
                <a:spcPts val="0"/>
              </a:spcAft>
              <a:buSzPts val="3900"/>
              <a:buNone/>
              <a:defRPr sz="3900"/>
            </a:lvl3pPr>
            <a:lvl4pPr lvl="3">
              <a:spcBef>
                <a:spcPts val="0"/>
              </a:spcBef>
              <a:spcAft>
                <a:spcPts val="0"/>
              </a:spcAft>
              <a:buSzPts val="3900"/>
              <a:buNone/>
              <a:defRPr sz="3900"/>
            </a:lvl4pPr>
            <a:lvl5pPr lvl="4">
              <a:spcBef>
                <a:spcPts val="0"/>
              </a:spcBef>
              <a:spcAft>
                <a:spcPts val="0"/>
              </a:spcAft>
              <a:buSzPts val="3900"/>
              <a:buNone/>
              <a:defRPr sz="3900"/>
            </a:lvl5pPr>
            <a:lvl6pPr lvl="5">
              <a:spcBef>
                <a:spcPts val="0"/>
              </a:spcBef>
              <a:spcAft>
                <a:spcPts val="0"/>
              </a:spcAft>
              <a:buSzPts val="3900"/>
              <a:buNone/>
              <a:defRPr sz="3900"/>
            </a:lvl6pPr>
            <a:lvl7pPr lvl="6">
              <a:spcBef>
                <a:spcPts val="0"/>
              </a:spcBef>
              <a:spcAft>
                <a:spcPts val="0"/>
              </a:spcAft>
              <a:buSzPts val="3900"/>
              <a:buNone/>
              <a:defRPr sz="3900"/>
            </a:lvl7pPr>
            <a:lvl8pPr lvl="7">
              <a:spcBef>
                <a:spcPts val="0"/>
              </a:spcBef>
              <a:spcAft>
                <a:spcPts val="0"/>
              </a:spcAft>
              <a:buSzPts val="3900"/>
              <a:buNone/>
              <a:defRPr sz="3900"/>
            </a:lvl8pPr>
            <a:lvl9pPr lvl="8">
              <a:spcBef>
                <a:spcPts val="0"/>
              </a:spcBef>
              <a:spcAft>
                <a:spcPts val="0"/>
              </a:spcAft>
              <a:buSzPts val="3900"/>
              <a:buNone/>
              <a:defRPr sz="3900"/>
            </a:lvl9pPr>
          </a:lstStyle>
          <a:p/>
        </p:txBody>
      </p:sp>
      <p:sp>
        <p:nvSpPr>
          <p:cNvPr id="144" name="Google Shape;144;p16"/>
          <p:cNvSpPr/>
          <p:nvPr/>
        </p:nvSpPr>
        <p:spPr>
          <a:xfrm flipH="1">
            <a:off x="-1801179" y="3473499"/>
            <a:ext cx="5171118" cy="2972279"/>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5" name="Google Shape;145;p16"/>
          <p:cNvSpPr/>
          <p:nvPr/>
        </p:nvSpPr>
        <p:spPr>
          <a:xfrm flipH="1">
            <a:off x="3543498" y="552738"/>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46" name="Google Shape;146;p16"/>
          <p:cNvGrpSpPr/>
          <p:nvPr/>
        </p:nvGrpSpPr>
        <p:grpSpPr>
          <a:xfrm flipH="1">
            <a:off x="4505376" y="672834"/>
            <a:ext cx="474643" cy="301588"/>
            <a:chOff x="7593894" y="395296"/>
            <a:chExt cx="474643" cy="301588"/>
          </a:xfrm>
        </p:grpSpPr>
        <p:sp>
          <p:nvSpPr>
            <p:cNvPr id="147" name="Google Shape;147;p16"/>
            <p:cNvSpPr/>
            <p:nvPr/>
          </p:nvSpPr>
          <p:spPr>
            <a:xfrm>
              <a:off x="7603183" y="404585"/>
              <a:ext cx="456065" cy="282964"/>
            </a:xfrm>
            <a:custGeom>
              <a:rect b="b" l="l" r="r" t="t"/>
              <a:pathLst>
                <a:path extrusionOk="0" h="6184" w="9967">
                  <a:moveTo>
                    <a:pt x="4678" y="1"/>
                  </a:moveTo>
                  <a:lnTo>
                    <a:pt x="4394" y="42"/>
                  </a:lnTo>
                  <a:lnTo>
                    <a:pt x="4109" y="164"/>
                  </a:lnTo>
                  <a:lnTo>
                    <a:pt x="3824" y="286"/>
                  </a:lnTo>
                  <a:lnTo>
                    <a:pt x="3540" y="448"/>
                  </a:lnTo>
                  <a:lnTo>
                    <a:pt x="3336" y="692"/>
                  </a:lnTo>
                  <a:lnTo>
                    <a:pt x="3133" y="936"/>
                  </a:lnTo>
                  <a:lnTo>
                    <a:pt x="2970" y="1181"/>
                  </a:lnTo>
                  <a:lnTo>
                    <a:pt x="2848" y="1465"/>
                  </a:lnTo>
                  <a:lnTo>
                    <a:pt x="2767" y="1750"/>
                  </a:lnTo>
                  <a:lnTo>
                    <a:pt x="2685" y="2075"/>
                  </a:lnTo>
                  <a:lnTo>
                    <a:pt x="2645" y="2360"/>
                  </a:lnTo>
                  <a:lnTo>
                    <a:pt x="2645" y="2686"/>
                  </a:lnTo>
                  <a:lnTo>
                    <a:pt x="2685" y="3011"/>
                  </a:lnTo>
                  <a:lnTo>
                    <a:pt x="2441" y="2848"/>
                  </a:lnTo>
                  <a:lnTo>
                    <a:pt x="2197" y="2767"/>
                  </a:lnTo>
                  <a:lnTo>
                    <a:pt x="1953" y="2686"/>
                  </a:lnTo>
                  <a:lnTo>
                    <a:pt x="1424" y="2686"/>
                  </a:lnTo>
                  <a:lnTo>
                    <a:pt x="1180" y="2767"/>
                  </a:lnTo>
                  <a:lnTo>
                    <a:pt x="936" y="2848"/>
                  </a:lnTo>
                  <a:lnTo>
                    <a:pt x="692" y="2970"/>
                  </a:lnTo>
                  <a:lnTo>
                    <a:pt x="570" y="3092"/>
                  </a:lnTo>
                  <a:lnTo>
                    <a:pt x="407" y="3214"/>
                  </a:lnTo>
                  <a:lnTo>
                    <a:pt x="204" y="3540"/>
                  </a:lnTo>
                  <a:lnTo>
                    <a:pt x="41" y="3906"/>
                  </a:lnTo>
                  <a:lnTo>
                    <a:pt x="1" y="4272"/>
                  </a:lnTo>
                  <a:lnTo>
                    <a:pt x="1" y="4679"/>
                  </a:lnTo>
                  <a:lnTo>
                    <a:pt x="82" y="5045"/>
                  </a:lnTo>
                  <a:lnTo>
                    <a:pt x="285" y="5370"/>
                  </a:lnTo>
                  <a:lnTo>
                    <a:pt x="407" y="5533"/>
                  </a:lnTo>
                  <a:lnTo>
                    <a:pt x="529" y="5655"/>
                  </a:lnTo>
                  <a:lnTo>
                    <a:pt x="814" y="5858"/>
                  </a:lnTo>
                  <a:lnTo>
                    <a:pt x="1180" y="6021"/>
                  </a:lnTo>
                  <a:lnTo>
                    <a:pt x="1587" y="6102"/>
                  </a:lnTo>
                  <a:lnTo>
                    <a:pt x="1994" y="6143"/>
                  </a:lnTo>
                  <a:lnTo>
                    <a:pt x="2848" y="6184"/>
                  </a:lnTo>
                  <a:lnTo>
                    <a:pt x="3580" y="6143"/>
                  </a:lnTo>
                  <a:lnTo>
                    <a:pt x="4678" y="6143"/>
                  </a:lnTo>
                  <a:lnTo>
                    <a:pt x="5736" y="6102"/>
                  </a:lnTo>
                  <a:lnTo>
                    <a:pt x="6834" y="6021"/>
                  </a:lnTo>
                  <a:lnTo>
                    <a:pt x="7892" y="5899"/>
                  </a:lnTo>
                  <a:lnTo>
                    <a:pt x="8543" y="5818"/>
                  </a:lnTo>
                  <a:lnTo>
                    <a:pt x="8868" y="5736"/>
                  </a:lnTo>
                  <a:lnTo>
                    <a:pt x="9153" y="5614"/>
                  </a:lnTo>
                  <a:lnTo>
                    <a:pt x="9438" y="5452"/>
                  </a:lnTo>
                  <a:lnTo>
                    <a:pt x="9682" y="5248"/>
                  </a:lnTo>
                  <a:lnTo>
                    <a:pt x="9844" y="5045"/>
                  </a:lnTo>
                  <a:lnTo>
                    <a:pt x="9926" y="4760"/>
                  </a:lnTo>
                  <a:lnTo>
                    <a:pt x="9966" y="4557"/>
                  </a:lnTo>
                  <a:lnTo>
                    <a:pt x="9966" y="4353"/>
                  </a:lnTo>
                  <a:lnTo>
                    <a:pt x="9885" y="4150"/>
                  </a:lnTo>
                  <a:lnTo>
                    <a:pt x="9804" y="3946"/>
                  </a:lnTo>
                  <a:lnTo>
                    <a:pt x="9682" y="3784"/>
                  </a:lnTo>
                  <a:lnTo>
                    <a:pt x="9560" y="3662"/>
                  </a:lnTo>
                  <a:lnTo>
                    <a:pt x="9397" y="3499"/>
                  </a:lnTo>
                  <a:lnTo>
                    <a:pt x="9234" y="3418"/>
                  </a:lnTo>
                  <a:lnTo>
                    <a:pt x="9031" y="3336"/>
                  </a:lnTo>
                  <a:lnTo>
                    <a:pt x="8827" y="3296"/>
                  </a:lnTo>
                  <a:lnTo>
                    <a:pt x="8421" y="3296"/>
                  </a:lnTo>
                  <a:lnTo>
                    <a:pt x="8014" y="3418"/>
                  </a:lnTo>
                  <a:lnTo>
                    <a:pt x="7648" y="3580"/>
                  </a:lnTo>
                  <a:lnTo>
                    <a:pt x="7729" y="3458"/>
                  </a:lnTo>
                  <a:lnTo>
                    <a:pt x="7770" y="3296"/>
                  </a:lnTo>
                  <a:lnTo>
                    <a:pt x="7811" y="3011"/>
                  </a:lnTo>
                  <a:lnTo>
                    <a:pt x="7729" y="2726"/>
                  </a:lnTo>
                  <a:lnTo>
                    <a:pt x="7648" y="2564"/>
                  </a:lnTo>
                  <a:lnTo>
                    <a:pt x="7566" y="2441"/>
                  </a:lnTo>
                  <a:lnTo>
                    <a:pt x="7444" y="2360"/>
                  </a:lnTo>
                  <a:lnTo>
                    <a:pt x="7322" y="2279"/>
                  </a:lnTo>
                  <a:lnTo>
                    <a:pt x="7038" y="2157"/>
                  </a:lnTo>
                  <a:lnTo>
                    <a:pt x="6590" y="2157"/>
                  </a:lnTo>
                  <a:lnTo>
                    <a:pt x="6428" y="2197"/>
                  </a:lnTo>
                  <a:lnTo>
                    <a:pt x="6550" y="1913"/>
                  </a:lnTo>
                  <a:lnTo>
                    <a:pt x="6550" y="1628"/>
                  </a:lnTo>
                  <a:lnTo>
                    <a:pt x="6550" y="1303"/>
                  </a:lnTo>
                  <a:lnTo>
                    <a:pt x="6428" y="1018"/>
                  </a:lnTo>
                  <a:lnTo>
                    <a:pt x="6306" y="733"/>
                  </a:lnTo>
                  <a:lnTo>
                    <a:pt x="6102" y="489"/>
                  </a:lnTo>
                  <a:lnTo>
                    <a:pt x="5858" y="286"/>
                  </a:lnTo>
                  <a:lnTo>
                    <a:pt x="5614" y="164"/>
                  </a:lnTo>
                  <a:lnTo>
                    <a:pt x="5289" y="42"/>
                  </a:lnTo>
                  <a:lnTo>
                    <a:pt x="50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8" name="Google Shape;148;p16"/>
            <p:cNvSpPr/>
            <p:nvPr/>
          </p:nvSpPr>
          <p:spPr>
            <a:xfrm>
              <a:off x="7593894" y="395296"/>
              <a:ext cx="474643" cy="301588"/>
            </a:xfrm>
            <a:custGeom>
              <a:rect b="b" l="l" r="r" t="t"/>
              <a:pathLst>
                <a:path extrusionOk="0" h="6591" w="10373">
                  <a:moveTo>
                    <a:pt x="5329" y="407"/>
                  </a:moveTo>
                  <a:lnTo>
                    <a:pt x="5532" y="448"/>
                  </a:lnTo>
                  <a:lnTo>
                    <a:pt x="5695" y="529"/>
                  </a:lnTo>
                  <a:lnTo>
                    <a:pt x="5858" y="611"/>
                  </a:lnTo>
                  <a:lnTo>
                    <a:pt x="6020" y="733"/>
                  </a:lnTo>
                  <a:lnTo>
                    <a:pt x="6183" y="855"/>
                  </a:lnTo>
                  <a:lnTo>
                    <a:pt x="6305" y="1017"/>
                  </a:lnTo>
                  <a:lnTo>
                    <a:pt x="6386" y="1180"/>
                  </a:lnTo>
                  <a:lnTo>
                    <a:pt x="6468" y="1384"/>
                  </a:lnTo>
                  <a:lnTo>
                    <a:pt x="6549" y="1546"/>
                  </a:lnTo>
                  <a:lnTo>
                    <a:pt x="6549" y="1750"/>
                  </a:lnTo>
                  <a:lnTo>
                    <a:pt x="6549" y="1953"/>
                  </a:lnTo>
                  <a:lnTo>
                    <a:pt x="6549" y="2116"/>
                  </a:lnTo>
                  <a:lnTo>
                    <a:pt x="6468" y="2319"/>
                  </a:lnTo>
                  <a:lnTo>
                    <a:pt x="6468" y="2441"/>
                  </a:lnTo>
                  <a:lnTo>
                    <a:pt x="6509" y="2522"/>
                  </a:lnTo>
                  <a:lnTo>
                    <a:pt x="6590" y="2604"/>
                  </a:lnTo>
                  <a:lnTo>
                    <a:pt x="6712" y="2604"/>
                  </a:lnTo>
                  <a:lnTo>
                    <a:pt x="6956" y="2563"/>
                  </a:lnTo>
                  <a:lnTo>
                    <a:pt x="7200" y="2563"/>
                  </a:lnTo>
                  <a:lnTo>
                    <a:pt x="7403" y="2644"/>
                  </a:lnTo>
                  <a:lnTo>
                    <a:pt x="7607" y="2807"/>
                  </a:lnTo>
                  <a:lnTo>
                    <a:pt x="7729" y="2970"/>
                  </a:lnTo>
                  <a:lnTo>
                    <a:pt x="7810" y="3214"/>
                  </a:lnTo>
                  <a:lnTo>
                    <a:pt x="7769" y="3458"/>
                  </a:lnTo>
                  <a:lnTo>
                    <a:pt x="7688" y="3702"/>
                  </a:lnTo>
                  <a:lnTo>
                    <a:pt x="7647" y="3783"/>
                  </a:lnTo>
                  <a:lnTo>
                    <a:pt x="7647" y="3824"/>
                  </a:lnTo>
                  <a:lnTo>
                    <a:pt x="7729" y="3946"/>
                  </a:lnTo>
                  <a:lnTo>
                    <a:pt x="7851" y="3987"/>
                  </a:lnTo>
                  <a:lnTo>
                    <a:pt x="7973" y="3987"/>
                  </a:lnTo>
                  <a:lnTo>
                    <a:pt x="8298" y="3824"/>
                  </a:lnTo>
                  <a:lnTo>
                    <a:pt x="8624" y="3702"/>
                  </a:lnTo>
                  <a:lnTo>
                    <a:pt x="8990" y="3702"/>
                  </a:lnTo>
                  <a:lnTo>
                    <a:pt x="9152" y="3743"/>
                  </a:lnTo>
                  <a:lnTo>
                    <a:pt x="9356" y="3824"/>
                  </a:lnTo>
                  <a:lnTo>
                    <a:pt x="9478" y="3865"/>
                  </a:lnTo>
                  <a:lnTo>
                    <a:pt x="9641" y="3987"/>
                  </a:lnTo>
                  <a:lnTo>
                    <a:pt x="9722" y="4109"/>
                  </a:lnTo>
                  <a:lnTo>
                    <a:pt x="9844" y="4231"/>
                  </a:lnTo>
                  <a:lnTo>
                    <a:pt x="9925" y="4394"/>
                  </a:lnTo>
                  <a:lnTo>
                    <a:pt x="9966" y="4556"/>
                  </a:lnTo>
                  <a:lnTo>
                    <a:pt x="9966" y="4719"/>
                  </a:lnTo>
                  <a:lnTo>
                    <a:pt x="9966" y="4882"/>
                  </a:lnTo>
                  <a:lnTo>
                    <a:pt x="9844" y="5166"/>
                  </a:lnTo>
                  <a:lnTo>
                    <a:pt x="9681" y="5370"/>
                  </a:lnTo>
                  <a:lnTo>
                    <a:pt x="9478" y="5532"/>
                  </a:lnTo>
                  <a:lnTo>
                    <a:pt x="9193" y="5655"/>
                  </a:lnTo>
                  <a:lnTo>
                    <a:pt x="8949" y="5777"/>
                  </a:lnTo>
                  <a:lnTo>
                    <a:pt x="8624" y="5858"/>
                  </a:lnTo>
                  <a:lnTo>
                    <a:pt x="8095" y="5939"/>
                  </a:lnTo>
                  <a:lnTo>
                    <a:pt x="8014" y="5939"/>
                  </a:lnTo>
                  <a:lnTo>
                    <a:pt x="8005" y="5947"/>
                  </a:lnTo>
                  <a:lnTo>
                    <a:pt x="8005" y="5947"/>
                  </a:lnTo>
                  <a:lnTo>
                    <a:pt x="6753" y="6061"/>
                  </a:lnTo>
                  <a:lnTo>
                    <a:pt x="5410" y="6143"/>
                  </a:lnTo>
                  <a:lnTo>
                    <a:pt x="4068" y="6183"/>
                  </a:lnTo>
                  <a:lnTo>
                    <a:pt x="2685" y="6183"/>
                  </a:lnTo>
                  <a:lnTo>
                    <a:pt x="2197" y="6143"/>
                  </a:lnTo>
                  <a:lnTo>
                    <a:pt x="1668" y="6102"/>
                  </a:lnTo>
                  <a:lnTo>
                    <a:pt x="1424" y="6021"/>
                  </a:lnTo>
                  <a:lnTo>
                    <a:pt x="1180" y="5939"/>
                  </a:lnTo>
                  <a:lnTo>
                    <a:pt x="977" y="5817"/>
                  </a:lnTo>
                  <a:lnTo>
                    <a:pt x="773" y="5655"/>
                  </a:lnTo>
                  <a:lnTo>
                    <a:pt x="610" y="5451"/>
                  </a:lnTo>
                  <a:lnTo>
                    <a:pt x="529" y="5248"/>
                  </a:lnTo>
                  <a:lnTo>
                    <a:pt x="448" y="5004"/>
                  </a:lnTo>
                  <a:lnTo>
                    <a:pt x="407" y="4800"/>
                  </a:lnTo>
                  <a:lnTo>
                    <a:pt x="407" y="4556"/>
                  </a:lnTo>
                  <a:lnTo>
                    <a:pt x="407" y="4312"/>
                  </a:lnTo>
                  <a:lnTo>
                    <a:pt x="488" y="4068"/>
                  </a:lnTo>
                  <a:lnTo>
                    <a:pt x="570" y="3865"/>
                  </a:lnTo>
                  <a:lnTo>
                    <a:pt x="773" y="3580"/>
                  </a:lnTo>
                  <a:lnTo>
                    <a:pt x="1017" y="3377"/>
                  </a:lnTo>
                  <a:lnTo>
                    <a:pt x="1261" y="3214"/>
                  </a:lnTo>
                  <a:lnTo>
                    <a:pt x="1587" y="3133"/>
                  </a:lnTo>
                  <a:lnTo>
                    <a:pt x="1871" y="3092"/>
                  </a:lnTo>
                  <a:lnTo>
                    <a:pt x="2197" y="3133"/>
                  </a:lnTo>
                  <a:lnTo>
                    <a:pt x="2482" y="3214"/>
                  </a:lnTo>
                  <a:lnTo>
                    <a:pt x="2766" y="3377"/>
                  </a:lnTo>
                  <a:lnTo>
                    <a:pt x="2970" y="3377"/>
                  </a:lnTo>
                  <a:lnTo>
                    <a:pt x="3051" y="3295"/>
                  </a:lnTo>
                  <a:lnTo>
                    <a:pt x="3092" y="3214"/>
                  </a:lnTo>
                  <a:lnTo>
                    <a:pt x="3051" y="2767"/>
                  </a:lnTo>
                  <a:lnTo>
                    <a:pt x="3092" y="2319"/>
                  </a:lnTo>
                  <a:lnTo>
                    <a:pt x="3214" y="1872"/>
                  </a:lnTo>
                  <a:lnTo>
                    <a:pt x="3376" y="1465"/>
                  </a:lnTo>
                  <a:lnTo>
                    <a:pt x="3621" y="1099"/>
                  </a:lnTo>
                  <a:lnTo>
                    <a:pt x="3905" y="814"/>
                  </a:lnTo>
                  <a:lnTo>
                    <a:pt x="4068" y="692"/>
                  </a:lnTo>
                  <a:lnTo>
                    <a:pt x="4271" y="570"/>
                  </a:lnTo>
                  <a:lnTo>
                    <a:pt x="4475" y="489"/>
                  </a:lnTo>
                  <a:lnTo>
                    <a:pt x="4719" y="448"/>
                  </a:lnTo>
                  <a:lnTo>
                    <a:pt x="5126" y="407"/>
                  </a:lnTo>
                  <a:close/>
                  <a:moveTo>
                    <a:pt x="4881" y="1"/>
                  </a:moveTo>
                  <a:lnTo>
                    <a:pt x="4597" y="41"/>
                  </a:lnTo>
                  <a:lnTo>
                    <a:pt x="4312" y="123"/>
                  </a:lnTo>
                  <a:lnTo>
                    <a:pt x="4068" y="245"/>
                  </a:lnTo>
                  <a:lnTo>
                    <a:pt x="3865" y="367"/>
                  </a:lnTo>
                  <a:lnTo>
                    <a:pt x="3621" y="529"/>
                  </a:lnTo>
                  <a:lnTo>
                    <a:pt x="3458" y="692"/>
                  </a:lnTo>
                  <a:lnTo>
                    <a:pt x="3254" y="895"/>
                  </a:lnTo>
                  <a:lnTo>
                    <a:pt x="3132" y="1099"/>
                  </a:lnTo>
                  <a:lnTo>
                    <a:pt x="3010" y="1343"/>
                  </a:lnTo>
                  <a:lnTo>
                    <a:pt x="2888" y="1587"/>
                  </a:lnTo>
                  <a:lnTo>
                    <a:pt x="2726" y="2116"/>
                  </a:lnTo>
                  <a:lnTo>
                    <a:pt x="2644" y="2644"/>
                  </a:lnTo>
                  <a:lnTo>
                    <a:pt x="2661" y="2878"/>
                  </a:lnTo>
                  <a:lnTo>
                    <a:pt x="2661" y="2878"/>
                  </a:lnTo>
                  <a:lnTo>
                    <a:pt x="2400" y="2767"/>
                  </a:lnTo>
                  <a:lnTo>
                    <a:pt x="2115" y="2685"/>
                  </a:lnTo>
                  <a:lnTo>
                    <a:pt x="1790" y="2685"/>
                  </a:lnTo>
                  <a:lnTo>
                    <a:pt x="1465" y="2726"/>
                  </a:lnTo>
                  <a:lnTo>
                    <a:pt x="1180" y="2807"/>
                  </a:lnTo>
                  <a:lnTo>
                    <a:pt x="895" y="2970"/>
                  </a:lnTo>
                  <a:lnTo>
                    <a:pt x="610" y="3133"/>
                  </a:lnTo>
                  <a:lnTo>
                    <a:pt x="448" y="3336"/>
                  </a:lnTo>
                  <a:lnTo>
                    <a:pt x="285" y="3580"/>
                  </a:lnTo>
                  <a:lnTo>
                    <a:pt x="163" y="3824"/>
                  </a:lnTo>
                  <a:lnTo>
                    <a:pt x="82" y="4068"/>
                  </a:lnTo>
                  <a:lnTo>
                    <a:pt x="0" y="4353"/>
                  </a:lnTo>
                  <a:lnTo>
                    <a:pt x="0" y="4597"/>
                  </a:lnTo>
                  <a:lnTo>
                    <a:pt x="0" y="4882"/>
                  </a:lnTo>
                  <a:lnTo>
                    <a:pt x="41" y="5166"/>
                  </a:lnTo>
                  <a:lnTo>
                    <a:pt x="163" y="5451"/>
                  </a:lnTo>
                  <a:lnTo>
                    <a:pt x="326" y="5695"/>
                  </a:lnTo>
                  <a:lnTo>
                    <a:pt x="488" y="5939"/>
                  </a:lnTo>
                  <a:lnTo>
                    <a:pt x="692" y="6102"/>
                  </a:lnTo>
                  <a:lnTo>
                    <a:pt x="936" y="6224"/>
                  </a:lnTo>
                  <a:lnTo>
                    <a:pt x="1180" y="6346"/>
                  </a:lnTo>
                  <a:lnTo>
                    <a:pt x="1465" y="6427"/>
                  </a:lnTo>
                  <a:lnTo>
                    <a:pt x="1749" y="6509"/>
                  </a:lnTo>
                  <a:lnTo>
                    <a:pt x="2360" y="6590"/>
                  </a:lnTo>
                  <a:lnTo>
                    <a:pt x="2970" y="6590"/>
                  </a:lnTo>
                  <a:lnTo>
                    <a:pt x="4149" y="6549"/>
                  </a:lnTo>
                  <a:lnTo>
                    <a:pt x="6102" y="6468"/>
                  </a:lnTo>
                  <a:lnTo>
                    <a:pt x="8095" y="6305"/>
                  </a:lnTo>
                  <a:lnTo>
                    <a:pt x="8176" y="6305"/>
                  </a:lnTo>
                  <a:lnTo>
                    <a:pt x="8186" y="6295"/>
                  </a:lnTo>
                  <a:lnTo>
                    <a:pt x="8186" y="6295"/>
                  </a:lnTo>
                  <a:lnTo>
                    <a:pt x="8461" y="6265"/>
                  </a:lnTo>
                  <a:lnTo>
                    <a:pt x="8827" y="6183"/>
                  </a:lnTo>
                  <a:lnTo>
                    <a:pt x="9234" y="6061"/>
                  </a:lnTo>
                  <a:lnTo>
                    <a:pt x="9559" y="5939"/>
                  </a:lnTo>
                  <a:lnTo>
                    <a:pt x="9885" y="5736"/>
                  </a:lnTo>
                  <a:lnTo>
                    <a:pt x="10007" y="5614"/>
                  </a:lnTo>
                  <a:lnTo>
                    <a:pt x="10129" y="5451"/>
                  </a:lnTo>
                  <a:lnTo>
                    <a:pt x="10251" y="5288"/>
                  </a:lnTo>
                  <a:lnTo>
                    <a:pt x="10291" y="5126"/>
                  </a:lnTo>
                  <a:lnTo>
                    <a:pt x="10373" y="4922"/>
                  </a:lnTo>
                  <a:lnTo>
                    <a:pt x="10373" y="4719"/>
                  </a:lnTo>
                  <a:lnTo>
                    <a:pt x="10373" y="4516"/>
                  </a:lnTo>
                  <a:lnTo>
                    <a:pt x="10291" y="4353"/>
                  </a:lnTo>
                  <a:lnTo>
                    <a:pt x="10251" y="4149"/>
                  </a:lnTo>
                  <a:lnTo>
                    <a:pt x="10129" y="3987"/>
                  </a:lnTo>
                  <a:lnTo>
                    <a:pt x="10007" y="3824"/>
                  </a:lnTo>
                  <a:lnTo>
                    <a:pt x="9844" y="3661"/>
                  </a:lnTo>
                  <a:lnTo>
                    <a:pt x="9681" y="3539"/>
                  </a:lnTo>
                  <a:lnTo>
                    <a:pt x="9519" y="3458"/>
                  </a:lnTo>
                  <a:lnTo>
                    <a:pt x="9315" y="3377"/>
                  </a:lnTo>
                  <a:lnTo>
                    <a:pt x="9071" y="3336"/>
                  </a:lnTo>
                  <a:lnTo>
                    <a:pt x="8868" y="3295"/>
                  </a:lnTo>
                  <a:lnTo>
                    <a:pt x="8624" y="3336"/>
                  </a:lnTo>
                  <a:lnTo>
                    <a:pt x="8380" y="3377"/>
                  </a:lnTo>
                  <a:lnTo>
                    <a:pt x="8176" y="3417"/>
                  </a:lnTo>
                  <a:lnTo>
                    <a:pt x="8176" y="3377"/>
                  </a:lnTo>
                  <a:lnTo>
                    <a:pt x="8176" y="3173"/>
                  </a:lnTo>
                  <a:lnTo>
                    <a:pt x="8176" y="3011"/>
                  </a:lnTo>
                  <a:lnTo>
                    <a:pt x="8095" y="2848"/>
                  </a:lnTo>
                  <a:lnTo>
                    <a:pt x="8014" y="2685"/>
                  </a:lnTo>
                  <a:lnTo>
                    <a:pt x="7891" y="2522"/>
                  </a:lnTo>
                  <a:lnTo>
                    <a:pt x="7769" y="2400"/>
                  </a:lnTo>
                  <a:lnTo>
                    <a:pt x="7647" y="2278"/>
                  </a:lnTo>
                  <a:lnTo>
                    <a:pt x="7485" y="2238"/>
                  </a:lnTo>
                  <a:lnTo>
                    <a:pt x="7281" y="2156"/>
                  </a:lnTo>
                  <a:lnTo>
                    <a:pt x="6940" y="2156"/>
                  </a:lnTo>
                  <a:lnTo>
                    <a:pt x="6956" y="2075"/>
                  </a:lnTo>
                  <a:lnTo>
                    <a:pt x="6956" y="1831"/>
                  </a:lnTo>
                  <a:lnTo>
                    <a:pt x="6956" y="1587"/>
                  </a:lnTo>
                  <a:lnTo>
                    <a:pt x="6915" y="1384"/>
                  </a:lnTo>
                  <a:lnTo>
                    <a:pt x="6834" y="1139"/>
                  </a:lnTo>
                  <a:lnTo>
                    <a:pt x="6712" y="936"/>
                  </a:lnTo>
                  <a:lnTo>
                    <a:pt x="6590" y="733"/>
                  </a:lnTo>
                  <a:lnTo>
                    <a:pt x="6427" y="529"/>
                  </a:lnTo>
                  <a:lnTo>
                    <a:pt x="6224" y="367"/>
                  </a:lnTo>
                  <a:lnTo>
                    <a:pt x="6061" y="245"/>
                  </a:lnTo>
                  <a:lnTo>
                    <a:pt x="5817" y="163"/>
                  </a:lnTo>
                  <a:lnTo>
                    <a:pt x="5614" y="82"/>
                  </a:lnTo>
                  <a:lnTo>
                    <a:pt x="5370" y="41"/>
                  </a:lnTo>
                  <a:lnTo>
                    <a:pt x="5126"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149" name="Google Shape;149;p16"/>
          <p:cNvGrpSpPr/>
          <p:nvPr/>
        </p:nvGrpSpPr>
        <p:grpSpPr>
          <a:xfrm flipH="1">
            <a:off x="4295452" y="4470667"/>
            <a:ext cx="474643" cy="299712"/>
            <a:chOff x="7729218" y="1694205"/>
            <a:chExt cx="474643" cy="299712"/>
          </a:xfrm>
        </p:grpSpPr>
        <p:sp>
          <p:nvSpPr>
            <p:cNvPr id="150" name="Google Shape;150;p16"/>
            <p:cNvSpPr/>
            <p:nvPr/>
          </p:nvSpPr>
          <p:spPr>
            <a:xfrm>
              <a:off x="7738507" y="1703494"/>
              <a:ext cx="456065" cy="281088"/>
            </a:xfrm>
            <a:custGeom>
              <a:rect b="b" l="l" r="r" t="t"/>
              <a:pathLst>
                <a:path extrusionOk="0" h="6143" w="9967">
                  <a:moveTo>
                    <a:pt x="4963" y="1"/>
                  </a:moveTo>
                  <a:lnTo>
                    <a:pt x="4638" y="41"/>
                  </a:lnTo>
                  <a:lnTo>
                    <a:pt x="4353" y="123"/>
                  </a:lnTo>
                  <a:lnTo>
                    <a:pt x="4068" y="286"/>
                  </a:lnTo>
                  <a:lnTo>
                    <a:pt x="3865" y="489"/>
                  </a:lnTo>
                  <a:lnTo>
                    <a:pt x="3661" y="733"/>
                  </a:lnTo>
                  <a:lnTo>
                    <a:pt x="3499" y="1018"/>
                  </a:lnTo>
                  <a:lnTo>
                    <a:pt x="3417" y="1302"/>
                  </a:lnTo>
                  <a:lnTo>
                    <a:pt x="3377" y="1587"/>
                  </a:lnTo>
                  <a:lnTo>
                    <a:pt x="3417" y="1913"/>
                  </a:lnTo>
                  <a:lnTo>
                    <a:pt x="3499" y="2197"/>
                  </a:lnTo>
                  <a:lnTo>
                    <a:pt x="3377" y="2157"/>
                  </a:lnTo>
                  <a:lnTo>
                    <a:pt x="3214" y="2116"/>
                  </a:lnTo>
                  <a:lnTo>
                    <a:pt x="2929" y="2157"/>
                  </a:lnTo>
                  <a:lnTo>
                    <a:pt x="2645" y="2238"/>
                  </a:lnTo>
                  <a:lnTo>
                    <a:pt x="2482" y="2319"/>
                  </a:lnTo>
                  <a:lnTo>
                    <a:pt x="2400" y="2441"/>
                  </a:lnTo>
                  <a:lnTo>
                    <a:pt x="2319" y="2563"/>
                  </a:lnTo>
                  <a:lnTo>
                    <a:pt x="2238" y="2685"/>
                  </a:lnTo>
                  <a:lnTo>
                    <a:pt x="2156" y="3011"/>
                  </a:lnTo>
                  <a:lnTo>
                    <a:pt x="2197" y="3296"/>
                  </a:lnTo>
                  <a:lnTo>
                    <a:pt x="2238" y="3458"/>
                  </a:lnTo>
                  <a:lnTo>
                    <a:pt x="2278" y="3580"/>
                  </a:lnTo>
                  <a:lnTo>
                    <a:pt x="1912" y="3377"/>
                  </a:lnTo>
                  <a:lnTo>
                    <a:pt x="1546" y="3296"/>
                  </a:lnTo>
                  <a:lnTo>
                    <a:pt x="1140" y="3296"/>
                  </a:lnTo>
                  <a:lnTo>
                    <a:pt x="936" y="3336"/>
                  </a:lnTo>
                  <a:lnTo>
                    <a:pt x="733" y="3418"/>
                  </a:lnTo>
                  <a:lnTo>
                    <a:pt x="570" y="3499"/>
                  </a:lnTo>
                  <a:lnTo>
                    <a:pt x="407" y="3621"/>
                  </a:lnTo>
                  <a:lnTo>
                    <a:pt x="245" y="3784"/>
                  </a:lnTo>
                  <a:lnTo>
                    <a:pt x="123" y="3946"/>
                  </a:lnTo>
                  <a:lnTo>
                    <a:pt x="41" y="4109"/>
                  </a:lnTo>
                  <a:lnTo>
                    <a:pt x="1" y="4312"/>
                  </a:lnTo>
                  <a:lnTo>
                    <a:pt x="1" y="4516"/>
                  </a:lnTo>
                  <a:lnTo>
                    <a:pt x="1" y="4719"/>
                  </a:lnTo>
                  <a:lnTo>
                    <a:pt x="123" y="5004"/>
                  </a:lnTo>
                  <a:lnTo>
                    <a:pt x="285" y="5248"/>
                  </a:lnTo>
                  <a:lnTo>
                    <a:pt x="529" y="5451"/>
                  </a:lnTo>
                  <a:lnTo>
                    <a:pt x="773" y="5573"/>
                  </a:lnTo>
                  <a:lnTo>
                    <a:pt x="1099" y="5695"/>
                  </a:lnTo>
                  <a:lnTo>
                    <a:pt x="1424" y="5777"/>
                  </a:lnTo>
                  <a:lnTo>
                    <a:pt x="2075" y="5899"/>
                  </a:lnTo>
                  <a:lnTo>
                    <a:pt x="3133" y="5980"/>
                  </a:lnTo>
                  <a:lnTo>
                    <a:pt x="4231" y="6062"/>
                  </a:lnTo>
                  <a:lnTo>
                    <a:pt x="5288" y="6102"/>
                  </a:lnTo>
                  <a:lnTo>
                    <a:pt x="6387" y="6143"/>
                  </a:lnTo>
                  <a:lnTo>
                    <a:pt x="7973" y="6143"/>
                  </a:lnTo>
                  <a:lnTo>
                    <a:pt x="8380" y="6062"/>
                  </a:lnTo>
                  <a:lnTo>
                    <a:pt x="8787" y="5980"/>
                  </a:lnTo>
                  <a:lnTo>
                    <a:pt x="9112" y="5858"/>
                  </a:lnTo>
                  <a:lnTo>
                    <a:pt x="9437" y="5655"/>
                  </a:lnTo>
                  <a:lnTo>
                    <a:pt x="9559" y="5533"/>
                  </a:lnTo>
                  <a:lnTo>
                    <a:pt x="9682" y="5370"/>
                  </a:lnTo>
                  <a:lnTo>
                    <a:pt x="9844" y="5004"/>
                  </a:lnTo>
                  <a:lnTo>
                    <a:pt x="9966" y="4638"/>
                  </a:lnTo>
                  <a:lnTo>
                    <a:pt x="9966" y="4272"/>
                  </a:lnTo>
                  <a:lnTo>
                    <a:pt x="9885" y="3865"/>
                  </a:lnTo>
                  <a:lnTo>
                    <a:pt x="9763" y="3540"/>
                  </a:lnTo>
                  <a:lnTo>
                    <a:pt x="9519" y="3214"/>
                  </a:lnTo>
                  <a:lnTo>
                    <a:pt x="9397" y="3092"/>
                  </a:lnTo>
                  <a:lnTo>
                    <a:pt x="9234" y="2970"/>
                  </a:lnTo>
                  <a:lnTo>
                    <a:pt x="9031" y="2807"/>
                  </a:lnTo>
                  <a:lnTo>
                    <a:pt x="8787" y="2726"/>
                  </a:lnTo>
                  <a:lnTo>
                    <a:pt x="8502" y="2685"/>
                  </a:lnTo>
                  <a:lnTo>
                    <a:pt x="8014" y="2685"/>
                  </a:lnTo>
                  <a:lnTo>
                    <a:pt x="7729" y="2726"/>
                  </a:lnTo>
                  <a:lnTo>
                    <a:pt x="7485" y="2848"/>
                  </a:lnTo>
                  <a:lnTo>
                    <a:pt x="7282" y="2970"/>
                  </a:lnTo>
                  <a:lnTo>
                    <a:pt x="7322" y="2685"/>
                  </a:lnTo>
                  <a:lnTo>
                    <a:pt x="7322" y="2360"/>
                  </a:lnTo>
                  <a:lnTo>
                    <a:pt x="7282" y="2035"/>
                  </a:lnTo>
                  <a:lnTo>
                    <a:pt x="7200" y="1750"/>
                  </a:lnTo>
                  <a:lnTo>
                    <a:pt x="7119" y="1424"/>
                  </a:lnTo>
                  <a:lnTo>
                    <a:pt x="6997" y="1180"/>
                  </a:lnTo>
                  <a:lnTo>
                    <a:pt x="6834" y="896"/>
                  </a:lnTo>
                  <a:lnTo>
                    <a:pt x="6631" y="652"/>
                  </a:lnTo>
                  <a:lnTo>
                    <a:pt x="6387" y="448"/>
                  </a:lnTo>
                  <a:lnTo>
                    <a:pt x="6143" y="286"/>
                  </a:lnTo>
                  <a:lnTo>
                    <a:pt x="5858" y="123"/>
                  </a:lnTo>
                  <a:lnTo>
                    <a:pt x="5573" y="41"/>
                  </a:lnTo>
                  <a:lnTo>
                    <a:pt x="5248"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1" name="Google Shape;151;p16"/>
            <p:cNvSpPr/>
            <p:nvPr/>
          </p:nvSpPr>
          <p:spPr>
            <a:xfrm>
              <a:off x="7729218" y="1694205"/>
              <a:ext cx="474643" cy="299712"/>
            </a:xfrm>
            <a:custGeom>
              <a:rect b="b" l="l" r="r" t="t"/>
              <a:pathLst>
                <a:path extrusionOk="0" h="6550" w="10373">
                  <a:moveTo>
                    <a:pt x="5451" y="366"/>
                  </a:moveTo>
                  <a:lnTo>
                    <a:pt x="5654" y="407"/>
                  </a:lnTo>
                  <a:lnTo>
                    <a:pt x="5858" y="489"/>
                  </a:lnTo>
                  <a:lnTo>
                    <a:pt x="6102" y="570"/>
                  </a:lnTo>
                  <a:lnTo>
                    <a:pt x="6264" y="651"/>
                  </a:lnTo>
                  <a:lnTo>
                    <a:pt x="6468" y="814"/>
                  </a:lnTo>
                  <a:lnTo>
                    <a:pt x="6752" y="1099"/>
                  </a:lnTo>
                  <a:lnTo>
                    <a:pt x="6996" y="1465"/>
                  </a:lnTo>
                  <a:lnTo>
                    <a:pt x="7159" y="1871"/>
                  </a:lnTo>
                  <a:lnTo>
                    <a:pt x="7281" y="2278"/>
                  </a:lnTo>
                  <a:lnTo>
                    <a:pt x="7322" y="2726"/>
                  </a:lnTo>
                  <a:lnTo>
                    <a:pt x="7281" y="3173"/>
                  </a:lnTo>
                  <a:lnTo>
                    <a:pt x="7322" y="3295"/>
                  </a:lnTo>
                  <a:lnTo>
                    <a:pt x="7363" y="3336"/>
                  </a:lnTo>
                  <a:lnTo>
                    <a:pt x="7485" y="3377"/>
                  </a:lnTo>
                  <a:lnTo>
                    <a:pt x="7566" y="3336"/>
                  </a:lnTo>
                  <a:lnTo>
                    <a:pt x="7851" y="3214"/>
                  </a:lnTo>
                  <a:lnTo>
                    <a:pt x="8095" y="3132"/>
                  </a:lnTo>
                  <a:lnTo>
                    <a:pt x="8379" y="3092"/>
                  </a:lnTo>
                  <a:lnTo>
                    <a:pt x="8664" y="3092"/>
                  </a:lnTo>
                  <a:lnTo>
                    <a:pt x="8949" y="3132"/>
                  </a:lnTo>
                  <a:lnTo>
                    <a:pt x="9193" y="3254"/>
                  </a:lnTo>
                  <a:lnTo>
                    <a:pt x="9437" y="3417"/>
                  </a:lnTo>
                  <a:lnTo>
                    <a:pt x="9640" y="3621"/>
                  </a:lnTo>
                  <a:lnTo>
                    <a:pt x="9762" y="3824"/>
                  </a:lnTo>
                  <a:lnTo>
                    <a:pt x="9885" y="4027"/>
                  </a:lnTo>
                  <a:lnTo>
                    <a:pt x="9925" y="4271"/>
                  </a:lnTo>
                  <a:lnTo>
                    <a:pt x="9966" y="4515"/>
                  </a:lnTo>
                  <a:lnTo>
                    <a:pt x="9966" y="4759"/>
                  </a:lnTo>
                  <a:lnTo>
                    <a:pt x="9925" y="5004"/>
                  </a:lnTo>
                  <a:lnTo>
                    <a:pt x="9844" y="5207"/>
                  </a:lnTo>
                  <a:lnTo>
                    <a:pt x="9762" y="5410"/>
                  </a:lnTo>
                  <a:lnTo>
                    <a:pt x="9600" y="5614"/>
                  </a:lnTo>
                  <a:lnTo>
                    <a:pt x="9396" y="5776"/>
                  </a:lnTo>
                  <a:lnTo>
                    <a:pt x="9193" y="5898"/>
                  </a:lnTo>
                  <a:lnTo>
                    <a:pt x="8949" y="5980"/>
                  </a:lnTo>
                  <a:lnTo>
                    <a:pt x="8461" y="6102"/>
                  </a:lnTo>
                  <a:lnTo>
                    <a:pt x="7932" y="6142"/>
                  </a:lnTo>
                  <a:lnTo>
                    <a:pt x="5654" y="6142"/>
                  </a:lnTo>
                  <a:lnTo>
                    <a:pt x="3946" y="6061"/>
                  </a:lnTo>
                  <a:lnTo>
                    <a:pt x="2278" y="5898"/>
                  </a:lnTo>
                  <a:lnTo>
                    <a:pt x="1709" y="5817"/>
                  </a:lnTo>
                  <a:lnTo>
                    <a:pt x="1424" y="5736"/>
                  </a:lnTo>
                  <a:lnTo>
                    <a:pt x="1139" y="5654"/>
                  </a:lnTo>
                  <a:lnTo>
                    <a:pt x="895" y="5532"/>
                  </a:lnTo>
                  <a:lnTo>
                    <a:pt x="651" y="5370"/>
                  </a:lnTo>
                  <a:lnTo>
                    <a:pt x="488" y="5126"/>
                  </a:lnTo>
                  <a:lnTo>
                    <a:pt x="407" y="4882"/>
                  </a:lnTo>
                  <a:lnTo>
                    <a:pt x="407" y="4719"/>
                  </a:lnTo>
                  <a:lnTo>
                    <a:pt x="407" y="4556"/>
                  </a:lnTo>
                  <a:lnTo>
                    <a:pt x="448" y="4393"/>
                  </a:lnTo>
                  <a:lnTo>
                    <a:pt x="529" y="4231"/>
                  </a:lnTo>
                  <a:lnTo>
                    <a:pt x="732" y="3987"/>
                  </a:lnTo>
                  <a:lnTo>
                    <a:pt x="976" y="3824"/>
                  </a:lnTo>
                  <a:lnTo>
                    <a:pt x="1139" y="3743"/>
                  </a:lnTo>
                  <a:lnTo>
                    <a:pt x="1343" y="3702"/>
                  </a:lnTo>
                  <a:lnTo>
                    <a:pt x="1709" y="3702"/>
                  </a:lnTo>
                  <a:lnTo>
                    <a:pt x="2075" y="3783"/>
                  </a:lnTo>
                  <a:lnTo>
                    <a:pt x="2400" y="3946"/>
                  </a:lnTo>
                  <a:lnTo>
                    <a:pt x="2481" y="3987"/>
                  </a:lnTo>
                  <a:lnTo>
                    <a:pt x="2522" y="3987"/>
                  </a:lnTo>
                  <a:lnTo>
                    <a:pt x="2644" y="3905"/>
                  </a:lnTo>
                  <a:lnTo>
                    <a:pt x="2685" y="3824"/>
                  </a:lnTo>
                  <a:lnTo>
                    <a:pt x="2685" y="3743"/>
                  </a:lnTo>
                  <a:lnTo>
                    <a:pt x="2685" y="3661"/>
                  </a:lnTo>
                  <a:lnTo>
                    <a:pt x="2563" y="3417"/>
                  </a:lnTo>
                  <a:lnTo>
                    <a:pt x="2563" y="3173"/>
                  </a:lnTo>
                  <a:lnTo>
                    <a:pt x="2644" y="2970"/>
                  </a:lnTo>
                  <a:lnTo>
                    <a:pt x="2766" y="2766"/>
                  </a:lnTo>
                  <a:lnTo>
                    <a:pt x="2929" y="2644"/>
                  </a:lnTo>
                  <a:lnTo>
                    <a:pt x="3173" y="2563"/>
                  </a:lnTo>
                  <a:lnTo>
                    <a:pt x="3417" y="2522"/>
                  </a:lnTo>
                  <a:lnTo>
                    <a:pt x="3661" y="2604"/>
                  </a:lnTo>
                  <a:lnTo>
                    <a:pt x="3783" y="2604"/>
                  </a:lnTo>
                  <a:lnTo>
                    <a:pt x="3864" y="2522"/>
                  </a:lnTo>
                  <a:lnTo>
                    <a:pt x="3905" y="2400"/>
                  </a:lnTo>
                  <a:lnTo>
                    <a:pt x="3864" y="2278"/>
                  </a:lnTo>
                  <a:lnTo>
                    <a:pt x="3824" y="2116"/>
                  </a:lnTo>
                  <a:lnTo>
                    <a:pt x="3783" y="1912"/>
                  </a:lnTo>
                  <a:lnTo>
                    <a:pt x="3783" y="1749"/>
                  </a:lnTo>
                  <a:lnTo>
                    <a:pt x="3824" y="1546"/>
                  </a:lnTo>
                  <a:lnTo>
                    <a:pt x="3864" y="1383"/>
                  </a:lnTo>
                  <a:lnTo>
                    <a:pt x="3946" y="1180"/>
                  </a:lnTo>
                  <a:lnTo>
                    <a:pt x="4149" y="895"/>
                  </a:lnTo>
                  <a:lnTo>
                    <a:pt x="4312" y="733"/>
                  </a:lnTo>
                  <a:lnTo>
                    <a:pt x="4475" y="611"/>
                  </a:lnTo>
                  <a:lnTo>
                    <a:pt x="4637" y="529"/>
                  </a:lnTo>
                  <a:lnTo>
                    <a:pt x="4841" y="448"/>
                  </a:lnTo>
                  <a:lnTo>
                    <a:pt x="5044" y="407"/>
                  </a:lnTo>
                  <a:lnTo>
                    <a:pt x="5247" y="366"/>
                  </a:lnTo>
                  <a:close/>
                  <a:moveTo>
                    <a:pt x="5003" y="0"/>
                  </a:moveTo>
                  <a:lnTo>
                    <a:pt x="4759" y="41"/>
                  </a:lnTo>
                  <a:lnTo>
                    <a:pt x="4515" y="122"/>
                  </a:lnTo>
                  <a:lnTo>
                    <a:pt x="4312" y="244"/>
                  </a:lnTo>
                  <a:lnTo>
                    <a:pt x="4108" y="366"/>
                  </a:lnTo>
                  <a:lnTo>
                    <a:pt x="3946" y="529"/>
                  </a:lnTo>
                  <a:lnTo>
                    <a:pt x="3783" y="692"/>
                  </a:lnTo>
                  <a:lnTo>
                    <a:pt x="3661" y="895"/>
                  </a:lnTo>
                  <a:lnTo>
                    <a:pt x="3539" y="1139"/>
                  </a:lnTo>
                  <a:lnTo>
                    <a:pt x="3458" y="1343"/>
                  </a:lnTo>
                  <a:lnTo>
                    <a:pt x="3417" y="1587"/>
                  </a:lnTo>
                  <a:lnTo>
                    <a:pt x="3417" y="1790"/>
                  </a:lnTo>
                  <a:lnTo>
                    <a:pt x="3417" y="2034"/>
                  </a:lnTo>
                  <a:lnTo>
                    <a:pt x="3431" y="2119"/>
                  </a:lnTo>
                  <a:lnTo>
                    <a:pt x="3431" y="2119"/>
                  </a:lnTo>
                  <a:lnTo>
                    <a:pt x="3417" y="2116"/>
                  </a:lnTo>
                  <a:lnTo>
                    <a:pt x="3254" y="2116"/>
                  </a:lnTo>
                  <a:lnTo>
                    <a:pt x="3051" y="2156"/>
                  </a:lnTo>
                  <a:lnTo>
                    <a:pt x="2888" y="2197"/>
                  </a:lnTo>
                  <a:lnTo>
                    <a:pt x="2725" y="2278"/>
                  </a:lnTo>
                  <a:lnTo>
                    <a:pt x="2603" y="2360"/>
                  </a:lnTo>
                  <a:lnTo>
                    <a:pt x="2441" y="2482"/>
                  </a:lnTo>
                  <a:lnTo>
                    <a:pt x="2359" y="2644"/>
                  </a:lnTo>
                  <a:lnTo>
                    <a:pt x="2237" y="2807"/>
                  </a:lnTo>
                  <a:lnTo>
                    <a:pt x="2197" y="2970"/>
                  </a:lnTo>
                  <a:lnTo>
                    <a:pt x="2156" y="3173"/>
                  </a:lnTo>
                  <a:lnTo>
                    <a:pt x="2156" y="3336"/>
                  </a:lnTo>
                  <a:lnTo>
                    <a:pt x="2170" y="3407"/>
                  </a:lnTo>
                  <a:lnTo>
                    <a:pt x="1993" y="3336"/>
                  </a:lnTo>
                  <a:lnTo>
                    <a:pt x="1749" y="3295"/>
                  </a:lnTo>
                  <a:lnTo>
                    <a:pt x="1302" y="3295"/>
                  </a:lnTo>
                  <a:lnTo>
                    <a:pt x="1098" y="3336"/>
                  </a:lnTo>
                  <a:lnTo>
                    <a:pt x="854" y="3417"/>
                  </a:lnTo>
                  <a:lnTo>
                    <a:pt x="692" y="3499"/>
                  </a:lnTo>
                  <a:lnTo>
                    <a:pt x="529" y="3621"/>
                  </a:lnTo>
                  <a:lnTo>
                    <a:pt x="366" y="3783"/>
                  </a:lnTo>
                  <a:lnTo>
                    <a:pt x="244" y="3946"/>
                  </a:lnTo>
                  <a:lnTo>
                    <a:pt x="122" y="4109"/>
                  </a:lnTo>
                  <a:lnTo>
                    <a:pt x="41" y="4312"/>
                  </a:lnTo>
                  <a:lnTo>
                    <a:pt x="0" y="4515"/>
                  </a:lnTo>
                  <a:lnTo>
                    <a:pt x="0" y="4719"/>
                  </a:lnTo>
                  <a:lnTo>
                    <a:pt x="0" y="4922"/>
                  </a:lnTo>
                  <a:lnTo>
                    <a:pt x="41" y="5126"/>
                  </a:lnTo>
                  <a:lnTo>
                    <a:pt x="122" y="5288"/>
                  </a:lnTo>
                  <a:lnTo>
                    <a:pt x="204" y="5451"/>
                  </a:lnTo>
                  <a:lnTo>
                    <a:pt x="488" y="5695"/>
                  </a:lnTo>
                  <a:lnTo>
                    <a:pt x="773" y="5898"/>
                  </a:lnTo>
                  <a:lnTo>
                    <a:pt x="1139" y="6061"/>
                  </a:lnTo>
                  <a:lnTo>
                    <a:pt x="1505" y="6183"/>
                  </a:lnTo>
                  <a:lnTo>
                    <a:pt x="1912" y="6265"/>
                  </a:lnTo>
                  <a:lnTo>
                    <a:pt x="2278" y="6305"/>
                  </a:lnTo>
                  <a:lnTo>
                    <a:pt x="4027" y="6427"/>
                  </a:lnTo>
                  <a:lnTo>
                    <a:pt x="5776" y="6509"/>
                  </a:lnTo>
                  <a:lnTo>
                    <a:pt x="7119" y="6549"/>
                  </a:lnTo>
                  <a:lnTo>
                    <a:pt x="7769" y="6549"/>
                  </a:lnTo>
                  <a:lnTo>
                    <a:pt x="8420" y="6509"/>
                  </a:lnTo>
                  <a:lnTo>
                    <a:pt x="8990" y="6387"/>
                  </a:lnTo>
                  <a:lnTo>
                    <a:pt x="9234" y="6305"/>
                  </a:lnTo>
                  <a:lnTo>
                    <a:pt x="9478" y="6183"/>
                  </a:lnTo>
                  <a:lnTo>
                    <a:pt x="9722" y="6020"/>
                  </a:lnTo>
                  <a:lnTo>
                    <a:pt x="9925" y="5858"/>
                  </a:lnTo>
                  <a:lnTo>
                    <a:pt x="10088" y="5654"/>
                  </a:lnTo>
                  <a:lnTo>
                    <a:pt x="10210" y="5370"/>
                  </a:lnTo>
                  <a:lnTo>
                    <a:pt x="10291" y="5126"/>
                  </a:lnTo>
                  <a:lnTo>
                    <a:pt x="10373" y="4882"/>
                  </a:lnTo>
                  <a:lnTo>
                    <a:pt x="10373" y="4597"/>
                  </a:lnTo>
                  <a:lnTo>
                    <a:pt x="10332" y="4312"/>
                  </a:lnTo>
                  <a:lnTo>
                    <a:pt x="10291" y="4068"/>
                  </a:lnTo>
                  <a:lnTo>
                    <a:pt x="10210" y="3783"/>
                  </a:lnTo>
                  <a:lnTo>
                    <a:pt x="10088" y="3539"/>
                  </a:lnTo>
                  <a:lnTo>
                    <a:pt x="9925" y="3336"/>
                  </a:lnTo>
                  <a:lnTo>
                    <a:pt x="9681" y="3092"/>
                  </a:lnTo>
                  <a:lnTo>
                    <a:pt x="9396" y="2888"/>
                  </a:lnTo>
                  <a:lnTo>
                    <a:pt x="9071" y="2766"/>
                  </a:lnTo>
                  <a:lnTo>
                    <a:pt x="8705" y="2685"/>
                  </a:lnTo>
                  <a:lnTo>
                    <a:pt x="8379" y="2685"/>
                  </a:lnTo>
                  <a:lnTo>
                    <a:pt x="8013" y="2726"/>
                  </a:lnTo>
                  <a:lnTo>
                    <a:pt x="7688" y="2848"/>
                  </a:lnTo>
                  <a:lnTo>
                    <a:pt x="7688" y="2644"/>
                  </a:lnTo>
                  <a:lnTo>
                    <a:pt x="7647" y="2075"/>
                  </a:lnTo>
                  <a:lnTo>
                    <a:pt x="7485" y="1587"/>
                  </a:lnTo>
                  <a:lnTo>
                    <a:pt x="7363" y="1343"/>
                  </a:lnTo>
                  <a:lnTo>
                    <a:pt x="7241" y="1099"/>
                  </a:lnTo>
                  <a:lnTo>
                    <a:pt x="7078" y="895"/>
                  </a:lnTo>
                  <a:lnTo>
                    <a:pt x="6915" y="692"/>
                  </a:lnTo>
                  <a:lnTo>
                    <a:pt x="6712" y="489"/>
                  </a:lnTo>
                  <a:lnTo>
                    <a:pt x="6508" y="366"/>
                  </a:lnTo>
                  <a:lnTo>
                    <a:pt x="6264" y="204"/>
                  </a:lnTo>
                  <a:lnTo>
                    <a:pt x="6020" y="122"/>
                  </a:lnTo>
                  <a:lnTo>
                    <a:pt x="5776" y="41"/>
                  </a:lnTo>
                  <a:lnTo>
                    <a:pt x="5491" y="0"/>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52" name="Google Shape;152;p16"/>
          <p:cNvSpPr/>
          <p:nvPr/>
        </p:nvSpPr>
        <p:spPr>
          <a:xfrm flipH="1">
            <a:off x="741543" y="587172"/>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3" name="Google Shape;153;p16"/>
          <p:cNvSpPr/>
          <p:nvPr/>
        </p:nvSpPr>
        <p:spPr>
          <a:xfrm flipH="1">
            <a:off x="497936" y="1629163"/>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54" name="Google Shape;154;p16"/>
          <p:cNvGrpSpPr/>
          <p:nvPr/>
        </p:nvGrpSpPr>
        <p:grpSpPr>
          <a:xfrm flipH="1" rot="5400000">
            <a:off x="7605726" y="-1041792"/>
            <a:ext cx="1915490" cy="2459786"/>
            <a:chOff x="2659350" y="1746500"/>
            <a:chExt cx="379350" cy="487125"/>
          </a:xfrm>
        </p:grpSpPr>
        <p:sp>
          <p:nvSpPr>
            <p:cNvPr id="155" name="Google Shape;155;p16"/>
            <p:cNvSpPr/>
            <p:nvPr/>
          </p:nvSpPr>
          <p:spPr>
            <a:xfrm>
              <a:off x="2659350" y="1746500"/>
              <a:ext cx="379350" cy="487125"/>
            </a:xfrm>
            <a:custGeom>
              <a:rect b="b" l="l" r="r" t="t"/>
              <a:pathLst>
                <a:path extrusionOk="0" h="19485" w="15174">
                  <a:moveTo>
                    <a:pt x="14116" y="1"/>
                  </a:moveTo>
                  <a:lnTo>
                    <a:pt x="14034" y="42"/>
                  </a:lnTo>
                  <a:lnTo>
                    <a:pt x="13261" y="774"/>
                  </a:lnTo>
                  <a:lnTo>
                    <a:pt x="12448" y="1465"/>
                  </a:lnTo>
                  <a:lnTo>
                    <a:pt x="11634" y="2116"/>
                  </a:lnTo>
                  <a:lnTo>
                    <a:pt x="10821" y="2767"/>
                  </a:lnTo>
                  <a:lnTo>
                    <a:pt x="9112" y="4028"/>
                  </a:lnTo>
                  <a:lnTo>
                    <a:pt x="7404" y="5248"/>
                  </a:lnTo>
                  <a:lnTo>
                    <a:pt x="5899" y="6428"/>
                  </a:lnTo>
                  <a:lnTo>
                    <a:pt x="5167" y="7079"/>
                  </a:lnTo>
                  <a:lnTo>
                    <a:pt x="4435" y="7729"/>
                  </a:lnTo>
                  <a:lnTo>
                    <a:pt x="3743" y="8380"/>
                  </a:lnTo>
                  <a:lnTo>
                    <a:pt x="3133" y="9072"/>
                  </a:lnTo>
                  <a:lnTo>
                    <a:pt x="2482" y="9844"/>
                  </a:lnTo>
                  <a:lnTo>
                    <a:pt x="1953" y="10617"/>
                  </a:lnTo>
                  <a:lnTo>
                    <a:pt x="1425" y="11390"/>
                  </a:lnTo>
                  <a:lnTo>
                    <a:pt x="1018" y="12204"/>
                  </a:lnTo>
                  <a:lnTo>
                    <a:pt x="652" y="13058"/>
                  </a:lnTo>
                  <a:lnTo>
                    <a:pt x="326" y="13912"/>
                  </a:lnTo>
                  <a:lnTo>
                    <a:pt x="123" y="14766"/>
                  </a:lnTo>
                  <a:lnTo>
                    <a:pt x="82" y="15173"/>
                  </a:lnTo>
                  <a:lnTo>
                    <a:pt x="42" y="15620"/>
                  </a:lnTo>
                  <a:lnTo>
                    <a:pt x="1" y="16068"/>
                  </a:lnTo>
                  <a:lnTo>
                    <a:pt x="42" y="16475"/>
                  </a:lnTo>
                  <a:lnTo>
                    <a:pt x="82" y="16922"/>
                  </a:lnTo>
                  <a:lnTo>
                    <a:pt x="164" y="17329"/>
                  </a:lnTo>
                  <a:lnTo>
                    <a:pt x="326" y="17736"/>
                  </a:lnTo>
                  <a:lnTo>
                    <a:pt x="489" y="18102"/>
                  </a:lnTo>
                  <a:lnTo>
                    <a:pt x="733" y="18468"/>
                  </a:lnTo>
                  <a:lnTo>
                    <a:pt x="977" y="18753"/>
                  </a:lnTo>
                  <a:lnTo>
                    <a:pt x="1303" y="18997"/>
                  </a:lnTo>
                  <a:lnTo>
                    <a:pt x="1669" y="19200"/>
                  </a:lnTo>
                  <a:lnTo>
                    <a:pt x="2035" y="19363"/>
                  </a:lnTo>
                  <a:lnTo>
                    <a:pt x="2442" y="19444"/>
                  </a:lnTo>
                  <a:lnTo>
                    <a:pt x="2930" y="19485"/>
                  </a:lnTo>
                  <a:lnTo>
                    <a:pt x="3418" y="19485"/>
                  </a:lnTo>
                  <a:lnTo>
                    <a:pt x="3906" y="19444"/>
                  </a:lnTo>
                  <a:lnTo>
                    <a:pt x="4394" y="19363"/>
                  </a:lnTo>
                  <a:lnTo>
                    <a:pt x="5370" y="19159"/>
                  </a:lnTo>
                  <a:lnTo>
                    <a:pt x="6306" y="18915"/>
                  </a:lnTo>
                  <a:lnTo>
                    <a:pt x="7323" y="18631"/>
                  </a:lnTo>
                  <a:lnTo>
                    <a:pt x="8340" y="18305"/>
                  </a:lnTo>
                  <a:lnTo>
                    <a:pt x="9356" y="17980"/>
                  </a:lnTo>
                  <a:lnTo>
                    <a:pt x="10333" y="17614"/>
                  </a:lnTo>
                  <a:lnTo>
                    <a:pt x="11309" y="17166"/>
                  </a:lnTo>
                  <a:lnTo>
                    <a:pt x="12285" y="16719"/>
                  </a:lnTo>
                  <a:lnTo>
                    <a:pt x="13221" y="16271"/>
                  </a:lnTo>
                  <a:lnTo>
                    <a:pt x="14156" y="15743"/>
                  </a:lnTo>
                  <a:lnTo>
                    <a:pt x="15051" y="15214"/>
                  </a:lnTo>
                  <a:lnTo>
                    <a:pt x="15132" y="15173"/>
                  </a:lnTo>
                  <a:lnTo>
                    <a:pt x="15173" y="15092"/>
                  </a:lnTo>
                  <a:lnTo>
                    <a:pt x="15173" y="15051"/>
                  </a:lnTo>
                  <a:lnTo>
                    <a:pt x="15132" y="14970"/>
                  </a:lnTo>
                  <a:lnTo>
                    <a:pt x="15092" y="14929"/>
                  </a:lnTo>
                  <a:lnTo>
                    <a:pt x="15010" y="14888"/>
                  </a:lnTo>
                  <a:lnTo>
                    <a:pt x="14888" y="14888"/>
                  </a:lnTo>
                  <a:lnTo>
                    <a:pt x="13994" y="15417"/>
                  </a:lnTo>
                  <a:lnTo>
                    <a:pt x="13099" y="15905"/>
                  </a:lnTo>
                  <a:lnTo>
                    <a:pt x="12163" y="16393"/>
                  </a:lnTo>
                  <a:lnTo>
                    <a:pt x="11228" y="16800"/>
                  </a:lnTo>
                  <a:lnTo>
                    <a:pt x="10292" y="17207"/>
                  </a:lnTo>
                  <a:lnTo>
                    <a:pt x="9316" y="17573"/>
                  </a:lnTo>
                  <a:lnTo>
                    <a:pt x="8340" y="17939"/>
                  </a:lnTo>
                  <a:lnTo>
                    <a:pt x="7363" y="18224"/>
                  </a:lnTo>
                  <a:lnTo>
                    <a:pt x="6387" y="18508"/>
                  </a:lnTo>
                  <a:lnTo>
                    <a:pt x="5452" y="18753"/>
                  </a:lnTo>
                  <a:lnTo>
                    <a:pt x="4475" y="18956"/>
                  </a:lnTo>
                  <a:lnTo>
                    <a:pt x="3987" y="19037"/>
                  </a:lnTo>
                  <a:lnTo>
                    <a:pt x="3499" y="19119"/>
                  </a:lnTo>
                  <a:lnTo>
                    <a:pt x="3052" y="19119"/>
                  </a:lnTo>
                  <a:lnTo>
                    <a:pt x="2604" y="19078"/>
                  </a:lnTo>
                  <a:lnTo>
                    <a:pt x="2157" y="18997"/>
                  </a:lnTo>
                  <a:lnTo>
                    <a:pt x="1750" y="18834"/>
                  </a:lnTo>
                  <a:lnTo>
                    <a:pt x="1425" y="18631"/>
                  </a:lnTo>
                  <a:lnTo>
                    <a:pt x="1140" y="18386"/>
                  </a:lnTo>
                  <a:lnTo>
                    <a:pt x="896" y="18061"/>
                  </a:lnTo>
                  <a:lnTo>
                    <a:pt x="692" y="17695"/>
                  </a:lnTo>
                  <a:lnTo>
                    <a:pt x="530" y="17329"/>
                  </a:lnTo>
                  <a:lnTo>
                    <a:pt x="448" y="16922"/>
                  </a:lnTo>
                  <a:lnTo>
                    <a:pt x="408" y="16475"/>
                  </a:lnTo>
                  <a:lnTo>
                    <a:pt x="367" y="16068"/>
                  </a:lnTo>
                  <a:lnTo>
                    <a:pt x="408" y="15661"/>
                  </a:lnTo>
                  <a:lnTo>
                    <a:pt x="448" y="15214"/>
                  </a:lnTo>
                  <a:lnTo>
                    <a:pt x="611" y="14400"/>
                  </a:lnTo>
                  <a:lnTo>
                    <a:pt x="855" y="13546"/>
                  </a:lnTo>
                  <a:lnTo>
                    <a:pt x="1181" y="12732"/>
                  </a:lnTo>
                  <a:lnTo>
                    <a:pt x="1587" y="11919"/>
                  </a:lnTo>
                  <a:lnTo>
                    <a:pt x="2035" y="11146"/>
                  </a:lnTo>
                  <a:lnTo>
                    <a:pt x="2564" y="10373"/>
                  </a:lnTo>
                  <a:lnTo>
                    <a:pt x="3133" y="9641"/>
                  </a:lnTo>
                  <a:lnTo>
                    <a:pt x="3743" y="8950"/>
                  </a:lnTo>
                  <a:lnTo>
                    <a:pt x="4394" y="8299"/>
                  </a:lnTo>
                  <a:lnTo>
                    <a:pt x="5045" y="7648"/>
                  </a:lnTo>
                  <a:lnTo>
                    <a:pt x="5736" y="7038"/>
                  </a:lnTo>
                  <a:lnTo>
                    <a:pt x="6468" y="6428"/>
                  </a:lnTo>
                  <a:lnTo>
                    <a:pt x="7201" y="5858"/>
                  </a:lnTo>
                  <a:lnTo>
                    <a:pt x="9031" y="4557"/>
                  </a:lnTo>
                  <a:lnTo>
                    <a:pt x="10821" y="3214"/>
                  </a:lnTo>
                  <a:lnTo>
                    <a:pt x="11756" y="2523"/>
                  </a:lnTo>
                  <a:lnTo>
                    <a:pt x="12611" y="1831"/>
                  </a:lnTo>
                  <a:lnTo>
                    <a:pt x="13465" y="1058"/>
                  </a:lnTo>
                  <a:lnTo>
                    <a:pt x="14278" y="286"/>
                  </a:lnTo>
                  <a:lnTo>
                    <a:pt x="14319" y="245"/>
                  </a:lnTo>
                  <a:lnTo>
                    <a:pt x="14360" y="164"/>
                  </a:lnTo>
                  <a:lnTo>
                    <a:pt x="14319" y="82"/>
                  </a:lnTo>
                  <a:lnTo>
                    <a:pt x="14278" y="42"/>
                  </a:lnTo>
                  <a:lnTo>
                    <a:pt x="14238"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6" name="Google Shape;156;p16"/>
            <p:cNvSpPr/>
            <p:nvPr/>
          </p:nvSpPr>
          <p:spPr>
            <a:xfrm>
              <a:off x="2701050" y="1843125"/>
              <a:ext cx="309175" cy="322375"/>
            </a:xfrm>
            <a:custGeom>
              <a:rect b="b" l="l" r="r" t="t"/>
              <a:pathLst>
                <a:path extrusionOk="0" h="12895" w="12367">
                  <a:moveTo>
                    <a:pt x="12163" y="0"/>
                  </a:moveTo>
                  <a:lnTo>
                    <a:pt x="12081" y="41"/>
                  </a:lnTo>
                  <a:lnTo>
                    <a:pt x="9600" y="1831"/>
                  </a:lnTo>
                  <a:lnTo>
                    <a:pt x="7160" y="3702"/>
                  </a:lnTo>
                  <a:lnTo>
                    <a:pt x="5939" y="4637"/>
                  </a:lnTo>
                  <a:lnTo>
                    <a:pt x="4760" y="5613"/>
                  </a:lnTo>
                  <a:lnTo>
                    <a:pt x="3580" y="6630"/>
                  </a:lnTo>
                  <a:lnTo>
                    <a:pt x="2441" y="7647"/>
                  </a:lnTo>
                  <a:lnTo>
                    <a:pt x="1872" y="8135"/>
                  </a:lnTo>
                  <a:lnTo>
                    <a:pt x="1343" y="8664"/>
                  </a:lnTo>
                  <a:lnTo>
                    <a:pt x="855" y="9193"/>
                  </a:lnTo>
                  <a:lnTo>
                    <a:pt x="611" y="9478"/>
                  </a:lnTo>
                  <a:lnTo>
                    <a:pt x="407" y="9762"/>
                  </a:lnTo>
                  <a:lnTo>
                    <a:pt x="285" y="10047"/>
                  </a:lnTo>
                  <a:lnTo>
                    <a:pt x="163" y="10332"/>
                  </a:lnTo>
                  <a:lnTo>
                    <a:pt x="82" y="10617"/>
                  </a:lnTo>
                  <a:lnTo>
                    <a:pt x="1" y="10901"/>
                  </a:lnTo>
                  <a:lnTo>
                    <a:pt x="1" y="11227"/>
                  </a:lnTo>
                  <a:lnTo>
                    <a:pt x="41" y="11511"/>
                  </a:lnTo>
                  <a:lnTo>
                    <a:pt x="123" y="11796"/>
                  </a:lnTo>
                  <a:lnTo>
                    <a:pt x="285" y="12081"/>
                  </a:lnTo>
                  <a:lnTo>
                    <a:pt x="448" y="12284"/>
                  </a:lnTo>
                  <a:lnTo>
                    <a:pt x="651" y="12488"/>
                  </a:lnTo>
                  <a:lnTo>
                    <a:pt x="896" y="12610"/>
                  </a:lnTo>
                  <a:lnTo>
                    <a:pt x="1140" y="12732"/>
                  </a:lnTo>
                  <a:lnTo>
                    <a:pt x="1384" y="12813"/>
                  </a:lnTo>
                  <a:lnTo>
                    <a:pt x="1668" y="12854"/>
                  </a:lnTo>
                  <a:lnTo>
                    <a:pt x="2238" y="12894"/>
                  </a:lnTo>
                  <a:lnTo>
                    <a:pt x="2929" y="12813"/>
                  </a:lnTo>
                  <a:lnTo>
                    <a:pt x="3621" y="12691"/>
                  </a:lnTo>
                  <a:lnTo>
                    <a:pt x="5004" y="12366"/>
                  </a:lnTo>
                  <a:lnTo>
                    <a:pt x="6712" y="11918"/>
                  </a:lnTo>
                  <a:lnTo>
                    <a:pt x="8380" y="11389"/>
                  </a:lnTo>
                  <a:lnTo>
                    <a:pt x="10048" y="10820"/>
                  </a:lnTo>
                  <a:lnTo>
                    <a:pt x="11715" y="10210"/>
                  </a:lnTo>
                  <a:lnTo>
                    <a:pt x="11756" y="10128"/>
                  </a:lnTo>
                  <a:lnTo>
                    <a:pt x="11797" y="10088"/>
                  </a:lnTo>
                  <a:lnTo>
                    <a:pt x="11837" y="9966"/>
                  </a:lnTo>
                  <a:lnTo>
                    <a:pt x="11797" y="9884"/>
                  </a:lnTo>
                  <a:lnTo>
                    <a:pt x="11756" y="9844"/>
                  </a:lnTo>
                  <a:lnTo>
                    <a:pt x="11675" y="9803"/>
                  </a:lnTo>
                  <a:lnTo>
                    <a:pt x="11593" y="9844"/>
                  </a:lnTo>
                  <a:lnTo>
                    <a:pt x="10210" y="10373"/>
                  </a:lnTo>
                  <a:lnTo>
                    <a:pt x="8827" y="10861"/>
                  </a:lnTo>
                  <a:lnTo>
                    <a:pt x="7444" y="11308"/>
                  </a:lnTo>
                  <a:lnTo>
                    <a:pt x="6021" y="11715"/>
                  </a:lnTo>
                  <a:lnTo>
                    <a:pt x="4597" y="12081"/>
                  </a:lnTo>
                  <a:lnTo>
                    <a:pt x="3173" y="12366"/>
                  </a:lnTo>
                  <a:lnTo>
                    <a:pt x="2604" y="12488"/>
                  </a:lnTo>
                  <a:lnTo>
                    <a:pt x="2034" y="12528"/>
                  </a:lnTo>
                  <a:lnTo>
                    <a:pt x="1709" y="12488"/>
                  </a:lnTo>
                  <a:lnTo>
                    <a:pt x="1424" y="12447"/>
                  </a:lnTo>
                  <a:lnTo>
                    <a:pt x="1180" y="12366"/>
                  </a:lnTo>
                  <a:lnTo>
                    <a:pt x="936" y="12244"/>
                  </a:lnTo>
                  <a:lnTo>
                    <a:pt x="692" y="12040"/>
                  </a:lnTo>
                  <a:lnTo>
                    <a:pt x="529" y="11796"/>
                  </a:lnTo>
                  <a:lnTo>
                    <a:pt x="448" y="11511"/>
                  </a:lnTo>
                  <a:lnTo>
                    <a:pt x="407" y="11227"/>
                  </a:lnTo>
                  <a:lnTo>
                    <a:pt x="407" y="10942"/>
                  </a:lnTo>
                  <a:lnTo>
                    <a:pt x="448" y="10657"/>
                  </a:lnTo>
                  <a:lnTo>
                    <a:pt x="529" y="10373"/>
                  </a:lnTo>
                  <a:lnTo>
                    <a:pt x="651" y="10088"/>
                  </a:lnTo>
                  <a:lnTo>
                    <a:pt x="855" y="9803"/>
                  </a:lnTo>
                  <a:lnTo>
                    <a:pt x="1058" y="9518"/>
                  </a:lnTo>
                  <a:lnTo>
                    <a:pt x="1546" y="8990"/>
                  </a:lnTo>
                  <a:lnTo>
                    <a:pt x="2034" y="8501"/>
                  </a:lnTo>
                  <a:lnTo>
                    <a:pt x="2563" y="8013"/>
                  </a:lnTo>
                  <a:lnTo>
                    <a:pt x="3621" y="7037"/>
                  </a:lnTo>
                  <a:lnTo>
                    <a:pt x="4719" y="6102"/>
                  </a:lnTo>
                  <a:lnTo>
                    <a:pt x="5858" y="5207"/>
                  </a:lnTo>
                  <a:lnTo>
                    <a:pt x="6956" y="4271"/>
                  </a:lnTo>
                  <a:lnTo>
                    <a:pt x="8299" y="3295"/>
                  </a:lnTo>
                  <a:lnTo>
                    <a:pt x="9600" y="2278"/>
                  </a:lnTo>
                  <a:lnTo>
                    <a:pt x="12285" y="366"/>
                  </a:lnTo>
                  <a:lnTo>
                    <a:pt x="12326" y="285"/>
                  </a:lnTo>
                  <a:lnTo>
                    <a:pt x="12366" y="203"/>
                  </a:lnTo>
                  <a:lnTo>
                    <a:pt x="12326" y="81"/>
                  </a:lnTo>
                  <a:lnTo>
                    <a:pt x="12285" y="41"/>
                  </a:lnTo>
                  <a:lnTo>
                    <a:pt x="1224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57" name="Google Shape;157;p16"/>
            <p:cNvSpPr/>
            <p:nvPr/>
          </p:nvSpPr>
          <p:spPr>
            <a:xfrm>
              <a:off x="2756975" y="1978375"/>
              <a:ext cx="183075" cy="133225"/>
            </a:xfrm>
            <a:custGeom>
              <a:rect b="b" l="l" r="r" t="t"/>
              <a:pathLst>
                <a:path extrusionOk="0" h="5329" w="7323">
                  <a:moveTo>
                    <a:pt x="5980" y="366"/>
                  </a:moveTo>
                  <a:lnTo>
                    <a:pt x="6306" y="407"/>
                  </a:lnTo>
                  <a:lnTo>
                    <a:pt x="6428" y="407"/>
                  </a:lnTo>
                  <a:lnTo>
                    <a:pt x="6550" y="488"/>
                  </a:lnTo>
                  <a:lnTo>
                    <a:pt x="6672" y="569"/>
                  </a:lnTo>
                  <a:lnTo>
                    <a:pt x="6753" y="651"/>
                  </a:lnTo>
                  <a:lnTo>
                    <a:pt x="6834" y="814"/>
                  </a:lnTo>
                  <a:lnTo>
                    <a:pt x="6875" y="936"/>
                  </a:lnTo>
                  <a:lnTo>
                    <a:pt x="6956" y="1302"/>
                  </a:lnTo>
                  <a:lnTo>
                    <a:pt x="6916" y="1586"/>
                  </a:lnTo>
                  <a:lnTo>
                    <a:pt x="6834" y="1912"/>
                  </a:lnTo>
                  <a:lnTo>
                    <a:pt x="6672" y="2197"/>
                  </a:lnTo>
                  <a:lnTo>
                    <a:pt x="6468" y="2522"/>
                  </a:lnTo>
                  <a:lnTo>
                    <a:pt x="6184" y="2766"/>
                  </a:lnTo>
                  <a:lnTo>
                    <a:pt x="5858" y="3010"/>
                  </a:lnTo>
                  <a:lnTo>
                    <a:pt x="5533" y="3213"/>
                  </a:lnTo>
                  <a:lnTo>
                    <a:pt x="4841" y="3580"/>
                  </a:lnTo>
                  <a:lnTo>
                    <a:pt x="4109" y="3864"/>
                  </a:lnTo>
                  <a:lnTo>
                    <a:pt x="3092" y="4271"/>
                  </a:lnTo>
                  <a:lnTo>
                    <a:pt x="2075" y="4637"/>
                  </a:lnTo>
                  <a:lnTo>
                    <a:pt x="1709" y="4800"/>
                  </a:lnTo>
                  <a:lnTo>
                    <a:pt x="1180" y="4963"/>
                  </a:lnTo>
                  <a:lnTo>
                    <a:pt x="692" y="4963"/>
                  </a:lnTo>
                  <a:lnTo>
                    <a:pt x="530" y="4881"/>
                  </a:lnTo>
                  <a:lnTo>
                    <a:pt x="448" y="4840"/>
                  </a:lnTo>
                  <a:lnTo>
                    <a:pt x="408" y="4759"/>
                  </a:lnTo>
                  <a:lnTo>
                    <a:pt x="367" y="4637"/>
                  </a:lnTo>
                  <a:lnTo>
                    <a:pt x="367" y="4515"/>
                  </a:lnTo>
                  <a:lnTo>
                    <a:pt x="448" y="4312"/>
                  </a:lnTo>
                  <a:lnTo>
                    <a:pt x="570" y="4108"/>
                  </a:lnTo>
                  <a:lnTo>
                    <a:pt x="733" y="3946"/>
                  </a:lnTo>
                  <a:lnTo>
                    <a:pt x="1384" y="3335"/>
                  </a:lnTo>
                  <a:lnTo>
                    <a:pt x="2075" y="2685"/>
                  </a:lnTo>
                  <a:lnTo>
                    <a:pt x="2848" y="2034"/>
                  </a:lnTo>
                  <a:lnTo>
                    <a:pt x="3621" y="1424"/>
                  </a:lnTo>
                  <a:lnTo>
                    <a:pt x="4068" y="1180"/>
                  </a:lnTo>
                  <a:lnTo>
                    <a:pt x="4475" y="936"/>
                  </a:lnTo>
                  <a:lnTo>
                    <a:pt x="4841" y="732"/>
                  </a:lnTo>
                  <a:lnTo>
                    <a:pt x="5207" y="569"/>
                  </a:lnTo>
                  <a:lnTo>
                    <a:pt x="5614" y="447"/>
                  </a:lnTo>
                  <a:lnTo>
                    <a:pt x="5980" y="366"/>
                  </a:lnTo>
                  <a:close/>
                  <a:moveTo>
                    <a:pt x="6021" y="0"/>
                  </a:moveTo>
                  <a:lnTo>
                    <a:pt x="5614" y="81"/>
                  </a:lnTo>
                  <a:lnTo>
                    <a:pt x="5207" y="203"/>
                  </a:lnTo>
                  <a:lnTo>
                    <a:pt x="4841" y="366"/>
                  </a:lnTo>
                  <a:lnTo>
                    <a:pt x="4353" y="569"/>
                  </a:lnTo>
                  <a:lnTo>
                    <a:pt x="3865" y="854"/>
                  </a:lnTo>
                  <a:lnTo>
                    <a:pt x="3377" y="1180"/>
                  </a:lnTo>
                  <a:lnTo>
                    <a:pt x="2930" y="1505"/>
                  </a:lnTo>
                  <a:lnTo>
                    <a:pt x="2035" y="2237"/>
                  </a:lnTo>
                  <a:lnTo>
                    <a:pt x="1180" y="2969"/>
                  </a:lnTo>
                  <a:lnTo>
                    <a:pt x="814" y="3295"/>
                  </a:lnTo>
                  <a:lnTo>
                    <a:pt x="448" y="3702"/>
                  </a:lnTo>
                  <a:lnTo>
                    <a:pt x="245" y="3905"/>
                  </a:lnTo>
                  <a:lnTo>
                    <a:pt x="123" y="4108"/>
                  </a:lnTo>
                  <a:lnTo>
                    <a:pt x="42" y="4352"/>
                  </a:lnTo>
                  <a:lnTo>
                    <a:pt x="1" y="4596"/>
                  </a:lnTo>
                  <a:lnTo>
                    <a:pt x="42" y="4840"/>
                  </a:lnTo>
                  <a:lnTo>
                    <a:pt x="164" y="5044"/>
                  </a:lnTo>
                  <a:lnTo>
                    <a:pt x="326" y="5207"/>
                  </a:lnTo>
                  <a:lnTo>
                    <a:pt x="530" y="5288"/>
                  </a:lnTo>
                  <a:lnTo>
                    <a:pt x="774" y="5329"/>
                  </a:lnTo>
                  <a:lnTo>
                    <a:pt x="1018" y="5329"/>
                  </a:lnTo>
                  <a:lnTo>
                    <a:pt x="1262" y="5288"/>
                  </a:lnTo>
                  <a:lnTo>
                    <a:pt x="1465" y="5247"/>
                  </a:lnTo>
                  <a:lnTo>
                    <a:pt x="2157" y="5003"/>
                  </a:lnTo>
                  <a:lnTo>
                    <a:pt x="2848" y="4759"/>
                  </a:lnTo>
                  <a:lnTo>
                    <a:pt x="4139" y="4266"/>
                  </a:lnTo>
                  <a:lnTo>
                    <a:pt x="4139" y="4266"/>
                  </a:lnTo>
                  <a:lnTo>
                    <a:pt x="4150" y="4271"/>
                  </a:lnTo>
                  <a:lnTo>
                    <a:pt x="4231" y="4230"/>
                  </a:lnTo>
                  <a:lnTo>
                    <a:pt x="4963" y="3905"/>
                  </a:lnTo>
                  <a:lnTo>
                    <a:pt x="5696" y="3539"/>
                  </a:lnTo>
                  <a:lnTo>
                    <a:pt x="6021" y="3335"/>
                  </a:lnTo>
                  <a:lnTo>
                    <a:pt x="6346" y="3091"/>
                  </a:lnTo>
                  <a:lnTo>
                    <a:pt x="6672" y="2847"/>
                  </a:lnTo>
                  <a:lnTo>
                    <a:pt x="6916" y="2522"/>
                  </a:lnTo>
                  <a:lnTo>
                    <a:pt x="7119" y="2197"/>
                  </a:lnTo>
                  <a:lnTo>
                    <a:pt x="7241" y="1871"/>
                  </a:lnTo>
                  <a:lnTo>
                    <a:pt x="7323" y="1505"/>
                  </a:lnTo>
                  <a:lnTo>
                    <a:pt x="7323" y="1098"/>
                  </a:lnTo>
                  <a:lnTo>
                    <a:pt x="7201" y="732"/>
                  </a:lnTo>
                  <a:lnTo>
                    <a:pt x="7119" y="569"/>
                  </a:lnTo>
                  <a:lnTo>
                    <a:pt x="7038" y="407"/>
                  </a:lnTo>
                  <a:lnTo>
                    <a:pt x="6916" y="285"/>
                  </a:lnTo>
                  <a:lnTo>
                    <a:pt x="6794" y="163"/>
                  </a:lnTo>
                  <a:lnTo>
                    <a:pt x="6631" y="81"/>
                  </a:lnTo>
                  <a:lnTo>
                    <a:pt x="6428" y="41"/>
                  </a:lnTo>
                  <a:lnTo>
                    <a:pt x="622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58" name="Google Shape;158;p16"/>
          <p:cNvSpPr/>
          <p:nvPr/>
        </p:nvSpPr>
        <p:spPr>
          <a:xfrm flipH="1">
            <a:off x="8231373" y="1783663"/>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59" name="Google Shape;159;p16"/>
          <p:cNvGrpSpPr/>
          <p:nvPr/>
        </p:nvGrpSpPr>
        <p:grpSpPr>
          <a:xfrm flipH="1">
            <a:off x="-1340959" y="3558109"/>
            <a:ext cx="2408503" cy="2408503"/>
            <a:chOff x="7349044" y="3624409"/>
            <a:chExt cx="2408503" cy="2408503"/>
          </a:xfrm>
        </p:grpSpPr>
        <p:sp>
          <p:nvSpPr>
            <p:cNvPr id="160" name="Google Shape;160;p16"/>
            <p:cNvSpPr/>
            <p:nvPr/>
          </p:nvSpPr>
          <p:spPr>
            <a:xfrm flipH="1" rot="8100000">
              <a:off x="7661995" y="4016892"/>
              <a:ext cx="1782600" cy="1623537"/>
            </a:xfrm>
            <a:custGeom>
              <a:rect b="b" l="l" r="r" t="t"/>
              <a:pathLst>
                <a:path extrusionOk="0" h="17451" w="19160">
                  <a:moveTo>
                    <a:pt x="9682" y="0"/>
                  </a:moveTo>
                  <a:lnTo>
                    <a:pt x="9600" y="41"/>
                  </a:lnTo>
                  <a:lnTo>
                    <a:pt x="9560" y="82"/>
                  </a:lnTo>
                  <a:lnTo>
                    <a:pt x="7892" y="1668"/>
                  </a:lnTo>
                  <a:lnTo>
                    <a:pt x="6306" y="3295"/>
                  </a:lnTo>
                  <a:lnTo>
                    <a:pt x="5533" y="4109"/>
                  </a:lnTo>
                  <a:lnTo>
                    <a:pt x="4760" y="4963"/>
                  </a:lnTo>
                  <a:lnTo>
                    <a:pt x="4028" y="5858"/>
                  </a:lnTo>
                  <a:lnTo>
                    <a:pt x="3336" y="6753"/>
                  </a:lnTo>
                  <a:lnTo>
                    <a:pt x="2686" y="7688"/>
                  </a:lnTo>
                  <a:lnTo>
                    <a:pt x="2075" y="8624"/>
                  </a:lnTo>
                  <a:lnTo>
                    <a:pt x="1506" y="9600"/>
                  </a:lnTo>
                  <a:lnTo>
                    <a:pt x="1018" y="10617"/>
                  </a:lnTo>
                  <a:lnTo>
                    <a:pt x="611" y="11552"/>
                  </a:lnTo>
                  <a:lnTo>
                    <a:pt x="448" y="12000"/>
                  </a:lnTo>
                  <a:lnTo>
                    <a:pt x="286" y="12488"/>
                  </a:lnTo>
                  <a:lnTo>
                    <a:pt x="164" y="12976"/>
                  </a:lnTo>
                  <a:lnTo>
                    <a:pt x="42" y="13464"/>
                  </a:lnTo>
                  <a:lnTo>
                    <a:pt x="1" y="13993"/>
                  </a:lnTo>
                  <a:lnTo>
                    <a:pt x="1" y="14481"/>
                  </a:lnTo>
                  <a:lnTo>
                    <a:pt x="42" y="14969"/>
                  </a:lnTo>
                  <a:lnTo>
                    <a:pt x="123" y="15417"/>
                  </a:lnTo>
                  <a:lnTo>
                    <a:pt x="286" y="15823"/>
                  </a:lnTo>
                  <a:lnTo>
                    <a:pt x="489" y="16230"/>
                  </a:lnTo>
                  <a:lnTo>
                    <a:pt x="733" y="16556"/>
                  </a:lnTo>
                  <a:lnTo>
                    <a:pt x="1059" y="16881"/>
                  </a:lnTo>
                  <a:lnTo>
                    <a:pt x="1465" y="17125"/>
                  </a:lnTo>
                  <a:lnTo>
                    <a:pt x="1913" y="17288"/>
                  </a:lnTo>
                  <a:lnTo>
                    <a:pt x="2441" y="17410"/>
                  </a:lnTo>
                  <a:lnTo>
                    <a:pt x="2930" y="17450"/>
                  </a:lnTo>
                  <a:lnTo>
                    <a:pt x="3458" y="17369"/>
                  </a:lnTo>
                  <a:lnTo>
                    <a:pt x="3987" y="17288"/>
                  </a:lnTo>
                  <a:lnTo>
                    <a:pt x="4516" y="17125"/>
                  </a:lnTo>
                  <a:lnTo>
                    <a:pt x="5004" y="16922"/>
                  </a:lnTo>
                  <a:lnTo>
                    <a:pt x="5492" y="16678"/>
                  </a:lnTo>
                  <a:lnTo>
                    <a:pt x="5940" y="16434"/>
                  </a:lnTo>
                  <a:lnTo>
                    <a:pt x="7038" y="15783"/>
                  </a:lnTo>
                  <a:lnTo>
                    <a:pt x="7567" y="15498"/>
                  </a:lnTo>
                  <a:lnTo>
                    <a:pt x="8136" y="15213"/>
                  </a:lnTo>
                  <a:lnTo>
                    <a:pt x="8665" y="15051"/>
                  </a:lnTo>
                  <a:lnTo>
                    <a:pt x="9194" y="14888"/>
                  </a:lnTo>
                  <a:lnTo>
                    <a:pt x="10251" y="14644"/>
                  </a:lnTo>
                  <a:lnTo>
                    <a:pt x="11350" y="14481"/>
                  </a:lnTo>
                  <a:lnTo>
                    <a:pt x="12448" y="14278"/>
                  </a:lnTo>
                  <a:lnTo>
                    <a:pt x="13017" y="14156"/>
                  </a:lnTo>
                  <a:lnTo>
                    <a:pt x="13546" y="13993"/>
                  </a:lnTo>
                  <a:lnTo>
                    <a:pt x="14075" y="13830"/>
                  </a:lnTo>
                  <a:lnTo>
                    <a:pt x="14563" y="13627"/>
                  </a:lnTo>
                  <a:lnTo>
                    <a:pt x="15092" y="13342"/>
                  </a:lnTo>
                  <a:lnTo>
                    <a:pt x="15580" y="13017"/>
                  </a:lnTo>
                  <a:lnTo>
                    <a:pt x="16027" y="12651"/>
                  </a:lnTo>
                  <a:lnTo>
                    <a:pt x="16434" y="12244"/>
                  </a:lnTo>
                  <a:lnTo>
                    <a:pt x="16800" y="11837"/>
                  </a:lnTo>
                  <a:lnTo>
                    <a:pt x="17126" y="11390"/>
                  </a:lnTo>
                  <a:lnTo>
                    <a:pt x="17410" y="10902"/>
                  </a:lnTo>
                  <a:lnTo>
                    <a:pt x="17695" y="10413"/>
                  </a:lnTo>
                  <a:lnTo>
                    <a:pt x="17939" y="9885"/>
                  </a:lnTo>
                  <a:lnTo>
                    <a:pt x="18142" y="9356"/>
                  </a:lnTo>
                  <a:lnTo>
                    <a:pt x="18305" y="8786"/>
                  </a:lnTo>
                  <a:lnTo>
                    <a:pt x="18509" y="8258"/>
                  </a:lnTo>
                  <a:lnTo>
                    <a:pt x="18753" y="7119"/>
                  </a:lnTo>
                  <a:lnTo>
                    <a:pt x="18956" y="6020"/>
                  </a:lnTo>
                  <a:lnTo>
                    <a:pt x="19159" y="4759"/>
                  </a:lnTo>
                  <a:lnTo>
                    <a:pt x="19159" y="4678"/>
                  </a:lnTo>
                  <a:lnTo>
                    <a:pt x="19119" y="4637"/>
                  </a:lnTo>
                  <a:lnTo>
                    <a:pt x="18997" y="4556"/>
                  </a:lnTo>
                  <a:lnTo>
                    <a:pt x="18875" y="4556"/>
                  </a:lnTo>
                  <a:lnTo>
                    <a:pt x="18834" y="4597"/>
                  </a:lnTo>
                  <a:lnTo>
                    <a:pt x="18793" y="4678"/>
                  </a:lnTo>
                  <a:lnTo>
                    <a:pt x="18631" y="5776"/>
                  </a:lnTo>
                  <a:lnTo>
                    <a:pt x="18427" y="6915"/>
                  </a:lnTo>
                  <a:lnTo>
                    <a:pt x="18183" y="8014"/>
                  </a:lnTo>
                  <a:lnTo>
                    <a:pt x="18020" y="8583"/>
                  </a:lnTo>
                  <a:lnTo>
                    <a:pt x="17858" y="9112"/>
                  </a:lnTo>
                  <a:lnTo>
                    <a:pt x="17654" y="9641"/>
                  </a:lnTo>
                  <a:lnTo>
                    <a:pt x="17410" y="10129"/>
                  </a:lnTo>
                  <a:lnTo>
                    <a:pt x="17166" y="10658"/>
                  </a:lnTo>
                  <a:lnTo>
                    <a:pt x="16882" y="11105"/>
                  </a:lnTo>
                  <a:lnTo>
                    <a:pt x="16556" y="11552"/>
                  </a:lnTo>
                  <a:lnTo>
                    <a:pt x="16190" y="12000"/>
                  </a:lnTo>
                  <a:lnTo>
                    <a:pt x="15743" y="12407"/>
                  </a:lnTo>
                  <a:lnTo>
                    <a:pt x="15295" y="12732"/>
                  </a:lnTo>
                  <a:lnTo>
                    <a:pt x="14848" y="13057"/>
                  </a:lnTo>
                  <a:lnTo>
                    <a:pt x="14400" y="13301"/>
                  </a:lnTo>
                  <a:lnTo>
                    <a:pt x="13912" y="13505"/>
                  </a:lnTo>
                  <a:lnTo>
                    <a:pt x="13383" y="13668"/>
                  </a:lnTo>
                  <a:lnTo>
                    <a:pt x="12895" y="13790"/>
                  </a:lnTo>
                  <a:lnTo>
                    <a:pt x="12366" y="13912"/>
                  </a:lnTo>
                  <a:lnTo>
                    <a:pt x="11309" y="14115"/>
                  </a:lnTo>
                  <a:lnTo>
                    <a:pt x="10251" y="14278"/>
                  </a:lnTo>
                  <a:lnTo>
                    <a:pt x="9194" y="14522"/>
                  </a:lnTo>
                  <a:lnTo>
                    <a:pt x="8665" y="14644"/>
                  </a:lnTo>
                  <a:lnTo>
                    <a:pt x="8177" y="14847"/>
                  </a:lnTo>
                  <a:lnTo>
                    <a:pt x="7689" y="15051"/>
                  </a:lnTo>
                  <a:lnTo>
                    <a:pt x="7201" y="15254"/>
                  </a:lnTo>
                  <a:lnTo>
                    <a:pt x="6224" y="15823"/>
                  </a:lnTo>
                  <a:lnTo>
                    <a:pt x="5248" y="16393"/>
                  </a:lnTo>
                  <a:lnTo>
                    <a:pt x="4760" y="16637"/>
                  </a:lnTo>
                  <a:lnTo>
                    <a:pt x="4231" y="16840"/>
                  </a:lnTo>
                  <a:lnTo>
                    <a:pt x="3702" y="16962"/>
                  </a:lnTo>
                  <a:lnTo>
                    <a:pt x="3133" y="17044"/>
                  </a:lnTo>
                  <a:lnTo>
                    <a:pt x="2645" y="17044"/>
                  </a:lnTo>
                  <a:lnTo>
                    <a:pt x="2157" y="16962"/>
                  </a:lnTo>
                  <a:lnTo>
                    <a:pt x="1913" y="16922"/>
                  </a:lnTo>
                  <a:lnTo>
                    <a:pt x="1709" y="16800"/>
                  </a:lnTo>
                  <a:lnTo>
                    <a:pt x="1465" y="16718"/>
                  </a:lnTo>
                  <a:lnTo>
                    <a:pt x="1262" y="16556"/>
                  </a:lnTo>
                  <a:lnTo>
                    <a:pt x="977" y="16271"/>
                  </a:lnTo>
                  <a:lnTo>
                    <a:pt x="692" y="15905"/>
                  </a:lnTo>
                  <a:lnTo>
                    <a:pt x="530" y="15498"/>
                  </a:lnTo>
                  <a:lnTo>
                    <a:pt x="408" y="15051"/>
                  </a:lnTo>
                  <a:lnTo>
                    <a:pt x="367" y="14603"/>
                  </a:lnTo>
                  <a:lnTo>
                    <a:pt x="367" y="14115"/>
                  </a:lnTo>
                  <a:lnTo>
                    <a:pt x="408" y="13668"/>
                  </a:lnTo>
                  <a:lnTo>
                    <a:pt x="489" y="13179"/>
                  </a:lnTo>
                  <a:lnTo>
                    <a:pt x="611" y="12732"/>
                  </a:lnTo>
                  <a:lnTo>
                    <a:pt x="733" y="12285"/>
                  </a:lnTo>
                  <a:lnTo>
                    <a:pt x="1059" y="11390"/>
                  </a:lnTo>
                  <a:lnTo>
                    <a:pt x="1506" y="10413"/>
                  </a:lnTo>
                  <a:lnTo>
                    <a:pt x="2035" y="9437"/>
                  </a:lnTo>
                  <a:lnTo>
                    <a:pt x="2604" y="8502"/>
                  </a:lnTo>
                  <a:lnTo>
                    <a:pt x="3174" y="7607"/>
                  </a:lnTo>
                  <a:lnTo>
                    <a:pt x="3824" y="6712"/>
                  </a:lnTo>
                  <a:lnTo>
                    <a:pt x="4516" y="5858"/>
                  </a:lnTo>
                  <a:lnTo>
                    <a:pt x="5207" y="5004"/>
                  </a:lnTo>
                  <a:lnTo>
                    <a:pt x="5940" y="4190"/>
                  </a:lnTo>
                  <a:lnTo>
                    <a:pt x="7485" y="2604"/>
                  </a:lnTo>
                  <a:lnTo>
                    <a:pt x="9031" y="1099"/>
                  </a:lnTo>
                  <a:lnTo>
                    <a:pt x="9804" y="326"/>
                  </a:lnTo>
                  <a:lnTo>
                    <a:pt x="9845" y="244"/>
                  </a:lnTo>
                  <a:lnTo>
                    <a:pt x="9845" y="204"/>
                  </a:lnTo>
                  <a:lnTo>
                    <a:pt x="9845" y="122"/>
                  </a:lnTo>
                  <a:lnTo>
                    <a:pt x="9804" y="82"/>
                  </a:lnTo>
                  <a:lnTo>
                    <a:pt x="9763" y="41"/>
                  </a:lnTo>
                  <a:lnTo>
                    <a:pt x="9682"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1" name="Google Shape;161;p16"/>
            <p:cNvSpPr/>
            <p:nvPr/>
          </p:nvSpPr>
          <p:spPr>
            <a:xfrm flipH="1" rot="8100000">
              <a:off x="7872293" y="4243499"/>
              <a:ext cx="1634949" cy="1309454"/>
            </a:xfrm>
            <a:custGeom>
              <a:rect b="b" l="l" r="r" t="t"/>
              <a:pathLst>
                <a:path extrusionOk="0" h="14075" w="17573">
                  <a:moveTo>
                    <a:pt x="14481" y="0"/>
                  </a:moveTo>
                  <a:lnTo>
                    <a:pt x="14400" y="41"/>
                  </a:lnTo>
                  <a:lnTo>
                    <a:pt x="12447" y="1099"/>
                  </a:lnTo>
                  <a:lnTo>
                    <a:pt x="10576" y="2238"/>
                  </a:lnTo>
                  <a:lnTo>
                    <a:pt x="8705" y="3458"/>
                  </a:lnTo>
                  <a:lnTo>
                    <a:pt x="6916" y="4760"/>
                  </a:lnTo>
                  <a:lnTo>
                    <a:pt x="5207" y="6142"/>
                  </a:lnTo>
                  <a:lnTo>
                    <a:pt x="3539" y="7566"/>
                  </a:lnTo>
                  <a:lnTo>
                    <a:pt x="1872" y="9112"/>
                  </a:lnTo>
                  <a:lnTo>
                    <a:pt x="1139" y="9844"/>
                  </a:lnTo>
                  <a:lnTo>
                    <a:pt x="814" y="10251"/>
                  </a:lnTo>
                  <a:lnTo>
                    <a:pt x="489" y="10658"/>
                  </a:lnTo>
                  <a:lnTo>
                    <a:pt x="285" y="11024"/>
                  </a:lnTo>
                  <a:lnTo>
                    <a:pt x="123" y="11471"/>
                  </a:lnTo>
                  <a:lnTo>
                    <a:pt x="41" y="11919"/>
                  </a:lnTo>
                  <a:lnTo>
                    <a:pt x="1" y="12325"/>
                  </a:lnTo>
                  <a:lnTo>
                    <a:pt x="82" y="12773"/>
                  </a:lnTo>
                  <a:lnTo>
                    <a:pt x="123" y="12976"/>
                  </a:lnTo>
                  <a:lnTo>
                    <a:pt x="204" y="13179"/>
                  </a:lnTo>
                  <a:lnTo>
                    <a:pt x="326" y="13342"/>
                  </a:lnTo>
                  <a:lnTo>
                    <a:pt x="448" y="13505"/>
                  </a:lnTo>
                  <a:lnTo>
                    <a:pt x="611" y="13668"/>
                  </a:lnTo>
                  <a:lnTo>
                    <a:pt x="814" y="13830"/>
                  </a:lnTo>
                  <a:lnTo>
                    <a:pt x="1017" y="13912"/>
                  </a:lnTo>
                  <a:lnTo>
                    <a:pt x="1262" y="13993"/>
                  </a:lnTo>
                  <a:lnTo>
                    <a:pt x="1465" y="14034"/>
                  </a:lnTo>
                  <a:lnTo>
                    <a:pt x="1709" y="14074"/>
                  </a:lnTo>
                  <a:lnTo>
                    <a:pt x="2156" y="14034"/>
                  </a:lnTo>
                  <a:lnTo>
                    <a:pt x="2645" y="13952"/>
                  </a:lnTo>
                  <a:lnTo>
                    <a:pt x="3092" y="13790"/>
                  </a:lnTo>
                  <a:lnTo>
                    <a:pt x="3539" y="13627"/>
                  </a:lnTo>
                  <a:lnTo>
                    <a:pt x="4353" y="13220"/>
                  </a:lnTo>
                  <a:lnTo>
                    <a:pt x="6183" y="12407"/>
                  </a:lnTo>
                  <a:lnTo>
                    <a:pt x="7973" y="11512"/>
                  </a:lnTo>
                  <a:lnTo>
                    <a:pt x="9722" y="10576"/>
                  </a:lnTo>
                  <a:lnTo>
                    <a:pt x="10576" y="10088"/>
                  </a:lnTo>
                  <a:lnTo>
                    <a:pt x="11431" y="9559"/>
                  </a:lnTo>
                  <a:lnTo>
                    <a:pt x="12203" y="9031"/>
                  </a:lnTo>
                  <a:lnTo>
                    <a:pt x="12976" y="8461"/>
                  </a:lnTo>
                  <a:lnTo>
                    <a:pt x="13749" y="7851"/>
                  </a:lnTo>
                  <a:lnTo>
                    <a:pt x="14481" y="7241"/>
                  </a:lnTo>
                  <a:lnTo>
                    <a:pt x="15173" y="6549"/>
                  </a:lnTo>
                  <a:lnTo>
                    <a:pt x="15824" y="5858"/>
                  </a:lnTo>
                  <a:lnTo>
                    <a:pt x="16434" y="5126"/>
                  </a:lnTo>
                  <a:lnTo>
                    <a:pt x="17003" y="4353"/>
                  </a:lnTo>
                  <a:lnTo>
                    <a:pt x="17532" y="3539"/>
                  </a:lnTo>
                  <a:lnTo>
                    <a:pt x="17573" y="3458"/>
                  </a:lnTo>
                  <a:lnTo>
                    <a:pt x="17573" y="3417"/>
                  </a:lnTo>
                  <a:lnTo>
                    <a:pt x="17532" y="3336"/>
                  </a:lnTo>
                  <a:lnTo>
                    <a:pt x="17491" y="3295"/>
                  </a:lnTo>
                  <a:lnTo>
                    <a:pt x="17288" y="3295"/>
                  </a:lnTo>
                  <a:lnTo>
                    <a:pt x="17207" y="3377"/>
                  </a:lnTo>
                  <a:lnTo>
                    <a:pt x="16718" y="4149"/>
                  </a:lnTo>
                  <a:lnTo>
                    <a:pt x="16190" y="4882"/>
                  </a:lnTo>
                  <a:lnTo>
                    <a:pt x="15580" y="5573"/>
                  </a:lnTo>
                  <a:lnTo>
                    <a:pt x="14929" y="6265"/>
                  </a:lnTo>
                  <a:lnTo>
                    <a:pt x="14278" y="6915"/>
                  </a:lnTo>
                  <a:lnTo>
                    <a:pt x="13586" y="7525"/>
                  </a:lnTo>
                  <a:lnTo>
                    <a:pt x="12854" y="8095"/>
                  </a:lnTo>
                  <a:lnTo>
                    <a:pt x="12122" y="8624"/>
                  </a:lnTo>
                  <a:lnTo>
                    <a:pt x="11349" y="9153"/>
                  </a:lnTo>
                  <a:lnTo>
                    <a:pt x="10536" y="9641"/>
                  </a:lnTo>
                  <a:lnTo>
                    <a:pt x="9763" y="10129"/>
                  </a:lnTo>
                  <a:lnTo>
                    <a:pt x="8909" y="10617"/>
                  </a:lnTo>
                  <a:lnTo>
                    <a:pt x="7241" y="11471"/>
                  </a:lnTo>
                  <a:lnTo>
                    <a:pt x="5573" y="12285"/>
                  </a:lnTo>
                  <a:lnTo>
                    <a:pt x="3865" y="13057"/>
                  </a:lnTo>
                  <a:lnTo>
                    <a:pt x="2970" y="13464"/>
                  </a:lnTo>
                  <a:lnTo>
                    <a:pt x="2522" y="13586"/>
                  </a:lnTo>
                  <a:lnTo>
                    <a:pt x="2034" y="13668"/>
                  </a:lnTo>
                  <a:lnTo>
                    <a:pt x="1790" y="13708"/>
                  </a:lnTo>
                  <a:lnTo>
                    <a:pt x="1587" y="13668"/>
                  </a:lnTo>
                  <a:lnTo>
                    <a:pt x="1384" y="13627"/>
                  </a:lnTo>
                  <a:lnTo>
                    <a:pt x="1180" y="13546"/>
                  </a:lnTo>
                  <a:lnTo>
                    <a:pt x="977" y="13464"/>
                  </a:lnTo>
                  <a:lnTo>
                    <a:pt x="814" y="13342"/>
                  </a:lnTo>
                  <a:lnTo>
                    <a:pt x="651" y="13179"/>
                  </a:lnTo>
                  <a:lnTo>
                    <a:pt x="529" y="12976"/>
                  </a:lnTo>
                  <a:lnTo>
                    <a:pt x="448" y="12773"/>
                  </a:lnTo>
                  <a:lnTo>
                    <a:pt x="407" y="12529"/>
                  </a:lnTo>
                  <a:lnTo>
                    <a:pt x="367" y="12325"/>
                  </a:lnTo>
                  <a:lnTo>
                    <a:pt x="367" y="12122"/>
                  </a:lnTo>
                  <a:lnTo>
                    <a:pt x="448" y="11674"/>
                  </a:lnTo>
                  <a:lnTo>
                    <a:pt x="570" y="11268"/>
                  </a:lnTo>
                  <a:lnTo>
                    <a:pt x="855" y="10820"/>
                  </a:lnTo>
                  <a:lnTo>
                    <a:pt x="1139" y="10413"/>
                  </a:lnTo>
                  <a:lnTo>
                    <a:pt x="1506" y="10007"/>
                  </a:lnTo>
                  <a:lnTo>
                    <a:pt x="1872" y="9641"/>
                  </a:lnTo>
                  <a:lnTo>
                    <a:pt x="3377" y="8217"/>
                  </a:lnTo>
                  <a:lnTo>
                    <a:pt x="4963" y="6834"/>
                  </a:lnTo>
                  <a:lnTo>
                    <a:pt x="6590" y="5492"/>
                  </a:lnTo>
                  <a:lnTo>
                    <a:pt x="8298" y="4231"/>
                  </a:lnTo>
                  <a:lnTo>
                    <a:pt x="10048" y="3010"/>
                  </a:lnTo>
                  <a:lnTo>
                    <a:pt x="11837" y="1912"/>
                  </a:lnTo>
                  <a:lnTo>
                    <a:pt x="13668" y="855"/>
                  </a:lnTo>
                  <a:lnTo>
                    <a:pt x="14603" y="366"/>
                  </a:lnTo>
                  <a:lnTo>
                    <a:pt x="14644" y="285"/>
                  </a:lnTo>
                  <a:lnTo>
                    <a:pt x="14685" y="244"/>
                  </a:lnTo>
                  <a:lnTo>
                    <a:pt x="14685" y="163"/>
                  </a:lnTo>
                  <a:lnTo>
                    <a:pt x="14644" y="122"/>
                  </a:lnTo>
                  <a:lnTo>
                    <a:pt x="14603" y="41"/>
                  </a:lnTo>
                  <a:lnTo>
                    <a:pt x="14563"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2" name="Google Shape;162;p16"/>
            <p:cNvSpPr/>
            <p:nvPr/>
          </p:nvSpPr>
          <p:spPr>
            <a:xfrm flipH="1" rot="8100000">
              <a:off x="8893413" y="4510443"/>
              <a:ext cx="673778" cy="582858"/>
            </a:xfrm>
            <a:custGeom>
              <a:rect b="b" l="l" r="r" t="t"/>
              <a:pathLst>
                <a:path extrusionOk="0" h="6265" w="7242">
                  <a:moveTo>
                    <a:pt x="6224" y="0"/>
                  </a:moveTo>
                  <a:lnTo>
                    <a:pt x="6143" y="41"/>
                  </a:lnTo>
                  <a:lnTo>
                    <a:pt x="3092" y="2319"/>
                  </a:lnTo>
                  <a:lnTo>
                    <a:pt x="1547" y="3498"/>
                  </a:lnTo>
                  <a:lnTo>
                    <a:pt x="896" y="3986"/>
                  </a:lnTo>
                  <a:lnTo>
                    <a:pt x="570" y="4271"/>
                  </a:lnTo>
                  <a:lnTo>
                    <a:pt x="326" y="4556"/>
                  </a:lnTo>
                  <a:lnTo>
                    <a:pt x="164" y="4800"/>
                  </a:lnTo>
                  <a:lnTo>
                    <a:pt x="42" y="5085"/>
                  </a:lnTo>
                  <a:lnTo>
                    <a:pt x="1" y="5410"/>
                  </a:lnTo>
                  <a:lnTo>
                    <a:pt x="82" y="5695"/>
                  </a:lnTo>
                  <a:lnTo>
                    <a:pt x="204" y="5980"/>
                  </a:lnTo>
                  <a:lnTo>
                    <a:pt x="326" y="6061"/>
                  </a:lnTo>
                  <a:lnTo>
                    <a:pt x="448" y="6142"/>
                  </a:lnTo>
                  <a:lnTo>
                    <a:pt x="570" y="6224"/>
                  </a:lnTo>
                  <a:lnTo>
                    <a:pt x="692" y="6264"/>
                  </a:lnTo>
                  <a:lnTo>
                    <a:pt x="977" y="6264"/>
                  </a:lnTo>
                  <a:lnTo>
                    <a:pt x="1181" y="6183"/>
                  </a:lnTo>
                  <a:lnTo>
                    <a:pt x="1343" y="6102"/>
                  </a:lnTo>
                  <a:lnTo>
                    <a:pt x="1709" y="5898"/>
                  </a:lnTo>
                  <a:lnTo>
                    <a:pt x="2482" y="5329"/>
                  </a:lnTo>
                  <a:lnTo>
                    <a:pt x="3987" y="4271"/>
                  </a:lnTo>
                  <a:lnTo>
                    <a:pt x="5614" y="2970"/>
                  </a:lnTo>
                  <a:lnTo>
                    <a:pt x="7160" y="1668"/>
                  </a:lnTo>
                  <a:lnTo>
                    <a:pt x="7241" y="1587"/>
                  </a:lnTo>
                  <a:lnTo>
                    <a:pt x="7241" y="1546"/>
                  </a:lnTo>
                  <a:lnTo>
                    <a:pt x="7201" y="1465"/>
                  </a:lnTo>
                  <a:lnTo>
                    <a:pt x="7160" y="1424"/>
                  </a:lnTo>
                  <a:lnTo>
                    <a:pt x="7038" y="1343"/>
                  </a:lnTo>
                  <a:lnTo>
                    <a:pt x="6997" y="1343"/>
                  </a:lnTo>
                  <a:lnTo>
                    <a:pt x="6916" y="1383"/>
                  </a:lnTo>
                  <a:lnTo>
                    <a:pt x="5655" y="2441"/>
                  </a:lnTo>
                  <a:lnTo>
                    <a:pt x="4394" y="3458"/>
                  </a:lnTo>
                  <a:lnTo>
                    <a:pt x="3092" y="4434"/>
                  </a:lnTo>
                  <a:lnTo>
                    <a:pt x="1750" y="5410"/>
                  </a:lnTo>
                  <a:lnTo>
                    <a:pt x="1465" y="5613"/>
                  </a:lnTo>
                  <a:lnTo>
                    <a:pt x="1140" y="5817"/>
                  </a:lnTo>
                  <a:lnTo>
                    <a:pt x="936" y="5858"/>
                  </a:lnTo>
                  <a:lnTo>
                    <a:pt x="774" y="5898"/>
                  </a:lnTo>
                  <a:lnTo>
                    <a:pt x="611" y="5858"/>
                  </a:lnTo>
                  <a:lnTo>
                    <a:pt x="489" y="5695"/>
                  </a:lnTo>
                  <a:lnTo>
                    <a:pt x="408" y="5573"/>
                  </a:lnTo>
                  <a:lnTo>
                    <a:pt x="367" y="5451"/>
                  </a:lnTo>
                  <a:lnTo>
                    <a:pt x="367" y="5288"/>
                  </a:lnTo>
                  <a:lnTo>
                    <a:pt x="408" y="5166"/>
                  </a:lnTo>
                  <a:lnTo>
                    <a:pt x="530" y="4881"/>
                  </a:lnTo>
                  <a:lnTo>
                    <a:pt x="733" y="4637"/>
                  </a:lnTo>
                  <a:lnTo>
                    <a:pt x="1018" y="4393"/>
                  </a:lnTo>
                  <a:lnTo>
                    <a:pt x="1303" y="4149"/>
                  </a:lnTo>
                  <a:lnTo>
                    <a:pt x="1913" y="3661"/>
                  </a:lnTo>
                  <a:lnTo>
                    <a:pt x="3255" y="2644"/>
                  </a:lnTo>
                  <a:lnTo>
                    <a:pt x="6346" y="366"/>
                  </a:lnTo>
                  <a:lnTo>
                    <a:pt x="6387" y="326"/>
                  </a:lnTo>
                  <a:lnTo>
                    <a:pt x="6428" y="244"/>
                  </a:lnTo>
                  <a:lnTo>
                    <a:pt x="6387" y="122"/>
                  </a:lnTo>
                  <a:lnTo>
                    <a:pt x="6346" y="41"/>
                  </a:lnTo>
                  <a:lnTo>
                    <a:pt x="6265" y="41"/>
                  </a:lnTo>
                  <a:lnTo>
                    <a:pt x="6224"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3" name="Google Shape;163;p16"/>
            <p:cNvSpPr/>
            <p:nvPr/>
          </p:nvSpPr>
          <p:spPr>
            <a:xfrm flipH="1" rot="8100000">
              <a:off x="7985425" y="4705653"/>
              <a:ext cx="688850" cy="510943"/>
            </a:xfrm>
            <a:custGeom>
              <a:rect b="b" l="l" r="r" t="t"/>
              <a:pathLst>
                <a:path extrusionOk="0" h="5492" w="7404">
                  <a:moveTo>
                    <a:pt x="6712" y="366"/>
                  </a:moveTo>
                  <a:lnTo>
                    <a:pt x="6875" y="407"/>
                  </a:lnTo>
                  <a:lnTo>
                    <a:pt x="6956" y="488"/>
                  </a:lnTo>
                  <a:lnTo>
                    <a:pt x="6997" y="610"/>
                  </a:lnTo>
                  <a:lnTo>
                    <a:pt x="6997" y="773"/>
                  </a:lnTo>
                  <a:lnTo>
                    <a:pt x="6956" y="895"/>
                  </a:lnTo>
                  <a:lnTo>
                    <a:pt x="6875" y="1058"/>
                  </a:lnTo>
                  <a:lnTo>
                    <a:pt x="6712" y="1302"/>
                  </a:lnTo>
                  <a:lnTo>
                    <a:pt x="6509" y="1505"/>
                  </a:lnTo>
                  <a:lnTo>
                    <a:pt x="6305" y="1668"/>
                  </a:lnTo>
                  <a:lnTo>
                    <a:pt x="5817" y="1953"/>
                  </a:lnTo>
                  <a:lnTo>
                    <a:pt x="4760" y="2685"/>
                  </a:lnTo>
                  <a:lnTo>
                    <a:pt x="3458" y="3580"/>
                  </a:lnTo>
                  <a:lnTo>
                    <a:pt x="2116" y="4475"/>
                  </a:lnTo>
                  <a:lnTo>
                    <a:pt x="1546" y="4800"/>
                  </a:lnTo>
                  <a:lnTo>
                    <a:pt x="1262" y="4963"/>
                  </a:lnTo>
                  <a:lnTo>
                    <a:pt x="936" y="5044"/>
                  </a:lnTo>
                  <a:lnTo>
                    <a:pt x="733" y="5125"/>
                  </a:lnTo>
                  <a:lnTo>
                    <a:pt x="489" y="5125"/>
                  </a:lnTo>
                  <a:lnTo>
                    <a:pt x="407" y="5085"/>
                  </a:lnTo>
                  <a:lnTo>
                    <a:pt x="367" y="5003"/>
                  </a:lnTo>
                  <a:lnTo>
                    <a:pt x="367" y="4881"/>
                  </a:lnTo>
                  <a:lnTo>
                    <a:pt x="407" y="4759"/>
                  </a:lnTo>
                  <a:lnTo>
                    <a:pt x="489" y="4637"/>
                  </a:lnTo>
                  <a:lnTo>
                    <a:pt x="733" y="4434"/>
                  </a:lnTo>
                  <a:lnTo>
                    <a:pt x="1140" y="4027"/>
                  </a:lnTo>
                  <a:lnTo>
                    <a:pt x="1994" y="3254"/>
                  </a:lnTo>
                  <a:lnTo>
                    <a:pt x="2889" y="2482"/>
                  </a:lnTo>
                  <a:lnTo>
                    <a:pt x="3824" y="1790"/>
                  </a:lnTo>
                  <a:lnTo>
                    <a:pt x="4719" y="1180"/>
                  </a:lnTo>
                  <a:lnTo>
                    <a:pt x="5167" y="854"/>
                  </a:lnTo>
                  <a:lnTo>
                    <a:pt x="5655" y="610"/>
                  </a:lnTo>
                  <a:lnTo>
                    <a:pt x="5899" y="488"/>
                  </a:lnTo>
                  <a:lnTo>
                    <a:pt x="6183" y="407"/>
                  </a:lnTo>
                  <a:lnTo>
                    <a:pt x="6427" y="366"/>
                  </a:lnTo>
                  <a:close/>
                  <a:moveTo>
                    <a:pt x="6265" y="0"/>
                  </a:moveTo>
                  <a:lnTo>
                    <a:pt x="5980" y="82"/>
                  </a:lnTo>
                  <a:lnTo>
                    <a:pt x="5533" y="244"/>
                  </a:lnTo>
                  <a:lnTo>
                    <a:pt x="5126" y="488"/>
                  </a:lnTo>
                  <a:lnTo>
                    <a:pt x="4312" y="1017"/>
                  </a:lnTo>
                  <a:lnTo>
                    <a:pt x="3092" y="1871"/>
                  </a:lnTo>
                  <a:lnTo>
                    <a:pt x="1912" y="2807"/>
                  </a:lnTo>
                  <a:lnTo>
                    <a:pt x="814" y="3824"/>
                  </a:lnTo>
                  <a:lnTo>
                    <a:pt x="570" y="4027"/>
                  </a:lnTo>
                  <a:lnTo>
                    <a:pt x="285" y="4312"/>
                  </a:lnTo>
                  <a:lnTo>
                    <a:pt x="82" y="4597"/>
                  </a:lnTo>
                  <a:lnTo>
                    <a:pt x="1" y="4719"/>
                  </a:lnTo>
                  <a:lnTo>
                    <a:pt x="1" y="4881"/>
                  </a:lnTo>
                  <a:lnTo>
                    <a:pt x="1" y="5085"/>
                  </a:lnTo>
                  <a:lnTo>
                    <a:pt x="41" y="5207"/>
                  </a:lnTo>
                  <a:lnTo>
                    <a:pt x="123" y="5329"/>
                  </a:lnTo>
                  <a:lnTo>
                    <a:pt x="204" y="5410"/>
                  </a:lnTo>
                  <a:lnTo>
                    <a:pt x="285" y="5451"/>
                  </a:lnTo>
                  <a:lnTo>
                    <a:pt x="407" y="5492"/>
                  </a:lnTo>
                  <a:lnTo>
                    <a:pt x="692" y="5492"/>
                  </a:lnTo>
                  <a:lnTo>
                    <a:pt x="1018" y="5410"/>
                  </a:lnTo>
                  <a:lnTo>
                    <a:pt x="1302" y="5329"/>
                  </a:lnTo>
                  <a:lnTo>
                    <a:pt x="1790" y="5085"/>
                  </a:lnTo>
                  <a:lnTo>
                    <a:pt x="2523" y="4678"/>
                  </a:lnTo>
                  <a:lnTo>
                    <a:pt x="3214" y="4190"/>
                  </a:lnTo>
                  <a:lnTo>
                    <a:pt x="4597" y="3254"/>
                  </a:lnTo>
                  <a:lnTo>
                    <a:pt x="5858" y="2400"/>
                  </a:lnTo>
                  <a:lnTo>
                    <a:pt x="6387" y="2034"/>
                  </a:lnTo>
                  <a:lnTo>
                    <a:pt x="6672" y="1831"/>
                  </a:lnTo>
                  <a:lnTo>
                    <a:pt x="6916" y="1627"/>
                  </a:lnTo>
                  <a:lnTo>
                    <a:pt x="7038" y="1505"/>
                  </a:lnTo>
                  <a:lnTo>
                    <a:pt x="7160" y="1343"/>
                  </a:lnTo>
                  <a:lnTo>
                    <a:pt x="7282" y="1139"/>
                  </a:lnTo>
                  <a:lnTo>
                    <a:pt x="7363" y="936"/>
                  </a:lnTo>
                  <a:lnTo>
                    <a:pt x="7404" y="732"/>
                  </a:lnTo>
                  <a:lnTo>
                    <a:pt x="7404" y="529"/>
                  </a:lnTo>
                  <a:lnTo>
                    <a:pt x="7322" y="366"/>
                  </a:lnTo>
                  <a:lnTo>
                    <a:pt x="7200" y="204"/>
                  </a:lnTo>
                  <a:lnTo>
                    <a:pt x="7078" y="82"/>
                  </a:lnTo>
                  <a:lnTo>
                    <a:pt x="6956" y="41"/>
                  </a:lnTo>
                  <a:lnTo>
                    <a:pt x="6794"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64" name="Google Shape;164;p16"/>
          <p:cNvSpPr/>
          <p:nvPr/>
        </p:nvSpPr>
        <p:spPr>
          <a:xfrm>
            <a:off x="2548754" y="356767"/>
            <a:ext cx="85704" cy="85658"/>
          </a:xfrm>
          <a:custGeom>
            <a:rect b="b" l="l" r="r" t="t"/>
            <a:pathLst>
              <a:path extrusionOk="0" h="1872" w="1873">
                <a:moveTo>
                  <a:pt x="733" y="1"/>
                </a:moveTo>
                <a:lnTo>
                  <a:pt x="489" y="82"/>
                </a:lnTo>
                <a:lnTo>
                  <a:pt x="245" y="245"/>
                </a:lnTo>
                <a:lnTo>
                  <a:pt x="82" y="448"/>
                </a:lnTo>
                <a:lnTo>
                  <a:pt x="1" y="692"/>
                </a:lnTo>
                <a:lnTo>
                  <a:pt x="1" y="936"/>
                </a:lnTo>
                <a:lnTo>
                  <a:pt x="42" y="1180"/>
                </a:lnTo>
                <a:lnTo>
                  <a:pt x="123" y="1424"/>
                </a:lnTo>
                <a:lnTo>
                  <a:pt x="245" y="1546"/>
                </a:lnTo>
                <a:lnTo>
                  <a:pt x="367" y="1668"/>
                </a:lnTo>
                <a:lnTo>
                  <a:pt x="489" y="1750"/>
                </a:lnTo>
                <a:lnTo>
                  <a:pt x="611" y="1831"/>
                </a:lnTo>
                <a:lnTo>
                  <a:pt x="774" y="1872"/>
                </a:lnTo>
                <a:lnTo>
                  <a:pt x="1099" y="1872"/>
                </a:lnTo>
                <a:lnTo>
                  <a:pt x="1221" y="1831"/>
                </a:lnTo>
                <a:lnTo>
                  <a:pt x="1384" y="1750"/>
                </a:lnTo>
                <a:lnTo>
                  <a:pt x="1506" y="1668"/>
                </a:lnTo>
                <a:lnTo>
                  <a:pt x="1628" y="1587"/>
                </a:lnTo>
                <a:lnTo>
                  <a:pt x="1750" y="1465"/>
                </a:lnTo>
                <a:lnTo>
                  <a:pt x="1831" y="1302"/>
                </a:lnTo>
                <a:lnTo>
                  <a:pt x="1872" y="1140"/>
                </a:lnTo>
                <a:lnTo>
                  <a:pt x="1872" y="936"/>
                </a:lnTo>
                <a:lnTo>
                  <a:pt x="1831" y="774"/>
                </a:lnTo>
                <a:lnTo>
                  <a:pt x="1791" y="611"/>
                </a:lnTo>
                <a:lnTo>
                  <a:pt x="1750" y="489"/>
                </a:lnTo>
                <a:lnTo>
                  <a:pt x="1628" y="367"/>
                </a:lnTo>
                <a:lnTo>
                  <a:pt x="1547" y="245"/>
                </a:lnTo>
                <a:lnTo>
                  <a:pt x="1262" y="82"/>
                </a:lnTo>
                <a:lnTo>
                  <a:pt x="97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5" name="Google Shape;165;p16"/>
          <p:cNvSpPr/>
          <p:nvPr/>
        </p:nvSpPr>
        <p:spPr>
          <a:xfrm>
            <a:off x="6077516" y="4470667"/>
            <a:ext cx="85704" cy="85658"/>
          </a:xfrm>
          <a:custGeom>
            <a:rect b="b" l="l" r="r" t="t"/>
            <a:pathLst>
              <a:path extrusionOk="0" h="1872" w="1873">
                <a:moveTo>
                  <a:pt x="733" y="1"/>
                </a:moveTo>
                <a:lnTo>
                  <a:pt x="489" y="82"/>
                </a:lnTo>
                <a:lnTo>
                  <a:pt x="245" y="245"/>
                </a:lnTo>
                <a:lnTo>
                  <a:pt x="82" y="448"/>
                </a:lnTo>
                <a:lnTo>
                  <a:pt x="1" y="692"/>
                </a:lnTo>
                <a:lnTo>
                  <a:pt x="1" y="936"/>
                </a:lnTo>
                <a:lnTo>
                  <a:pt x="42" y="1180"/>
                </a:lnTo>
                <a:lnTo>
                  <a:pt x="123" y="1424"/>
                </a:lnTo>
                <a:lnTo>
                  <a:pt x="245" y="1546"/>
                </a:lnTo>
                <a:lnTo>
                  <a:pt x="367" y="1668"/>
                </a:lnTo>
                <a:lnTo>
                  <a:pt x="489" y="1750"/>
                </a:lnTo>
                <a:lnTo>
                  <a:pt x="611" y="1831"/>
                </a:lnTo>
                <a:lnTo>
                  <a:pt x="774" y="1872"/>
                </a:lnTo>
                <a:lnTo>
                  <a:pt x="1099" y="1872"/>
                </a:lnTo>
                <a:lnTo>
                  <a:pt x="1221" y="1831"/>
                </a:lnTo>
                <a:lnTo>
                  <a:pt x="1384" y="1750"/>
                </a:lnTo>
                <a:lnTo>
                  <a:pt x="1506" y="1668"/>
                </a:lnTo>
                <a:lnTo>
                  <a:pt x="1628" y="1587"/>
                </a:lnTo>
                <a:lnTo>
                  <a:pt x="1750" y="1465"/>
                </a:lnTo>
                <a:lnTo>
                  <a:pt x="1831" y="1302"/>
                </a:lnTo>
                <a:lnTo>
                  <a:pt x="1872" y="1140"/>
                </a:lnTo>
                <a:lnTo>
                  <a:pt x="1872" y="936"/>
                </a:lnTo>
                <a:lnTo>
                  <a:pt x="1831" y="774"/>
                </a:lnTo>
                <a:lnTo>
                  <a:pt x="1791" y="611"/>
                </a:lnTo>
                <a:lnTo>
                  <a:pt x="1750" y="489"/>
                </a:lnTo>
                <a:lnTo>
                  <a:pt x="1628" y="367"/>
                </a:lnTo>
                <a:lnTo>
                  <a:pt x="1547" y="245"/>
                </a:lnTo>
                <a:lnTo>
                  <a:pt x="1262" y="82"/>
                </a:lnTo>
                <a:lnTo>
                  <a:pt x="97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66" name="Google Shape;166;p16"/>
          <p:cNvGrpSpPr/>
          <p:nvPr/>
        </p:nvGrpSpPr>
        <p:grpSpPr>
          <a:xfrm>
            <a:off x="6412456" y="442427"/>
            <a:ext cx="307124" cy="305294"/>
            <a:chOff x="1026043" y="1162815"/>
            <a:chExt cx="307124" cy="305294"/>
          </a:xfrm>
        </p:grpSpPr>
        <p:sp>
          <p:nvSpPr>
            <p:cNvPr id="167" name="Google Shape;167;p16"/>
            <p:cNvSpPr/>
            <p:nvPr/>
          </p:nvSpPr>
          <p:spPr>
            <a:xfrm>
              <a:off x="1026043" y="1162815"/>
              <a:ext cx="307124" cy="305294"/>
            </a:xfrm>
            <a:custGeom>
              <a:rect b="b" l="l" r="r" t="t"/>
              <a:pathLst>
                <a:path extrusionOk="0" h="6672" w="6712">
                  <a:moveTo>
                    <a:pt x="2766" y="1"/>
                  </a:moveTo>
                  <a:lnTo>
                    <a:pt x="2644" y="41"/>
                  </a:lnTo>
                  <a:lnTo>
                    <a:pt x="2563" y="82"/>
                  </a:lnTo>
                  <a:lnTo>
                    <a:pt x="2441" y="163"/>
                  </a:lnTo>
                  <a:lnTo>
                    <a:pt x="2359" y="245"/>
                  </a:lnTo>
                  <a:lnTo>
                    <a:pt x="2319" y="367"/>
                  </a:lnTo>
                  <a:lnTo>
                    <a:pt x="2237" y="651"/>
                  </a:lnTo>
                  <a:lnTo>
                    <a:pt x="2197" y="936"/>
                  </a:lnTo>
                  <a:lnTo>
                    <a:pt x="2197" y="1221"/>
                  </a:lnTo>
                  <a:lnTo>
                    <a:pt x="2237" y="1506"/>
                  </a:lnTo>
                  <a:lnTo>
                    <a:pt x="2075" y="1343"/>
                  </a:lnTo>
                  <a:lnTo>
                    <a:pt x="1871" y="1221"/>
                  </a:lnTo>
                  <a:lnTo>
                    <a:pt x="1546" y="1139"/>
                  </a:lnTo>
                  <a:lnTo>
                    <a:pt x="1424" y="1099"/>
                  </a:lnTo>
                  <a:lnTo>
                    <a:pt x="1261" y="1139"/>
                  </a:lnTo>
                  <a:lnTo>
                    <a:pt x="1139" y="1180"/>
                  </a:lnTo>
                  <a:lnTo>
                    <a:pt x="1017" y="1262"/>
                  </a:lnTo>
                  <a:lnTo>
                    <a:pt x="895" y="1343"/>
                  </a:lnTo>
                  <a:lnTo>
                    <a:pt x="814" y="1506"/>
                  </a:lnTo>
                  <a:lnTo>
                    <a:pt x="773" y="1790"/>
                  </a:lnTo>
                  <a:lnTo>
                    <a:pt x="773" y="2075"/>
                  </a:lnTo>
                  <a:lnTo>
                    <a:pt x="854" y="2360"/>
                  </a:lnTo>
                  <a:lnTo>
                    <a:pt x="1017" y="2604"/>
                  </a:lnTo>
                  <a:lnTo>
                    <a:pt x="1180" y="2807"/>
                  </a:lnTo>
                  <a:lnTo>
                    <a:pt x="1383" y="3011"/>
                  </a:lnTo>
                  <a:lnTo>
                    <a:pt x="1017" y="2970"/>
                  </a:lnTo>
                  <a:lnTo>
                    <a:pt x="814" y="3011"/>
                  </a:lnTo>
                  <a:lnTo>
                    <a:pt x="651" y="3051"/>
                  </a:lnTo>
                  <a:lnTo>
                    <a:pt x="407" y="3214"/>
                  </a:lnTo>
                  <a:lnTo>
                    <a:pt x="204" y="3377"/>
                  </a:lnTo>
                  <a:lnTo>
                    <a:pt x="82" y="3621"/>
                  </a:lnTo>
                  <a:lnTo>
                    <a:pt x="0" y="3865"/>
                  </a:lnTo>
                  <a:lnTo>
                    <a:pt x="0" y="4109"/>
                  </a:lnTo>
                  <a:lnTo>
                    <a:pt x="82" y="4353"/>
                  </a:lnTo>
                  <a:lnTo>
                    <a:pt x="244" y="4516"/>
                  </a:lnTo>
                  <a:lnTo>
                    <a:pt x="488" y="4678"/>
                  </a:lnTo>
                  <a:lnTo>
                    <a:pt x="692" y="4719"/>
                  </a:lnTo>
                  <a:lnTo>
                    <a:pt x="936" y="4760"/>
                  </a:lnTo>
                  <a:lnTo>
                    <a:pt x="1424" y="4719"/>
                  </a:lnTo>
                  <a:lnTo>
                    <a:pt x="1180" y="5004"/>
                  </a:lnTo>
                  <a:lnTo>
                    <a:pt x="1098" y="5166"/>
                  </a:lnTo>
                  <a:lnTo>
                    <a:pt x="1058" y="5370"/>
                  </a:lnTo>
                  <a:lnTo>
                    <a:pt x="1017" y="5655"/>
                  </a:lnTo>
                  <a:lnTo>
                    <a:pt x="1098" y="5939"/>
                  </a:lnTo>
                  <a:lnTo>
                    <a:pt x="1139" y="6061"/>
                  </a:lnTo>
                  <a:lnTo>
                    <a:pt x="1220" y="6143"/>
                  </a:lnTo>
                  <a:lnTo>
                    <a:pt x="1342" y="6265"/>
                  </a:lnTo>
                  <a:lnTo>
                    <a:pt x="1464" y="6305"/>
                  </a:lnTo>
                  <a:lnTo>
                    <a:pt x="1709" y="6387"/>
                  </a:lnTo>
                  <a:lnTo>
                    <a:pt x="1993" y="6387"/>
                  </a:lnTo>
                  <a:lnTo>
                    <a:pt x="2237" y="6346"/>
                  </a:lnTo>
                  <a:lnTo>
                    <a:pt x="2481" y="6224"/>
                  </a:lnTo>
                  <a:lnTo>
                    <a:pt x="2685" y="6021"/>
                  </a:lnTo>
                  <a:lnTo>
                    <a:pt x="2888" y="5777"/>
                  </a:lnTo>
                  <a:lnTo>
                    <a:pt x="3010" y="6102"/>
                  </a:lnTo>
                  <a:lnTo>
                    <a:pt x="3092" y="6265"/>
                  </a:lnTo>
                  <a:lnTo>
                    <a:pt x="3173" y="6387"/>
                  </a:lnTo>
                  <a:lnTo>
                    <a:pt x="3295" y="6509"/>
                  </a:lnTo>
                  <a:lnTo>
                    <a:pt x="3417" y="6590"/>
                  </a:lnTo>
                  <a:lnTo>
                    <a:pt x="3580" y="6671"/>
                  </a:lnTo>
                  <a:lnTo>
                    <a:pt x="3905" y="6671"/>
                  </a:lnTo>
                  <a:lnTo>
                    <a:pt x="4108" y="6590"/>
                  </a:lnTo>
                  <a:lnTo>
                    <a:pt x="4312" y="6468"/>
                  </a:lnTo>
                  <a:lnTo>
                    <a:pt x="4475" y="6305"/>
                  </a:lnTo>
                  <a:lnTo>
                    <a:pt x="4597" y="6102"/>
                  </a:lnTo>
                  <a:lnTo>
                    <a:pt x="4678" y="5777"/>
                  </a:lnTo>
                  <a:lnTo>
                    <a:pt x="4678" y="5451"/>
                  </a:lnTo>
                  <a:lnTo>
                    <a:pt x="4841" y="5533"/>
                  </a:lnTo>
                  <a:lnTo>
                    <a:pt x="5003" y="5573"/>
                  </a:lnTo>
                  <a:lnTo>
                    <a:pt x="5166" y="5614"/>
                  </a:lnTo>
                  <a:lnTo>
                    <a:pt x="5329" y="5573"/>
                  </a:lnTo>
                  <a:lnTo>
                    <a:pt x="5491" y="5533"/>
                  </a:lnTo>
                  <a:lnTo>
                    <a:pt x="5654" y="5492"/>
                  </a:lnTo>
                  <a:lnTo>
                    <a:pt x="5817" y="5370"/>
                  </a:lnTo>
                  <a:lnTo>
                    <a:pt x="5939" y="5248"/>
                  </a:lnTo>
                  <a:lnTo>
                    <a:pt x="6061" y="5085"/>
                  </a:lnTo>
                  <a:lnTo>
                    <a:pt x="6142" y="4922"/>
                  </a:lnTo>
                  <a:lnTo>
                    <a:pt x="6183" y="4760"/>
                  </a:lnTo>
                  <a:lnTo>
                    <a:pt x="6224" y="4597"/>
                  </a:lnTo>
                  <a:lnTo>
                    <a:pt x="6224" y="4434"/>
                  </a:lnTo>
                  <a:lnTo>
                    <a:pt x="6183" y="4231"/>
                  </a:lnTo>
                  <a:lnTo>
                    <a:pt x="6102" y="4068"/>
                  </a:lnTo>
                  <a:lnTo>
                    <a:pt x="6020" y="3946"/>
                  </a:lnTo>
                  <a:lnTo>
                    <a:pt x="6183" y="3865"/>
                  </a:lnTo>
                  <a:lnTo>
                    <a:pt x="6346" y="3783"/>
                  </a:lnTo>
                  <a:lnTo>
                    <a:pt x="6468" y="3702"/>
                  </a:lnTo>
                  <a:lnTo>
                    <a:pt x="6549" y="3539"/>
                  </a:lnTo>
                  <a:lnTo>
                    <a:pt x="6630" y="3417"/>
                  </a:lnTo>
                  <a:lnTo>
                    <a:pt x="6712" y="3255"/>
                  </a:lnTo>
                  <a:lnTo>
                    <a:pt x="6712" y="3051"/>
                  </a:lnTo>
                  <a:lnTo>
                    <a:pt x="6712" y="2889"/>
                  </a:lnTo>
                  <a:lnTo>
                    <a:pt x="6671" y="2685"/>
                  </a:lnTo>
                  <a:lnTo>
                    <a:pt x="6590" y="2522"/>
                  </a:lnTo>
                  <a:lnTo>
                    <a:pt x="6468" y="2360"/>
                  </a:lnTo>
                  <a:lnTo>
                    <a:pt x="6346" y="2238"/>
                  </a:lnTo>
                  <a:lnTo>
                    <a:pt x="6183" y="2156"/>
                  </a:lnTo>
                  <a:lnTo>
                    <a:pt x="6020" y="2116"/>
                  </a:lnTo>
                  <a:lnTo>
                    <a:pt x="5858" y="2075"/>
                  </a:lnTo>
                  <a:lnTo>
                    <a:pt x="5654" y="2075"/>
                  </a:lnTo>
                  <a:lnTo>
                    <a:pt x="5776" y="1750"/>
                  </a:lnTo>
                  <a:lnTo>
                    <a:pt x="5817" y="1546"/>
                  </a:lnTo>
                  <a:lnTo>
                    <a:pt x="5817" y="1384"/>
                  </a:lnTo>
                  <a:lnTo>
                    <a:pt x="5776" y="1099"/>
                  </a:lnTo>
                  <a:lnTo>
                    <a:pt x="5654" y="855"/>
                  </a:lnTo>
                  <a:lnTo>
                    <a:pt x="5491" y="651"/>
                  </a:lnTo>
                  <a:lnTo>
                    <a:pt x="5369" y="570"/>
                  </a:lnTo>
                  <a:lnTo>
                    <a:pt x="5247" y="489"/>
                  </a:lnTo>
                  <a:lnTo>
                    <a:pt x="4963" y="448"/>
                  </a:lnTo>
                  <a:lnTo>
                    <a:pt x="4678" y="489"/>
                  </a:lnTo>
                  <a:lnTo>
                    <a:pt x="4434" y="570"/>
                  </a:lnTo>
                  <a:lnTo>
                    <a:pt x="4190" y="733"/>
                  </a:lnTo>
                  <a:lnTo>
                    <a:pt x="3946" y="977"/>
                  </a:lnTo>
                  <a:lnTo>
                    <a:pt x="3783" y="1262"/>
                  </a:lnTo>
                  <a:lnTo>
                    <a:pt x="3661" y="895"/>
                  </a:lnTo>
                  <a:lnTo>
                    <a:pt x="3458" y="448"/>
                  </a:lnTo>
                  <a:lnTo>
                    <a:pt x="3336" y="245"/>
                  </a:lnTo>
                  <a:lnTo>
                    <a:pt x="3132" y="82"/>
                  </a:lnTo>
                  <a:lnTo>
                    <a:pt x="3010" y="41"/>
                  </a:lnTo>
                  <a:lnTo>
                    <a:pt x="2888"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8" name="Google Shape;168;p16"/>
            <p:cNvSpPr/>
            <p:nvPr/>
          </p:nvSpPr>
          <p:spPr>
            <a:xfrm>
              <a:off x="1109780" y="1246551"/>
              <a:ext cx="169440" cy="158275"/>
            </a:xfrm>
            <a:custGeom>
              <a:rect b="b" l="l" r="r" t="t"/>
              <a:pathLst>
                <a:path extrusionOk="0" h="3459" w="3703">
                  <a:moveTo>
                    <a:pt x="1668" y="1"/>
                  </a:moveTo>
                  <a:lnTo>
                    <a:pt x="1424" y="82"/>
                  </a:lnTo>
                  <a:lnTo>
                    <a:pt x="1140" y="164"/>
                  </a:lnTo>
                  <a:lnTo>
                    <a:pt x="936" y="286"/>
                  </a:lnTo>
                  <a:lnTo>
                    <a:pt x="692" y="448"/>
                  </a:lnTo>
                  <a:lnTo>
                    <a:pt x="489" y="652"/>
                  </a:lnTo>
                  <a:lnTo>
                    <a:pt x="285" y="896"/>
                  </a:lnTo>
                  <a:lnTo>
                    <a:pt x="163" y="1140"/>
                  </a:lnTo>
                  <a:lnTo>
                    <a:pt x="41" y="1425"/>
                  </a:lnTo>
                  <a:lnTo>
                    <a:pt x="1" y="1709"/>
                  </a:lnTo>
                  <a:lnTo>
                    <a:pt x="1" y="1994"/>
                  </a:lnTo>
                  <a:lnTo>
                    <a:pt x="82" y="2320"/>
                  </a:lnTo>
                  <a:lnTo>
                    <a:pt x="204" y="2604"/>
                  </a:lnTo>
                  <a:lnTo>
                    <a:pt x="367" y="2848"/>
                  </a:lnTo>
                  <a:lnTo>
                    <a:pt x="570" y="3052"/>
                  </a:lnTo>
                  <a:lnTo>
                    <a:pt x="814" y="3214"/>
                  </a:lnTo>
                  <a:lnTo>
                    <a:pt x="1058" y="3336"/>
                  </a:lnTo>
                  <a:lnTo>
                    <a:pt x="1302" y="3418"/>
                  </a:lnTo>
                  <a:lnTo>
                    <a:pt x="1587" y="3458"/>
                  </a:lnTo>
                  <a:lnTo>
                    <a:pt x="1912" y="3458"/>
                  </a:lnTo>
                  <a:lnTo>
                    <a:pt x="2197" y="3377"/>
                  </a:lnTo>
                  <a:lnTo>
                    <a:pt x="2441" y="3255"/>
                  </a:lnTo>
                  <a:lnTo>
                    <a:pt x="2726" y="3092"/>
                  </a:lnTo>
                  <a:lnTo>
                    <a:pt x="2970" y="2889"/>
                  </a:lnTo>
                  <a:lnTo>
                    <a:pt x="3173" y="2686"/>
                  </a:lnTo>
                  <a:lnTo>
                    <a:pt x="3377" y="2401"/>
                  </a:lnTo>
                  <a:lnTo>
                    <a:pt x="3539" y="2157"/>
                  </a:lnTo>
                  <a:lnTo>
                    <a:pt x="3621" y="1831"/>
                  </a:lnTo>
                  <a:lnTo>
                    <a:pt x="3702" y="1547"/>
                  </a:lnTo>
                  <a:lnTo>
                    <a:pt x="3702" y="1303"/>
                  </a:lnTo>
                  <a:lnTo>
                    <a:pt x="3661" y="1059"/>
                  </a:lnTo>
                  <a:lnTo>
                    <a:pt x="3580" y="815"/>
                  </a:lnTo>
                  <a:lnTo>
                    <a:pt x="3458" y="611"/>
                  </a:lnTo>
                  <a:lnTo>
                    <a:pt x="3336" y="448"/>
                  </a:lnTo>
                  <a:lnTo>
                    <a:pt x="3173" y="286"/>
                  </a:lnTo>
                  <a:lnTo>
                    <a:pt x="2929" y="164"/>
                  </a:lnTo>
                  <a:lnTo>
                    <a:pt x="2726" y="82"/>
                  </a:lnTo>
                  <a:lnTo>
                    <a:pt x="2441"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69" name="Google Shape;169;p16"/>
            <p:cNvSpPr/>
            <p:nvPr/>
          </p:nvSpPr>
          <p:spPr>
            <a:xfrm>
              <a:off x="1200974" y="1274509"/>
              <a:ext cx="18669" cy="18623"/>
            </a:xfrm>
            <a:custGeom>
              <a:rect b="b" l="l" r="r" t="t"/>
              <a:pathLst>
                <a:path extrusionOk="0" h="407" w="408">
                  <a:moveTo>
                    <a:pt x="204" y="0"/>
                  </a:moveTo>
                  <a:lnTo>
                    <a:pt x="123" y="41"/>
                  </a:lnTo>
                  <a:lnTo>
                    <a:pt x="82" y="81"/>
                  </a:lnTo>
                  <a:lnTo>
                    <a:pt x="41" y="122"/>
                  </a:lnTo>
                  <a:lnTo>
                    <a:pt x="1" y="204"/>
                  </a:lnTo>
                  <a:lnTo>
                    <a:pt x="41" y="285"/>
                  </a:lnTo>
                  <a:lnTo>
                    <a:pt x="82" y="326"/>
                  </a:lnTo>
                  <a:lnTo>
                    <a:pt x="123" y="366"/>
                  </a:lnTo>
                  <a:lnTo>
                    <a:pt x="204" y="407"/>
                  </a:lnTo>
                  <a:lnTo>
                    <a:pt x="285" y="366"/>
                  </a:lnTo>
                  <a:lnTo>
                    <a:pt x="367" y="326"/>
                  </a:lnTo>
                  <a:lnTo>
                    <a:pt x="407" y="285"/>
                  </a:lnTo>
                  <a:lnTo>
                    <a:pt x="407" y="204"/>
                  </a:lnTo>
                  <a:lnTo>
                    <a:pt x="407" y="122"/>
                  </a:lnTo>
                  <a:lnTo>
                    <a:pt x="367" y="81"/>
                  </a:lnTo>
                  <a:lnTo>
                    <a:pt x="285" y="41"/>
                  </a:lnTo>
                  <a:lnTo>
                    <a:pt x="204"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0" name="Google Shape;170;p16"/>
            <p:cNvSpPr/>
            <p:nvPr/>
          </p:nvSpPr>
          <p:spPr>
            <a:xfrm>
              <a:off x="1158191" y="1281922"/>
              <a:ext cx="18623" cy="16793"/>
            </a:xfrm>
            <a:custGeom>
              <a:rect b="b" l="l" r="r" t="t"/>
              <a:pathLst>
                <a:path extrusionOk="0" h="367" w="407">
                  <a:moveTo>
                    <a:pt x="122" y="1"/>
                  </a:moveTo>
                  <a:lnTo>
                    <a:pt x="41" y="42"/>
                  </a:lnTo>
                  <a:lnTo>
                    <a:pt x="0" y="123"/>
                  </a:lnTo>
                  <a:lnTo>
                    <a:pt x="0" y="164"/>
                  </a:lnTo>
                  <a:lnTo>
                    <a:pt x="0" y="245"/>
                  </a:lnTo>
                  <a:lnTo>
                    <a:pt x="41" y="326"/>
                  </a:lnTo>
                  <a:lnTo>
                    <a:pt x="82" y="367"/>
                  </a:lnTo>
                  <a:lnTo>
                    <a:pt x="285" y="367"/>
                  </a:lnTo>
                  <a:lnTo>
                    <a:pt x="366" y="326"/>
                  </a:lnTo>
                  <a:lnTo>
                    <a:pt x="407" y="245"/>
                  </a:lnTo>
                  <a:lnTo>
                    <a:pt x="407" y="164"/>
                  </a:lnTo>
                  <a:lnTo>
                    <a:pt x="407" y="123"/>
                  </a:lnTo>
                  <a:lnTo>
                    <a:pt x="366" y="42"/>
                  </a:lnTo>
                  <a:lnTo>
                    <a:pt x="32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1" name="Google Shape;171;p16"/>
            <p:cNvSpPr/>
            <p:nvPr/>
          </p:nvSpPr>
          <p:spPr>
            <a:xfrm>
              <a:off x="1143274" y="1328457"/>
              <a:ext cx="16793" cy="18669"/>
            </a:xfrm>
            <a:custGeom>
              <a:rect b="b" l="l" r="r" t="t"/>
              <a:pathLst>
                <a:path extrusionOk="0" h="408" w="367">
                  <a:moveTo>
                    <a:pt x="123" y="1"/>
                  </a:moveTo>
                  <a:lnTo>
                    <a:pt x="41" y="82"/>
                  </a:lnTo>
                  <a:lnTo>
                    <a:pt x="1" y="123"/>
                  </a:lnTo>
                  <a:lnTo>
                    <a:pt x="1" y="204"/>
                  </a:lnTo>
                  <a:lnTo>
                    <a:pt x="1" y="285"/>
                  </a:lnTo>
                  <a:lnTo>
                    <a:pt x="41" y="326"/>
                  </a:lnTo>
                  <a:lnTo>
                    <a:pt x="123" y="367"/>
                  </a:lnTo>
                  <a:lnTo>
                    <a:pt x="204" y="407"/>
                  </a:lnTo>
                  <a:lnTo>
                    <a:pt x="285" y="367"/>
                  </a:lnTo>
                  <a:lnTo>
                    <a:pt x="326" y="326"/>
                  </a:lnTo>
                  <a:lnTo>
                    <a:pt x="367" y="285"/>
                  </a:lnTo>
                  <a:lnTo>
                    <a:pt x="367" y="204"/>
                  </a:lnTo>
                  <a:lnTo>
                    <a:pt x="367" y="123"/>
                  </a:lnTo>
                  <a:lnTo>
                    <a:pt x="326" y="82"/>
                  </a:lnTo>
                  <a:lnTo>
                    <a:pt x="28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2" name="Google Shape;172;p16"/>
            <p:cNvSpPr/>
            <p:nvPr/>
          </p:nvSpPr>
          <p:spPr>
            <a:xfrm>
              <a:off x="1182351" y="1356369"/>
              <a:ext cx="16839" cy="18669"/>
            </a:xfrm>
            <a:custGeom>
              <a:rect b="b" l="l" r="r" t="t"/>
              <a:pathLst>
                <a:path extrusionOk="0" h="408" w="368">
                  <a:moveTo>
                    <a:pt x="123" y="1"/>
                  </a:moveTo>
                  <a:lnTo>
                    <a:pt x="42" y="42"/>
                  </a:lnTo>
                  <a:lnTo>
                    <a:pt x="1" y="123"/>
                  </a:lnTo>
                  <a:lnTo>
                    <a:pt x="1" y="204"/>
                  </a:lnTo>
                  <a:lnTo>
                    <a:pt x="1" y="286"/>
                  </a:lnTo>
                  <a:lnTo>
                    <a:pt x="42" y="326"/>
                  </a:lnTo>
                  <a:lnTo>
                    <a:pt x="123" y="367"/>
                  </a:lnTo>
                  <a:lnTo>
                    <a:pt x="204" y="408"/>
                  </a:lnTo>
                  <a:lnTo>
                    <a:pt x="286" y="367"/>
                  </a:lnTo>
                  <a:lnTo>
                    <a:pt x="326" y="326"/>
                  </a:lnTo>
                  <a:lnTo>
                    <a:pt x="367" y="286"/>
                  </a:lnTo>
                  <a:lnTo>
                    <a:pt x="367" y="204"/>
                  </a:lnTo>
                  <a:lnTo>
                    <a:pt x="367" y="123"/>
                  </a:lnTo>
                  <a:lnTo>
                    <a:pt x="326" y="42"/>
                  </a:lnTo>
                  <a:lnTo>
                    <a:pt x="28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3" name="Google Shape;173;p16"/>
            <p:cNvSpPr/>
            <p:nvPr/>
          </p:nvSpPr>
          <p:spPr>
            <a:xfrm>
              <a:off x="1225180" y="1319168"/>
              <a:ext cx="18669" cy="18669"/>
            </a:xfrm>
            <a:custGeom>
              <a:rect b="b" l="l" r="r" t="t"/>
              <a:pathLst>
                <a:path extrusionOk="0" h="408" w="408">
                  <a:moveTo>
                    <a:pt x="123" y="0"/>
                  </a:moveTo>
                  <a:lnTo>
                    <a:pt x="82" y="41"/>
                  </a:lnTo>
                  <a:lnTo>
                    <a:pt x="41" y="122"/>
                  </a:lnTo>
                  <a:lnTo>
                    <a:pt x="1" y="204"/>
                  </a:lnTo>
                  <a:lnTo>
                    <a:pt x="41" y="244"/>
                  </a:lnTo>
                  <a:lnTo>
                    <a:pt x="82" y="326"/>
                  </a:lnTo>
                  <a:lnTo>
                    <a:pt x="123" y="366"/>
                  </a:lnTo>
                  <a:lnTo>
                    <a:pt x="204" y="407"/>
                  </a:lnTo>
                  <a:lnTo>
                    <a:pt x="285" y="366"/>
                  </a:lnTo>
                  <a:lnTo>
                    <a:pt x="367" y="326"/>
                  </a:lnTo>
                  <a:lnTo>
                    <a:pt x="407" y="244"/>
                  </a:lnTo>
                  <a:lnTo>
                    <a:pt x="407" y="204"/>
                  </a:lnTo>
                  <a:lnTo>
                    <a:pt x="407" y="122"/>
                  </a:lnTo>
                  <a:lnTo>
                    <a:pt x="367"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4" name="Google Shape;174;p16"/>
            <p:cNvSpPr/>
            <p:nvPr/>
          </p:nvSpPr>
          <p:spPr>
            <a:xfrm>
              <a:off x="1186103" y="1309834"/>
              <a:ext cx="18669" cy="18669"/>
            </a:xfrm>
            <a:custGeom>
              <a:rect b="b" l="l" r="r" t="t"/>
              <a:pathLst>
                <a:path extrusionOk="0" h="408" w="408">
                  <a:moveTo>
                    <a:pt x="204" y="1"/>
                  </a:moveTo>
                  <a:lnTo>
                    <a:pt x="122" y="42"/>
                  </a:lnTo>
                  <a:lnTo>
                    <a:pt x="82" y="82"/>
                  </a:lnTo>
                  <a:lnTo>
                    <a:pt x="41" y="123"/>
                  </a:lnTo>
                  <a:lnTo>
                    <a:pt x="0" y="204"/>
                  </a:lnTo>
                  <a:lnTo>
                    <a:pt x="41" y="286"/>
                  </a:lnTo>
                  <a:lnTo>
                    <a:pt x="82" y="367"/>
                  </a:lnTo>
                  <a:lnTo>
                    <a:pt x="122" y="408"/>
                  </a:lnTo>
                  <a:lnTo>
                    <a:pt x="285" y="408"/>
                  </a:lnTo>
                  <a:lnTo>
                    <a:pt x="366" y="367"/>
                  </a:lnTo>
                  <a:lnTo>
                    <a:pt x="407" y="286"/>
                  </a:lnTo>
                  <a:lnTo>
                    <a:pt x="407" y="204"/>
                  </a:lnTo>
                  <a:lnTo>
                    <a:pt x="407" y="123"/>
                  </a:lnTo>
                  <a:lnTo>
                    <a:pt x="366" y="82"/>
                  </a:lnTo>
                  <a:lnTo>
                    <a:pt x="285" y="42"/>
                  </a:lnTo>
                  <a:lnTo>
                    <a:pt x="2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175" name="Google Shape;175;p16"/>
          <p:cNvGrpSpPr/>
          <p:nvPr/>
        </p:nvGrpSpPr>
        <p:grpSpPr>
          <a:xfrm>
            <a:off x="3712948" y="1762875"/>
            <a:ext cx="309000" cy="305294"/>
            <a:chOff x="8360310" y="1124637"/>
            <a:chExt cx="309000" cy="305294"/>
          </a:xfrm>
        </p:grpSpPr>
        <p:sp>
          <p:nvSpPr>
            <p:cNvPr id="176" name="Google Shape;176;p16"/>
            <p:cNvSpPr/>
            <p:nvPr/>
          </p:nvSpPr>
          <p:spPr>
            <a:xfrm>
              <a:off x="8360310" y="1124637"/>
              <a:ext cx="309000" cy="305294"/>
            </a:xfrm>
            <a:custGeom>
              <a:rect b="b" l="l" r="r" t="t"/>
              <a:pathLst>
                <a:path extrusionOk="0" h="6672" w="6753">
                  <a:moveTo>
                    <a:pt x="2767" y="1"/>
                  </a:moveTo>
                  <a:lnTo>
                    <a:pt x="2645" y="42"/>
                  </a:lnTo>
                  <a:lnTo>
                    <a:pt x="2563" y="82"/>
                  </a:lnTo>
                  <a:lnTo>
                    <a:pt x="2441" y="164"/>
                  </a:lnTo>
                  <a:lnTo>
                    <a:pt x="2360" y="245"/>
                  </a:lnTo>
                  <a:lnTo>
                    <a:pt x="2319" y="367"/>
                  </a:lnTo>
                  <a:lnTo>
                    <a:pt x="2238" y="652"/>
                  </a:lnTo>
                  <a:lnTo>
                    <a:pt x="2197" y="937"/>
                  </a:lnTo>
                  <a:lnTo>
                    <a:pt x="2197" y="1221"/>
                  </a:lnTo>
                  <a:lnTo>
                    <a:pt x="2238" y="1506"/>
                  </a:lnTo>
                  <a:lnTo>
                    <a:pt x="2075" y="1343"/>
                  </a:lnTo>
                  <a:lnTo>
                    <a:pt x="1872" y="1221"/>
                  </a:lnTo>
                  <a:lnTo>
                    <a:pt x="1546" y="1099"/>
                  </a:lnTo>
                  <a:lnTo>
                    <a:pt x="1262" y="1099"/>
                  </a:lnTo>
                  <a:lnTo>
                    <a:pt x="1140" y="1140"/>
                  </a:lnTo>
                  <a:lnTo>
                    <a:pt x="1018" y="1221"/>
                  </a:lnTo>
                  <a:lnTo>
                    <a:pt x="895" y="1343"/>
                  </a:lnTo>
                  <a:lnTo>
                    <a:pt x="855" y="1506"/>
                  </a:lnTo>
                  <a:lnTo>
                    <a:pt x="773" y="1791"/>
                  </a:lnTo>
                  <a:lnTo>
                    <a:pt x="814" y="2075"/>
                  </a:lnTo>
                  <a:lnTo>
                    <a:pt x="855" y="2360"/>
                  </a:lnTo>
                  <a:lnTo>
                    <a:pt x="1018" y="2604"/>
                  </a:lnTo>
                  <a:lnTo>
                    <a:pt x="1180" y="2808"/>
                  </a:lnTo>
                  <a:lnTo>
                    <a:pt x="1384" y="2970"/>
                  </a:lnTo>
                  <a:lnTo>
                    <a:pt x="1018" y="2970"/>
                  </a:lnTo>
                  <a:lnTo>
                    <a:pt x="814" y="3011"/>
                  </a:lnTo>
                  <a:lnTo>
                    <a:pt x="651" y="3052"/>
                  </a:lnTo>
                  <a:lnTo>
                    <a:pt x="407" y="3174"/>
                  </a:lnTo>
                  <a:lnTo>
                    <a:pt x="204" y="3377"/>
                  </a:lnTo>
                  <a:lnTo>
                    <a:pt x="82" y="3621"/>
                  </a:lnTo>
                  <a:lnTo>
                    <a:pt x="1" y="3865"/>
                  </a:lnTo>
                  <a:lnTo>
                    <a:pt x="1" y="4109"/>
                  </a:lnTo>
                  <a:lnTo>
                    <a:pt x="82" y="4353"/>
                  </a:lnTo>
                  <a:lnTo>
                    <a:pt x="245" y="4516"/>
                  </a:lnTo>
                  <a:lnTo>
                    <a:pt x="489" y="4638"/>
                  </a:lnTo>
                  <a:lnTo>
                    <a:pt x="692" y="4719"/>
                  </a:lnTo>
                  <a:lnTo>
                    <a:pt x="936" y="4719"/>
                  </a:lnTo>
                  <a:lnTo>
                    <a:pt x="1424" y="4679"/>
                  </a:lnTo>
                  <a:lnTo>
                    <a:pt x="1424" y="4679"/>
                  </a:lnTo>
                  <a:lnTo>
                    <a:pt x="1180" y="5004"/>
                  </a:lnTo>
                  <a:lnTo>
                    <a:pt x="1099" y="5167"/>
                  </a:lnTo>
                  <a:lnTo>
                    <a:pt x="1058" y="5370"/>
                  </a:lnTo>
                  <a:lnTo>
                    <a:pt x="1018" y="5655"/>
                  </a:lnTo>
                  <a:lnTo>
                    <a:pt x="1099" y="5899"/>
                  </a:lnTo>
                  <a:lnTo>
                    <a:pt x="1140" y="6021"/>
                  </a:lnTo>
                  <a:lnTo>
                    <a:pt x="1221" y="6143"/>
                  </a:lnTo>
                  <a:lnTo>
                    <a:pt x="1343" y="6224"/>
                  </a:lnTo>
                  <a:lnTo>
                    <a:pt x="1465" y="6306"/>
                  </a:lnTo>
                  <a:lnTo>
                    <a:pt x="1709" y="6387"/>
                  </a:lnTo>
                  <a:lnTo>
                    <a:pt x="1994" y="6387"/>
                  </a:lnTo>
                  <a:lnTo>
                    <a:pt x="2238" y="6346"/>
                  </a:lnTo>
                  <a:lnTo>
                    <a:pt x="2482" y="6224"/>
                  </a:lnTo>
                  <a:lnTo>
                    <a:pt x="2726" y="6021"/>
                  </a:lnTo>
                  <a:lnTo>
                    <a:pt x="2889" y="5777"/>
                  </a:lnTo>
                  <a:lnTo>
                    <a:pt x="3011" y="6102"/>
                  </a:lnTo>
                  <a:lnTo>
                    <a:pt x="3092" y="6265"/>
                  </a:lnTo>
                  <a:lnTo>
                    <a:pt x="3173" y="6387"/>
                  </a:lnTo>
                  <a:lnTo>
                    <a:pt x="3295" y="6509"/>
                  </a:lnTo>
                  <a:lnTo>
                    <a:pt x="3417" y="6590"/>
                  </a:lnTo>
                  <a:lnTo>
                    <a:pt x="3580" y="6631"/>
                  </a:lnTo>
                  <a:lnTo>
                    <a:pt x="3743" y="6672"/>
                  </a:lnTo>
                  <a:lnTo>
                    <a:pt x="3906" y="6672"/>
                  </a:lnTo>
                  <a:lnTo>
                    <a:pt x="4109" y="6590"/>
                  </a:lnTo>
                  <a:lnTo>
                    <a:pt x="4312" y="6468"/>
                  </a:lnTo>
                  <a:lnTo>
                    <a:pt x="4475" y="6306"/>
                  </a:lnTo>
                  <a:lnTo>
                    <a:pt x="4597" y="6102"/>
                  </a:lnTo>
                  <a:lnTo>
                    <a:pt x="4678" y="5777"/>
                  </a:lnTo>
                  <a:lnTo>
                    <a:pt x="4678" y="5452"/>
                  </a:lnTo>
                  <a:lnTo>
                    <a:pt x="4841" y="5533"/>
                  </a:lnTo>
                  <a:lnTo>
                    <a:pt x="5004" y="5574"/>
                  </a:lnTo>
                  <a:lnTo>
                    <a:pt x="5329" y="5574"/>
                  </a:lnTo>
                  <a:lnTo>
                    <a:pt x="5492" y="5533"/>
                  </a:lnTo>
                  <a:lnTo>
                    <a:pt x="5655" y="5492"/>
                  </a:lnTo>
                  <a:lnTo>
                    <a:pt x="5817" y="5370"/>
                  </a:lnTo>
                  <a:lnTo>
                    <a:pt x="5939" y="5248"/>
                  </a:lnTo>
                  <a:lnTo>
                    <a:pt x="6061" y="5085"/>
                  </a:lnTo>
                  <a:lnTo>
                    <a:pt x="6143" y="4923"/>
                  </a:lnTo>
                  <a:lnTo>
                    <a:pt x="6183" y="4760"/>
                  </a:lnTo>
                  <a:lnTo>
                    <a:pt x="6224" y="4597"/>
                  </a:lnTo>
                  <a:lnTo>
                    <a:pt x="6224" y="4394"/>
                  </a:lnTo>
                  <a:lnTo>
                    <a:pt x="6183" y="4231"/>
                  </a:lnTo>
                  <a:lnTo>
                    <a:pt x="6102" y="4069"/>
                  </a:lnTo>
                  <a:lnTo>
                    <a:pt x="6021" y="3947"/>
                  </a:lnTo>
                  <a:lnTo>
                    <a:pt x="6183" y="3865"/>
                  </a:lnTo>
                  <a:lnTo>
                    <a:pt x="6346" y="3784"/>
                  </a:lnTo>
                  <a:lnTo>
                    <a:pt x="6468" y="3662"/>
                  </a:lnTo>
                  <a:lnTo>
                    <a:pt x="6590" y="3540"/>
                  </a:lnTo>
                  <a:lnTo>
                    <a:pt x="6672" y="3418"/>
                  </a:lnTo>
                  <a:lnTo>
                    <a:pt x="6712" y="3255"/>
                  </a:lnTo>
                  <a:lnTo>
                    <a:pt x="6753" y="3052"/>
                  </a:lnTo>
                  <a:lnTo>
                    <a:pt x="6712" y="2848"/>
                  </a:lnTo>
                  <a:lnTo>
                    <a:pt x="6672" y="2686"/>
                  </a:lnTo>
                  <a:lnTo>
                    <a:pt x="6590" y="2523"/>
                  </a:lnTo>
                  <a:lnTo>
                    <a:pt x="6468" y="2360"/>
                  </a:lnTo>
                  <a:lnTo>
                    <a:pt x="6346" y="2238"/>
                  </a:lnTo>
                  <a:lnTo>
                    <a:pt x="6183" y="2157"/>
                  </a:lnTo>
                  <a:lnTo>
                    <a:pt x="6021" y="2116"/>
                  </a:lnTo>
                  <a:lnTo>
                    <a:pt x="5858" y="2075"/>
                  </a:lnTo>
                  <a:lnTo>
                    <a:pt x="5695" y="2075"/>
                  </a:lnTo>
                  <a:lnTo>
                    <a:pt x="5817" y="1750"/>
                  </a:lnTo>
                  <a:lnTo>
                    <a:pt x="5817" y="1547"/>
                  </a:lnTo>
                  <a:lnTo>
                    <a:pt x="5817" y="1384"/>
                  </a:lnTo>
                  <a:lnTo>
                    <a:pt x="5777" y="1099"/>
                  </a:lnTo>
                  <a:lnTo>
                    <a:pt x="5655" y="855"/>
                  </a:lnTo>
                  <a:lnTo>
                    <a:pt x="5492" y="652"/>
                  </a:lnTo>
                  <a:lnTo>
                    <a:pt x="5370" y="570"/>
                  </a:lnTo>
                  <a:lnTo>
                    <a:pt x="5248" y="489"/>
                  </a:lnTo>
                  <a:lnTo>
                    <a:pt x="4963" y="448"/>
                  </a:lnTo>
                  <a:lnTo>
                    <a:pt x="4678" y="489"/>
                  </a:lnTo>
                  <a:lnTo>
                    <a:pt x="4434" y="570"/>
                  </a:lnTo>
                  <a:lnTo>
                    <a:pt x="4190" y="733"/>
                  </a:lnTo>
                  <a:lnTo>
                    <a:pt x="3946" y="977"/>
                  </a:lnTo>
                  <a:lnTo>
                    <a:pt x="3784" y="1262"/>
                  </a:lnTo>
                  <a:lnTo>
                    <a:pt x="3661" y="896"/>
                  </a:lnTo>
                  <a:lnTo>
                    <a:pt x="3458" y="448"/>
                  </a:lnTo>
                  <a:lnTo>
                    <a:pt x="3336" y="245"/>
                  </a:lnTo>
                  <a:lnTo>
                    <a:pt x="3133" y="82"/>
                  </a:lnTo>
                  <a:lnTo>
                    <a:pt x="3011" y="42"/>
                  </a:lnTo>
                  <a:lnTo>
                    <a:pt x="2889"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7" name="Google Shape;177;p16"/>
            <p:cNvSpPr/>
            <p:nvPr/>
          </p:nvSpPr>
          <p:spPr>
            <a:xfrm>
              <a:off x="8444093" y="1206543"/>
              <a:ext cx="169394" cy="160105"/>
            </a:xfrm>
            <a:custGeom>
              <a:rect b="b" l="l" r="r" t="t"/>
              <a:pathLst>
                <a:path extrusionOk="0" h="3499" w="3702">
                  <a:moveTo>
                    <a:pt x="2197" y="1"/>
                  </a:moveTo>
                  <a:lnTo>
                    <a:pt x="1912" y="41"/>
                  </a:lnTo>
                  <a:lnTo>
                    <a:pt x="1668" y="41"/>
                  </a:lnTo>
                  <a:lnTo>
                    <a:pt x="1424" y="123"/>
                  </a:lnTo>
                  <a:lnTo>
                    <a:pt x="1180" y="204"/>
                  </a:lnTo>
                  <a:lnTo>
                    <a:pt x="936" y="326"/>
                  </a:lnTo>
                  <a:lnTo>
                    <a:pt x="692" y="489"/>
                  </a:lnTo>
                  <a:lnTo>
                    <a:pt x="488" y="692"/>
                  </a:lnTo>
                  <a:lnTo>
                    <a:pt x="285" y="936"/>
                  </a:lnTo>
                  <a:lnTo>
                    <a:pt x="163" y="1180"/>
                  </a:lnTo>
                  <a:lnTo>
                    <a:pt x="41" y="1465"/>
                  </a:lnTo>
                  <a:lnTo>
                    <a:pt x="0" y="1750"/>
                  </a:lnTo>
                  <a:lnTo>
                    <a:pt x="41" y="2035"/>
                  </a:lnTo>
                  <a:lnTo>
                    <a:pt x="81" y="2360"/>
                  </a:lnTo>
                  <a:lnTo>
                    <a:pt x="203" y="2645"/>
                  </a:lnTo>
                  <a:lnTo>
                    <a:pt x="366" y="2889"/>
                  </a:lnTo>
                  <a:lnTo>
                    <a:pt x="570" y="3092"/>
                  </a:lnTo>
                  <a:lnTo>
                    <a:pt x="814" y="3255"/>
                  </a:lnTo>
                  <a:lnTo>
                    <a:pt x="1058" y="3377"/>
                  </a:lnTo>
                  <a:lnTo>
                    <a:pt x="1342" y="3458"/>
                  </a:lnTo>
                  <a:lnTo>
                    <a:pt x="1627" y="3499"/>
                  </a:lnTo>
                  <a:lnTo>
                    <a:pt x="1912" y="3499"/>
                  </a:lnTo>
                  <a:lnTo>
                    <a:pt x="2197" y="3417"/>
                  </a:lnTo>
                  <a:lnTo>
                    <a:pt x="2481" y="3295"/>
                  </a:lnTo>
                  <a:lnTo>
                    <a:pt x="2725" y="3133"/>
                  </a:lnTo>
                  <a:lnTo>
                    <a:pt x="2969" y="2929"/>
                  </a:lnTo>
                  <a:lnTo>
                    <a:pt x="3173" y="2726"/>
                  </a:lnTo>
                  <a:lnTo>
                    <a:pt x="3376" y="2441"/>
                  </a:lnTo>
                  <a:lnTo>
                    <a:pt x="3539" y="2157"/>
                  </a:lnTo>
                  <a:lnTo>
                    <a:pt x="3620" y="1872"/>
                  </a:lnTo>
                  <a:lnTo>
                    <a:pt x="3702" y="1587"/>
                  </a:lnTo>
                  <a:lnTo>
                    <a:pt x="3702" y="1343"/>
                  </a:lnTo>
                  <a:lnTo>
                    <a:pt x="3661" y="1099"/>
                  </a:lnTo>
                  <a:lnTo>
                    <a:pt x="3580" y="855"/>
                  </a:lnTo>
                  <a:lnTo>
                    <a:pt x="3498" y="652"/>
                  </a:lnTo>
                  <a:lnTo>
                    <a:pt x="3335" y="489"/>
                  </a:lnTo>
                  <a:lnTo>
                    <a:pt x="3173" y="326"/>
                  </a:lnTo>
                  <a:lnTo>
                    <a:pt x="2969" y="204"/>
                  </a:lnTo>
                  <a:lnTo>
                    <a:pt x="2725" y="123"/>
                  </a:lnTo>
                  <a:lnTo>
                    <a:pt x="2441" y="41"/>
                  </a:lnTo>
                  <a:lnTo>
                    <a:pt x="219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8" name="Google Shape;178;p16"/>
            <p:cNvSpPr/>
            <p:nvPr/>
          </p:nvSpPr>
          <p:spPr>
            <a:xfrm>
              <a:off x="8535287" y="1236332"/>
              <a:ext cx="18623" cy="18669"/>
            </a:xfrm>
            <a:custGeom>
              <a:rect b="b" l="l" r="r" t="t"/>
              <a:pathLst>
                <a:path extrusionOk="0" h="408" w="407">
                  <a:moveTo>
                    <a:pt x="122" y="1"/>
                  </a:moveTo>
                  <a:lnTo>
                    <a:pt x="82" y="41"/>
                  </a:lnTo>
                  <a:lnTo>
                    <a:pt x="41" y="123"/>
                  </a:lnTo>
                  <a:lnTo>
                    <a:pt x="0" y="204"/>
                  </a:lnTo>
                  <a:lnTo>
                    <a:pt x="41" y="285"/>
                  </a:lnTo>
                  <a:lnTo>
                    <a:pt x="82" y="326"/>
                  </a:lnTo>
                  <a:lnTo>
                    <a:pt x="122" y="367"/>
                  </a:lnTo>
                  <a:lnTo>
                    <a:pt x="204" y="407"/>
                  </a:lnTo>
                  <a:lnTo>
                    <a:pt x="285" y="367"/>
                  </a:lnTo>
                  <a:lnTo>
                    <a:pt x="366" y="326"/>
                  </a:lnTo>
                  <a:lnTo>
                    <a:pt x="407" y="285"/>
                  </a:lnTo>
                  <a:lnTo>
                    <a:pt x="407" y="204"/>
                  </a:lnTo>
                  <a:lnTo>
                    <a:pt x="407" y="123"/>
                  </a:lnTo>
                  <a:lnTo>
                    <a:pt x="366" y="41"/>
                  </a:lnTo>
                  <a:lnTo>
                    <a:pt x="28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79" name="Google Shape;179;p16"/>
            <p:cNvSpPr/>
            <p:nvPr/>
          </p:nvSpPr>
          <p:spPr>
            <a:xfrm>
              <a:off x="8492458" y="1241914"/>
              <a:ext cx="18669" cy="18669"/>
            </a:xfrm>
            <a:custGeom>
              <a:rect b="b" l="l" r="r" t="t"/>
              <a:pathLst>
                <a:path extrusionOk="0" h="408" w="408">
                  <a:moveTo>
                    <a:pt x="204" y="1"/>
                  </a:moveTo>
                  <a:lnTo>
                    <a:pt x="123" y="41"/>
                  </a:lnTo>
                  <a:lnTo>
                    <a:pt x="41" y="82"/>
                  </a:lnTo>
                  <a:lnTo>
                    <a:pt x="1" y="123"/>
                  </a:lnTo>
                  <a:lnTo>
                    <a:pt x="1" y="204"/>
                  </a:lnTo>
                  <a:lnTo>
                    <a:pt x="1" y="285"/>
                  </a:lnTo>
                  <a:lnTo>
                    <a:pt x="41" y="367"/>
                  </a:lnTo>
                  <a:lnTo>
                    <a:pt x="82" y="407"/>
                  </a:lnTo>
                  <a:lnTo>
                    <a:pt x="285" y="407"/>
                  </a:lnTo>
                  <a:lnTo>
                    <a:pt x="367" y="367"/>
                  </a:lnTo>
                  <a:lnTo>
                    <a:pt x="407" y="285"/>
                  </a:lnTo>
                  <a:lnTo>
                    <a:pt x="407" y="204"/>
                  </a:lnTo>
                  <a:lnTo>
                    <a:pt x="407" y="163"/>
                  </a:lnTo>
                  <a:lnTo>
                    <a:pt x="367" y="82"/>
                  </a:lnTo>
                  <a:lnTo>
                    <a:pt x="326" y="41"/>
                  </a:lnTo>
                  <a:lnTo>
                    <a:pt x="2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0" name="Google Shape;180;p16"/>
            <p:cNvSpPr/>
            <p:nvPr/>
          </p:nvSpPr>
          <p:spPr>
            <a:xfrm>
              <a:off x="8477587" y="1290326"/>
              <a:ext cx="16793" cy="18623"/>
            </a:xfrm>
            <a:custGeom>
              <a:rect b="b" l="l" r="r" t="t"/>
              <a:pathLst>
                <a:path extrusionOk="0" h="407" w="367">
                  <a:moveTo>
                    <a:pt x="122" y="0"/>
                  </a:moveTo>
                  <a:lnTo>
                    <a:pt x="41" y="41"/>
                  </a:lnTo>
                  <a:lnTo>
                    <a:pt x="0" y="122"/>
                  </a:lnTo>
                  <a:lnTo>
                    <a:pt x="0" y="204"/>
                  </a:lnTo>
                  <a:lnTo>
                    <a:pt x="0" y="285"/>
                  </a:lnTo>
                  <a:lnTo>
                    <a:pt x="41" y="326"/>
                  </a:lnTo>
                  <a:lnTo>
                    <a:pt x="122" y="366"/>
                  </a:lnTo>
                  <a:lnTo>
                    <a:pt x="204" y="407"/>
                  </a:lnTo>
                  <a:lnTo>
                    <a:pt x="285" y="366"/>
                  </a:lnTo>
                  <a:lnTo>
                    <a:pt x="326" y="326"/>
                  </a:lnTo>
                  <a:lnTo>
                    <a:pt x="366" y="285"/>
                  </a:lnTo>
                  <a:lnTo>
                    <a:pt x="366" y="204"/>
                  </a:lnTo>
                  <a:lnTo>
                    <a:pt x="366" y="122"/>
                  </a:lnTo>
                  <a:lnTo>
                    <a:pt x="326"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1" name="Google Shape;181;p16"/>
            <p:cNvSpPr/>
            <p:nvPr/>
          </p:nvSpPr>
          <p:spPr>
            <a:xfrm>
              <a:off x="8516664" y="1318238"/>
              <a:ext cx="16793" cy="18669"/>
            </a:xfrm>
            <a:custGeom>
              <a:rect b="b" l="l" r="r" t="t"/>
              <a:pathLst>
                <a:path extrusionOk="0" h="408" w="367">
                  <a:moveTo>
                    <a:pt x="122" y="0"/>
                  </a:moveTo>
                  <a:lnTo>
                    <a:pt x="41" y="41"/>
                  </a:lnTo>
                  <a:lnTo>
                    <a:pt x="0" y="122"/>
                  </a:lnTo>
                  <a:lnTo>
                    <a:pt x="0" y="204"/>
                  </a:lnTo>
                  <a:lnTo>
                    <a:pt x="0" y="244"/>
                  </a:lnTo>
                  <a:lnTo>
                    <a:pt x="41" y="326"/>
                  </a:lnTo>
                  <a:lnTo>
                    <a:pt x="122" y="366"/>
                  </a:lnTo>
                  <a:lnTo>
                    <a:pt x="204" y="407"/>
                  </a:lnTo>
                  <a:lnTo>
                    <a:pt x="285" y="366"/>
                  </a:lnTo>
                  <a:lnTo>
                    <a:pt x="326" y="326"/>
                  </a:lnTo>
                  <a:lnTo>
                    <a:pt x="367" y="244"/>
                  </a:lnTo>
                  <a:lnTo>
                    <a:pt x="367" y="204"/>
                  </a:lnTo>
                  <a:lnTo>
                    <a:pt x="367" y="122"/>
                  </a:lnTo>
                  <a:lnTo>
                    <a:pt x="326"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2" name="Google Shape;182;p16"/>
            <p:cNvSpPr/>
            <p:nvPr/>
          </p:nvSpPr>
          <p:spPr>
            <a:xfrm>
              <a:off x="8561324" y="1280991"/>
              <a:ext cx="16793" cy="16793"/>
            </a:xfrm>
            <a:custGeom>
              <a:rect b="b" l="l" r="r" t="t"/>
              <a:pathLst>
                <a:path extrusionOk="0" h="367" w="367">
                  <a:moveTo>
                    <a:pt x="82" y="1"/>
                  </a:moveTo>
                  <a:lnTo>
                    <a:pt x="41" y="41"/>
                  </a:lnTo>
                  <a:lnTo>
                    <a:pt x="1" y="123"/>
                  </a:lnTo>
                  <a:lnTo>
                    <a:pt x="1" y="163"/>
                  </a:lnTo>
                  <a:lnTo>
                    <a:pt x="1" y="245"/>
                  </a:lnTo>
                  <a:lnTo>
                    <a:pt x="41" y="326"/>
                  </a:lnTo>
                  <a:lnTo>
                    <a:pt x="82" y="367"/>
                  </a:lnTo>
                  <a:lnTo>
                    <a:pt x="245" y="367"/>
                  </a:lnTo>
                  <a:lnTo>
                    <a:pt x="326" y="326"/>
                  </a:lnTo>
                  <a:lnTo>
                    <a:pt x="367" y="245"/>
                  </a:lnTo>
                  <a:lnTo>
                    <a:pt x="367" y="163"/>
                  </a:lnTo>
                  <a:lnTo>
                    <a:pt x="367" y="123"/>
                  </a:lnTo>
                  <a:lnTo>
                    <a:pt x="326" y="41"/>
                  </a:lnTo>
                  <a:lnTo>
                    <a:pt x="24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3" name="Google Shape;183;p16"/>
            <p:cNvSpPr/>
            <p:nvPr/>
          </p:nvSpPr>
          <p:spPr>
            <a:xfrm>
              <a:off x="8522247" y="1271702"/>
              <a:ext cx="16793" cy="18669"/>
            </a:xfrm>
            <a:custGeom>
              <a:rect b="b" l="l" r="r" t="t"/>
              <a:pathLst>
                <a:path extrusionOk="0" h="408" w="367">
                  <a:moveTo>
                    <a:pt x="163" y="0"/>
                  </a:moveTo>
                  <a:lnTo>
                    <a:pt x="82" y="41"/>
                  </a:lnTo>
                  <a:lnTo>
                    <a:pt x="41" y="82"/>
                  </a:lnTo>
                  <a:lnTo>
                    <a:pt x="0" y="122"/>
                  </a:lnTo>
                  <a:lnTo>
                    <a:pt x="0" y="204"/>
                  </a:lnTo>
                  <a:lnTo>
                    <a:pt x="0" y="285"/>
                  </a:lnTo>
                  <a:lnTo>
                    <a:pt x="41" y="326"/>
                  </a:lnTo>
                  <a:lnTo>
                    <a:pt x="82" y="407"/>
                  </a:lnTo>
                  <a:lnTo>
                    <a:pt x="245" y="407"/>
                  </a:lnTo>
                  <a:lnTo>
                    <a:pt x="326" y="326"/>
                  </a:lnTo>
                  <a:lnTo>
                    <a:pt x="367" y="285"/>
                  </a:lnTo>
                  <a:lnTo>
                    <a:pt x="367" y="204"/>
                  </a:lnTo>
                  <a:lnTo>
                    <a:pt x="367" y="122"/>
                  </a:lnTo>
                  <a:lnTo>
                    <a:pt x="326" y="82"/>
                  </a:lnTo>
                  <a:lnTo>
                    <a:pt x="245" y="41"/>
                  </a:lnTo>
                  <a:lnTo>
                    <a:pt x="163"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84" name="Google Shape;184;p16"/>
          <p:cNvSpPr/>
          <p:nvPr/>
        </p:nvSpPr>
        <p:spPr>
          <a:xfrm>
            <a:off x="8120573" y="4025460"/>
            <a:ext cx="303418" cy="305294"/>
          </a:xfrm>
          <a:custGeom>
            <a:rect b="b" l="l" r="r" t="t"/>
            <a:pathLst>
              <a:path extrusionOk="0" h="6672" w="6631">
                <a:moveTo>
                  <a:pt x="3742" y="0"/>
                </a:moveTo>
                <a:lnTo>
                  <a:pt x="2766" y="41"/>
                </a:lnTo>
                <a:lnTo>
                  <a:pt x="2685" y="41"/>
                </a:lnTo>
                <a:lnTo>
                  <a:pt x="2603" y="82"/>
                </a:lnTo>
                <a:lnTo>
                  <a:pt x="2563" y="163"/>
                </a:lnTo>
                <a:lnTo>
                  <a:pt x="2563" y="244"/>
                </a:lnTo>
                <a:lnTo>
                  <a:pt x="2603" y="2644"/>
                </a:lnTo>
                <a:lnTo>
                  <a:pt x="203" y="2685"/>
                </a:lnTo>
                <a:lnTo>
                  <a:pt x="122" y="2685"/>
                </a:lnTo>
                <a:lnTo>
                  <a:pt x="41" y="2726"/>
                </a:lnTo>
                <a:lnTo>
                  <a:pt x="0" y="2807"/>
                </a:lnTo>
                <a:lnTo>
                  <a:pt x="0" y="2848"/>
                </a:lnTo>
                <a:lnTo>
                  <a:pt x="0" y="3905"/>
                </a:lnTo>
                <a:lnTo>
                  <a:pt x="41" y="3987"/>
                </a:lnTo>
                <a:lnTo>
                  <a:pt x="81" y="4068"/>
                </a:lnTo>
                <a:lnTo>
                  <a:pt x="325" y="4068"/>
                </a:lnTo>
                <a:lnTo>
                  <a:pt x="366" y="4027"/>
                </a:lnTo>
                <a:lnTo>
                  <a:pt x="529" y="4027"/>
                </a:lnTo>
                <a:lnTo>
                  <a:pt x="1139" y="3987"/>
                </a:lnTo>
                <a:lnTo>
                  <a:pt x="2603" y="3987"/>
                </a:lnTo>
                <a:lnTo>
                  <a:pt x="2644" y="6468"/>
                </a:lnTo>
                <a:lnTo>
                  <a:pt x="2644" y="6549"/>
                </a:lnTo>
                <a:lnTo>
                  <a:pt x="2685" y="6590"/>
                </a:lnTo>
                <a:lnTo>
                  <a:pt x="2766" y="6630"/>
                </a:lnTo>
                <a:lnTo>
                  <a:pt x="2847" y="6671"/>
                </a:lnTo>
                <a:lnTo>
                  <a:pt x="3864" y="6671"/>
                </a:lnTo>
                <a:lnTo>
                  <a:pt x="3946" y="6630"/>
                </a:lnTo>
                <a:lnTo>
                  <a:pt x="3986" y="6590"/>
                </a:lnTo>
                <a:lnTo>
                  <a:pt x="4068" y="6508"/>
                </a:lnTo>
                <a:lnTo>
                  <a:pt x="4027" y="6346"/>
                </a:lnTo>
                <a:lnTo>
                  <a:pt x="3986" y="6305"/>
                </a:lnTo>
                <a:lnTo>
                  <a:pt x="3905" y="6264"/>
                </a:lnTo>
                <a:lnTo>
                  <a:pt x="4027" y="6305"/>
                </a:lnTo>
                <a:lnTo>
                  <a:pt x="4027" y="6264"/>
                </a:lnTo>
                <a:lnTo>
                  <a:pt x="3986" y="6102"/>
                </a:lnTo>
                <a:lnTo>
                  <a:pt x="3986" y="5492"/>
                </a:lnTo>
                <a:lnTo>
                  <a:pt x="3946" y="3987"/>
                </a:lnTo>
                <a:lnTo>
                  <a:pt x="6508" y="3987"/>
                </a:lnTo>
                <a:lnTo>
                  <a:pt x="6549" y="3946"/>
                </a:lnTo>
                <a:lnTo>
                  <a:pt x="6630" y="3864"/>
                </a:lnTo>
                <a:lnTo>
                  <a:pt x="6630" y="3783"/>
                </a:lnTo>
                <a:lnTo>
                  <a:pt x="6630" y="2766"/>
                </a:lnTo>
                <a:lnTo>
                  <a:pt x="6590" y="2726"/>
                </a:lnTo>
                <a:lnTo>
                  <a:pt x="6549" y="2644"/>
                </a:lnTo>
                <a:lnTo>
                  <a:pt x="6508" y="2604"/>
                </a:lnTo>
                <a:lnTo>
                  <a:pt x="3946" y="2604"/>
                </a:lnTo>
                <a:lnTo>
                  <a:pt x="3946" y="204"/>
                </a:lnTo>
                <a:lnTo>
                  <a:pt x="3946" y="122"/>
                </a:lnTo>
                <a:lnTo>
                  <a:pt x="3905" y="82"/>
                </a:lnTo>
                <a:lnTo>
                  <a:pt x="3824" y="41"/>
                </a:lnTo>
                <a:lnTo>
                  <a:pt x="3742" y="0"/>
                </a:lnTo>
                <a:close/>
              </a:path>
            </a:pathLst>
          </a:custGeom>
          <a:solidFill>
            <a:schemeClr val="accen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5" name="Google Shape;185;p16"/>
          <p:cNvSpPr/>
          <p:nvPr/>
        </p:nvSpPr>
        <p:spPr>
          <a:xfrm>
            <a:off x="318460" y="2731446"/>
            <a:ext cx="303418" cy="303418"/>
          </a:xfrm>
          <a:custGeom>
            <a:rect b="b" l="l" r="r" t="t"/>
            <a:pathLst>
              <a:path extrusionOk="0" h="6631" w="6631">
                <a:moveTo>
                  <a:pt x="2685" y="1"/>
                </a:moveTo>
                <a:lnTo>
                  <a:pt x="2604" y="41"/>
                </a:lnTo>
                <a:lnTo>
                  <a:pt x="2563" y="123"/>
                </a:lnTo>
                <a:lnTo>
                  <a:pt x="2563" y="204"/>
                </a:lnTo>
                <a:lnTo>
                  <a:pt x="2604" y="2604"/>
                </a:lnTo>
                <a:lnTo>
                  <a:pt x="204" y="2645"/>
                </a:lnTo>
                <a:lnTo>
                  <a:pt x="123" y="2645"/>
                </a:lnTo>
                <a:lnTo>
                  <a:pt x="41" y="2685"/>
                </a:lnTo>
                <a:lnTo>
                  <a:pt x="1" y="2767"/>
                </a:lnTo>
                <a:lnTo>
                  <a:pt x="1" y="2807"/>
                </a:lnTo>
                <a:lnTo>
                  <a:pt x="1" y="3865"/>
                </a:lnTo>
                <a:lnTo>
                  <a:pt x="1" y="3946"/>
                </a:lnTo>
                <a:lnTo>
                  <a:pt x="82" y="4028"/>
                </a:lnTo>
                <a:lnTo>
                  <a:pt x="285" y="4028"/>
                </a:lnTo>
                <a:lnTo>
                  <a:pt x="367" y="3987"/>
                </a:lnTo>
                <a:lnTo>
                  <a:pt x="529" y="3987"/>
                </a:lnTo>
                <a:lnTo>
                  <a:pt x="1099" y="3946"/>
                </a:lnTo>
                <a:lnTo>
                  <a:pt x="2604" y="3946"/>
                </a:lnTo>
                <a:lnTo>
                  <a:pt x="2645" y="6427"/>
                </a:lnTo>
                <a:lnTo>
                  <a:pt x="2645" y="6509"/>
                </a:lnTo>
                <a:lnTo>
                  <a:pt x="2685" y="6549"/>
                </a:lnTo>
                <a:lnTo>
                  <a:pt x="2767" y="6590"/>
                </a:lnTo>
                <a:lnTo>
                  <a:pt x="2848" y="6631"/>
                </a:lnTo>
                <a:lnTo>
                  <a:pt x="3865" y="6631"/>
                </a:lnTo>
                <a:lnTo>
                  <a:pt x="3946" y="6590"/>
                </a:lnTo>
                <a:lnTo>
                  <a:pt x="3987" y="6590"/>
                </a:lnTo>
                <a:lnTo>
                  <a:pt x="4068" y="6468"/>
                </a:lnTo>
                <a:lnTo>
                  <a:pt x="4028" y="6305"/>
                </a:lnTo>
                <a:lnTo>
                  <a:pt x="4028" y="6224"/>
                </a:lnTo>
                <a:lnTo>
                  <a:pt x="3987" y="6061"/>
                </a:lnTo>
                <a:lnTo>
                  <a:pt x="3987" y="5451"/>
                </a:lnTo>
                <a:lnTo>
                  <a:pt x="3946" y="3946"/>
                </a:lnTo>
                <a:lnTo>
                  <a:pt x="6509" y="3946"/>
                </a:lnTo>
                <a:lnTo>
                  <a:pt x="6550" y="3906"/>
                </a:lnTo>
                <a:lnTo>
                  <a:pt x="6590" y="3824"/>
                </a:lnTo>
                <a:lnTo>
                  <a:pt x="6631" y="3743"/>
                </a:lnTo>
                <a:lnTo>
                  <a:pt x="6631" y="2767"/>
                </a:lnTo>
                <a:lnTo>
                  <a:pt x="6590" y="2685"/>
                </a:lnTo>
                <a:lnTo>
                  <a:pt x="6550" y="2604"/>
                </a:lnTo>
                <a:lnTo>
                  <a:pt x="6509" y="2563"/>
                </a:lnTo>
                <a:lnTo>
                  <a:pt x="3946" y="2563"/>
                </a:lnTo>
                <a:lnTo>
                  <a:pt x="3946" y="163"/>
                </a:lnTo>
                <a:lnTo>
                  <a:pt x="3946" y="123"/>
                </a:lnTo>
                <a:lnTo>
                  <a:pt x="3906" y="41"/>
                </a:lnTo>
                <a:lnTo>
                  <a:pt x="3824"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6" name="Google Shape;186;p16"/>
          <p:cNvSpPr txBox="1"/>
          <p:nvPr>
            <p:ph idx="12" type="sldNum"/>
          </p:nvPr>
        </p:nvSpPr>
        <p:spPr>
          <a:xfrm>
            <a:off x="8556784" y="4749851"/>
            <a:ext cx="548700" cy="393600"/>
          </a:xfrm>
          <a:prstGeom prst="rect">
            <a:avLst/>
          </a:prstGeom>
        </p:spPr>
        <p:txBody>
          <a:bodyPr anchorCtr="0" anchor="t"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hanks">
  <p:cSld name="CUSTOM_3_1">
    <p:spTree>
      <p:nvGrpSpPr>
        <p:cNvPr id="187" name="Shape 187"/>
        <p:cNvGrpSpPr/>
        <p:nvPr/>
      </p:nvGrpSpPr>
      <p:grpSpPr>
        <a:xfrm>
          <a:off x="0" y="0"/>
          <a:ext cx="0" cy="0"/>
          <a:chOff x="0" y="0"/>
          <a:chExt cx="0" cy="0"/>
        </a:xfrm>
      </p:grpSpPr>
      <p:sp>
        <p:nvSpPr>
          <p:cNvPr id="188" name="Google Shape;188;p17"/>
          <p:cNvSpPr/>
          <p:nvPr/>
        </p:nvSpPr>
        <p:spPr>
          <a:xfrm flipH="1" rot="10800000">
            <a:off x="-3335934" y="4390282"/>
            <a:ext cx="5171118" cy="2972279"/>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89" name="Google Shape;189;p17"/>
          <p:cNvSpPr txBox="1"/>
          <p:nvPr>
            <p:ph type="title"/>
          </p:nvPr>
        </p:nvSpPr>
        <p:spPr>
          <a:xfrm>
            <a:off x="979600" y="642175"/>
            <a:ext cx="4953900" cy="10044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sz="7000"/>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90" name="Google Shape;190;p17"/>
          <p:cNvSpPr txBox="1"/>
          <p:nvPr>
            <p:ph idx="1" type="subTitle"/>
          </p:nvPr>
        </p:nvSpPr>
        <p:spPr>
          <a:xfrm>
            <a:off x="979600" y="1901476"/>
            <a:ext cx="4953900" cy="815400"/>
          </a:xfrm>
          <a:prstGeom prst="rect">
            <a:avLst/>
          </a:prstGeom>
        </p:spPr>
        <p:txBody>
          <a:bodyPr anchorCtr="0" anchor="ctr" bIns="91425" lIns="91425" spcFirstLastPara="1" rIns="91425" wrap="square" tIns="91425">
            <a:normAutofit/>
          </a:bodyPr>
          <a:lstStyle>
            <a:lvl1pPr lvl="0">
              <a:lnSpc>
                <a:spcPct val="100000"/>
              </a:lnSpc>
              <a:spcBef>
                <a:spcPts val="0"/>
              </a:spcBef>
              <a:spcAft>
                <a:spcPts val="0"/>
              </a:spcAft>
              <a:buSzPts val="1800"/>
              <a:buNone/>
              <a:defRPr/>
            </a:lvl1pPr>
            <a:lvl2pPr lvl="1" algn="ctr">
              <a:lnSpc>
                <a:spcPct val="100000"/>
              </a:lnSpc>
              <a:spcBef>
                <a:spcPts val="0"/>
              </a:spcBef>
              <a:spcAft>
                <a:spcPts val="0"/>
              </a:spcAft>
              <a:buSzPts val="1400"/>
              <a:buNone/>
              <a:defRPr/>
            </a:lvl2pPr>
            <a:lvl3pPr lvl="2" algn="ctr">
              <a:lnSpc>
                <a:spcPct val="100000"/>
              </a:lnSpc>
              <a:spcBef>
                <a:spcPts val="0"/>
              </a:spcBef>
              <a:spcAft>
                <a:spcPts val="0"/>
              </a:spcAft>
              <a:buSzPts val="1400"/>
              <a:buNone/>
              <a:defRPr/>
            </a:lvl3pPr>
            <a:lvl4pPr lvl="3" algn="ctr">
              <a:lnSpc>
                <a:spcPct val="100000"/>
              </a:lnSpc>
              <a:spcBef>
                <a:spcPts val="0"/>
              </a:spcBef>
              <a:spcAft>
                <a:spcPts val="0"/>
              </a:spcAft>
              <a:buSzPts val="1400"/>
              <a:buNone/>
              <a:defRPr/>
            </a:lvl4pPr>
            <a:lvl5pPr lvl="4" algn="ctr">
              <a:lnSpc>
                <a:spcPct val="100000"/>
              </a:lnSpc>
              <a:spcBef>
                <a:spcPts val="0"/>
              </a:spcBef>
              <a:spcAft>
                <a:spcPts val="0"/>
              </a:spcAft>
              <a:buSzPts val="1400"/>
              <a:buNone/>
              <a:defRPr/>
            </a:lvl5pPr>
            <a:lvl6pPr lvl="5" algn="ctr">
              <a:lnSpc>
                <a:spcPct val="100000"/>
              </a:lnSpc>
              <a:spcBef>
                <a:spcPts val="0"/>
              </a:spcBef>
              <a:spcAft>
                <a:spcPts val="0"/>
              </a:spcAft>
              <a:buSzPts val="1400"/>
              <a:buNone/>
              <a:defRPr/>
            </a:lvl6pPr>
            <a:lvl7pPr lvl="6" algn="ctr">
              <a:lnSpc>
                <a:spcPct val="100000"/>
              </a:lnSpc>
              <a:spcBef>
                <a:spcPts val="0"/>
              </a:spcBef>
              <a:spcAft>
                <a:spcPts val="0"/>
              </a:spcAft>
              <a:buSzPts val="1400"/>
              <a:buNone/>
              <a:defRPr/>
            </a:lvl7pPr>
            <a:lvl8pPr lvl="7" algn="ctr">
              <a:lnSpc>
                <a:spcPct val="100000"/>
              </a:lnSpc>
              <a:spcBef>
                <a:spcPts val="0"/>
              </a:spcBef>
              <a:spcAft>
                <a:spcPts val="0"/>
              </a:spcAft>
              <a:buSzPts val="1400"/>
              <a:buNone/>
              <a:defRPr/>
            </a:lvl8pPr>
            <a:lvl9pPr lvl="8" algn="ctr">
              <a:lnSpc>
                <a:spcPct val="100000"/>
              </a:lnSpc>
              <a:spcBef>
                <a:spcPts val="0"/>
              </a:spcBef>
              <a:spcAft>
                <a:spcPts val="0"/>
              </a:spcAft>
              <a:buSzPts val="1400"/>
              <a:buNone/>
              <a:defRPr/>
            </a:lvl9pPr>
          </a:lstStyle>
          <a:p/>
        </p:txBody>
      </p:sp>
      <p:sp>
        <p:nvSpPr>
          <p:cNvPr id="191" name="Google Shape;191;p17"/>
          <p:cNvSpPr txBox="1"/>
          <p:nvPr/>
        </p:nvSpPr>
        <p:spPr>
          <a:xfrm>
            <a:off x="802375" y="3580498"/>
            <a:ext cx="4959600" cy="5127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300"/>
              </a:spcBef>
              <a:spcAft>
                <a:spcPts val="0"/>
              </a:spcAft>
              <a:buNone/>
            </a:pPr>
            <a:r>
              <a:rPr lang="en" sz="1200">
                <a:solidFill>
                  <a:schemeClr val="dk1"/>
                </a:solidFill>
                <a:latin typeface="Hind"/>
                <a:ea typeface="Hind"/>
                <a:cs typeface="Hind"/>
                <a:sym typeface="Hind"/>
              </a:rPr>
              <a:t>CREDITS: This presentation template was created by </a:t>
            </a:r>
            <a:r>
              <a:rPr b="1" lang="en" sz="1200">
                <a:solidFill>
                  <a:schemeClr val="dk1"/>
                </a:solidFill>
                <a:uFill>
                  <a:noFill/>
                </a:uFill>
                <a:latin typeface="Hind"/>
                <a:ea typeface="Hind"/>
                <a:cs typeface="Hind"/>
                <a:sym typeface="Hind"/>
                <a:hlinkClick r:id="rId2">
                  <a:extLst>
                    <a:ext uri="{A12FA001-AC4F-418D-AE19-62706E023703}">
                      <ahyp:hlinkClr val="tx"/>
                    </a:ext>
                  </a:extLst>
                </a:hlinkClick>
              </a:rPr>
              <a:t>Slidesgo</a:t>
            </a:r>
            <a:r>
              <a:rPr b="1" lang="en" sz="1200">
                <a:solidFill>
                  <a:schemeClr val="dk1"/>
                </a:solidFill>
                <a:latin typeface="Hind"/>
                <a:ea typeface="Hind"/>
                <a:cs typeface="Hind"/>
                <a:sym typeface="Hind"/>
              </a:rPr>
              <a:t>,</a:t>
            </a:r>
            <a:r>
              <a:rPr lang="en" sz="1200">
                <a:solidFill>
                  <a:schemeClr val="dk1"/>
                </a:solidFill>
                <a:latin typeface="Hind"/>
                <a:ea typeface="Hind"/>
                <a:cs typeface="Hind"/>
                <a:sym typeface="Hind"/>
              </a:rPr>
              <a:t> including icons by </a:t>
            </a:r>
            <a:r>
              <a:rPr b="1" lang="en" sz="1200">
                <a:solidFill>
                  <a:schemeClr val="dk1"/>
                </a:solidFill>
                <a:uFill>
                  <a:noFill/>
                </a:uFill>
                <a:latin typeface="Hind"/>
                <a:ea typeface="Hind"/>
                <a:cs typeface="Hind"/>
                <a:sym typeface="Hind"/>
                <a:hlinkClick r:id="rId3">
                  <a:extLst>
                    <a:ext uri="{A12FA001-AC4F-418D-AE19-62706E023703}">
                      <ahyp:hlinkClr val="tx"/>
                    </a:ext>
                  </a:extLst>
                </a:hlinkClick>
              </a:rPr>
              <a:t>Flaticon</a:t>
            </a:r>
            <a:r>
              <a:rPr lang="en" sz="1200">
                <a:solidFill>
                  <a:schemeClr val="dk1"/>
                </a:solidFill>
                <a:latin typeface="Hind"/>
                <a:ea typeface="Hind"/>
                <a:cs typeface="Hind"/>
                <a:sym typeface="Hind"/>
              </a:rPr>
              <a:t> and infographics &amp; images by </a:t>
            </a:r>
            <a:r>
              <a:rPr b="1" lang="en" sz="1200">
                <a:solidFill>
                  <a:schemeClr val="dk1"/>
                </a:solidFill>
                <a:uFill>
                  <a:noFill/>
                </a:uFill>
                <a:latin typeface="Hind"/>
                <a:ea typeface="Hind"/>
                <a:cs typeface="Hind"/>
                <a:sym typeface="Hind"/>
                <a:hlinkClick r:id="rId4">
                  <a:extLst>
                    <a:ext uri="{A12FA001-AC4F-418D-AE19-62706E023703}">
                      <ahyp:hlinkClr val="tx"/>
                    </a:ext>
                  </a:extLst>
                </a:hlinkClick>
              </a:rPr>
              <a:t>Freepik</a:t>
            </a:r>
            <a:endParaRPr b="1" sz="1200">
              <a:solidFill>
                <a:schemeClr val="dk1"/>
              </a:solidFill>
              <a:latin typeface="Hind"/>
              <a:ea typeface="Hind"/>
              <a:cs typeface="Hind"/>
              <a:sym typeface="Hind"/>
            </a:endParaRPr>
          </a:p>
        </p:txBody>
      </p:sp>
      <p:grpSp>
        <p:nvGrpSpPr>
          <p:cNvPr id="192" name="Google Shape;192;p17"/>
          <p:cNvGrpSpPr/>
          <p:nvPr/>
        </p:nvGrpSpPr>
        <p:grpSpPr>
          <a:xfrm flipH="1" rot="10800000">
            <a:off x="7693887" y="-941801"/>
            <a:ext cx="2408503" cy="2408503"/>
            <a:chOff x="7349044" y="3624409"/>
            <a:chExt cx="2408503" cy="2408503"/>
          </a:xfrm>
        </p:grpSpPr>
        <p:sp>
          <p:nvSpPr>
            <p:cNvPr id="193" name="Google Shape;193;p17"/>
            <p:cNvSpPr/>
            <p:nvPr/>
          </p:nvSpPr>
          <p:spPr>
            <a:xfrm flipH="1" rot="8100000">
              <a:off x="7661995" y="4016892"/>
              <a:ext cx="1782600" cy="1623537"/>
            </a:xfrm>
            <a:custGeom>
              <a:rect b="b" l="l" r="r" t="t"/>
              <a:pathLst>
                <a:path extrusionOk="0" h="17451" w="19160">
                  <a:moveTo>
                    <a:pt x="9682" y="0"/>
                  </a:moveTo>
                  <a:lnTo>
                    <a:pt x="9600" y="41"/>
                  </a:lnTo>
                  <a:lnTo>
                    <a:pt x="9560" y="82"/>
                  </a:lnTo>
                  <a:lnTo>
                    <a:pt x="7892" y="1668"/>
                  </a:lnTo>
                  <a:lnTo>
                    <a:pt x="6306" y="3295"/>
                  </a:lnTo>
                  <a:lnTo>
                    <a:pt x="5533" y="4109"/>
                  </a:lnTo>
                  <a:lnTo>
                    <a:pt x="4760" y="4963"/>
                  </a:lnTo>
                  <a:lnTo>
                    <a:pt x="4028" y="5858"/>
                  </a:lnTo>
                  <a:lnTo>
                    <a:pt x="3336" y="6753"/>
                  </a:lnTo>
                  <a:lnTo>
                    <a:pt x="2686" y="7688"/>
                  </a:lnTo>
                  <a:lnTo>
                    <a:pt x="2075" y="8624"/>
                  </a:lnTo>
                  <a:lnTo>
                    <a:pt x="1506" y="9600"/>
                  </a:lnTo>
                  <a:lnTo>
                    <a:pt x="1018" y="10617"/>
                  </a:lnTo>
                  <a:lnTo>
                    <a:pt x="611" y="11552"/>
                  </a:lnTo>
                  <a:lnTo>
                    <a:pt x="448" y="12000"/>
                  </a:lnTo>
                  <a:lnTo>
                    <a:pt x="286" y="12488"/>
                  </a:lnTo>
                  <a:lnTo>
                    <a:pt x="164" y="12976"/>
                  </a:lnTo>
                  <a:lnTo>
                    <a:pt x="42" y="13464"/>
                  </a:lnTo>
                  <a:lnTo>
                    <a:pt x="1" y="13993"/>
                  </a:lnTo>
                  <a:lnTo>
                    <a:pt x="1" y="14481"/>
                  </a:lnTo>
                  <a:lnTo>
                    <a:pt x="42" y="14969"/>
                  </a:lnTo>
                  <a:lnTo>
                    <a:pt x="123" y="15417"/>
                  </a:lnTo>
                  <a:lnTo>
                    <a:pt x="286" y="15823"/>
                  </a:lnTo>
                  <a:lnTo>
                    <a:pt x="489" y="16230"/>
                  </a:lnTo>
                  <a:lnTo>
                    <a:pt x="733" y="16556"/>
                  </a:lnTo>
                  <a:lnTo>
                    <a:pt x="1059" y="16881"/>
                  </a:lnTo>
                  <a:lnTo>
                    <a:pt x="1465" y="17125"/>
                  </a:lnTo>
                  <a:lnTo>
                    <a:pt x="1913" y="17288"/>
                  </a:lnTo>
                  <a:lnTo>
                    <a:pt x="2441" y="17410"/>
                  </a:lnTo>
                  <a:lnTo>
                    <a:pt x="2930" y="17450"/>
                  </a:lnTo>
                  <a:lnTo>
                    <a:pt x="3458" y="17369"/>
                  </a:lnTo>
                  <a:lnTo>
                    <a:pt x="3987" y="17288"/>
                  </a:lnTo>
                  <a:lnTo>
                    <a:pt x="4516" y="17125"/>
                  </a:lnTo>
                  <a:lnTo>
                    <a:pt x="5004" y="16922"/>
                  </a:lnTo>
                  <a:lnTo>
                    <a:pt x="5492" y="16678"/>
                  </a:lnTo>
                  <a:lnTo>
                    <a:pt x="5940" y="16434"/>
                  </a:lnTo>
                  <a:lnTo>
                    <a:pt x="7038" y="15783"/>
                  </a:lnTo>
                  <a:lnTo>
                    <a:pt x="7567" y="15498"/>
                  </a:lnTo>
                  <a:lnTo>
                    <a:pt x="8136" y="15213"/>
                  </a:lnTo>
                  <a:lnTo>
                    <a:pt x="8665" y="15051"/>
                  </a:lnTo>
                  <a:lnTo>
                    <a:pt x="9194" y="14888"/>
                  </a:lnTo>
                  <a:lnTo>
                    <a:pt x="10251" y="14644"/>
                  </a:lnTo>
                  <a:lnTo>
                    <a:pt x="11350" y="14481"/>
                  </a:lnTo>
                  <a:lnTo>
                    <a:pt x="12448" y="14278"/>
                  </a:lnTo>
                  <a:lnTo>
                    <a:pt x="13017" y="14156"/>
                  </a:lnTo>
                  <a:lnTo>
                    <a:pt x="13546" y="13993"/>
                  </a:lnTo>
                  <a:lnTo>
                    <a:pt x="14075" y="13830"/>
                  </a:lnTo>
                  <a:lnTo>
                    <a:pt x="14563" y="13627"/>
                  </a:lnTo>
                  <a:lnTo>
                    <a:pt x="15092" y="13342"/>
                  </a:lnTo>
                  <a:lnTo>
                    <a:pt x="15580" y="13017"/>
                  </a:lnTo>
                  <a:lnTo>
                    <a:pt x="16027" y="12651"/>
                  </a:lnTo>
                  <a:lnTo>
                    <a:pt x="16434" y="12244"/>
                  </a:lnTo>
                  <a:lnTo>
                    <a:pt x="16800" y="11837"/>
                  </a:lnTo>
                  <a:lnTo>
                    <a:pt x="17126" y="11390"/>
                  </a:lnTo>
                  <a:lnTo>
                    <a:pt x="17410" y="10902"/>
                  </a:lnTo>
                  <a:lnTo>
                    <a:pt x="17695" y="10413"/>
                  </a:lnTo>
                  <a:lnTo>
                    <a:pt x="17939" y="9885"/>
                  </a:lnTo>
                  <a:lnTo>
                    <a:pt x="18142" y="9356"/>
                  </a:lnTo>
                  <a:lnTo>
                    <a:pt x="18305" y="8786"/>
                  </a:lnTo>
                  <a:lnTo>
                    <a:pt x="18509" y="8258"/>
                  </a:lnTo>
                  <a:lnTo>
                    <a:pt x="18753" y="7119"/>
                  </a:lnTo>
                  <a:lnTo>
                    <a:pt x="18956" y="6020"/>
                  </a:lnTo>
                  <a:lnTo>
                    <a:pt x="19159" y="4759"/>
                  </a:lnTo>
                  <a:lnTo>
                    <a:pt x="19159" y="4678"/>
                  </a:lnTo>
                  <a:lnTo>
                    <a:pt x="19119" y="4637"/>
                  </a:lnTo>
                  <a:lnTo>
                    <a:pt x="18997" y="4556"/>
                  </a:lnTo>
                  <a:lnTo>
                    <a:pt x="18875" y="4556"/>
                  </a:lnTo>
                  <a:lnTo>
                    <a:pt x="18834" y="4597"/>
                  </a:lnTo>
                  <a:lnTo>
                    <a:pt x="18793" y="4678"/>
                  </a:lnTo>
                  <a:lnTo>
                    <a:pt x="18631" y="5776"/>
                  </a:lnTo>
                  <a:lnTo>
                    <a:pt x="18427" y="6915"/>
                  </a:lnTo>
                  <a:lnTo>
                    <a:pt x="18183" y="8014"/>
                  </a:lnTo>
                  <a:lnTo>
                    <a:pt x="18020" y="8583"/>
                  </a:lnTo>
                  <a:lnTo>
                    <a:pt x="17858" y="9112"/>
                  </a:lnTo>
                  <a:lnTo>
                    <a:pt x="17654" y="9641"/>
                  </a:lnTo>
                  <a:lnTo>
                    <a:pt x="17410" y="10129"/>
                  </a:lnTo>
                  <a:lnTo>
                    <a:pt x="17166" y="10658"/>
                  </a:lnTo>
                  <a:lnTo>
                    <a:pt x="16882" y="11105"/>
                  </a:lnTo>
                  <a:lnTo>
                    <a:pt x="16556" y="11552"/>
                  </a:lnTo>
                  <a:lnTo>
                    <a:pt x="16190" y="12000"/>
                  </a:lnTo>
                  <a:lnTo>
                    <a:pt x="15743" y="12407"/>
                  </a:lnTo>
                  <a:lnTo>
                    <a:pt x="15295" y="12732"/>
                  </a:lnTo>
                  <a:lnTo>
                    <a:pt x="14848" y="13057"/>
                  </a:lnTo>
                  <a:lnTo>
                    <a:pt x="14400" y="13301"/>
                  </a:lnTo>
                  <a:lnTo>
                    <a:pt x="13912" y="13505"/>
                  </a:lnTo>
                  <a:lnTo>
                    <a:pt x="13383" y="13668"/>
                  </a:lnTo>
                  <a:lnTo>
                    <a:pt x="12895" y="13790"/>
                  </a:lnTo>
                  <a:lnTo>
                    <a:pt x="12366" y="13912"/>
                  </a:lnTo>
                  <a:lnTo>
                    <a:pt x="11309" y="14115"/>
                  </a:lnTo>
                  <a:lnTo>
                    <a:pt x="10251" y="14278"/>
                  </a:lnTo>
                  <a:lnTo>
                    <a:pt x="9194" y="14522"/>
                  </a:lnTo>
                  <a:lnTo>
                    <a:pt x="8665" y="14644"/>
                  </a:lnTo>
                  <a:lnTo>
                    <a:pt x="8177" y="14847"/>
                  </a:lnTo>
                  <a:lnTo>
                    <a:pt x="7689" y="15051"/>
                  </a:lnTo>
                  <a:lnTo>
                    <a:pt x="7201" y="15254"/>
                  </a:lnTo>
                  <a:lnTo>
                    <a:pt x="6224" y="15823"/>
                  </a:lnTo>
                  <a:lnTo>
                    <a:pt x="5248" y="16393"/>
                  </a:lnTo>
                  <a:lnTo>
                    <a:pt x="4760" y="16637"/>
                  </a:lnTo>
                  <a:lnTo>
                    <a:pt x="4231" y="16840"/>
                  </a:lnTo>
                  <a:lnTo>
                    <a:pt x="3702" y="16962"/>
                  </a:lnTo>
                  <a:lnTo>
                    <a:pt x="3133" y="17044"/>
                  </a:lnTo>
                  <a:lnTo>
                    <a:pt x="2645" y="17044"/>
                  </a:lnTo>
                  <a:lnTo>
                    <a:pt x="2157" y="16962"/>
                  </a:lnTo>
                  <a:lnTo>
                    <a:pt x="1913" y="16922"/>
                  </a:lnTo>
                  <a:lnTo>
                    <a:pt x="1709" y="16800"/>
                  </a:lnTo>
                  <a:lnTo>
                    <a:pt x="1465" y="16718"/>
                  </a:lnTo>
                  <a:lnTo>
                    <a:pt x="1262" y="16556"/>
                  </a:lnTo>
                  <a:lnTo>
                    <a:pt x="977" y="16271"/>
                  </a:lnTo>
                  <a:lnTo>
                    <a:pt x="692" y="15905"/>
                  </a:lnTo>
                  <a:lnTo>
                    <a:pt x="530" y="15498"/>
                  </a:lnTo>
                  <a:lnTo>
                    <a:pt x="408" y="15051"/>
                  </a:lnTo>
                  <a:lnTo>
                    <a:pt x="367" y="14603"/>
                  </a:lnTo>
                  <a:lnTo>
                    <a:pt x="367" y="14115"/>
                  </a:lnTo>
                  <a:lnTo>
                    <a:pt x="408" y="13668"/>
                  </a:lnTo>
                  <a:lnTo>
                    <a:pt x="489" y="13179"/>
                  </a:lnTo>
                  <a:lnTo>
                    <a:pt x="611" y="12732"/>
                  </a:lnTo>
                  <a:lnTo>
                    <a:pt x="733" y="12285"/>
                  </a:lnTo>
                  <a:lnTo>
                    <a:pt x="1059" y="11390"/>
                  </a:lnTo>
                  <a:lnTo>
                    <a:pt x="1506" y="10413"/>
                  </a:lnTo>
                  <a:lnTo>
                    <a:pt x="2035" y="9437"/>
                  </a:lnTo>
                  <a:lnTo>
                    <a:pt x="2604" y="8502"/>
                  </a:lnTo>
                  <a:lnTo>
                    <a:pt x="3174" y="7607"/>
                  </a:lnTo>
                  <a:lnTo>
                    <a:pt x="3824" y="6712"/>
                  </a:lnTo>
                  <a:lnTo>
                    <a:pt x="4516" y="5858"/>
                  </a:lnTo>
                  <a:lnTo>
                    <a:pt x="5207" y="5004"/>
                  </a:lnTo>
                  <a:lnTo>
                    <a:pt x="5940" y="4190"/>
                  </a:lnTo>
                  <a:lnTo>
                    <a:pt x="7485" y="2604"/>
                  </a:lnTo>
                  <a:lnTo>
                    <a:pt x="9031" y="1099"/>
                  </a:lnTo>
                  <a:lnTo>
                    <a:pt x="9804" y="326"/>
                  </a:lnTo>
                  <a:lnTo>
                    <a:pt x="9845" y="244"/>
                  </a:lnTo>
                  <a:lnTo>
                    <a:pt x="9845" y="204"/>
                  </a:lnTo>
                  <a:lnTo>
                    <a:pt x="9845" y="122"/>
                  </a:lnTo>
                  <a:lnTo>
                    <a:pt x="9804" y="82"/>
                  </a:lnTo>
                  <a:lnTo>
                    <a:pt x="9763" y="41"/>
                  </a:lnTo>
                  <a:lnTo>
                    <a:pt x="9682"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4" name="Google Shape;194;p17"/>
            <p:cNvSpPr/>
            <p:nvPr/>
          </p:nvSpPr>
          <p:spPr>
            <a:xfrm flipH="1" rot="8100000">
              <a:off x="7872293" y="4243499"/>
              <a:ext cx="1634949" cy="1309454"/>
            </a:xfrm>
            <a:custGeom>
              <a:rect b="b" l="l" r="r" t="t"/>
              <a:pathLst>
                <a:path extrusionOk="0" h="14075" w="17573">
                  <a:moveTo>
                    <a:pt x="14481" y="0"/>
                  </a:moveTo>
                  <a:lnTo>
                    <a:pt x="14400" y="41"/>
                  </a:lnTo>
                  <a:lnTo>
                    <a:pt x="12447" y="1099"/>
                  </a:lnTo>
                  <a:lnTo>
                    <a:pt x="10576" y="2238"/>
                  </a:lnTo>
                  <a:lnTo>
                    <a:pt x="8705" y="3458"/>
                  </a:lnTo>
                  <a:lnTo>
                    <a:pt x="6916" y="4760"/>
                  </a:lnTo>
                  <a:lnTo>
                    <a:pt x="5207" y="6142"/>
                  </a:lnTo>
                  <a:lnTo>
                    <a:pt x="3539" y="7566"/>
                  </a:lnTo>
                  <a:lnTo>
                    <a:pt x="1872" y="9112"/>
                  </a:lnTo>
                  <a:lnTo>
                    <a:pt x="1139" y="9844"/>
                  </a:lnTo>
                  <a:lnTo>
                    <a:pt x="814" y="10251"/>
                  </a:lnTo>
                  <a:lnTo>
                    <a:pt x="489" y="10658"/>
                  </a:lnTo>
                  <a:lnTo>
                    <a:pt x="285" y="11024"/>
                  </a:lnTo>
                  <a:lnTo>
                    <a:pt x="123" y="11471"/>
                  </a:lnTo>
                  <a:lnTo>
                    <a:pt x="41" y="11919"/>
                  </a:lnTo>
                  <a:lnTo>
                    <a:pt x="1" y="12325"/>
                  </a:lnTo>
                  <a:lnTo>
                    <a:pt x="82" y="12773"/>
                  </a:lnTo>
                  <a:lnTo>
                    <a:pt x="123" y="12976"/>
                  </a:lnTo>
                  <a:lnTo>
                    <a:pt x="204" y="13179"/>
                  </a:lnTo>
                  <a:lnTo>
                    <a:pt x="326" y="13342"/>
                  </a:lnTo>
                  <a:lnTo>
                    <a:pt x="448" y="13505"/>
                  </a:lnTo>
                  <a:lnTo>
                    <a:pt x="611" y="13668"/>
                  </a:lnTo>
                  <a:lnTo>
                    <a:pt x="814" y="13830"/>
                  </a:lnTo>
                  <a:lnTo>
                    <a:pt x="1017" y="13912"/>
                  </a:lnTo>
                  <a:lnTo>
                    <a:pt x="1262" y="13993"/>
                  </a:lnTo>
                  <a:lnTo>
                    <a:pt x="1465" y="14034"/>
                  </a:lnTo>
                  <a:lnTo>
                    <a:pt x="1709" y="14074"/>
                  </a:lnTo>
                  <a:lnTo>
                    <a:pt x="2156" y="14034"/>
                  </a:lnTo>
                  <a:lnTo>
                    <a:pt x="2645" y="13952"/>
                  </a:lnTo>
                  <a:lnTo>
                    <a:pt x="3092" y="13790"/>
                  </a:lnTo>
                  <a:lnTo>
                    <a:pt x="3539" y="13627"/>
                  </a:lnTo>
                  <a:lnTo>
                    <a:pt x="4353" y="13220"/>
                  </a:lnTo>
                  <a:lnTo>
                    <a:pt x="6183" y="12407"/>
                  </a:lnTo>
                  <a:lnTo>
                    <a:pt x="7973" y="11512"/>
                  </a:lnTo>
                  <a:lnTo>
                    <a:pt x="9722" y="10576"/>
                  </a:lnTo>
                  <a:lnTo>
                    <a:pt x="10576" y="10088"/>
                  </a:lnTo>
                  <a:lnTo>
                    <a:pt x="11431" y="9559"/>
                  </a:lnTo>
                  <a:lnTo>
                    <a:pt x="12203" y="9031"/>
                  </a:lnTo>
                  <a:lnTo>
                    <a:pt x="12976" y="8461"/>
                  </a:lnTo>
                  <a:lnTo>
                    <a:pt x="13749" y="7851"/>
                  </a:lnTo>
                  <a:lnTo>
                    <a:pt x="14481" y="7241"/>
                  </a:lnTo>
                  <a:lnTo>
                    <a:pt x="15173" y="6549"/>
                  </a:lnTo>
                  <a:lnTo>
                    <a:pt x="15824" y="5858"/>
                  </a:lnTo>
                  <a:lnTo>
                    <a:pt x="16434" y="5126"/>
                  </a:lnTo>
                  <a:lnTo>
                    <a:pt x="17003" y="4353"/>
                  </a:lnTo>
                  <a:lnTo>
                    <a:pt x="17532" y="3539"/>
                  </a:lnTo>
                  <a:lnTo>
                    <a:pt x="17573" y="3458"/>
                  </a:lnTo>
                  <a:lnTo>
                    <a:pt x="17573" y="3417"/>
                  </a:lnTo>
                  <a:lnTo>
                    <a:pt x="17532" y="3336"/>
                  </a:lnTo>
                  <a:lnTo>
                    <a:pt x="17491" y="3295"/>
                  </a:lnTo>
                  <a:lnTo>
                    <a:pt x="17288" y="3295"/>
                  </a:lnTo>
                  <a:lnTo>
                    <a:pt x="17207" y="3377"/>
                  </a:lnTo>
                  <a:lnTo>
                    <a:pt x="16718" y="4149"/>
                  </a:lnTo>
                  <a:lnTo>
                    <a:pt x="16190" y="4882"/>
                  </a:lnTo>
                  <a:lnTo>
                    <a:pt x="15580" y="5573"/>
                  </a:lnTo>
                  <a:lnTo>
                    <a:pt x="14929" y="6265"/>
                  </a:lnTo>
                  <a:lnTo>
                    <a:pt x="14278" y="6915"/>
                  </a:lnTo>
                  <a:lnTo>
                    <a:pt x="13586" y="7525"/>
                  </a:lnTo>
                  <a:lnTo>
                    <a:pt x="12854" y="8095"/>
                  </a:lnTo>
                  <a:lnTo>
                    <a:pt x="12122" y="8624"/>
                  </a:lnTo>
                  <a:lnTo>
                    <a:pt x="11349" y="9153"/>
                  </a:lnTo>
                  <a:lnTo>
                    <a:pt x="10536" y="9641"/>
                  </a:lnTo>
                  <a:lnTo>
                    <a:pt x="9763" y="10129"/>
                  </a:lnTo>
                  <a:lnTo>
                    <a:pt x="8909" y="10617"/>
                  </a:lnTo>
                  <a:lnTo>
                    <a:pt x="7241" y="11471"/>
                  </a:lnTo>
                  <a:lnTo>
                    <a:pt x="5573" y="12285"/>
                  </a:lnTo>
                  <a:lnTo>
                    <a:pt x="3865" y="13057"/>
                  </a:lnTo>
                  <a:lnTo>
                    <a:pt x="2970" y="13464"/>
                  </a:lnTo>
                  <a:lnTo>
                    <a:pt x="2522" y="13586"/>
                  </a:lnTo>
                  <a:lnTo>
                    <a:pt x="2034" y="13668"/>
                  </a:lnTo>
                  <a:lnTo>
                    <a:pt x="1790" y="13708"/>
                  </a:lnTo>
                  <a:lnTo>
                    <a:pt x="1587" y="13668"/>
                  </a:lnTo>
                  <a:lnTo>
                    <a:pt x="1384" y="13627"/>
                  </a:lnTo>
                  <a:lnTo>
                    <a:pt x="1180" y="13546"/>
                  </a:lnTo>
                  <a:lnTo>
                    <a:pt x="977" y="13464"/>
                  </a:lnTo>
                  <a:lnTo>
                    <a:pt x="814" y="13342"/>
                  </a:lnTo>
                  <a:lnTo>
                    <a:pt x="651" y="13179"/>
                  </a:lnTo>
                  <a:lnTo>
                    <a:pt x="529" y="12976"/>
                  </a:lnTo>
                  <a:lnTo>
                    <a:pt x="448" y="12773"/>
                  </a:lnTo>
                  <a:lnTo>
                    <a:pt x="407" y="12529"/>
                  </a:lnTo>
                  <a:lnTo>
                    <a:pt x="367" y="12325"/>
                  </a:lnTo>
                  <a:lnTo>
                    <a:pt x="367" y="12122"/>
                  </a:lnTo>
                  <a:lnTo>
                    <a:pt x="448" y="11674"/>
                  </a:lnTo>
                  <a:lnTo>
                    <a:pt x="570" y="11268"/>
                  </a:lnTo>
                  <a:lnTo>
                    <a:pt x="855" y="10820"/>
                  </a:lnTo>
                  <a:lnTo>
                    <a:pt x="1139" y="10413"/>
                  </a:lnTo>
                  <a:lnTo>
                    <a:pt x="1506" y="10007"/>
                  </a:lnTo>
                  <a:lnTo>
                    <a:pt x="1872" y="9641"/>
                  </a:lnTo>
                  <a:lnTo>
                    <a:pt x="3377" y="8217"/>
                  </a:lnTo>
                  <a:lnTo>
                    <a:pt x="4963" y="6834"/>
                  </a:lnTo>
                  <a:lnTo>
                    <a:pt x="6590" y="5492"/>
                  </a:lnTo>
                  <a:lnTo>
                    <a:pt x="8298" y="4231"/>
                  </a:lnTo>
                  <a:lnTo>
                    <a:pt x="10048" y="3010"/>
                  </a:lnTo>
                  <a:lnTo>
                    <a:pt x="11837" y="1912"/>
                  </a:lnTo>
                  <a:lnTo>
                    <a:pt x="13668" y="855"/>
                  </a:lnTo>
                  <a:lnTo>
                    <a:pt x="14603" y="366"/>
                  </a:lnTo>
                  <a:lnTo>
                    <a:pt x="14644" y="285"/>
                  </a:lnTo>
                  <a:lnTo>
                    <a:pt x="14685" y="244"/>
                  </a:lnTo>
                  <a:lnTo>
                    <a:pt x="14685" y="163"/>
                  </a:lnTo>
                  <a:lnTo>
                    <a:pt x="14644" y="122"/>
                  </a:lnTo>
                  <a:lnTo>
                    <a:pt x="14603" y="41"/>
                  </a:lnTo>
                  <a:lnTo>
                    <a:pt x="14563"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5" name="Google Shape;195;p17"/>
            <p:cNvSpPr/>
            <p:nvPr/>
          </p:nvSpPr>
          <p:spPr>
            <a:xfrm flipH="1" rot="8100000">
              <a:off x="7985425" y="4705653"/>
              <a:ext cx="688850" cy="510943"/>
            </a:xfrm>
            <a:custGeom>
              <a:rect b="b" l="l" r="r" t="t"/>
              <a:pathLst>
                <a:path extrusionOk="0" h="5492" w="7404">
                  <a:moveTo>
                    <a:pt x="6712" y="366"/>
                  </a:moveTo>
                  <a:lnTo>
                    <a:pt x="6875" y="407"/>
                  </a:lnTo>
                  <a:lnTo>
                    <a:pt x="6956" y="488"/>
                  </a:lnTo>
                  <a:lnTo>
                    <a:pt x="6997" y="610"/>
                  </a:lnTo>
                  <a:lnTo>
                    <a:pt x="6997" y="773"/>
                  </a:lnTo>
                  <a:lnTo>
                    <a:pt x="6956" y="895"/>
                  </a:lnTo>
                  <a:lnTo>
                    <a:pt x="6875" y="1058"/>
                  </a:lnTo>
                  <a:lnTo>
                    <a:pt x="6712" y="1302"/>
                  </a:lnTo>
                  <a:lnTo>
                    <a:pt x="6509" y="1505"/>
                  </a:lnTo>
                  <a:lnTo>
                    <a:pt x="6305" y="1668"/>
                  </a:lnTo>
                  <a:lnTo>
                    <a:pt x="5817" y="1953"/>
                  </a:lnTo>
                  <a:lnTo>
                    <a:pt x="4760" y="2685"/>
                  </a:lnTo>
                  <a:lnTo>
                    <a:pt x="3458" y="3580"/>
                  </a:lnTo>
                  <a:lnTo>
                    <a:pt x="2116" y="4475"/>
                  </a:lnTo>
                  <a:lnTo>
                    <a:pt x="1546" y="4800"/>
                  </a:lnTo>
                  <a:lnTo>
                    <a:pt x="1262" y="4963"/>
                  </a:lnTo>
                  <a:lnTo>
                    <a:pt x="936" y="5044"/>
                  </a:lnTo>
                  <a:lnTo>
                    <a:pt x="733" y="5125"/>
                  </a:lnTo>
                  <a:lnTo>
                    <a:pt x="489" y="5125"/>
                  </a:lnTo>
                  <a:lnTo>
                    <a:pt x="407" y="5085"/>
                  </a:lnTo>
                  <a:lnTo>
                    <a:pt x="367" y="5003"/>
                  </a:lnTo>
                  <a:lnTo>
                    <a:pt x="367" y="4881"/>
                  </a:lnTo>
                  <a:lnTo>
                    <a:pt x="407" y="4759"/>
                  </a:lnTo>
                  <a:lnTo>
                    <a:pt x="489" y="4637"/>
                  </a:lnTo>
                  <a:lnTo>
                    <a:pt x="733" y="4434"/>
                  </a:lnTo>
                  <a:lnTo>
                    <a:pt x="1140" y="4027"/>
                  </a:lnTo>
                  <a:lnTo>
                    <a:pt x="1994" y="3254"/>
                  </a:lnTo>
                  <a:lnTo>
                    <a:pt x="2889" y="2482"/>
                  </a:lnTo>
                  <a:lnTo>
                    <a:pt x="3824" y="1790"/>
                  </a:lnTo>
                  <a:lnTo>
                    <a:pt x="4719" y="1180"/>
                  </a:lnTo>
                  <a:lnTo>
                    <a:pt x="5167" y="854"/>
                  </a:lnTo>
                  <a:lnTo>
                    <a:pt x="5655" y="610"/>
                  </a:lnTo>
                  <a:lnTo>
                    <a:pt x="5899" y="488"/>
                  </a:lnTo>
                  <a:lnTo>
                    <a:pt x="6183" y="407"/>
                  </a:lnTo>
                  <a:lnTo>
                    <a:pt x="6427" y="366"/>
                  </a:lnTo>
                  <a:close/>
                  <a:moveTo>
                    <a:pt x="6265" y="0"/>
                  </a:moveTo>
                  <a:lnTo>
                    <a:pt x="5980" y="82"/>
                  </a:lnTo>
                  <a:lnTo>
                    <a:pt x="5533" y="244"/>
                  </a:lnTo>
                  <a:lnTo>
                    <a:pt x="5126" y="488"/>
                  </a:lnTo>
                  <a:lnTo>
                    <a:pt x="4312" y="1017"/>
                  </a:lnTo>
                  <a:lnTo>
                    <a:pt x="3092" y="1871"/>
                  </a:lnTo>
                  <a:lnTo>
                    <a:pt x="1912" y="2807"/>
                  </a:lnTo>
                  <a:lnTo>
                    <a:pt x="814" y="3824"/>
                  </a:lnTo>
                  <a:lnTo>
                    <a:pt x="570" y="4027"/>
                  </a:lnTo>
                  <a:lnTo>
                    <a:pt x="285" y="4312"/>
                  </a:lnTo>
                  <a:lnTo>
                    <a:pt x="82" y="4597"/>
                  </a:lnTo>
                  <a:lnTo>
                    <a:pt x="1" y="4719"/>
                  </a:lnTo>
                  <a:lnTo>
                    <a:pt x="1" y="4881"/>
                  </a:lnTo>
                  <a:lnTo>
                    <a:pt x="1" y="5085"/>
                  </a:lnTo>
                  <a:lnTo>
                    <a:pt x="41" y="5207"/>
                  </a:lnTo>
                  <a:lnTo>
                    <a:pt x="123" y="5329"/>
                  </a:lnTo>
                  <a:lnTo>
                    <a:pt x="204" y="5410"/>
                  </a:lnTo>
                  <a:lnTo>
                    <a:pt x="285" y="5451"/>
                  </a:lnTo>
                  <a:lnTo>
                    <a:pt x="407" y="5492"/>
                  </a:lnTo>
                  <a:lnTo>
                    <a:pt x="692" y="5492"/>
                  </a:lnTo>
                  <a:lnTo>
                    <a:pt x="1018" y="5410"/>
                  </a:lnTo>
                  <a:lnTo>
                    <a:pt x="1302" y="5329"/>
                  </a:lnTo>
                  <a:lnTo>
                    <a:pt x="1790" y="5085"/>
                  </a:lnTo>
                  <a:lnTo>
                    <a:pt x="2523" y="4678"/>
                  </a:lnTo>
                  <a:lnTo>
                    <a:pt x="3214" y="4190"/>
                  </a:lnTo>
                  <a:lnTo>
                    <a:pt x="4597" y="3254"/>
                  </a:lnTo>
                  <a:lnTo>
                    <a:pt x="5858" y="2400"/>
                  </a:lnTo>
                  <a:lnTo>
                    <a:pt x="6387" y="2034"/>
                  </a:lnTo>
                  <a:lnTo>
                    <a:pt x="6672" y="1831"/>
                  </a:lnTo>
                  <a:lnTo>
                    <a:pt x="6916" y="1627"/>
                  </a:lnTo>
                  <a:lnTo>
                    <a:pt x="7038" y="1505"/>
                  </a:lnTo>
                  <a:lnTo>
                    <a:pt x="7160" y="1343"/>
                  </a:lnTo>
                  <a:lnTo>
                    <a:pt x="7282" y="1139"/>
                  </a:lnTo>
                  <a:lnTo>
                    <a:pt x="7363" y="936"/>
                  </a:lnTo>
                  <a:lnTo>
                    <a:pt x="7404" y="732"/>
                  </a:lnTo>
                  <a:lnTo>
                    <a:pt x="7404" y="529"/>
                  </a:lnTo>
                  <a:lnTo>
                    <a:pt x="7322" y="366"/>
                  </a:lnTo>
                  <a:lnTo>
                    <a:pt x="7200" y="204"/>
                  </a:lnTo>
                  <a:lnTo>
                    <a:pt x="7078" y="82"/>
                  </a:lnTo>
                  <a:lnTo>
                    <a:pt x="6956" y="41"/>
                  </a:lnTo>
                  <a:lnTo>
                    <a:pt x="6794"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6" name="Google Shape;196;p17"/>
            <p:cNvSpPr/>
            <p:nvPr/>
          </p:nvSpPr>
          <p:spPr>
            <a:xfrm flipH="1" rot="8100000">
              <a:off x="8893413" y="4510443"/>
              <a:ext cx="673778" cy="582858"/>
            </a:xfrm>
            <a:custGeom>
              <a:rect b="b" l="l" r="r" t="t"/>
              <a:pathLst>
                <a:path extrusionOk="0" h="6265" w="7242">
                  <a:moveTo>
                    <a:pt x="6224" y="0"/>
                  </a:moveTo>
                  <a:lnTo>
                    <a:pt x="6143" y="41"/>
                  </a:lnTo>
                  <a:lnTo>
                    <a:pt x="3092" y="2319"/>
                  </a:lnTo>
                  <a:lnTo>
                    <a:pt x="1547" y="3498"/>
                  </a:lnTo>
                  <a:lnTo>
                    <a:pt x="896" y="3986"/>
                  </a:lnTo>
                  <a:lnTo>
                    <a:pt x="570" y="4271"/>
                  </a:lnTo>
                  <a:lnTo>
                    <a:pt x="326" y="4556"/>
                  </a:lnTo>
                  <a:lnTo>
                    <a:pt x="164" y="4800"/>
                  </a:lnTo>
                  <a:lnTo>
                    <a:pt x="42" y="5085"/>
                  </a:lnTo>
                  <a:lnTo>
                    <a:pt x="1" y="5410"/>
                  </a:lnTo>
                  <a:lnTo>
                    <a:pt x="82" y="5695"/>
                  </a:lnTo>
                  <a:lnTo>
                    <a:pt x="204" y="5980"/>
                  </a:lnTo>
                  <a:lnTo>
                    <a:pt x="326" y="6061"/>
                  </a:lnTo>
                  <a:lnTo>
                    <a:pt x="448" y="6142"/>
                  </a:lnTo>
                  <a:lnTo>
                    <a:pt x="570" y="6224"/>
                  </a:lnTo>
                  <a:lnTo>
                    <a:pt x="692" y="6264"/>
                  </a:lnTo>
                  <a:lnTo>
                    <a:pt x="977" y="6264"/>
                  </a:lnTo>
                  <a:lnTo>
                    <a:pt x="1181" y="6183"/>
                  </a:lnTo>
                  <a:lnTo>
                    <a:pt x="1343" y="6102"/>
                  </a:lnTo>
                  <a:lnTo>
                    <a:pt x="1709" y="5898"/>
                  </a:lnTo>
                  <a:lnTo>
                    <a:pt x="2482" y="5329"/>
                  </a:lnTo>
                  <a:lnTo>
                    <a:pt x="3987" y="4271"/>
                  </a:lnTo>
                  <a:lnTo>
                    <a:pt x="5614" y="2970"/>
                  </a:lnTo>
                  <a:lnTo>
                    <a:pt x="7160" y="1668"/>
                  </a:lnTo>
                  <a:lnTo>
                    <a:pt x="7241" y="1587"/>
                  </a:lnTo>
                  <a:lnTo>
                    <a:pt x="7241" y="1546"/>
                  </a:lnTo>
                  <a:lnTo>
                    <a:pt x="7201" y="1465"/>
                  </a:lnTo>
                  <a:lnTo>
                    <a:pt x="7160" y="1424"/>
                  </a:lnTo>
                  <a:lnTo>
                    <a:pt x="7038" y="1343"/>
                  </a:lnTo>
                  <a:lnTo>
                    <a:pt x="6997" y="1343"/>
                  </a:lnTo>
                  <a:lnTo>
                    <a:pt x="6916" y="1383"/>
                  </a:lnTo>
                  <a:lnTo>
                    <a:pt x="5655" y="2441"/>
                  </a:lnTo>
                  <a:lnTo>
                    <a:pt x="4394" y="3458"/>
                  </a:lnTo>
                  <a:lnTo>
                    <a:pt x="3092" y="4434"/>
                  </a:lnTo>
                  <a:lnTo>
                    <a:pt x="1750" y="5410"/>
                  </a:lnTo>
                  <a:lnTo>
                    <a:pt x="1465" y="5613"/>
                  </a:lnTo>
                  <a:lnTo>
                    <a:pt x="1140" y="5817"/>
                  </a:lnTo>
                  <a:lnTo>
                    <a:pt x="936" y="5858"/>
                  </a:lnTo>
                  <a:lnTo>
                    <a:pt x="774" y="5898"/>
                  </a:lnTo>
                  <a:lnTo>
                    <a:pt x="611" y="5858"/>
                  </a:lnTo>
                  <a:lnTo>
                    <a:pt x="489" y="5695"/>
                  </a:lnTo>
                  <a:lnTo>
                    <a:pt x="408" y="5573"/>
                  </a:lnTo>
                  <a:lnTo>
                    <a:pt x="367" y="5451"/>
                  </a:lnTo>
                  <a:lnTo>
                    <a:pt x="367" y="5288"/>
                  </a:lnTo>
                  <a:lnTo>
                    <a:pt x="408" y="5166"/>
                  </a:lnTo>
                  <a:lnTo>
                    <a:pt x="530" y="4881"/>
                  </a:lnTo>
                  <a:lnTo>
                    <a:pt x="733" y="4637"/>
                  </a:lnTo>
                  <a:lnTo>
                    <a:pt x="1018" y="4393"/>
                  </a:lnTo>
                  <a:lnTo>
                    <a:pt x="1303" y="4149"/>
                  </a:lnTo>
                  <a:lnTo>
                    <a:pt x="1913" y="3661"/>
                  </a:lnTo>
                  <a:lnTo>
                    <a:pt x="3255" y="2644"/>
                  </a:lnTo>
                  <a:lnTo>
                    <a:pt x="6346" y="366"/>
                  </a:lnTo>
                  <a:lnTo>
                    <a:pt x="6387" y="326"/>
                  </a:lnTo>
                  <a:lnTo>
                    <a:pt x="6428" y="244"/>
                  </a:lnTo>
                  <a:lnTo>
                    <a:pt x="6387" y="122"/>
                  </a:lnTo>
                  <a:lnTo>
                    <a:pt x="6346" y="41"/>
                  </a:lnTo>
                  <a:lnTo>
                    <a:pt x="6265" y="41"/>
                  </a:lnTo>
                  <a:lnTo>
                    <a:pt x="6224" y="0"/>
                  </a:lnTo>
                  <a:close/>
                </a:path>
              </a:pathLst>
            </a:custGeom>
            <a:solidFill>
              <a:schemeClr val="accent1"/>
            </a:solidFill>
            <a:ln cap="flat" cmpd="sng" w="9525">
              <a:solidFill>
                <a:schemeClr val="accen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197" name="Google Shape;197;p17"/>
          <p:cNvSpPr/>
          <p:nvPr/>
        </p:nvSpPr>
        <p:spPr>
          <a:xfrm flipH="1" rot="10800000">
            <a:off x="6652416" y="-1583268"/>
            <a:ext cx="5171118" cy="2972279"/>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98" name="Google Shape;198;p17"/>
          <p:cNvSpPr/>
          <p:nvPr/>
        </p:nvSpPr>
        <p:spPr>
          <a:xfrm flipH="1" rot="10800000">
            <a:off x="215042" y="2494309"/>
            <a:ext cx="85658" cy="85658"/>
          </a:xfrm>
          <a:custGeom>
            <a:rect b="b" l="l" r="r" t="t"/>
            <a:pathLst>
              <a:path extrusionOk="0" h="1872" w="1872">
                <a:moveTo>
                  <a:pt x="733" y="1"/>
                </a:moveTo>
                <a:lnTo>
                  <a:pt x="489" y="82"/>
                </a:lnTo>
                <a:lnTo>
                  <a:pt x="286" y="245"/>
                </a:lnTo>
                <a:lnTo>
                  <a:pt x="123" y="448"/>
                </a:lnTo>
                <a:lnTo>
                  <a:pt x="1" y="692"/>
                </a:lnTo>
                <a:lnTo>
                  <a:pt x="1" y="936"/>
                </a:lnTo>
                <a:lnTo>
                  <a:pt x="41" y="1221"/>
                </a:lnTo>
                <a:lnTo>
                  <a:pt x="164" y="1424"/>
                </a:lnTo>
                <a:lnTo>
                  <a:pt x="245" y="1587"/>
                </a:lnTo>
                <a:lnTo>
                  <a:pt x="367" y="1668"/>
                </a:lnTo>
                <a:lnTo>
                  <a:pt x="489" y="1750"/>
                </a:lnTo>
                <a:lnTo>
                  <a:pt x="652" y="1831"/>
                </a:lnTo>
                <a:lnTo>
                  <a:pt x="774" y="1872"/>
                </a:lnTo>
                <a:lnTo>
                  <a:pt x="1099" y="1872"/>
                </a:lnTo>
                <a:lnTo>
                  <a:pt x="1262" y="1831"/>
                </a:lnTo>
                <a:lnTo>
                  <a:pt x="1384" y="1790"/>
                </a:lnTo>
                <a:lnTo>
                  <a:pt x="1546" y="1709"/>
                </a:lnTo>
                <a:lnTo>
                  <a:pt x="1628" y="1587"/>
                </a:lnTo>
                <a:lnTo>
                  <a:pt x="1750" y="1465"/>
                </a:lnTo>
                <a:lnTo>
                  <a:pt x="1831" y="1302"/>
                </a:lnTo>
                <a:lnTo>
                  <a:pt x="1872" y="1140"/>
                </a:lnTo>
                <a:lnTo>
                  <a:pt x="1872" y="977"/>
                </a:lnTo>
                <a:lnTo>
                  <a:pt x="1872" y="773"/>
                </a:lnTo>
                <a:lnTo>
                  <a:pt x="1831" y="651"/>
                </a:lnTo>
                <a:lnTo>
                  <a:pt x="1750" y="489"/>
                </a:lnTo>
                <a:lnTo>
                  <a:pt x="1669" y="367"/>
                </a:lnTo>
                <a:lnTo>
                  <a:pt x="1546" y="245"/>
                </a:lnTo>
                <a:lnTo>
                  <a:pt x="1302" y="82"/>
                </a:lnTo>
                <a:lnTo>
                  <a:pt x="977"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199" name="Google Shape;199;p17"/>
          <p:cNvGrpSpPr/>
          <p:nvPr/>
        </p:nvGrpSpPr>
        <p:grpSpPr>
          <a:xfrm flipH="1">
            <a:off x="-1113124" y="-1583272"/>
            <a:ext cx="1915490" cy="2459786"/>
            <a:chOff x="2659350" y="1746500"/>
            <a:chExt cx="379350" cy="487125"/>
          </a:xfrm>
        </p:grpSpPr>
        <p:sp>
          <p:nvSpPr>
            <p:cNvPr id="200" name="Google Shape;200;p17"/>
            <p:cNvSpPr/>
            <p:nvPr/>
          </p:nvSpPr>
          <p:spPr>
            <a:xfrm>
              <a:off x="2659350" y="1746500"/>
              <a:ext cx="379350" cy="487125"/>
            </a:xfrm>
            <a:custGeom>
              <a:rect b="b" l="l" r="r" t="t"/>
              <a:pathLst>
                <a:path extrusionOk="0" h="19485" w="15174">
                  <a:moveTo>
                    <a:pt x="14116" y="1"/>
                  </a:moveTo>
                  <a:lnTo>
                    <a:pt x="14034" y="42"/>
                  </a:lnTo>
                  <a:lnTo>
                    <a:pt x="13261" y="774"/>
                  </a:lnTo>
                  <a:lnTo>
                    <a:pt x="12448" y="1465"/>
                  </a:lnTo>
                  <a:lnTo>
                    <a:pt x="11634" y="2116"/>
                  </a:lnTo>
                  <a:lnTo>
                    <a:pt x="10821" y="2767"/>
                  </a:lnTo>
                  <a:lnTo>
                    <a:pt x="9112" y="4028"/>
                  </a:lnTo>
                  <a:lnTo>
                    <a:pt x="7404" y="5248"/>
                  </a:lnTo>
                  <a:lnTo>
                    <a:pt x="5899" y="6428"/>
                  </a:lnTo>
                  <a:lnTo>
                    <a:pt x="5167" y="7079"/>
                  </a:lnTo>
                  <a:lnTo>
                    <a:pt x="4435" y="7729"/>
                  </a:lnTo>
                  <a:lnTo>
                    <a:pt x="3743" y="8380"/>
                  </a:lnTo>
                  <a:lnTo>
                    <a:pt x="3133" y="9072"/>
                  </a:lnTo>
                  <a:lnTo>
                    <a:pt x="2482" y="9844"/>
                  </a:lnTo>
                  <a:lnTo>
                    <a:pt x="1953" y="10617"/>
                  </a:lnTo>
                  <a:lnTo>
                    <a:pt x="1425" y="11390"/>
                  </a:lnTo>
                  <a:lnTo>
                    <a:pt x="1018" y="12204"/>
                  </a:lnTo>
                  <a:lnTo>
                    <a:pt x="652" y="13058"/>
                  </a:lnTo>
                  <a:lnTo>
                    <a:pt x="326" y="13912"/>
                  </a:lnTo>
                  <a:lnTo>
                    <a:pt x="123" y="14766"/>
                  </a:lnTo>
                  <a:lnTo>
                    <a:pt x="82" y="15173"/>
                  </a:lnTo>
                  <a:lnTo>
                    <a:pt x="42" y="15620"/>
                  </a:lnTo>
                  <a:lnTo>
                    <a:pt x="1" y="16068"/>
                  </a:lnTo>
                  <a:lnTo>
                    <a:pt x="42" y="16475"/>
                  </a:lnTo>
                  <a:lnTo>
                    <a:pt x="82" y="16922"/>
                  </a:lnTo>
                  <a:lnTo>
                    <a:pt x="164" y="17329"/>
                  </a:lnTo>
                  <a:lnTo>
                    <a:pt x="326" y="17736"/>
                  </a:lnTo>
                  <a:lnTo>
                    <a:pt x="489" y="18102"/>
                  </a:lnTo>
                  <a:lnTo>
                    <a:pt x="733" y="18468"/>
                  </a:lnTo>
                  <a:lnTo>
                    <a:pt x="977" y="18753"/>
                  </a:lnTo>
                  <a:lnTo>
                    <a:pt x="1303" y="18997"/>
                  </a:lnTo>
                  <a:lnTo>
                    <a:pt x="1669" y="19200"/>
                  </a:lnTo>
                  <a:lnTo>
                    <a:pt x="2035" y="19363"/>
                  </a:lnTo>
                  <a:lnTo>
                    <a:pt x="2442" y="19444"/>
                  </a:lnTo>
                  <a:lnTo>
                    <a:pt x="2930" y="19485"/>
                  </a:lnTo>
                  <a:lnTo>
                    <a:pt x="3418" y="19485"/>
                  </a:lnTo>
                  <a:lnTo>
                    <a:pt x="3906" y="19444"/>
                  </a:lnTo>
                  <a:lnTo>
                    <a:pt x="4394" y="19363"/>
                  </a:lnTo>
                  <a:lnTo>
                    <a:pt x="5370" y="19159"/>
                  </a:lnTo>
                  <a:lnTo>
                    <a:pt x="6306" y="18915"/>
                  </a:lnTo>
                  <a:lnTo>
                    <a:pt x="7323" y="18631"/>
                  </a:lnTo>
                  <a:lnTo>
                    <a:pt x="8340" y="18305"/>
                  </a:lnTo>
                  <a:lnTo>
                    <a:pt x="9356" y="17980"/>
                  </a:lnTo>
                  <a:lnTo>
                    <a:pt x="10333" y="17614"/>
                  </a:lnTo>
                  <a:lnTo>
                    <a:pt x="11309" y="17166"/>
                  </a:lnTo>
                  <a:lnTo>
                    <a:pt x="12285" y="16719"/>
                  </a:lnTo>
                  <a:lnTo>
                    <a:pt x="13221" y="16271"/>
                  </a:lnTo>
                  <a:lnTo>
                    <a:pt x="14156" y="15743"/>
                  </a:lnTo>
                  <a:lnTo>
                    <a:pt x="15051" y="15214"/>
                  </a:lnTo>
                  <a:lnTo>
                    <a:pt x="15132" y="15173"/>
                  </a:lnTo>
                  <a:lnTo>
                    <a:pt x="15173" y="15092"/>
                  </a:lnTo>
                  <a:lnTo>
                    <a:pt x="15173" y="15051"/>
                  </a:lnTo>
                  <a:lnTo>
                    <a:pt x="15132" y="14970"/>
                  </a:lnTo>
                  <a:lnTo>
                    <a:pt x="15092" y="14929"/>
                  </a:lnTo>
                  <a:lnTo>
                    <a:pt x="15010" y="14888"/>
                  </a:lnTo>
                  <a:lnTo>
                    <a:pt x="14888" y="14888"/>
                  </a:lnTo>
                  <a:lnTo>
                    <a:pt x="13994" y="15417"/>
                  </a:lnTo>
                  <a:lnTo>
                    <a:pt x="13099" y="15905"/>
                  </a:lnTo>
                  <a:lnTo>
                    <a:pt x="12163" y="16393"/>
                  </a:lnTo>
                  <a:lnTo>
                    <a:pt x="11228" y="16800"/>
                  </a:lnTo>
                  <a:lnTo>
                    <a:pt x="10292" y="17207"/>
                  </a:lnTo>
                  <a:lnTo>
                    <a:pt x="9316" y="17573"/>
                  </a:lnTo>
                  <a:lnTo>
                    <a:pt x="8340" y="17939"/>
                  </a:lnTo>
                  <a:lnTo>
                    <a:pt x="7363" y="18224"/>
                  </a:lnTo>
                  <a:lnTo>
                    <a:pt x="6387" y="18508"/>
                  </a:lnTo>
                  <a:lnTo>
                    <a:pt x="5452" y="18753"/>
                  </a:lnTo>
                  <a:lnTo>
                    <a:pt x="4475" y="18956"/>
                  </a:lnTo>
                  <a:lnTo>
                    <a:pt x="3987" y="19037"/>
                  </a:lnTo>
                  <a:lnTo>
                    <a:pt x="3499" y="19119"/>
                  </a:lnTo>
                  <a:lnTo>
                    <a:pt x="3052" y="19119"/>
                  </a:lnTo>
                  <a:lnTo>
                    <a:pt x="2604" y="19078"/>
                  </a:lnTo>
                  <a:lnTo>
                    <a:pt x="2157" y="18997"/>
                  </a:lnTo>
                  <a:lnTo>
                    <a:pt x="1750" y="18834"/>
                  </a:lnTo>
                  <a:lnTo>
                    <a:pt x="1425" y="18631"/>
                  </a:lnTo>
                  <a:lnTo>
                    <a:pt x="1140" y="18386"/>
                  </a:lnTo>
                  <a:lnTo>
                    <a:pt x="896" y="18061"/>
                  </a:lnTo>
                  <a:lnTo>
                    <a:pt x="692" y="17695"/>
                  </a:lnTo>
                  <a:lnTo>
                    <a:pt x="530" y="17329"/>
                  </a:lnTo>
                  <a:lnTo>
                    <a:pt x="448" y="16922"/>
                  </a:lnTo>
                  <a:lnTo>
                    <a:pt x="408" y="16475"/>
                  </a:lnTo>
                  <a:lnTo>
                    <a:pt x="367" y="16068"/>
                  </a:lnTo>
                  <a:lnTo>
                    <a:pt x="408" y="15661"/>
                  </a:lnTo>
                  <a:lnTo>
                    <a:pt x="448" y="15214"/>
                  </a:lnTo>
                  <a:lnTo>
                    <a:pt x="611" y="14400"/>
                  </a:lnTo>
                  <a:lnTo>
                    <a:pt x="855" y="13546"/>
                  </a:lnTo>
                  <a:lnTo>
                    <a:pt x="1181" y="12732"/>
                  </a:lnTo>
                  <a:lnTo>
                    <a:pt x="1587" y="11919"/>
                  </a:lnTo>
                  <a:lnTo>
                    <a:pt x="2035" y="11146"/>
                  </a:lnTo>
                  <a:lnTo>
                    <a:pt x="2564" y="10373"/>
                  </a:lnTo>
                  <a:lnTo>
                    <a:pt x="3133" y="9641"/>
                  </a:lnTo>
                  <a:lnTo>
                    <a:pt x="3743" y="8950"/>
                  </a:lnTo>
                  <a:lnTo>
                    <a:pt x="4394" y="8299"/>
                  </a:lnTo>
                  <a:lnTo>
                    <a:pt x="5045" y="7648"/>
                  </a:lnTo>
                  <a:lnTo>
                    <a:pt x="5736" y="7038"/>
                  </a:lnTo>
                  <a:lnTo>
                    <a:pt x="6468" y="6428"/>
                  </a:lnTo>
                  <a:lnTo>
                    <a:pt x="7201" y="5858"/>
                  </a:lnTo>
                  <a:lnTo>
                    <a:pt x="9031" y="4557"/>
                  </a:lnTo>
                  <a:lnTo>
                    <a:pt x="10821" y="3214"/>
                  </a:lnTo>
                  <a:lnTo>
                    <a:pt x="11756" y="2523"/>
                  </a:lnTo>
                  <a:lnTo>
                    <a:pt x="12611" y="1831"/>
                  </a:lnTo>
                  <a:lnTo>
                    <a:pt x="13465" y="1058"/>
                  </a:lnTo>
                  <a:lnTo>
                    <a:pt x="14278" y="286"/>
                  </a:lnTo>
                  <a:lnTo>
                    <a:pt x="14319" y="245"/>
                  </a:lnTo>
                  <a:lnTo>
                    <a:pt x="14360" y="164"/>
                  </a:lnTo>
                  <a:lnTo>
                    <a:pt x="14319" y="82"/>
                  </a:lnTo>
                  <a:lnTo>
                    <a:pt x="14278" y="42"/>
                  </a:lnTo>
                  <a:lnTo>
                    <a:pt x="14238"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1" name="Google Shape;201;p17"/>
            <p:cNvSpPr/>
            <p:nvPr/>
          </p:nvSpPr>
          <p:spPr>
            <a:xfrm>
              <a:off x="2701050" y="1843125"/>
              <a:ext cx="309175" cy="322375"/>
            </a:xfrm>
            <a:custGeom>
              <a:rect b="b" l="l" r="r" t="t"/>
              <a:pathLst>
                <a:path extrusionOk="0" h="12895" w="12367">
                  <a:moveTo>
                    <a:pt x="12163" y="0"/>
                  </a:moveTo>
                  <a:lnTo>
                    <a:pt x="12081" y="41"/>
                  </a:lnTo>
                  <a:lnTo>
                    <a:pt x="9600" y="1831"/>
                  </a:lnTo>
                  <a:lnTo>
                    <a:pt x="7160" y="3702"/>
                  </a:lnTo>
                  <a:lnTo>
                    <a:pt x="5939" y="4637"/>
                  </a:lnTo>
                  <a:lnTo>
                    <a:pt x="4760" y="5613"/>
                  </a:lnTo>
                  <a:lnTo>
                    <a:pt x="3580" y="6630"/>
                  </a:lnTo>
                  <a:lnTo>
                    <a:pt x="2441" y="7647"/>
                  </a:lnTo>
                  <a:lnTo>
                    <a:pt x="1872" y="8135"/>
                  </a:lnTo>
                  <a:lnTo>
                    <a:pt x="1343" y="8664"/>
                  </a:lnTo>
                  <a:lnTo>
                    <a:pt x="855" y="9193"/>
                  </a:lnTo>
                  <a:lnTo>
                    <a:pt x="611" y="9478"/>
                  </a:lnTo>
                  <a:lnTo>
                    <a:pt x="407" y="9762"/>
                  </a:lnTo>
                  <a:lnTo>
                    <a:pt x="285" y="10047"/>
                  </a:lnTo>
                  <a:lnTo>
                    <a:pt x="163" y="10332"/>
                  </a:lnTo>
                  <a:lnTo>
                    <a:pt x="82" y="10617"/>
                  </a:lnTo>
                  <a:lnTo>
                    <a:pt x="1" y="10901"/>
                  </a:lnTo>
                  <a:lnTo>
                    <a:pt x="1" y="11227"/>
                  </a:lnTo>
                  <a:lnTo>
                    <a:pt x="41" y="11511"/>
                  </a:lnTo>
                  <a:lnTo>
                    <a:pt x="123" y="11796"/>
                  </a:lnTo>
                  <a:lnTo>
                    <a:pt x="285" y="12081"/>
                  </a:lnTo>
                  <a:lnTo>
                    <a:pt x="448" y="12284"/>
                  </a:lnTo>
                  <a:lnTo>
                    <a:pt x="651" y="12488"/>
                  </a:lnTo>
                  <a:lnTo>
                    <a:pt x="896" y="12610"/>
                  </a:lnTo>
                  <a:lnTo>
                    <a:pt x="1140" y="12732"/>
                  </a:lnTo>
                  <a:lnTo>
                    <a:pt x="1384" y="12813"/>
                  </a:lnTo>
                  <a:lnTo>
                    <a:pt x="1668" y="12854"/>
                  </a:lnTo>
                  <a:lnTo>
                    <a:pt x="2238" y="12894"/>
                  </a:lnTo>
                  <a:lnTo>
                    <a:pt x="2929" y="12813"/>
                  </a:lnTo>
                  <a:lnTo>
                    <a:pt x="3621" y="12691"/>
                  </a:lnTo>
                  <a:lnTo>
                    <a:pt x="5004" y="12366"/>
                  </a:lnTo>
                  <a:lnTo>
                    <a:pt x="6712" y="11918"/>
                  </a:lnTo>
                  <a:lnTo>
                    <a:pt x="8380" y="11389"/>
                  </a:lnTo>
                  <a:lnTo>
                    <a:pt x="10048" y="10820"/>
                  </a:lnTo>
                  <a:lnTo>
                    <a:pt x="11715" y="10210"/>
                  </a:lnTo>
                  <a:lnTo>
                    <a:pt x="11756" y="10128"/>
                  </a:lnTo>
                  <a:lnTo>
                    <a:pt x="11797" y="10088"/>
                  </a:lnTo>
                  <a:lnTo>
                    <a:pt x="11837" y="9966"/>
                  </a:lnTo>
                  <a:lnTo>
                    <a:pt x="11797" y="9884"/>
                  </a:lnTo>
                  <a:lnTo>
                    <a:pt x="11756" y="9844"/>
                  </a:lnTo>
                  <a:lnTo>
                    <a:pt x="11675" y="9803"/>
                  </a:lnTo>
                  <a:lnTo>
                    <a:pt x="11593" y="9844"/>
                  </a:lnTo>
                  <a:lnTo>
                    <a:pt x="10210" y="10373"/>
                  </a:lnTo>
                  <a:lnTo>
                    <a:pt x="8827" y="10861"/>
                  </a:lnTo>
                  <a:lnTo>
                    <a:pt x="7444" y="11308"/>
                  </a:lnTo>
                  <a:lnTo>
                    <a:pt x="6021" y="11715"/>
                  </a:lnTo>
                  <a:lnTo>
                    <a:pt x="4597" y="12081"/>
                  </a:lnTo>
                  <a:lnTo>
                    <a:pt x="3173" y="12366"/>
                  </a:lnTo>
                  <a:lnTo>
                    <a:pt x="2604" y="12488"/>
                  </a:lnTo>
                  <a:lnTo>
                    <a:pt x="2034" y="12528"/>
                  </a:lnTo>
                  <a:lnTo>
                    <a:pt x="1709" y="12488"/>
                  </a:lnTo>
                  <a:lnTo>
                    <a:pt x="1424" y="12447"/>
                  </a:lnTo>
                  <a:lnTo>
                    <a:pt x="1180" y="12366"/>
                  </a:lnTo>
                  <a:lnTo>
                    <a:pt x="936" y="12244"/>
                  </a:lnTo>
                  <a:lnTo>
                    <a:pt x="692" y="12040"/>
                  </a:lnTo>
                  <a:lnTo>
                    <a:pt x="529" y="11796"/>
                  </a:lnTo>
                  <a:lnTo>
                    <a:pt x="448" y="11511"/>
                  </a:lnTo>
                  <a:lnTo>
                    <a:pt x="407" y="11227"/>
                  </a:lnTo>
                  <a:lnTo>
                    <a:pt x="407" y="10942"/>
                  </a:lnTo>
                  <a:lnTo>
                    <a:pt x="448" y="10657"/>
                  </a:lnTo>
                  <a:lnTo>
                    <a:pt x="529" y="10373"/>
                  </a:lnTo>
                  <a:lnTo>
                    <a:pt x="651" y="10088"/>
                  </a:lnTo>
                  <a:lnTo>
                    <a:pt x="855" y="9803"/>
                  </a:lnTo>
                  <a:lnTo>
                    <a:pt x="1058" y="9518"/>
                  </a:lnTo>
                  <a:lnTo>
                    <a:pt x="1546" y="8990"/>
                  </a:lnTo>
                  <a:lnTo>
                    <a:pt x="2034" y="8501"/>
                  </a:lnTo>
                  <a:lnTo>
                    <a:pt x="2563" y="8013"/>
                  </a:lnTo>
                  <a:lnTo>
                    <a:pt x="3621" y="7037"/>
                  </a:lnTo>
                  <a:lnTo>
                    <a:pt x="4719" y="6102"/>
                  </a:lnTo>
                  <a:lnTo>
                    <a:pt x="5858" y="5207"/>
                  </a:lnTo>
                  <a:lnTo>
                    <a:pt x="6956" y="4271"/>
                  </a:lnTo>
                  <a:lnTo>
                    <a:pt x="8299" y="3295"/>
                  </a:lnTo>
                  <a:lnTo>
                    <a:pt x="9600" y="2278"/>
                  </a:lnTo>
                  <a:lnTo>
                    <a:pt x="12285" y="366"/>
                  </a:lnTo>
                  <a:lnTo>
                    <a:pt x="12326" y="285"/>
                  </a:lnTo>
                  <a:lnTo>
                    <a:pt x="12366" y="203"/>
                  </a:lnTo>
                  <a:lnTo>
                    <a:pt x="12326" y="81"/>
                  </a:lnTo>
                  <a:lnTo>
                    <a:pt x="12285" y="41"/>
                  </a:lnTo>
                  <a:lnTo>
                    <a:pt x="1224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2" name="Google Shape;202;p17"/>
            <p:cNvSpPr/>
            <p:nvPr/>
          </p:nvSpPr>
          <p:spPr>
            <a:xfrm>
              <a:off x="2756975" y="1978375"/>
              <a:ext cx="183075" cy="133225"/>
            </a:xfrm>
            <a:custGeom>
              <a:rect b="b" l="l" r="r" t="t"/>
              <a:pathLst>
                <a:path extrusionOk="0" h="5329" w="7323">
                  <a:moveTo>
                    <a:pt x="5980" y="366"/>
                  </a:moveTo>
                  <a:lnTo>
                    <a:pt x="6306" y="407"/>
                  </a:lnTo>
                  <a:lnTo>
                    <a:pt x="6428" y="407"/>
                  </a:lnTo>
                  <a:lnTo>
                    <a:pt x="6550" y="488"/>
                  </a:lnTo>
                  <a:lnTo>
                    <a:pt x="6672" y="569"/>
                  </a:lnTo>
                  <a:lnTo>
                    <a:pt x="6753" y="651"/>
                  </a:lnTo>
                  <a:lnTo>
                    <a:pt x="6834" y="814"/>
                  </a:lnTo>
                  <a:lnTo>
                    <a:pt x="6875" y="936"/>
                  </a:lnTo>
                  <a:lnTo>
                    <a:pt x="6956" y="1302"/>
                  </a:lnTo>
                  <a:lnTo>
                    <a:pt x="6916" y="1586"/>
                  </a:lnTo>
                  <a:lnTo>
                    <a:pt x="6834" y="1912"/>
                  </a:lnTo>
                  <a:lnTo>
                    <a:pt x="6672" y="2197"/>
                  </a:lnTo>
                  <a:lnTo>
                    <a:pt x="6468" y="2522"/>
                  </a:lnTo>
                  <a:lnTo>
                    <a:pt x="6184" y="2766"/>
                  </a:lnTo>
                  <a:lnTo>
                    <a:pt x="5858" y="3010"/>
                  </a:lnTo>
                  <a:lnTo>
                    <a:pt x="5533" y="3213"/>
                  </a:lnTo>
                  <a:lnTo>
                    <a:pt x="4841" y="3580"/>
                  </a:lnTo>
                  <a:lnTo>
                    <a:pt x="4109" y="3864"/>
                  </a:lnTo>
                  <a:lnTo>
                    <a:pt x="3092" y="4271"/>
                  </a:lnTo>
                  <a:lnTo>
                    <a:pt x="2075" y="4637"/>
                  </a:lnTo>
                  <a:lnTo>
                    <a:pt x="1709" y="4800"/>
                  </a:lnTo>
                  <a:lnTo>
                    <a:pt x="1180" y="4963"/>
                  </a:lnTo>
                  <a:lnTo>
                    <a:pt x="692" y="4963"/>
                  </a:lnTo>
                  <a:lnTo>
                    <a:pt x="530" y="4881"/>
                  </a:lnTo>
                  <a:lnTo>
                    <a:pt x="448" y="4840"/>
                  </a:lnTo>
                  <a:lnTo>
                    <a:pt x="408" y="4759"/>
                  </a:lnTo>
                  <a:lnTo>
                    <a:pt x="367" y="4637"/>
                  </a:lnTo>
                  <a:lnTo>
                    <a:pt x="367" y="4515"/>
                  </a:lnTo>
                  <a:lnTo>
                    <a:pt x="448" y="4312"/>
                  </a:lnTo>
                  <a:lnTo>
                    <a:pt x="570" y="4108"/>
                  </a:lnTo>
                  <a:lnTo>
                    <a:pt x="733" y="3946"/>
                  </a:lnTo>
                  <a:lnTo>
                    <a:pt x="1384" y="3335"/>
                  </a:lnTo>
                  <a:lnTo>
                    <a:pt x="2075" y="2685"/>
                  </a:lnTo>
                  <a:lnTo>
                    <a:pt x="2848" y="2034"/>
                  </a:lnTo>
                  <a:lnTo>
                    <a:pt x="3621" y="1424"/>
                  </a:lnTo>
                  <a:lnTo>
                    <a:pt x="4068" y="1180"/>
                  </a:lnTo>
                  <a:lnTo>
                    <a:pt x="4475" y="936"/>
                  </a:lnTo>
                  <a:lnTo>
                    <a:pt x="4841" y="732"/>
                  </a:lnTo>
                  <a:lnTo>
                    <a:pt x="5207" y="569"/>
                  </a:lnTo>
                  <a:lnTo>
                    <a:pt x="5614" y="447"/>
                  </a:lnTo>
                  <a:lnTo>
                    <a:pt x="5980" y="366"/>
                  </a:lnTo>
                  <a:close/>
                  <a:moveTo>
                    <a:pt x="6021" y="0"/>
                  </a:moveTo>
                  <a:lnTo>
                    <a:pt x="5614" y="81"/>
                  </a:lnTo>
                  <a:lnTo>
                    <a:pt x="5207" y="203"/>
                  </a:lnTo>
                  <a:lnTo>
                    <a:pt x="4841" y="366"/>
                  </a:lnTo>
                  <a:lnTo>
                    <a:pt x="4353" y="569"/>
                  </a:lnTo>
                  <a:lnTo>
                    <a:pt x="3865" y="854"/>
                  </a:lnTo>
                  <a:lnTo>
                    <a:pt x="3377" y="1180"/>
                  </a:lnTo>
                  <a:lnTo>
                    <a:pt x="2930" y="1505"/>
                  </a:lnTo>
                  <a:lnTo>
                    <a:pt x="2035" y="2237"/>
                  </a:lnTo>
                  <a:lnTo>
                    <a:pt x="1180" y="2969"/>
                  </a:lnTo>
                  <a:lnTo>
                    <a:pt x="814" y="3295"/>
                  </a:lnTo>
                  <a:lnTo>
                    <a:pt x="448" y="3702"/>
                  </a:lnTo>
                  <a:lnTo>
                    <a:pt x="245" y="3905"/>
                  </a:lnTo>
                  <a:lnTo>
                    <a:pt x="123" y="4108"/>
                  </a:lnTo>
                  <a:lnTo>
                    <a:pt x="42" y="4352"/>
                  </a:lnTo>
                  <a:lnTo>
                    <a:pt x="1" y="4596"/>
                  </a:lnTo>
                  <a:lnTo>
                    <a:pt x="42" y="4840"/>
                  </a:lnTo>
                  <a:lnTo>
                    <a:pt x="164" y="5044"/>
                  </a:lnTo>
                  <a:lnTo>
                    <a:pt x="326" y="5207"/>
                  </a:lnTo>
                  <a:lnTo>
                    <a:pt x="530" y="5288"/>
                  </a:lnTo>
                  <a:lnTo>
                    <a:pt x="774" y="5329"/>
                  </a:lnTo>
                  <a:lnTo>
                    <a:pt x="1018" y="5329"/>
                  </a:lnTo>
                  <a:lnTo>
                    <a:pt x="1262" y="5288"/>
                  </a:lnTo>
                  <a:lnTo>
                    <a:pt x="1465" y="5247"/>
                  </a:lnTo>
                  <a:lnTo>
                    <a:pt x="2157" y="5003"/>
                  </a:lnTo>
                  <a:lnTo>
                    <a:pt x="2848" y="4759"/>
                  </a:lnTo>
                  <a:lnTo>
                    <a:pt x="4139" y="4266"/>
                  </a:lnTo>
                  <a:lnTo>
                    <a:pt x="4139" y="4266"/>
                  </a:lnTo>
                  <a:lnTo>
                    <a:pt x="4150" y="4271"/>
                  </a:lnTo>
                  <a:lnTo>
                    <a:pt x="4231" y="4230"/>
                  </a:lnTo>
                  <a:lnTo>
                    <a:pt x="4963" y="3905"/>
                  </a:lnTo>
                  <a:lnTo>
                    <a:pt x="5696" y="3539"/>
                  </a:lnTo>
                  <a:lnTo>
                    <a:pt x="6021" y="3335"/>
                  </a:lnTo>
                  <a:lnTo>
                    <a:pt x="6346" y="3091"/>
                  </a:lnTo>
                  <a:lnTo>
                    <a:pt x="6672" y="2847"/>
                  </a:lnTo>
                  <a:lnTo>
                    <a:pt x="6916" y="2522"/>
                  </a:lnTo>
                  <a:lnTo>
                    <a:pt x="7119" y="2197"/>
                  </a:lnTo>
                  <a:lnTo>
                    <a:pt x="7241" y="1871"/>
                  </a:lnTo>
                  <a:lnTo>
                    <a:pt x="7323" y="1505"/>
                  </a:lnTo>
                  <a:lnTo>
                    <a:pt x="7323" y="1098"/>
                  </a:lnTo>
                  <a:lnTo>
                    <a:pt x="7201" y="732"/>
                  </a:lnTo>
                  <a:lnTo>
                    <a:pt x="7119" y="569"/>
                  </a:lnTo>
                  <a:lnTo>
                    <a:pt x="7038" y="407"/>
                  </a:lnTo>
                  <a:lnTo>
                    <a:pt x="6916" y="285"/>
                  </a:lnTo>
                  <a:lnTo>
                    <a:pt x="6794" y="163"/>
                  </a:lnTo>
                  <a:lnTo>
                    <a:pt x="6631" y="81"/>
                  </a:lnTo>
                  <a:lnTo>
                    <a:pt x="6428" y="41"/>
                  </a:lnTo>
                  <a:lnTo>
                    <a:pt x="6224" y="0"/>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203" name="Google Shape;203;p17"/>
          <p:cNvSpPr/>
          <p:nvPr/>
        </p:nvSpPr>
        <p:spPr>
          <a:xfrm flipH="1" rot="10800000">
            <a:off x="2181092" y="4799671"/>
            <a:ext cx="85658" cy="85658"/>
          </a:xfrm>
          <a:custGeom>
            <a:rect b="b" l="l" r="r" t="t"/>
            <a:pathLst>
              <a:path extrusionOk="0" h="1872" w="1872">
                <a:moveTo>
                  <a:pt x="733" y="1"/>
                </a:moveTo>
                <a:lnTo>
                  <a:pt x="489" y="82"/>
                </a:lnTo>
                <a:lnTo>
                  <a:pt x="286" y="245"/>
                </a:lnTo>
                <a:lnTo>
                  <a:pt x="123" y="448"/>
                </a:lnTo>
                <a:lnTo>
                  <a:pt x="1" y="692"/>
                </a:lnTo>
                <a:lnTo>
                  <a:pt x="1" y="936"/>
                </a:lnTo>
                <a:lnTo>
                  <a:pt x="41" y="1221"/>
                </a:lnTo>
                <a:lnTo>
                  <a:pt x="164" y="1424"/>
                </a:lnTo>
                <a:lnTo>
                  <a:pt x="245" y="1587"/>
                </a:lnTo>
                <a:lnTo>
                  <a:pt x="367" y="1668"/>
                </a:lnTo>
                <a:lnTo>
                  <a:pt x="489" y="1750"/>
                </a:lnTo>
                <a:lnTo>
                  <a:pt x="652" y="1831"/>
                </a:lnTo>
                <a:lnTo>
                  <a:pt x="774" y="1872"/>
                </a:lnTo>
                <a:lnTo>
                  <a:pt x="1099" y="1872"/>
                </a:lnTo>
                <a:lnTo>
                  <a:pt x="1262" y="1831"/>
                </a:lnTo>
                <a:lnTo>
                  <a:pt x="1384" y="1790"/>
                </a:lnTo>
                <a:lnTo>
                  <a:pt x="1546" y="1709"/>
                </a:lnTo>
                <a:lnTo>
                  <a:pt x="1628" y="1587"/>
                </a:lnTo>
                <a:lnTo>
                  <a:pt x="1750" y="1465"/>
                </a:lnTo>
                <a:lnTo>
                  <a:pt x="1831" y="1302"/>
                </a:lnTo>
                <a:lnTo>
                  <a:pt x="1872" y="1140"/>
                </a:lnTo>
                <a:lnTo>
                  <a:pt x="1872" y="977"/>
                </a:lnTo>
                <a:lnTo>
                  <a:pt x="1872" y="773"/>
                </a:lnTo>
                <a:lnTo>
                  <a:pt x="1831" y="651"/>
                </a:lnTo>
                <a:lnTo>
                  <a:pt x="1750" y="489"/>
                </a:lnTo>
                <a:lnTo>
                  <a:pt x="1669" y="367"/>
                </a:lnTo>
                <a:lnTo>
                  <a:pt x="1546" y="245"/>
                </a:lnTo>
                <a:lnTo>
                  <a:pt x="1302" y="82"/>
                </a:lnTo>
                <a:lnTo>
                  <a:pt x="977"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4" name="Google Shape;204;p17"/>
          <p:cNvSpPr/>
          <p:nvPr/>
        </p:nvSpPr>
        <p:spPr>
          <a:xfrm flipH="1" rot="10800000">
            <a:off x="7048941" y="336880"/>
            <a:ext cx="303418" cy="305294"/>
          </a:xfrm>
          <a:custGeom>
            <a:rect b="b" l="l" r="r" t="t"/>
            <a:pathLst>
              <a:path extrusionOk="0" h="6672" w="6631">
                <a:moveTo>
                  <a:pt x="3742" y="0"/>
                </a:moveTo>
                <a:lnTo>
                  <a:pt x="2766" y="41"/>
                </a:lnTo>
                <a:lnTo>
                  <a:pt x="2685" y="41"/>
                </a:lnTo>
                <a:lnTo>
                  <a:pt x="2603" y="82"/>
                </a:lnTo>
                <a:lnTo>
                  <a:pt x="2563" y="163"/>
                </a:lnTo>
                <a:lnTo>
                  <a:pt x="2563" y="244"/>
                </a:lnTo>
                <a:lnTo>
                  <a:pt x="2603" y="2644"/>
                </a:lnTo>
                <a:lnTo>
                  <a:pt x="203" y="2685"/>
                </a:lnTo>
                <a:lnTo>
                  <a:pt x="122" y="2685"/>
                </a:lnTo>
                <a:lnTo>
                  <a:pt x="41" y="2726"/>
                </a:lnTo>
                <a:lnTo>
                  <a:pt x="0" y="2807"/>
                </a:lnTo>
                <a:lnTo>
                  <a:pt x="0" y="2848"/>
                </a:lnTo>
                <a:lnTo>
                  <a:pt x="0" y="3905"/>
                </a:lnTo>
                <a:lnTo>
                  <a:pt x="41" y="3987"/>
                </a:lnTo>
                <a:lnTo>
                  <a:pt x="81" y="4068"/>
                </a:lnTo>
                <a:lnTo>
                  <a:pt x="325" y="4068"/>
                </a:lnTo>
                <a:lnTo>
                  <a:pt x="366" y="4027"/>
                </a:lnTo>
                <a:lnTo>
                  <a:pt x="529" y="4027"/>
                </a:lnTo>
                <a:lnTo>
                  <a:pt x="1139" y="3987"/>
                </a:lnTo>
                <a:lnTo>
                  <a:pt x="2603" y="3987"/>
                </a:lnTo>
                <a:lnTo>
                  <a:pt x="2644" y="6468"/>
                </a:lnTo>
                <a:lnTo>
                  <a:pt x="2644" y="6549"/>
                </a:lnTo>
                <a:lnTo>
                  <a:pt x="2685" y="6590"/>
                </a:lnTo>
                <a:lnTo>
                  <a:pt x="2766" y="6630"/>
                </a:lnTo>
                <a:lnTo>
                  <a:pt x="2847" y="6671"/>
                </a:lnTo>
                <a:lnTo>
                  <a:pt x="3864" y="6671"/>
                </a:lnTo>
                <a:lnTo>
                  <a:pt x="3946" y="6630"/>
                </a:lnTo>
                <a:lnTo>
                  <a:pt x="3986" y="6590"/>
                </a:lnTo>
                <a:lnTo>
                  <a:pt x="4068" y="6508"/>
                </a:lnTo>
                <a:lnTo>
                  <a:pt x="4027" y="6346"/>
                </a:lnTo>
                <a:lnTo>
                  <a:pt x="3986" y="6305"/>
                </a:lnTo>
                <a:lnTo>
                  <a:pt x="3905" y="6264"/>
                </a:lnTo>
                <a:lnTo>
                  <a:pt x="4027" y="6305"/>
                </a:lnTo>
                <a:lnTo>
                  <a:pt x="4027" y="6264"/>
                </a:lnTo>
                <a:lnTo>
                  <a:pt x="3986" y="6102"/>
                </a:lnTo>
                <a:lnTo>
                  <a:pt x="3986" y="5492"/>
                </a:lnTo>
                <a:lnTo>
                  <a:pt x="3946" y="3987"/>
                </a:lnTo>
                <a:lnTo>
                  <a:pt x="6508" y="3987"/>
                </a:lnTo>
                <a:lnTo>
                  <a:pt x="6549" y="3946"/>
                </a:lnTo>
                <a:lnTo>
                  <a:pt x="6630" y="3864"/>
                </a:lnTo>
                <a:lnTo>
                  <a:pt x="6630" y="3783"/>
                </a:lnTo>
                <a:lnTo>
                  <a:pt x="6630" y="2766"/>
                </a:lnTo>
                <a:lnTo>
                  <a:pt x="6590" y="2726"/>
                </a:lnTo>
                <a:lnTo>
                  <a:pt x="6549" y="2644"/>
                </a:lnTo>
                <a:lnTo>
                  <a:pt x="6508" y="2604"/>
                </a:lnTo>
                <a:lnTo>
                  <a:pt x="3946" y="2604"/>
                </a:lnTo>
                <a:lnTo>
                  <a:pt x="3946" y="204"/>
                </a:lnTo>
                <a:lnTo>
                  <a:pt x="3946" y="122"/>
                </a:lnTo>
                <a:lnTo>
                  <a:pt x="3905" y="82"/>
                </a:lnTo>
                <a:lnTo>
                  <a:pt x="3824" y="41"/>
                </a:lnTo>
                <a:lnTo>
                  <a:pt x="3742" y="0"/>
                </a:lnTo>
                <a:close/>
              </a:path>
            </a:pathLst>
          </a:custGeom>
          <a:solidFill>
            <a:schemeClr val="accen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5" name="Google Shape;205;p17"/>
          <p:cNvSpPr/>
          <p:nvPr/>
        </p:nvSpPr>
        <p:spPr>
          <a:xfrm flipH="1" rot="10800000">
            <a:off x="8643139" y="4513511"/>
            <a:ext cx="152693" cy="154523"/>
          </a:xfrm>
          <a:custGeom>
            <a:rect b="b" l="l" r="r" t="t"/>
            <a:pathLst>
              <a:path extrusionOk="0" h="3377" w="3337">
                <a:moveTo>
                  <a:pt x="1506" y="0"/>
                </a:moveTo>
                <a:lnTo>
                  <a:pt x="1262" y="41"/>
                </a:lnTo>
                <a:lnTo>
                  <a:pt x="1018" y="122"/>
                </a:lnTo>
                <a:lnTo>
                  <a:pt x="774" y="204"/>
                </a:lnTo>
                <a:lnTo>
                  <a:pt x="570" y="366"/>
                </a:lnTo>
                <a:lnTo>
                  <a:pt x="408" y="529"/>
                </a:lnTo>
                <a:lnTo>
                  <a:pt x="245" y="692"/>
                </a:lnTo>
                <a:lnTo>
                  <a:pt x="164" y="895"/>
                </a:lnTo>
                <a:lnTo>
                  <a:pt x="82" y="1098"/>
                </a:lnTo>
                <a:lnTo>
                  <a:pt x="1" y="1342"/>
                </a:lnTo>
                <a:lnTo>
                  <a:pt x="1" y="1546"/>
                </a:lnTo>
                <a:lnTo>
                  <a:pt x="1" y="1790"/>
                </a:lnTo>
                <a:lnTo>
                  <a:pt x="1" y="1993"/>
                </a:lnTo>
                <a:lnTo>
                  <a:pt x="123" y="2319"/>
                </a:lnTo>
                <a:lnTo>
                  <a:pt x="245" y="2563"/>
                </a:lnTo>
                <a:lnTo>
                  <a:pt x="448" y="2807"/>
                </a:lnTo>
                <a:lnTo>
                  <a:pt x="692" y="3010"/>
                </a:lnTo>
                <a:lnTo>
                  <a:pt x="936" y="3173"/>
                </a:lnTo>
                <a:lnTo>
                  <a:pt x="1221" y="3295"/>
                </a:lnTo>
                <a:lnTo>
                  <a:pt x="1506" y="3376"/>
                </a:lnTo>
                <a:lnTo>
                  <a:pt x="1831" y="3376"/>
                </a:lnTo>
                <a:lnTo>
                  <a:pt x="2075" y="3336"/>
                </a:lnTo>
                <a:lnTo>
                  <a:pt x="2319" y="3254"/>
                </a:lnTo>
                <a:lnTo>
                  <a:pt x="2564" y="3173"/>
                </a:lnTo>
                <a:lnTo>
                  <a:pt x="2767" y="3010"/>
                </a:lnTo>
                <a:lnTo>
                  <a:pt x="2930" y="2847"/>
                </a:lnTo>
                <a:lnTo>
                  <a:pt x="3092" y="2685"/>
                </a:lnTo>
                <a:lnTo>
                  <a:pt x="3214" y="2441"/>
                </a:lnTo>
                <a:lnTo>
                  <a:pt x="3296" y="2197"/>
                </a:lnTo>
                <a:lnTo>
                  <a:pt x="3336" y="1912"/>
                </a:lnTo>
                <a:lnTo>
                  <a:pt x="3336" y="1627"/>
                </a:lnTo>
                <a:lnTo>
                  <a:pt x="3296" y="1342"/>
                </a:lnTo>
                <a:lnTo>
                  <a:pt x="3214" y="1098"/>
                </a:lnTo>
                <a:lnTo>
                  <a:pt x="3092" y="854"/>
                </a:lnTo>
                <a:lnTo>
                  <a:pt x="2930" y="610"/>
                </a:lnTo>
                <a:lnTo>
                  <a:pt x="2726" y="407"/>
                </a:lnTo>
                <a:lnTo>
                  <a:pt x="2482" y="244"/>
                </a:lnTo>
                <a:lnTo>
                  <a:pt x="2238" y="122"/>
                </a:lnTo>
                <a:lnTo>
                  <a:pt x="1994" y="41"/>
                </a:lnTo>
                <a:lnTo>
                  <a:pt x="1750" y="0"/>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206" name="Google Shape;206;p17"/>
          <p:cNvGrpSpPr/>
          <p:nvPr/>
        </p:nvGrpSpPr>
        <p:grpSpPr>
          <a:xfrm>
            <a:off x="8565936" y="2543477"/>
            <a:ext cx="307124" cy="305294"/>
            <a:chOff x="1026043" y="1162815"/>
            <a:chExt cx="307124" cy="305294"/>
          </a:xfrm>
        </p:grpSpPr>
        <p:sp>
          <p:nvSpPr>
            <p:cNvPr id="207" name="Google Shape;207;p17"/>
            <p:cNvSpPr/>
            <p:nvPr/>
          </p:nvSpPr>
          <p:spPr>
            <a:xfrm>
              <a:off x="1026043" y="1162815"/>
              <a:ext cx="307124" cy="305294"/>
            </a:xfrm>
            <a:custGeom>
              <a:rect b="b" l="l" r="r" t="t"/>
              <a:pathLst>
                <a:path extrusionOk="0" h="6672" w="6712">
                  <a:moveTo>
                    <a:pt x="2766" y="1"/>
                  </a:moveTo>
                  <a:lnTo>
                    <a:pt x="2644" y="41"/>
                  </a:lnTo>
                  <a:lnTo>
                    <a:pt x="2563" y="82"/>
                  </a:lnTo>
                  <a:lnTo>
                    <a:pt x="2441" y="163"/>
                  </a:lnTo>
                  <a:lnTo>
                    <a:pt x="2359" y="245"/>
                  </a:lnTo>
                  <a:lnTo>
                    <a:pt x="2319" y="367"/>
                  </a:lnTo>
                  <a:lnTo>
                    <a:pt x="2237" y="651"/>
                  </a:lnTo>
                  <a:lnTo>
                    <a:pt x="2197" y="936"/>
                  </a:lnTo>
                  <a:lnTo>
                    <a:pt x="2197" y="1221"/>
                  </a:lnTo>
                  <a:lnTo>
                    <a:pt x="2237" y="1506"/>
                  </a:lnTo>
                  <a:lnTo>
                    <a:pt x="2075" y="1343"/>
                  </a:lnTo>
                  <a:lnTo>
                    <a:pt x="1871" y="1221"/>
                  </a:lnTo>
                  <a:lnTo>
                    <a:pt x="1546" y="1139"/>
                  </a:lnTo>
                  <a:lnTo>
                    <a:pt x="1424" y="1099"/>
                  </a:lnTo>
                  <a:lnTo>
                    <a:pt x="1261" y="1139"/>
                  </a:lnTo>
                  <a:lnTo>
                    <a:pt x="1139" y="1180"/>
                  </a:lnTo>
                  <a:lnTo>
                    <a:pt x="1017" y="1262"/>
                  </a:lnTo>
                  <a:lnTo>
                    <a:pt x="895" y="1343"/>
                  </a:lnTo>
                  <a:lnTo>
                    <a:pt x="814" y="1506"/>
                  </a:lnTo>
                  <a:lnTo>
                    <a:pt x="773" y="1790"/>
                  </a:lnTo>
                  <a:lnTo>
                    <a:pt x="773" y="2075"/>
                  </a:lnTo>
                  <a:lnTo>
                    <a:pt x="854" y="2360"/>
                  </a:lnTo>
                  <a:lnTo>
                    <a:pt x="1017" y="2604"/>
                  </a:lnTo>
                  <a:lnTo>
                    <a:pt x="1180" y="2807"/>
                  </a:lnTo>
                  <a:lnTo>
                    <a:pt x="1383" y="3011"/>
                  </a:lnTo>
                  <a:lnTo>
                    <a:pt x="1017" y="2970"/>
                  </a:lnTo>
                  <a:lnTo>
                    <a:pt x="814" y="3011"/>
                  </a:lnTo>
                  <a:lnTo>
                    <a:pt x="651" y="3051"/>
                  </a:lnTo>
                  <a:lnTo>
                    <a:pt x="407" y="3214"/>
                  </a:lnTo>
                  <a:lnTo>
                    <a:pt x="204" y="3377"/>
                  </a:lnTo>
                  <a:lnTo>
                    <a:pt x="82" y="3621"/>
                  </a:lnTo>
                  <a:lnTo>
                    <a:pt x="0" y="3865"/>
                  </a:lnTo>
                  <a:lnTo>
                    <a:pt x="0" y="4109"/>
                  </a:lnTo>
                  <a:lnTo>
                    <a:pt x="82" y="4353"/>
                  </a:lnTo>
                  <a:lnTo>
                    <a:pt x="244" y="4516"/>
                  </a:lnTo>
                  <a:lnTo>
                    <a:pt x="488" y="4678"/>
                  </a:lnTo>
                  <a:lnTo>
                    <a:pt x="692" y="4719"/>
                  </a:lnTo>
                  <a:lnTo>
                    <a:pt x="936" y="4760"/>
                  </a:lnTo>
                  <a:lnTo>
                    <a:pt x="1424" y="4719"/>
                  </a:lnTo>
                  <a:lnTo>
                    <a:pt x="1180" y="5004"/>
                  </a:lnTo>
                  <a:lnTo>
                    <a:pt x="1098" y="5166"/>
                  </a:lnTo>
                  <a:lnTo>
                    <a:pt x="1058" y="5370"/>
                  </a:lnTo>
                  <a:lnTo>
                    <a:pt x="1017" y="5655"/>
                  </a:lnTo>
                  <a:lnTo>
                    <a:pt x="1098" y="5939"/>
                  </a:lnTo>
                  <a:lnTo>
                    <a:pt x="1139" y="6061"/>
                  </a:lnTo>
                  <a:lnTo>
                    <a:pt x="1220" y="6143"/>
                  </a:lnTo>
                  <a:lnTo>
                    <a:pt x="1342" y="6265"/>
                  </a:lnTo>
                  <a:lnTo>
                    <a:pt x="1464" y="6305"/>
                  </a:lnTo>
                  <a:lnTo>
                    <a:pt x="1709" y="6387"/>
                  </a:lnTo>
                  <a:lnTo>
                    <a:pt x="1993" y="6387"/>
                  </a:lnTo>
                  <a:lnTo>
                    <a:pt x="2237" y="6346"/>
                  </a:lnTo>
                  <a:lnTo>
                    <a:pt x="2481" y="6224"/>
                  </a:lnTo>
                  <a:lnTo>
                    <a:pt x="2685" y="6021"/>
                  </a:lnTo>
                  <a:lnTo>
                    <a:pt x="2888" y="5777"/>
                  </a:lnTo>
                  <a:lnTo>
                    <a:pt x="3010" y="6102"/>
                  </a:lnTo>
                  <a:lnTo>
                    <a:pt x="3092" y="6265"/>
                  </a:lnTo>
                  <a:lnTo>
                    <a:pt x="3173" y="6387"/>
                  </a:lnTo>
                  <a:lnTo>
                    <a:pt x="3295" y="6509"/>
                  </a:lnTo>
                  <a:lnTo>
                    <a:pt x="3417" y="6590"/>
                  </a:lnTo>
                  <a:lnTo>
                    <a:pt x="3580" y="6671"/>
                  </a:lnTo>
                  <a:lnTo>
                    <a:pt x="3905" y="6671"/>
                  </a:lnTo>
                  <a:lnTo>
                    <a:pt x="4108" y="6590"/>
                  </a:lnTo>
                  <a:lnTo>
                    <a:pt x="4312" y="6468"/>
                  </a:lnTo>
                  <a:lnTo>
                    <a:pt x="4475" y="6305"/>
                  </a:lnTo>
                  <a:lnTo>
                    <a:pt x="4597" y="6102"/>
                  </a:lnTo>
                  <a:lnTo>
                    <a:pt x="4678" y="5777"/>
                  </a:lnTo>
                  <a:lnTo>
                    <a:pt x="4678" y="5451"/>
                  </a:lnTo>
                  <a:lnTo>
                    <a:pt x="4841" y="5533"/>
                  </a:lnTo>
                  <a:lnTo>
                    <a:pt x="5003" y="5573"/>
                  </a:lnTo>
                  <a:lnTo>
                    <a:pt x="5166" y="5614"/>
                  </a:lnTo>
                  <a:lnTo>
                    <a:pt x="5329" y="5573"/>
                  </a:lnTo>
                  <a:lnTo>
                    <a:pt x="5491" y="5533"/>
                  </a:lnTo>
                  <a:lnTo>
                    <a:pt x="5654" y="5492"/>
                  </a:lnTo>
                  <a:lnTo>
                    <a:pt x="5817" y="5370"/>
                  </a:lnTo>
                  <a:lnTo>
                    <a:pt x="5939" y="5248"/>
                  </a:lnTo>
                  <a:lnTo>
                    <a:pt x="6061" y="5085"/>
                  </a:lnTo>
                  <a:lnTo>
                    <a:pt x="6142" y="4922"/>
                  </a:lnTo>
                  <a:lnTo>
                    <a:pt x="6183" y="4760"/>
                  </a:lnTo>
                  <a:lnTo>
                    <a:pt x="6224" y="4597"/>
                  </a:lnTo>
                  <a:lnTo>
                    <a:pt x="6224" y="4434"/>
                  </a:lnTo>
                  <a:lnTo>
                    <a:pt x="6183" y="4231"/>
                  </a:lnTo>
                  <a:lnTo>
                    <a:pt x="6102" y="4068"/>
                  </a:lnTo>
                  <a:lnTo>
                    <a:pt x="6020" y="3946"/>
                  </a:lnTo>
                  <a:lnTo>
                    <a:pt x="6183" y="3865"/>
                  </a:lnTo>
                  <a:lnTo>
                    <a:pt x="6346" y="3783"/>
                  </a:lnTo>
                  <a:lnTo>
                    <a:pt x="6468" y="3702"/>
                  </a:lnTo>
                  <a:lnTo>
                    <a:pt x="6549" y="3539"/>
                  </a:lnTo>
                  <a:lnTo>
                    <a:pt x="6630" y="3417"/>
                  </a:lnTo>
                  <a:lnTo>
                    <a:pt x="6712" y="3255"/>
                  </a:lnTo>
                  <a:lnTo>
                    <a:pt x="6712" y="3051"/>
                  </a:lnTo>
                  <a:lnTo>
                    <a:pt x="6712" y="2889"/>
                  </a:lnTo>
                  <a:lnTo>
                    <a:pt x="6671" y="2685"/>
                  </a:lnTo>
                  <a:lnTo>
                    <a:pt x="6590" y="2522"/>
                  </a:lnTo>
                  <a:lnTo>
                    <a:pt x="6468" y="2360"/>
                  </a:lnTo>
                  <a:lnTo>
                    <a:pt x="6346" y="2238"/>
                  </a:lnTo>
                  <a:lnTo>
                    <a:pt x="6183" y="2156"/>
                  </a:lnTo>
                  <a:lnTo>
                    <a:pt x="6020" y="2116"/>
                  </a:lnTo>
                  <a:lnTo>
                    <a:pt x="5858" y="2075"/>
                  </a:lnTo>
                  <a:lnTo>
                    <a:pt x="5654" y="2075"/>
                  </a:lnTo>
                  <a:lnTo>
                    <a:pt x="5776" y="1750"/>
                  </a:lnTo>
                  <a:lnTo>
                    <a:pt x="5817" y="1546"/>
                  </a:lnTo>
                  <a:lnTo>
                    <a:pt x="5817" y="1384"/>
                  </a:lnTo>
                  <a:lnTo>
                    <a:pt x="5776" y="1099"/>
                  </a:lnTo>
                  <a:lnTo>
                    <a:pt x="5654" y="855"/>
                  </a:lnTo>
                  <a:lnTo>
                    <a:pt x="5491" y="651"/>
                  </a:lnTo>
                  <a:lnTo>
                    <a:pt x="5369" y="570"/>
                  </a:lnTo>
                  <a:lnTo>
                    <a:pt x="5247" y="489"/>
                  </a:lnTo>
                  <a:lnTo>
                    <a:pt x="4963" y="448"/>
                  </a:lnTo>
                  <a:lnTo>
                    <a:pt x="4678" y="489"/>
                  </a:lnTo>
                  <a:lnTo>
                    <a:pt x="4434" y="570"/>
                  </a:lnTo>
                  <a:lnTo>
                    <a:pt x="4190" y="733"/>
                  </a:lnTo>
                  <a:lnTo>
                    <a:pt x="3946" y="977"/>
                  </a:lnTo>
                  <a:lnTo>
                    <a:pt x="3783" y="1262"/>
                  </a:lnTo>
                  <a:lnTo>
                    <a:pt x="3661" y="895"/>
                  </a:lnTo>
                  <a:lnTo>
                    <a:pt x="3458" y="448"/>
                  </a:lnTo>
                  <a:lnTo>
                    <a:pt x="3336" y="245"/>
                  </a:lnTo>
                  <a:lnTo>
                    <a:pt x="3132" y="82"/>
                  </a:lnTo>
                  <a:lnTo>
                    <a:pt x="3010" y="41"/>
                  </a:lnTo>
                  <a:lnTo>
                    <a:pt x="2888" y="1"/>
                  </a:lnTo>
                  <a:close/>
                </a:path>
              </a:pathLst>
            </a:custGeom>
            <a:solidFill>
              <a:schemeClr val="accen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8" name="Google Shape;208;p17"/>
            <p:cNvSpPr/>
            <p:nvPr/>
          </p:nvSpPr>
          <p:spPr>
            <a:xfrm>
              <a:off x="1109780" y="1246551"/>
              <a:ext cx="169440" cy="158275"/>
            </a:xfrm>
            <a:custGeom>
              <a:rect b="b" l="l" r="r" t="t"/>
              <a:pathLst>
                <a:path extrusionOk="0" h="3459" w="3703">
                  <a:moveTo>
                    <a:pt x="1668" y="1"/>
                  </a:moveTo>
                  <a:lnTo>
                    <a:pt x="1424" y="82"/>
                  </a:lnTo>
                  <a:lnTo>
                    <a:pt x="1140" y="164"/>
                  </a:lnTo>
                  <a:lnTo>
                    <a:pt x="936" y="286"/>
                  </a:lnTo>
                  <a:lnTo>
                    <a:pt x="692" y="448"/>
                  </a:lnTo>
                  <a:lnTo>
                    <a:pt x="489" y="652"/>
                  </a:lnTo>
                  <a:lnTo>
                    <a:pt x="285" y="896"/>
                  </a:lnTo>
                  <a:lnTo>
                    <a:pt x="163" y="1140"/>
                  </a:lnTo>
                  <a:lnTo>
                    <a:pt x="41" y="1425"/>
                  </a:lnTo>
                  <a:lnTo>
                    <a:pt x="1" y="1709"/>
                  </a:lnTo>
                  <a:lnTo>
                    <a:pt x="1" y="1994"/>
                  </a:lnTo>
                  <a:lnTo>
                    <a:pt x="82" y="2320"/>
                  </a:lnTo>
                  <a:lnTo>
                    <a:pt x="204" y="2604"/>
                  </a:lnTo>
                  <a:lnTo>
                    <a:pt x="367" y="2848"/>
                  </a:lnTo>
                  <a:lnTo>
                    <a:pt x="570" y="3052"/>
                  </a:lnTo>
                  <a:lnTo>
                    <a:pt x="814" y="3214"/>
                  </a:lnTo>
                  <a:lnTo>
                    <a:pt x="1058" y="3336"/>
                  </a:lnTo>
                  <a:lnTo>
                    <a:pt x="1302" y="3418"/>
                  </a:lnTo>
                  <a:lnTo>
                    <a:pt x="1587" y="3458"/>
                  </a:lnTo>
                  <a:lnTo>
                    <a:pt x="1912" y="3458"/>
                  </a:lnTo>
                  <a:lnTo>
                    <a:pt x="2197" y="3377"/>
                  </a:lnTo>
                  <a:lnTo>
                    <a:pt x="2441" y="3255"/>
                  </a:lnTo>
                  <a:lnTo>
                    <a:pt x="2726" y="3092"/>
                  </a:lnTo>
                  <a:lnTo>
                    <a:pt x="2970" y="2889"/>
                  </a:lnTo>
                  <a:lnTo>
                    <a:pt x="3173" y="2686"/>
                  </a:lnTo>
                  <a:lnTo>
                    <a:pt x="3377" y="2401"/>
                  </a:lnTo>
                  <a:lnTo>
                    <a:pt x="3539" y="2157"/>
                  </a:lnTo>
                  <a:lnTo>
                    <a:pt x="3621" y="1831"/>
                  </a:lnTo>
                  <a:lnTo>
                    <a:pt x="3702" y="1547"/>
                  </a:lnTo>
                  <a:lnTo>
                    <a:pt x="3702" y="1303"/>
                  </a:lnTo>
                  <a:lnTo>
                    <a:pt x="3661" y="1059"/>
                  </a:lnTo>
                  <a:lnTo>
                    <a:pt x="3580" y="815"/>
                  </a:lnTo>
                  <a:lnTo>
                    <a:pt x="3458" y="611"/>
                  </a:lnTo>
                  <a:lnTo>
                    <a:pt x="3336" y="448"/>
                  </a:lnTo>
                  <a:lnTo>
                    <a:pt x="3173" y="286"/>
                  </a:lnTo>
                  <a:lnTo>
                    <a:pt x="2929" y="164"/>
                  </a:lnTo>
                  <a:lnTo>
                    <a:pt x="2726" y="82"/>
                  </a:lnTo>
                  <a:lnTo>
                    <a:pt x="2441" y="1"/>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09" name="Google Shape;209;p17"/>
            <p:cNvSpPr/>
            <p:nvPr/>
          </p:nvSpPr>
          <p:spPr>
            <a:xfrm>
              <a:off x="1200974" y="1274509"/>
              <a:ext cx="18669" cy="18623"/>
            </a:xfrm>
            <a:custGeom>
              <a:rect b="b" l="l" r="r" t="t"/>
              <a:pathLst>
                <a:path extrusionOk="0" h="407" w="408">
                  <a:moveTo>
                    <a:pt x="204" y="0"/>
                  </a:moveTo>
                  <a:lnTo>
                    <a:pt x="123" y="41"/>
                  </a:lnTo>
                  <a:lnTo>
                    <a:pt x="82" y="81"/>
                  </a:lnTo>
                  <a:lnTo>
                    <a:pt x="41" y="122"/>
                  </a:lnTo>
                  <a:lnTo>
                    <a:pt x="1" y="204"/>
                  </a:lnTo>
                  <a:lnTo>
                    <a:pt x="41" y="285"/>
                  </a:lnTo>
                  <a:lnTo>
                    <a:pt x="82" y="326"/>
                  </a:lnTo>
                  <a:lnTo>
                    <a:pt x="123" y="366"/>
                  </a:lnTo>
                  <a:lnTo>
                    <a:pt x="204" y="407"/>
                  </a:lnTo>
                  <a:lnTo>
                    <a:pt x="285" y="366"/>
                  </a:lnTo>
                  <a:lnTo>
                    <a:pt x="367" y="326"/>
                  </a:lnTo>
                  <a:lnTo>
                    <a:pt x="407" y="285"/>
                  </a:lnTo>
                  <a:lnTo>
                    <a:pt x="407" y="204"/>
                  </a:lnTo>
                  <a:lnTo>
                    <a:pt x="407" y="122"/>
                  </a:lnTo>
                  <a:lnTo>
                    <a:pt x="367" y="81"/>
                  </a:lnTo>
                  <a:lnTo>
                    <a:pt x="285" y="41"/>
                  </a:lnTo>
                  <a:lnTo>
                    <a:pt x="204"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0" name="Google Shape;210;p17"/>
            <p:cNvSpPr/>
            <p:nvPr/>
          </p:nvSpPr>
          <p:spPr>
            <a:xfrm>
              <a:off x="1158191" y="1281922"/>
              <a:ext cx="18623" cy="16793"/>
            </a:xfrm>
            <a:custGeom>
              <a:rect b="b" l="l" r="r" t="t"/>
              <a:pathLst>
                <a:path extrusionOk="0" h="367" w="407">
                  <a:moveTo>
                    <a:pt x="122" y="1"/>
                  </a:moveTo>
                  <a:lnTo>
                    <a:pt x="41" y="42"/>
                  </a:lnTo>
                  <a:lnTo>
                    <a:pt x="0" y="123"/>
                  </a:lnTo>
                  <a:lnTo>
                    <a:pt x="0" y="164"/>
                  </a:lnTo>
                  <a:lnTo>
                    <a:pt x="0" y="245"/>
                  </a:lnTo>
                  <a:lnTo>
                    <a:pt x="41" y="326"/>
                  </a:lnTo>
                  <a:lnTo>
                    <a:pt x="82" y="367"/>
                  </a:lnTo>
                  <a:lnTo>
                    <a:pt x="285" y="367"/>
                  </a:lnTo>
                  <a:lnTo>
                    <a:pt x="366" y="326"/>
                  </a:lnTo>
                  <a:lnTo>
                    <a:pt x="407" y="245"/>
                  </a:lnTo>
                  <a:lnTo>
                    <a:pt x="407" y="164"/>
                  </a:lnTo>
                  <a:lnTo>
                    <a:pt x="407" y="123"/>
                  </a:lnTo>
                  <a:lnTo>
                    <a:pt x="366" y="42"/>
                  </a:lnTo>
                  <a:lnTo>
                    <a:pt x="32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1" name="Google Shape;211;p17"/>
            <p:cNvSpPr/>
            <p:nvPr/>
          </p:nvSpPr>
          <p:spPr>
            <a:xfrm>
              <a:off x="1143274" y="1328457"/>
              <a:ext cx="16793" cy="18669"/>
            </a:xfrm>
            <a:custGeom>
              <a:rect b="b" l="l" r="r" t="t"/>
              <a:pathLst>
                <a:path extrusionOk="0" h="408" w="367">
                  <a:moveTo>
                    <a:pt x="123" y="1"/>
                  </a:moveTo>
                  <a:lnTo>
                    <a:pt x="41" y="82"/>
                  </a:lnTo>
                  <a:lnTo>
                    <a:pt x="1" y="123"/>
                  </a:lnTo>
                  <a:lnTo>
                    <a:pt x="1" y="204"/>
                  </a:lnTo>
                  <a:lnTo>
                    <a:pt x="1" y="285"/>
                  </a:lnTo>
                  <a:lnTo>
                    <a:pt x="41" y="326"/>
                  </a:lnTo>
                  <a:lnTo>
                    <a:pt x="123" y="367"/>
                  </a:lnTo>
                  <a:lnTo>
                    <a:pt x="204" y="407"/>
                  </a:lnTo>
                  <a:lnTo>
                    <a:pt x="285" y="367"/>
                  </a:lnTo>
                  <a:lnTo>
                    <a:pt x="326" y="326"/>
                  </a:lnTo>
                  <a:lnTo>
                    <a:pt x="367" y="285"/>
                  </a:lnTo>
                  <a:lnTo>
                    <a:pt x="367" y="204"/>
                  </a:lnTo>
                  <a:lnTo>
                    <a:pt x="367" y="123"/>
                  </a:lnTo>
                  <a:lnTo>
                    <a:pt x="326" y="82"/>
                  </a:lnTo>
                  <a:lnTo>
                    <a:pt x="285"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2" name="Google Shape;212;p17"/>
            <p:cNvSpPr/>
            <p:nvPr/>
          </p:nvSpPr>
          <p:spPr>
            <a:xfrm>
              <a:off x="1182351" y="1356369"/>
              <a:ext cx="16839" cy="18669"/>
            </a:xfrm>
            <a:custGeom>
              <a:rect b="b" l="l" r="r" t="t"/>
              <a:pathLst>
                <a:path extrusionOk="0" h="408" w="368">
                  <a:moveTo>
                    <a:pt x="123" y="1"/>
                  </a:moveTo>
                  <a:lnTo>
                    <a:pt x="42" y="42"/>
                  </a:lnTo>
                  <a:lnTo>
                    <a:pt x="1" y="123"/>
                  </a:lnTo>
                  <a:lnTo>
                    <a:pt x="1" y="204"/>
                  </a:lnTo>
                  <a:lnTo>
                    <a:pt x="1" y="286"/>
                  </a:lnTo>
                  <a:lnTo>
                    <a:pt x="42" y="326"/>
                  </a:lnTo>
                  <a:lnTo>
                    <a:pt x="123" y="367"/>
                  </a:lnTo>
                  <a:lnTo>
                    <a:pt x="204" y="408"/>
                  </a:lnTo>
                  <a:lnTo>
                    <a:pt x="286" y="367"/>
                  </a:lnTo>
                  <a:lnTo>
                    <a:pt x="326" y="326"/>
                  </a:lnTo>
                  <a:lnTo>
                    <a:pt x="367" y="286"/>
                  </a:lnTo>
                  <a:lnTo>
                    <a:pt x="367" y="204"/>
                  </a:lnTo>
                  <a:lnTo>
                    <a:pt x="367" y="123"/>
                  </a:lnTo>
                  <a:lnTo>
                    <a:pt x="326" y="42"/>
                  </a:lnTo>
                  <a:lnTo>
                    <a:pt x="286"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3" name="Google Shape;213;p17"/>
            <p:cNvSpPr/>
            <p:nvPr/>
          </p:nvSpPr>
          <p:spPr>
            <a:xfrm>
              <a:off x="1225180" y="1319168"/>
              <a:ext cx="18669" cy="18669"/>
            </a:xfrm>
            <a:custGeom>
              <a:rect b="b" l="l" r="r" t="t"/>
              <a:pathLst>
                <a:path extrusionOk="0" h="408" w="408">
                  <a:moveTo>
                    <a:pt x="123" y="0"/>
                  </a:moveTo>
                  <a:lnTo>
                    <a:pt x="82" y="41"/>
                  </a:lnTo>
                  <a:lnTo>
                    <a:pt x="41" y="122"/>
                  </a:lnTo>
                  <a:lnTo>
                    <a:pt x="1" y="204"/>
                  </a:lnTo>
                  <a:lnTo>
                    <a:pt x="41" y="244"/>
                  </a:lnTo>
                  <a:lnTo>
                    <a:pt x="82" y="326"/>
                  </a:lnTo>
                  <a:lnTo>
                    <a:pt x="123" y="366"/>
                  </a:lnTo>
                  <a:lnTo>
                    <a:pt x="204" y="407"/>
                  </a:lnTo>
                  <a:lnTo>
                    <a:pt x="285" y="366"/>
                  </a:lnTo>
                  <a:lnTo>
                    <a:pt x="367" y="326"/>
                  </a:lnTo>
                  <a:lnTo>
                    <a:pt x="407" y="244"/>
                  </a:lnTo>
                  <a:lnTo>
                    <a:pt x="407" y="204"/>
                  </a:lnTo>
                  <a:lnTo>
                    <a:pt x="407" y="122"/>
                  </a:lnTo>
                  <a:lnTo>
                    <a:pt x="367" y="41"/>
                  </a:lnTo>
                  <a:lnTo>
                    <a:pt x="285" y="0"/>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4" name="Google Shape;214;p17"/>
            <p:cNvSpPr/>
            <p:nvPr/>
          </p:nvSpPr>
          <p:spPr>
            <a:xfrm>
              <a:off x="1186103" y="1309834"/>
              <a:ext cx="18669" cy="18669"/>
            </a:xfrm>
            <a:custGeom>
              <a:rect b="b" l="l" r="r" t="t"/>
              <a:pathLst>
                <a:path extrusionOk="0" h="408" w="408">
                  <a:moveTo>
                    <a:pt x="204" y="1"/>
                  </a:moveTo>
                  <a:lnTo>
                    <a:pt x="122" y="42"/>
                  </a:lnTo>
                  <a:lnTo>
                    <a:pt x="82" y="82"/>
                  </a:lnTo>
                  <a:lnTo>
                    <a:pt x="41" y="123"/>
                  </a:lnTo>
                  <a:lnTo>
                    <a:pt x="0" y="204"/>
                  </a:lnTo>
                  <a:lnTo>
                    <a:pt x="41" y="286"/>
                  </a:lnTo>
                  <a:lnTo>
                    <a:pt x="82" y="367"/>
                  </a:lnTo>
                  <a:lnTo>
                    <a:pt x="122" y="408"/>
                  </a:lnTo>
                  <a:lnTo>
                    <a:pt x="285" y="408"/>
                  </a:lnTo>
                  <a:lnTo>
                    <a:pt x="366" y="367"/>
                  </a:lnTo>
                  <a:lnTo>
                    <a:pt x="407" y="286"/>
                  </a:lnTo>
                  <a:lnTo>
                    <a:pt x="407" y="204"/>
                  </a:lnTo>
                  <a:lnTo>
                    <a:pt x="407" y="123"/>
                  </a:lnTo>
                  <a:lnTo>
                    <a:pt x="366" y="82"/>
                  </a:lnTo>
                  <a:lnTo>
                    <a:pt x="285" y="42"/>
                  </a:lnTo>
                  <a:lnTo>
                    <a:pt x="20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215" name="Google Shape;215;p17"/>
          <p:cNvSpPr/>
          <p:nvPr/>
        </p:nvSpPr>
        <p:spPr>
          <a:xfrm flipH="1" rot="10800000">
            <a:off x="5104921" y="422330"/>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16" name="Google Shape;216;p17"/>
          <p:cNvSpPr txBox="1"/>
          <p:nvPr>
            <p:ph idx="12" type="sldNum"/>
          </p:nvPr>
        </p:nvSpPr>
        <p:spPr>
          <a:xfrm>
            <a:off x="8556784" y="4749851"/>
            <a:ext cx="548700" cy="393600"/>
          </a:xfrm>
          <a:prstGeom prst="rect">
            <a:avLst/>
          </a:prstGeom>
        </p:spPr>
        <p:txBody>
          <a:bodyPr anchorCtr="0" anchor="t"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slideLayout" Target="../slideLayouts/slideLayout15.xml"/><Relationship Id="rId14" Type="http://schemas.openxmlformats.org/officeDocument/2006/relationships/slideLayout" Target="../slideLayouts/slideLayout14.xml"/><Relationship Id="rId17" Type="http://schemas.openxmlformats.org/officeDocument/2006/relationships/theme" Target="../theme/theme2.xml"/><Relationship Id="rId16" Type="http://schemas.openxmlformats.org/officeDocument/2006/relationships/slideLayout" Target="../slideLayouts/slideLayout16.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Lst>
  <p:hf dt="0" ftr="0" hdr="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0.xml"/><Relationship Id="rId3" Type="http://schemas.openxmlformats.org/officeDocument/2006/relationships/image" Target="../media/image1.jp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1.xml"/><Relationship Id="rId3" Type="http://schemas.openxmlformats.org/officeDocument/2006/relationships/image" Target="../media/image8.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0.xml"/><Relationship Id="rId3" Type="http://schemas.openxmlformats.org/officeDocument/2006/relationships/image" Target="../media/image3.png"/><Relationship Id="rId4" Type="http://schemas.openxmlformats.org/officeDocument/2006/relationships/image" Target="../media/image6.png"/><Relationship Id="rId5" Type="http://schemas.openxmlformats.org/officeDocument/2006/relationships/image" Target="../media/image4.pn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2.xml"/><Relationship Id="rId3" Type="http://schemas.openxmlformats.org/officeDocument/2006/relationships/image" Target="../media/image11.png"/><Relationship Id="rId4" Type="http://schemas.openxmlformats.org/officeDocument/2006/relationships/image" Target="../media/image13.png"/><Relationship Id="rId5" Type="http://schemas.openxmlformats.org/officeDocument/2006/relationships/image" Target="../media/image9.png"/><Relationship Id="rId6" Type="http://schemas.openxmlformats.org/officeDocument/2006/relationships/image" Target="../media/image15.png"/><Relationship Id="rId7" Type="http://schemas.openxmlformats.org/officeDocument/2006/relationships/image" Target="../media/image10.png"/><Relationship Id="rId8" Type="http://schemas.openxmlformats.org/officeDocument/2006/relationships/image" Target="../media/image14.png"/></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6.xml"/><Relationship Id="rId3" Type="http://schemas.openxmlformats.org/officeDocument/2006/relationships/image" Target="../media/image16.jpg"/></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0.xml"/><Relationship Id="rId3" Type="http://schemas.openxmlformats.org/officeDocument/2006/relationships/image" Target="../media/image2.jp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3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4.xml"/><Relationship Id="rId3" Type="http://schemas.openxmlformats.org/officeDocument/2006/relationships/image" Target="../media/image5.jpg"/></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5.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6.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8.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9.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40.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1.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2.xml"/><Relationship Id="rId3" Type="http://schemas.openxmlformats.org/officeDocument/2006/relationships/image" Target="../media/image12.jpg"/></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3.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4.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5.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6.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7.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48.xml"/><Relationship Id="rId3" Type="http://schemas.openxmlformats.org/officeDocument/2006/relationships/image" Target="../media/image7.jp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0" name="Shape 220"/>
        <p:cNvGrpSpPr/>
        <p:nvPr/>
      </p:nvGrpSpPr>
      <p:grpSpPr>
        <a:xfrm>
          <a:off x="0" y="0"/>
          <a:ext cx="0" cy="0"/>
          <a:chOff x="0" y="0"/>
          <a:chExt cx="0" cy="0"/>
        </a:xfrm>
      </p:grpSpPr>
      <p:sp>
        <p:nvSpPr>
          <p:cNvPr id="221" name="Google Shape;221;p18"/>
          <p:cNvSpPr txBox="1"/>
          <p:nvPr>
            <p:ph type="ctrTitle"/>
          </p:nvPr>
        </p:nvSpPr>
        <p:spPr>
          <a:xfrm>
            <a:off x="459450" y="1320175"/>
            <a:ext cx="8225100" cy="2303700"/>
          </a:xfrm>
          <a:prstGeom prst="rect">
            <a:avLst/>
          </a:prstGeom>
        </p:spPr>
        <p:txBody>
          <a:bodyPr anchorCtr="0" anchor="b" bIns="91425" lIns="91425" spcFirstLastPara="1" rIns="91425" wrap="square" tIns="91425">
            <a:normAutofit/>
          </a:bodyPr>
          <a:lstStyle/>
          <a:p>
            <a:pPr indent="0" lvl="0" marL="0" rtl="0" algn="ctr">
              <a:lnSpc>
                <a:spcPct val="115000"/>
              </a:lnSpc>
              <a:spcBef>
                <a:spcPts val="0"/>
              </a:spcBef>
              <a:spcAft>
                <a:spcPts val="0"/>
              </a:spcAft>
              <a:buClr>
                <a:schemeClr val="dk1"/>
              </a:buClr>
              <a:buSzPts val="1100"/>
              <a:buFont typeface="Arial"/>
              <a:buNone/>
            </a:pPr>
            <a:r>
              <a:rPr lang="en" sz="3000"/>
              <a:t>Enhancing</a:t>
            </a:r>
            <a:r>
              <a:rPr lang="en" sz="3000"/>
              <a:t> Cultural Competence: Addressing Mental Health Disparities in AANHPI Communities</a:t>
            </a:r>
            <a:endParaRPr sz="3000"/>
          </a:p>
          <a:p>
            <a:pPr indent="0" lvl="0" marL="0" rtl="0" algn="ctr">
              <a:spcBef>
                <a:spcPts val="0"/>
              </a:spcBef>
              <a:spcAft>
                <a:spcPts val="0"/>
              </a:spcAft>
              <a:buNone/>
            </a:pPr>
            <a:r>
              <a:t/>
            </a:r>
            <a:endParaRPr sz="3000"/>
          </a:p>
        </p:txBody>
      </p:sp>
      <p:sp>
        <p:nvSpPr>
          <p:cNvPr id="222" name="Google Shape;222;p18"/>
          <p:cNvSpPr txBox="1"/>
          <p:nvPr>
            <p:ph idx="1" type="subTitle"/>
          </p:nvPr>
        </p:nvSpPr>
        <p:spPr>
          <a:xfrm>
            <a:off x="459450" y="3016625"/>
            <a:ext cx="4223700" cy="475800"/>
          </a:xfrm>
          <a:prstGeom prst="rect">
            <a:avLst/>
          </a:prstGeom>
        </p:spPr>
        <p:txBody>
          <a:bodyPr anchorCtr="0" anchor="t" bIns="91425" lIns="91425" spcFirstLastPara="1" rIns="91425" wrap="square" tIns="91425">
            <a:normAutofit fontScale="25000"/>
          </a:bodyPr>
          <a:lstStyle/>
          <a:p>
            <a:pPr indent="0" lvl="0" marL="0" rtl="0" algn="ctr">
              <a:spcBef>
                <a:spcPts val="0"/>
              </a:spcBef>
              <a:spcAft>
                <a:spcPts val="0"/>
              </a:spcAft>
              <a:buNone/>
            </a:pPr>
            <a:r>
              <a:rPr lang="en"/>
              <a:t>APAMSA Chapter at Columbia </a:t>
            </a:r>
            <a:r>
              <a:rPr lang="en"/>
              <a:t>University</a:t>
            </a:r>
            <a:r>
              <a:rPr lang="en"/>
              <a:t>, Vagelos College of Physicians and Surgeons</a:t>
            </a:r>
            <a:endParaRPr/>
          </a:p>
          <a:p>
            <a:pPr indent="0" lvl="0" marL="0" rtl="0" algn="ctr">
              <a:spcBef>
                <a:spcPts val="0"/>
              </a:spcBef>
              <a:spcAft>
                <a:spcPts val="0"/>
              </a:spcAft>
              <a:buNone/>
            </a:pPr>
            <a:r>
              <a:t/>
            </a:r>
            <a:endParaRPr/>
          </a:p>
        </p:txBody>
      </p:sp>
      <p:sp>
        <p:nvSpPr>
          <p:cNvPr id="223" name="Google Shape;223;p1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224" name="Google Shape;224;p18"/>
          <p:cNvSpPr txBox="1"/>
          <p:nvPr>
            <p:ph type="ctrTitle"/>
          </p:nvPr>
        </p:nvSpPr>
        <p:spPr>
          <a:xfrm>
            <a:off x="5883038" y="2707175"/>
            <a:ext cx="2706600" cy="719100"/>
          </a:xfrm>
          <a:prstGeom prst="rect">
            <a:avLst/>
          </a:prstGeom>
          <a:solidFill>
            <a:schemeClr val="accent1"/>
          </a:solidFill>
          <a:ln cap="flat" cmpd="sng" w="28575">
            <a:solidFill>
              <a:schemeClr val="dk1"/>
            </a:solidFill>
            <a:prstDash val="solid"/>
            <a:round/>
            <a:headEnd len="sm" w="sm" type="none"/>
            <a:tailEnd len="sm" w="sm" type="none"/>
          </a:ln>
        </p:spPr>
        <p:txBody>
          <a:bodyPr anchorCtr="0" anchor="b" bIns="91425" lIns="91425" spcFirstLastPara="1" rIns="91425" wrap="square" tIns="91425">
            <a:normAutofit/>
          </a:bodyPr>
          <a:lstStyle/>
          <a:p>
            <a:pPr indent="0" lvl="0" marL="0" rtl="0" algn="ctr">
              <a:spcBef>
                <a:spcPts val="0"/>
              </a:spcBef>
              <a:spcAft>
                <a:spcPts val="0"/>
              </a:spcAft>
              <a:buNone/>
            </a:pPr>
            <a:r>
              <a:rPr lang="en" sz="1700"/>
              <a:t>Please complete the </a:t>
            </a:r>
            <a:br>
              <a:rPr lang="en" sz="1700"/>
            </a:br>
            <a:r>
              <a:rPr lang="en" sz="1700"/>
              <a:t>Pre-workshop Survey!</a:t>
            </a:r>
            <a:endParaRPr sz="1700"/>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1" name="Shape 291"/>
        <p:cNvGrpSpPr/>
        <p:nvPr/>
      </p:nvGrpSpPr>
      <p:grpSpPr>
        <a:xfrm>
          <a:off x="0" y="0"/>
          <a:ext cx="0" cy="0"/>
          <a:chOff x="0" y="0"/>
          <a:chExt cx="0" cy="0"/>
        </a:xfrm>
      </p:grpSpPr>
      <p:sp>
        <p:nvSpPr>
          <p:cNvPr id="292" name="Google Shape;292;p2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t>‹#›</a:t>
            </a:fld>
            <a:endParaRPr/>
          </a:p>
        </p:txBody>
      </p:sp>
      <p:sp>
        <p:nvSpPr>
          <p:cNvPr id="293" name="Google Shape;293;p27"/>
          <p:cNvSpPr txBox="1"/>
          <p:nvPr>
            <p:ph idx="4294967295" type="title"/>
          </p:nvPr>
        </p:nvSpPr>
        <p:spPr>
          <a:xfrm>
            <a:off x="241000" y="433625"/>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AANHPI Mental Health Statistics</a:t>
            </a:r>
            <a:endParaRPr b="1"/>
          </a:p>
        </p:txBody>
      </p:sp>
      <p:sp>
        <p:nvSpPr>
          <p:cNvPr id="294" name="Google Shape;294;p27"/>
          <p:cNvSpPr txBox="1"/>
          <p:nvPr>
            <p:ph idx="4294967295" type="subTitle"/>
          </p:nvPr>
        </p:nvSpPr>
        <p:spPr>
          <a:xfrm>
            <a:off x="410450" y="2246925"/>
            <a:ext cx="4500900" cy="986100"/>
          </a:xfrm>
          <a:prstGeom prst="rect">
            <a:avLst/>
          </a:prstGeom>
          <a:ln cap="flat" cmpd="sng" w="28575">
            <a:solidFill>
              <a:srgbClr val="C9DAF9"/>
            </a:solidFill>
            <a:prstDash val="solid"/>
            <a:round/>
            <a:headEnd len="sm" w="sm" type="none"/>
            <a:tailEnd len="sm" w="sm" type="none"/>
          </a:ln>
        </p:spPr>
        <p:txBody>
          <a:bodyPr anchorCtr="0" anchor="t" bIns="91425" lIns="91425" spcFirstLastPara="1" rIns="91425" wrap="square" tIns="91425">
            <a:noAutofit/>
          </a:bodyPr>
          <a:lstStyle/>
          <a:p>
            <a:pPr indent="0" lvl="0" marL="0" rtl="0" algn="l">
              <a:spcBef>
                <a:spcPts val="0"/>
              </a:spcBef>
              <a:spcAft>
                <a:spcPts val="1200"/>
              </a:spcAft>
              <a:buNone/>
            </a:pPr>
            <a:r>
              <a:rPr lang="en" sz="1500"/>
              <a:t>However, Asian American individuals are up to</a:t>
            </a:r>
            <a:r>
              <a:rPr b="1" lang="en" sz="1500"/>
              <a:t> 5x less likely </a:t>
            </a:r>
            <a:r>
              <a:rPr lang="en" sz="1500"/>
              <a:t>to seek out mental health services compared to their White peers.</a:t>
            </a:r>
            <a:endParaRPr sz="1500"/>
          </a:p>
        </p:txBody>
      </p:sp>
      <p:sp>
        <p:nvSpPr>
          <p:cNvPr id="295" name="Google Shape;295;p27"/>
          <p:cNvSpPr txBox="1"/>
          <p:nvPr>
            <p:ph idx="4294967295" type="subTitle"/>
          </p:nvPr>
        </p:nvSpPr>
        <p:spPr>
          <a:xfrm>
            <a:off x="410450" y="1333675"/>
            <a:ext cx="4500900" cy="738300"/>
          </a:xfrm>
          <a:prstGeom prst="rect">
            <a:avLst/>
          </a:prstGeom>
          <a:ln cap="flat" cmpd="sng" w="28575">
            <a:solidFill>
              <a:srgbClr val="C9DAF9"/>
            </a:solidFill>
            <a:prstDash val="solid"/>
            <a:round/>
            <a:headEnd len="sm" w="sm" type="none"/>
            <a:tailEnd len="sm" w="sm" type="none"/>
          </a:ln>
        </p:spPr>
        <p:txBody>
          <a:bodyPr anchorCtr="0" anchor="t" bIns="91425" lIns="91425" spcFirstLastPara="1" rIns="91425" wrap="square" tIns="91425">
            <a:noAutofit/>
          </a:bodyPr>
          <a:lstStyle/>
          <a:p>
            <a:pPr indent="0" lvl="0" marL="0" rtl="0" algn="l">
              <a:spcBef>
                <a:spcPts val="0"/>
              </a:spcBef>
              <a:spcAft>
                <a:spcPts val="1200"/>
              </a:spcAft>
              <a:buNone/>
            </a:pPr>
            <a:r>
              <a:rPr lang="en" sz="1500"/>
              <a:t>Up to </a:t>
            </a:r>
            <a:r>
              <a:rPr b="1" lang="en" sz="1500"/>
              <a:t>23.5% </a:t>
            </a:r>
            <a:r>
              <a:rPr lang="en" sz="1500"/>
              <a:t>of Asian Americans individuals experience a </a:t>
            </a:r>
            <a:r>
              <a:rPr b="1" lang="en" sz="1500"/>
              <a:t>psychiatric disorder</a:t>
            </a:r>
            <a:r>
              <a:rPr lang="en" sz="1500"/>
              <a:t> in their lifetime. </a:t>
            </a:r>
            <a:endParaRPr sz="1500"/>
          </a:p>
        </p:txBody>
      </p:sp>
      <p:sp>
        <p:nvSpPr>
          <p:cNvPr id="296" name="Google Shape;296;p27"/>
          <p:cNvSpPr/>
          <p:nvPr/>
        </p:nvSpPr>
        <p:spPr>
          <a:xfrm>
            <a:off x="6054153" y="4663347"/>
            <a:ext cx="85704" cy="85658"/>
          </a:xfrm>
          <a:custGeom>
            <a:rect b="b" l="l" r="r" t="t"/>
            <a:pathLst>
              <a:path extrusionOk="0" h="1872" w="1873">
                <a:moveTo>
                  <a:pt x="733" y="1"/>
                </a:moveTo>
                <a:lnTo>
                  <a:pt x="489" y="82"/>
                </a:lnTo>
                <a:lnTo>
                  <a:pt x="245" y="245"/>
                </a:lnTo>
                <a:lnTo>
                  <a:pt x="82" y="448"/>
                </a:lnTo>
                <a:lnTo>
                  <a:pt x="1" y="692"/>
                </a:lnTo>
                <a:lnTo>
                  <a:pt x="1" y="936"/>
                </a:lnTo>
                <a:lnTo>
                  <a:pt x="42" y="1221"/>
                </a:lnTo>
                <a:lnTo>
                  <a:pt x="123" y="1424"/>
                </a:lnTo>
                <a:lnTo>
                  <a:pt x="245" y="1546"/>
                </a:lnTo>
                <a:lnTo>
                  <a:pt x="367" y="1668"/>
                </a:lnTo>
                <a:lnTo>
                  <a:pt x="489" y="1750"/>
                </a:lnTo>
                <a:lnTo>
                  <a:pt x="611" y="1831"/>
                </a:lnTo>
                <a:lnTo>
                  <a:pt x="774" y="1872"/>
                </a:lnTo>
                <a:lnTo>
                  <a:pt x="1099" y="1872"/>
                </a:lnTo>
                <a:lnTo>
                  <a:pt x="1262" y="1831"/>
                </a:lnTo>
                <a:lnTo>
                  <a:pt x="1384" y="1791"/>
                </a:lnTo>
                <a:lnTo>
                  <a:pt x="1506" y="1709"/>
                </a:lnTo>
                <a:lnTo>
                  <a:pt x="1628" y="1587"/>
                </a:lnTo>
                <a:lnTo>
                  <a:pt x="1750" y="1465"/>
                </a:lnTo>
                <a:lnTo>
                  <a:pt x="1831" y="1302"/>
                </a:lnTo>
                <a:lnTo>
                  <a:pt x="1872" y="1140"/>
                </a:lnTo>
                <a:lnTo>
                  <a:pt x="1872" y="977"/>
                </a:lnTo>
                <a:lnTo>
                  <a:pt x="1872" y="774"/>
                </a:lnTo>
                <a:lnTo>
                  <a:pt x="1791" y="652"/>
                </a:lnTo>
                <a:lnTo>
                  <a:pt x="1750" y="489"/>
                </a:lnTo>
                <a:lnTo>
                  <a:pt x="1669" y="367"/>
                </a:lnTo>
                <a:lnTo>
                  <a:pt x="1547" y="245"/>
                </a:lnTo>
                <a:lnTo>
                  <a:pt x="1303" y="82"/>
                </a:lnTo>
                <a:lnTo>
                  <a:pt x="977" y="1"/>
                </a:lnTo>
                <a:close/>
              </a:path>
            </a:pathLst>
          </a:cu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97" name="Google Shape;297;p27"/>
          <p:cNvSpPr txBox="1"/>
          <p:nvPr/>
        </p:nvSpPr>
        <p:spPr>
          <a:xfrm>
            <a:off x="0" y="4851000"/>
            <a:ext cx="65214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Alvarez et al. </a:t>
            </a:r>
            <a:r>
              <a:rPr i="1" lang="en" sz="800">
                <a:solidFill>
                  <a:schemeClr val="dk1"/>
                </a:solidFill>
                <a:latin typeface="Hind"/>
                <a:ea typeface="Hind"/>
                <a:cs typeface="Hind"/>
                <a:sym typeface="Hind"/>
              </a:rPr>
              <a:t>Soc Psychiatry Psychiatr Epidemio. 2019. </a:t>
            </a:r>
            <a:r>
              <a:rPr lang="en" sz="800">
                <a:solidFill>
                  <a:schemeClr val="dk1"/>
                </a:solidFill>
                <a:latin typeface="Hind"/>
                <a:ea typeface="Hind"/>
                <a:cs typeface="Hind"/>
                <a:sym typeface="Hind"/>
              </a:rPr>
              <a:t>Tse and Haslam </a:t>
            </a:r>
            <a:r>
              <a:rPr i="1" lang="en" sz="800">
                <a:solidFill>
                  <a:schemeClr val="dk1"/>
                </a:solidFill>
                <a:latin typeface="Hind"/>
                <a:ea typeface="Hind"/>
                <a:cs typeface="Hind"/>
                <a:sym typeface="Hind"/>
              </a:rPr>
              <a:t>Front Psychol.</a:t>
            </a:r>
            <a:r>
              <a:rPr lang="en" sz="800">
                <a:solidFill>
                  <a:schemeClr val="dk1"/>
                </a:solidFill>
                <a:latin typeface="Hind"/>
                <a:ea typeface="Hind"/>
                <a:cs typeface="Hind"/>
                <a:sym typeface="Hind"/>
              </a:rPr>
              <a:t> 2021. Kim and Lee. </a:t>
            </a:r>
            <a:r>
              <a:rPr i="1" lang="en" sz="800">
                <a:solidFill>
                  <a:srgbClr val="1B1B1B"/>
                </a:solidFill>
                <a:latin typeface="Calibri"/>
                <a:ea typeface="Calibri"/>
                <a:cs typeface="Calibri"/>
                <a:sym typeface="Calibri"/>
              </a:rPr>
              <a:t>J Racial Ethn Health Disparities</a:t>
            </a:r>
            <a:r>
              <a:rPr lang="en" sz="800">
                <a:solidFill>
                  <a:srgbClr val="1B1B1B"/>
                </a:solidFill>
                <a:latin typeface="Calibri"/>
                <a:ea typeface="Calibri"/>
                <a:cs typeface="Calibri"/>
                <a:sym typeface="Calibri"/>
              </a:rPr>
              <a:t>. 2022.</a:t>
            </a:r>
            <a:endParaRPr sz="800">
              <a:solidFill>
                <a:schemeClr val="dk1"/>
              </a:solidFill>
              <a:latin typeface="Hind"/>
              <a:ea typeface="Hind"/>
              <a:cs typeface="Hind"/>
              <a:sym typeface="Hind"/>
            </a:endParaRPr>
          </a:p>
        </p:txBody>
      </p:sp>
      <p:sp>
        <p:nvSpPr>
          <p:cNvPr id="298" name="Google Shape;298;p27"/>
          <p:cNvSpPr txBox="1"/>
          <p:nvPr/>
        </p:nvSpPr>
        <p:spPr>
          <a:xfrm>
            <a:off x="410460" y="3413270"/>
            <a:ext cx="4500900" cy="877200"/>
          </a:xfrm>
          <a:prstGeom prst="rect">
            <a:avLst/>
          </a:prstGeom>
          <a:noFill/>
          <a:ln cap="flat" cmpd="sng" w="28575">
            <a:solidFill>
              <a:srgbClr val="C9DAF9"/>
            </a:solidFill>
            <a:prstDash val="solid"/>
            <a:round/>
            <a:headEnd len="sm" w="sm" type="none"/>
            <a:tailEnd len="sm" w="sm" type="none"/>
          </a:ln>
        </p:spPr>
        <p:txBody>
          <a:bodyPr anchorCtr="0" anchor="t" bIns="91425" lIns="91425" spcFirstLastPara="1" rIns="91425" wrap="square" tIns="91425">
            <a:spAutoFit/>
          </a:bodyPr>
          <a:lstStyle/>
          <a:p>
            <a:pPr indent="0" lvl="0" marL="0" rtl="0" algn="ctr">
              <a:spcBef>
                <a:spcPts val="0"/>
              </a:spcBef>
              <a:spcAft>
                <a:spcPts val="1600"/>
              </a:spcAft>
              <a:buNone/>
            </a:pPr>
            <a:r>
              <a:rPr lang="en" sz="1500">
                <a:solidFill>
                  <a:srgbClr val="434343"/>
                </a:solidFill>
                <a:latin typeface="Hind"/>
                <a:ea typeface="Hind"/>
                <a:cs typeface="Hind"/>
                <a:sym typeface="Hind"/>
              </a:rPr>
              <a:t>AA youths used mental health services (outpatient, 24 hour care, informal services, etc.) </a:t>
            </a:r>
            <a:r>
              <a:rPr b="1" lang="en" sz="1500">
                <a:solidFill>
                  <a:srgbClr val="434343"/>
                </a:solidFill>
                <a:latin typeface="Hind"/>
                <a:ea typeface="Hind"/>
                <a:cs typeface="Hind"/>
                <a:sym typeface="Hind"/>
              </a:rPr>
              <a:t>less than other racial &amp; ethnic groups.</a:t>
            </a:r>
            <a:endParaRPr b="1" sz="1500">
              <a:solidFill>
                <a:srgbClr val="434343"/>
              </a:solidFill>
              <a:latin typeface="Hind"/>
              <a:ea typeface="Hind"/>
              <a:cs typeface="Hind"/>
              <a:sym typeface="Hind"/>
            </a:endParaRPr>
          </a:p>
        </p:txBody>
      </p:sp>
      <p:pic>
        <p:nvPicPr>
          <p:cNvPr descr="Mental health and psychotherapy for person with anxiety disorder, rain clouds over head (Provided by Getty Images)" id="299" name="Google Shape;299;p27"/>
          <p:cNvPicPr preferRelativeResize="0"/>
          <p:nvPr/>
        </p:nvPicPr>
        <p:blipFill>
          <a:blip r:embed="rId3">
            <a:alphaModFix/>
          </a:blip>
          <a:stretch>
            <a:fillRect/>
          </a:stretch>
        </p:blipFill>
        <p:spPr>
          <a:xfrm>
            <a:off x="5115830" y="859315"/>
            <a:ext cx="3702026" cy="3702026"/>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3" name="Shape 303"/>
        <p:cNvGrpSpPr/>
        <p:nvPr/>
      </p:nvGrpSpPr>
      <p:grpSpPr>
        <a:xfrm>
          <a:off x="0" y="0"/>
          <a:ext cx="0" cy="0"/>
          <a:chOff x="0" y="0"/>
          <a:chExt cx="0" cy="0"/>
        </a:xfrm>
      </p:grpSpPr>
      <p:sp>
        <p:nvSpPr>
          <p:cNvPr id="304" name="Google Shape;304;p28"/>
          <p:cNvSpPr txBox="1"/>
          <p:nvPr>
            <p:ph type="title"/>
          </p:nvPr>
        </p:nvSpPr>
        <p:spPr>
          <a:xfrm>
            <a:off x="339000" y="521225"/>
            <a:ext cx="7704000" cy="8703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400"/>
              <a:t>With the COVID-19 pandemic having increased rates of discrimination and hate directed toward AANHPI individuals... </a:t>
            </a:r>
            <a:endParaRPr sz="1400"/>
          </a:p>
        </p:txBody>
      </p:sp>
      <p:sp>
        <p:nvSpPr>
          <p:cNvPr id="305" name="Google Shape;305;p28"/>
          <p:cNvSpPr txBox="1"/>
          <p:nvPr>
            <p:ph idx="4294967295" type="subTitle"/>
          </p:nvPr>
        </p:nvSpPr>
        <p:spPr>
          <a:xfrm>
            <a:off x="447600" y="865625"/>
            <a:ext cx="8248800" cy="13149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r>
              <a:rPr b="1" lang="en" sz="2700">
                <a:latin typeface="Hind"/>
                <a:ea typeface="Hind"/>
                <a:cs typeface="Hind"/>
                <a:sym typeface="Hind"/>
              </a:rPr>
              <a:t>Addressing mental health challenges is more pressing than ever before.</a:t>
            </a:r>
            <a:endParaRPr b="1" sz="2500">
              <a:latin typeface="Hind"/>
              <a:ea typeface="Hind"/>
              <a:cs typeface="Hind"/>
              <a:sym typeface="Hind"/>
            </a:endParaRPr>
          </a:p>
        </p:txBody>
      </p:sp>
      <p:sp>
        <p:nvSpPr>
          <p:cNvPr id="306" name="Google Shape;306;p28"/>
          <p:cNvSpPr txBox="1"/>
          <p:nvPr/>
        </p:nvSpPr>
        <p:spPr>
          <a:xfrm flipH="1">
            <a:off x="5292900" y="2028125"/>
            <a:ext cx="3318600" cy="1457400"/>
          </a:xfrm>
          <a:prstGeom prst="rect">
            <a:avLst/>
          </a:prstGeom>
          <a:noFill/>
          <a:ln>
            <a:noFill/>
          </a:ln>
        </p:spPr>
        <p:txBody>
          <a:bodyPr anchorCtr="0" anchor="ctr" bIns="91425" lIns="91425" spcFirstLastPara="1" rIns="91425" wrap="square" tIns="91425">
            <a:noAutofit/>
          </a:bodyPr>
          <a:lstStyle/>
          <a:p>
            <a:pPr indent="0" lvl="0" marL="0" rtl="0" algn="l">
              <a:spcBef>
                <a:spcPts val="0"/>
              </a:spcBef>
              <a:spcAft>
                <a:spcPts val="0"/>
              </a:spcAft>
              <a:buNone/>
            </a:pPr>
            <a:r>
              <a:rPr b="1" lang="en" sz="1700">
                <a:solidFill>
                  <a:srgbClr val="BF9000"/>
                </a:solidFill>
                <a:latin typeface="Hind"/>
                <a:ea typeface="Hind"/>
                <a:cs typeface="Hind"/>
                <a:sym typeface="Hind"/>
              </a:rPr>
              <a:t>35% of AANHPI individuals reported symptoms of anxiety disorder during the COVID-19 pandemic.</a:t>
            </a:r>
            <a:endParaRPr b="1" sz="1700">
              <a:solidFill>
                <a:srgbClr val="BF9000"/>
              </a:solidFill>
              <a:latin typeface="Hind"/>
              <a:ea typeface="Hind"/>
              <a:cs typeface="Hind"/>
              <a:sym typeface="Hind"/>
            </a:endParaRPr>
          </a:p>
        </p:txBody>
      </p:sp>
      <p:pic>
        <p:nvPicPr>
          <p:cNvPr id="307" name="Google Shape;307;p28" title="Chart"/>
          <p:cNvPicPr preferRelativeResize="0"/>
          <p:nvPr/>
        </p:nvPicPr>
        <p:blipFill>
          <a:blip r:embed="rId3">
            <a:alphaModFix/>
          </a:blip>
          <a:stretch>
            <a:fillRect/>
          </a:stretch>
        </p:blipFill>
        <p:spPr>
          <a:xfrm>
            <a:off x="282300" y="1552200"/>
            <a:ext cx="5293851" cy="3273376"/>
          </a:xfrm>
          <a:prstGeom prst="rect">
            <a:avLst/>
          </a:prstGeom>
          <a:noFill/>
          <a:ln>
            <a:noFill/>
          </a:ln>
        </p:spPr>
      </p:pic>
      <p:sp>
        <p:nvSpPr>
          <p:cNvPr id="308" name="Google Shape;308;p28"/>
          <p:cNvSpPr/>
          <p:nvPr/>
        </p:nvSpPr>
        <p:spPr>
          <a:xfrm>
            <a:off x="3850700" y="2947488"/>
            <a:ext cx="138000" cy="138000"/>
          </a:xfrm>
          <a:prstGeom prst="ellipse">
            <a:avLst/>
          </a:pr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cxnSp>
        <p:nvCxnSpPr>
          <p:cNvPr id="309" name="Google Shape;309;p28"/>
          <p:cNvCxnSpPr>
            <a:endCxn id="308" idx="0"/>
          </p:cNvCxnSpPr>
          <p:nvPr/>
        </p:nvCxnSpPr>
        <p:spPr>
          <a:xfrm flipH="1">
            <a:off x="3919700" y="2358288"/>
            <a:ext cx="1323900" cy="589200"/>
          </a:xfrm>
          <a:prstGeom prst="bentConnector2">
            <a:avLst/>
          </a:prstGeom>
          <a:noFill/>
          <a:ln cap="flat" cmpd="sng" w="19050">
            <a:solidFill>
              <a:schemeClr val="dk1"/>
            </a:solidFill>
            <a:prstDash val="solid"/>
            <a:round/>
            <a:headEnd len="med" w="med" type="oval"/>
            <a:tailEnd len="med" w="med" type="none"/>
          </a:ln>
        </p:spPr>
      </p:cxnSp>
      <p:sp>
        <p:nvSpPr>
          <p:cNvPr id="310" name="Google Shape;310;p28"/>
          <p:cNvSpPr txBox="1"/>
          <p:nvPr/>
        </p:nvSpPr>
        <p:spPr>
          <a:xfrm>
            <a:off x="0" y="4888450"/>
            <a:ext cx="2124900" cy="2550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Vahratian et al. </a:t>
            </a:r>
            <a:r>
              <a:rPr i="1" lang="en" sz="800">
                <a:solidFill>
                  <a:schemeClr val="dk1"/>
                </a:solidFill>
                <a:latin typeface="Hind"/>
                <a:ea typeface="Hind"/>
                <a:cs typeface="Hind"/>
                <a:sym typeface="Hind"/>
              </a:rPr>
              <a:t>Morb Mortal Wkly Rep.</a:t>
            </a:r>
            <a:r>
              <a:rPr lang="en" sz="800">
                <a:solidFill>
                  <a:schemeClr val="dk1"/>
                </a:solidFill>
                <a:latin typeface="Hind"/>
                <a:ea typeface="Hind"/>
                <a:cs typeface="Hind"/>
                <a:sym typeface="Hind"/>
              </a:rPr>
              <a:t> 2021.</a:t>
            </a:r>
            <a:endParaRPr sz="800">
              <a:solidFill>
                <a:schemeClr val="dk1"/>
              </a:solidFill>
              <a:latin typeface="Hind"/>
              <a:ea typeface="Hind"/>
              <a:cs typeface="Hind"/>
              <a:sym typeface="Hind"/>
            </a:endParaRPr>
          </a:p>
        </p:txBody>
      </p:sp>
      <p:sp>
        <p:nvSpPr>
          <p:cNvPr id="311" name="Google Shape;311;p2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312" name="Google Shape;312;p28"/>
          <p:cNvSpPr txBox="1"/>
          <p:nvPr/>
        </p:nvSpPr>
        <p:spPr>
          <a:xfrm>
            <a:off x="4511700" y="3532838"/>
            <a:ext cx="4184700" cy="11697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1600"/>
              </a:spcAft>
              <a:buNone/>
            </a:pPr>
            <a:r>
              <a:rPr lang="en" sz="1600">
                <a:solidFill>
                  <a:srgbClr val="434343"/>
                </a:solidFill>
                <a:latin typeface="Hind"/>
                <a:ea typeface="Hind"/>
                <a:cs typeface="Hind"/>
                <a:sym typeface="Hind"/>
              </a:rPr>
              <a:t>There is a </a:t>
            </a:r>
            <a:r>
              <a:rPr b="1" i="1" lang="en" sz="1600">
                <a:solidFill>
                  <a:srgbClr val="434343"/>
                </a:solidFill>
                <a:latin typeface="Hind"/>
                <a:ea typeface="Hind"/>
                <a:cs typeface="Hind"/>
                <a:sym typeface="Hind"/>
              </a:rPr>
              <a:t>stronger association </a:t>
            </a:r>
            <a:r>
              <a:rPr lang="en" sz="1600">
                <a:solidFill>
                  <a:srgbClr val="434343"/>
                </a:solidFill>
                <a:latin typeface="Hind"/>
                <a:ea typeface="Hind"/>
                <a:cs typeface="Hind"/>
                <a:sym typeface="Hind"/>
              </a:rPr>
              <a:t>between </a:t>
            </a:r>
            <a:r>
              <a:rPr b="1" lang="en" sz="1600">
                <a:solidFill>
                  <a:srgbClr val="434343"/>
                </a:solidFill>
                <a:latin typeface="Hind"/>
                <a:ea typeface="Hind"/>
                <a:cs typeface="Hind"/>
                <a:sym typeface="Hind"/>
              </a:rPr>
              <a:t>experiencing racism</a:t>
            </a:r>
            <a:r>
              <a:rPr lang="en" sz="1600">
                <a:solidFill>
                  <a:srgbClr val="434343"/>
                </a:solidFill>
                <a:latin typeface="Hind"/>
                <a:ea typeface="Hind"/>
                <a:cs typeface="Hind"/>
                <a:sym typeface="Hind"/>
              </a:rPr>
              <a:t> and </a:t>
            </a:r>
            <a:r>
              <a:rPr b="1" lang="en" sz="1600">
                <a:solidFill>
                  <a:srgbClr val="434343"/>
                </a:solidFill>
                <a:latin typeface="Hind"/>
                <a:ea typeface="Hind"/>
                <a:cs typeface="Hind"/>
                <a:sym typeface="Hind"/>
              </a:rPr>
              <a:t>negative mental health concerns</a:t>
            </a:r>
            <a:r>
              <a:rPr lang="en" sz="1600">
                <a:solidFill>
                  <a:srgbClr val="434343"/>
                </a:solidFill>
                <a:latin typeface="Hind"/>
                <a:ea typeface="Hind"/>
                <a:cs typeface="Hind"/>
                <a:sym typeface="Hind"/>
              </a:rPr>
              <a:t> for AAs when compared to other populations.</a:t>
            </a:r>
            <a:endParaRPr sz="1600">
              <a:latin typeface="Hind"/>
              <a:ea typeface="Hind"/>
              <a:cs typeface="Hind"/>
              <a:sym typeface="Hind"/>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6" name="Shape 316"/>
        <p:cNvGrpSpPr/>
        <p:nvPr/>
      </p:nvGrpSpPr>
      <p:grpSpPr>
        <a:xfrm>
          <a:off x="0" y="0"/>
          <a:ext cx="0" cy="0"/>
          <a:chOff x="0" y="0"/>
          <a:chExt cx="0" cy="0"/>
        </a:xfrm>
      </p:grpSpPr>
      <p:sp>
        <p:nvSpPr>
          <p:cNvPr id="317" name="Google Shape;317;p29"/>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Reflection</a:t>
            </a:r>
            <a:endParaRPr/>
          </a:p>
        </p:txBody>
      </p:sp>
      <p:sp>
        <p:nvSpPr>
          <p:cNvPr id="318" name="Google Shape;318;p29"/>
          <p:cNvSpPr txBox="1"/>
          <p:nvPr>
            <p:ph idx="1" type="body"/>
          </p:nvPr>
        </p:nvSpPr>
        <p:spPr>
          <a:xfrm>
            <a:off x="720000" y="1546501"/>
            <a:ext cx="7704000" cy="2050500"/>
          </a:xfrm>
          <a:prstGeom prst="rect">
            <a:avLst/>
          </a:prstGeom>
        </p:spPr>
        <p:txBody>
          <a:bodyPr anchorCtr="0" anchor="t" bIns="91425" lIns="91425" spcFirstLastPara="1" rIns="91425" wrap="square" tIns="91425">
            <a:normAutofit/>
          </a:bodyPr>
          <a:lstStyle/>
          <a:p>
            <a:pPr indent="0" lvl="0" marL="0" rtl="0" algn="ctr">
              <a:spcBef>
                <a:spcPts val="0"/>
              </a:spcBef>
              <a:spcAft>
                <a:spcPts val="1200"/>
              </a:spcAft>
              <a:buNone/>
            </a:pPr>
            <a:r>
              <a:rPr lang="en" sz="3600"/>
              <a:t>What are some potential causes of mental health problems in AANHPI populations?</a:t>
            </a:r>
            <a:endParaRPr sz="3600"/>
          </a:p>
        </p:txBody>
      </p:sp>
      <p:sp>
        <p:nvSpPr>
          <p:cNvPr id="319" name="Google Shape;319;p2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3" name="Shape 323"/>
        <p:cNvGrpSpPr/>
        <p:nvPr/>
      </p:nvGrpSpPr>
      <p:grpSpPr>
        <a:xfrm>
          <a:off x="0" y="0"/>
          <a:ext cx="0" cy="0"/>
          <a:chOff x="0" y="0"/>
          <a:chExt cx="0" cy="0"/>
        </a:xfrm>
      </p:grpSpPr>
      <p:sp>
        <p:nvSpPr>
          <p:cNvPr id="324" name="Google Shape;324;p3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t>‹#›</a:t>
            </a:fld>
            <a:endParaRPr/>
          </a:p>
        </p:txBody>
      </p:sp>
      <p:grpSp>
        <p:nvGrpSpPr>
          <p:cNvPr id="325" name="Google Shape;325;p30"/>
          <p:cNvGrpSpPr/>
          <p:nvPr/>
        </p:nvGrpSpPr>
        <p:grpSpPr>
          <a:xfrm>
            <a:off x="4718975" y="864068"/>
            <a:ext cx="3826636" cy="2350145"/>
            <a:chOff x="526736" y="916254"/>
            <a:chExt cx="4031857" cy="2258235"/>
          </a:xfrm>
        </p:grpSpPr>
        <p:sp>
          <p:nvSpPr>
            <p:cNvPr id="326" name="Google Shape;326;p30"/>
            <p:cNvSpPr/>
            <p:nvPr/>
          </p:nvSpPr>
          <p:spPr>
            <a:xfrm flipH="1" rot="10313485">
              <a:off x="1265357"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27" name="Google Shape;327;p30"/>
            <p:cNvSpPr/>
            <p:nvPr/>
          </p:nvSpPr>
          <p:spPr>
            <a:xfrm rot="-10313485">
              <a:off x="639755"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328" name="Google Shape;328;p30"/>
          <p:cNvGrpSpPr/>
          <p:nvPr/>
        </p:nvGrpSpPr>
        <p:grpSpPr>
          <a:xfrm rot="10800000">
            <a:off x="4718764" y="2700187"/>
            <a:ext cx="3826636" cy="2350145"/>
            <a:chOff x="526736" y="916254"/>
            <a:chExt cx="4031857" cy="2258235"/>
          </a:xfrm>
        </p:grpSpPr>
        <p:sp>
          <p:nvSpPr>
            <p:cNvPr id="329" name="Google Shape;329;p30"/>
            <p:cNvSpPr/>
            <p:nvPr/>
          </p:nvSpPr>
          <p:spPr>
            <a:xfrm flipH="1" rot="10313485">
              <a:off x="1265357"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30" name="Google Shape;330;p30"/>
            <p:cNvSpPr/>
            <p:nvPr/>
          </p:nvSpPr>
          <p:spPr>
            <a:xfrm rot="-10313485">
              <a:off x="639755"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331" name="Google Shape;331;p30"/>
          <p:cNvGrpSpPr/>
          <p:nvPr/>
        </p:nvGrpSpPr>
        <p:grpSpPr>
          <a:xfrm rot="10800000">
            <a:off x="598389" y="2700201"/>
            <a:ext cx="3826636" cy="2350145"/>
            <a:chOff x="526736" y="916254"/>
            <a:chExt cx="4031857" cy="2258235"/>
          </a:xfrm>
        </p:grpSpPr>
        <p:sp>
          <p:nvSpPr>
            <p:cNvPr id="332" name="Google Shape;332;p30"/>
            <p:cNvSpPr/>
            <p:nvPr/>
          </p:nvSpPr>
          <p:spPr>
            <a:xfrm flipH="1" rot="10313485">
              <a:off x="1265357"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33" name="Google Shape;333;p30"/>
            <p:cNvSpPr/>
            <p:nvPr/>
          </p:nvSpPr>
          <p:spPr>
            <a:xfrm rot="-10313485">
              <a:off x="639755"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334" name="Google Shape;334;p30"/>
          <p:cNvGrpSpPr/>
          <p:nvPr/>
        </p:nvGrpSpPr>
        <p:grpSpPr>
          <a:xfrm>
            <a:off x="598601" y="864055"/>
            <a:ext cx="3826636" cy="2350145"/>
            <a:chOff x="526736" y="916254"/>
            <a:chExt cx="4031857" cy="2258235"/>
          </a:xfrm>
        </p:grpSpPr>
        <p:sp>
          <p:nvSpPr>
            <p:cNvPr id="335" name="Google Shape;335;p30"/>
            <p:cNvSpPr/>
            <p:nvPr/>
          </p:nvSpPr>
          <p:spPr>
            <a:xfrm flipH="1" rot="10313485">
              <a:off x="1265357"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36" name="Google Shape;336;p30"/>
            <p:cNvSpPr/>
            <p:nvPr/>
          </p:nvSpPr>
          <p:spPr>
            <a:xfrm rot="-10313485">
              <a:off x="639755" y="1131401"/>
              <a:ext cx="3180219" cy="1827941"/>
            </a:xfrm>
            <a:custGeom>
              <a:rect b="b" l="l" r="r" t="t"/>
              <a:pathLst>
                <a:path extrusionOk="0" h="20014" w="34820">
                  <a:moveTo>
                    <a:pt x="27294" y="1"/>
                  </a:moveTo>
                  <a:lnTo>
                    <a:pt x="26765" y="41"/>
                  </a:lnTo>
                  <a:lnTo>
                    <a:pt x="25626" y="123"/>
                  </a:lnTo>
                  <a:lnTo>
                    <a:pt x="24487" y="326"/>
                  </a:lnTo>
                  <a:lnTo>
                    <a:pt x="23348" y="529"/>
                  </a:lnTo>
                  <a:lnTo>
                    <a:pt x="22210" y="814"/>
                  </a:lnTo>
                  <a:lnTo>
                    <a:pt x="17044" y="1953"/>
                  </a:lnTo>
                  <a:lnTo>
                    <a:pt x="11878" y="3133"/>
                  </a:lnTo>
                  <a:lnTo>
                    <a:pt x="10698" y="3377"/>
                  </a:lnTo>
                  <a:lnTo>
                    <a:pt x="9559" y="3662"/>
                  </a:lnTo>
                  <a:lnTo>
                    <a:pt x="8380" y="3987"/>
                  </a:lnTo>
                  <a:lnTo>
                    <a:pt x="7281" y="4394"/>
                  </a:lnTo>
                  <a:lnTo>
                    <a:pt x="6264" y="4760"/>
                  </a:lnTo>
                  <a:lnTo>
                    <a:pt x="5288" y="5248"/>
                  </a:lnTo>
                  <a:lnTo>
                    <a:pt x="4353" y="5777"/>
                  </a:lnTo>
                  <a:lnTo>
                    <a:pt x="3905" y="6061"/>
                  </a:lnTo>
                  <a:lnTo>
                    <a:pt x="3458" y="6387"/>
                  </a:lnTo>
                  <a:lnTo>
                    <a:pt x="2766" y="6997"/>
                  </a:lnTo>
                  <a:lnTo>
                    <a:pt x="2156" y="7648"/>
                  </a:lnTo>
                  <a:lnTo>
                    <a:pt x="1587" y="8339"/>
                  </a:lnTo>
                  <a:lnTo>
                    <a:pt x="1099" y="9112"/>
                  </a:lnTo>
                  <a:lnTo>
                    <a:pt x="692" y="9885"/>
                  </a:lnTo>
                  <a:lnTo>
                    <a:pt x="366" y="10699"/>
                  </a:lnTo>
                  <a:lnTo>
                    <a:pt x="244" y="11146"/>
                  </a:lnTo>
                  <a:lnTo>
                    <a:pt x="122" y="11553"/>
                  </a:lnTo>
                  <a:lnTo>
                    <a:pt x="82" y="11959"/>
                  </a:lnTo>
                  <a:lnTo>
                    <a:pt x="0" y="12407"/>
                  </a:lnTo>
                  <a:lnTo>
                    <a:pt x="0" y="12854"/>
                  </a:lnTo>
                  <a:lnTo>
                    <a:pt x="0" y="13261"/>
                  </a:lnTo>
                  <a:lnTo>
                    <a:pt x="41" y="13709"/>
                  </a:lnTo>
                  <a:lnTo>
                    <a:pt x="122" y="14115"/>
                  </a:lnTo>
                  <a:lnTo>
                    <a:pt x="244" y="14522"/>
                  </a:lnTo>
                  <a:lnTo>
                    <a:pt x="366" y="14929"/>
                  </a:lnTo>
                  <a:lnTo>
                    <a:pt x="529" y="15336"/>
                  </a:lnTo>
                  <a:lnTo>
                    <a:pt x="732" y="15742"/>
                  </a:lnTo>
                  <a:lnTo>
                    <a:pt x="1017" y="16190"/>
                  </a:lnTo>
                  <a:lnTo>
                    <a:pt x="1302" y="16597"/>
                  </a:lnTo>
                  <a:lnTo>
                    <a:pt x="1668" y="17003"/>
                  </a:lnTo>
                  <a:lnTo>
                    <a:pt x="1993" y="17369"/>
                  </a:lnTo>
                  <a:lnTo>
                    <a:pt x="2400" y="17695"/>
                  </a:lnTo>
                  <a:lnTo>
                    <a:pt x="2807" y="17980"/>
                  </a:lnTo>
                  <a:lnTo>
                    <a:pt x="3214" y="18264"/>
                  </a:lnTo>
                  <a:lnTo>
                    <a:pt x="3661" y="18549"/>
                  </a:lnTo>
                  <a:lnTo>
                    <a:pt x="4109" y="18793"/>
                  </a:lnTo>
                  <a:lnTo>
                    <a:pt x="4597" y="18996"/>
                  </a:lnTo>
                  <a:lnTo>
                    <a:pt x="5532" y="19363"/>
                  </a:lnTo>
                  <a:lnTo>
                    <a:pt x="6549" y="19607"/>
                  </a:lnTo>
                  <a:lnTo>
                    <a:pt x="7525" y="19810"/>
                  </a:lnTo>
                  <a:lnTo>
                    <a:pt x="8136" y="19891"/>
                  </a:lnTo>
                  <a:lnTo>
                    <a:pt x="8746" y="19932"/>
                  </a:lnTo>
                  <a:lnTo>
                    <a:pt x="10007" y="20013"/>
                  </a:lnTo>
                  <a:lnTo>
                    <a:pt x="11227" y="19973"/>
                  </a:lnTo>
                  <a:lnTo>
                    <a:pt x="12447" y="19891"/>
                  </a:lnTo>
                  <a:lnTo>
                    <a:pt x="14928" y="19688"/>
                  </a:lnTo>
                  <a:lnTo>
                    <a:pt x="16149" y="19566"/>
                  </a:lnTo>
                  <a:lnTo>
                    <a:pt x="17369" y="19485"/>
                  </a:lnTo>
                  <a:lnTo>
                    <a:pt x="18711" y="19444"/>
                  </a:lnTo>
                  <a:lnTo>
                    <a:pt x="20013" y="19485"/>
                  </a:lnTo>
                  <a:lnTo>
                    <a:pt x="22657" y="19566"/>
                  </a:lnTo>
                  <a:lnTo>
                    <a:pt x="23837" y="19647"/>
                  </a:lnTo>
                  <a:lnTo>
                    <a:pt x="25626" y="19647"/>
                  </a:lnTo>
                  <a:lnTo>
                    <a:pt x="26196" y="19607"/>
                  </a:lnTo>
                  <a:lnTo>
                    <a:pt x="26806" y="19525"/>
                  </a:lnTo>
                  <a:lnTo>
                    <a:pt x="27375" y="19403"/>
                  </a:lnTo>
                  <a:lnTo>
                    <a:pt x="27823" y="19281"/>
                  </a:lnTo>
                  <a:lnTo>
                    <a:pt x="28311" y="19118"/>
                  </a:lnTo>
                  <a:lnTo>
                    <a:pt x="28758" y="18915"/>
                  </a:lnTo>
                  <a:lnTo>
                    <a:pt x="29206" y="18712"/>
                  </a:lnTo>
                  <a:lnTo>
                    <a:pt x="29613" y="18508"/>
                  </a:lnTo>
                  <a:lnTo>
                    <a:pt x="30060" y="18264"/>
                  </a:lnTo>
                  <a:lnTo>
                    <a:pt x="30833" y="17695"/>
                  </a:lnTo>
                  <a:lnTo>
                    <a:pt x="31565" y="17044"/>
                  </a:lnTo>
                  <a:lnTo>
                    <a:pt x="32257" y="16352"/>
                  </a:lnTo>
                  <a:lnTo>
                    <a:pt x="32867" y="15580"/>
                  </a:lnTo>
                  <a:lnTo>
                    <a:pt x="33395" y="14766"/>
                  </a:lnTo>
                  <a:lnTo>
                    <a:pt x="33680" y="14278"/>
                  </a:lnTo>
                  <a:lnTo>
                    <a:pt x="33884" y="13749"/>
                  </a:lnTo>
                  <a:lnTo>
                    <a:pt x="34128" y="13261"/>
                  </a:lnTo>
                  <a:lnTo>
                    <a:pt x="34290" y="12732"/>
                  </a:lnTo>
                  <a:lnTo>
                    <a:pt x="34453" y="12204"/>
                  </a:lnTo>
                  <a:lnTo>
                    <a:pt x="34575" y="11634"/>
                  </a:lnTo>
                  <a:lnTo>
                    <a:pt x="34697" y="11105"/>
                  </a:lnTo>
                  <a:lnTo>
                    <a:pt x="34778" y="10536"/>
                  </a:lnTo>
                  <a:lnTo>
                    <a:pt x="34819" y="9966"/>
                  </a:lnTo>
                  <a:lnTo>
                    <a:pt x="34819" y="9438"/>
                  </a:lnTo>
                  <a:lnTo>
                    <a:pt x="34819" y="8868"/>
                  </a:lnTo>
                  <a:lnTo>
                    <a:pt x="34819" y="8299"/>
                  </a:lnTo>
                  <a:lnTo>
                    <a:pt x="34738" y="7729"/>
                  </a:lnTo>
                  <a:lnTo>
                    <a:pt x="34656" y="7200"/>
                  </a:lnTo>
                  <a:lnTo>
                    <a:pt x="34575" y="6631"/>
                  </a:lnTo>
                  <a:lnTo>
                    <a:pt x="34412" y="6102"/>
                  </a:lnTo>
                  <a:lnTo>
                    <a:pt x="34290" y="5533"/>
                  </a:lnTo>
                  <a:lnTo>
                    <a:pt x="34087" y="5004"/>
                  </a:lnTo>
                  <a:lnTo>
                    <a:pt x="33884" y="4475"/>
                  </a:lnTo>
                  <a:lnTo>
                    <a:pt x="33640" y="3946"/>
                  </a:lnTo>
                  <a:lnTo>
                    <a:pt x="33395" y="3499"/>
                  </a:lnTo>
                  <a:lnTo>
                    <a:pt x="33111" y="3051"/>
                  </a:lnTo>
                  <a:lnTo>
                    <a:pt x="32826" y="2604"/>
                  </a:lnTo>
                  <a:lnTo>
                    <a:pt x="32501" y="2238"/>
                  </a:lnTo>
                  <a:lnTo>
                    <a:pt x="32134" y="1831"/>
                  </a:lnTo>
                  <a:lnTo>
                    <a:pt x="31768" y="1465"/>
                  </a:lnTo>
                  <a:lnTo>
                    <a:pt x="31362" y="1180"/>
                  </a:lnTo>
                  <a:lnTo>
                    <a:pt x="30914" y="896"/>
                  </a:lnTo>
                  <a:lnTo>
                    <a:pt x="30426" y="611"/>
                  </a:lnTo>
                  <a:lnTo>
                    <a:pt x="29938" y="407"/>
                  </a:lnTo>
                  <a:lnTo>
                    <a:pt x="29450" y="285"/>
                  </a:lnTo>
                  <a:lnTo>
                    <a:pt x="28921" y="163"/>
                  </a:lnTo>
                  <a:lnTo>
                    <a:pt x="28392" y="82"/>
                  </a:lnTo>
                  <a:lnTo>
                    <a:pt x="27823" y="41"/>
                  </a:lnTo>
                  <a:lnTo>
                    <a:pt x="27294" y="1"/>
                  </a:lnTo>
                  <a:close/>
                </a:path>
              </a:pathLst>
            </a:custGeom>
            <a:solidFill>
              <a:schemeClr val="dk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337" name="Google Shape;337;p30"/>
          <p:cNvSpPr txBox="1"/>
          <p:nvPr>
            <p:ph idx="4294967295" type="title"/>
          </p:nvPr>
        </p:nvSpPr>
        <p:spPr>
          <a:xfrm>
            <a:off x="1363013" y="1213775"/>
            <a:ext cx="2297400" cy="527700"/>
          </a:xfrm>
          <a:prstGeom prst="rect">
            <a:avLst/>
          </a:prstGeom>
        </p:spPr>
        <p:txBody>
          <a:bodyPr anchorCtr="0" anchor="t" bIns="91425" lIns="91425" spcFirstLastPara="1" rIns="91425" wrap="square" tIns="91425">
            <a:normAutofit fontScale="90000"/>
          </a:bodyPr>
          <a:lstStyle/>
          <a:p>
            <a:pPr indent="0" lvl="0" marL="0" rtl="0" algn="ctr">
              <a:spcBef>
                <a:spcPts val="0"/>
              </a:spcBef>
              <a:spcAft>
                <a:spcPts val="0"/>
              </a:spcAft>
              <a:buNone/>
            </a:pPr>
            <a:r>
              <a:rPr lang="en"/>
              <a:t>Discrimination</a:t>
            </a:r>
            <a:endParaRPr/>
          </a:p>
        </p:txBody>
      </p:sp>
      <p:sp>
        <p:nvSpPr>
          <p:cNvPr id="338" name="Google Shape;338;p30"/>
          <p:cNvSpPr txBox="1"/>
          <p:nvPr>
            <p:ph idx="4294967295" type="subTitle"/>
          </p:nvPr>
        </p:nvSpPr>
        <p:spPr>
          <a:xfrm>
            <a:off x="974350" y="1665275"/>
            <a:ext cx="3250200" cy="867300"/>
          </a:xfrm>
          <a:prstGeom prst="rect">
            <a:avLst/>
          </a:prstGeom>
        </p:spPr>
        <p:txBody>
          <a:bodyPr anchorCtr="0" anchor="t" bIns="91425" lIns="91425" spcFirstLastPara="1" rIns="91425" wrap="square" tIns="91425">
            <a:normAutofit fontScale="70000"/>
          </a:bodyPr>
          <a:lstStyle/>
          <a:p>
            <a:pPr indent="0" lvl="0" marL="0" rtl="0" algn="l">
              <a:spcBef>
                <a:spcPts val="0"/>
              </a:spcBef>
              <a:spcAft>
                <a:spcPts val="1200"/>
              </a:spcAft>
              <a:buNone/>
            </a:pPr>
            <a:r>
              <a:rPr lang="en">
                <a:solidFill>
                  <a:schemeClr val="lt1"/>
                </a:solidFill>
              </a:rPr>
              <a:t>Anti-Asian harassment following COVID-19 has increased the prevalence and severity of mental health illness amongst AAs</a:t>
            </a:r>
            <a:endParaRPr>
              <a:solidFill>
                <a:schemeClr val="lt1"/>
              </a:solidFill>
            </a:endParaRPr>
          </a:p>
        </p:txBody>
      </p:sp>
      <p:sp>
        <p:nvSpPr>
          <p:cNvPr id="339" name="Google Shape;339;p30"/>
          <p:cNvSpPr/>
          <p:nvPr/>
        </p:nvSpPr>
        <p:spPr>
          <a:xfrm>
            <a:off x="1188500" y="478775"/>
            <a:ext cx="685200" cy="527700"/>
          </a:xfrm>
          <a:prstGeom prst="rect">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340" name="Google Shape;340;p30"/>
          <p:cNvSpPr/>
          <p:nvPr/>
        </p:nvSpPr>
        <p:spPr>
          <a:xfrm>
            <a:off x="6995175" y="240775"/>
            <a:ext cx="685200" cy="527700"/>
          </a:xfrm>
          <a:prstGeom prst="rect">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341" name="Google Shape;341;p30"/>
          <p:cNvSpPr txBox="1"/>
          <p:nvPr>
            <p:ph idx="4294967295" type="title"/>
          </p:nvPr>
        </p:nvSpPr>
        <p:spPr>
          <a:xfrm>
            <a:off x="720000" y="291375"/>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Drivers of mental health problems</a:t>
            </a:r>
            <a:endParaRPr/>
          </a:p>
        </p:txBody>
      </p:sp>
      <p:sp>
        <p:nvSpPr>
          <p:cNvPr id="342" name="Google Shape;342;p30"/>
          <p:cNvSpPr txBox="1"/>
          <p:nvPr>
            <p:ph idx="4294967295" type="title"/>
          </p:nvPr>
        </p:nvSpPr>
        <p:spPr>
          <a:xfrm>
            <a:off x="5123699" y="1213775"/>
            <a:ext cx="3146100" cy="527700"/>
          </a:xfrm>
          <a:prstGeom prst="rect">
            <a:avLst/>
          </a:prstGeom>
        </p:spPr>
        <p:txBody>
          <a:bodyPr anchorCtr="0" anchor="t" bIns="91425" lIns="91425" spcFirstLastPara="1" rIns="91425" wrap="square" tIns="91425">
            <a:normAutofit/>
          </a:bodyPr>
          <a:lstStyle/>
          <a:p>
            <a:pPr indent="0" lvl="0" marL="0" rtl="0" algn="ctr">
              <a:spcBef>
                <a:spcPts val="0"/>
              </a:spcBef>
              <a:spcAft>
                <a:spcPts val="0"/>
              </a:spcAft>
              <a:buNone/>
            </a:pPr>
            <a:r>
              <a:rPr lang="en" sz="1800"/>
              <a:t>Model Minority Stereotype</a:t>
            </a:r>
            <a:endParaRPr sz="1800"/>
          </a:p>
        </p:txBody>
      </p:sp>
      <p:sp>
        <p:nvSpPr>
          <p:cNvPr id="343" name="Google Shape;343;p30"/>
          <p:cNvSpPr txBox="1"/>
          <p:nvPr>
            <p:ph idx="4294967295" type="subTitle"/>
          </p:nvPr>
        </p:nvSpPr>
        <p:spPr>
          <a:xfrm>
            <a:off x="5071650" y="1689100"/>
            <a:ext cx="3250200" cy="867300"/>
          </a:xfrm>
          <a:prstGeom prst="rect">
            <a:avLst/>
          </a:prstGeom>
        </p:spPr>
        <p:txBody>
          <a:bodyPr anchorCtr="0" anchor="t" bIns="91425" lIns="91425" spcFirstLastPara="1" rIns="91425" wrap="square" tIns="91425">
            <a:normAutofit fontScale="85000" lnSpcReduction="20000"/>
          </a:bodyPr>
          <a:lstStyle/>
          <a:p>
            <a:pPr indent="0" lvl="0" marL="0" rtl="0" algn="l">
              <a:spcBef>
                <a:spcPts val="0"/>
              </a:spcBef>
              <a:spcAft>
                <a:spcPts val="1200"/>
              </a:spcAft>
              <a:buNone/>
            </a:pPr>
            <a:r>
              <a:rPr lang="en">
                <a:solidFill>
                  <a:schemeClr val="lt1"/>
                </a:solidFill>
              </a:rPr>
              <a:t>Discrimination towards AAs by non-AA groups and pressure on AAs to conform to the stereotype</a:t>
            </a:r>
            <a:endParaRPr>
              <a:solidFill>
                <a:schemeClr val="lt1"/>
              </a:solidFill>
            </a:endParaRPr>
          </a:p>
        </p:txBody>
      </p:sp>
      <p:sp>
        <p:nvSpPr>
          <p:cNvPr id="344" name="Google Shape;344;p30"/>
          <p:cNvSpPr txBox="1"/>
          <p:nvPr>
            <p:ph idx="4294967295" type="title"/>
          </p:nvPr>
        </p:nvSpPr>
        <p:spPr>
          <a:xfrm>
            <a:off x="1153815" y="3191375"/>
            <a:ext cx="2716200" cy="527700"/>
          </a:xfrm>
          <a:prstGeom prst="rect">
            <a:avLst/>
          </a:prstGeom>
        </p:spPr>
        <p:txBody>
          <a:bodyPr anchorCtr="0" anchor="t" bIns="91425" lIns="91425" spcFirstLastPara="1" rIns="91425" wrap="square" tIns="91425">
            <a:normAutofit fontScale="90000"/>
          </a:bodyPr>
          <a:lstStyle/>
          <a:p>
            <a:pPr indent="0" lvl="0" marL="0" rtl="0" algn="ctr">
              <a:spcBef>
                <a:spcPts val="0"/>
              </a:spcBef>
              <a:spcAft>
                <a:spcPts val="0"/>
              </a:spcAft>
              <a:buNone/>
            </a:pPr>
            <a:r>
              <a:rPr lang="en"/>
              <a:t>Historical Trauma</a:t>
            </a:r>
            <a:endParaRPr/>
          </a:p>
        </p:txBody>
      </p:sp>
      <p:sp>
        <p:nvSpPr>
          <p:cNvPr id="345" name="Google Shape;345;p30"/>
          <p:cNvSpPr txBox="1"/>
          <p:nvPr>
            <p:ph idx="4294967295" type="subTitle"/>
          </p:nvPr>
        </p:nvSpPr>
        <p:spPr>
          <a:xfrm>
            <a:off x="974350" y="3694175"/>
            <a:ext cx="3250200" cy="867300"/>
          </a:xfrm>
          <a:prstGeom prst="rect">
            <a:avLst/>
          </a:prstGeom>
        </p:spPr>
        <p:txBody>
          <a:bodyPr anchorCtr="0" anchor="t" bIns="91425" lIns="91425" spcFirstLastPara="1" rIns="91425" wrap="square" tIns="91425">
            <a:normAutofit fontScale="62500"/>
          </a:bodyPr>
          <a:lstStyle/>
          <a:p>
            <a:pPr indent="0" lvl="0" marL="0" rtl="0" algn="l">
              <a:spcBef>
                <a:spcPts val="0"/>
              </a:spcBef>
              <a:spcAft>
                <a:spcPts val="1200"/>
              </a:spcAft>
              <a:buNone/>
            </a:pPr>
            <a:r>
              <a:rPr lang="en">
                <a:solidFill>
                  <a:schemeClr val="lt1"/>
                </a:solidFill>
              </a:rPr>
              <a:t>U.S. colonization (Hawaii, Pacific, Philippines), resettlement (SE AAs), racist policies (Japanese American internment, Chinese Exclusion Act)</a:t>
            </a:r>
            <a:endParaRPr>
              <a:solidFill>
                <a:schemeClr val="lt1"/>
              </a:solidFill>
            </a:endParaRPr>
          </a:p>
        </p:txBody>
      </p:sp>
      <p:sp>
        <p:nvSpPr>
          <p:cNvPr id="346" name="Google Shape;346;p30"/>
          <p:cNvSpPr txBox="1"/>
          <p:nvPr>
            <p:ph idx="4294967295" type="title"/>
          </p:nvPr>
        </p:nvSpPr>
        <p:spPr>
          <a:xfrm>
            <a:off x="4927788" y="3242675"/>
            <a:ext cx="3408600" cy="527700"/>
          </a:xfrm>
          <a:prstGeom prst="rect">
            <a:avLst/>
          </a:prstGeom>
        </p:spPr>
        <p:txBody>
          <a:bodyPr anchorCtr="0" anchor="t" bIns="91425" lIns="91425" spcFirstLastPara="1" rIns="91425" wrap="square" tIns="91425">
            <a:normAutofit/>
          </a:bodyPr>
          <a:lstStyle/>
          <a:p>
            <a:pPr indent="0" lvl="0" marL="0" rtl="0" algn="ctr">
              <a:spcBef>
                <a:spcPts val="0"/>
              </a:spcBef>
              <a:spcAft>
                <a:spcPts val="0"/>
              </a:spcAft>
              <a:buNone/>
            </a:pPr>
            <a:r>
              <a:rPr lang="en" sz="1800"/>
              <a:t>Perpetual Foreigner Stereotype</a:t>
            </a:r>
            <a:endParaRPr sz="1800"/>
          </a:p>
        </p:txBody>
      </p:sp>
      <p:sp>
        <p:nvSpPr>
          <p:cNvPr id="347" name="Google Shape;347;p30"/>
          <p:cNvSpPr txBox="1"/>
          <p:nvPr>
            <p:ph idx="4294967295" type="subTitle"/>
          </p:nvPr>
        </p:nvSpPr>
        <p:spPr>
          <a:xfrm>
            <a:off x="5071650" y="3694175"/>
            <a:ext cx="3250200" cy="867300"/>
          </a:xfrm>
          <a:prstGeom prst="rect">
            <a:avLst/>
          </a:prstGeom>
        </p:spPr>
        <p:txBody>
          <a:bodyPr anchorCtr="0" anchor="t" bIns="91425" lIns="91425" spcFirstLastPara="1" rIns="91425" wrap="square" tIns="91425">
            <a:normAutofit fontScale="77500" lnSpcReduction="10000"/>
          </a:bodyPr>
          <a:lstStyle/>
          <a:p>
            <a:pPr indent="0" lvl="0" marL="0" rtl="0" algn="l">
              <a:spcBef>
                <a:spcPts val="0"/>
              </a:spcBef>
              <a:spcAft>
                <a:spcPts val="1200"/>
              </a:spcAft>
              <a:buNone/>
            </a:pPr>
            <a:r>
              <a:rPr lang="en">
                <a:solidFill>
                  <a:schemeClr val="lt1"/>
                </a:solidFill>
              </a:rPr>
              <a:t>Perceived as a foreigner, regardless of citizenship status, which is a barrier to a sense of belonging</a:t>
            </a:r>
            <a:endParaRPr>
              <a:solidFill>
                <a:schemeClr val="lt1"/>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1" name="Shape 351"/>
        <p:cNvGrpSpPr/>
        <p:nvPr/>
      </p:nvGrpSpPr>
      <p:grpSpPr>
        <a:xfrm>
          <a:off x="0" y="0"/>
          <a:ext cx="0" cy="0"/>
          <a:chOff x="0" y="0"/>
          <a:chExt cx="0" cy="0"/>
        </a:xfrm>
      </p:grpSpPr>
      <p:sp>
        <p:nvSpPr>
          <p:cNvPr id="352" name="Google Shape;352;p31"/>
          <p:cNvSpPr txBox="1"/>
          <p:nvPr>
            <p:ph type="title"/>
          </p:nvPr>
        </p:nvSpPr>
        <p:spPr>
          <a:xfrm>
            <a:off x="265375" y="517430"/>
            <a:ext cx="85452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Examples of differing </a:t>
            </a:r>
            <a:r>
              <a:rPr lang="en"/>
              <a:t>subgroup </a:t>
            </a:r>
            <a:r>
              <a:rPr lang="en">
                <a:solidFill>
                  <a:srgbClr val="EAB56F"/>
                </a:solidFill>
              </a:rPr>
              <a:t>burdens</a:t>
            </a:r>
            <a:endParaRPr>
              <a:solidFill>
                <a:srgbClr val="EAB56F"/>
              </a:solidFill>
            </a:endParaRPr>
          </a:p>
        </p:txBody>
      </p:sp>
      <p:sp>
        <p:nvSpPr>
          <p:cNvPr id="353" name="Google Shape;353;p31"/>
          <p:cNvSpPr txBox="1"/>
          <p:nvPr>
            <p:ph idx="1" type="body"/>
          </p:nvPr>
        </p:nvSpPr>
        <p:spPr>
          <a:xfrm>
            <a:off x="1302475" y="1288625"/>
            <a:ext cx="7335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800"/>
              <a:t>78% of Filipino American women rate their </a:t>
            </a:r>
            <a:r>
              <a:rPr b="1" lang="en" sz="1800"/>
              <a:t>mental health as excellent or very good</a:t>
            </a:r>
            <a:r>
              <a:rPr lang="en" sz="1800"/>
              <a:t> v. 45% of Chinese American women v. 50% of Vietnamese American women </a:t>
            </a:r>
            <a:endParaRPr sz="1800"/>
          </a:p>
          <a:p>
            <a:pPr indent="0" lvl="0" marL="0" rtl="0" algn="l">
              <a:spcBef>
                <a:spcPts val="1200"/>
              </a:spcBef>
              <a:spcAft>
                <a:spcPts val="0"/>
              </a:spcAft>
              <a:buNone/>
            </a:pPr>
            <a:r>
              <a:t/>
            </a:r>
            <a:endParaRPr sz="400"/>
          </a:p>
          <a:p>
            <a:pPr indent="0" lvl="0" marL="0" rtl="0" algn="l">
              <a:spcBef>
                <a:spcPts val="1200"/>
              </a:spcBef>
              <a:spcAft>
                <a:spcPts val="0"/>
              </a:spcAft>
              <a:buNone/>
            </a:pPr>
            <a:r>
              <a:rPr lang="en" sz="1800"/>
              <a:t>33% of Korean American adults experience symptoms of </a:t>
            </a:r>
            <a:r>
              <a:rPr b="1" lang="en" sz="1800"/>
              <a:t>depression</a:t>
            </a:r>
            <a:r>
              <a:rPr lang="en" sz="1800"/>
              <a:t> v. less than 16% of Chinese Americans</a:t>
            </a:r>
            <a:endParaRPr sz="1800"/>
          </a:p>
          <a:p>
            <a:pPr indent="0" lvl="0" marL="0" rtl="0" algn="l">
              <a:spcBef>
                <a:spcPts val="1200"/>
              </a:spcBef>
              <a:spcAft>
                <a:spcPts val="0"/>
              </a:spcAft>
              <a:buNone/>
            </a:pPr>
            <a:r>
              <a:t/>
            </a:r>
            <a:endParaRPr sz="100"/>
          </a:p>
          <a:p>
            <a:pPr indent="0" lvl="0" marL="0" rtl="0" algn="l">
              <a:spcBef>
                <a:spcPts val="1200"/>
              </a:spcBef>
              <a:spcAft>
                <a:spcPts val="1200"/>
              </a:spcAft>
              <a:buNone/>
            </a:pPr>
            <a:r>
              <a:rPr lang="en" sz="1800"/>
              <a:t>Japanese American and Korean American men are at </a:t>
            </a:r>
            <a:r>
              <a:rPr b="1" lang="en" sz="1800"/>
              <a:t>greater risk of suicide</a:t>
            </a:r>
            <a:r>
              <a:rPr lang="en" sz="1800"/>
              <a:t> than all other Asian American men</a:t>
            </a:r>
            <a:endParaRPr sz="1800"/>
          </a:p>
        </p:txBody>
      </p:sp>
      <p:sp>
        <p:nvSpPr>
          <p:cNvPr id="354" name="Google Shape;354;p31"/>
          <p:cNvSpPr txBox="1"/>
          <p:nvPr/>
        </p:nvSpPr>
        <p:spPr>
          <a:xfrm>
            <a:off x="0" y="4835700"/>
            <a:ext cx="3751800" cy="307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800">
                <a:solidFill>
                  <a:schemeClr val="dk1"/>
                </a:solidFill>
                <a:latin typeface="Hind"/>
                <a:ea typeface="Hind"/>
                <a:cs typeface="Hind"/>
                <a:sym typeface="Hind"/>
              </a:rPr>
              <a:t>Kim et al. </a:t>
            </a:r>
            <a:r>
              <a:rPr i="1" lang="en" sz="800">
                <a:solidFill>
                  <a:schemeClr val="dk1"/>
                </a:solidFill>
                <a:latin typeface="Hind"/>
                <a:ea typeface="Hind"/>
                <a:cs typeface="Hind"/>
                <a:sym typeface="Hind"/>
              </a:rPr>
              <a:t>PLoS ONE</a:t>
            </a:r>
            <a:r>
              <a:rPr lang="en" sz="800">
                <a:solidFill>
                  <a:schemeClr val="dk1"/>
                </a:solidFill>
                <a:latin typeface="Hind"/>
                <a:ea typeface="Hind"/>
                <a:cs typeface="Hind"/>
                <a:sym typeface="Hind"/>
              </a:rPr>
              <a:t>. 2015; Maxwell and Kwon. </a:t>
            </a:r>
            <a:r>
              <a:rPr i="1" lang="en" sz="800">
                <a:solidFill>
                  <a:schemeClr val="dk1"/>
                </a:solidFill>
                <a:latin typeface="Hind"/>
                <a:ea typeface="Hind"/>
                <a:cs typeface="Hind"/>
                <a:sym typeface="Hind"/>
              </a:rPr>
              <a:t>Center for </a:t>
            </a:r>
            <a:r>
              <a:rPr i="1" lang="en" sz="800">
                <a:solidFill>
                  <a:schemeClr val="dk1"/>
                </a:solidFill>
                <a:latin typeface="Hind"/>
                <a:ea typeface="Hind"/>
                <a:cs typeface="Hind"/>
                <a:sym typeface="Hind"/>
              </a:rPr>
              <a:t>American</a:t>
            </a:r>
            <a:r>
              <a:rPr i="1" lang="en" sz="800">
                <a:solidFill>
                  <a:schemeClr val="dk1"/>
                </a:solidFill>
                <a:latin typeface="Hind"/>
                <a:ea typeface="Hind"/>
                <a:cs typeface="Hind"/>
                <a:sym typeface="Hind"/>
              </a:rPr>
              <a:t> Progress</a:t>
            </a:r>
            <a:r>
              <a:rPr lang="en" sz="800">
                <a:solidFill>
                  <a:schemeClr val="dk1"/>
                </a:solidFill>
                <a:latin typeface="Hind"/>
                <a:ea typeface="Hind"/>
                <a:cs typeface="Hind"/>
                <a:sym typeface="Hind"/>
              </a:rPr>
              <a:t>. 2018.</a:t>
            </a:r>
            <a:endParaRPr sz="800">
              <a:solidFill>
                <a:schemeClr val="dk1"/>
              </a:solidFill>
              <a:latin typeface="Hind"/>
              <a:ea typeface="Hind"/>
              <a:cs typeface="Hind"/>
              <a:sym typeface="Hind"/>
            </a:endParaRPr>
          </a:p>
        </p:txBody>
      </p:sp>
      <p:sp>
        <p:nvSpPr>
          <p:cNvPr id="355" name="Google Shape;355;p3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grpSp>
        <p:nvGrpSpPr>
          <p:cNvPr id="356" name="Google Shape;356;p31"/>
          <p:cNvGrpSpPr/>
          <p:nvPr/>
        </p:nvGrpSpPr>
        <p:grpSpPr>
          <a:xfrm>
            <a:off x="651400" y="1458325"/>
            <a:ext cx="612000" cy="612000"/>
            <a:chOff x="651400" y="1458325"/>
            <a:chExt cx="612000" cy="612000"/>
          </a:xfrm>
        </p:grpSpPr>
        <p:sp>
          <p:nvSpPr>
            <p:cNvPr id="357" name="Google Shape;357;p31"/>
            <p:cNvSpPr/>
            <p:nvPr/>
          </p:nvSpPr>
          <p:spPr>
            <a:xfrm>
              <a:off x="651400" y="1458325"/>
              <a:ext cx="612000" cy="6120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grpSp>
          <p:nvGrpSpPr>
            <p:cNvPr id="358" name="Google Shape;358;p31"/>
            <p:cNvGrpSpPr/>
            <p:nvPr/>
          </p:nvGrpSpPr>
          <p:grpSpPr>
            <a:xfrm>
              <a:off x="786675" y="1576022"/>
              <a:ext cx="302167" cy="376606"/>
              <a:chOff x="4075625" y="3362000"/>
              <a:chExt cx="339475" cy="423200"/>
            </a:xfrm>
          </p:grpSpPr>
          <p:sp>
            <p:nvSpPr>
              <p:cNvPr id="359" name="Google Shape;359;p31"/>
              <p:cNvSpPr/>
              <p:nvPr/>
            </p:nvSpPr>
            <p:spPr>
              <a:xfrm>
                <a:off x="4232575" y="3444550"/>
                <a:ext cx="65125" cy="134875"/>
              </a:xfrm>
              <a:custGeom>
                <a:rect b="b" l="l" r="r" t="t"/>
                <a:pathLst>
                  <a:path extrusionOk="0" h="5395" w="2605">
                    <a:moveTo>
                      <a:pt x="1302" y="1"/>
                    </a:moveTo>
                    <a:lnTo>
                      <a:pt x="977" y="233"/>
                    </a:lnTo>
                    <a:lnTo>
                      <a:pt x="744" y="512"/>
                    </a:lnTo>
                    <a:lnTo>
                      <a:pt x="512" y="838"/>
                    </a:lnTo>
                    <a:lnTo>
                      <a:pt x="326" y="1210"/>
                    </a:lnTo>
                    <a:lnTo>
                      <a:pt x="186" y="1535"/>
                    </a:lnTo>
                    <a:lnTo>
                      <a:pt x="93" y="1907"/>
                    </a:lnTo>
                    <a:lnTo>
                      <a:pt x="0" y="2326"/>
                    </a:lnTo>
                    <a:lnTo>
                      <a:pt x="0" y="2698"/>
                    </a:lnTo>
                    <a:lnTo>
                      <a:pt x="0" y="3116"/>
                    </a:lnTo>
                    <a:lnTo>
                      <a:pt x="93" y="3488"/>
                    </a:lnTo>
                    <a:lnTo>
                      <a:pt x="186" y="3860"/>
                    </a:lnTo>
                    <a:lnTo>
                      <a:pt x="326" y="4232"/>
                    </a:lnTo>
                    <a:lnTo>
                      <a:pt x="512" y="4558"/>
                    </a:lnTo>
                    <a:lnTo>
                      <a:pt x="744" y="4883"/>
                    </a:lnTo>
                    <a:lnTo>
                      <a:pt x="977" y="5162"/>
                    </a:lnTo>
                    <a:lnTo>
                      <a:pt x="1302" y="5395"/>
                    </a:lnTo>
                    <a:lnTo>
                      <a:pt x="1581" y="5162"/>
                    </a:lnTo>
                    <a:lnTo>
                      <a:pt x="1860" y="4883"/>
                    </a:lnTo>
                    <a:lnTo>
                      <a:pt x="2046" y="4558"/>
                    </a:lnTo>
                    <a:lnTo>
                      <a:pt x="2232" y="4232"/>
                    </a:lnTo>
                    <a:lnTo>
                      <a:pt x="2418" y="3860"/>
                    </a:lnTo>
                    <a:lnTo>
                      <a:pt x="2511" y="3488"/>
                    </a:lnTo>
                    <a:lnTo>
                      <a:pt x="2558" y="3116"/>
                    </a:lnTo>
                    <a:lnTo>
                      <a:pt x="2604" y="2698"/>
                    </a:lnTo>
                    <a:lnTo>
                      <a:pt x="2558" y="2326"/>
                    </a:lnTo>
                    <a:lnTo>
                      <a:pt x="2511" y="1907"/>
                    </a:lnTo>
                    <a:lnTo>
                      <a:pt x="2418" y="1535"/>
                    </a:lnTo>
                    <a:lnTo>
                      <a:pt x="2232" y="1210"/>
                    </a:lnTo>
                    <a:lnTo>
                      <a:pt x="2046" y="838"/>
                    </a:lnTo>
                    <a:lnTo>
                      <a:pt x="1860" y="512"/>
                    </a:lnTo>
                    <a:lnTo>
                      <a:pt x="1581" y="233"/>
                    </a:lnTo>
                    <a:lnTo>
                      <a:pt x="1302"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0" name="Google Shape;360;p31"/>
              <p:cNvSpPr/>
              <p:nvPr/>
            </p:nvSpPr>
            <p:spPr>
              <a:xfrm>
                <a:off x="4232575" y="3444550"/>
                <a:ext cx="65125" cy="134875"/>
              </a:xfrm>
              <a:custGeom>
                <a:rect b="b" l="l" r="r" t="t"/>
                <a:pathLst>
                  <a:path extrusionOk="0" fill="none" h="5395" w="2605">
                    <a:moveTo>
                      <a:pt x="1302" y="1"/>
                    </a:moveTo>
                    <a:lnTo>
                      <a:pt x="1302" y="1"/>
                    </a:lnTo>
                    <a:lnTo>
                      <a:pt x="977" y="233"/>
                    </a:lnTo>
                    <a:lnTo>
                      <a:pt x="744" y="512"/>
                    </a:lnTo>
                    <a:lnTo>
                      <a:pt x="512" y="838"/>
                    </a:lnTo>
                    <a:lnTo>
                      <a:pt x="326" y="1210"/>
                    </a:lnTo>
                    <a:lnTo>
                      <a:pt x="186" y="1535"/>
                    </a:lnTo>
                    <a:lnTo>
                      <a:pt x="93" y="1907"/>
                    </a:lnTo>
                    <a:lnTo>
                      <a:pt x="0" y="2326"/>
                    </a:lnTo>
                    <a:lnTo>
                      <a:pt x="0" y="2698"/>
                    </a:lnTo>
                    <a:lnTo>
                      <a:pt x="0" y="2698"/>
                    </a:lnTo>
                    <a:lnTo>
                      <a:pt x="0" y="3116"/>
                    </a:lnTo>
                    <a:lnTo>
                      <a:pt x="93" y="3488"/>
                    </a:lnTo>
                    <a:lnTo>
                      <a:pt x="186" y="3860"/>
                    </a:lnTo>
                    <a:lnTo>
                      <a:pt x="326" y="4232"/>
                    </a:lnTo>
                    <a:lnTo>
                      <a:pt x="512" y="4558"/>
                    </a:lnTo>
                    <a:lnTo>
                      <a:pt x="744" y="4883"/>
                    </a:lnTo>
                    <a:lnTo>
                      <a:pt x="977" y="5162"/>
                    </a:lnTo>
                    <a:lnTo>
                      <a:pt x="1302" y="5395"/>
                    </a:lnTo>
                    <a:lnTo>
                      <a:pt x="1302" y="5395"/>
                    </a:lnTo>
                    <a:lnTo>
                      <a:pt x="1581" y="5162"/>
                    </a:lnTo>
                    <a:lnTo>
                      <a:pt x="1860" y="4883"/>
                    </a:lnTo>
                    <a:lnTo>
                      <a:pt x="2046" y="4558"/>
                    </a:lnTo>
                    <a:lnTo>
                      <a:pt x="2232" y="4232"/>
                    </a:lnTo>
                    <a:lnTo>
                      <a:pt x="2418" y="3860"/>
                    </a:lnTo>
                    <a:lnTo>
                      <a:pt x="2511" y="3488"/>
                    </a:lnTo>
                    <a:lnTo>
                      <a:pt x="2558" y="3116"/>
                    </a:lnTo>
                    <a:lnTo>
                      <a:pt x="2604" y="2698"/>
                    </a:lnTo>
                    <a:lnTo>
                      <a:pt x="2604" y="2698"/>
                    </a:lnTo>
                    <a:lnTo>
                      <a:pt x="2558" y="2326"/>
                    </a:lnTo>
                    <a:lnTo>
                      <a:pt x="2511" y="1907"/>
                    </a:lnTo>
                    <a:lnTo>
                      <a:pt x="2418" y="1535"/>
                    </a:lnTo>
                    <a:lnTo>
                      <a:pt x="2232" y="1210"/>
                    </a:lnTo>
                    <a:lnTo>
                      <a:pt x="2046" y="838"/>
                    </a:lnTo>
                    <a:lnTo>
                      <a:pt x="1860" y="512"/>
                    </a:lnTo>
                    <a:lnTo>
                      <a:pt x="1581" y="233"/>
                    </a:lnTo>
                    <a:lnTo>
                      <a:pt x="1302" y="1"/>
                    </a:lnTo>
                    <a:lnTo>
                      <a:pt x="1302"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1" name="Google Shape;361;p31"/>
              <p:cNvSpPr/>
              <p:nvPr/>
            </p:nvSpPr>
            <p:spPr>
              <a:xfrm>
                <a:off x="4265125" y="34445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2" name="Google Shape;362;p31"/>
              <p:cNvSpPr/>
              <p:nvPr/>
            </p:nvSpPr>
            <p:spPr>
              <a:xfrm>
                <a:off x="4187225" y="3489900"/>
                <a:ext cx="38400" cy="83725"/>
              </a:xfrm>
              <a:custGeom>
                <a:rect b="b" l="l" r="r" t="t"/>
                <a:pathLst>
                  <a:path extrusionOk="0" h="3349" w="1536">
                    <a:moveTo>
                      <a:pt x="94" y="0"/>
                    </a:moveTo>
                    <a:lnTo>
                      <a:pt x="47" y="326"/>
                    </a:lnTo>
                    <a:lnTo>
                      <a:pt x="1" y="651"/>
                    </a:lnTo>
                    <a:lnTo>
                      <a:pt x="1" y="977"/>
                    </a:lnTo>
                    <a:lnTo>
                      <a:pt x="47" y="1302"/>
                    </a:lnTo>
                    <a:lnTo>
                      <a:pt x="140" y="1581"/>
                    </a:lnTo>
                    <a:lnTo>
                      <a:pt x="233" y="1907"/>
                    </a:lnTo>
                    <a:lnTo>
                      <a:pt x="373" y="2186"/>
                    </a:lnTo>
                    <a:lnTo>
                      <a:pt x="559" y="2465"/>
                    </a:lnTo>
                    <a:lnTo>
                      <a:pt x="791" y="2744"/>
                    </a:lnTo>
                    <a:lnTo>
                      <a:pt x="1024" y="2976"/>
                    </a:lnTo>
                    <a:lnTo>
                      <a:pt x="1256" y="3162"/>
                    </a:lnTo>
                    <a:lnTo>
                      <a:pt x="1535" y="3348"/>
                    </a:lnTo>
                    <a:lnTo>
                      <a:pt x="1210" y="2790"/>
                    </a:lnTo>
                    <a:lnTo>
                      <a:pt x="977" y="2186"/>
                    </a:lnTo>
                    <a:lnTo>
                      <a:pt x="838" y="1535"/>
                    </a:lnTo>
                    <a:lnTo>
                      <a:pt x="791" y="884"/>
                    </a:lnTo>
                    <a:lnTo>
                      <a:pt x="838" y="512"/>
                    </a:lnTo>
                    <a:lnTo>
                      <a:pt x="884" y="140"/>
                    </a:lnTo>
                    <a:lnTo>
                      <a:pt x="512" y="47"/>
                    </a:lnTo>
                    <a:lnTo>
                      <a:pt x="94"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3" name="Google Shape;363;p31"/>
              <p:cNvSpPr/>
              <p:nvPr/>
            </p:nvSpPr>
            <p:spPr>
              <a:xfrm>
                <a:off x="4187225" y="3489900"/>
                <a:ext cx="38400" cy="83725"/>
              </a:xfrm>
              <a:custGeom>
                <a:rect b="b" l="l" r="r" t="t"/>
                <a:pathLst>
                  <a:path extrusionOk="0" fill="none" h="3349" w="1536">
                    <a:moveTo>
                      <a:pt x="884" y="140"/>
                    </a:moveTo>
                    <a:lnTo>
                      <a:pt x="884" y="140"/>
                    </a:lnTo>
                    <a:lnTo>
                      <a:pt x="512" y="47"/>
                    </a:lnTo>
                    <a:lnTo>
                      <a:pt x="94" y="0"/>
                    </a:lnTo>
                    <a:lnTo>
                      <a:pt x="94" y="0"/>
                    </a:lnTo>
                    <a:lnTo>
                      <a:pt x="47" y="326"/>
                    </a:lnTo>
                    <a:lnTo>
                      <a:pt x="1" y="651"/>
                    </a:lnTo>
                    <a:lnTo>
                      <a:pt x="1" y="977"/>
                    </a:lnTo>
                    <a:lnTo>
                      <a:pt x="47" y="1302"/>
                    </a:lnTo>
                    <a:lnTo>
                      <a:pt x="140" y="1581"/>
                    </a:lnTo>
                    <a:lnTo>
                      <a:pt x="233" y="1907"/>
                    </a:lnTo>
                    <a:lnTo>
                      <a:pt x="373" y="2186"/>
                    </a:lnTo>
                    <a:lnTo>
                      <a:pt x="559" y="2465"/>
                    </a:lnTo>
                    <a:lnTo>
                      <a:pt x="559" y="2465"/>
                    </a:lnTo>
                    <a:lnTo>
                      <a:pt x="791" y="2744"/>
                    </a:lnTo>
                    <a:lnTo>
                      <a:pt x="1024" y="2976"/>
                    </a:lnTo>
                    <a:lnTo>
                      <a:pt x="1256" y="3162"/>
                    </a:lnTo>
                    <a:lnTo>
                      <a:pt x="1535" y="3348"/>
                    </a:lnTo>
                    <a:lnTo>
                      <a:pt x="1535" y="3348"/>
                    </a:lnTo>
                    <a:lnTo>
                      <a:pt x="1210" y="2790"/>
                    </a:lnTo>
                    <a:lnTo>
                      <a:pt x="977" y="2186"/>
                    </a:lnTo>
                    <a:lnTo>
                      <a:pt x="838" y="1535"/>
                    </a:lnTo>
                    <a:lnTo>
                      <a:pt x="791" y="884"/>
                    </a:lnTo>
                    <a:lnTo>
                      <a:pt x="791" y="884"/>
                    </a:lnTo>
                    <a:lnTo>
                      <a:pt x="838" y="512"/>
                    </a:lnTo>
                    <a:lnTo>
                      <a:pt x="884" y="140"/>
                    </a:lnTo>
                    <a:lnTo>
                      <a:pt x="884" y="14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4" name="Google Shape;364;p31"/>
              <p:cNvSpPr/>
              <p:nvPr/>
            </p:nvSpPr>
            <p:spPr>
              <a:xfrm>
                <a:off x="4209325" y="349337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5" name="Google Shape;365;p31"/>
              <p:cNvSpPr/>
              <p:nvPr/>
            </p:nvSpPr>
            <p:spPr>
              <a:xfrm>
                <a:off x="4075625" y="3362000"/>
                <a:ext cx="339475" cy="423200"/>
              </a:xfrm>
              <a:custGeom>
                <a:rect b="b" l="l" r="r" t="t"/>
                <a:pathLst>
                  <a:path extrusionOk="0" h="16928" w="13579">
                    <a:moveTo>
                      <a:pt x="7720" y="2187"/>
                    </a:moveTo>
                    <a:lnTo>
                      <a:pt x="7859" y="2280"/>
                    </a:lnTo>
                    <a:lnTo>
                      <a:pt x="8138" y="2466"/>
                    </a:lnTo>
                    <a:lnTo>
                      <a:pt x="8417" y="2698"/>
                    </a:lnTo>
                    <a:lnTo>
                      <a:pt x="8696" y="2977"/>
                    </a:lnTo>
                    <a:lnTo>
                      <a:pt x="8929" y="3256"/>
                    </a:lnTo>
                    <a:lnTo>
                      <a:pt x="9161" y="3535"/>
                    </a:lnTo>
                    <a:lnTo>
                      <a:pt x="9347" y="3861"/>
                    </a:lnTo>
                    <a:lnTo>
                      <a:pt x="9487" y="4186"/>
                    </a:lnTo>
                    <a:lnTo>
                      <a:pt x="9626" y="4558"/>
                    </a:lnTo>
                    <a:lnTo>
                      <a:pt x="10045" y="4419"/>
                    </a:lnTo>
                    <a:lnTo>
                      <a:pt x="10463" y="4326"/>
                    </a:lnTo>
                    <a:lnTo>
                      <a:pt x="11347" y="4326"/>
                    </a:lnTo>
                    <a:lnTo>
                      <a:pt x="11486" y="4372"/>
                    </a:lnTo>
                    <a:lnTo>
                      <a:pt x="11626" y="4465"/>
                    </a:lnTo>
                    <a:lnTo>
                      <a:pt x="11719" y="4558"/>
                    </a:lnTo>
                    <a:lnTo>
                      <a:pt x="11765" y="4698"/>
                    </a:lnTo>
                    <a:lnTo>
                      <a:pt x="11905" y="5163"/>
                    </a:lnTo>
                    <a:lnTo>
                      <a:pt x="11951" y="5674"/>
                    </a:lnTo>
                    <a:lnTo>
                      <a:pt x="11951" y="6139"/>
                    </a:lnTo>
                    <a:lnTo>
                      <a:pt x="11858" y="6651"/>
                    </a:lnTo>
                    <a:lnTo>
                      <a:pt x="11765" y="7116"/>
                    </a:lnTo>
                    <a:lnTo>
                      <a:pt x="11579" y="7581"/>
                    </a:lnTo>
                    <a:lnTo>
                      <a:pt x="11347" y="7999"/>
                    </a:lnTo>
                    <a:lnTo>
                      <a:pt x="11021" y="8418"/>
                    </a:lnTo>
                    <a:lnTo>
                      <a:pt x="10742" y="8743"/>
                    </a:lnTo>
                    <a:lnTo>
                      <a:pt x="10417" y="9022"/>
                    </a:lnTo>
                    <a:lnTo>
                      <a:pt x="10045" y="9255"/>
                    </a:lnTo>
                    <a:lnTo>
                      <a:pt x="9673" y="9487"/>
                    </a:lnTo>
                    <a:lnTo>
                      <a:pt x="9254" y="9627"/>
                    </a:lnTo>
                    <a:lnTo>
                      <a:pt x="8836" y="9766"/>
                    </a:lnTo>
                    <a:lnTo>
                      <a:pt x="8417" y="9813"/>
                    </a:lnTo>
                    <a:lnTo>
                      <a:pt x="7999" y="9859"/>
                    </a:lnTo>
                    <a:lnTo>
                      <a:pt x="7441" y="9813"/>
                    </a:lnTo>
                    <a:lnTo>
                      <a:pt x="6976" y="9813"/>
                    </a:lnTo>
                    <a:lnTo>
                      <a:pt x="6511" y="9720"/>
                    </a:lnTo>
                    <a:lnTo>
                      <a:pt x="6046" y="9580"/>
                    </a:lnTo>
                    <a:lnTo>
                      <a:pt x="5627" y="9394"/>
                    </a:lnTo>
                    <a:lnTo>
                      <a:pt x="5255" y="9162"/>
                    </a:lnTo>
                    <a:lnTo>
                      <a:pt x="4883" y="8883"/>
                    </a:lnTo>
                    <a:lnTo>
                      <a:pt x="4511" y="8557"/>
                    </a:lnTo>
                    <a:lnTo>
                      <a:pt x="4232" y="8185"/>
                    </a:lnTo>
                    <a:lnTo>
                      <a:pt x="3953" y="7767"/>
                    </a:lnTo>
                    <a:lnTo>
                      <a:pt x="3767" y="7302"/>
                    </a:lnTo>
                    <a:lnTo>
                      <a:pt x="3628" y="6837"/>
                    </a:lnTo>
                    <a:lnTo>
                      <a:pt x="3535" y="6372"/>
                    </a:lnTo>
                    <a:lnTo>
                      <a:pt x="3488" y="5860"/>
                    </a:lnTo>
                    <a:lnTo>
                      <a:pt x="3535" y="5395"/>
                    </a:lnTo>
                    <a:lnTo>
                      <a:pt x="3581" y="4884"/>
                    </a:lnTo>
                    <a:lnTo>
                      <a:pt x="3767" y="4419"/>
                    </a:lnTo>
                    <a:lnTo>
                      <a:pt x="3814" y="4279"/>
                    </a:lnTo>
                    <a:lnTo>
                      <a:pt x="3907" y="4186"/>
                    </a:lnTo>
                    <a:lnTo>
                      <a:pt x="4046" y="4140"/>
                    </a:lnTo>
                    <a:lnTo>
                      <a:pt x="4186" y="4093"/>
                    </a:lnTo>
                    <a:lnTo>
                      <a:pt x="4558" y="4093"/>
                    </a:lnTo>
                    <a:lnTo>
                      <a:pt x="4930" y="4140"/>
                    </a:lnTo>
                    <a:lnTo>
                      <a:pt x="5255" y="4233"/>
                    </a:lnTo>
                    <a:lnTo>
                      <a:pt x="5581" y="4326"/>
                    </a:lnTo>
                    <a:lnTo>
                      <a:pt x="5906" y="3721"/>
                    </a:lnTo>
                    <a:lnTo>
                      <a:pt x="6278" y="3163"/>
                    </a:lnTo>
                    <a:lnTo>
                      <a:pt x="6743" y="2652"/>
                    </a:lnTo>
                    <a:lnTo>
                      <a:pt x="7301" y="2280"/>
                    </a:lnTo>
                    <a:lnTo>
                      <a:pt x="7441" y="2187"/>
                    </a:lnTo>
                    <a:close/>
                    <a:moveTo>
                      <a:pt x="7580" y="1"/>
                    </a:moveTo>
                    <a:lnTo>
                      <a:pt x="6976" y="47"/>
                    </a:lnTo>
                    <a:lnTo>
                      <a:pt x="6371" y="94"/>
                    </a:lnTo>
                    <a:lnTo>
                      <a:pt x="5813" y="280"/>
                    </a:lnTo>
                    <a:lnTo>
                      <a:pt x="5255" y="466"/>
                    </a:lnTo>
                    <a:lnTo>
                      <a:pt x="4744" y="698"/>
                    </a:lnTo>
                    <a:lnTo>
                      <a:pt x="4232" y="1024"/>
                    </a:lnTo>
                    <a:lnTo>
                      <a:pt x="3767" y="1350"/>
                    </a:lnTo>
                    <a:lnTo>
                      <a:pt x="3349" y="1768"/>
                    </a:lnTo>
                    <a:lnTo>
                      <a:pt x="2930" y="2187"/>
                    </a:lnTo>
                    <a:lnTo>
                      <a:pt x="2558" y="2698"/>
                    </a:lnTo>
                    <a:lnTo>
                      <a:pt x="2279" y="3163"/>
                    </a:lnTo>
                    <a:lnTo>
                      <a:pt x="2000" y="3721"/>
                    </a:lnTo>
                    <a:lnTo>
                      <a:pt x="1814" y="4279"/>
                    </a:lnTo>
                    <a:lnTo>
                      <a:pt x="1675" y="4837"/>
                    </a:lnTo>
                    <a:lnTo>
                      <a:pt x="1582" y="5395"/>
                    </a:lnTo>
                    <a:lnTo>
                      <a:pt x="1582" y="6000"/>
                    </a:lnTo>
                    <a:lnTo>
                      <a:pt x="1582" y="7255"/>
                    </a:lnTo>
                    <a:lnTo>
                      <a:pt x="94" y="10045"/>
                    </a:lnTo>
                    <a:lnTo>
                      <a:pt x="47" y="10185"/>
                    </a:lnTo>
                    <a:lnTo>
                      <a:pt x="1" y="10278"/>
                    </a:lnTo>
                    <a:lnTo>
                      <a:pt x="47" y="10417"/>
                    </a:lnTo>
                    <a:lnTo>
                      <a:pt x="94" y="10557"/>
                    </a:lnTo>
                    <a:lnTo>
                      <a:pt x="140" y="10650"/>
                    </a:lnTo>
                    <a:lnTo>
                      <a:pt x="280" y="10696"/>
                    </a:lnTo>
                    <a:lnTo>
                      <a:pt x="373" y="10743"/>
                    </a:lnTo>
                    <a:lnTo>
                      <a:pt x="512" y="10789"/>
                    </a:lnTo>
                    <a:lnTo>
                      <a:pt x="1582" y="10789"/>
                    </a:lnTo>
                    <a:lnTo>
                      <a:pt x="1582" y="11998"/>
                    </a:lnTo>
                    <a:lnTo>
                      <a:pt x="1582" y="12324"/>
                    </a:lnTo>
                    <a:lnTo>
                      <a:pt x="1628" y="12649"/>
                    </a:lnTo>
                    <a:lnTo>
                      <a:pt x="1721" y="12928"/>
                    </a:lnTo>
                    <a:lnTo>
                      <a:pt x="1814" y="13207"/>
                    </a:lnTo>
                    <a:lnTo>
                      <a:pt x="1954" y="13486"/>
                    </a:lnTo>
                    <a:lnTo>
                      <a:pt x="2093" y="13719"/>
                    </a:lnTo>
                    <a:lnTo>
                      <a:pt x="2279" y="13998"/>
                    </a:lnTo>
                    <a:lnTo>
                      <a:pt x="2465" y="14184"/>
                    </a:lnTo>
                    <a:lnTo>
                      <a:pt x="2698" y="14416"/>
                    </a:lnTo>
                    <a:lnTo>
                      <a:pt x="2930" y="14556"/>
                    </a:lnTo>
                    <a:lnTo>
                      <a:pt x="3209" y="14742"/>
                    </a:lnTo>
                    <a:lnTo>
                      <a:pt x="3488" y="14881"/>
                    </a:lnTo>
                    <a:lnTo>
                      <a:pt x="3767" y="14974"/>
                    </a:lnTo>
                    <a:lnTo>
                      <a:pt x="4046" y="15067"/>
                    </a:lnTo>
                    <a:lnTo>
                      <a:pt x="4372" y="15114"/>
                    </a:lnTo>
                    <a:lnTo>
                      <a:pt x="6511" y="15114"/>
                    </a:lnTo>
                    <a:lnTo>
                      <a:pt x="6511" y="16416"/>
                    </a:lnTo>
                    <a:lnTo>
                      <a:pt x="6557" y="16602"/>
                    </a:lnTo>
                    <a:lnTo>
                      <a:pt x="6650" y="16788"/>
                    </a:lnTo>
                    <a:lnTo>
                      <a:pt x="6836" y="16881"/>
                    </a:lnTo>
                    <a:lnTo>
                      <a:pt x="7022" y="16927"/>
                    </a:lnTo>
                    <a:lnTo>
                      <a:pt x="13067" y="16927"/>
                    </a:lnTo>
                    <a:lnTo>
                      <a:pt x="13253" y="16881"/>
                    </a:lnTo>
                    <a:lnTo>
                      <a:pt x="13439" y="16788"/>
                    </a:lnTo>
                    <a:lnTo>
                      <a:pt x="13532" y="16602"/>
                    </a:lnTo>
                    <a:lnTo>
                      <a:pt x="13579" y="16416"/>
                    </a:lnTo>
                    <a:lnTo>
                      <a:pt x="13579" y="6000"/>
                    </a:lnTo>
                    <a:lnTo>
                      <a:pt x="13532" y="5395"/>
                    </a:lnTo>
                    <a:lnTo>
                      <a:pt x="13439" y="4837"/>
                    </a:lnTo>
                    <a:lnTo>
                      <a:pt x="13300" y="4279"/>
                    </a:lnTo>
                    <a:lnTo>
                      <a:pt x="13114" y="3721"/>
                    </a:lnTo>
                    <a:lnTo>
                      <a:pt x="12881" y="3163"/>
                    </a:lnTo>
                    <a:lnTo>
                      <a:pt x="12556" y="2698"/>
                    </a:lnTo>
                    <a:lnTo>
                      <a:pt x="12184" y="2187"/>
                    </a:lnTo>
                    <a:lnTo>
                      <a:pt x="11812" y="1768"/>
                    </a:lnTo>
                    <a:lnTo>
                      <a:pt x="11347" y="1350"/>
                    </a:lnTo>
                    <a:lnTo>
                      <a:pt x="10882" y="1024"/>
                    </a:lnTo>
                    <a:lnTo>
                      <a:pt x="10370" y="698"/>
                    </a:lnTo>
                    <a:lnTo>
                      <a:pt x="9859" y="466"/>
                    </a:lnTo>
                    <a:lnTo>
                      <a:pt x="9301" y="280"/>
                    </a:lnTo>
                    <a:lnTo>
                      <a:pt x="8743" y="94"/>
                    </a:lnTo>
                    <a:lnTo>
                      <a:pt x="8138" y="47"/>
                    </a:lnTo>
                    <a:lnTo>
                      <a:pt x="7580"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6" name="Google Shape;366;p31"/>
              <p:cNvSpPr/>
              <p:nvPr/>
            </p:nvSpPr>
            <p:spPr>
              <a:xfrm>
                <a:off x="4075625" y="3362000"/>
                <a:ext cx="339475" cy="423200"/>
              </a:xfrm>
              <a:custGeom>
                <a:rect b="b" l="l" r="r" t="t"/>
                <a:pathLst>
                  <a:path extrusionOk="0" fill="none" h="16928" w="13579">
                    <a:moveTo>
                      <a:pt x="11812" y="1768"/>
                    </a:moveTo>
                    <a:lnTo>
                      <a:pt x="11812" y="1768"/>
                    </a:lnTo>
                    <a:lnTo>
                      <a:pt x="11347" y="1350"/>
                    </a:lnTo>
                    <a:lnTo>
                      <a:pt x="10882" y="1024"/>
                    </a:lnTo>
                    <a:lnTo>
                      <a:pt x="10370" y="698"/>
                    </a:lnTo>
                    <a:lnTo>
                      <a:pt x="9859" y="466"/>
                    </a:lnTo>
                    <a:lnTo>
                      <a:pt x="9301" y="280"/>
                    </a:lnTo>
                    <a:lnTo>
                      <a:pt x="8743" y="94"/>
                    </a:lnTo>
                    <a:lnTo>
                      <a:pt x="8138" y="47"/>
                    </a:lnTo>
                    <a:lnTo>
                      <a:pt x="7580" y="1"/>
                    </a:lnTo>
                    <a:lnTo>
                      <a:pt x="7580" y="1"/>
                    </a:lnTo>
                    <a:lnTo>
                      <a:pt x="6976" y="47"/>
                    </a:lnTo>
                    <a:lnTo>
                      <a:pt x="6371" y="94"/>
                    </a:lnTo>
                    <a:lnTo>
                      <a:pt x="5813" y="280"/>
                    </a:lnTo>
                    <a:lnTo>
                      <a:pt x="5255" y="466"/>
                    </a:lnTo>
                    <a:lnTo>
                      <a:pt x="4744" y="698"/>
                    </a:lnTo>
                    <a:lnTo>
                      <a:pt x="4232" y="1024"/>
                    </a:lnTo>
                    <a:lnTo>
                      <a:pt x="3767" y="1350"/>
                    </a:lnTo>
                    <a:lnTo>
                      <a:pt x="3349" y="1768"/>
                    </a:lnTo>
                    <a:lnTo>
                      <a:pt x="3349" y="1768"/>
                    </a:lnTo>
                    <a:lnTo>
                      <a:pt x="2930" y="2187"/>
                    </a:lnTo>
                    <a:lnTo>
                      <a:pt x="2558" y="2698"/>
                    </a:lnTo>
                    <a:lnTo>
                      <a:pt x="2279" y="3163"/>
                    </a:lnTo>
                    <a:lnTo>
                      <a:pt x="2000" y="3721"/>
                    </a:lnTo>
                    <a:lnTo>
                      <a:pt x="1814" y="4279"/>
                    </a:lnTo>
                    <a:lnTo>
                      <a:pt x="1675" y="4837"/>
                    </a:lnTo>
                    <a:lnTo>
                      <a:pt x="1582" y="5395"/>
                    </a:lnTo>
                    <a:lnTo>
                      <a:pt x="1582" y="6000"/>
                    </a:lnTo>
                    <a:lnTo>
                      <a:pt x="1582" y="7255"/>
                    </a:lnTo>
                    <a:lnTo>
                      <a:pt x="94" y="10045"/>
                    </a:lnTo>
                    <a:lnTo>
                      <a:pt x="94" y="10045"/>
                    </a:lnTo>
                    <a:lnTo>
                      <a:pt x="47" y="10185"/>
                    </a:lnTo>
                    <a:lnTo>
                      <a:pt x="1" y="10278"/>
                    </a:lnTo>
                    <a:lnTo>
                      <a:pt x="47" y="10417"/>
                    </a:lnTo>
                    <a:lnTo>
                      <a:pt x="94" y="10557"/>
                    </a:lnTo>
                    <a:lnTo>
                      <a:pt x="94" y="10557"/>
                    </a:lnTo>
                    <a:lnTo>
                      <a:pt x="140" y="10650"/>
                    </a:lnTo>
                    <a:lnTo>
                      <a:pt x="280" y="10696"/>
                    </a:lnTo>
                    <a:lnTo>
                      <a:pt x="373" y="10743"/>
                    </a:lnTo>
                    <a:lnTo>
                      <a:pt x="512" y="10789"/>
                    </a:lnTo>
                    <a:lnTo>
                      <a:pt x="1582" y="10789"/>
                    </a:lnTo>
                    <a:lnTo>
                      <a:pt x="1582" y="11998"/>
                    </a:lnTo>
                    <a:lnTo>
                      <a:pt x="1582" y="11998"/>
                    </a:lnTo>
                    <a:lnTo>
                      <a:pt x="1582" y="12324"/>
                    </a:lnTo>
                    <a:lnTo>
                      <a:pt x="1628" y="12649"/>
                    </a:lnTo>
                    <a:lnTo>
                      <a:pt x="1721" y="12928"/>
                    </a:lnTo>
                    <a:lnTo>
                      <a:pt x="1814" y="13207"/>
                    </a:lnTo>
                    <a:lnTo>
                      <a:pt x="1954" y="13486"/>
                    </a:lnTo>
                    <a:lnTo>
                      <a:pt x="2093" y="13719"/>
                    </a:lnTo>
                    <a:lnTo>
                      <a:pt x="2279" y="13998"/>
                    </a:lnTo>
                    <a:lnTo>
                      <a:pt x="2465" y="14184"/>
                    </a:lnTo>
                    <a:lnTo>
                      <a:pt x="2698" y="14416"/>
                    </a:lnTo>
                    <a:lnTo>
                      <a:pt x="2930" y="14556"/>
                    </a:lnTo>
                    <a:lnTo>
                      <a:pt x="3209" y="14742"/>
                    </a:lnTo>
                    <a:lnTo>
                      <a:pt x="3488" y="14881"/>
                    </a:lnTo>
                    <a:lnTo>
                      <a:pt x="3767" y="14974"/>
                    </a:lnTo>
                    <a:lnTo>
                      <a:pt x="4046" y="15067"/>
                    </a:lnTo>
                    <a:lnTo>
                      <a:pt x="4372" y="15114"/>
                    </a:lnTo>
                    <a:lnTo>
                      <a:pt x="4697" y="15114"/>
                    </a:lnTo>
                    <a:lnTo>
                      <a:pt x="6511" y="15114"/>
                    </a:lnTo>
                    <a:lnTo>
                      <a:pt x="6511" y="16416"/>
                    </a:lnTo>
                    <a:lnTo>
                      <a:pt x="6511" y="16416"/>
                    </a:lnTo>
                    <a:lnTo>
                      <a:pt x="6557" y="16602"/>
                    </a:lnTo>
                    <a:lnTo>
                      <a:pt x="6650" y="16788"/>
                    </a:lnTo>
                    <a:lnTo>
                      <a:pt x="6836" y="16881"/>
                    </a:lnTo>
                    <a:lnTo>
                      <a:pt x="7022" y="16927"/>
                    </a:lnTo>
                    <a:lnTo>
                      <a:pt x="13067" y="16927"/>
                    </a:lnTo>
                    <a:lnTo>
                      <a:pt x="13067" y="16927"/>
                    </a:lnTo>
                    <a:lnTo>
                      <a:pt x="13253" y="16881"/>
                    </a:lnTo>
                    <a:lnTo>
                      <a:pt x="13439" y="16788"/>
                    </a:lnTo>
                    <a:lnTo>
                      <a:pt x="13532" y="16602"/>
                    </a:lnTo>
                    <a:lnTo>
                      <a:pt x="13579" y="16416"/>
                    </a:lnTo>
                    <a:lnTo>
                      <a:pt x="13579" y="6000"/>
                    </a:lnTo>
                    <a:lnTo>
                      <a:pt x="13579" y="6000"/>
                    </a:lnTo>
                    <a:lnTo>
                      <a:pt x="13532" y="5395"/>
                    </a:lnTo>
                    <a:lnTo>
                      <a:pt x="13439" y="4837"/>
                    </a:lnTo>
                    <a:lnTo>
                      <a:pt x="13300" y="4279"/>
                    </a:lnTo>
                    <a:lnTo>
                      <a:pt x="13114" y="3721"/>
                    </a:lnTo>
                    <a:lnTo>
                      <a:pt x="12881" y="3163"/>
                    </a:lnTo>
                    <a:lnTo>
                      <a:pt x="12556" y="2698"/>
                    </a:lnTo>
                    <a:lnTo>
                      <a:pt x="12184" y="2187"/>
                    </a:lnTo>
                    <a:lnTo>
                      <a:pt x="11812" y="1768"/>
                    </a:lnTo>
                    <a:lnTo>
                      <a:pt x="11812" y="1768"/>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7" name="Google Shape;367;p31"/>
              <p:cNvSpPr/>
              <p:nvPr/>
            </p:nvSpPr>
            <p:spPr>
              <a:xfrm>
                <a:off x="4162825" y="3416650"/>
                <a:ext cx="211600" cy="191850"/>
              </a:xfrm>
              <a:custGeom>
                <a:rect b="b" l="l" r="r" t="t"/>
                <a:pathLst>
                  <a:path extrusionOk="0" fill="none" h="7674" w="8464">
                    <a:moveTo>
                      <a:pt x="7533" y="6232"/>
                    </a:moveTo>
                    <a:lnTo>
                      <a:pt x="7533" y="6232"/>
                    </a:lnTo>
                    <a:lnTo>
                      <a:pt x="7254" y="6557"/>
                    </a:lnTo>
                    <a:lnTo>
                      <a:pt x="6929" y="6836"/>
                    </a:lnTo>
                    <a:lnTo>
                      <a:pt x="6557" y="7069"/>
                    </a:lnTo>
                    <a:lnTo>
                      <a:pt x="6185" y="7301"/>
                    </a:lnTo>
                    <a:lnTo>
                      <a:pt x="5766" y="7441"/>
                    </a:lnTo>
                    <a:lnTo>
                      <a:pt x="5348" y="7580"/>
                    </a:lnTo>
                    <a:lnTo>
                      <a:pt x="4929" y="7627"/>
                    </a:lnTo>
                    <a:lnTo>
                      <a:pt x="4511" y="7673"/>
                    </a:lnTo>
                    <a:lnTo>
                      <a:pt x="4511" y="7673"/>
                    </a:lnTo>
                    <a:lnTo>
                      <a:pt x="3953" y="7627"/>
                    </a:lnTo>
                    <a:lnTo>
                      <a:pt x="3953" y="7627"/>
                    </a:lnTo>
                    <a:lnTo>
                      <a:pt x="3488" y="7627"/>
                    </a:lnTo>
                    <a:lnTo>
                      <a:pt x="3023" y="7534"/>
                    </a:lnTo>
                    <a:lnTo>
                      <a:pt x="2558" y="7394"/>
                    </a:lnTo>
                    <a:lnTo>
                      <a:pt x="2139" y="7208"/>
                    </a:lnTo>
                    <a:lnTo>
                      <a:pt x="1767" y="6976"/>
                    </a:lnTo>
                    <a:lnTo>
                      <a:pt x="1395" y="6697"/>
                    </a:lnTo>
                    <a:lnTo>
                      <a:pt x="1023" y="6371"/>
                    </a:lnTo>
                    <a:lnTo>
                      <a:pt x="744" y="5999"/>
                    </a:lnTo>
                    <a:lnTo>
                      <a:pt x="744" y="5999"/>
                    </a:lnTo>
                    <a:lnTo>
                      <a:pt x="465" y="5581"/>
                    </a:lnTo>
                    <a:lnTo>
                      <a:pt x="279" y="5116"/>
                    </a:lnTo>
                    <a:lnTo>
                      <a:pt x="140" y="4651"/>
                    </a:lnTo>
                    <a:lnTo>
                      <a:pt x="47" y="4186"/>
                    </a:lnTo>
                    <a:lnTo>
                      <a:pt x="0" y="3674"/>
                    </a:lnTo>
                    <a:lnTo>
                      <a:pt x="47" y="3209"/>
                    </a:lnTo>
                    <a:lnTo>
                      <a:pt x="93" y="2698"/>
                    </a:lnTo>
                    <a:lnTo>
                      <a:pt x="279" y="2233"/>
                    </a:lnTo>
                    <a:lnTo>
                      <a:pt x="279" y="2233"/>
                    </a:lnTo>
                    <a:lnTo>
                      <a:pt x="326" y="2093"/>
                    </a:lnTo>
                    <a:lnTo>
                      <a:pt x="419" y="2000"/>
                    </a:lnTo>
                    <a:lnTo>
                      <a:pt x="558" y="1954"/>
                    </a:lnTo>
                    <a:lnTo>
                      <a:pt x="698" y="1907"/>
                    </a:lnTo>
                    <a:lnTo>
                      <a:pt x="698" y="1907"/>
                    </a:lnTo>
                    <a:lnTo>
                      <a:pt x="1070" y="1907"/>
                    </a:lnTo>
                    <a:lnTo>
                      <a:pt x="1442" y="1954"/>
                    </a:lnTo>
                    <a:lnTo>
                      <a:pt x="1767" y="2047"/>
                    </a:lnTo>
                    <a:lnTo>
                      <a:pt x="2093" y="2140"/>
                    </a:lnTo>
                    <a:lnTo>
                      <a:pt x="2093" y="2140"/>
                    </a:lnTo>
                    <a:lnTo>
                      <a:pt x="2418" y="1535"/>
                    </a:lnTo>
                    <a:lnTo>
                      <a:pt x="2790" y="977"/>
                    </a:lnTo>
                    <a:lnTo>
                      <a:pt x="3255" y="466"/>
                    </a:lnTo>
                    <a:lnTo>
                      <a:pt x="3813" y="94"/>
                    </a:lnTo>
                    <a:lnTo>
                      <a:pt x="3813" y="94"/>
                    </a:lnTo>
                    <a:lnTo>
                      <a:pt x="3953" y="1"/>
                    </a:lnTo>
                    <a:lnTo>
                      <a:pt x="4092" y="1"/>
                    </a:lnTo>
                    <a:lnTo>
                      <a:pt x="4232" y="1"/>
                    </a:lnTo>
                    <a:lnTo>
                      <a:pt x="4371" y="94"/>
                    </a:lnTo>
                    <a:lnTo>
                      <a:pt x="4371" y="94"/>
                    </a:lnTo>
                    <a:lnTo>
                      <a:pt x="4650" y="280"/>
                    </a:lnTo>
                    <a:lnTo>
                      <a:pt x="4929" y="512"/>
                    </a:lnTo>
                    <a:lnTo>
                      <a:pt x="5208" y="791"/>
                    </a:lnTo>
                    <a:lnTo>
                      <a:pt x="5441" y="1070"/>
                    </a:lnTo>
                    <a:lnTo>
                      <a:pt x="5673" y="1349"/>
                    </a:lnTo>
                    <a:lnTo>
                      <a:pt x="5859" y="1675"/>
                    </a:lnTo>
                    <a:lnTo>
                      <a:pt x="5999" y="2000"/>
                    </a:lnTo>
                    <a:lnTo>
                      <a:pt x="6138" y="2372"/>
                    </a:lnTo>
                    <a:lnTo>
                      <a:pt x="6138" y="2372"/>
                    </a:lnTo>
                    <a:lnTo>
                      <a:pt x="6557" y="2233"/>
                    </a:lnTo>
                    <a:lnTo>
                      <a:pt x="6975" y="2140"/>
                    </a:lnTo>
                    <a:lnTo>
                      <a:pt x="7394" y="2140"/>
                    </a:lnTo>
                    <a:lnTo>
                      <a:pt x="7859" y="2140"/>
                    </a:lnTo>
                    <a:lnTo>
                      <a:pt x="7859" y="2140"/>
                    </a:lnTo>
                    <a:lnTo>
                      <a:pt x="7998" y="2186"/>
                    </a:lnTo>
                    <a:lnTo>
                      <a:pt x="8138" y="2279"/>
                    </a:lnTo>
                    <a:lnTo>
                      <a:pt x="8231" y="2372"/>
                    </a:lnTo>
                    <a:lnTo>
                      <a:pt x="8277" y="2512"/>
                    </a:lnTo>
                    <a:lnTo>
                      <a:pt x="8277" y="2512"/>
                    </a:lnTo>
                    <a:lnTo>
                      <a:pt x="8417" y="2977"/>
                    </a:lnTo>
                    <a:lnTo>
                      <a:pt x="8463" y="3488"/>
                    </a:lnTo>
                    <a:lnTo>
                      <a:pt x="8463" y="3953"/>
                    </a:lnTo>
                    <a:lnTo>
                      <a:pt x="8370" y="4465"/>
                    </a:lnTo>
                    <a:lnTo>
                      <a:pt x="8277" y="4930"/>
                    </a:lnTo>
                    <a:lnTo>
                      <a:pt x="8091" y="5395"/>
                    </a:lnTo>
                    <a:lnTo>
                      <a:pt x="7859" y="5813"/>
                    </a:lnTo>
                    <a:lnTo>
                      <a:pt x="7533" y="6232"/>
                    </a:lnTo>
                    <a:lnTo>
                      <a:pt x="7533" y="6232"/>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8" name="Google Shape;368;p31"/>
              <p:cNvSpPr/>
              <p:nvPr/>
            </p:nvSpPr>
            <p:spPr>
              <a:xfrm>
                <a:off x="4351150" y="357242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69" name="Google Shape;369;p31"/>
              <p:cNvSpPr/>
              <p:nvPr/>
            </p:nvSpPr>
            <p:spPr>
              <a:xfrm>
                <a:off x="4300000" y="3494550"/>
                <a:ext cx="50000" cy="84875"/>
              </a:xfrm>
              <a:custGeom>
                <a:rect b="b" l="l" r="r" t="t"/>
                <a:pathLst>
                  <a:path extrusionOk="0" h="3395" w="2000">
                    <a:moveTo>
                      <a:pt x="1907" y="0"/>
                    </a:moveTo>
                    <a:lnTo>
                      <a:pt x="1395" y="47"/>
                    </a:lnTo>
                    <a:lnTo>
                      <a:pt x="884" y="233"/>
                    </a:lnTo>
                    <a:lnTo>
                      <a:pt x="884" y="698"/>
                    </a:lnTo>
                    <a:lnTo>
                      <a:pt x="884" y="1070"/>
                    </a:lnTo>
                    <a:lnTo>
                      <a:pt x="837" y="1442"/>
                    </a:lnTo>
                    <a:lnTo>
                      <a:pt x="744" y="1767"/>
                    </a:lnTo>
                    <a:lnTo>
                      <a:pt x="651" y="2139"/>
                    </a:lnTo>
                    <a:lnTo>
                      <a:pt x="512" y="2465"/>
                    </a:lnTo>
                    <a:lnTo>
                      <a:pt x="372" y="2790"/>
                    </a:lnTo>
                    <a:lnTo>
                      <a:pt x="186" y="3069"/>
                    </a:lnTo>
                    <a:lnTo>
                      <a:pt x="0" y="3395"/>
                    </a:lnTo>
                    <a:lnTo>
                      <a:pt x="0" y="3395"/>
                    </a:lnTo>
                    <a:lnTo>
                      <a:pt x="372" y="3209"/>
                    </a:lnTo>
                    <a:lnTo>
                      <a:pt x="698" y="3023"/>
                    </a:lnTo>
                    <a:lnTo>
                      <a:pt x="1023" y="2744"/>
                    </a:lnTo>
                    <a:lnTo>
                      <a:pt x="1302" y="2465"/>
                    </a:lnTo>
                    <a:lnTo>
                      <a:pt x="1488" y="2186"/>
                    </a:lnTo>
                    <a:lnTo>
                      <a:pt x="1674" y="1907"/>
                    </a:lnTo>
                    <a:lnTo>
                      <a:pt x="1814" y="1628"/>
                    </a:lnTo>
                    <a:lnTo>
                      <a:pt x="1907" y="1302"/>
                    </a:lnTo>
                    <a:lnTo>
                      <a:pt x="1953" y="977"/>
                    </a:lnTo>
                    <a:lnTo>
                      <a:pt x="2000" y="651"/>
                    </a:lnTo>
                    <a:lnTo>
                      <a:pt x="1953" y="326"/>
                    </a:lnTo>
                    <a:lnTo>
                      <a:pt x="1907"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0" name="Google Shape;370;p31"/>
              <p:cNvSpPr/>
              <p:nvPr/>
            </p:nvSpPr>
            <p:spPr>
              <a:xfrm>
                <a:off x="4300000" y="3494550"/>
                <a:ext cx="50000" cy="84875"/>
              </a:xfrm>
              <a:custGeom>
                <a:rect b="b" l="l" r="r" t="t"/>
                <a:pathLst>
                  <a:path extrusionOk="0" fill="none" h="3395" w="2000">
                    <a:moveTo>
                      <a:pt x="884" y="233"/>
                    </a:moveTo>
                    <a:lnTo>
                      <a:pt x="884" y="233"/>
                    </a:lnTo>
                    <a:lnTo>
                      <a:pt x="884" y="698"/>
                    </a:lnTo>
                    <a:lnTo>
                      <a:pt x="884" y="698"/>
                    </a:lnTo>
                    <a:lnTo>
                      <a:pt x="884" y="1070"/>
                    </a:lnTo>
                    <a:lnTo>
                      <a:pt x="837" y="1442"/>
                    </a:lnTo>
                    <a:lnTo>
                      <a:pt x="744" y="1767"/>
                    </a:lnTo>
                    <a:lnTo>
                      <a:pt x="651" y="2139"/>
                    </a:lnTo>
                    <a:lnTo>
                      <a:pt x="512" y="2465"/>
                    </a:lnTo>
                    <a:lnTo>
                      <a:pt x="372" y="2790"/>
                    </a:lnTo>
                    <a:lnTo>
                      <a:pt x="186" y="3069"/>
                    </a:lnTo>
                    <a:lnTo>
                      <a:pt x="0" y="3395"/>
                    </a:lnTo>
                    <a:lnTo>
                      <a:pt x="0" y="3395"/>
                    </a:lnTo>
                    <a:lnTo>
                      <a:pt x="372" y="3209"/>
                    </a:lnTo>
                    <a:lnTo>
                      <a:pt x="698" y="3023"/>
                    </a:lnTo>
                    <a:lnTo>
                      <a:pt x="1023" y="2744"/>
                    </a:lnTo>
                    <a:lnTo>
                      <a:pt x="1302" y="2465"/>
                    </a:lnTo>
                    <a:lnTo>
                      <a:pt x="1302" y="2465"/>
                    </a:lnTo>
                    <a:lnTo>
                      <a:pt x="1488" y="2186"/>
                    </a:lnTo>
                    <a:lnTo>
                      <a:pt x="1674" y="1907"/>
                    </a:lnTo>
                    <a:lnTo>
                      <a:pt x="1814" y="1628"/>
                    </a:lnTo>
                    <a:lnTo>
                      <a:pt x="1907" y="1302"/>
                    </a:lnTo>
                    <a:lnTo>
                      <a:pt x="1953" y="977"/>
                    </a:lnTo>
                    <a:lnTo>
                      <a:pt x="2000" y="651"/>
                    </a:lnTo>
                    <a:lnTo>
                      <a:pt x="1953" y="326"/>
                    </a:lnTo>
                    <a:lnTo>
                      <a:pt x="1907" y="0"/>
                    </a:lnTo>
                    <a:lnTo>
                      <a:pt x="1907" y="0"/>
                    </a:lnTo>
                    <a:lnTo>
                      <a:pt x="1395" y="47"/>
                    </a:lnTo>
                    <a:lnTo>
                      <a:pt x="884" y="233"/>
                    </a:lnTo>
                    <a:lnTo>
                      <a:pt x="884" y="23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1" name="Google Shape;371;p31"/>
              <p:cNvSpPr/>
              <p:nvPr/>
            </p:nvSpPr>
            <p:spPr>
              <a:xfrm>
                <a:off x="4322075" y="3500350"/>
                <a:ext cx="25" cy="25"/>
              </a:xfrm>
              <a:custGeom>
                <a:rect b="b" l="l" r="r" t="t"/>
                <a:pathLst>
                  <a:path extrusionOk="0" fill="none" h="1" w="1">
                    <a:moveTo>
                      <a:pt x="1" y="1"/>
                    </a:moveTo>
                    <a:lnTo>
                      <a:pt x="1"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grpSp>
        <p:nvGrpSpPr>
          <p:cNvPr id="372" name="Google Shape;372;p31"/>
          <p:cNvGrpSpPr/>
          <p:nvPr/>
        </p:nvGrpSpPr>
        <p:grpSpPr>
          <a:xfrm>
            <a:off x="651400" y="2649975"/>
            <a:ext cx="612000" cy="612000"/>
            <a:chOff x="651400" y="2649975"/>
            <a:chExt cx="612000" cy="612000"/>
          </a:xfrm>
        </p:grpSpPr>
        <p:sp>
          <p:nvSpPr>
            <p:cNvPr id="373" name="Google Shape;373;p31"/>
            <p:cNvSpPr/>
            <p:nvPr/>
          </p:nvSpPr>
          <p:spPr>
            <a:xfrm>
              <a:off x="651400" y="2649975"/>
              <a:ext cx="612000" cy="6120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grpSp>
          <p:nvGrpSpPr>
            <p:cNvPr id="374" name="Google Shape;374;p31"/>
            <p:cNvGrpSpPr/>
            <p:nvPr/>
          </p:nvGrpSpPr>
          <p:grpSpPr>
            <a:xfrm>
              <a:off x="786695" y="2767672"/>
              <a:ext cx="302133" cy="376626"/>
              <a:chOff x="7000550" y="1260175"/>
              <a:chExt cx="339475" cy="423175"/>
            </a:xfrm>
          </p:grpSpPr>
          <p:sp>
            <p:nvSpPr>
              <p:cNvPr id="375" name="Google Shape;375;p31"/>
              <p:cNvSpPr/>
              <p:nvPr/>
            </p:nvSpPr>
            <p:spPr>
              <a:xfrm>
                <a:off x="7000550" y="1260175"/>
                <a:ext cx="339475" cy="423175"/>
              </a:xfrm>
              <a:custGeom>
                <a:rect b="b" l="l" r="r" t="t"/>
                <a:pathLst>
                  <a:path extrusionOk="0" h="16927" w="13579">
                    <a:moveTo>
                      <a:pt x="7580" y="2000"/>
                    </a:moveTo>
                    <a:lnTo>
                      <a:pt x="7999" y="2046"/>
                    </a:lnTo>
                    <a:lnTo>
                      <a:pt x="8371" y="2139"/>
                    </a:lnTo>
                    <a:lnTo>
                      <a:pt x="8743" y="2325"/>
                    </a:lnTo>
                    <a:lnTo>
                      <a:pt x="9068" y="2604"/>
                    </a:lnTo>
                    <a:lnTo>
                      <a:pt x="9301" y="2837"/>
                    </a:lnTo>
                    <a:lnTo>
                      <a:pt x="9440" y="3069"/>
                    </a:lnTo>
                    <a:lnTo>
                      <a:pt x="9580" y="3348"/>
                    </a:lnTo>
                    <a:lnTo>
                      <a:pt x="9673" y="3581"/>
                    </a:lnTo>
                    <a:lnTo>
                      <a:pt x="10045" y="3627"/>
                    </a:lnTo>
                    <a:lnTo>
                      <a:pt x="10370" y="3767"/>
                    </a:lnTo>
                    <a:lnTo>
                      <a:pt x="10696" y="3906"/>
                    </a:lnTo>
                    <a:lnTo>
                      <a:pt x="10975" y="4139"/>
                    </a:lnTo>
                    <a:lnTo>
                      <a:pt x="11207" y="4418"/>
                    </a:lnTo>
                    <a:lnTo>
                      <a:pt x="11347" y="4743"/>
                    </a:lnTo>
                    <a:lnTo>
                      <a:pt x="11440" y="5069"/>
                    </a:lnTo>
                    <a:lnTo>
                      <a:pt x="11486" y="5441"/>
                    </a:lnTo>
                    <a:lnTo>
                      <a:pt x="11440" y="5813"/>
                    </a:lnTo>
                    <a:lnTo>
                      <a:pt x="11347" y="6138"/>
                    </a:lnTo>
                    <a:lnTo>
                      <a:pt x="11207" y="6464"/>
                    </a:lnTo>
                    <a:lnTo>
                      <a:pt x="10975" y="6743"/>
                    </a:lnTo>
                    <a:lnTo>
                      <a:pt x="10696" y="6975"/>
                    </a:lnTo>
                    <a:lnTo>
                      <a:pt x="10370" y="7115"/>
                    </a:lnTo>
                    <a:lnTo>
                      <a:pt x="10045" y="7254"/>
                    </a:lnTo>
                    <a:lnTo>
                      <a:pt x="5116" y="7254"/>
                    </a:lnTo>
                    <a:lnTo>
                      <a:pt x="4790" y="7115"/>
                    </a:lnTo>
                    <a:lnTo>
                      <a:pt x="4465" y="6975"/>
                    </a:lnTo>
                    <a:lnTo>
                      <a:pt x="4186" y="6743"/>
                    </a:lnTo>
                    <a:lnTo>
                      <a:pt x="3953" y="6464"/>
                    </a:lnTo>
                    <a:lnTo>
                      <a:pt x="3814" y="6138"/>
                    </a:lnTo>
                    <a:lnTo>
                      <a:pt x="3674" y="5813"/>
                    </a:lnTo>
                    <a:lnTo>
                      <a:pt x="3628" y="5441"/>
                    </a:lnTo>
                    <a:lnTo>
                      <a:pt x="3674" y="5069"/>
                    </a:lnTo>
                    <a:lnTo>
                      <a:pt x="3814" y="4743"/>
                    </a:lnTo>
                    <a:lnTo>
                      <a:pt x="3953" y="4418"/>
                    </a:lnTo>
                    <a:lnTo>
                      <a:pt x="4186" y="4139"/>
                    </a:lnTo>
                    <a:lnTo>
                      <a:pt x="4465" y="3906"/>
                    </a:lnTo>
                    <a:lnTo>
                      <a:pt x="4790" y="3767"/>
                    </a:lnTo>
                    <a:lnTo>
                      <a:pt x="5116" y="3627"/>
                    </a:lnTo>
                    <a:lnTo>
                      <a:pt x="5488" y="3581"/>
                    </a:lnTo>
                    <a:lnTo>
                      <a:pt x="5581" y="3348"/>
                    </a:lnTo>
                    <a:lnTo>
                      <a:pt x="5720" y="3069"/>
                    </a:lnTo>
                    <a:lnTo>
                      <a:pt x="5860" y="2837"/>
                    </a:lnTo>
                    <a:lnTo>
                      <a:pt x="6046" y="2604"/>
                    </a:lnTo>
                    <a:lnTo>
                      <a:pt x="6371" y="2325"/>
                    </a:lnTo>
                    <a:lnTo>
                      <a:pt x="6743" y="2139"/>
                    </a:lnTo>
                    <a:lnTo>
                      <a:pt x="7162" y="2046"/>
                    </a:lnTo>
                    <a:lnTo>
                      <a:pt x="7580" y="2000"/>
                    </a:lnTo>
                    <a:close/>
                    <a:moveTo>
                      <a:pt x="5581" y="8277"/>
                    </a:moveTo>
                    <a:lnTo>
                      <a:pt x="5767" y="8324"/>
                    </a:lnTo>
                    <a:lnTo>
                      <a:pt x="5953" y="8417"/>
                    </a:lnTo>
                    <a:lnTo>
                      <a:pt x="6046" y="8556"/>
                    </a:lnTo>
                    <a:lnTo>
                      <a:pt x="6092" y="8742"/>
                    </a:lnTo>
                    <a:lnTo>
                      <a:pt x="6092" y="9440"/>
                    </a:lnTo>
                    <a:lnTo>
                      <a:pt x="6046" y="9626"/>
                    </a:lnTo>
                    <a:lnTo>
                      <a:pt x="5953" y="9812"/>
                    </a:lnTo>
                    <a:lnTo>
                      <a:pt x="5767" y="9905"/>
                    </a:lnTo>
                    <a:lnTo>
                      <a:pt x="5581" y="9951"/>
                    </a:lnTo>
                    <a:lnTo>
                      <a:pt x="5395" y="9905"/>
                    </a:lnTo>
                    <a:lnTo>
                      <a:pt x="5255" y="9812"/>
                    </a:lnTo>
                    <a:lnTo>
                      <a:pt x="5116" y="9626"/>
                    </a:lnTo>
                    <a:lnTo>
                      <a:pt x="5116" y="9440"/>
                    </a:lnTo>
                    <a:lnTo>
                      <a:pt x="5116" y="8742"/>
                    </a:lnTo>
                    <a:lnTo>
                      <a:pt x="5116" y="8556"/>
                    </a:lnTo>
                    <a:lnTo>
                      <a:pt x="5255" y="8417"/>
                    </a:lnTo>
                    <a:lnTo>
                      <a:pt x="5395" y="8324"/>
                    </a:lnTo>
                    <a:lnTo>
                      <a:pt x="5581" y="8277"/>
                    </a:lnTo>
                    <a:close/>
                    <a:moveTo>
                      <a:pt x="7580" y="8277"/>
                    </a:moveTo>
                    <a:lnTo>
                      <a:pt x="7766" y="8324"/>
                    </a:lnTo>
                    <a:lnTo>
                      <a:pt x="7906" y="8417"/>
                    </a:lnTo>
                    <a:lnTo>
                      <a:pt x="8045" y="8556"/>
                    </a:lnTo>
                    <a:lnTo>
                      <a:pt x="8092" y="8742"/>
                    </a:lnTo>
                    <a:lnTo>
                      <a:pt x="8092" y="9440"/>
                    </a:lnTo>
                    <a:lnTo>
                      <a:pt x="8045" y="9626"/>
                    </a:lnTo>
                    <a:lnTo>
                      <a:pt x="7906" y="9812"/>
                    </a:lnTo>
                    <a:lnTo>
                      <a:pt x="7766" y="9905"/>
                    </a:lnTo>
                    <a:lnTo>
                      <a:pt x="7580" y="9951"/>
                    </a:lnTo>
                    <a:lnTo>
                      <a:pt x="7394" y="9905"/>
                    </a:lnTo>
                    <a:lnTo>
                      <a:pt x="7208" y="9812"/>
                    </a:lnTo>
                    <a:lnTo>
                      <a:pt x="7115" y="9626"/>
                    </a:lnTo>
                    <a:lnTo>
                      <a:pt x="7069" y="9440"/>
                    </a:lnTo>
                    <a:lnTo>
                      <a:pt x="7069" y="8742"/>
                    </a:lnTo>
                    <a:lnTo>
                      <a:pt x="7115" y="8556"/>
                    </a:lnTo>
                    <a:lnTo>
                      <a:pt x="7208" y="8417"/>
                    </a:lnTo>
                    <a:lnTo>
                      <a:pt x="7394" y="8324"/>
                    </a:lnTo>
                    <a:lnTo>
                      <a:pt x="7580" y="8277"/>
                    </a:lnTo>
                    <a:close/>
                    <a:moveTo>
                      <a:pt x="9580" y="8277"/>
                    </a:moveTo>
                    <a:lnTo>
                      <a:pt x="9766" y="8324"/>
                    </a:lnTo>
                    <a:lnTo>
                      <a:pt x="9905" y="8417"/>
                    </a:lnTo>
                    <a:lnTo>
                      <a:pt x="9998" y="8556"/>
                    </a:lnTo>
                    <a:lnTo>
                      <a:pt x="10045" y="8742"/>
                    </a:lnTo>
                    <a:lnTo>
                      <a:pt x="10045" y="9440"/>
                    </a:lnTo>
                    <a:lnTo>
                      <a:pt x="9998" y="9626"/>
                    </a:lnTo>
                    <a:lnTo>
                      <a:pt x="9905" y="9812"/>
                    </a:lnTo>
                    <a:lnTo>
                      <a:pt x="9766" y="9905"/>
                    </a:lnTo>
                    <a:lnTo>
                      <a:pt x="9580" y="9951"/>
                    </a:lnTo>
                    <a:lnTo>
                      <a:pt x="9347" y="9905"/>
                    </a:lnTo>
                    <a:lnTo>
                      <a:pt x="9208" y="9812"/>
                    </a:lnTo>
                    <a:lnTo>
                      <a:pt x="9115" y="9626"/>
                    </a:lnTo>
                    <a:lnTo>
                      <a:pt x="9068" y="9440"/>
                    </a:lnTo>
                    <a:lnTo>
                      <a:pt x="9068" y="8742"/>
                    </a:lnTo>
                    <a:lnTo>
                      <a:pt x="9115" y="8556"/>
                    </a:lnTo>
                    <a:lnTo>
                      <a:pt x="9208" y="8417"/>
                    </a:lnTo>
                    <a:lnTo>
                      <a:pt x="9347" y="8324"/>
                    </a:lnTo>
                    <a:lnTo>
                      <a:pt x="9580" y="8277"/>
                    </a:lnTo>
                    <a:close/>
                    <a:moveTo>
                      <a:pt x="7580" y="0"/>
                    </a:moveTo>
                    <a:lnTo>
                      <a:pt x="6976" y="47"/>
                    </a:lnTo>
                    <a:lnTo>
                      <a:pt x="6371" y="93"/>
                    </a:lnTo>
                    <a:lnTo>
                      <a:pt x="5813" y="279"/>
                    </a:lnTo>
                    <a:lnTo>
                      <a:pt x="5255" y="465"/>
                    </a:lnTo>
                    <a:lnTo>
                      <a:pt x="4744" y="698"/>
                    </a:lnTo>
                    <a:lnTo>
                      <a:pt x="4232" y="1023"/>
                    </a:lnTo>
                    <a:lnTo>
                      <a:pt x="3767" y="1349"/>
                    </a:lnTo>
                    <a:lnTo>
                      <a:pt x="3349" y="1767"/>
                    </a:lnTo>
                    <a:lnTo>
                      <a:pt x="2930" y="2186"/>
                    </a:lnTo>
                    <a:lnTo>
                      <a:pt x="2558" y="2697"/>
                    </a:lnTo>
                    <a:lnTo>
                      <a:pt x="2279" y="3162"/>
                    </a:lnTo>
                    <a:lnTo>
                      <a:pt x="2000" y="3720"/>
                    </a:lnTo>
                    <a:lnTo>
                      <a:pt x="1814" y="4278"/>
                    </a:lnTo>
                    <a:lnTo>
                      <a:pt x="1675" y="4836"/>
                    </a:lnTo>
                    <a:lnTo>
                      <a:pt x="1582" y="5394"/>
                    </a:lnTo>
                    <a:lnTo>
                      <a:pt x="1582" y="5999"/>
                    </a:lnTo>
                    <a:lnTo>
                      <a:pt x="1582" y="7254"/>
                    </a:lnTo>
                    <a:lnTo>
                      <a:pt x="94" y="10044"/>
                    </a:lnTo>
                    <a:lnTo>
                      <a:pt x="47" y="10184"/>
                    </a:lnTo>
                    <a:lnTo>
                      <a:pt x="1" y="10277"/>
                    </a:lnTo>
                    <a:lnTo>
                      <a:pt x="47" y="10416"/>
                    </a:lnTo>
                    <a:lnTo>
                      <a:pt x="94" y="10556"/>
                    </a:lnTo>
                    <a:lnTo>
                      <a:pt x="140" y="10649"/>
                    </a:lnTo>
                    <a:lnTo>
                      <a:pt x="280" y="10695"/>
                    </a:lnTo>
                    <a:lnTo>
                      <a:pt x="373" y="10742"/>
                    </a:lnTo>
                    <a:lnTo>
                      <a:pt x="512" y="10788"/>
                    </a:lnTo>
                    <a:lnTo>
                      <a:pt x="1582" y="10788"/>
                    </a:lnTo>
                    <a:lnTo>
                      <a:pt x="1582" y="11997"/>
                    </a:lnTo>
                    <a:lnTo>
                      <a:pt x="1582" y="12323"/>
                    </a:lnTo>
                    <a:lnTo>
                      <a:pt x="1628" y="12648"/>
                    </a:lnTo>
                    <a:lnTo>
                      <a:pt x="1721" y="12927"/>
                    </a:lnTo>
                    <a:lnTo>
                      <a:pt x="1814" y="13206"/>
                    </a:lnTo>
                    <a:lnTo>
                      <a:pt x="1954" y="13485"/>
                    </a:lnTo>
                    <a:lnTo>
                      <a:pt x="2093" y="13718"/>
                    </a:lnTo>
                    <a:lnTo>
                      <a:pt x="2279" y="13997"/>
                    </a:lnTo>
                    <a:lnTo>
                      <a:pt x="2465" y="14183"/>
                    </a:lnTo>
                    <a:lnTo>
                      <a:pt x="2698" y="14415"/>
                    </a:lnTo>
                    <a:lnTo>
                      <a:pt x="2930" y="14555"/>
                    </a:lnTo>
                    <a:lnTo>
                      <a:pt x="3209" y="14741"/>
                    </a:lnTo>
                    <a:lnTo>
                      <a:pt x="3488" y="14880"/>
                    </a:lnTo>
                    <a:lnTo>
                      <a:pt x="3767" y="14973"/>
                    </a:lnTo>
                    <a:lnTo>
                      <a:pt x="4046" y="15066"/>
                    </a:lnTo>
                    <a:lnTo>
                      <a:pt x="4372" y="15113"/>
                    </a:lnTo>
                    <a:lnTo>
                      <a:pt x="6511" y="15113"/>
                    </a:lnTo>
                    <a:lnTo>
                      <a:pt x="6511" y="16415"/>
                    </a:lnTo>
                    <a:lnTo>
                      <a:pt x="6557" y="16601"/>
                    </a:lnTo>
                    <a:lnTo>
                      <a:pt x="6650" y="16787"/>
                    </a:lnTo>
                    <a:lnTo>
                      <a:pt x="6836" y="16880"/>
                    </a:lnTo>
                    <a:lnTo>
                      <a:pt x="7022" y="16926"/>
                    </a:lnTo>
                    <a:lnTo>
                      <a:pt x="13067" y="16926"/>
                    </a:lnTo>
                    <a:lnTo>
                      <a:pt x="13253" y="16880"/>
                    </a:lnTo>
                    <a:lnTo>
                      <a:pt x="13439" y="16787"/>
                    </a:lnTo>
                    <a:lnTo>
                      <a:pt x="13532" y="16601"/>
                    </a:lnTo>
                    <a:lnTo>
                      <a:pt x="13579" y="16415"/>
                    </a:lnTo>
                    <a:lnTo>
                      <a:pt x="13579" y="5999"/>
                    </a:lnTo>
                    <a:lnTo>
                      <a:pt x="13532" y="5394"/>
                    </a:lnTo>
                    <a:lnTo>
                      <a:pt x="13439" y="4836"/>
                    </a:lnTo>
                    <a:lnTo>
                      <a:pt x="13300" y="4278"/>
                    </a:lnTo>
                    <a:lnTo>
                      <a:pt x="13114" y="3720"/>
                    </a:lnTo>
                    <a:lnTo>
                      <a:pt x="12881" y="3162"/>
                    </a:lnTo>
                    <a:lnTo>
                      <a:pt x="12556" y="2697"/>
                    </a:lnTo>
                    <a:lnTo>
                      <a:pt x="12184" y="2186"/>
                    </a:lnTo>
                    <a:lnTo>
                      <a:pt x="11812" y="1767"/>
                    </a:lnTo>
                    <a:lnTo>
                      <a:pt x="11347" y="1349"/>
                    </a:lnTo>
                    <a:lnTo>
                      <a:pt x="10882" y="1023"/>
                    </a:lnTo>
                    <a:lnTo>
                      <a:pt x="10370" y="698"/>
                    </a:lnTo>
                    <a:lnTo>
                      <a:pt x="9859" y="465"/>
                    </a:lnTo>
                    <a:lnTo>
                      <a:pt x="9301" y="279"/>
                    </a:lnTo>
                    <a:lnTo>
                      <a:pt x="8743" y="93"/>
                    </a:lnTo>
                    <a:lnTo>
                      <a:pt x="8138" y="47"/>
                    </a:lnTo>
                    <a:lnTo>
                      <a:pt x="7580"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6" name="Google Shape;376;p31"/>
              <p:cNvSpPr/>
              <p:nvPr/>
            </p:nvSpPr>
            <p:spPr>
              <a:xfrm>
                <a:off x="7000550" y="1260175"/>
                <a:ext cx="339475" cy="423175"/>
              </a:xfrm>
              <a:custGeom>
                <a:rect b="b" l="l" r="r" t="t"/>
                <a:pathLst>
                  <a:path extrusionOk="0" fill="none" h="16927" w="13579">
                    <a:moveTo>
                      <a:pt x="11812" y="1767"/>
                    </a:moveTo>
                    <a:lnTo>
                      <a:pt x="11812" y="1767"/>
                    </a:lnTo>
                    <a:lnTo>
                      <a:pt x="11347" y="1349"/>
                    </a:lnTo>
                    <a:lnTo>
                      <a:pt x="10882" y="1023"/>
                    </a:lnTo>
                    <a:lnTo>
                      <a:pt x="10370" y="698"/>
                    </a:lnTo>
                    <a:lnTo>
                      <a:pt x="9859" y="465"/>
                    </a:lnTo>
                    <a:lnTo>
                      <a:pt x="9301" y="279"/>
                    </a:lnTo>
                    <a:lnTo>
                      <a:pt x="8743" y="93"/>
                    </a:lnTo>
                    <a:lnTo>
                      <a:pt x="8138" y="47"/>
                    </a:lnTo>
                    <a:lnTo>
                      <a:pt x="7580" y="0"/>
                    </a:lnTo>
                    <a:lnTo>
                      <a:pt x="7580" y="0"/>
                    </a:lnTo>
                    <a:lnTo>
                      <a:pt x="6976" y="47"/>
                    </a:lnTo>
                    <a:lnTo>
                      <a:pt x="6371" y="93"/>
                    </a:lnTo>
                    <a:lnTo>
                      <a:pt x="5813" y="279"/>
                    </a:lnTo>
                    <a:lnTo>
                      <a:pt x="5255" y="465"/>
                    </a:lnTo>
                    <a:lnTo>
                      <a:pt x="4744" y="698"/>
                    </a:lnTo>
                    <a:lnTo>
                      <a:pt x="4232" y="1023"/>
                    </a:lnTo>
                    <a:lnTo>
                      <a:pt x="3767" y="1349"/>
                    </a:lnTo>
                    <a:lnTo>
                      <a:pt x="3349" y="1767"/>
                    </a:lnTo>
                    <a:lnTo>
                      <a:pt x="3349" y="1767"/>
                    </a:lnTo>
                    <a:lnTo>
                      <a:pt x="2930" y="2186"/>
                    </a:lnTo>
                    <a:lnTo>
                      <a:pt x="2558" y="2697"/>
                    </a:lnTo>
                    <a:lnTo>
                      <a:pt x="2279" y="3162"/>
                    </a:lnTo>
                    <a:lnTo>
                      <a:pt x="2000" y="3720"/>
                    </a:lnTo>
                    <a:lnTo>
                      <a:pt x="1814" y="4278"/>
                    </a:lnTo>
                    <a:lnTo>
                      <a:pt x="1675" y="4836"/>
                    </a:lnTo>
                    <a:lnTo>
                      <a:pt x="1582" y="5394"/>
                    </a:lnTo>
                    <a:lnTo>
                      <a:pt x="1582" y="5999"/>
                    </a:lnTo>
                    <a:lnTo>
                      <a:pt x="1582" y="7254"/>
                    </a:lnTo>
                    <a:lnTo>
                      <a:pt x="94" y="10044"/>
                    </a:lnTo>
                    <a:lnTo>
                      <a:pt x="94" y="10044"/>
                    </a:lnTo>
                    <a:lnTo>
                      <a:pt x="47" y="10184"/>
                    </a:lnTo>
                    <a:lnTo>
                      <a:pt x="1" y="10277"/>
                    </a:lnTo>
                    <a:lnTo>
                      <a:pt x="47" y="10416"/>
                    </a:lnTo>
                    <a:lnTo>
                      <a:pt x="94" y="10556"/>
                    </a:lnTo>
                    <a:lnTo>
                      <a:pt x="94" y="10556"/>
                    </a:lnTo>
                    <a:lnTo>
                      <a:pt x="140" y="10649"/>
                    </a:lnTo>
                    <a:lnTo>
                      <a:pt x="280" y="10695"/>
                    </a:lnTo>
                    <a:lnTo>
                      <a:pt x="373" y="10742"/>
                    </a:lnTo>
                    <a:lnTo>
                      <a:pt x="512" y="10788"/>
                    </a:lnTo>
                    <a:lnTo>
                      <a:pt x="1582" y="10788"/>
                    </a:lnTo>
                    <a:lnTo>
                      <a:pt x="1582" y="11997"/>
                    </a:lnTo>
                    <a:lnTo>
                      <a:pt x="1582" y="11997"/>
                    </a:lnTo>
                    <a:lnTo>
                      <a:pt x="1582" y="12323"/>
                    </a:lnTo>
                    <a:lnTo>
                      <a:pt x="1628" y="12648"/>
                    </a:lnTo>
                    <a:lnTo>
                      <a:pt x="1721" y="12927"/>
                    </a:lnTo>
                    <a:lnTo>
                      <a:pt x="1814" y="13206"/>
                    </a:lnTo>
                    <a:lnTo>
                      <a:pt x="1954" y="13485"/>
                    </a:lnTo>
                    <a:lnTo>
                      <a:pt x="2093" y="13718"/>
                    </a:lnTo>
                    <a:lnTo>
                      <a:pt x="2279" y="13997"/>
                    </a:lnTo>
                    <a:lnTo>
                      <a:pt x="2465" y="14183"/>
                    </a:lnTo>
                    <a:lnTo>
                      <a:pt x="2698" y="14415"/>
                    </a:lnTo>
                    <a:lnTo>
                      <a:pt x="2930" y="14555"/>
                    </a:lnTo>
                    <a:lnTo>
                      <a:pt x="3209" y="14741"/>
                    </a:lnTo>
                    <a:lnTo>
                      <a:pt x="3488" y="14880"/>
                    </a:lnTo>
                    <a:lnTo>
                      <a:pt x="3767" y="14973"/>
                    </a:lnTo>
                    <a:lnTo>
                      <a:pt x="4046" y="15066"/>
                    </a:lnTo>
                    <a:lnTo>
                      <a:pt x="4372" y="15113"/>
                    </a:lnTo>
                    <a:lnTo>
                      <a:pt x="4697" y="15113"/>
                    </a:lnTo>
                    <a:lnTo>
                      <a:pt x="6511" y="15113"/>
                    </a:lnTo>
                    <a:lnTo>
                      <a:pt x="6511" y="16415"/>
                    </a:lnTo>
                    <a:lnTo>
                      <a:pt x="6511" y="16415"/>
                    </a:lnTo>
                    <a:lnTo>
                      <a:pt x="6557" y="16601"/>
                    </a:lnTo>
                    <a:lnTo>
                      <a:pt x="6650" y="16787"/>
                    </a:lnTo>
                    <a:lnTo>
                      <a:pt x="6836" y="16880"/>
                    </a:lnTo>
                    <a:lnTo>
                      <a:pt x="7022" y="16926"/>
                    </a:lnTo>
                    <a:lnTo>
                      <a:pt x="13067" y="16926"/>
                    </a:lnTo>
                    <a:lnTo>
                      <a:pt x="13067" y="16926"/>
                    </a:lnTo>
                    <a:lnTo>
                      <a:pt x="13253" y="16880"/>
                    </a:lnTo>
                    <a:lnTo>
                      <a:pt x="13439" y="16787"/>
                    </a:lnTo>
                    <a:lnTo>
                      <a:pt x="13532" y="16601"/>
                    </a:lnTo>
                    <a:lnTo>
                      <a:pt x="13579" y="16415"/>
                    </a:lnTo>
                    <a:lnTo>
                      <a:pt x="13579" y="5999"/>
                    </a:lnTo>
                    <a:lnTo>
                      <a:pt x="13579" y="5999"/>
                    </a:lnTo>
                    <a:lnTo>
                      <a:pt x="13532" y="5394"/>
                    </a:lnTo>
                    <a:lnTo>
                      <a:pt x="13439" y="4836"/>
                    </a:lnTo>
                    <a:lnTo>
                      <a:pt x="13300" y="4278"/>
                    </a:lnTo>
                    <a:lnTo>
                      <a:pt x="13114" y="3720"/>
                    </a:lnTo>
                    <a:lnTo>
                      <a:pt x="12881" y="3162"/>
                    </a:lnTo>
                    <a:lnTo>
                      <a:pt x="12556" y="2697"/>
                    </a:lnTo>
                    <a:lnTo>
                      <a:pt x="12184" y="2186"/>
                    </a:lnTo>
                    <a:lnTo>
                      <a:pt x="11812" y="1767"/>
                    </a:lnTo>
                    <a:lnTo>
                      <a:pt x="11812" y="1767"/>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7" name="Google Shape;377;p31"/>
              <p:cNvSpPr/>
              <p:nvPr/>
            </p:nvSpPr>
            <p:spPr>
              <a:xfrm>
                <a:off x="7128425" y="1467100"/>
                <a:ext cx="24450" cy="41875"/>
              </a:xfrm>
              <a:custGeom>
                <a:rect b="b" l="l" r="r" t="t"/>
                <a:pathLst>
                  <a:path extrusionOk="0" fill="none" h="1675" w="978">
                    <a:moveTo>
                      <a:pt x="977" y="1163"/>
                    </a:moveTo>
                    <a:lnTo>
                      <a:pt x="977" y="1163"/>
                    </a:lnTo>
                    <a:lnTo>
                      <a:pt x="931" y="1349"/>
                    </a:lnTo>
                    <a:lnTo>
                      <a:pt x="838" y="1535"/>
                    </a:lnTo>
                    <a:lnTo>
                      <a:pt x="652" y="1628"/>
                    </a:lnTo>
                    <a:lnTo>
                      <a:pt x="466" y="1674"/>
                    </a:lnTo>
                    <a:lnTo>
                      <a:pt x="466" y="1674"/>
                    </a:lnTo>
                    <a:lnTo>
                      <a:pt x="280" y="1628"/>
                    </a:lnTo>
                    <a:lnTo>
                      <a:pt x="140" y="1535"/>
                    </a:lnTo>
                    <a:lnTo>
                      <a:pt x="1" y="1349"/>
                    </a:lnTo>
                    <a:lnTo>
                      <a:pt x="1" y="1163"/>
                    </a:lnTo>
                    <a:lnTo>
                      <a:pt x="1" y="465"/>
                    </a:lnTo>
                    <a:lnTo>
                      <a:pt x="1" y="465"/>
                    </a:lnTo>
                    <a:lnTo>
                      <a:pt x="1" y="279"/>
                    </a:lnTo>
                    <a:lnTo>
                      <a:pt x="140" y="140"/>
                    </a:lnTo>
                    <a:lnTo>
                      <a:pt x="280" y="47"/>
                    </a:lnTo>
                    <a:lnTo>
                      <a:pt x="466" y="0"/>
                    </a:lnTo>
                    <a:lnTo>
                      <a:pt x="466" y="0"/>
                    </a:lnTo>
                    <a:lnTo>
                      <a:pt x="652" y="47"/>
                    </a:lnTo>
                    <a:lnTo>
                      <a:pt x="838" y="140"/>
                    </a:lnTo>
                    <a:lnTo>
                      <a:pt x="931" y="279"/>
                    </a:lnTo>
                    <a:lnTo>
                      <a:pt x="977" y="465"/>
                    </a:lnTo>
                    <a:lnTo>
                      <a:pt x="977" y="116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8" name="Google Shape;378;p31"/>
              <p:cNvSpPr/>
              <p:nvPr/>
            </p:nvSpPr>
            <p:spPr>
              <a:xfrm>
                <a:off x="7177250" y="1467100"/>
                <a:ext cx="25600" cy="41875"/>
              </a:xfrm>
              <a:custGeom>
                <a:rect b="b" l="l" r="r" t="t"/>
                <a:pathLst>
                  <a:path extrusionOk="0" fill="none" h="1675" w="1024">
                    <a:moveTo>
                      <a:pt x="1024" y="1163"/>
                    </a:moveTo>
                    <a:lnTo>
                      <a:pt x="1024" y="1163"/>
                    </a:lnTo>
                    <a:lnTo>
                      <a:pt x="977" y="1349"/>
                    </a:lnTo>
                    <a:lnTo>
                      <a:pt x="838" y="1535"/>
                    </a:lnTo>
                    <a:lnTo>
                      <a:pt x="698" y="1628"/>
                    </a:lnTo>
                    <a:lnTo>
                      <a:pt x="512" y="1674"/>
                    </a:lnTo>
                    <a:lnTo>
                      <a:pt x="512" y="1674"/>
                    </a:lnTo>
                    <a:lnTo>
                      <a:pt x="326" y="1628"/>
                    </a:lnTo>
                    <a:lnTo>
                      <a:pt x="140" y="1535"/>
                    </a:lnTo>
                    <a:lnTo>
                      <a:pt x="47" y="1349"/>
                    </a:lnTo>
                    <a:lnTo>
                      <a:pt x="1" y="1163"/>
                    </a:lnTo>
                    <a:lnTo>
                      <a:pt x="1" y="465"/>
                    </a:lnTo>
                    <a:lnTo>
                      <a:pt x="1" y="465"/>
                    </a:lnTo>
                    <a:lnTo>
                      <a:pt x="47" y="279"/>
                    </a:lnTo>
                    <a:lnTo>
                      <a:pt x="140" y="140"/>
                    </a:lnTo>
                    <a:lnTo>
                      <a:pt x="326" y="47"/>
                    </a:lnTo>
                    <a:lnTo>
                      <a:pt x="512" y="0"/>
                    </a:lnTo>
                    <a:lnTo>
                      <a:pt x="512" y="0"/>
                    </a:lnTo>
                    <a:lnTo>
                      <a:pt x="698" y="47"/>
                    </a:lnTo>
                    <a:lnTo>
                      <a:pt x="838" y="140"/>
                    </a:lnTo>
                    <a:lnTo>
                      <a:pt x="977" y="279"/>
                    </a:lnTo>
                    <a:lnTo>
                      <a:pt x="1024" y="465"/>
                    </a:lnTo>
                    <a:lnTo>
                      <a:pt x="1024" y="116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9" name="Google Shape;379;p31"/>
              <p:cNvSpPr/>
              <p:nvPr/>
            </p:nvSpPr>
            <p:spPr>
              <a:xfrm>
                <a:off x="7227250" y="1467100"/>
                <a:ext cx="24425" cy="41875"/>
              </a:xfrm>
              <a:custGeom>
                <a:rect b="b" l="l" r="r" t="t"/>
                <a:pathLst>
                  <a:path extrusionOk="0" fill="none" h="1675" w="977">
                    <a:moveTo>
                      <a:pt x="977" y="1163"/>
                    </a:moveTo>
                    <a:lnTo>
                      <a:pt x="977" y="1163"/>
                    </a:lnTo>
                    <a:lnTo>
                      <a:pt x="930" y="1349"/>
                    </a:lnTo>
                    <a:lnTo>
                      <a:pt x="837" y="1535"/>
                    </a:lnTo>
                    <a:lnTo>
                      <a:pt x="698" y="1628"/>
                    </a:lnTo>
                    <a:lnTo>
                      <a:pt x="512" y="1674"/>
                    </a:lnTo>
                    <a:lnTo>
                      <a:pt x="512" y="1674"/>
                    </a:lnTo>
                    <a:lnTo>
                      <a:pt x="279" y="1628"/>
                    </a:lnTo>
                    <a:lnTo>
                      <a:pt x="140" y="1535"/>
                    </a:lnTo>
                    <a:lnTo>
                      <a:pt x="47" y="1349"/>
                    </a:lnTo>
                    <a:lnTo>
                      <a:pt x="0" y="1163"/>
                    </a:lnTo>
                    <a:lnTo>
                      <a:pt x="0" y="465"/>
                    </a:lnTo>
                    <a:lnTo>
                      <a:pt x="0" y="465"/>
                    </a:lnTo>
                    <a:lnTo>
                      <a:pt x="47" y="279"/>
                    </a:lnTo>
                    <a:lnTo>
                      <a:pt x="140" y="140"/>
                    </a:lnTo>
                    <a:lnTo>
                      <a:pt x="279" y="47"/>
                    </a:lnTo>
                    <a:lnTo>
                      <a:pt x="512" y="0"/>
                    </a:lnTo>
                    <a:lnTo>
                      <a:pt x="512" y="0"/>
                    </a:lnTo>
                    <a:lnTo>
                      <a:pt x="698" y="47"/>
                    </a:lnTo>
                    <a:lnTo>
                      <a:pt x="837" y="140"/>
                    </a:lnTo>
                    <a:lnTo>
                      <a:pt x="930" y="279"/>
                    </a:lnTo>
                    <a:lnTo>
                      <a:pt x="977" y="465"/>
                    </a:lnTo>
                    <a:lnTo>
                      <a:pt x="977" y="116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0" name="Google Shape;380;p31"/>
              <p:cNvSpPr/>
              <p:nvPr/>
            </p:nvSpPr>
            <p:spPr>
              <a:xfrm>
                <a:off x="7091225" y="1310150"/>
                <a:ext cx="196500" cy="131400"/>
              </a:xfrm>
              <a:custGeom>
                <a:rect b="b" l="l" r="r" t="t"/>
                <a:pathLst>
                  <a:path extrusionOk="0" fill="none" h="5256" w="7860">
                    <a:moveTo>
                      <a:pt x="6046" y="5255"/>
                    </a:moveTo>
                    <a:lnTo>
                      <a:pt x="1861" y="5255"/>
                    </a:lnTo>
                    <a:lnTo>
                      <a:pt x="1861" y="5255"/>
                    </a:lnTo>
                    <a:lnTo>
                      <a:pt x="1489" y="5255"/>
                    </a:lnTo>
                    <a:lnTo>
                      <a:pt x="1163" y="5116"/>
                    </a:lnTo>
                    <a:lnTo>
                      <a:pt x="838" y="4976"/>
                    </a:lnTo>
                    <a:lnTo>
                      <a:pt x="559" y="4744"/>
                    </a:lnTo>
                    <a:lnTo>
                      <a:pt x="326" y="4465"/>
                    </a:lnTo>
                    <a:lnTo>
                      <a:pt x="187" y="4139"/>
                    </a:lnTo>
                    <a:lnTo>
                      <a:pt x="47" y="3814"/>
                    </a:lnTo>
                    <a:lnTo>
                      <a:pt x="1" y="3442"/>
                    </a:lnTo>
                    <a:lnTo>
                      <a:pt x="1" y="3442"/>
                    </a:lnTo>
                    <a:lnTo>
                      <a:pt x="47" y="3070"/>
                    </a:lnTo>
                    <a:lnTo>
                      <a:pt x="187" y="2744"/>
                    </a:lnTo>
                    <a:lnTo>
                      <a:pt x="326" y="2419"/>
                    </a:lnTo>
                    <a:lnTo>
                      <a:pt x="559" y="2140"/>
                    </a:lnTo>
                    <a:lnTo>
                      <a:pt x="838" y="1907"/>
                    </a:lnTo>
                    <a:lnTo>
                      <a:pt x="1163" y="1768"/>
                    </a:lnTo>
                    <a:lnTo>
                      <a:pt x="1489" y="1628"/>
                    </a:lnTo>
                    <a:lnTo>
                      <a:pt x="1861" y="1582"/>
                    </a:lnTo>
                    <a:lnTo>
                      <a:pt x="1861" y="1582"/>
                    </a:lnTo>
                    <a:lnTo>
                      <a:pt x="1861" y="1582"/>
                    </a:lnTo>
                    <a:lnTo>
                      <a:pt x="1954" y="1349"/>
                    </a:lnTo>
                    <a:lnTo>
                      <a:pt x="2093" y="1070"/>
                    </a:lnTo>
                    <a:lnTo>
                      <a:pt x="2233" y="838"/>
                    </a:lnTo>
                    <a:lnTo>
                      <a:pt x="2419" y="605"/>
                    </a:lnTo>
                    <a:lnTo>
                      <a:pt x="2419" y="605"/>
                    </a:lnTo>
                    <a:lnTo>
                      <a:pt x="2744" y="326"/>
                    </a:lnTo>
                    <a:lnTo>
                      <a:pt x="3116" y="140"/>
                    </a:lnTo>
                    <a:lnTo>
                      <a:pt x="3535" y="47"/>
                    </a:lnTo>
                    <a:lnTo>
                      <a:pt x="3953" y="1"/>
                    </a:lnTo>
                    <a:lnTo>
                      <a:pt x="3953" y="1"/>
                    </a:lnTo>
                    <a:lnTo>
                      <a:pt x="4372" y="47"/>
                    </a:lnTo>
                    <a:lnTo>
                      <a:pt x="4744" y="140"/>
                    </a:lnTo>
                    <a:lnTo>
                      <a:pt x="5116" y="326"/>
                    </a:lnTo>
                    <a:lnTo>
                      <a:pt x="5441" y="605"/>
                    </a:lnTo>
                    <a:lnTo>
                      <a:pt x="5441" y="605"/>
                    </a:lnTo>
                    <a:lnTo>
                      <a:pt x="5674" y="838"/>
                    </a:lnTo>
                    <a:lnTo>
                      <a:pt x="5813" y="1070"/>
                    </a:lnTo>
                    <a:lnTo>
                      <a:pt x="5953" y="1349"/>
                    </a:lnTo>
                    <a:lnTo>
                      <a:pt x="6046" y="1582"/>
                    </a:lnTo>
                    <a:lnTo>
                      <a:pt x="6046" y="1582"/>
                    </a:lnTo>
                    <a:lnTo>
                      <a:pt x="6046" y="1582"/>
                    </a:lnTo>
                    <a:lnTo>
                      <a:pt x="6418" y="1628"/>
                    </a:lnTo>
                    <a:lnTo>
                      <a:pt x="6743" y="1768"/>
                    </a:lnTo>
                    <a:lnTo>
                      <a:pt x="7069" y="1907"/>
                    </a:lnTo>
                    <a:lnTo>
                      <a:pt x="7348" y="2140"/>
                    </a:lnTo>
                    <a:lnTo>
                      <a:pt x="7580" y="2419"/>
                    </a:lnTo>
                    <a:lnTo>
                      <a:pt x="7720" y="2744"/>
                    </a:lnTo>
                    <a:lnTo>
                      <a:pt x="7813" y="3070"/>
                    </a:lnTo>
                    <a:lnTo>
                      <a:pt x="7859" y="3442"/>
                    </a:lnTo>
                    <a:lnTo>
                      <a:pt x="7859" y="3442"/>
                    </a:lnTo>
                    <a:lnTo>
                      <a:pt x="7813" y="3814"/>
                    </a:lnTo>
                    <a:lnTo>
                      <a:pt x="7720" y="4139"/>
                    </a:lnTo>
                    <a:lnTo>
                      <a:pt x="7580" y="4465"/>
                    </a:lnTo>
                    <a:lnTo>
                      <a:pt x="7348" y="4744"/>
                    </a:lnTo>
                    <a:lnTo>
                      <a:pt x="7069" y="4976"/>
                    </a:lnTo>
                    <a:lnTo>
                      <a:pt x="6743" y="5116"/>
                    </a:lnTo>
                    <a:lnTo>
                      <a:pt x="6418" y="5255"/>
                    </a:lnTo>
                    <a:lnTo>
                      <a:pt x="6046" y="5255"/>
                    </a:lnTo>
                    <a:lnTo>
                      <a:pt x="6046" y="5255"/>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1" name="Google Shape;381;p31"/>
              <p:cNvSpPr/>
              <p:nvPr/>
            </p:nvSpPr>
            <p:spPr>
              <a:xfrm>
                <a:off x="7242350" y="1441525"/>
                <a:ext cx="25" cy="25"/>
              </a:xfrm>
              <a:custGeom>
                <a:rect b="b" l="l" r="r" t="t"/>
                <a:pathLst>
                  <a:path extrusionOk="0" fill="none" h="1" w="1">
                    <a:moveTo>
                      <a:pt x="1" y="0"/>
                    </a:moveTo>
                    <a:lnTo>
                      <a:pt x="1"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2" name="Google Shape;382;p31"/>
              <p:cNvSpPr/>
              <p:nvPr/>
            </p:nvSpPr>
            <p:spPr>
              <a:xfrm>
                <a:off x="7116800" y="1334575"/>
                <a:ext cx="146500" cy="82550"/>
              </a:xfrm>
              <a:custGeom>
                <a:rect b="b" l="l" r="r" t="t"/>
                <a:pathLst>
                  <a:path extrusionOk="0" h="3302" w="5860">
                    <a:moveTo>
                      <a:pt x="2930" y="0"/>
                    </a:moveTo>
                    <a:lnTo>
                      <a:pt x="2698" y="47"/>
                    </a:lnTo>
                    <a:lnTo>
                      <a:pt x="2465" y="93"/>
                    </a:lnTo>
                    <a:lnTo>
                      <a:pt x="2279" y="186"/>
                    </a:lnTo>
                    <a:lnTo>
                      <a:pt x="2093" y="326"/>
                    </a:lnTo>
                    <a:lnTo>
                      <a:pt x="1954" y="512"/>
                    </a:lnTo>
                    <a:lnTo>
                      <a:pt x="1861" y="698"/>
                    </a:lnTo>
                    <a:lnTo>
                      <a:pt x="1768" y="930"/>
                    </a:lnTo>
                    <a:lnTo>
                      <a:pt x="1768" y="1116"/>
                    </a:lnTo>
                    <a:lnTo>
                      <a:pt x="1721" y="1302"/>
                    </a:lnTo>
                    <a:lnTo>
                      <a:pt x="1628" y="1488"/>
                    </a:lnTo>
                    <a:lnTo>
                      <a:pt x="1442" y="1581"/>
                    </a:lnTo>
                    <a:lnTo>
                      <a:pt x="1256" y="1628"/>
                    </a:lnTo>
                    <a:lnTo>
                      <a:pt x="652" y="1628"/>
                    </a:lnTo>
                    <a:lnTo>
                      <a:pt x="512" y="1674"/>
                    </a:lnTo>
                    <a:lnTo>
                      <a:pt x="373" y="1767"/>
                    </a:lnTo>
                    <a:lnTo>
                      <a:pt x="233" y="1860"/>
                    </a:lnTo>
                    <a:lnTo>
                      <a:pt x="140" y="2000"/>
                    </a:lnTo>
                    <a:lnTo>
                      <a:pt x="47" y="2139"/>
                    </a:lnTo>
                    <a:lnTo>
                      <a:pt x="1" y="2279"/>
                    </a:lnTo>
                    <a:lnTo>
                      <a:pt x="1" y="2465"/>
                    </a:lnTo>
                    <a:lnTo>
                      <a:pt x="1" y="2651"/>
                    </a:lnTo>
                    <a:lnTo>
                      <a:pt x="47" y="2790"/>
                    </a:lnTo>
                    <a:lnTo>
                      <a:pt x="140" y="2930"/>
                    </a:lnTo>
                    <a:lnTo>
                      <a:pt x="233" y="3069"/>
                    </a:lnTo>
                    <a:lnTo>
                      <a:pt x="373" y="3162"/>
                    </a:lnTo>
                    <a:lnTo>
                      <a:pt x="512" y="3255"/>
                    </a:lnTo>
                    <a:lnTo>
                      <a:pt x="652" y="3302"/>
                    </a:lnTo>
                    <a:lnTo>
                      <a:pt x="5162" y="3302"/>
                    </a:lnTo>
                    <a:lnTo>
                      <a:pt x="5348" y="3255"/>
                    </a:lnTo>
                    <a:lnTo>
                      <a:pt x="5488" y="3162"/>
                    </a:lnTo>
                    <a:lnTo>
                      <a:pt x="5627" y="3069"/>
                    </a:lnTo>
                    <a:lnTo>
                      <a:pt x="5720" y="2930"/>
                    </a:lnTo>
                    <a:lnTo>
                      <a:pt x="5813" y="2790"/>
                    </a:lnTo>
                    <a:lnTo>
                      <a:pt x="5860" y="2651"/>
                    </a:lnTo>
                    <a:lnTo>
                      <a:pt x="5860" y="2465"/>
                    </a:lnTo>
                    <a:lnTo>
                      <a:pt x="5860" y="2279"/>
                    </a:lnTo>
                    <a:lnTo>
                      <a:pt x="5813" y="2139"/>
                    </a:lnTo>
                    <a:lnTo>
                      <a:pt x="5720" y="2000"/>
                    </a:lnTo>
                    <a:lnTo>
                      <a:pt x="5627" y="1860"/>
                    </a:lnTo>
                    <a:lnTo>
                      <a:pt x="5488" y="1767"/>
                    </a:lnTo>
                    <a:lnTo>
                      <a:pt x="5348" y="1674"/>
                    </a:lnTo>
                    <a:lnTo>
                      <a:pt x="5162" y="1628"/>
                    </a:lnTo>
                    <a:lnTo>
                      <a:pt x="4604" y="1628"/>
                    </a:lnTo>
                    <a:lnTo>
                      <a:pt x="4372" y="1581"/>
                    </a:lnTo>
                    <a:lnTo>
                      <a:pt x="4232" y="1488"/>
                    </a:lnTo>
                    <a:lnTo>
                      <a:pt x="4139" y="1302"/>
                    </a:lnTo>
                    <a:lnTo>
                      <a:pt x="4093" y="1116"/>
                    </a:lnTo>
                    <a:lnTo>
                      <a:pt x="4046" y="930"/>
                    </a:lnTo>
                    <a:lnTo>
                      <a:pt x="4000" y="698"/>
                    </a:lnTo>
                    <a:lnTo>
                      <a:pt x="3860" y="512"/>
                    </a:lnTo>
                    <a:lnTo>
                      <a:pt x="3721" y="326"/>
                    </a:lnTo>
                    <a:lnTo>
                      <a:pt x="3581" y="186"/>
                    </a:lnTo>
                    <a:lnTo>
                      <a:pt x="3349" y="93"/>
                    </a:lnTo>
                    <a:lnTo>
                      <a:pt x="3163" y="47"/>
                    </a:lnTo>
                    <a:lnTo>
                      <a:pt x="2930"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3" name="Google Shape;383;p31"/>
              <p:cNvSpPr/>
              <p:nvPr/>
            </p:nvSpPr>
            <p:spPr>
              <a:xfrm>
                <a:off x="7116800" y="1334575"/>
                <a:ext cx="146500" cy="82550"/>
              </a:xfrm>
              <a:custGeom>
                <a:rect b="b" l="l" r="r" t="t"/>
                <a:pathLst>
                  <a:path extrusionOk="0" fill="none" h="3302" w="5860">
                    <a:moveTo>
                      <a:pt x="5023" y="1628"/>
                    </a:moveTo>
                    <a:lnTo>
                      <a:pt x="4604" y="1628"/>
                    </a:lnTo>
                    <a:lnTo>
                      <a:pt x="4604" y="1628"/>
                    </a:lnTo>
                    <a:lnTo>
                      <a:pt x="4372" y="1581"/>
                    </a:lnTo>
                    <a:lnTo>
                      <a:pt x="4232" y="1488"/>
                    </a:lnTo>
                    <a:lnTo>
                      <a:pt x="4139" y="1302"/>
                    </a:lnTo>
                    <a:lnTo>
                      <a:pt x="4093" y="1116"/>
                    </a:lnTo>
                    <a:lnTo>
                      <a:pt x="4093" y="1116"/>
                    </a:lnTo>
                    <a:lnTo>
                      <a:pt x="4046" y="930"/>
                    </a:lnTo>
                    <a:lnTo>
                      <a:pt x="4000" y="698"/>
                    </a:lnTo>
                    <a:lnTo>
                      <a:pt x="3860" y="512"/>
                    </a:lnTo>
                    <a:lnTo>
                      <a:pt x="3721" y="326"/>
                    </a:lnTo>
                    <a:lnTo>
                      <a:pt x="3581" y="186"/>
                    </a:lnTo>
                    <a:lnTo>
                      <a:pt x="3349" y="93"/>
                    </a:lnTo>
                    <a:lnTo>
                      <a:pt x="3163" y="47"/>
                    </a:lnTo>
                    <a:lnTo>
                      <a:pt x="2930" y="0"/>
                    </a:lnTo>
                    <a:lnTo>
                      <a:pt x="2930" y="0"/>
                    </a:lnTo>
                    <a:lnTo>
                      <a:pt x="2698" y="47"/>
                    </a:lnTo>
                    <a:lnTo>
                      <a:pt x="2465" y="93"/>
                    </a:lnTo>
                    <a:lnTo>
                      <a:pt x="2279" y="186"/>
                    </a:lnTo>
                    <a:lnTo>
                      <a:pt x="2093" y="326"/>
                    </a:lnTo>
                    <a:lnTo>
                      <a:pt x="1954" y="512"/>
                    </a:lnTo>
                    <a:lnTo>
                      <a:pt x="1861" y="698"/>
                    </a:lnTo>
                    <a:lnTo>
                      <a:pt x="1768" y="930"/>
                    </a:lnTo>
                    <a:lnTo>
                      <a:pt x="1768" y="1116"/>
                    </a:lnTo>
                    <a:lnTo>
                      <a:pt x="1768" y="1116"/>
                    </a:lnTo>
                    <a:lnTo>
                      <a:pt x="1721" y="1302"/>
                    </a:lnTo>
                    <a:lnTo>
                      <a:pt x="1628" y="1488"/>
                    </a:lnTo>
                    <a:lnTo>
                      <a:pt x="1442" y="1581"/>
                    </a:lnTo>
                    <a:lnTo>
                      <a:pt x="1256" y="1628"/>
                    </a:lnTo>
                    <a:lnTo>
                      <a:pt x="838" y="1628"/>
                    </a:lnTo>
                    <a:lnTo>
                      <a:pt x="838" y="1628"/>
                    </a:lnTo>
                    <a:lnTo>
                      <a:pt x="652" y="1628"/>
                    </a:lnTo>
                    <a:lnTo>
                      <a:pt x="512" y="1674"/>
                    </a:lnTo>
                    <a:lnTo>
                      <a:pt x="373" y="1767"/>
                    </a:lnTo>
                    <a:lnTo>
                      <a:pt x="233" y="1860"/>
                    </a:lnTo>
                    <a:lnTo>
                      <a:pt x="140" y="2000"/>
                    </a:lnTo>
                    <a:lnTo>
                      <a:pt x="47" y="2139"/>
                    </a:lnTo>
                    <a:lnTo>
                      <a:pt x="1" y="2279"/>
                    </a:lnTo>
                    <a:lnTo>
                      <a:pt x="1" y="2465"/>
                    </a:lnTo>
                    <a:lnTo>
                      <a:pt x="1" y="2465"/>
                    </a:lnTo>
                    <a:lnTo>
                      <a:pt x="1" y="2651"/>
                    </a:lnTo>
                    <a:lnTo>
                      <a:pt x="47" y="2790"/>
                    </a:lnTo>
                    <a:lnTo>
                      <a:pt x="140" y="2930"/>
                    </a:lnTo>
                    <a:lnTo>
                      <a:pt x="233" y="3069"/>
                    </a:lnTo>
                    <a:lnTo>
                      <a:pt x="373" y="3162"/>
                    </a:lnTo>
                    <a:lnTo>
                      <a:pt x="512" y="3255"/>
                    </a:lnTo>
                    <a:lnTo>
                      <a:pt x="652" y="3302"/>
                    </a:lnTo>
                    <a:lnTo>
                      <a:pt x="838" y="3302"/>
                    </a:lnTo>
                    <a:lnTo>
                      <a:pt x="5023" y="3302"/>
                    </a:lnTo>
                    <a:lnTo>
                      <a:pt x="5023" y="3302"/>
                    </a:lnTo>
                    <a:lnTo>
                      <a:pt x="5162" y="3302"/>
                    </a:lnTo>
                    <a:lnTo>
                      <a:pt x="5348" y="3255"/>
                    </a:lnTo>
                    <a:lnTo>
                      <a:pt x="5488" y="3162"/>
                    </a:lnTo>
                    <a:lnTo>
                      <a:pt x="5627" y="3069"/>
                    </a:lnTo>
                    <a:lnTo>
                      <a:pt x="5720" y="2930"/>
                    </a:lnTo>
                    <a:lnTo>
                      <a:pt x="5813" y="2790"/>
                    </a:lnTo>
                    <a:lnTo>
                      <a:pt x="5860" y="2651"/>
                    </a:lnTo>
                    <a:lnTo>
                      <a:pt x="5860" y="2465"/>
                    </a:lnTo>
                    <a:lnTo>
                      <a:pt x="5860" y="2465"/>
                    </a:lnTo>
                    <a:lnTo>
                      <a:pt x="5860" y="2279"/>
                    </a:lnTo>
                    <a:lnTo>
                      <a:pt x="5813" y="2139"/>
                    </a:lnTo>
                    <a:lnTo>
                      <a:pt x="5720" y="2000"/>
                    </a:lnTo>
                    <a:lnTo>
                      <a:pt x="5627" y="1860"/>
                    </a:lnTo>
                    <a:lnTo>
                      <a:pt x="5488" y="1767"/>
                    </a:lnTo>
                    <a:lnTo>
                      <a:pt x="5348" y="1674"/>
                    </a:lnTo>
                    <a:lnTo>
                      <a:pt x="5162" y="1628"/>
                    </a:lnTo>
                    <a:lnTo>
                      <a:pt x="5023" y="1628"/>
                    </a:lnTo>
                    <a:lnTo>
                      <a:pt x="5023" y="1628"/>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4" name="Google Shape;384;p31"/>
              <p:cNvSpPr/>
              <p:nvPr/>
            </p:nvSpPr>
            <p:spPr>
              <a:xfrm>
                <a:off x="7242350" y="1375250"/>
                <a:ext cx="25" cy="25"/>
              </a:xfrm>
              <a:custGeom>
                <a:rect b="b" l="l" r="r" t="t"/>
                <a:pathLst>
                  <a:path extrusionOk="0" fill="none" h="1" w="1">
                    <a:moveTo>
                      <a:pt x="1" y="1"/>
                    </a:moveTo>
                    <a:lnTo>
                      <a:pt x="1"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grpSp>
        <p:nvGrpSpPr>
          <p:cNvPr id="385" name="Google Shape;385;p31"/>
          <p:cNvGrpSpPr/>
          <p:nvPr/>
        </p:nvGrpSpPr>
        <p:grpSpPr>
          <a:xfrm>
            <a:off x="651400" y="3674565"/>
            <a:ext cx="612000" cy="612000"/>
            <a:chOff x="651400" y="3723925"/>
            <a:chExt cx="612000" cy="612000"/>
          </a:xfrm>
        </p:grpSpPr>
        <p:sp>
          <p:nvSpPr>
            <p:cNvPr id="386" name="Google Shape;386;p31"/>
            <p:cNvSpPr/>
            <p:nvPr/>
          </p:nvSpPr>
          <p:spPr>
            <a:xfrm>
              <a:off x="651400" y="3723925"/>
              <a:ext cx="612000" cy="6120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grpSp>
          <p:nvGrpSpPr>
            <p:cNvPr id="387" name="Google Shape;387;p31"/>
            <p:cNvGrpSpPr/>
            <p:nvPr/>
          </p:nvGrpSpPr>
          <p:grpSpPr>
            <a:xfrm>
              <a:off x="786703" y="3841622"/>
              <a:ext cx="302133" cy="376626"/>
              <a:chOff x="4801050" y="1260175"/>
              <a:chExt cx="339475" cy="423175"/>
            </a:xfrm>
          </p:grpSpPr>
          <p:sp>
            <p:nvSpPr>
              <p:cNvPr id="388" name="Google Shape;388;p31"/>
              <p:cNvSpPr/>
              <p:nvPr/>
            </p:nvSpPr>
            <p:spPr>
              <a:xfrm>
                <a:off x="4916125" y="1333400"/>
                <a:ext cx="147675" cy="82575"/>
              </a:xfrm>
              <a:custGeom>
                <a:rect b="b" l="l" r="r" t="t"/>
                <a:pathLst>
                  <a:path extrusionOk="0" h="3303" w="5907">
                    <a:moveTo>
                      <a:pt x="2744" y="1"/>
                    </a:moveTo>
                    <a:lnTo>
                      <a:pt x="2512" y="47"/>
                    </a:lnTo>
                    <a:lnTo>
                      <a:pt x="2326" y="187"/>
                    </a:lnTo>
                    <a:lnTo>
                      <a:pt x="2140" y="326"/>
                    </a:lnTo>
                    <a:lnTo>
                      <a:pt x="2000" y="466"/>
                    </a:lnTo>
                    <a:lnTo>
                      <a:pt x="1907" y="652"/>
                    </a:lnTo>
                    <a:lnTo>
                      <a:pt x="1814" y="884"/>
                    </a:lnTo>
                    <a:lnTo>
                      <a:pt x="1768" y="1117"/>
                    </a:lnTo>
                    <a:lnTo>
                      <a:pt x="1768" y="1303"/>
                    </a:lnTo>
                    <a:lnTo>
                      <a:pt x="1628" y="1442"/>
                    </a:lnTo>
                    <a:lnTo>
                      <a:pt x="1489" y="1582"/>
                    </a:lnTo>
                    <a:lnTo>
                      <a:pt x="884" y="1582"/>
                    </a:lnTo>
                    <a:lnTo>
                      <a:pt x="698" y="1628"/>
                    </a:lnTo>
                    <a:lnTo>
                      <a:pt x="559" y="1675"/>
                    </a:lnTo>
                    <a:lnTo>
                      <a:pt x="373" y="1721"/>
                    </a:lnTo>
                    <a:lnTo>
                      <a:pt x="280" y="1861"/>
                    </a:lnTo>
                    <a:lnTo>
                      <a:pt x="187" y="1954"/>
                    </a:lnTo>
                    <a:lnTo>
                      <a:pt x="94" y="2093"/>
                    </a:lnTo>
                    <a:lnTo>
                      <a:pt x="47" y="2279"/>
                    </a:lnTo>
                    <a:lnTo>
                      <a:pt x="1" y="2419"/>
                    </a:lnTo>
                    <a:lnTo>
                      <a:pt x="47" y="2605"/>
                    </a:lnTo>
                    <a:lnTo>
                      <a:pt x="94" y="2791"/>
                    </a:lnTo>
                    <a:lnTo>
                      <a:pt x="187" y="2930"/>
                    </a:lnTo>
                    <a:lnTo>
                      <a:pt x="280" y="3023"/>
                    </a:lnTo>
                    <a:lnTo>
                      <a:pt x="373" y="3116"/>
                    </a:lnTo>
                    <a:lnTo>
                      <a:pt x="559" y="3209"/>
                    </a:lnTo>
                    <a:lnTo>
                      <a:pt x="698" y="3256"/>
                    </a:lnTo>
                    <a:lnTo>
                      <a:pt x="884" y="3302"/>
                    </a:lnTo>
                    <a:lnTo>
                      <a:pt x="5023" y="3302"/>
                    </a:lnTo>
                    <a:lnTo>
                      <a:pt x="5209" y="3256"/>
                    </a:lnTo>
                    <a:lnTo>
                      <a:pt x="5395" y="3209"/>
                    </a:lnTo>
                    <a:lnTo>
                      <a:pt x="5535" y="3116"/>
                    </a:lnTo>
                    <a:lnTo>
                      <a:pt x="5628" y="3023"/>
                    </a:lnTo>
                    <a:lnTo>
                      <a:pt x="5767" y="2930"/>
                    </a:lnTo>
                    <a:lnTo>
                      <a:pt x="5814" y="2791"/>
                    </a:lnTo>
                    <a:lnTo>
                      <a:pt x="5860" y="2605"/>
                    </a:lnTo>
                    <a:lnTo>
                      <a:pt x="5907" y="2419"/>
                    </a:lnTo>
                    <a:lnTo>
                      <a:pt x="5860" y="2279"/>
                    </a:lnTo>
                    <a:lnTo>
                      <a:pt x="5814" y="2093"/>
                    </a:lnTo>
                    <a:lnTo>
                      <a:pt x="5767" y="1954"/>
                    </a:lnTo>
                    <a:lnTo>
                      <a:pt x="5628" y="1861"/>
                    </a:lnTo>
                    <a:lnTo>
                      <a:pt x="5535" y="1721"/>
                    </a:lnTo>
                    <a:lnTo>
                      <a:pt x="5395" y="1675"/>
                    </a:lnTo>
                    <a:lnTo>
                      <a:pt x="5209" y="1628"/>
                    </a:lnTo>
                    <a:lnTo>
                      <a:pt x="5023" y="1582"/>
                    </a:lnTo>
                    <a:lnTo>
                      <a:pt x="4419" y="1582"/>
                    </a:lnTo>
                    <a:lnTo>
                      <a:pt x="4279" y="1442"/>
                    </a:lnTo>
                    <a:lnTo>
                      <a:pt x="4140" y="1303"/>
                    </a:lnTo>
                    <a:lnTo>
                      <a:pt x="4140" y="1117"/>
                    </a:lnTo>
                    <a:lnTo>
                      <a:pt x="4093" y="884"/>
                    </a:lnTo>
                    <a:lnTo>
                      <a:pt x="4000" y="652"/>
                    </a:lnTo>
                    <a:lnTo>
                      <a:pt x="3907" y="466"/>
                    </a:lnTo>
                    <a:lnTo>
                      <a:pt x="3768" y="326"/>
                    </a:lnTo>
                    <a:lnTo>
                      <a:pt x="3582" y="187"/>
                    </a:lnTo>
                    <a:lnTo>
                      <a:pt x="3396" y="47"/>
                    </a:lnTo>
                    <a:lnTo>
                      <a:pt x="3163"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89" name="Google Shape;389;p31"/>
              <p:cNvSpPr/>
              <p:nvPr/>
            </p:nvSpPr>
            <p:spPr>
              <a:xfrm>
                <a:off x="4916125" y="1333400"/>
                <a:ext cx="147675" cy="82575"/>
              </a:xfrm>
              <a:custGeom>
                <a:rect b="b" l="l" r="r" t="t"/>
                <a:pathLst>
                  <a:path extrusionOk="0" fill="none" h="3303" w="5907">
                    <a:moveTo>
                      <a:pt x="5023" y="1582"/>
                    </a:moveTo>
                    <a:lnTo>
                      <a:pt x="4605" y="1582"/>
                    </a:lnTo>
                    <a:lnTo>
                      <a:pt x="4605" y="1582"/>
                    </a:lnTo>
                    <a:lnTo>
                      <a:pt x="4419" y="1582"/>
                    </a:lnTo>
                    <a:lnTo>
                      <a:pt x="4279" y="1442"/>
                    </a:lnTo>
                    <a:lnTo>
                      <a:pt x="4140" y="1303"/>
                    </a:lnTo>
                    <a:lnTo>
                      <a:pt x="4140" y="1117"/>
                    </a:lnTo>
                    <a:lnTo>
                      <a:pt x="4140" y="1117"/>
                    </a:lnTo>
                    <a:lnTo>
                      <a:pt x="4093" y="884"/>
                    </a:lnTo>
                    <a:lnTo>
                      <a:pt x="4000" y="652"/>
                    </a:lnTo>
                    <a:lnTo>
                      <a:pt x="3907" y="466"/>
                    </a:lnTo>
                    <a:lnTo>
                      <a:pt x="3768" y="326"/>
                    </a:lnTo>
                    <a:lnTo>
                      <a:pt x="3582" y="187"/>
                    </a:lnTo>
                    <a:lnTo>
                      <a:pt x="3396" y="47"/>
                    </a:lnTo>
                    <a:lnTo>
                      <a:pt x="3163" y="1"/>
                    </a:lnTo>
                    <a:lnTo>
                      <a:pt x="2977" y="1"/>
                    </a:lnTo>
                    <a:lnTo>
                      <a:pt x="2977" y="1"/>
                    </a:lnTo>
                    <a:lnTo>
                      <a:pt x="2744" y="1"/>
                    </a:lnTo>
                    <a:lnTo>
                      <a:pt x="2512" y="47"/>
                    </a:lnTo>
                    <a:lnTo>
                      <a:pt x="2326" y="187"/>
                    </a:lnTo>
                    <a:lnTo>
                      <a:pt x="2140" y="326"/>
                    </a:lnTo>
                    <a:lnTo>
                      <a:pt x="2000" y="466"/>
                    </a:lnTo>
                    <a:lnTo>
                      <a:pt x="1907" y="652"/>
                    </a:lnTo>
                    <a:lnTo>
                      <a:pt x="1814" y="884"/>
                    </a:lnTo>
                    <a:lnTo>
                      <a:pt x="1768" y="1117"/>
                    </a:lnTo>
                    <a:lnTo>
                      <a:pt x="1768" y="1117"/>
                    </a:lnTo>
                    <a:lnTo>
                      <a:pt x="1768" y="1303"/>
                    </a:lnTo>
                    <a:lnTo>
                      <a:pt x="1628" y="1442"/>
                    </a:lnTo>
                    <a:lnTo>
                      <a:pt x="1489" y="1582"/>
                    </a:lnTo>
                    <a:lnTo>
                      <a:pt x="1303" y="1582"/>
                    </a:lnTo>
                    <a:lnTo>
                      <a:pt x="884" y="1582"/>
                    </a:lnTo>
                    <a:lnTo>
                      <a:pt x="884" y="1582"/>
                    </a:lnTo>
                    <a:lnTo>
                      <a:pt x="698" y="1628"/>
                    </a:lnTo>
                    <a:lnTo>
                      <a:pt x="559" y="1675"/>
                    </a:lnTo>
                    <a:lnTo>
                      <a:pt x="373" y="1721"/>
                    </a:lnTo>
                    <a:lnTo>
                      <a:pt x="280" y="1861"/>
                    </a:lnTo>
                    <a:lnTo>
                      <a:pt x="187" y="1954"/>
                    </a:lnTo>
                    <a:lnTo>
                      <a:pt x="94" y="2093"/>
                    </a:lnTo>
                    <a:lnTo>
                      <a:pt x="47" y="2279"/>
                    </a:lnTo>
                    <a:lnTo>
                      <a:pt x="1" y="2419"/>
                    </a:lnTo>
                    <a:lnTo>
                      <a:pt x="1" y="2419"/>
                    </a:lnTo>
                    <a:lnTo>
                      <a:pt x="47" y="2605"/>
                    </a:lnTo>
                    <a:lnTo>
                      <a:pt x="94" y="2791"/>
                    </a:lnTo>
                    <a:lnTo>
                      <a:pt x="187" y="2930"/>
                    </a:lnTo>
                    <a:lnTo>
                      <a:pt x="280" y="3023"/>
                    </a:lnTo>
                    <a:lnTo>
                      <a:pt x="373" y="3116"/>
                    </a:lnTo>
                    <a:lnTo>
                      <a:pt x="559" y="3209"/>
                    </a:lnTo>
                    <a:lnTo>
                      <a:pt x="698" y="3256"/>
                    </a:lnTo>
                    <a:lnTo>
                      <a:pt x="884" y="3302"/>
                    </a:lnTo>
                    <a:lnTo>
                      <a:pt x="5023" y="3302"/>
                    </a:lnTo>
                    <a:lnTo>
                      <a:pt x="5023" y="3302"/>
                    </a:lnTo>
                    <a:lnTo>
                      <a:pt x="5209" y="3256"/>
                    </a:lnTo>
                    <a:lnTo>
                      <a:pt x="5395" y="3209"/>
                    </a:lnTo>
                    <a:lnTo>
                      <a:pt x="5535" y="3116"/>
                    </a:lnTo>
                    <a:lnTo>
                      <a:pt x="5628" y="3023"/>
                    </a:lnTo>
                    <a:lnTo>
                      <a:pt x="5767" y="2930"/>
                    </a:lnTo>
                    <a:lnTo>
                      <a:pt x="5814" y="2791"/>
                    </a:lnTo>
                    <a:lnTo>
                      <a:pt x="5860" y="2605"/>
                    </a:lnTo>
                    <a:lnTo>
                      <a:pt x="5907" y="2419"/>
                    </a:lnTo>
                    <a:lnTo>
                      <a:pt x="5907" y="2419"/>
                    </a:lnTo>
                    <a:lnTo>
                      <a:pt x="5860" y="2279"/>
                    </a:lnTo>
                    <a:lnTo>
                      <a:pt x="5814" y="2093"/>
                    </a:lnTo>
                    <a:lnTo>
                      <a:pt x="5767" y="1954"/>
                    </a:lnTo>
                    <a:lnTo>
                      <a:pt x="5628" y="1861"/>
                    </a:lnTo>
                    <a:lnTo>
                      <a:pt x="5535" y="1721"/>
                    </a:lnTo>
                    <a:lnTo>
                      <a:pt x="5395" y="1675"/>
                    </a:lnTo>
                    <a:lnTo>
                      <a:pt x="5209" y="1628"/>
                    </a:lnTo>
                    <a:lnTo>
                      <a:pt x="5023" y="1582"/>
                    </a:lnTo>
                    <a:lnTo>
                      <a:pt x="5023" y="1582"/>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90" name="Google Shape;390;p31"/>
              <p:cNvSpPr/>
              <p:nvPr/>
            </p:nvSpPr>
            <p:spPr>
              <a:xfrm>
                <a:off x="5041700" y="137292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91" name="Google Shape;391;p31"/>
              <p:cNvSpPr/>
              <p:nvPr/>
            </p:nvSpPr>
            <p:spPr>
              <a:xfrm>
                <a:off x="4801050" y="1260175"/>
                <a:ext cx="339475" cy="423175"/>
              </a:xfrm>
              <a:custGeom>
                <a:rect b="b" l="l" r="r" t="t"/>
                <a:pathLst>
                  <a:path extrusionOk="0" h="16927" w="13579">
                    <a:moveTo>
                      <a:pt x="7580" y="1907"/>
                    </a:moveTo>
                    <a:lnTo>
                      <a:pt x="7999" y="1953"/>
                    </a:lnTo>
                    <a:lnTo>
                      <a:pt x="8371" y="2093"/>
                    </a:lnTo>
                    <a:lnTo>
                      <a:pt x="8743" y="2279"/>
                    </a:lnTo>
                    <a:lnTo>
                      <a:pt x="9068" y="2511"/>
                    </a:lnTo>
                    <a:lnTo>
                      <a:pt x="9254" y="2744"/>
                    </a:lnTo>
                    <a:lnTo>
                      <a:pt x="9440" y="2976"/>
                    </a:lnTo>
                    <a:lnTo>
                      <a:pt x="9533" y="3255"/>
                    </a:lnTo>
                    <a:lnTo>
                      <a:pt x="9626" y="3534"/>
                    </a:lnTo>
                    <a:lnTo>
                      <a:pt x="9998" y="3581"/>
                    </a:lnTo>
                    <a:lnTo>
                      <a:pt x="10370" y="3674"/>
                    </a:lnTo>
                    <a:lnTo>
                      <a:pt x="10696" y="3860"/>
                    </a:lnTo>
                    <a:lnTo>
                      <a:pt x="10928" y="4092"/>
                    </a:lnTo>
                    <a:lnTo>
                      <a:pt x="11161" y="4325"/>
                    </a:lnTo>
                    <a:lnTo>
                      <a:pt x="11347" y="4650"/>
                    </a:lnTo>
                    <a:lnTo>
                      <a:pt x="11440" y="5022"/>
                    </a:lnTo>
                    <a:lnTo>
                      <a:pt x="11486" y="5348"/>
                    </a:lnTo>
                    <a:lnTo>
                      <a:pt x="11440" y="5720"/>
                    </a:lnTo>
                    <a:lnTo>
                      <a:pt x="11347" y="6092"/>
                    </a:lnTo>
                    <a:lnTo>
                      <a:pt x="11161" y="6371"/>
                    </a:lnTo>
                    <a:lnTo>
                      <a:pt x="10928" y="6650"/>
                    </a:lnTo>
                    <a:lnTo>
                      <a:pt x="10696" y="6882"/>
                    </a:lnTo>
                    <a:lnTo>
                      <a:pt x="10370" y="7068"/>
                    </a:lnTo>
                    <a:lnTo>
                      <a:pt x="9998" y="7161"/>
                    </a:lnTo>
                    <a:lnTo>
                      <a:pt x="9626" y="7208"/>
                    </a:lnTo>
                    <a:lnTo>
                      <a:pt x="7626" y="7208"/>
                    </a:lnTo>
                    <a:lnTo>
                      <a:pt x="7254" y="7952"/>
                    </a:lnTo>
                    <a:lnTo>
                      <a:pt x="8092" y="7952"/>
                    </a:lnTo>
                    <a:lnTo>
                      <a:pt x="8231" y="7998"/>
                    </a:lnTo>
                    <a:lnTo>
                      <a:pt x="8371" y="7998"/>
                    </a:lnTo>
                    <a:lnTo>
                      <a:pt x="8464" y="8091"/>
                    </a:lnTo>
                    <a:lnTo>
                      <a:pt x="8510" y="8184"/>
                    </a:lnTo>
                    <a:lnTo>
                      <a:pt x="8603" y="8324"/>
                    </a:lnTo>
                    <a:lnTo>
                      <a:pt x="8603" y="8417"/>
                    </a:lnTo>
                    <a:lnTo>
                      <a:pt x="8603" y="8556"/>
                    </a:lnTo>
                    <a:lnTo>
                      <a:pt x="8557" y="8649"/>
                    </a:lnTo>
                    <a:lnTo>
                      <a:pt x="7859" y="10091"/>
                    </a:lnTo>
                    <a:lnTo>
                      <a:pt x="7766" y="10230"/>
                    </a:lnTo>
                    <a:lnTo>
                      <a:pt x="7673" y="10323"/>
                    </a:lnTo>
                    <a:lnTo>
                      <a:pt x="7533" y="10370"/>
                    </a:lnTo>
                    <a:lnTo>
                      <a:pt x="7394" y="10370"/>
                    </a:lnTo>
                    <a:lnTo>
                      <a:pt x="7208" y="10323"/>
                    </a:lnTo>
                    <a:lnTo>
                      <a:pt x="7022" y="10230"/>
                    </a:lnTo>
                    <a:lnTo>
                      <a:pt x="6929" y="10044"/>
                    </a:lnTo>
                    <a:lnTo>
                      <a:pt x="6929" y="9858"/>
                    </a:lnTo>
                    <a:lnTo>
                      <a:pt x="6975" y="9672"/>
                    </a:lnTo>
                    <a:lnTo>
                      <a:pt x="7301" y="8928"/>
                    </a:lnTo>
                    <a:lnTo>
                      <a:pt x="6371" y="8928"/>
                    </a:lnTo>
                    <a:lnTo>
                      <a:pt x="6231" y="8882"/>
                    </a:lnTo>
                    <a:lnTo>
                      <a:pt x="6138" y="8835"/>
                    </a:lnTo>
                    <a:lnTo>
                      <a:pt x="6045" y="8696"/>
                    </a:lnTo>
                    <a:lnTo>
                      <a:pt x="5999" y="8603"/>
                    </a:lnTo>
                    <a:lnTo>
                      <a:pt x="5999" y="8463"/>
                    </a:lnTo>
                    <a:lnTo>
                      <a:pt x="5999" y="8370"/>
                    </a:lnTo>
                    <a:lnTo>
                      <a:pt x="6045" y="8231"/>
                    </a:lnTo>
                    <a:lnTo>
                      <a:pt x="6557" y="7208"/>
                    </a:lnTo>
                    <a:lnTo>
                      <a:pt x="5487" y="7208"/>
                    </a:lnTo>
                    <a:lnTo>
                      <a:pt x="5115" y="7161"/>
                    </a:lnTo>
                    <a:lnTo>
                      <a:pt x="4743" y="7068"/>
                    </a:lnTo>
                    <a:lnTo>
                      <a:pt x="4464" y="6882"/>
                    </a:lnTo>
                    <a:lnTo>
                      <a:pt x="4185" y="6650"/>
                    </a:lnTo>
                    <a:lnTo>
                      <a:pt x="3953" y="6371"/>
                    </a:lnTo>
                    <a:lnTo>
                      <a:pt x="3767" y="6092"/>
                    </a:lnTo>
                    <a:lnTo>
                      <a:pt x="3674" y="5720"/>
                    </a:lnTo>
                    <a:lnTo>
                      <a:pt x="3627" y="5348"/>
                    </a:lnTo>
                    <a:lnTo>
                      <a:pt x="3674" y="5022"/>
                    </a:lnTo>
                    <a:lnTo>
                      <a:pt x="3767" y="4650"/>
                    </a:lnTo>
                    <a:lnTo>
                      <a:pt x="3953" y="4325"/>
                    </a:lnTo>
                    <a:lnTo>
                      <a:pt x="4185" y="4092"/>
                    </a:lnTo>
                    <a:lnTo>
                      <a:pt x="4464" y="3860"/>
                    </a:lnTo>
                    <a:lnTo>
                      <a:pt x="4743" y="3674"/>
                    </a:lnTo>
                    <a:lnTo>
                      <a:pt x="5115" y="3581"/>
                    </a:lnTo>
                    <a:lnTo>
                      <a:pt x="5487" y="3534"/>
                    </a:lnTo>
                    <a:lnTo>
                      <a:pt x="5580" y="3255"/>
                    </a:lnTo>
                    <a:lnTo>
                      <a:pt x="5673" y="2976"/>
                    </a:lnTo>
                    <a:lnTo>
                      <a:pt x="5859" y="2744"/>
                    </a:lnTo>
                    <a:lnTo>
                      <a:pt x="6045" y="2511"/>
                    </a:lnTo>
                    <a:lnTo>
                      <a:pt x="6371" y="2279"/>
                    </a:lnTo>
                    <a:lnTo>
                      <a:pt x="6743" y="2093"/>
                    </a:lnTo>
                    <a:lnTo>
                      <a:pt x="7161" y="1953"/>
                    </a:lnTo>
                    <a:lnTo>
                      <a:pt x="7580" y="1907"/>
                    </a:lnTo>
                    <a:close/>
                    <a:moveTo>
                      <a:pt x="7580" y="0"/>
                    </a:moveTo>
                    <a:lnTo>
                      <a:pt x="6975" y="47"/>
                    </a:lnTo>
                    <a:lnTo>
                      <a:pt x="6371" y="93"/>
                    </a:lnTo>
                    <a:lnTo>
                      <a:pt x="5813" y="279"/>
                    </a:lnTo>
                    <a:lnTo>
                      <a:pt x="5255" y="465"/>
                    </a:lnTo>
                    <a:lnTo>
                      <a:pt x="4743" y="698"/>
                    </a:lnTo>
                    <a:lnTo>
                      <a:pt x="4232" y="1023"/>
                    </a:lnTo>
                    <a:lnTo>
                      <a:pt x="3767" y="1349"/>
                    </a:lnTo>
                    <a:lnTo>
                      <a:pt x="3348" y="1767"/>
                    </a:lnTo>
                    <a:lnTo>
                      <a:pt x="2930" y="2186"/>
                    </a:lnTo>
                    <a:lnTo>
                      <a:pt x="2558" y="2697"/>
                    </a:lnTo>
                    <a:lnTo>
                      <a:pt x="2279" y="3162"/>
                    </a:lnTo>
                    <a:lnTo>
                      <a:pt x="2000" y="3720"/>
                    </a:lnTo>
                    <a:lnTo>
                      <a:pt x="1814" y="4278"/>
                    </a:lnTo>
                    <a:lnTo>
                      <a:pt x="1674" y="4836"/>
                    </a:lnTo>
                    <a:lnTo>
                      <a:pt x="1581" y="5394"/>
                    </a:lnTo>
                    <a:lnTo>
                      <a:pt x="1581" y="5999"/>
                    </a:lnTo>
                    <a:lnTo>
                      <a:pt x="1581" y="7254"/>
                    </a:lnTo>
                    <a:lnTo>
                      <a:pt x="93" y="10044"/>
                    </a:lnTo>
                    <a:lnTo>
                      <a:pt x="47" y="10184"/>
                    </a:lnTo>
                    <a:lnTo>
                      <a:pt x="0" y="10277"/>
                    </a:lnTo>
                    <a:lnTo>
                      <a:pt x="47" y="10416"/>
                    </a:lnTo>
                    <a:lnTo>
                      <a:pt x="93" y="10556"/>
                    </a:lnTo>
                    <a:lnTo>
                      <a:pt x="140" y="10649"/>
                    </a:lnTo>
                    <a:lnTo>
                      <a:pt x="279" y="10695"/>
                    </a:lnTo>
                    <a:lnTo>
                      <a:pt x="372" y="10742"/>
                    </a:lnTo>
                    <a:lnTo>
                      <a:pt x="512" y="10788"/>
                    </a:lnTo>
                    <a:lnTo>
                      <a:pt x="1581" y="10788"/>
                    </a:lnTo>
                    <a:lnTo>
                      <a:pt x="1581" y="11997"/>
                    </a:lnTo>
                    <a:lnTo>
                      <a:pt x="1581" y="12323"/>
                    </a:lnTo>
                    <a:lnTo>
                      <a:pt x="1628" y="12648"/>
                    </a:lnTo>
                    <a:lnTo>
                      <a:pt x="1721" y="12927"/>
                    </a:lnTo>
                    <a:lnTo>
                      <a:pt x="1814" y="13206"/>
                    </a:lnTo>
                    <a:lnTo>
                      <a:pt x="1953" y="13485"/>
                    </a:lnTo>
                    <a:lnTo>
                      <a:pt x="2093" y="13718"/>
                    </a:lnTo>
                    <a:lnTo>
                      <a:pt x="2279" y="13997"/>
                    </a:lnTo>
                    <a:lnTo>
                      <a:pt x="2465" y="14183"/>
                    </a:lnTo>
                    <a:lnTo>
                      <a:pt x="2697" y="14415"/>
                    </a:lnTo>
                    <a:lnTo>
                      <a:pt x="2930" y="14555"/>
                    </a:lnTo>
                    <a:lnTo>
                      <a:pt x="3209" y="14741"/>
                    </a:lnTo>
                    <a:lnTo>
                      <a:pt x="3488" y="14880"/>
                    </a:lnTo>
                    <a:lnTo>
                      <a:pt x="3767" y="14973"/>
                    </a:lnTo>
                    <a:lnTo>
                      <a:pt x="4046" y="15066"/>
                    </a:lnTo>
                    <a:lnTo>
                      <a:pt x="4371" y="15113"/>
                    </a:lnTo>
                    <a:lnTo>
                      <a:pt x="6510" y="15113"/>
                    </a:lnTo>
                    <a:lnTo>
                      <a:pt x="6510" y="16415"/>
                    </a:lnTo>
                    <a:lnTo>
                      <a:pt x="6557" y="16601"/>
                    </a:lnTo>
                    <a:lnTo>
                      <a:pt x="6650" y="16787"/>
                    </a:lnTo>
                    <a:lnTo>
                      <a:pt x="6836" y="16880"/>
                    </a:lnTo>
                    <a:lnTo>
                      <a:pt x="7022" y="16926"/>
                    </a:lnTo>
                    <a:lnTo>
                      <a:pt x="13067" y="16926"/>
                    </a:lnTo>
                    <a:lnTo>
                      <a:pt x="13253" y="16880"/>
                    </a:lnTo>
                    <a:lnTo>
                      <a:pt x="13439" y="16787"/>
                    </a:lnTo>
                    <a:lnTo>
                      <a:pt x="13532" y="16601"/>
                    </a:lnTo>
                    <a:lnTo>
                      <a:pt x="13579" y="16415"/>
                    </a:lnTo>
                    <a:lnTo>
                      <a:pt x="13579" y="5999"/>
                    </a:lnTo>
                    <a:lnTo>
                      <a:pt x="13532" y="5394"/>
                    </a:lnTo>
                    <a:lnTo>
                      <a:pt x="13439" y="4836"/>
                    </a:lnTo>
                    <a:lnTo>
                      <a:pt x="13300" y="4278"/>
                    </a:lnTo>
                    <a:lnTo>
                      <a:pt x="13114" y="3720"/>
                    </a:lnTo>
                    <a:lnTo>
                      <a:pt x="12881" y="3162"/>
                    </a:lnTo>
                    <a:lnTo>
                      <a:pt x="12556" y="2697"/>
                    </a:lnTo>
                    <a:lnTo>
                      <a:pt x="12184" y="2186"/>
                    </a:lnTo>
                    <a:lnTo>
                      <a:pt x="11812" y="1767"/>
                    </a:lnTo>
                    <a:lnTo>
                      <a:pt x="11347" y="1349"/>
                    </a:lnTo>
                    <a:lnTo>
                      <a:pt x="10882" y="1023"/>
                    </a:lnTo>
                    <a:lnTo>
                      <a:pt x="10370" y="698"/>
                    </a:lnTo>
                    <a:lnTo>
                      <a:pt x="9859" y="465"/>
                    </a:lnTo>
                    <a:lnTo>
                      <a:pt x="9301" y="279"/>
                    </a:lnTo>
                    <a:lnTo>
                      <a:pt x="8743" y="93"/>
                    </a:lnTo>
                    <a:lnTo>
                      <a:pt x="8138" y="47"/>
                    </a:lnTo>
                    <a:lnTo>
                      <a:pt x="7580"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92" name="Google Shape;392;p31"/>
              <p:cNvSpPr/>
              <p:nvPr/>
            </p:nvSpPr>
            <p:spPr>
              <a:xfrm>
                <a:off x="4801050" y="1260175"/>
                <a:ext cx="339475" cy="423175"/>
              </a:xfrm>
              <a:custGeom>
                <a:rect b="b" l="l" r="r" t="t"/>
                <a:pathLst>
                  <a:path extrusionOk="0" fill="none" h="16927" w="13579">
                    <a:moveTo>
                      <a:pt x="11812" y="1767"/>
                    </a:moveTo>
                    <a:lnTo>
                      <a:pt x="11812" y="1767"/>
                    </a:lnTo>
                    <a:lnTo>
                      <a:pt x="11347" y="1349"/>
                    </a:lnTo>
                    <a:lnTo>
                      <a:pt x="10882" y="1023"/>
                    </a:lnTo>
                    <a:lnTo>
                      <a:pt x="10370" y="698"/>
                    </a:lnTo>
                    <a:lnTo>
                      <a:pt x="9859" y="465"/>
                    </a:lnTo>
                    <a:lnTo>
                      <a:pt x="9301" y="279"/>
                    </a:lnTo>
                    <a:lnTo>
                      <a:pt x="8743" y="93"/>
                    </a:lnTo>
                    <a:lnTo>
                      <a:pt x="8138" y="47"/>
                    </a:lnTo>
                    <a:lnTo>
                      <a:pt x="7580" y="0"/>
                    </a:lnTo>
                    <a:lnTo>
                      <a:pt x="7580" y="0"/>
                    </a:lnTo>
                    <a:lnTo>
                      <a:pt x="6975" y="47"/>
                    </a:lnTo>
                    <a:lnTo>
                      <a:pt x="6371" y="93"/>
                    </a:lnTo>
                    <a:lnTo>
                      <a:pt x="5813" y="279"/>
                    </a:lnTo>
                    <a:lnTo>
                      <a:pt x="5255" y="465"/>
                    </a:lnTo>
                    <a:lnTo>
                      <a:pt x="4743" y="698"/>
                    </a:lnTo>
                    <a:lnTo>
                      <a:pt x="4232" y="1023"/>
                    </a:lnTo>
                    <a:lnTo>
                      <a:pt x="3767" y="1349"/>
                    </a:lnTo>
                    <a:lnTo>
                      <a:pt x="3348" y="1767"/>
                    </a:lnTo>
                    <a:lnTo>
                      <a:pt x="3348" y="1767"/>
                    </a:lnTo>
                    <a:lnTo>
                      <a:pt x="2930" y="2186"/>
                    </a:lnTo>
                    <a:lnTo>
                      <a:pt x="2558" y="2697"/>
                    </a:lnTo>
                    <a:lnTo>
                      <a:pt x="2279" y="3162"/>
                    </a:lnTo>
                    <a:lnTo>
                      <a:pt x="2000" y="3720"/>
                    </a:lnTo>
                    <a:lnTo>
                      <a:pt x="1814" y="4278"/>
                    </a:lnTo>
                    <a:lnTo>
                      <a:pt x="1674" y="4836"/>
                    </a:lnTo>
                    <a:lnTo>
                      <a:pt x="1581" y="5394"/>
                    </a:lnTo>
                    <a:lnTo>
                      <a:pt x="1581" y="5999"/>
                    </a:lnTo>
                    <a:lnTo>
                      <a:pt x="1581" y="7254"/>
                    </a:lnTo>
                    <a:lnTo>
                      <a:pt x="93" y="10044"/>
                    </a:lnTo>
                    <a:lnTo>
                      <a:pt x="93" y="10044"/>
                    </a:lnTo>
                    <a:lnTo>
                      <a:pt x="47" y="10184"/>
                    </a:lnTo>
                    <a:lnTo>
                      <a:pt x="0" y="10277"/>
                    </a:lnTo>
                    <a:lnTo>
                      <a:pt x="47" y="10416"/>
                    </a:lnTo>
                    <a:lnTo>
                      <a:pt x="93" y="10556"/>
                    </a:lnTo>
                    <a:lnTo>
                      <a:pt x="93" y="10556"/>
                    </a:lnTo>
                    <a:lnTo>
                      <a:pt x="140" y="10649"/>
                    </a:lnTo>
                    <a:lnTo>
                      <a:pt x="279" y="10695"/>
                    </a:lnTo>
                    <a:lnTo>
                      <a:pt x="372" y="10742"/>
                    </a:lnTo>
                    <a:lnTo>
                      <a:pt x="512" y="10788"/>
                    </a:lnTo>
                    <a:lnTo>
                      <a:pt x="1581" y="10788"/>
                    </a:lnTo>
                    <a:lnTo>
                      <a:pt x="1581" y="11997"/>
                    </a:lnTo>
                    <a:lnTo>
                      <a:pt x="1581" y="11997"/>
                    </a:lnTo>
                    <a:lnTo>
                      <a:pt x="1581" y="12323"/>
                    </a:lnTo>
                    <a:lnTo>
                      <a:pt x="1628" y="12648"/>
                    </a:lnTo>
                    <a:lnTo>
                      <a:pt x="1721" y="12927"/>
                    </a:lnTo>
                    <a:lnTo>
                      <a:pt x="1814" y="13206"/>
                    </a:lnTo>
                    <a:lnTo>
                      <a:pt x="1953" y="13485"/>
                    </a:lnTo>
                    <a:lnTo>
                      <a:pt x="2093" y="13718"/>
                    </a:lnTo>
                    <a:lnTo>
                      <a:pt x="2279" y="13997"/>
                    </a:lnTo>
                    <a:lnTo>
                      <a:pt x="2465" y="14183"/>
                    </a:lnTo>
                    <a:lnTo>
                      <a:pt x="2697" y="14415"/>
                    </a:lnTo>
                    <a:lnTo>
                      <a:pt x="2930" y="14555"/>
                    </a:lnTo>
                    <a:lnTo>
                      <a:pt x="3209" y="14741"/>
                    </a:lnTo>
                    <a:lnTo>
                      <a:pt x="3488" y="14880"/>
                    </a:lnTo>
                    <a:lnTo>
                      <a:pt x="3767" y="14973"/>
                    </a:lnTo>
                    <a:lnTo>
                      <a:pt x="4046" y="15066"/>
                    </a:lnTo>
                    <a:lnTo>
                      <a:pt x="4371" y="15113"/>
                    </a:lnTo>
                    <a:lnTo>
                      <a:pt x="4697" y="15113"/>
                    </a:lnTo>
                    <a:lnTo>
                      <a:pt x="6510" y="15113"/>
                    </a:lnTo>
                    <a:lnTo>
                      <a:pt x="6510" y="16415"/>
                    </a:lnTo>
                    <a:lnTo>
                      <a:pt x="6510" y="16415"/>
                    </a:lnTo>
                    <a:lnTo>
                      <a:pt x="6557" y="16601"/>
                    </a:lnTo>
                    <a:lnTo>
                      <a:pt x="6650" y="16787"/>
                    </a:lnTo>
                    <a:lnTo>
                      <a:pt x="6836" y="16880"/>
                    </a:lnTo>
                    <a:lnTo>
                      <a:pt x="7022" y="16926"/>
                    </a:lnTo>
                    <a:lnTo>
                      <a:pt x="13067" y="16926"/>
                    </a:lnTo>
                    <a:lnTo>
                      <a:pt x="13067" y="16926"/>
                    </a:lnTo>
                    <a:lnTo>
                      <a:pt x="13253" y="16880"/>
                    </a:lnTo>
                    <a:lnTo>
                      <a:pt x="13439" y="16787"/>
                    </a:lnTo>
                    <a:lnTo>
                      <a:pt x="13532" y="16601"/>
                    </a:lnTo>
                    <a:lnTo>
                      <a:pt x="13579" y="16415"/>
                    </a:lnTo>
                    <a:lnTo>
                      <a:pt x="13579" y="5999"/>
                    </a:lnTo>
                    <a:lnTo>
                      <a:pt x="13579" y="5999"/>
                    </a:lnTo>
                    <a:lnTo>
                      <a:pt x="13532" y="5394"/>
                    </a:lnTo>
                    <a:lnTo>
                      <a:pt x="13439" y="4836"/>
                    </a:lnTo>
                    <a:lnTo>
                      <a:pt x="13300" y="4278"/>
                    </a:lnTo>
                    <a:lnTo>
                      <a:pt x="13114" y="3720"/>
                    </a:lnTo>
                    <a:lnTo>
                      <a:pt x="12881" y="3162"/>
                    </a:lnTo>
                    <a:lnTo>
                      <a:pt x="12556" y="2697"/>
                    </a:lnTo>
                    <a:lnTo>
                      <a:pt x="12184" y="2186"/>
                    </a:lnTo>
                    <a:lnTo>
                      <a:pt x="11812" y="1767"/>
                    </a:lnTo>
                    <a:lnTo>
                      <a:pt x="11812" y="1767"/>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93" name="Google Shape;393;p31"/>
              <p:cNvSpPr/>
              <p:nvPr/>
            </p:nvSpPr>
            <p:spPr>
              <a:xfrm>
                <a:off x="4891725" y="1307825"/>
                <a:ext cx="196500" cy="211600"/>
              </a:xfrm>
              <a:custGeom>
                <a:rect b="b" l="l" r="r" t="t"/>
                <a:pathLst>
                  <a:path extrusionOk="0" fill="none" h="8464" w="7860">
                    <a:moveTo>
                      <a:pt x="5999" y="5302"/>
                    </a:moveTo>
                    <a:lnTo>
                      <a:pt x="3999" y="5302"/>
                    </a:lnTo>
                    <a:lnTo>
                      <a:pt x="3627" y="6046"/>
                    </a:lnTo>
                    <a:lnTo>
                      <a:pt x="4465" y="6046"/>
                    </a:lnTo>
                    <a:lnTo>
                      <a:pt x="4465" y="6046"/>
                    </a:lnTo>
                    <a:lnTo>
                      <a:pt x="4604" y="6092"/>
                    </a:lnTo>
                    <a:lnTo>
                      <a:pt x="4744" y="6092"/>
                    </a:lnTo>
                    <a:lnTo>
                      <a:pt x="4837" y="6185"/>
                    </a:lnTo>
                    <a:lnTo>
                      <a:pt x="4883" y="6278"/>
                    </a:lnTo>
                    <a:lnTo>
                      <a:pt x="4883" y="6278"/>
                    </a:lnTo>
                    <a:lnTo>
                      <a:pt x="4976" y="6418"/>
                    </a:lnTo>
                    <a:lnTo>
                      <a:pt x="4976" y="6511"/>
                    </a:lnTo>
                    <a:lnTo>
                      <a:pt x="4976" y="6650"/>
                    </a:lnTo>
                    <a:lnTo>
                      <a:pt x="4930" y="6743"/>
                    </a:lnTo>
                    <a:lnTo>
                      <a:pt x="4232" y="8185"/>
                    </a:lnTo>
                    <a:lnTo>
                      <a:pt x="4232" y="8185"/>
                    </a:lnTo>
                    <a:lnTo>
                      <a:pt x="4139" y="8324"/>
                    </a:lnTo>
                    <a:lnTo>
                      <a:pt x="4046" y="8417"/>
                    </a:lnTo>
                    <a:lnTo>
                      <a:pt x="3906" y="8464"/>
                    </a:lnTo>
                    <a:lnTo>
                      <a:pt x="3767" y="8464"/>
                    </a:lnTo>
                    <a:lnTo>
                      <a:pt x="3767" y="8464"/>
                    </a:lnTo>
                    <a:lnTo>
                      <a:pt x="3581" y="8417"/>
                    </a:lnTo>
                    <a:lnTo>
                      <a:pt x="3581" y="8417"/>
                    </a:lnTo>
                    <a:lnTo>
                      <a:pt x="3395" y="8324"/>
                    </a:lnTo>
                    <a:lnTo>
                      <a:pt x="3302" y="8138"/>
                    </a:lnTo>
                    <a:lnTo>
                      <a:pt x="3302" y="7952"/>
                    </a:lnTo>
                    <a:lnTo>
                      <a:pt x="3348" y="7766"/>
                    </a:lnTo>
                    <a:lnTo>
                      <a:pt x="3674" y="7022"/>
                    </a:lnTo>
                    <a:lnTo>
                      <a:pt x="2837" y="7022"/>
                    </a:lnTo>
                    <a:lnTo>
                      <a:pt x="2837" y="7022"/>
                    </a:lnTo>
                    <a:lnTo>
                      <a:pt x="2744" y="7022"/>
                    </a:lnTo>
                    <a:lnTo>
                      <a:pt x="2604" y="6976"/>
                    </a:lnTo>
                    <a:lnTo>
                      <a:pt x="2511" y="6929"/>
                    </a:lnTo>
                    <a:lnTo>
                      <a:pt x="2418" y="6790"/>
                    </a:lnTo>
                    <a:lnTo>
                      <a:pt x="2418" y="6790"/>
                    </a:lnTo>
                    <a:lnTo>
                      <a:pt x="2372" y="6697"/>
                    </a:lnTo>
                    <a:lnTo>
                      <a:pt x="2372" y="6557"/>
                    </a:lnTo>
                    <a:lnTo>
                      <a:pt x="2372" y="6464"/>
                    </a:lnTo>
                    <a:lnTo>
                      <a:pt x="2418" y="6325"/>
                    </a:lnTo>
                    <a:lnTo>
                      <a:pt x="2930" y="5302"/>
                    </a:lnTo>
                    <a:lnTo>
                      <a:pt x="1860" y="5302"/>
                    </a:lnTo>
                    <a:lnTo>
                      <a:pt x="1860" y="5302"/>
                    </a:lnTo>
                    <a:lnTo>
                      <a:pt x="1488" y="5255"/>
                    </a:lnTo>
                    <a:lnTo>
                      <a:pt x="1116" y="5162"/>
                    </a:lnTo>
                    <a:lnTo>
                      <a:pt x="837" y="4976"/>
                    </a:lnTo>
                    <a:lnTo>
                      <a:pt x="558" y="4744"/>
                    </a:lnTo>
                    <a:lnTo>
                      <a:pt x="326" y="4465"/>
                    </a:lnTo>
                    <a:lnTo>
                      <a:pt x="140" y="4186"/>
                    </a:lnTo>
                    <a:lnTo>
                      <a:pt x="47" y="3814"/>
                    </a:lnTo>
                    <a:lnTo>
                      <a:pt x="0" y="3442"/>
                    </a:lnTo>
                    <a:lnTo>
                      <a:pt x="0" y="3442"/>
                    </a:lnTo>
                    <a:lnTo>
                      <a:pt x="47" y="3116"/>
                    </a:lnTo>
                    <a:lnTo>
                      <a:pt x="140" y="2744"/>
                    </a:lnTo>
                    <a:lnTo>
                      <a:pt x="326" y="2419"/>
                    </a:lnTo>
                    <a:lnTo>
                      <a:pt x="558" y="2186"/>
                    </a:lnTo>
                    <a:lnTo>
                      <a:pt x="837" y="1954"/>
                    </a:lnTo>
                    <a:lnTo>
                      <a:pt x="1116" y="1768"/>
                    </a:lnTo>
                    <a:lnTo>
                      <a:pt x="1488" y="1675"/>
                    </a:lnTo>
                    <a:lnTo>
                      <a:pt x="1860" y="1628"/>
                    </a:lnTo>
                    <a:lnTo>
                      <a:pt x="1860" y="1628"/>
                    </a:lnTo>
                    <a:lnTo>
                      <a:pt x="1860" y="1628"/>
                    </a:lnTo>
                    <a:lnTo>
                      <a:pt x="1953" y="1349"/>
                    </a:lnTo>
                    <a:lnTo>
                      <a:pt x="2046" y="1070"/>
                    </a:lnTo>
                    <a:lnTo>
                      <a:pt x="2232" y="838"/>
                    </a:lnTo>
                    <a:lnTo>
                      <a:pt x="2418" y="605"/>
                    </a:lnTo>
                    <a:lnTo>
                      <a:pt x="2418" y="605"/>
                    </a:lnTo>
                    <a:lnTo>
                      <a:pt x="2744" y="373"/>
                    </a:lnTo>
                    <a:lnTo>
                      <a:pt x="3116" y="187"/>
                    </a:lnTo>
                    <a:lnTo>
                      <a:pt x="3534" y="47"/>
                    </a:lnTo>
                    <a:lnTo>
                      <a:pt x="3953" y="1"/>
                    </a:lnTo>
                    <a:lnTo>
                      <a:pt x="3953" y="1"/>
                    </a:lnTo>
                    <a:lnTo>
                      <a:pt x="4372" y="47"/>
                    </a:lnTo>
                    <a:lnTo>
                      <a:pt x="4744" y="187"/>
                    </a:lnTo>
                    <a:lnTo>
                      <a:pt x="5116" y="373"/>
                    </a:lnTo>
                    <a:lnTo>
                      <a:pt x="5441" y="605"/>
                    </a:lnTo>
                    <a:lnTo>
                      <a:pt x="5441" y="605"/>
                    </a:lnTo>
                    <a:lnTo>
                      <a:pt x="5627" y="838"/>
                    </a:lnTo>
                    <a:lnTo>
                      <a:pt x="5813" y="1070"/>
                    </a:lnTo>
                    <a:lnTo>
                      <a:pt x="5906" y="1349"/>
                    </a:lnTo>
                    <a:lnTo>
                      <a:pt x="5999" y="1628"/>
                    </a:lnTo>
                    <a:lnTo>
                      <a:pt x="5999" y="1628"/>
                    </a:lnTo>
                    <a:lnTo>
                      <a:pt x="5999" y="1628"/>
                    </a:lnTo>
                    <a:lnTo>
                      <a:pt x="6371" y="1675"/>
                    </a:lnTo>
                    <a:lnTo>
                      <a:pt x="6743" y="1768"/>
                    </a:lnTo>
                    <a:lnTo>
                      <a:pt x="7069" y="1954"/>
                    </a:lnTo>
                    <a:lnTo>
                      <a:pt x="7301" y="2186"/>
                    </a:lnTo>
                    <a:lnTo>
                      <a:pt x="7534" y="2419"/>
                    </a:lnTo>
                    <a:lnTo>
                      <a:pt x="7720" y="2744"/>
                    </a:lnTo>
                    <a:lnTo>
                      <a:pt x="7813" y="3116"/>
                    </a:lnTo>
                    <a:lnTo>
                      <a:pt x="7859" y="3442"/>
                    </a:lnTo>
                    <a:lnTo>
                      <a:pt x="7859" y="3442"/>
                    </a:lnTo>
                    <a:lnTo>
                      <a:pt x="7813" y="3814"/>
                    </a:lnTo>
                    <a:lnTo>
                      <a:pt x="7720" y="4186"/>
                    </a:lnTo>
                    <a:lnTo>
                      <a:pt x="7534" y="4465"/>
                    </a:lnTo>
                    <a:lnTo>
                      <a:pt x="7301" y="4744"/>
                    </a:lnTo>
                    <a:lnTo>
                      <a:pt x="7069" y="4976"/>
                    </a:lnTo>
                    <a:lnTo>
                      <a:pt x="6743" y="5162"/>
                    </a:lnTo>
                    <a:lnTo>
                      <a:pt x="6371" y="5255"/>
                    </a:lnTo>
                    <a:lnTo>
                      <a:pt x="5999" y="5302"/>
                    </a:lnTo>
                    <a:lnTo>
                      <a:pt x="5999" y="5302"/>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94" name="Google Shape;394;p31"/>
              <p:cNvSpPr/>
              <p:nvPr/>
            </p:nvSpPr>
            <p:spPr>
              <a:xfrm>
                <a:off x="5041700" y="14403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8" name="Shape 398"/>
        <p:cNvGrpSpPr/>
        <p:nvPr/>
      </p:nvGrpSpPr>
      <p:grpSpPr>
        <a:xfrm>
          <a:off x="0" y="0"/>
          <a:ext cx="0" cy="0"/>
          <a:chOff x="0" y="0"/>
          <a:chExt cx="0" cy="0"/>
        </a:xfrm>
      </p:grpSpPr>
      <p:sp>
        <p:nvSpPr>
          <p:cNvPr id="399" name="Google Shape;399;p32"/>
          <p:cNvSpPr/>
          <p:nvPr/>
        </p:nvSpPr>
        <p:spPr>
          <a:xfrm>
            <a:off x="712625" y="1514630"/>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400" name="Google Shape;400;p32"/>
          <p:cNvGrpSpPr/>
          <p:nvPr/>
        </p:nvGrpSpPr>
        <p:grpSpPr>
          <a:xfrm>
            <a:off x="884351" y="1649105"/>
            <a:ext cx="302155" cy="376626"/>
            <a:chOff x="2545725" y="2673800"/>
            <a:chExt cx="339500" cy="423175"/>
          </a:xfrm>
        </p:grpSpPr>
        <p:sp>
          <p:nvSpPr>
            <p:cNvPr id="401" name="Google Shape;401;p32"/>
            <p:cNvSpPr/>
            <p:nvPr/>
          </p:nvSpPr>
          <p:spPr>
            <a:xfrm>
              <a:off x="2545725" y="2673800"/>
              <a:ext cx="339500" cy="423175"/>
            </a:xfrm>
            <a:custGeom>
              <a:rect b="b" l="l" r="r" t="t"/>
              <a:pathLst>
                <a:path extrusionOk="0" h="16927" w="13580">
                  <a:moveTo>
                    <a:pt x="8278" y="2000"/>
                  </a:moveTo>
                  <a:lnTo>
                    <a:pt x="8418" y="2093"/>
                  </a:lnTo>
                  <a:lnTo>
                    <a:pt x="8511" y="2232"/>
                  </a:lnTo>
                  <a:lnTo>
                    <a:pt x="8604" y="2372"/>
                  </a:lnTo>
                  <a:lnTo>
                    <a:pt x="8743" y="2418"/>
                  </a:lnTo>
                  <a:lnTo>
                    <a:pt x="8883" y="2558"/>
                  </a:lnTo>
                  <a:lnTo>
                    <a:pt x="8929" y="2697"/>
                  </a:lnTo>
                  <a:lnTo>
                    <a:pt x="8976" y="2837"/>
                  </a:lnTo>
                  <a:lnTo>
                    <a:pt x="8929" y="3023"/>
                  </a:lnTo>
                  <a:lnTo>
                    <a:pt x="8883" y="3162"/>
                  </a:lnTo>
                  <a:lnTo>
                    <a:pt x="8743" y="3255"/>
                  </a:lnTo>
                  <a:lnTo>
                    <a:pt x="8604" y="3302"/>
                  </a:lnTo>
                  <a:lnTo>
                    <a:pt x="8511" y="3488"/>
                  </a:lnTo>
                  <a:lnTo>
                    <a:pt x="8418" y="3581"/>
                  </a:lnTo>
                  <a:lnTo>
                    <a:pt x="8278" y="3674"/>
                  </a:lnTo>
                  <a:lnTo>
                    <a:pt x="8092" y="3720"/>
                  </a:lnTo>
                  <a:lnTo>
                    <a:pt x="7953" y="3674"/>
                  </a:lnTo>
                  <a:lnTo>
                    <a:pt x="7813" y="3581"/>
                  </a:lnTo>
                  <a:lnTo>
                    <a:pt x="7720" y="3488"/>
                  </a:lnTo>
                  <a:lnTo>
                    <a:pt x="7627" y="3302"/>
                  </a:lnTo>
                  <a:lnTo>
                    <a:pt x="7488" y="3255"/>
                  </a:lnTo>
                  <a:lnTo>
                    <a:pt x="7348" y="3162"/>
                  </a:lnTo>
                  <a:lnTo>
                    <a:pt x="7302" y="3023"/>
                  </a:lnTo>
                  <a:lnTo>
                    <a:pt x="7255" y="2837"/>
                  </a:lnTo>
                  <a:lnTo>
                    <a:pt x="7302" y="2697"/>
                  </a:lnTo>
                  <a:lnTo>
                    <a:pt x="7348" y="2558"/>
                  </a:lnTo>
                  <a:lnTo>
                    <a:pt x="7488" y="2418"/>
                  </a:lnTo>
                  <a:lnTo>
                    <a:pt x="7627" y="2372"/>
                  </a:lnTo>
                  <a:lnTo>
                    <a:pt x="7720" y="2232"/>
                  </a:lnTo>
                  <a:lnTo>
                    <a:pt x="7813" y="2093"/>
                  </a:lnTo>
                  <a:lnTo>
                    <a:pt x="7953" y="2000"/>
                  </a:lnTo>
                  <a:close/>
                  <a:moveTo>
                    <a:pt x="9580" y="4139"/>
                  </a:moveTo>
                  <a:lnTo>
                    <a:pt x="9766" y="4232"/>
                  </a:lnTo>
                  <a:lnTo>
                    <a:pt x="9859" y="4371"/>
                  </a:lnTo>
                  <a:lnTo>
                    <a:pt x="9906" y="4511"/>
                  </a:lnTo>
                  <a:lnTo>
                    <a:pt x="10045" y="4557"/>
                  </a:lnTo>
                  <a:lnTo>
                    <a:pt x="10185" y="4697"/>
                  </a:lnTo>
                  <a:lnTo>
                    <a:pt x="10278" y="4836"/>
                  </a:lnTo>
                  <a:lnTo>
                    <a:pt x="10278" y="4976"/>
                  </a:lnTo>
                  <a:lnTo>
                    <a:pt x="10278" y="5162"/>
                  </a:lnTo>
                  <a:lnTo>
                    <a:pt x="10185" y="5301"/>
                  </a:lnTo>
                  <a:lnTo>
                    <a:pt x="10045" y="5394"/>
                  </a:lnTo>
                  <a:lnTo>
                    <a:pt x="9906" y="5487"/>
                  </a:lnTo>
                  <a:lnTo>
                    <a:pt x="9859" y="5627"/>
                  </a:lnTo>
                  <a:lnTo>
                    <a:pt x="9766" y="5766"/>
                  </a:lnTo>
                  <a:lnTo>
                    <a:pt x="9580" y="5813"/>
                  </a:lnTo>
                  <a:lnTo>
                    <a:pt x="9441" y="5859"/>
                  </a:lnTo>
                  <a:lnTo>
                    <a:pt x="9255" y="5813"/>
                  </a:lnTo>
                  <a:lnTo>
                    <a:pt x="9115" y="5766"/>
                  </a:lnTo>
                  <a:lnTo>
                    <a:pt x="9022" y="5627"/>
                  </a:lnTo>
                  <a:lnTo>
                    <a:pt x="8976" y="5487"/>
                  </a:lnTo>
                  <a:lnTo>
                    <a:pt x="8790" y="5394"/>
                  </a:lnTo>
                  <a:lnTo>
                    <a:pt x="8697" y="5301"/>
                  </a:lnTo>
                  <a:lnTo>
                    <a:pt x="8604" y="5162"/>
                  </a:lnTo>
                  <a:lnTo>
                    <a:pt x="8557" y="4976"/>
                  </a:lnTo>
                  <a:lnTo>
                    <a:pt x="8604" y="4836"/>
                  </a:lnTo>
                  <a:lnTo>
                    <a:pt x="8697" y="4697"/>
                  </a:lnTo>
                  <a:lnTo>
                    <a:pt x="8790" y="4557"/>
                  </a:lnTo>
                  <a:lnTo>
                    <a:pt x="8976" y="4511"/>
                  </a:lnTo>
                  <a:lnTo>
                    <a:pt x="9022" y="4371"/>
                  </a:lnTo>
                  <a:lnTo>
                    <a:pt x="9115" y="4232"/>
                  </a:lnTo>
                  <a:lnTo>
                    <a:pt x="9255" y="4139"/>
                  </a:lnTo>
                  <a:close/>
                  <a:moveTo>
                    <a:pt x="6000" y="2465"/>
                  </a:moveTo>
                  <a:lnTo>
                    <a:pt x="6139" y="2558"/>
                  </a:lnTo>
                  <a:lnTo>
                    <a:pt x="6232" y="2651"/>
                  </a:lnTo>
                  <a:lnTo>
                    <a:pt x="6279" y="2790"/>
                  </a:lnTo>
                  <a:lnTo>
                    <a:pt x="6325" y="2930"/>
                  </a:lnTo>
                  <a:lnTo>
                    <a:pt x="6279" y="3069"/>
                  </a:lnTo>
                  <a:lnTo>
                    <a:pt x="6232" y="3441"/>
                  </a:lnTo>
                  <a:lnTo>
                    <a:pt x="6186" y="3767"/>
                  </a:lnTo>
                  <a:lnTo>
                    <a:pt x="6186" y="4139"/>
                  </a:lnTo>
                  <a:lnTo>
                    <a:pt x="6186" y="4464"/>
                  </a:lnTo>
                  <a:lnTo>
                    <a:pt x="6279" y="4836"/>
                  </a:lnTo>
                  <a:lnTo>
                    <a:pt x="6418" y="5162"/>
                  </a:lnTo>
                  <a:lnTo>
                    <a:pt x="6558" y="5487"/>
                  </a:lnTo>
                  <a:lnTo>
                    <a:pt x="6744" y="5766"/>
                  </a:lnTo>
                  <a:lnTo>
                    <a:pt x="6976" y="6045"/>
                  </a:lnTo>
                  <a:lnTo>
                    <a:pt x="7255" y="6324"/>
                  </a:lnTo>
                  <a:lnTo>
                    <a:pt x="7534" y="6510"/>
                  </a:lnTo>
                  <a:lnTo>
                    <a:pt x="7813" y="6696"/>
                  </a:lnTo>
                  <a:lnTo>
                    <a:pt x="8139" y="6836"/>
                  </a:lnTo>
                  <a:lnTo>
                    <a:pt x="8464" y="6929"/>
                  </a:lnTo>
                  <a:lnTo>
                    <a:pt x="8836" y="6975"/>
                  </a:lnTo>
                  <a:lnTo>
                    <a:pt x="9208" y="7022"/>
                  </a:lnTo>
                  <a:lnTo>
                    <a:pt x="9580" y="6975"/>
                  </a:lnTo>
                  <a:lnTo>
                    <a:pt x="9952" y="6929"/>
                  </a:lnTo>
                  <a:lnTo>
                    <a:pt x="10324" y="6789"/>
                  </a:lnTo>
                  <a:lnTo>
                    <a:pt x="10696" y="6603"/>
                  </a:lnTo>
                  <a:lnTo>
                    <a:pt x="10836" y="6557"/>
                  </a:lnTo>
                  <a:lnTo>
                    <a:pt x="10975" y="6557"/>
                  </a:lnTo>
                  <a:lnTo>
                    <a:pt x="11115" y="6603"/>
                  </a:lnTo>
                  <a:lnTo>
                    <a:pt x="11254" y="6650"/>
                  </a:lnTo>
                  <a:lnTo>
                    <a:pt x="11347" y="6789"/>
                  </a:lnTo>
                  <a:lnTo>
                    <a:pt x="11394" y="6882"/>
                  </a:lnTo>
                  <a:lnTo>
                    <a:pt x="11440" y="7022"/>
                  </a:lnTo>
                  <a:lnTo>
                    <a:pt x="11394" y="7208"/>
                  </a:lnTo>
                  <a:lnTo>
                    <a:pt x="11161" y="7766"/>
                  </a:lnTo>
                  <a:lnTo>
                    <a:pt x="10836" y="8324"/>
                  </a:lnTo>
                  <a:lnTo>
                    <a:pt x="10464" y="8789"/>
                  </a:lnTo>
                  <a:lnTo>
                    <a:pt x="9952" y="9208"/>
                  </a:lnTo>
                  <a:lnTo>
                    <a:pt x="9441" y="9580"/>
                  </a:lnTo>
                  <a:lnTo>
                    <a:pt x="8836" y="9812"/>
                  </a:lnTo>
                  <a:lnTo>
                    <a:pt x="8232" y="9952"/>
                  </a:lnTo>
                  <a:lnTo>
                    <a:pt x="7581" y="9998"/>
                  </a:lnTo>
                  <a:lnTo>
                    <a:pt x="7162" y="9998"/>
                  </a:lnTo>
                  <a:lnTo>
                    <a:pt x="6744" y="9952"/>
                  </a:lnTo>
                  <a:lnTo>
                    <a:pt x="6372" y="9859"/>
                  </a:lnTo>
                  <a:lnTo>
                    <a:pt x="6000" y="9719"/>
                  </a:lnTo>
                  <a:lnTo>
                    <a:pt x="5674" y="9533"/>
                  </a:lnTo>
                  <a:lnTo>
                    <a:pt x="5302" y="9347"/>
                  </a:lnTo>
                  <a:lnTo>
                    <a:pt x="5023" y="9115"/>
                  </a:lnTo>
                  <a:lnTo>
                    <a:pt x="4744" y="8836"/>
                  </a:lnTo>
                  <a:lnTo>
                    <a:pt x="4465" y="8557"/>
                  </a:lnTo>
                  <a:lnTo>
                    <a:pt x="4233" y="8231"/>
                  </a:lnTo>
                  <a:lnTo>
                    <a:pt x="4047" y="7906"/>
                  </a:lnTo>
                  <a:lnTo>
                    <a:pt x="3861" y="7580"/>
                  </a:lnTo>
                  <a:lnTo>
                    <a:pt x="3721" y="7208"/>
                  </a:lnTo>
                  <a:lnTo>
                    <a:pt x="3628" y="6789"/>
                  </a:lnTo>
                  <a:lnTo>
                    <a:pt x="3582" y="6417"/>
                  </a:lnTo>
                  <a:lnTo>
                    <a:pt x="3535" y="5999"/>
                  </a:lnTo>
                  <a:lnTo>
                    <a:pt x="3582" y="5487"/>
                  </a:lnTo>
                  <a:lnTo>
                    <a:pt x="3675" y="4929"/>
                  </a:lnTo>
                  <a:lnTo>
                    <a:pt x="3861" y="4464"/>
                  </a:lnTo>
                  <a:lnTo>
                    <a:pt x="4093" y="3999"/>
                  </a:lnTo>
                  <a:lnTo>
                    <a:pt x="4372" y="3534"/>
                  </a:lnTo>
                  <a:lnTo>
                    <a:pt x="4744" y="3162"/>
                  </a:lnTo>
                  <a:lnTo>
                    <a:pt x="5116" y="2790"/>
                  </a:lnTo>
                  <a:lnTo>
                    <a:pt x="5581" y="2511"/>
                  </a:lnTo>
                  <a:lnTo>
                    <a:pt x="5721" y="2465"/>
                  </a:lnTo>
                  <a:close/>
                  <a:moveTo>
                    <a:pt x="7581" y="0"/>
                  </a:moveTo>
                  <a:lnTo>
                    <a:pt x="6976" y="47"/>
                  </a:lnTo>
                  <a:lnTo>
                    <a:pt x="6372" y="93"/>
                  </a:lnTo>
                  <a:lnTo>
                    <a:pt x="5814" y="279"/>
                  </a:lnTo>
                  <a:lnTo>
                    <a:pt x="5256" y="465"/>
                  </a:lnTo>
                  <a:lnTo>
                    <a:pt x="4744" y="698"/>
                  </a:lnTo>
                  <a:lnTo>
                    <a:pt x="4233" y="1023"/>
                  </a:lnTo>
                  <a:lnTo>
                    <a:pt x="3768" y="1349"/>
                  </a:lnTo>
                  <a:lnTo>
                    <a:pt x="3349" y="1767"/>
                  </a:lnTo>
                  <a:lnTo>
                    <a:pt x="2931" y="2186"/>
                  </a:lnTo>
                  <a:lnTo>
                    <a:pt x="2558" y="2697"/>
                  </a:lnTo>
                  <a:lnTo>
                    <a:pt x="2279" y="3162"/>
                  </a:lnTo>
                  <a:lnTo>
                    <a:pt x="2000" y="3720"/>
                  </a:lnTo>
                  <a:lnTo>
                    <a:pt x="1814" y="4278"/>
                  </a:lnTo>
                  <a:lnTo>
                    <a:pt x="1675" y="4836"/>
                  </a:lnTo>
                  <a:lnTo>
                    <a:pt x="1582" y="5394"/>
                  </a:lnTo>
                  <a:lnTo>
                    <a:pt x="1582" y="5999"/>
                  </a:lnTo>
                  <a:lnTo>
                    <a:pt x="1582" y="7255"/>
                  </a:lnTo>
                  <a:lnTo>
                    <a:pt x="94" y="10045"/>
                  </a:lnTo>
                  <a:lnTo>
                    <a:pt x="47" y="10184"/>
                  </a:lnTo>
                  <a:lnTo>
                    <a:pt x="1" y="10277"/>
                  </a:lnTo>
                  <a:lnTo>
                    <a:pt x="47" y="10417"/>
                  </a:lnTo>
                  <a:lnTo>
                    <a:pt x="94" y="10556"/>
                  </a:lnTo>
                  <a:lnTo>
                    <a:pt x="140" y="10649"/>
                  </a:lnTo>
                  <a:lnTo>
                    <a:pt x="280" y="10696"/>
                  </a:lnTo>
                  <a:lnTo>
                    <a:pt x="373" y="10742"/>
                  </a:lnTo>
                  <a:lnTo>
                    <a:pt x="512" y="10789"/>
                  </a:lnTo>
                  <a:lnTo>
                    <a:pt x="1582" y="10789"/>
                  </a:lnTo>
                  <a:lnTo>
                    <a:pt x="1582" y="11998"/>
                  </a:lnTo>
                  <a:lnTo>
                    <a:pt x="1582" y="12323"/>
                  </a:lnTo>
                  <a:lnTo>
                    <a:pt x="1628" y="12649"/>
                  </a:lnTo>
                  <a:lnTo>
                    <a:pt x="1721" y="12928"/>
                  </a:lnTo>
                  <a:lnTo>
                    <a:pt x="1814" y="13207"/>
                  </a:lnTo>
                  <a:lnTo>
                    <a:pt x="1954" y="13486"/>
                  </a:lnTo>
                  <a:lnTo>
                    <a:pt x="2093" y="13718"/>
                  </a:lnTo>
                  <a:lnTo>
                    <a:pt x="2279" y="13997"/>
                  </a:lnTo>
                  <a:lnTo>
                    <a:pt x="2465" y="14183"/>
                  </a:lnTo>
                  <a:lnTo>
                    <a:pt x="2698" y="14416"/>
                  </a:lnTo>
                  <a:lnTo>
                    <a:pt x="2931" y="14555"/>
                  </a:lnTo>
                  <a:lnTo>
                    <a:pt x="3210" y="14741"/>
                  </a:lnTo>
                  <a:lnTo>
                    <a:pt x="3489" y="14881"/>
                  </a:lnTo>
                  <a:lnTo>
                    <a:pt x="3768" y="14974"/>
                  </a:lnTo>
                  <a:lnTo>
                    <a:pt x="4047" y="15067"/>
                  </a:lnTo>
                  <a:lnTo>
                    <a:pt x="4372" y="15113"/>
                  </a:lnTo>
                  <a:lnTo>
                    <a:pt x="6511" y="15113"/>
                  </a:lnTo>
                  <a:lnTo>
                    <a:pt x="6511" y="16415"/>
                  </a:lnTo>
                  <a:lnTo>
                    <a:pt x="6558" y="16601"/>
                  </a:lnTo>
                  <a:lnTo>
                    <a:pt x="6651" y="16787"/>
                  </a:lnTo>
                  <a:lnTo>
                    <a:pt x="6837" y="16880"/>
                  </a:lnTo>
                  <a:lnTo>
                    <a:pt x="7023" y="16927"/>
                  </a:lnTo>
                  <a:lnTo>
                    <a:pt x="13068" y="16927"/>
                  </a:lnTo>
                  <a:lnTo>
                    <a:pt x="13254" y="16880"/>
                  </a:lnTo>
                  <a:lnTo>
                    <a:pt x="13440" y="16787"/>
                  </a:lnTo>
                  <a:lnTo>
                    <a:pt x="13533" y="16601"/>
                  </a:lnTo>
                  <a:lnTo>
                    <a:pt x="13579" y="16415"/>
                  </a:lnTo>
                  <a:lnTo>
                    <a:pt x="13579" y="5999"/>
                  </a:lnTo>
                  <a:lnTo>
                    <a:pt x="13533" y="5394"/>
                  </a:lnTo>
                  <a:lnTo>
                    <a:pt x="13440" y="4836"/>
                  </a:lnTo>
                  <a:lnTo>
                    <a:pt x="13300" y="4278"/>
                  </a:lnTo>
                  <a:lnTo>
                    <a:pt x="13114" y="3720"/>
                  </a:lnTo>
                  <a:lnTo>
                    <a:pt x="12882" y="3162"/>
                  </a:lnTo>
                  <a:lnTo>
                    <a:pt x="12556" y="2697"/>
                  </a:lnTo>
                  <a:lnTo>
                    <a:pt x="12184" y="2186"/>
                  </a:lnTo>
                  <a:lnTo>
                    <a:pt x="11812" y="1767"/>
                  </a:lnTo>
                  <a:lnTo>
                    <a:pt x="11347" y="1349"/>
                  </a:lnTo>
                  <a:lnTo>
                    <a:pt x="10882" y="1023"/>
                  </a:lnTo>
                  <a:lnTo>
                    <a:pt x="10371" y="698"/>
                  </a:lnTo>
                  <a:lnTo>
                    <a:pt x="9859" y="465"/>
                  </a:lnTo>
                  <a:lnTo>
                    <a:pt x="9301" y="279"/>
                  </a:lnTo>
                  <a:lnTo>
                    <a:pt x="8743" y="93"/>
                  </a:lnTo>
                  <a:lnTo>
                    <a:pt x="8139" y="47"/>
                  </a:lnTo>
                  <a:lnTo>
                    <a:pt x="7581"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2" name="Google Shape;402;p32"/>
            <p:cNvSpPr/>
            <p:nvPr/>
          </p:nvSpPr>
          <p:spPr>
            <a:xfrm>
              <a:off x="2545725" y="2673800"/>
              <a:ext cx="339500" cy="423175"/>
            </a:xfrm>
            <a:custGeom>
              <a:rect b="b" l="l" r="r" t="t"/>
              <a:pathLst>
                <a:path extrusionOk="0" fill="none" h="16927" w="13580">
                  <a:moveTo>
                    <a:pt x="11812" y="1767"/>
                  </a:moveTo>
                  <a:lnTo>
                    <a:pt x="11812" y="1767"/>
                  </a:lnTo>
                  <a:lnTo>
                    <a:pt x="11347" y="1349"/>
                  </a:lnTo>
                  <a:lnTo>
                    <a:pt x="10882" y="1023"/>
                  </a:lnTo>
                  <a:lnTo>
                    <a:pt x="10371" y="698"/>
                  </a:lnTo>
                  <a:lnTo>
                    <a:pt x="9859" y="465"/>
                  </a:lnTo>
                  <a:lnTo>
                    <a:pt x="9301" y="279"/>
                  </a:lnTo>
                  <a:lnTo>
                    <a:pt x="8743" y="93"/>
                  </a:lnTo>
                  <a:lnTo>
                    <a:pt x="8139" y="47"/>
                  </a:lnTo>
                  <a:lnTo>
                    <a:pt x="7581" y="0"/>
                  </a:lnTo>
                  <a:lnTo>
                    <a:pt x="7581" y="0"/>
                  </a:lnTo>
                  <a:lnTo>
                    <a:pt x="6976" y="47"/>
                  </a:lnTo>
                  <a:lnTo>
                    <a:pt x="6372" y="93"/>
                  </a:lnTo>
                  <a:lnTo>
                    <a:pt x="5814" y="279"/>
                  </a:lnTo>
                  <a:lnTo>
                    <a:pt x="5256" y="465"/>
                  </a:lnTo>
                  <a:lnTo>
                    <a:pt x="4744" y="698"/>
                  </a:lnTo>
                  <a:lnTo>
                    <a:pt x="4233" y="1023"/>
                  </a:lnTo>
                  <a:lnTo>
                    <a:pt x="3768" y="1349"/>
                  </a:lnTo>
                  <a:lnTo>
                    <a:pt x="3349" y="1767"/>
                  </a:lnTo>
                  <a:lnTo>
                    <a:pt x="3349" y="1767"/>
                  </a:lnTo>
                  <a:lnTo>
                    <a:pt x="2931" y="2186"/>
                  </a:lnTo>
                  <a:lnTo>
                    <a:pt x="2558" y="2697"/>
                  </a:lnTo>
                  <a:lnTo>
                    <a:pt x="2279" y="3162"/>
                  </a:lnTo>
                  <a:lnTo>
                    <a:pt x="2000" y="3720"/>
                  </a:lnTo>
                  <a:lnTo>
                    <a:pt x="1814" y="4278"/>
                  </a:lnTo>
                  <a:lnTo>
                    <a:pt x="1675" y="4836"/>
                  </a:lnTo>
                  <a:lnTo>
                    <a:pt x="1582" y="5394"/>
                  </a:lnTo>
                  <a:lnTo>
                    <a:pt x="1582" y="5999"/>
                  </a:lnTo>
                  <a:lnTo>
                    <a:pt x="1582" y="7255"/>
                  </a:lnTo>
                  <a:lnTo>
                    <a:pt x="94" y="10045"/>
                  </a:lnTo>
                  <a:lnTo>
                    <a:pt x="94" y="10045"/>
                  </a:lnTo>
                  <a:lnTo>
                    <a:pt x="47" y="10184"/>
                  </a:lnTo>
                  <a:lnTo>
                    <a:pt x="1" y="10277"/>
                  </a:lnTo>
                  <a:lnTo>
                    <a:pt x="47" y="10417"/>
                  </a:lnTo>
                  <a:lnTo>
                    <a:pt x="94" y="10556"/>
                  </a:lnTo>
                  <a:lnTo>
                    <a:pt x="94" y="10556"/>
                  </a:lnTo>
                  <a:lnTo>
                    <a:pt x="140" y="10649"/>
                  </a:lnTo>
                  <a:lnTo>
                    <a:pt x="280" y="10696"/>
                  </a:lnTo>
                  <a:lnTo>
                    <a:pt x="373" y="10742"/>
                  </a:lnTo>
                  <a:lnTo>
                    <a:pt x="512" y="10789"/>
                  </a:lnTo>
                  <a:lnTo>
                    <a:pt x="1582" y="10789"/>
                  </a:lnTo>
                  <a:lnTo>
                    <a:pt x="1582" y="11998"/>
                  </a:lnTo>
                  <a:lnTo>
                    <a:pt x="1582" y="11998"/>
                  </a:lnTo>
                  <a:lnTo>
                    <a:pt x="1582" y="12323"/>
                  </a:lnTo>
                  <a:lnTo>
                    <a:pt x="1628" y="12649"/>
                  </a:lnTo>
                  <a:lnTo>
                    <a:pt x="1721" y="12928"/>
                  </a:lnTo>
                  <a:lnTo>
                    <a:pt x="1814" y="13207"/>
                  </a:lnTo>
                  <a:lnTo>
                    <a:pt x="1954" y="13486"/>
                  </a:lnTo>
                  <a:lnTo>
                    <a:pt x="2093" y="13718"/>
                  </a:lnTo>
                  <a:lnTo>
                    <a:pt x="2279" y="13997"/>
                  </a:lnTo>
                  <a:lnTo>
                    <a:pt x="2465" y="14183"/>
                  </a:lnTo>
                  <a:lnTo>
                    <a:pt x="2698" y="14416"/>
                  </a:lnTo>
                  <a:lnTo>
                    <a:pt x="2931" y="14555"/>
                  </a:lnTo>
                  <a:lnTo>
                    <a:pt x="3210" y="14741"/>
                  </a:lnTo>
                  <a:lnTo>
                    <a:pt x="3489" y="14881"/>
                  </a:lnTo>
                  <a:lnTo>
                    <a:pt x="3768" y="14974"/>
                  </a:lnTo>
                  <a:lnTo>
                    <a:pt x="4047" y="15067"/>
                  </a:lnTo>
                  <a:lnTo>
                    <a:pt x="4372" y="15113"/>
                  </a:lnTo>
                  <a:lnTo>
                    <a:pt x="4698" y="15113"/>
                  </a:lnTo>
                  <a:lnTo>
                    <a:pt x="6511" y="15113"/>
                  </a:lnTo>
                  <a:lnTo>
                    <a:pt x="6511" y="16415"/>
                  </a:lnTo>
                  <a:lnTo>
                    <a:pt x="6511" y="16415"/>
                  </a:lnTo>
                  <a:lnTo>
                    <a:pt x="6558" y="16601"/>
                  </a:lnTo>
                  <a:lnTo>
                    <a:pt x="6651" y="16787"/>
                  </a:lnTo>
                  <a:lnTo>
                    <a:pt x="6837" y="16880"/>
                  </a:lnTo>
                  <a:lnTo>
                    <a:pt x="7023" y="16927"/>
                  </a:lnTo>
                  <a:lnTo>
                    <a:pt x="13068" y="16927"/>
                  </a:lnTo>
                  <a:lnTo>
                    <a:pt x="13068" y="16927"/>
                  </a:lnTo>
                  <a:lnTo>
                    <a:pt x="13254" y="16880"/>
                  </a:lnTo>
                  <a:lnTo>
                    <a:pt x="13440" y="16787"/>
                  </a:lnTo>
                  <a:lnTo>
                    <a:pt x="13533" y="16601"/>
                  </a:lnTo>
                  <a:lnTo>
                    <a:pt x="13579" y="16415"/>
                  </a:lnTo>
                  <a:lnTo>
                    <a:pt x="13579" y="5999"/>
                  </a:lnTo>
                  <a:lnTo>
                    <a:pt x="13579" y="5999"/>
                  </a:lnTo>
                  <a:lnTo>
                    <a:pt x="13533" y="5394"/>
                  </a:lnTo>
                  <a:lnTo>
                    <a:pt x="13440" y="4836"/>
                  </a:lnTo>
                  <a:lnTo>
                    <a:pt x="13300" y="4278"/>
                  </a:lnTo>
                  <a:lnTo>
                    <a:pt x="13114" y="3720"/>
                  </a:lnTo>
                  <a:lnTo>
                    <a:pt x="12882" y="3162"/>
                  </a:lnTo>
                  <a:lnTo>
                    <a:pt x="12556" y="2697"/>
                  </a:lnTo>
                  <a:lnTo>
                    <a:pt x="12184" y="2186"/>
                  </a:lnTo>
                  <a:lnTo>
                    <a:pt x="11812" y="1767"/>
                  </a:lnTo>
                  <a:lnTo>
                    <a:pt x="11812" y="1767"/>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3" name="Google Shape;403;p32"/>
            <p:cNvSpPr/>
            <p:nvPr/>
          </p:nvSpPr>
          <p:spPr>
            <a:xfrm>
              <a:off x="2759650" y="2777250"/>
              <a:ext cx="43025" cy="43050"/>
            </a:xfrm>
            <a:custGeom>
              <a:rect b="b" l="l" r="r" t="t"/>
              <a:pathLst>
                <a:path extrusionOk="0" fill="none" h="1722" w="1721">
                  <a:moveTo>
                    <a:pt x="884" y="1"/>
                  </a:moveTo>
                  <a:lnTo>
                    <a:pt x="884" y="1"/>
                  </a:lnTo>
                  <a:lnTo>
                    <a:pt x="1023" y="1"/>
                  </a:lnTo>
                  <a:lnTo>
                    <a:pt x="1209" y="94"/>
                  </a:lnTo>
                  <a:lnTo>
                    <a:pt x="1302" y="233"/>
                  </a:lnTo>
                  <a:lnTo>
                    <a:pt x="1349" y="373"/>
                  </a:lnTo>
                  <a:lnTo>
                    <a:pt x="1349" y="373"/>
                  </a:lnTo>
                  <a:lnTo>
                    <a:pt x="1488" y="419"/>
                  </a:lnTo>
                  <a:lnTo>
                    <a:pt x="1628" y="559"/>
                  </a:lnTo>
                  <a:lnTo>
                    <a:pt x="1721" y="698"/>
                  </a:lnTo>
                  <a:lnTo>
                    <a:pt x="1721" y="838"/>
                  </a:lnTo>
                  <a:lnTo>
                    <a:pt x="1721" y="838"/>
                  </a:lnTo>
                  <a:lnTo>
                    <a:pt x="1721" y="1024"/>
                  </a:lnTo>
                  <a:lnTo>
                    <a:pt x="1628" y="1163"/>
                  </a:lnTo>
                  <a:lnTo>
                    <a:pt x="1488" y="1256"/>
                  </a:lnTo>
                  <a:lnTo>
                    <a:pt x="1349" y="1349"/>
                  </a:lnTo>
                  <a:lnTo>
                    <a:pt x="1349" y="1349"/>
                  </a:lnTo>
                  <a:lnTo>
                    <a:pt x="1302" y="1489"/>
                  </a:lnTo>
                  <a:lnTo>
                    <a:pt x="1209" y="1628"/>
                  </a:lnTo>
                  <a:lnTo>
                    <a:pt x="1023" y="1675"/>
                  </a:lnTo>
                  <a:lnTo>
                    <a:pt x="884" y="1721"/>
                  </a:lnTo>
                  <a:lnTo>
                    <a:pt x="884" y="1721"/>
                  </a:lnTo>
                  <a:lnTo>
                    <a:pt x="698" y="1675"/>
                  </a:lnTo>
                  <a:lnTo>
                    <a:pt x="558" y="1628"/>
                  </a:lnTo>
                  <a:lnTo>
                    <a:pt x="465" y="1489"/>
                  </a:lnTo>
                  <a:lnTo>
                    <a:pt x="419" y="1349"/>
                  </a:lnTo>
                  <a:lnTo>
                    <a:pt x="419" y="1349"/>
                  </a:lnTo>
                  <a:lnTo>
                    <a:pt x="233" y="1256"/>
                  </a:lnTo>
                  <a:lnTo>
                    <a:pt x="140" y="1163"/>
                  </a:lnTo>
                  <a:lnTo>
                    <a:pt x="47" y="1024"/>
                  </a:lnTo>
                  <a:lnTo>
                    <a:pt x="0" y="838"/>
                  </a:lnTo>
                  <a:lnTo>
                    <a:pt x="0" y="838"/>
                  </a:lnTo>
                  <a:lnTo>
                    <a:pt x="47" y="698"/>
                  </a:lnTo>
                  <a:lnTo>
                    <a:pt x="140" y="559"/>
                  </a:lnTo>
                  <a:lnTo>
                    <a:pt x="233" y="419"/>
                  </a:lnTo>
                  <a:lnTo>
                    <a:pt x="419" y="373"/>
                  </a:lnTo>
                  <a:lnTo>
                    <a:pt x="419" y="373"/>
                  </a:lnTo>
                  <a:lnTo>
                    <a:pt x="465" y="233"/>
                  </a:lnTo>
                  <a:lnTo>
                    <a:pt x="558" y="94"/>
                  </a:lnTo>
                  <a:lnTo>
                    <a:pt x="698" y="1"/>
                  </a:lnTo>
                  <a:lnTo>
                    <a:pt x="884" y="1"/>
                  </a:lnTo>
                  <a:lnTo>
                    <a:pt x="884"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4" name="Google Shape;404;p32"/>
            <p:cNvSpPr/>
            <p:nvPr/>
          </p:nvSpPr>
          <p:spPr>
            <a:xfrm>
              <a:off x="2727100" y="2723775"/>
              <a:ext cx="43025" cy="43050"/>
            </a:xfrm>
            <a:custGeom>
              <a:rect b="b" l="l" r="r" t="t"/>
              <a:pathLst>
                <a:path extrusionOk="0" fill="none" h="1722" w="1721">
                  <a:moveTo>
                    <a:pt x="372" y="373"/>
                  </a:moveTo>
                  <a:lnTo>
                    <a:pt x="372" y="373"/>
                  </a:lnTo>
                  <a:lnTo>
                    <a:pt x="465" y="233"/>
                  </a:lnTo>
                  <a:lnTo>
                    <a:pt x="558" y="94"/>
                  </a:lnTo>
                  <a:lnTo>
                    <a:pt x="698" y="1"/>
                  </a:lnTo>
                  <a:lnTo>
                    <a:pt x="837" y="1"/>
                  </a:lnTo>
                  <a:lnTo>
                    <a:pt x="837" y="1"/>
                  </a:lnTo>
                  <a:lnTo>
                    <a:pt x="1023" y="1"/>
                  </a:lnTo>
                  <a:lnTo>
                    <a:pt x="1163" y="94"/>
                  </a:lnTo>
                  <a:lnTo>
                    <a:pt x="1256" y="233"/>
                  </a:lnTo>
                  <a:lnTo>
                    <a:pt x="1349" y="373"/>
                  </a:lnTo>
                  <a:lnTo>
                    <a:pt x="1349" y="373"/>
                  </a:lnTo>
                  <a:lnTo>
                    <a:pt x="1488" y="419"/>
                  </a:lnTo>
                  <a:lnTo>
                    <a:pt x="1628" y="559"/>
                  </a:lnTo>
                  <a:lnTo>
                    <a:pt x="1674" y="698"/>
                  </a:lnTo>
                  <a:lnTo>
                    <a:pt x="1721" y="838"/>
                  </a:lnTo>
                  <a:lnTo>
                    <a:pt x="1721" y="838"/>
                  </a:lnTo>
                  <a:lnTo>
                    <a:pt x="1674" y="1024"/>
                  </a:lnTo>
                  <a:lnTo>
                    <a:pt x="1628" y="1163"/>
                  </a:lnTo>
                  <a:lnTo>
                    <a:pt x="1488" y="1256"/>
                  </a:lnTo>
                  <a:lnTo>
                    <a:pt x="1349" y="1303"/>
                  </a:lnTo>
                  <a:lnTo>
                    <a:pt x="1349" y="1303"/>
                  </a:lnTo>
                  <a:lnTo>
                    <a:pt x="1256" y="1489"/>
                  </a:lnTo>
                  <a:lnTo>
                    <a:pt x="1163" y="1582"/>
                  </a:lnTo>
                  <a:lnTo>
                    <a:pt x="1023" y="1675"/>
                  </a:lnTo>
                  <a:lnTo>
                    <a:pt x="837" y="1721"/>
                  </a:lnTo>
                  <a:lnTo>
                    <a:pt x="837" y="1721"/>
                  </a:lnTo>
                  <a:lnTo>
                    <a:pt x="698" y="1675"/>
                  </a:lnTo>
                  <a:lnTo>
                    <a:pt x="558" y="1582"/>
                  </a:lnTo>
                  <a:lnTo>
                    <a:pt x="465" y="1489"/>
                  </a:lnTo>
                  <a:lnTo>
                    <a:pt x="372" y="1303"/>
                  </a:lnTo>
                  <a:lnTo>
                    <a:pt x="372" y="1303"/>
                  </a:lnTo>
                  <a:lnTo>
                    <a:pt x="233" y="1256"/>
                  </a:lnTo>
                  <a:lnTo>
                    <a:pt x="93" y="1163"/>
                  </a:lnTo>
                  <a:lnTo>
                    <a:pt x="47" y="1024"/>
                  </a:lnTo>
                  <a:lnTo>
                    <a:pt x="0" y="838"/>
                  </a:lnTo>
                  <a:lnTo>
                    <a:pt x="0" y="838"/>
                  </a:lnTo>
                  <a:lnTo>
                    <a:pt x="47" y="698"/>
                  </a:lnTo>
                  <a:lnTo>
                    <a:pt x="93" y="559"/>
                  </a:lnTo>
                  <a:lnTo>
                    <a:pt x="233" y="419"/>
                  </a:lnTo>
                  <a:lnTo>
                    <a:pt x="372" y="373"/>
                  </a:lnTo>
                  <a:lnTo>
                    <a:pt x="372" y="37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5" name="Google Shape;405;p32"/>
            <p:cNvSpPr/>
            <p:nvPr/>
          </p:nvSpPr>
          <p:spPr>
            <a:xfrm>
              <a:off x="2634100" y="2735400"/>
              <a:ext cx="197650" cy="188375"/>
            </a:xfrm>
            <a:custGeom>
              <a:rect b="b" l="l" r="r" t="t"/>
              <a:pathLst>
                <a:path extrusionOk="0" fill="none" h="7535" w="7906">
                  <a:moveTo>
                    <a:pt x="7859" y="4744"/>
                  </a:moveTo>
                  <a:lnTo>
                    <a:pt x="7859" y="4744"/>
                  </a:lnTo>
                  <a:lnTo>
                    <a:pt x="7626" y="5302"/>
                  </a:lnTo>
                  <a:lnTo>
                    <a:pt x="7301" y="5860"/>
                  </a:lnTo>
                  <a:lnTo>
                    <a:pt x="6929" y="6325"/>
                  </a:lnTo>
                  <a:lnTo>
                    <a:pt x="6417" y="6744"/>
                  </a:lnTo>
                  <a:lnTo>
                    <a:pt x="6417" y="6744"/>
                  </a:lnTo>
                  <a:lnTo>
                    <a:pt x="5906" y="7116"/>
                  </a:lnTo>
                  <a:lnTo>
                    <a:pt x="5301" y="7348"/>
                  </a:lnTo>
                  <a:lnTo>
                    <a:pt x="4697" y="7488"/>
                  </a:lnTo>
                  <a:lnTo>
                    <a:pt x="4046" y="7534"/>
                  </a:lnTo>
                  <a:lnTo>
                    <a:pt x="4046" y="7534"/>
                  </a:lnTo>
                  <a:lnTo>
                    <a:pt x="3627" y="7534"/>
                  </a:lnTo>
                  <a:lnTo>
                    <a:pt x="3209" y="7488"/>
                  </a:lnTo>
                  <a:lnTo>
                    <a:pt x="2837" y="7395"/>
                  </a:lnTo>
                  <a:lnTo>
                    <a:pt x="2465" y="7255"/>
                  </a:lnTo>
                  <a:lnTo>
                    <a:pt x="2139" y="7069"/>
                  </a:lnTo>
                  <a:lnTo>
                    <a:pt x="1767" y="6883"/>
                  </a:lnTo>
                  <a:lnTo>
                    <a:pt x="1488" y="6651"/>
                  </a:lnTo>
                  <a:lnTo>
                    <a:pt x="1209" y="6372"/>
                  </a:lnTo>
                  <a:lnTo>
                    <a:pt x="930" y="6093"/>
                  </a:lnTo>
                  <a:lnTo>
                    <a:pt x="698" y="5767"/>
                  </a:lnTo>
                  <a:lnTo>
                    <a:pt x="512" y="5442"/>
                  </a:lnTo>
                  <a:lnTo>
                    <a:pt x="326" y="5116"/>
                  </a:lnTo>
                  <a:lnTo>
                    <a:pt x="186" y="4744"/>
                  </a:lnTo>
                  <a:lnTo>
                    <a:pt x="93" y="4325"/>
                  </a:lnTo>
                  <a:lnTo>
                    <a:pt x="47" y="3953"/>
                  </a:lnTo>
                  <a:lnTo>
                    <a:pt x="0" y="3535"/>
                  </a:lnTo>
                  <a:lnTo>
                    <a:pt x="0" y="3535"/>
                  </a:lnTo>
                  <a:lnTo>
                    <a:pt x="47" y="3023"/>
                  </a:lnTo>
                  <a:lnTo>
                    <a:pt x="140" y="2465"/>
                  </a:lnTo>
                  <a:lnTo>
                    <a:pt x="326" y="2000"/>
                  </a:lnTo>
                  <a:lnTo>
                    <a:pt x="558" y="1535"/>
                  </a:lnTo>
                  <a:lnTo>
                    <a:pt x="837" y="1070"/>
                  </a:lnTo>
                  <a:lnTo>
                    <a:pt x="1209" y="698"/>
                  </a:lnTo>
                  <a:lnTo>
                    <a:pt x="1581" y="326"/>
                  </a:lnTo>
                  <a:lnTo>
                    <a:pt x="2046" y="47"/>
                  </a:lnTo>
                  <a:lnTo>
                    <a:pt x="2046" y="47"/>
                  </a:lnTo>
                  <a:lnTo>
                    <a:pt x="2186" y="1"/>
                  </a:lnTo>
                  <a:lnTo>
                    <a:pt x="2325" y="1"/>
                  </a:lnTo>
                  <a:lnTo>
                    <a:pt x="2465" y="1"/>
                  </a:lnTo>
                  <a:lnTo>
                    <a:pt x="2604" y="94"/>
                  </a:lnTo>
                  <a:lnTo>
                    <a:pt x="2604" y="94"/>
                  </a:lnTo>
                  <a:lnTo>
                    <a:pt x="2697" y="187"/>
                  </a:lnTo>
                  <a:lnTo>
                    <a:pt x="2744" y="326"/>
                  </a:lnTo>
                  <a:lnTo>
                    <a:pt x="2790" y="466"/>
                  </a:lnTo>
                  <a:lnTo>
                    <a:pt x="2744" y="605"/>
                  </a:lnTo>
                  <a:lnTo>
                    <a:pt x="2744" y="605"/>
                  </a:lnTo>
                  <a:lnTo>
                    <a:pt x="2697" y="977"/>
                  </a:lnTo>
                  <a:lnTo>
                    <a:pt x="2651" y="1303"/>
                  </a:lnTo>
                  <a:lnTo>
                    <a:pt x="2651" y="1675"/>
                  </a:lnTo>
                  <a:lnTo>
                    <a:pt x="2651" y="2000"/>
                  </a:lnTo>
                  <a:lnTo>
                    <a:pt x="2744" y="2372"/>
                  </a:lnTo>
                  <a:lnTo>
                    <a:pt x="2883" y="2698"/>
                  </a:lnTo>
                  <a:lnTo>
                    <a:pt x="3023" y="3023"/>
                  </a:lnTo>
                  <a:lnTo>
                    <a:pt x="3209" y="3302"/>
                  </a:lnTo>
                  <a:lnTo>
                    <a:pt x="3209" y="3302"/>
                  </a:lnTo>
                  <a:lnTo>
                    <a:pt x="3441" y="3581"/>
                  </a:lnTo>
                  <a:lnTo>
                    <a:pt x="3720" y="3860"/>
                  </a:lnTo>
                  <a:lnTo>
                    <a:pt x="3999" y="4046"/>
                  </a:lnTo>
                  <a:lnTo>
                    <a:pt x="4278" y="4232"/>
                  </a:lnTo>
                  <a:lnTo>
                    <a:pt x="4604" y="4372"/>
                  </a:lnTo>
                  <a:lnTo>
                    <a:pt x="4929" y="4465"/>
                  </a:lnTo>
                  <a:lnTo>
                    <a:pt x="5301" y="4511"/>
                  </a:lnTo>
                  <a:lnTo>
                    <a:pt x="5673" y="4558"/>
                  </a:lnTo>
                  <a:lnTo>
                    <a:pt x="5673" y="4558"/>
                  </a:lnTo>
                  <a:lnTo>
                    <a:pt x="6045" y="4511"/>
                  </a:lnTo>
                  <a:lnTo>
                    <a:pt x="6417" y="4465"/>
                  </a:lnTo>
                  <a:lnTo>
                    <a:pt x="6789" y="4325"/>
                  </a:lnTo>
                  <a:lnTo>
                    <a:pt x="7161" y="4139"/>
                  </a:lnTo>
                  <a:lnTo>
                    <a:pt x="7161" y="4139"/>
                  </a:lnTo>
                  <a:lnTo>
                    <a:pt x="7301" y="4093"/>
                  </a:lnTo>
                  <a:lnTo>
                    <a:pt x="7440" y="4093"/>
                  </a:lnTo>
                  <a:lnTo>
                    <a:pt x="7580" y="4139"/>
                  </a:lnTo>
                  <a:lnTo>
                    <a:pt x="7719" y="4186"/>
                  </a:lnTo>
                  <a:lnTo>
                    <a:pt x="7719" y="4186"/>
                  </a:lnTo>
                  <a:lnTo>
                    <a:pt x="7812" y="4325"/>
                  </a:lnTo>
                  <a:lnTo>
                    <a:pt x="7859" y="4418"/>
                  </a:lnTo>
                  <a:lnTo>
                    <a:pt x="7905" y="4558"/>
                  </a:lnTo>
                  <a:lnTo>
                    <a:pt x="7859" y="4744"/>
                  </a:lnTo>
                  <a:lnTo>
                    <a:pt x="7859" y="4744"/>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6" name="Google Shape;406;p32"/>
            <p:cNvSpPr/>
            <p:nvPr/>
          </p:nvSpPr>
          <p:spPr>
            <a:xfrm>
              <a:off x="2830550" y="2854000"/>
              <a:ext cx="25" cy="0"/>
            </a:xfrm>
            <a:custGeom>
              <a:rect b="b" l="l" r="r" t="t"/>
              <a:pathLst>
                <a:path extrusionOk="0" fill="none" h="0" w="1">
                  <a:moveTo>
                    <a:pt x="1" y="0"/>
                  </a:moveTo>
                  <a:lnTo>
                    <a:pt x="1"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7" name="Google Shape;407;p32"/>
            <p:cNvSpPr/>
            <p:nvPr/>
          </p:nvSpPr>
          <p:spPr>
            <a:xfrm>
              <a:off x="2659675" y="2777250"/>
              <a:ext cx="133700" cy="122100"/>
            </a:xfrm>
            <a:custGeom>
              <a:rect b="b" l="l" r="r" t="t"/>
              <a:pathLst>
                <a:path extrusionOk="0" h="4884" w="5348">
                  <a:moveTo>
                    <a:pt x="605" y="1"/>
                  </a:moveTo>
                  <a:lnTo>
                    <a:pt x="326" y="419"/>
                  </a:lnTo>
                  <a:lnTo>
                    <a:pt x="140" y="884"/>
                  </a:lnTo>
                  <a:lnTo>
                    <a:pt x="47" y="1349"/>
                  </a:lnTo>
                  <a:lnTo>
                    <a:pt x="0" y="1861"/>
                  </a:lnTo>
                  <a:lnTo>
                    <a:pt x="0" y="2186"/>
                  </a:lnTo>
                  <a:lnTo>
                    <a:pt x="47" y="2465"/>
                  </a:lnTo>
                  <a:lnTo>
                    <a:pt x="140" y="2744"/>
                  </a:lnTo>
                  <a:lnTo>
                    <a:pt x="233" y="3023"/>
                  </a:lnTo>
                  <a:lnTo>
                    <a:pt x="326" y="3303"/>
                  </a:lnTo>
                  <a:lnTo>
                    <a:pt x="512" y="3535"/>
                  </a:lnTo>
                  <a:lnTo>
                    <a:pt x="884" y="4000"/>
                  </a:lnTo>
                  <a:lnTo>
                    <a:pt x="1302" y="4372"/>
                  </a:lnTo>
                  <a:lnTo>
                    <a:pt x="1581" y="4512"/>
                  </a:lnTo>
                  <a:lnTo>
                    <a:pt x="1814" y="4651"/>
                  </a:lnTo>
                  <a:lnTo>
                    <a:pt x="2093" y="4744"/>
                  </a:lnTo>
                  <a:lnTo>
                    <a:pt x="2418" y="4837"/>
                  </a:lnTo>
                  <a:lnTo>
                    <a:pt x="2697" y="4884"/>
                  </a:lnTo>
                  <a:lnTo>
                    <a:pt x="3348" y="4884"/>
                  </a:lnTo>
                  <a:lnTo>
                    <a:pt x="3674" y="4837"/>
                  </a:lnTo>
                  <a:lnTo>
                    <a:pt x="3999" y="4744"/>
                  </a:lnTo>
                  <a:lnTo>
                    <a:pt x="4325" y="4605"/>
                  </a:lnTo>
                  <a:lnTo>
                    <a:pt x="4604" y="4465"/>
                  </a:lnTo>
                  <a:lnTo>
                    <a:pt x="4883" y="4279"/>
                  </a:lnTo>
                  <a:lnTo>
                    <a:pt x="5115" y="4047"/>
                  </a:lnTo>
                  <a:lnTo>
                    <a:pt x="5348" y="3814"/>
                  </a:lnTo>
                  <a:lnTo>
                    <a:pt x="5348" y="3814"/>
                  </a:lnTo>
                  <a:lnTo>
                    <a:pt x="4976" y="3861"/>
                  </a:lnTo>
                  <a:lnTo>
                    <a:pt x="4650" y="3861"/>
                  </a:lnTo>
                  <a:lnTo>
                    <a:pt x="4139" y="3814"/>
                  </a:lnTo>
                  <a:lnTo>
                    <a:pt x="3674" y="3768"/>
                  </a:lnTo>
                  <a:lnTo>
                    <a:pt x="3255" y="3628"/>
                  </a:lnTo>
                  <a:lnTo>
                    <a:pt x="2837" y="3442"/>
                  </a:lnTo>
                  <a:lnTo>
                    <a:pt x="2418" y="3210"/>
                  </a:lnTo>
                  <a:lnTo>
                    <a:pt x="2046" y="2930"/>
                  </a:lnTo>
                  <a:lnTo>
                    <a:pt x="1721" y="2605"/>
                  </a:lnTo>
                  <a:lnTo>
                    <a:pt x="1395" y="2233"/>
                  </a:lnTo>
                  <a:lnTo>
                    <a:pt x="1070" y="1721"/>
                  </a:lnTo>
                  <a:lnTo>
                    <a:pt x="837" y="1163"/>
                  </a:lnTo>
                  <a:lnTo>
                    <a:pt x="698" y="605"/>
                  </a:lnTo>
                  <a:lnTo>
                    <a:pt x="605"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8" name="Google Shape;408;p32"/>
            <p:cNvSpPr/>
            <p:nvPr/>
          </p:nvSpPr>
          <p:spPr>
            <a:xfrm>
              <a:off x="2659675" y="2777250"/>
              <a:ext cx="133700" cy="122100"/>
            </a:xfrm>
            <a:custGeom>
              <a:rect b="b" l="l" r="r" t="t"/>
              <a:pathLst>
                <a:path extrusionOk="0" fill="none" h="4884" w="5348">
                  <a:moveTo>
                    <a:pt x="1395" y="2233"/>
                  </a:moveTo>
                  <a:lnTo>
                    <a:pt x="1395" y="2233"/>
                  </a:lnTo>
                  <a:lnTo>
                    <a:pt x="1070" y="1721"/>
                  </a:lnTo>
                  <a:lnTo>
                    <a:pt x="837" y="1163"/>
                  </a:lnTo>
                  <a:lnTo>
                    <a:pt x="698" y="605"/>
                  </a:lnTo>
                  <a:lnTo>
                    <a:pt x="605" y="1"/>
                  </a:lnTo>
                  <a:lnTo>
                    <a:pt x="605" y="1"/>
                  </a:lnTo>
                  <a:lnTo>
                    <a:pt x="326" y="419"/>
                  </a:lnTo>
                  <a:lnTo>
                    <a:pt x="140" y="884"/>
                  </a:lnTo>
                  <a:lnTo>
                    <a:pt x="47" y="1349"/>
                  </a:lnTo>
                  <a:lnTo>
                    <a:pt x="0" y="1861"/>
                  </a:lnTo>
                  <a:lnTo>
                    <a:pt x="0" y="1861"/>
                  </a:lnTo>
                  <a:lnTo>
                    <a:pt x="0" y="2186"/>
                  </a:lnTo>
                  <a:lnTo>
                    <a:pt x="47" y="2465"/>
                  </a:lnTo>
                  <a:lnTo>
                    <a:pt x="140" y="2744"/>
                  </a:lnTo>
                  <a:lnTo>
                    <a:pt x="233" y="3023"/>
                  </a:lnTo>
                  <a:lnTo>
                    <a:pt x="326" y="3303"/>
                  </a:lnTo>
                  <a:lnTo>
                    <a:pt x="512" y="3535"/>
                  </a:lnTo>
                  <a:lnTo>
                    <a:pt x="884" y="4000"/>
                  </a:lnTo>
                  <a:lnTo>
                    <a:pt x="1302" y="4372"/>
                  </a:lnTo>
                  <a:lnTo>
                    <a:pt x="1581" y="4512"/>
                  </a:lnTo>
                  <a:lnTo>
                    <a:pt x="1814" y="4651"/>
                  </a:lnTo>
                  <a:lnTo>
                    <a:pt x="2093" y="4744"/>
                  </a:lnTo>
                  <a:lnTo>
                    <a:pt x="2418" y="4837"/>
                  </a:lnTo>
                  <a:lnTo>
                    <a:pt x="2697" y="4884"/>
                  </a:lnTo>
                  <a:lnTo>
                    <a:pt x="3023" y="4884"/>
                  </a:lnTo>
                  <a:lnTo>
                    <a:pt x="3023" y="4884"/>
                  </a:lnTo>
                  <a:lnTo>
                    <a:pt x="3348" y="4884"/>
                  </a:lnTo>
                  <a:lnTo>
                    <a:pt x="3674" y="4837"/>
                  </a:lnTo>
                  <a:lnTo>
                    <a:pt x="3999" y="4744"/>
                  </a:lnTo>
                  <a:lnTo>
                    <a:pt x="4325" y="4605"/>
                  </a:lnTo>
                  <a:lnTo>
                    <a:pt x="4604" y="4465"/>
                  </a:lnTo>
                  <a:lnTo>
                    <a:pt x="4883" y="4279"/>
                  </a:lnTo>
                  <a:lnTo>
                    <a:pt x="5115" y="4047"/>
                  </a:lnTo>
                  <a:lnTo>
                    <a:pt x="5348" y="3814"/>
                  </a:lnTo>
                  <a:lnTo>
                    <a:pt x="5348" y="3814"/>
                  </a:lnTo>
                  <a:lnTo>
                    <a:pt x="4976" y="3861"/>
                  </a:lnTo>
                  <a:lnTo>
                    <a:pt x="4650" y="3861"/>
                  </a:lnTo>
                  <a:lnTo>
                    <a:pt x="4650" y="3861"/>
                  </a:lnTo>
                  <a:lnTo>
                    <a:pt x="4139" y="3814"/>
                  </a:lnTo>
                  <a:lnTo>
                    <a:pt x="3674" y="3768"/>
                  </a:lnTo>
                  <a:lnTo>
                    <a:pt x="3255" y="3628"/>
                  </a:lnTo>
                  <a:lnTo>
                    <a:pt x="2837" y="3442"/>
                  </a:lnTo>
                  <a:lnTo>
                    <a:pt x="2418" y="3210"/>
                  </a:lnTo>
                  <a:lnTo>
                    <a:pt x="2046" y="2930"/>
                  </a:lnTo>
                  <a:lnTo>
                    <a:pt x="1721" y="2605"/>
                  </a:lnTo>
                  <a:lnTo>
                    <a:pt x="1395" y="2233"/>
                  </a:lnTo>
                  <a:lnTo>
                    <a:pt x="1395" y="2233"/>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09" name="Google Shape;409;p32"/>
            <p:cNvSpPr/>
            <p:nvPr/>
          </p:nvSpPr>
          <p:spPr>
            <a:xfrm>
              <a:off x="2694550" y="28330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410" name="Google Shape;410;p32"/>
          <p:cNvSpPr txBox="1"/>
          <p:nvPr>
            <p:ph idx="1" type="body"/>
          </p:nvPr>
        </p:nvSpPr>
        <p:spPr>
          <a:xfrm>
            <a:off x="1426225" y="1484330"/>
            <a:ext cx="7190700" cy="706200"/>
          </a:xfrm>
          <a:prstGeom prst="rect">
            <a:avLst/>
          </a:prstGeom>
        </p:spPr>
        <p:txBody>
          <a:bodyPr anchorCtr="0" anchor="t" bIns="91425" lIns="91425" spcFirstLastPara="1" rIns="91425" wrap="square" tIns="91425">
            <a:normAutofit lnSpcReduction="20000"/>
          </a:bodyPr>
          <a:lstStyle/>
          <a:p>
            <a:pPr indent="0" lvl="0" marL="0" rtl="0" algn="l">
              <a:spcBef>
                <a:spcPts val="0"/>
              </a:spcBef>
              <a:spcAft>
                <a:spcPts val="1200"/>
              </a:spcAft>
              <a:buNone/>
            </a:pPr>
            <a:r>
              <a:rPr b="1" lang="en" sz="1800"/>
              <a:t>South Asians</a:t>
            </a:r>
            <a:r>
              <a:rPr lang="en" sz="1800"/>
              <a:t> often describe psychological distress in the form of physical symptoms: lack of sleep, body aches, digestive problems </a:t>
            </a:r>
            <a:endParaRPr sz="1800"/>
          </a:p>
        </p:txBody>
      </p:sp>
      <p:sp>
        <p:nvSpPr>
          <p:cNvPr id="411" name="Google Shape;411;p3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412" name="Google Shape;412;p32"/>
          <p:cNvSpPr txBox="1"/>
          <p:nvPr/>
        </p:nvSpPr>
        <p:spPr>
          <a:xfrm>
            <a:off x="1426225" y="3278425"/>
            <a:ext cx="7190700" cy="1015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1600"/>
              </a:spcAft>
              <a:buNone/>
            </a:pPr>
            <a:r>
              <a:rPr b="1" lang="en" sz="1800">
                <a:solidFill>
                  <a:srgbClr val="434343"/>
                </a:solidFill>
                <a:latin typeface="Hind"/>
                <a:ea typeface="Hind"/>
                <a:cs typeface="Hind"/>
                <a:sym typeface="Hind"/>
              </a:rPr>
              <a:t>Native Hawaiians</a:t>
            </a:r>
            <a:r>
              <a:rPr lang="en" sz="1800">
                <a:solidFill>
                  <a:srgbClr val="434343"/>
                </a:solidFill>
                <a:latin typeface="Hind"/>
                <a:ea typeface="Hind"/>
                <a:cs typeface="Hind"/>
                <a:sym typeface="Hind"/>
              </a:rPr>
              <a:t> prefer traditional healing practices and health management and thus rely on a more holistic, integrative approach to health (including physical, spiritual, emotional, and mental spheres)</a:t>
            </a:r>
            <a:endParaRPr sz="1800">
              <a:solidFill>
                <a:srgbClr val="434343"/>
              </a:solidFill>
              <a:latin typeface="Hind"/>
              <a:ea typeface="Hind"/>
              <a:cs typeface="Hind"/>
              <a:sym typeface="Hind"/>
            </a:endParaRPr>
          </a:p>
        </p:txBody>
      </p:sp>
      <p:sp>
        <p:nvSpPr>
          <p:cNvPr id="413" name="Google Shape;413;p32"/>
          <p:cNvSpPr txBox="1"/>
          <p:nvPr/>
        </p:nvSpPr>
        <p:spPr>
          <a:xfrm>
            <a:off x="1426225" y="2403125"/>
            <a:ext cx="68244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1600"/>
              </a:spcAft>
              <a:buNone/>
            </a:pPr>
            <a:r>
              <a:rPr b="1" lang="en" sz="1800">
                <a:solidFill>
                  <a:srgbClr val="434343"/>
                </a:solidFill>
                <a:latin typeface="Hind"/>
                <a:ea typeface="Hind"/>
                <a:cs typeface="Hind"/>
                <a:sym typeface="Hind"/>
              </a:rPr>
              <a:t>Korean</a:t>
            </a:r>
            <a:r>
              <a:rPr lang="en" sz="1800">
                <a:solidFill>
                  <a:srgbClr val="434343"/>
                </a:solidFill>
                <a:latin typeface="Hind"/>
                <a:ea typeface="Hind"/>
                <a:cs typeface="Hind"/>
                <a:sym typeface="Hind"/>
              </a:rPr>
              <a:t> hwabyung (“anger syndrome”) presents as insomnia, fatigue, panic, and other physical symptoms</a:t>
            </a:r>
            <a:endParaRPr sz="1800">
              <a:solidFill>
                <a:srgbClr val="434343"/>
              </a:solidFill>
              <a:latin typeface="Hind"/>
              <a:ea typeface="Hind"/>
              <a:cs typeface="Hind"/>
              <a:sym typeface="Hind"/>
            </a:endParaRPr>
          </a:p>
        </p:txBody>
      </p:sp>
      <p:sp>
        <p:nvSpPr>
          <p:cNvPr id="414" name="Google Shape;414;p32"/>
          <p:cNvSpPr/>
          <p:nvPr/>
        </p:nvSpPr>
        <p:spPr>
          <a:xfrm>
            <a:off x="8619350" y="362675"/>
            <a:ext cx="417600" cy="393600"/>
          </a:xfrm>
          <a:prstGeom prst="rect">
            <a:avLst/>
          </a:prstGeom>
          <a:solidFill>
            <a:schemeClr val="accent6"/>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415" name="Google Shape;415;p32"/>
          <p:cNvSpPr txBox="1"/>
          <p:nvPr>
            <p:ph type="title"/>
          </p:nvPr>
        </p:nvSpPr>
        <p:spPr>
          <a:xfrm>
            <a:off x="93900" y="362675"/>
            <a:ext cx="89562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100"/>
              <a:t>Examples of differing subgroup </a:t>
            </a:r>
            <a:r>
              <a:rPr lang="en" sz="3100">
                <a:solidFill>
                  <a:srgbClr val="EAB56F"/>
                </a:solidFill>
              </a:rPr>
              <a:t>presentations</a:t>
            </a:r>
            <a:endParaRPr sz="3100">
              <a:solidFill>
                <a:srgbClr val="EAB56F"/>
              </a:solidFill>
            </a:endParaRPr>
          </a:p>
        </p:txBody>
      </p:sp>
      <p:sp>
        <p:nvSpPr>
          <p:cNvPr id="416" name="Google Shape;416;p32"/>
          <p:cNvSpPr/>
          <p:nvPr/>
        </p:nvSpPr>
        <p:spPr>
          <a:xfrm rot="-5971637">
            <a:off x="209997" y="3469712"/>
            <a:ext cx="435000" cy="603526"/>
          </a:xfrm>
          <a:prstGeom prst="rtTriangle">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417" name="Google Shape;417;p32"/>
          <p:cNvSpPr/>
          <p:nvPr/>
        </p:nvSpPr>
        <p:spPr>
          <a:xfrm>
            <a:off x="712625" y="3463525"/>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418" name="Google Shape;418;p32"/>
          <p:cNvGrpSpPr/>
          <p:nvPr/>
        </p:nvGrpSpPr>
        <p:grpSpPr>
          <a:xfrm>
            <a:off x="880119" y="3609926"/>
            <a:ext cx="310602" cy="352803"/>
            <a:chOff x="-28069875" y="3175300"/>
            <a:chExt cx="260725" cy="296150"/>
          </a:xfrm>
        </p:grpSpPr>
        <p:sp>
          <p:nvSpPr>
            <p:cNvPr id="419" name="Google Shape;419;p32"/>
            <p:cNvSpPr/>
            <p:nvPr/>
          </p:nvSpPr>
          <p:spPr>
            <a:xfrm>
              <a:off x="-28059650" y="3192625"/>
              <a:ext cx="26025" cy="70125"/>
            </a:xfrm>
            <a:custGeom>
              <a:rect b="b" l="l" r="r" t="t"/>
              <a:pathLst>
                <a:path extrusionOk="0" h="2805" w="1041">
                  <a:moveTo>
                    <a:pt x="536" y="0"/>
                  </a:moveTo>
                  <a:cubicBezTo>
                    <a:pt x="253" y="0"/>
                    <a:pt x="1" y="252"/>
                    <a:pt x="1" y="536"/>
                  </a:cubicBezTo>
                  <a:lnTo>
                    <a:pt x="1" y="2458"/>
                  </a:lnTo>
                  <a:cubicBezTo>
                    <a:pt x="410" y="2458"/>
                    <a:pt x="757" y="2584"/>
                    <a:pt x="1040" y="2804"/>
                  </a:cubicBezTo>
                  <a:lnTo>
                    <a:pt x="1040" y="536"/>
                  </a:lnTo>
                  <a:cubicBezTo>
                    <a:pt x="1040" y="252"/>
                    <a:pt x="788" y="0"/>
                    <a:pt x="536" y="0"/>
                  </a:cubicBezTo>
                  <a:close/>
                </a:path>
              </a:pathLst>
            </a:custGeom>
            <a:solidFill>
              <a:srgbClr val="22222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0" name="Google Shape;420;p32"/>
            <p:cNvSpPr/>
            <p:nvPr/>
          </p:nvSpPr>
          <p:spPr>
            <a:xfrm>
              <a:off x="-27843050" y="3192625"/>
              <a:ext cx="26025" cy="69325"/>
            </a:xfrm>
            <a:custGeom>
              <a:rect b="b" l="l" r="r" t="t"/>
              <a:pathLst>
                <a:path extrusionOk="0" h="2773" w="1041">
                  <a:moveTo>
                    <a:pt x="536" y="0"/>
                  </a:moveTo>
                  <a:cubicBezTo>
                    <a:pt x="253" y="0"/>
                    <a:pt x="1" y="252"/>
                    <a:pt x="1" y="536"/>
                  </a:cubicBezTo>
                  <a:lnTo>
                    <a:pt x="1" y="2773"/>
                  </a:lnTo>
                  <a:cubicBezTo>
                    <a:pt x="284" y="2584"/>
                    <a:pt x="694" y="2426"/>
                    <a:pt x="1040" y="2426"/>
                  </a:cubicBezTo>
                  <a:lnTo>
                    <a:pt x="1040" y="536"/>
                  </a:lnTo>
                  <a:cubicBezTo>
                    <a:pt x="1040" y="252"/>
                    <a:pt x="788" y="0"/>
                    <a:pt x="536" y="0"/>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1" name="Google Shape;421;p32"/>
            <p:cNvSpPr/>
            <p:nvPr/>
          </p:nvSpPr>
          <p:spPr>
            <a:xfrm>
              <a:off x="-27973000" y="3202075"/>
              <a:ext cx="26000" cy="57525"/>
            </a:xfrm>
            <a:custGeom>
              <a:rect b="b" l="l" r="r" t="t"/>
              <a:pathLst>
                <a:path extrusionOk="0" h="2301" w="1040">
                  <a:moveTo>
                    <a:pt x="536" y="0"/>
                  </a:moveTo>
                  <a:cubicBezTo>
                    <a:pt x="252" y="0"/>
                    <a:pt x="0" y="221"/>
                    <a:pt x="0" y="504"/>
                  </a:cubicBezTo>
                  <a:lnTo>
                    <a:pt x="0" y="1954"/>
                  </a:lnTo>
                  <a:cubicBezTo>
                    <a:pt x="410" y="1985"/>
                    <a:pt x="756" y="2080"/>
                    <a:pt x="1040" y="2300"/>
                  </a:cubicBezTo>
                  <a:lnTo>
                    <a:pt x="1040" y="504"/>
                  </a:lnTo>
                  <a:cubicBezTo>
                    <a:pt x="1040" y="221"/>
                    <a:pt x="788" y="0"/>
                    <a:pt x="536" y="0"/>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2" name="Google Shape;422;p32"/>
            <p:cNvSpPr/>
            <p:nvPr/>
          </p:nvSpPr>
          <p:spPr>
            <a:xfrm>
              <a:off x="-27929675" y="3202075"/>
              <a:ext cx="26000" cy="57525"/>
            </a:xfrm>
            <a:custGeom>
              <a:rect b="b" l="l" r="r" t="t"/>
              <a:pathLst>
                <a:path extrusionOk="0" h="2301" w="1040">
                  <a:moveTo>
                    <a:pt x="536" y="0"/>
                  </a:moveTo>
                  <a:cubicBezTo>
                    <a:pt x="252" y="0"/>
                    <a:pt x="0" y="221"/>
                    <a:pt x="0" y="504"/>
                  </a:cubicBezTo>
                  <a:lnTo>
                    <a:pt x="0" y="2300"/>
                  </a:lnTo>
                  <a:cubicBezTo>
                    <a:pt x="315" y="2111"/>
                    <a:pt x="693" y="1985"/>
                    <a:pt x="1040" y="1954"/>
                  </a:cubicBezTo>
                  <a:lnTo>
                    <a:pt x="1040" y="504"/>
                  </a:lnTo>
                  <a:cubicBezTo>
                    <a:pt x="1040" y="221"/>
                    <a:pt x="788" y="0"/>
                    <a:pt x="536" y="0"/>
                  </a:cubicBezTo>
                  <a:close/>
                </a:path>
              </a:pathLst>
            </a:custGeom>
            <a:solidFill>
              <a:srgbClr val="22222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3" name="Google Shape;423;p32"/>
            <p:cNvSpPr/>
            <p:nvPr/>
          </p:nvSpPr>
          <p:spPr>
            <a:xfrm>
              <a:off x="-28016325" y="3175300"/>
              <a:ext cx="26025" cy="91375"/>
            </a:xfrm>
            <a:custGeom>
              <a:rect b="b" l="l" r="r" t="t"/>
              <a:pathLst>
                <a:path extrusionOk="0" h="3655" w="1041">
                  <a:moveTo>
                    <a:pt x="536" y="0"/>
                  </a:moveTo>
                  <a:cubicBezTo>
                    <a:pt x="253" y="0"/>
                    <a:pt x="1" y="221"/>
                    <a:pt x="1" y="504"/>
                  </a:cubicBezTo>
                  <a:lnTo>
                    <a:pt x="1" y="3655"/>
                  </a:lnTo>
                  <a:cubicBezTo>
                    <a:pt x="1" y="3655"/>
                    <a:pt x="1" y="3623"/>
                    <a:pt x="64" y="3623"/>
                  </a:cubicBezTo>
                  <a:cubicBezTo>
                    <a:pt x="284" y="3371"/>
                    <a:pt x="631" y="3182"/>
                    <a:pt x="1040" y="3056"/>
                  </a:cubicBezTo>
                  <a:lnTo>
                    <a:pt x="1040" y="504"/>
                  </a:lnTo>
                  <a:cubicBezTo>
                    <a:pt x="1040" y="221"/>
                    <a:pt x="788" y="0"/>
                    <a:pt x="536" y="0"/>
                  </a:cubicBezTo>
                  <a:close/>
                </a:path>
              </a:pathLst>
            </a:custGeom>
            <a:solidFill>
              <a:srgbClr val="22222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4" name="Google Shape;424;p32"/>
            <p:cNvSpPr/>
            <p:nvPr/>
          </p:nvSpPr>
          <p:spPr>
            <a:xfrm>
              <a:off x="-27886375" y="3176075"/>
              <a:ext cx="26025" cy="91400"/>
            </a:xfrm>
            <a:custGeom>
              <a:rect b="b" l="l" r="r" t="t"/>
              <a:pathLst>
                <a:path extrusionOk="0" h="3656" w="1041">
                  <a:moveTo>
                    <a:pt x="536" y="1"/>
                  </a:moveTo>
                  <a:cubicBezTo>
                    <a:pt x="253" y="1"/>
                    <a:pt x="1" y="221"/>
                    <a:pt x="1" y="505"/>
                  </a:cubicBezTo>
                  <a:lnTo>
                    <a:pt x="1" y="3088"/>
                  </a:lnTo>
                  <a:cubicBezTo>
                    <a:pt x="379" y="3151"/>
                    <a:pt x="726" y="3340"/>
                    <a:pt x="1041" y="3655"/>
                  </a:cubicBezTo>
                  <a:lnTo>
                    <a:pt x="1041" y="505"/>
                  </a:lnTo>
                  <a:cubicBezTo>
                    <a:pt x="1041" y="253"/>
                    <a:pt x="789" y="1"/>
                    <a:pt x="536" y="1"/>
                  </a:cubicBezTo>
                  <a:close/>
                </a:path>
              </a:pathLst>
            </a:custGeom>
            <a:solidFill>
              <a:srgbClr val="22222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5" name="Google Shape;425;p32"/>
            <p:cNvSpPr/>
            <p:nvPr/>
          </p:nvSpPr>
          <p:spPr>
            <a:xfrm>
              <a:off x="-28017900" y="3269025"/>
              <a:ext cx="161475" cy="133125"/>
            </a:xfrm>
            <a:custGeom>
              <a:rect b="b" l="l" r="r" t="t"/>
              <a:pathLst>
                <a:path extrusionOk="0" h="5325" w="6459">
                  <a:moveTo>
                    <a:pt x="1733" y="0"/>
                  </a:moveTo>
                  <a:cubicBezTo>
                    <a:pt x="1355" y="0"/>
                    <a:pt x="946" y="158"/>
                    <a:pt x="662" y="410"/>
                  </a:cubicBezTo>
                  <a:cubicBezTo>
                    <a:pt x="64" y="882"/>
                    <a:pt x="1" y="1639"/>
                    <a:pt x="347" y="2237"/>
                  </a:cubicBezTo>
                  <a:cubicBezTo>
                    <a:pt x="1324" y="2458"/>
                    <a:pt x="2048" y="3340"/>
                    <a:pt x="2174" y="4348"/>
                  </a:cubicBezTo>
                  <a:lnTo>
                    <a:pt x="3214" y="5325"/>
                  </a:lnTo>
                  <a:lnTo>
                    <a:pt x="4285" y="4348"/>
                  </a:lnTo>
                  <a:cubicBezTo>
                    <a:pt x="4380" y="3340"/>
                    <a:pt x="5073" y="2521"/>
                    <a:pt x="6113" y="2237"/>
                  </a:cubicBezTo>
                  <a:cubicBezTo>
                    <a:pt x="6459" y="1639"/>
                    <a:pt x="6333" y="882"/>
                    <a:pt x="5860" y="410"/>
                  </a:cubicBezTo>
                  <a:cubicBezTo>
                    <a:pt x="5577" y="158"/>
                    <a:pt x="5199" y="0"/>
                    <a:pt x="4789" y="0"/>
                  </a:cubicBezTo>
                  <a:cubicBezTo>
                    <a:pt x="4411" y="0"/>
                    <a:pt x="4002" y="158"/>
                    <a:pt x="3750" y="410"/>
                  </a:cubicBezTo>
                  <a:lnTo>
                    <a:pt x="3277" y="882"/>
                  </a:lnTo>
                  <a:lnTo>
                    <a:pt x="2805" y="410"/>
                  </a:lnTo>
                  <a:cubicBezTo>
                    <a:pt x="2521" y="158"/>
                    <a:pt x="2143" y="0"/>
                    <a:pt x="1733" y="0"/>
                  </a:cubicBez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6" name="Google Shape;426;p32"/>
            <p:cNvSpPr/>
            <p:nvPr/>
          </p:nvSpPr>
          <p:spPr>
            <a:xfrm>
              <a:off x="-27930475" y="3269800"/>
              <a:ext cx="121325" cy="201650"/>
            </a:xfrm>
            <a:custGeom>
              <a:rect b="b" l="l" r="r" t="t"/>
              <a:pathLst>
                <a:path extrusionOk="0" h="8066" w="4853">
                  <a:moveTo>
                    <a:pt x="4506" y="1"/>
                  </a:moveTo>
                  <a:cubicBezTo>
                    <a:pt x="3876" y="1"/>
                    <a:pt x="3403" y="505"/>
                    <a:pt x="3403" y="1198"/>
                  </a:cubicBezTo>
                  <a:lnTo>
                    <a:pt x="3403" y="2395"/>
                  </a:lnTo>
                  <a:cubicBezTo>
                    <a:pt x="3403" y="2584"/>
                    <a:pt x="3246" y="2742"/>
                    <a:pt x="3025" y="2742"/>
                  </a:cubicBezTo>
                  <a:cubicBezTo>
                    <a:pt x="2679" y="2742"/>
                    <a:pt x="2363" y="2868"/>
                    <a:pt x="2080" y="3025"/>
                  </a:cubicBezTo>
                  <a:cubicBezTo>
                    <a:pt x="1702" y="3372"/>
                    <a:pt x="1418" y="3939"/>
                    <a:pt x="1418" y="4474"/>
                  </a:cubicBezTo>
                  <a:lnTo>
                    <a:pt x="1418" y="5231"/>
                  </a:lnTo>
                  <a:cubicBezTo>
                    <a:pt x="1418" y="5420"/>
                    <a:pt x="1261" y="5577"/>
                    <a:pt x="1072" y="5577"/>
                  </a:cubicBezTo>
                  <a:cubicBezTo>
                    <a:pt x="883" y="5577"/>
                    <a:pt x="725" y="5420"/>
                    <a:pt x="725" y="5231"/>
                  </a:cubicBezTo>
                  <a:lnTo>
                    <a:pt x="1" y="5892"/>
                  </a:lnTo>
                  <a:lnTo>
                    <a:pt x="1" y="8066"/>
                  </a:lnTo>
                  <a:lnTo>
                    <a:pt x="3813" y="8066"/>
                  </a:lnTo>
                  <a:cubicBezTo>
                    <a:pt x="4033" y="8066"/>
                    <a:pt x="4191" y="7908"/>
                    <a:pt x="4191" y="7719"/>
                  </a:cubicBezTo>
                  <a:cubicBezTo>
                    <a:pt x="4191" y="7530"/>
                    <a:pt x="4033" y="7373"/>
                    <a:pt x="3813" y="7373"/>
                  </a:cubicBezTo>
                  <a:lnTo>
                    <a:pt x="3466" y="7373"/>
                  </a:lnTo>
                  <a:lnTo>
                    <a:pt x="3466" y="6270"/>
                  </a:lnTo>
                  <a:cubicBezTo>
                    <a:pt x="3466" y="6176"/>
                    <a:pt x="3498" y="6050"/>
                    <a:pt x="3592" y="6018"/>
                  </a:cubicBezTo>
                  <a:lnTo>
                    <a:pt x="4128" y="5420"/>
                  </a:lnTo>
                  <a:cubicBezTo>
                    <a:pt x="4600" y="4947"/>
                    <a:pt x="4852" y="4380"/>
                    <a:pt x="4852" y="3687"/>
                  </a:cubicBezTo>
                  <a:lnTo>
                    <a:pt x="4852" y="347"/>
                  </a:lnTo>
                  <a:cubicBezTo>
                    <a:pt x="4852" y="158"/>
                    <a:pt x="4695" y="1"/>
                    <a:pt x="4506" y="1"/>
                  </a:cubicBez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27" name="Google Shape;427;p32"/>
            <p:cNvSpPr/>
            <p:nvPr/>
          </p:nvSpPr>
          <p:spPr>
            <a:xfrm>
              <a:off x="-28069875" y="3271375"/>
              <a:ext cx="122875" cy="200075"/>
            </a:xfrm>
            <a:custGeom>
              <a:rect b="b" l="l" r="r" t="t"/>
              <a:pathLst>
                <a:path extrusionOk="0" h="8003" w="4915">
                  <a:moveTo>
                    <a:pt x="347" y="1"/>
                  </a:moveTo>
                  <a:cubicBezTo>
                    <a:pt x="158" y="1"/>
                    <a:pt x="0" y="158"/>
                    <a:pt x="0" y="379"/>
                  </a:cubicBezTo>
                  <a:lnTo>
                    <a:pt x="0" y="3718"/>
                  </a:lnTo>
                  <a:cubicBezTo>
                    <a:pt x="0" y="4348"/>
                    <a:pt x="221" y="4979"/>
                    <a:pt x="693" y="5451"/>
                  </a:cubicBezTo>
                  <a:lnTo>
                    <a:pt x="1323" y="5955"/>
                  </a:lnTo>
                  <a:cubicBezTo>
                    <a:pt x="1418" y="6018"/>
                    <a:pt x="1449" y="6113"/>
                    <a:pt x="1449" y="6207"/>
                  </a:cubicBezTo>
                  <a:lnTo>
                    <a:pt x="1449" y="7310"/>
                  </a:lnTo>
                  <a:lnTo>
                    <a:pt x="1103" y="7310"/>
                  </a:lnTo>
                  <a:cubicBezTo>
                    <a:pt x="882" y="7310"/>
                    <a:pt x="725" y="7467"/>
                    <a:pt x="725" y="7656"/>
                  </a:cubicBezTo>
                  <a:cubicBezTo>
                    <a:pt x="725" y="7845"/>
                    <a:pt x="882" y="8003"/>
                    <a:pt x="1103" y="8003"/>
                  </a:cubicBezTo>
                  <a:lnTo>
                    <a:pt x="4915" y="8003"/>
                  </a:lnTo>
                  <a:lnTo>
                    <a:pt x="4915" y="5829"/>
                  </a:lnTo>
                  <a:lnTo>
                    <a:pt x="4190" y="5168"/>
                  </a:lnTo>
                  <a:cubicBezTo>
                    <a:pt x="4190" y="5357"/>
                    <a:pt x="4033" y="5514"/>
                    <a:pt x="3844" y="5514"/>
                  </a:cubicBezTo>
                  <a:cubicBezTo>
                    <a:pt x="3655" y="5514"/>
                    <a:pt x="3497" y="5357"/>
                    <a:pt x="3497" y="5168"/>
                  </a:cubicBezTo>
                  <a:lnTo>
                    <a:pt x="3497" y="4411"/>
                  </a:lnTo>
                  <a:cubicBezTo>
                    <a:pt x="3497" y="3876"/>
                    <a:pt x="3214" y="3372"/>
                    <a:pt x="2741" y="3057"/>
                  </a:cubicBezTo>
                  <a:cubicBezTo>
                    <a:pt x="2458" y="2899"/>
                    <a:pt x="2143" y="2773"/>
                    <a:pt x="1796" y="2773"/>
                  </a:cubicBezTo>
                  <a:cubicBezTo>
                    <a:pt x="1607" y="2773"/>
                    <a:pt x="1449" y="2616"/>
                    <a:pt x="1449" y="2427"/>
                  </a:cubicBezTo>
                  <a:lnTo>
                    <a:pt x="1449" y="1229"/>
                  </a:lnTo>
                  <a:cubicBezTo>
                    <a:pt x="1449" y="473"/>
                    <a:pt x="945" y="1"/>
                    <a:pt x="347" y="1"/>
                  </a:cubicBez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428" name="Google Shape;428;p32"/>
          <p:cNvSpPr/>
          <p:nvPr/>
        </p:nvSpPr>
        <p:spPr>
          <a:xfrm>
            <a:off x="712625" y="2449775"/>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429" name="Google Shape;429;p32"/>
          <p:cNvGrpSpPr/>
          <p:nvPr/>
        </p:nvGrpSpPr>
        <p:grpSpPr>
          <a:xfrm>
            <a:off x="850079" y="2541538"/>
            <a:ext cx="370700" cy="462065"/>
            <a:chOff x="3308350" y="2673800"/>
            <a:chExt cx="339500" cy="423175"/>
          </a:xfrm>
        </p:grpSpPr>
        <p:sp>
          <p:nvSpPr>
            <p:cNvPr id="430" name="Google Shape;430;p32"/>
            <p:cNvSpPr/>
            <p:nvPr/>
          </p:nvSpPr>
          <p:spPr>
            <a:xfrm>
              <a:off x="3523425" y="2787725"/>
              <a:ext cx="38375" cy="16300"/>
            </a:xfrm>
            <a:custGeom>
              <a:rect b="b" l="l" r="r" t="t"/>
              <a:pathLst>
                <a:path extrusionOk="0" h="652" w="1535">
                  <a:moveTo>
                    <a:pt x="1535" y="0"/>
                  </a:moveTo>
                  <a:lnTo>
                    <a:pt x="0" y="419"/>
                  </a:lnTo>
                  <a:lnTo>
                    <a:pt x="186" y="558"/>
                  </a:lnTo>
                  <a:lnTo>
                    <a:pt x="419" y="605"/>
                  </a:lnTo>
                  <a:lnTo>
                    <a:pt x="651" y="651"/>
                  </a:lnTo>
                  <a:lnTo>
                    <a:pt x="884" y="605"/>
                  </a:lnTo>
                  <a:lnTo>
                    <a:pt x="1116" y="512"/>
                  </a:lnTo>
                  <a:lnTo>
                    <a:pt x="1256" y="372"/>
                  </a:lnTo>
                  <a:lnTo>
                    <a:pt x="1442" y="186"/>
                  </a:lnTo>
                  <a:lnTo>
                    <a:pt x="1535" y="0"/>
                  </a:lnTo>
                  <a:close/>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1" name="Google Shape;431;p32"/>
            <p:cNvSpPr/>
            <p:nvPr/>
          </p:nvSpPr>
          <p:spPr>
            <a:xfrm>
              <a:off x="3523425" y="2787725"/>
              <a:ext cx="38375" cy="16300"/>
            </a:xfrm>
            <a:custGeom>
              <a:rect b="b" l="l" r="r" t="t"/>
              <a:pathLst>
                <a:path extrusionOk="0" fill="none" h="652" w="1535">
                  <a:moveTo>
                    <a:pt x="884" y="605"/>
                  </a:moveTo>
                  <a:lnTo>
                    <a:pt x="884" y="605"/>
                  </a:lnTo>
                  <a:lnTo>
                    <a:pt x="1116" y="512"/>
                  </a:lnTo>
                  <a:lnTo>
                    <a:pt x="1256" y="372"/>
                  </a:lnTo>
                  <a:lnTo>
                    <a:pt x="1442" y="186"/>
                  </a:lnTo>
                  <a:lnTo>
                    <a:pt x="1535" y="0"/>
                  </a:lnTo>
                  <a:lnTo>
                    <a:pt x="0" y="419"/>
                  </a:lnTo>
                  <a:lnTo>
                    <a:pt x="0" y="419"/>
                  </a:lnTo>
                  <a:lnTo>
                    <a:pt x="186" y="558"/>
                  </a:lnTo>
                  <a:lnTo>
                    <a:pt x="419" y="605"/>
                  </a:lnTo>
                  <a:lnTo>
                    <a:pt x="651" y="651"/>
                  </a:lnTo>
                  <a:lnTo>
                    <a:pt x="884" y="605"/>
                  </a:lnTo>
                  <a:lnTo>
                    <a:pt x="884" y="605"/>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2" name="Google Shape;432;p32"/>
            <p:cNvSpPr/>
            <p:nvPr/>
          </p:nvSpPr>
          <p:spPr>
            <a:xfrm>
              <a:off x="3545500" y="2802825"/>
              <a:ext cx="25" cy="25"/>
            </a:xfrm>
            <a:custGeom>
              <a:rect b="b" l="l" r="r" t="t"/>
              <a:pathLst>
                <a:path extrusionOk="0" fill="none" h="1" w="1">
                  <a:moveTo>
                    <a:pt x="1" y="1"/>
                  </a:moveTo>
                  <a:lnTo>
                    <a:pt x="1" y="1"/>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3" name="Google Shape;433;p32"/>
            <p:cNvSpPr/>
            <p:nvPr/>
          </p:nvSpPr>
          <p:spPr>
            <a:xfrm>
              <a:off x="3438550" y="2787725"/>
              <a:ext cx="38400" cy="16300"/>
            </a:xfrm>
            <a:custGeom>
              <a:rect b="b" l="l" r="r" t="t"/>
              <a:pathLst>
                <a:path extrusionOk="0" h="652" w="1536">
                  <a:moveTo>
                    <a:pt x="1" y="0"/>
                  </a:moveTo>
                  <a:lnTo>
                    <a:pt x="94" y="186"/>
                  </a:lnTo>
                  <a:lnTo>
                    <a:pt x="187" y="326"/>
                  </a:lnTo>
                  <a:lnTo>
                    <a:pt x="326" y="465"/>
                  </a:lnTo>
                  <a:lnTo>
                    <a:pt x="512" y="558"/>
                  </a:lnTo>
                  <a:lnTo>
                    <a:pt x="652" y="605"/>
                  </a:lnTo>
                  <a:lnTo>
                    <a:pt x="838" y="651"/>
                  </a:lnTo>
                  <a:lnTo>
                    <a:pt x="1024" y="651"/>
                  </a:lnTo>
                  <a:lnTo>
                    <a:pt x="1210" y="605"/>
                  </a:lnTo>
                  <a:lnTo>
                    <a:pt x="1349" y="512"/>
                  </a:lnTo>
                  <a:lnTo>
                    <a:pt x="1535" y="419"/>
                  </a:lnTo>
                  <a:lnTo>
                    <a:pt x="1" y="0"/>
                  </a:lnTo>
                  <a:close/>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4" name="Google Shape;434;p32"/>
            <p:cNvSpPr/>
            <p:nvPr/>
          </p:nvSpPr>
          <p:spPr>
            <a:xfrm>
              <a:off x="3438550" y="2787725"/>
              <a:ext cx="38400" cy="16300"/>
            </a:xfrm>
            <a:custGeom>
              <a:rect b="b" l="l" r="r" t="t"/>
              <a:pathLst>
                <a:path extrusionOk="0" fill="none" h="652" w="1536">
                  <a:moveTo>
                    <a:pt x="94" y="186"/>
                  </a:moveTo>
                  <a:lnTo>
                    <a:pt x="94" y="186"/>
                  </a:lnTo>
                  <a:lnTo>
                    <a:pt x="187" y="326"/>
                  </a:lnTo>
                  <a:lnTo>
                    <a:pt x="326" y="465"/>
                  </a:lnTo>
                  <a:lnTo>
                    <a:pt x="512" y="558"/>
                  </a:lnTo>
                  <a:lnTo>
                    <a:pt x="652" y="605"/>
                  </a:lnTo>
                  <a:lnTo>
                    <a:pt x="652" y="605"/>
                  </a:lnTo>
                  <a:lnTo>
                    <a:pt x="838" y="651"/>
                  </a:lnTo>
                  <a:lnTo>
                    <a:pt x="1024" y="651"/>
                  </a:lnTo>
                  <a:lnTo>
                    <a:pt x="1210" y="605"/>
                  </a:lnTo>
                  <a:lnTo>
                    <a:pt x="1349" y="512"/>
                  </a:lnTo>
                  <a:lnTo>
                    <a:pt x="1349" y="512"/>
                  </a:lnTo>
                  <a:lnTo>
                    <a:pt x="1535" y="419"/>
                  </a:lnTo>
                  <a:lnTo>
                    <a:pt x="1" y="0"/>
                  </a:lnTo>
                  <a:lnTo>
                    <a:pt x="1" y="0"/>
                  </a:lnTo>
                  <a:lnTo>
                    <a:pt x="94" y="186"/>
                  </a:lnTo>
                  <a:lnTo>
                    <a:pt x="94" y="186"/>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5" name="Google Shape;435;p32"/>
            <p:cNvSpPr/>
            <p:nvPr/>
          </p:nvSpPr>
          <p:spPr>
            <a:xfrm>
              <a:off x="3440875" y="2792375"/>
              <a:ext cx="25" cy="25"/>
            </a:xfrm>
            <a:custGeom>
              <a:rect b="b" l="l" r="r" t="t"/>
              <a:pathLst>
                <a:path extrusionOk="0" fill="none" h="1" w="1">
                  <a:moveTo>
                    <a:pt x="1" y="0"/>
                  </a:moveTo>
                  <a:lnTo>
                    <a:pt x="1" y="0"/>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6" name="Google Shape;436;p32"/>
            <p:cNvSpPr/>
            <p:nvPr/>
          </p:nvSpPr>
          <p:spPr>
            <a:xfrm>
              <a:off x="3313155" y="2705157"/>
              <a:ext cx="289186" cy="360460"/>
            </a:xfrm>
            <a:custGeom>
              <a:rect b="b" l="l" r="r" t="t"/>
              <a:pathLst>
                <a:path extrusionOk="0" h="16927" w="13580">
                  <a:moveTo>
                    <a:pt x="10696" y="3441"/>
                  </a:moveTo>
                  <a:lnTo>
                    <a:pt x="10836" y="3488"/>
                  </a:lnTo>
                  <a:lnTo>
                    <a:pt x="11022" y="3627"/>
                  </a:lnTo>
                  <a:lnTo>
                    <a:pt x="11068" y="3767"/>
                  </a:lnTo>
                  <a:lnTo>
                    <a:pt x="11161" y="4185"/>
                  </a:lnTo>
                  <a:lnTo>
                    <a:pt x="11115" y="4557"/>
                  </a:lnTo>
                  <a:lnTo>
                    <a:pt x="11068" y="4883"/>
                  </a:lnTo>
                  <a:lnTo>
                    <a:pt x="10882" y="5255"/>
                  </a:lnTo>
                  <a:lnTo>
                    <a:pt x="10696" y="5534"/>
                  </a:lnTo>
                  <a:lnTo>
                    <a:pt x="10417" y="5813"/>
                  </a:lnTo>
                  <a:lnTo>
                    <a:pt x="10091" y="5999"/>
                  </a:lnTo>
                  <a:lnTo>
                    <a:pt x="9719" y="6138"/>
                  </a:lnTo>
                  <a:lnTo>
                    <a:pt x="9487" y="6185"/>
                  </a:lnTo>
                  <a:lnTo>
                    <a:pt x="9022" y="6185"/>
                  </a:lnTo>
                  <a:lnTo>
                    <a:pt x="8789" y="6138"/>
                  </a:lnTo>
                  <a:lnTo>
                    <a:pt x="8371" y="5999"/>
                  </a:lnTo>
                  <a:lnTo>
                    <a:pt x="7999" y="5720"/>
                  </a:lnTo>
                  <a:lnTo>
                    <a:pt x="7673" y="5394"/>
                  </a:lnTo>
                  <a:lnTo>
                    <a:pt x="7394" y="5720"/>
                  </a:lnTo>
                  <a:lnTo>
                    <a:pt x="7069" y="5952"/>
                  </a:lnTo>
                  <a:lnTo>
                    <a:pt x="6836" y="6045"/>
                  </a:lnTo>
                  <a:lnTo>
                    <a:pt x="6604" y="6138"/>
                  </a:lnTo>
                  <a:lnTo>
                    <a:pt x="6371" y="6185"/>
                  </a:lnTo>
                  <a:lnTo>
                    <a:pt x="5860" y="6185"/>
                  </a:lnTo>
                  <a:lnTo>
                    <a:pt x="5627" y="6138"/>
                  </a:lnTo>
                  <a:lnTo>
                    <a:pt x="5255" y="5999"/>
                  </a:lnTo>
                  <a:lnTo>
                    <a:pt x="4930" y="5813"/>
                  </a:lnTo>
                  <a:lnTo>
                    <a:pt x="4651" y="5534"/>
                  </a:lnTo>
                  <a:lnTo>
                    <a:pt x="4465" y="5255"/>
                  </a:lnTo>
                  <a:lnTo>
                    <a:pt x="4279" y="4883"/>
                  </a:lnTo>
                  <a:lnTo>
                    <a:pt x="4232" y="4511"/>
                  </a:lnTo>
                  <a:lnTo>
                    <a:pt x="4186" y="4139"/>
                  </a:lnTo>
                  <a:lnTo>
                    <a:pt x="4279" y="3767"/>
                  </a:lnTo>
                  <a:lnTo>
                    <a:pt x="4325" y="3627"/>
                  </a:lnTo>
                  <a:lnTo>
                    <a:pt x="4511" y="3488"/>
                  </a:lnTo>
                  <a:lnTo>
                    <a:pt x="4697" y="3441"/>
                  </a:lnTo>
                  <a:lnTo>
                    <a:pt x="4883" y="3441"/>
                  </a:lnTo>
                  <a:lnTo>
                    <a:pt x="7627" y="4185"/>
                  </a:lnTo>
                  <a:lnTo>
                    <a:pt x="7720" y="4185"/>
                  </a:lnTo>
                  <a:lnTo>
                    <a:pt x="10464" y="3441"/>
                  </a:lnTo>
                  <a:close/>
                  <a:moveTo>
                    <a:pt x="10184" y="7394"/>
                  </a:moveTo>
                  <a:lnTo>
                    <a:pt x="10324" y="7441"/>
                  </a:lnTo>
                  <a:lnTo>
                    <a:pt x="10836" y="7766"/>
                  </a:lnTo>
                  <a:lnTo>
                    <a:pt x="10975" y="7906"/>
                  </a:lnTo>
                  <a:lnTo>
                    <a:pt x="11022" y="8092"/>
                  </a:lnTo>
                  <a:lnTo>
                    <a:pt x="11022" y="8278"/>
                  </a:lnTo>
                  <a:lnTo>
                    <a:pt x="10975" y="8464"/>
                  </a:lnTo>
                  <a:lnTo>
                    <a:pt x="10836" y="8603"/>
                  </a:lnTo>
                  <a:lnTo>
                    <a:pt x="10650" y="8696"/>
                  </a:lnTo>
                  <a:lnTo>
                    <a:pt x="10464" y="8696"/>
                  </a:lnTo>
                  <a:lnTo>
                    <a:pt x="10278" y="8603"/>
                  </a:lnTo>
                  <a:lnTo>
                    <a:pt x="10091" y="8464"/>
                  </a:lnTo>
                  <a:lnTo>
                    <a:pt x="9533" y="8929"/>
                  </a:lnTo>
                  <a:lnTo>
                    <a:pt x="9394" y="9022"/>
                  </a:lnTo>
                  <a:lnTo>
                    <a:pt x="9068" y="9022"/>
                  </a:lnTo>
                  <a:lnTo>
                    <a:pt x="8929" y="8929"/>
                  </a:lnTo>
                  <a:lnTo>
                    <a:pt x="8371" y="8510"/>
                  </a:lnTo>
                  <a:lnTo>
                    <a:pt x="7859" y="8929"/>
                  </a:lnTo>
                  <a:lnTo>
                    <a:pt x="7720" y="9022"/>
                  </a:lnTo>
                  <a:lnTo>
                    <a:pt x="7394" y="9022"/>
                  </a:lnTo>
                  <a:lnTo>
                    <a:pt x="7255" y="8929"/>
                  </a:lnTo>
                  <a:lnTo>
                    <a:pt x="6743" y="8510"/>
                  </a:lnTo>
                  <a:lnTo>
                    <a:pt x="6232" y="8929"/>
                  </a:lnTo>
                  <a:lnTo>
                    <a:pt x="6092" y="9022"/>
                  </a:lnTo>
                  <a:lnTo>
                    <a:pt x="5767" y="9022"/>
                  </a:lnTo>
                  <a:lnTo>
                    <a:pt x="5581" y="8929"/>
                  </a:lnTo>
                  <a:lnTo>
                    <a:pt x="5069" y="8464"/>
                  </a:lnTo>
                  <a:lnTo>
                    <a:pt x="4883" y="8603"/>
                  </a:lnTo>
                  <a:lnTo>
                    <a:pt x="4697" y="8696"/>
                  </a:lnTo>
                  <a:lnTo>
                    <a:pt x="4511" y="8696"/>
                  </a:lnTo>
                  <a:lnTo>
                    <a:pt x="4325" y="8603"/>
                  </a:lnTo>
                  <a:lnTo>
                    <a:pt x="4186" y="8464"/>
                  </a:lnTo>
                  <a:lnTo>
                    <a:pt x="4093" y="8278"/>
                  </a:lnTo>
                  <a:lnTo>
                    <a:pt x="4093" y="8092"/>
                  </a:lnTo>
                  <a:lnTo>
                    <a:pt x="4186" y="7906"/>
                  </a:lnTo>
                  <a:lnTo>
                    <a:pt x="4325" y="7766"/>
                  </a:lnTo>
                  <a:lnTo>
                    <a:pt x="4790" y="7441"/>
                  </a:lnTo>
                  <a:lnTo>
                    <a:pt x="4976" y="7394"/>
                  </a:lnTo>
                  <a:lnTo>
                    <a:pt x="5255" y="7394"/>
                  </a:lnTo>
                  <a:lnTo>
                    <a:pt x="5395" y="7487"/>
                  </a:lnTo>
                  <a:lnTo>
                    <a:pt x="5906" y="7906"/>
                  </a:lnTo>
                  <a:lnTo>
                    <a:pt x="6418" y="7487"/>
                  </a:lnTo>
                  <a:lnTo>
                    <a:pt x="6557" y="7394"/>
                  </a:lnTo>
                  <a:lnTo>
                    <a:pt x="6883" y="7394"/>
                  </a:lnTo>
                  <a:lnTo>
                    <a:pt x="7069" y="7487"/>
                  </a:lnTo>
                  <a:lnTo>
                    <a:pt x="7580" y="7906"/>
                  </a:lnTo>
                  <a:lnTo>
                    <a:pt x="8092" y="7487"/>
                  </a:lnTo>
                  <a:lnTo>
                    <a:pt x="8231" y="7394"/>
                  </a:lnTo>
                  <a:lnTo>
                    <a:pt x="8557" y="7394"/>
                  </a:lnTo>
                  <a:lnTo>
                    <a:pt x="8696" y="7487"/>
                  </a:lnTo>
                  <a:lnTo>
                    <a:pt x="9208" y="7906"/>
                  </a:lnTo>
                  <a:lnTo>
                    <a:pt x="9719" y="7487"/>
                  </a:lnTo>
                  <a:lnTo>
                    <a:pt x="9859" y="7394"/>
                  </a:lnTo>
                  <a:close/>
                  <a:moveTo>
                    <a:pt x="7580" y="0"/>
                  </a:moveTo>
                  <a:lnTo>
                    <a:pt x="6976" y="47"/>
                  </a:lnTo>
                  <a:lnTo>
                    <a:pt x="6371" y="93"/>
                  </a:lnTo>
                  <a:lnTo>
                    <a:pt x="5813" y="279"/>
                  </a:lnTo>
                  <a:lnTo>
                    <a:pt x="5255" y="465"/>
                  </a:lnTo>
                  <a:lnTo>
                    <a:pt x="4744" y="698"/>
                  </a:lnTo>
                  <a:lnTo>
                    <a:pt x="4232" y="1023"/>
                  </a:lnTo>
                  <a:lnTo>
                    <a:pt x="3767" y="1349"/>
                  </a:lnTo>
                  <a:lnTo>
                    <a:pt x="3349" y="1767"/>
                  </a:lnTo>
                  <a:lnTo>
                    <a:pt x="2930" y="2186"/>
                  </a:lnTo>
                  <a:lnTo>
                    <a:pt x="2558" y="2697"/>
                  </a:lnTo>
                  <a:lnTo>
                    <a:pt x="2279" y="3162"/>
                  </a:lnTo>
                  <a:lnTo>
                    <a:pt x="2000" y="3720"/>
                  </a:lnTo>
                  <a:lnTo>
                    <a:pt x="1814" y="4278"/>
                  </a:lnTo>
                  <a:lnTo>
                    <a:pt x="1675" y="4836"/>
                  </a:lnTo>
                  <a:lnTo>
                    <a:pt x="1582" y="5394"/>
                  </a:lnTo>
                  <a:lnTo>
                    <a:pt x="1582" y="5999"/>
                  </a:lnTo>
                  <a:lnTo>
                    <a:pt x="1582" y="7255"/>
                  </a:lnTo>
                  <a:lnTo>
                    <a:pt x="94" y="10045"/>
                  </a:lnTo>
                  <a:lnTo>
                    <a:pt x="47" y="10184"/>
                  </a:lnTo>
                  <a:lnTo>
                    <a:pt x="1" y="10277"/>
                  </a:lnTo>
                  <a:lnTo>
                    <a:pt x="47" y="10417"/>
                  </a:lnTo>
                  <a:lnTo>
                    <a:pt x="94" y="10556"/>
                  </a:lnTo>
                  <a:lnTo>
                    <a:pt x="140" y="10649"/>
                  </a:lnTo>
                  <a:lnTo>
                    <a:pt x="280" y="10696"/>
                  </a:lnTo>
                  <a:lnTo>
                    <a:pt x="373" y="10742"/>
                  </a:lnTo>
                  <a:lnTo>
                    <a:pt x="512" y="10789"/>
                  </a:lnTo>
                  <a:lnTo>
                    <a:pt x="1582" y="10789"/>
                  </a:lnTo>
                  <a:lnTo>
                    <a:pt x="1582" y="11998"/>
                  </a:lnTo>
                  <a:lnTo>
                    <a:pt x="1582" y="12323"/>
                  </a:lnTo>
                  <a:lnTo>
                    <a:pt x="1628" y="12649"/>
                  </a:lnTo>
                  <a:lnTo>
                    <a:pt x="1721" y="12928"/>
                  </a:lnTo>
                  <a:lnTo>
                    <a:pt x="1814" y="13207"/>
                  </a:lnTo>
                  <a:lnTo>
                    <a:pt x="1954" y="13486"/>
                  </a:lnTo>
                  <a:lnTo>
                    <a:pt x="2093" y="13718"/>
                  </a:lnTo>
                  <a:lnTo>
                    <a:pt x="2279" y="13997"/>
                  </a:lnTo>
                  <a:lnTo>
                    <a:pt x="2465" y="14183"/>
                  </a:lnTo>
                  <a:lnTo>
                    <a:pt x="2698" y="14416"/>
                  </a:lnTo>
                  <a:lnTo>
                    <a:pt x="2930" y="14555"/>
                  </a:lnTo>
                  <a:lnTo>
                    <a:pt x="3209" y="14741"/>
                  </a:lnTo>
                  <a:lnTo>
                    <a:pt x="3488" y="14881"/>
                  </a:lnTo>
                  <a:lnTo>
                    <a:pt x="3767" y="14974"/>
                  </a:lnTo>
                  <a:lnTo>
                    <a:pt x="4046" y="15067"/>
                  </a:lnTo>
                  <a:lnTo>
                    <a:pt x="4372" y="15113"/>
                  </a:lnTo>
                  <a:lnTo>
                    <a:pt x="6511" y="15113"/>
                  </a:lnTo>
                  <a:lnTo>
                    <a:pt x="6511" y="16415"/>
                  </a:lnTo>
                  <a:lnTo>
                    <a:pt x="6557" y="16601"/>
                  </a:lnTo>
                  <a:lnTo>
                    <a:pt x="6650" y="16787"/>
                  </a:lnTo>
                  <a:lnTo>
                    <a:pt x="6836" y="16880"/>
                  </a:lnTo>
                  <a:lnTo>
                    <a:pt x="7022" y="16927"/>
                  </a:lnTo>
                  <a:lnTo>
                    <a:pt x="13068" y="16927"/>
                  </a:lnTo>
                  <a:lnTo>
                    <a:pt x="13254" y="16880"/>
                  </a:lnTo>
                  <a:lnTo>
                    <a:pt x="13440" y="16787"/>
                  </a:lnTo>
                  <a:lnTo>
                    <a:pt x="13533" y="16601"/>
                  </a:lnTo>
                  <a:lnTo>
                    <a:pt x="13579" y="16415"/>
                  </a:lnTo>
                  <a:lnTo>
                    <a:pt x="13579" y="5999"/>
                  </a:lnTo>
                  <a:lnTo>
                    <a:pt x="13533" y="5394"/>
                  </a:lnTo>
                  <a:lnTo>
                    <a:pt x="13440" y="4836"/>
                  </a:lnTo>
                  <a:lnTo>
                    <a:pt x="13300" y="4278"/>
                  </a:lnTo>
                  <a:lnTo>
                    <a:pt x="13114" y="3720"/>
                  </a:lnTo>
                  <a:lnTo>
                    <a:pt x="12882" y="3162"/>
                  </a:lnTo>
                  <a:lnTo>
                    <a:pt x="12556" y="2697"/>
                  </a:lnTo>
                  <a:lnTo>
                    <a:pt x="12184" y="2186"/>
                  </a:lnTo>
                  <a:lnTo>
                    <a:pt x="11812" y="1767"/>
                  </a:lnTo>
                  <a:lnTo>
                    <a:pt x="11347" y="1349"/>
                  </a:lnTo>
                  <a:lnTo>
                    <a:pt x="10882" y="1023"/>
                  </a:lnTo>
                  <a:lnTo>
                    <a:pt x="10371" y="698"/>
                  </a:lnTo>
                  <a:lnTo>
                    <a:pt x="9859" y="465"/>
                  </a:lnTo>
                  <a:lnTo>
                    <a:pt x="9301" y="279"/>
                  </a:lnTo>
                  <a:lnTo>
                    <a:pt x="8743" y="93"/>
                  </a:lnTo>
                  <a:lnTo>
                    <a:pt x="8138" y="47"/>
                  </a:lnTo>
                  <a:lnTo>
                    <a:pt x="7580" y="0"/>
                  </a:ln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7" name="Google Shape;437;p32"/>
            <p:cNvSpPr/>
            <p:nvPr/>
          </p:nvSpPr>
          <p:spPr>
            <a:xfrm>
              <a:off x="3308350" y="2673800"/>
              <a:ext cx="339500" cy="423175"/>
            </a:xfrm>
            <a:custGeom>
              <a:rect b="b" l="l" r="r" t="t"/>
              <a:pathLst>
                <a:path extrusionOk="0" fill="none" h="16927" w="13580">
                  <a:moveTo>
                    <a:pt x="11812" y="1767"/>
                  </a:moveTo>
                  <a:lnTo>
                    <a:pt x="11812" y="1767"/>
                  </a:lnTo>
                  <a:lnTo>
                    <a:pt x="11347" y="1349"/>
                  </a:lnTo>
                  <a:lnTo>
                    <a:pt x="10882" y="1023"/>
                  </a:lnTo>
                  <a:lnTo>
                    <a:pt x="10371" y="698"/>
                  </a:lnTo>
                  <a:lnTo>
                    <a:pt x="9859" y="465"/>
                  </a:lnTo>
                  <a:lnTo>
                    <a:pt x="9301" y="279"/>
                  </a:lnTo>
                  <a:lnTo>
                    <a:pt x="8743" y="93"/>
                  </a:lnTo>
                  <a:lnTo>
                    <a:pt x="8138" y="47"/>
                  </a:lnTo>
                  <a:lnTo>
                    <a:pt x="7580" y="0"/>
                  </a:lnTo>
                  <a:lnTo>
                    <a:pt x="7580" y="0"/>
                  </a:lnTo>
                  <a:lnTo>
                    <a:pt x="6976" y="47"/>
                  </a:lnTo>
                  <a:lnTo>
                    <a:pt x="6371" y="93"/>
                  </a:lnTo>
                  <a:lnTo>
                    <a:pt x="5813" y="279"/>
                  </a:lnTo>
                  <a:lnTo>
                    <a:pt x="5255" y="465"/>
                  </a:lnTo>
                  <a:lnTo>
                    <a:pt x="4744" y="698"/>
                  </a:lnTo>
                  <a:lnTo>
                    <a:pt x="4232" y="1023"/>
                  </a:lnTo>
                  <a:lnTo>
                    <a:pt x="3767" y="1349"/>
                  </a:lnTo>
                  <a:lnTo>
                    <a:pt x="3349" y="1767"/>
                  </a:lnTo>
                  <a:lnTo>
                    <a:pt x="3349" y="1767"/>
                  </a:lnTo>
                  <a:lnTo>
                    <a:pt x="2930" y="2186"/>
                  </a:lnTo>
                  <a:lnTo>
                    <a:pt x="2558" y="2697"/>
                  </a:lnTo>
                  <a:lnTo>
                    <a:pt x="2279" y="3162"/>
                  </a:lnTo>
                  <a:lnTo>
                    <a:pt x="2000" y="3720"/>
                  </a:lnTo>
                  <a:lnTo>
                    <a:pt x="1814" y="4278"/>
                  </a:lnTo>
                  <a:lnTo>
                    <a:pt x="1675" y="4836"/>
                  </a:lnTo>
                  <a:lnTo>
                    <a:pt x="1582" y="5394"/>
                  </a:lnTo>
                  <a:lnTo>
                    <a:pt x="1582" y="5999"/>
                  </a:lnTo>
                  <a:lnTo>
                    <a:pt x="1582" y="7255"/>
                  </a:lnTo>
                  <a:lnTo>
                    <a:pt x="94" y="10045"/>
                  </a:lnTo>
                  <a:lnTo>
                    <a:pt x="94" y="10045"/>
                  </a:lnTo>
                  <a:lnTo>
                    <a:pt x="47" y="10184"/>
                  </a:lnTo>
                  <a:lnTo>
                    <a:pt x="1" y="10277"/>
                  </a:lnTo>
                  <a:lnTo>
                    <a:pt x="47" y="10417"/>
                  </a:lnTo>
                  <a:lnTo>
                    <a:pt x="94" y="10556"/>
                  </a:lnTo>
                  <a:lnTo>
                    <a:pt x="94" y="10556"/>
                  </a:lnTo>
                  <a:lnTo>
                    <a:pt x="140" y="10649"/>
                  </a:lnTo>
                  <a:lnTo>
                    <a:pt x="280" y="10696"/>
                  </a:lnTo>
                  <a:lnTo>
                    <a:pt x="373" y="10742"/>
                  </a:lnTo>
                  <a:lnTo>
                    <a:pt x="512" y="10789"/>
                  </a:lnTo>
                  <a:lnTo>
                    <a:pt x="1582" y="10789"/>
                  </a:lnTo>
                  <a:lnTo>
                    <a:pt x="1582" y="11998"/>
                  </a:lnTo>
                  <a:lnTo>
                    <a:pt x="1582" y="11998"/>
                  </a:lnTo>
                  <a:lnTo>
                    <a:pt x="1582" y="12323"/>
                  </a:lnTo>
                  <a:lnTo>
                    <a:pt x="1628" y="12649"/>
                  </a:lnTo>
                  <a:lnTo>
                    <a:pt x="1721" y="12928"/>
                  </a:lnTo>
                  <a:lnTo>
                    <a:pt x="1814" y="13207"/>
                  </a:lnTo>
                  <a:lnTo>
                    <a:pt x="1954" y="13486"/>
                  </a:lnTo>
                  <a:lnTo>
                    <a:pt x="2093" y="13718"/>
                  </a:lnTo>
                  <a:lnTo>
                    <a:pt x="2279" y="13997"/>
                  </a:lnTo>
                  <a:lnTo>
                    <a:pt x="2465" y="14183"/>
                  </a:lnTo>
                  <a:lnTo>
                    <a:pt x="2698" y="14416"/>
                  </a:lnTo>
                  <a:lnTo>
                    <a:pt x="2930" y="14555"/>
                  </a:lnTo>
                  <a:lnTo>
                    <a:pt x="3209" y="14741"/>
                  </a:lnTo>
                  <a:lnTo>
                    <a:pt x="3488" y="14881"/>
                  </a:lnTo>
                  <a:lnTo>
                    <a:pt x="3767" y="14974"/>
                  </a:lnTo>
                  <a:lnTo>
                    <a:pt x="4046" y="15067"/>
                  </a:lnTo>
                  <a:lnTo>
                    <a:pt x="4372" y="15113"/>
                  </a:lnTo>
                  <a:lnTo>
                    <a:pt x="4697" y="15113"/>
                  </a:lnTo>
                  <a:lnTo>
                    <a:pt x="6511" y="15113"/>
                  </a:lnTo>
                  <a:lnTo>
                    <a:pt x="6511" y="16415"/>
                  </a:lnTo>
                  <a:lnTo>
                    <a:pt x="6511" y="16415"/>
                  </a:lnTo>
                  <a:lnTo>
                    <a:pt x="6557" y="16601"/>
                  </a:lnTo>
                  <a:lnTo>
                    <a:pt x="6650" y="16787"/>
                  </a:lnTo>
                  <a:lnTo>
                    <a:pt x="6836" y="16880"/>
                  </a:lnTo>
                  <a:lnTo>
                    <a:pt x="7022" y="16927"/>
                  </a:lnTo>
                  <a:lnTo>
                    <a:pt x="13068" y="16927"/>
                  </a:lnTo>
                  <a:lnTo>
                    <a:pt x="13068" y="16927"/>
                  </a:lnTo>
                  <a:lnTo>
                    <a:pt x="13254" y="16880"/>
                  </a:lnTo>
                  <a:lnTo>
                    <a:pt x="13440" y="16787"/>
                  </a:lnTo>
                  <a:lnTo>
                    <a:pt x="13533" y="16601"/>
                  </a:lnTo>
                  <a:lnTo>
                    <a:pt x="13579" y="16415"/>
                  </a:lnTo>
                  <a:lnTo>
                    <a:pt x="13579" y="5999"/>
                  </a:lnTo>
                  <a:lnTo>
                    <a:pt x="13579" y="5999"/>
                  </a:lnTo>
                  <a:lnTo>
                    <a:pt x="13533" y="5394"/>
                  </a:lnTo>
                  <a:lnTo>
                    <a:pt x="13440" y="4836"/>
                  </a:lnTo>
                  <a:lnTo>
                    <a:pt x="13300" y="4278"/>
                  </a:lnTo>
                  <a:lnTo>
                    <a:pt x="13114" y="3720"/>
                  </a:lnTo>
                  <a:lnTo>
                    <a:pt x="12882" y="3162"/>
                  </a:lnTo>
                  <a:lnTo>
                    <a:pt x="12556" y="2697"/>
                  </a:lnTo>
                  <a:lnTo>
                    <a:pt x="12184" y="2186"/>
                  </a:lnTo>
                  <a:lnTo>
                    <a:pt x="11812" y="1767"/>
                  </a:lnTo>
                  <a:lnTo>
                    <a:pt x="11812" y="1767"/>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8" name="Google Shape;438;p32"/>
            <p:cNvSpPr/>
            <p:nvPr/>
          </p:nvSpPr>
          <p:spPr>
            <a:xfrm>
              <a:off x="3410650" y="2858650"/>
              <a:ext cx="173250" cy="40700"/>
            </a:xfrm>
            <a:custGeom>
              <a:rect b="b" l="l" r="r" t="t"/>
              <a:pathLst>
                <a:path extrusionOk="0" fill="none" h="1628" w="6930">
                  <a:moveTo>
                    <a:pt x="6883" y="1070"/>
                  </a:moveTo>
                  <a:lnTo>
                    <a:pt x="6883" y="1070"/>
                  </a:lnTo>
                  <a:lnTo>
                    <a:pt x="6744" y="1209"/>
                  </a:lnTo>
                  <a:lnTo>
                    <a:pt x="6558" y="1302"/>
                  </a:lnTo>
                  <a:lnTo>
                    <a:pt x="6372" y="1302"/>
                  </a:lnTo>
                  <a:lnTo>
                    <a:pt x="6186" y="1209"/>
                  </a:lnTo>
                  <a:lnTo>
                    <a:pt x="5999" y="1070"/>
                  </a:lnTo>
                  <a:lnTo>
                    <a:pt x="5441" y="1535"/>
                  </a:lnTo>
                  <a:lnTo>
                    <a:pt x="5441" y="1535"/>
                  </a:lnTo>
                  <a:lnTo>
                    <a:pt x="5302" y="1628"/>
                  </a:lnTo>
                  <a:lnTo>
                    <a:pt x="5116" y="1628"/>
                  </a:lnTo>
                  <a:lnTo>
                    <a:pt x="5116" y="1628"/>
                  </a:lnTo>
                  <a:lnTo>
                    <a:pt x="4976" y="1628"/>
                  </a:lnTo>
                  <a:lnTo>
                    <a:pt x="4837" y="1535"/>
                  </a:lnTo>
                  <a:lnTo>
                    <a:pt x="4279" y="1116"/>
                  </a:lnTo>
                  <a:lnTo>
                    <a:pt x="3767" y="1535"/>
                  </a:lnTo>
                  <a:lnTo>
                    <a:pt x="3767" y="1535"/>
                  </a:lnTo>
                  <a:lnTo>
                    <a:pt x="3628" y="1628"/>
                  </a:lnTo>
                  <a:lnTo>
                    <a:pt x="3488" y="1628"/>
                  </a:lnTo>
                  <a:lnTo>
                    <a:pt x="3302" y="1628"/>
                  </a:lnTo>
                  <a:lnTo>
                    <a:pt x="3163" y="1535"/>
                  </a:lnTo>
                  <a:lnTo>
                    <a:pt x="2651" y="1116"/>
                  </a:lnTo>
                  <a:lnTo>
                    <a:pt x="2140" y="1535"/>
                  </a:lnTo>
                  <a:lnTo>
                    <a:pt x="2140" y="1535"/>
                  </a:lnTo>
                  <a:lnTo>
                    <a:pt x="2000" y="1628"/>
                  </a:lnTo>
                  <a:lnTo>
                    <a:pt x="1814" y="1628"/>
                  </a:lnTo>
                  <a:lnTo>
                    <a:pt x="1675" y="1628"/>
                  </a:lnTo>
                  <a:lnTo>
                    <a:pt x="1489" y="1535"/>
                  </a:lnTo>
                  <a:lnTo>
                    <a:pt x="977" y="1070"/>
                  </a:lnTo>
                  <a:lnTo>
                    <a:pt x="791" y="1209"/>
                  </a:lnTo>
                  <a:lnTo>
                    <a:pt x="791" y="1209"/>
                  </a:lnTo>
                  <a:lnTo>
                    <a:pt x="605" y="1302"/>
                  </a:lnTo>
                  <a:lnTo>
                    <a:pt x="419" y="1302"/>
                  </a:lnTo>
                  <a:lnTo>
                    <a:pt x="233" y="1209"/>
                  </a:lnTo>
                  <a:lnTo>
                    <a:pt x="94" y="1070"/>
                  </a:lnTo>
                  <a:lnTo>
                    <a:pt x="94" y="1070"/>
                  </a:lnTo>
                  <a:lnTo>
                    <a:pt x="1" y="884"/>
                  </a:lnTo>
                  <a:lnTo>
                    <a:pt x="1" y="698"/>
                  </a:lnTo>
                  <a:lnTo>
                    <a:pt x="94" y="512"/>
                  </a:lnTo>
                  <a:lnTo>
                    <a:pt x="233" y="372"/>
                  </a:lnTo>
                  <a:lnTo>
                    <a:pt x="698" y="47"/>
                  </a:lnTo>
                  <a:lnTo>
                    <a:pt x="698" y="47"/>
                  </a:lnTo>
                  <a:lnTo>
                    <a:pt x="884" y="0"/>
                  </a:lnTo>
                  <a:lnTo>
                    <a:pt x="1024" y="0"/>
                  </a:lnTo>
                  <a:lnTo>
                    <a:pt x="1163" y="0"/>
                  </a:lnTo>
                  <a:lnTo>
                    <a:pt x="1303" y="93"/>
                  </a:lnTo>
                  <a:lnTo>
                    <a:pt x="1814" y="512"/>
                  </a:lnTo>
                  <a:lnTo>
                    <a:pt x="2326" y="93"/>
                  </a:lnTo>
                  <a:lnTo>
                    <a:pt x="2326" y="93"/>
                  </a:lnTo>
                  <a:lnTo>
                    <a:pt x="2465" y="0"/>
                  </a:lnTo>
                  <a:lnTo>
                    <a:pt x="2651" y="0"/>
                  </a:lnTo>
                  <a:lnTo>
                    <a:pt x="2791" y="0"/>
                  </a:lnTo>
                  <a:lnTo>
                    <a:pt x="2977" y="93"/>
                  </a:lnTo>
                  <a:lnTo>
                    <a:pt x="3488" y="512"/>
                  </a:lnTo>
                  <a:lnTo>
                    <a:pt x="4000" y="93"/>
                  </a:lnTo>
                  <a:lnTo>
                    <a:pt x="4000" y="93"/>
                  </a:lnTo>
                  <a:lnTo>
                    <a:pt x="4139" y="0"/>
                  </a:lnTo>
                  <a:lnTo>
                    <a:pt x="4279" y="0"/>
                  </a:lnTo>
                  <a:lnTo>
                    <a:pt x="4465" y="0"/>
                  </a:lnTo>
                  <a:lnTo>
                    <a:pt x="4604" y="93"/>
                  </a:lnTo>
                  <a:lnTo>
                    <a:pt x="5116" y="512"/>
                  </a:lnTo>
                  <a:lnTo>
                    <a:pt x="5627" y="93"/>
                  </a:lnTo>
                  <a:lnTo>
                    <a:pt x="5627" y="93"/>
                  </a:lnTo>
                  <a:lnTo>
                    <a:pt x="5767" y="0"/>
                  </a:lnTo>
                  <a:lnTo>
                    <a:pt x="5953" y="0"/>
                  </a:lnTo>
                  <a:lnTo>
                    <a:pt x="6092" y="0"/>
                  </a:lnTo>
                  <a:lnTo>
                    <a:pt x="6232" y="47"/>
                  </a:lnTo>
                  <a:lnTo>
                    <a:pt x="6744" y="372"/>
                  </a:lnTo>
                  <a:lnTo>
                    <a:pt x="6744" y="372"/>
                  </a:lnTo>
                  <a:lnTo>
                    <a:pt x="6883" y="512"/>
                  </a:lnTo>
                  <a:lnTo>
                    <a:pt x="6930" y="698"/>
                  </a:lnTo>
                  <a:lnTo>
                    <a:pt x="6930" y="884"/>
                  </a:lnTo>
                  <a:lnTo>
                    <a:pt x="6883" y="1070"/>
                  </a:lnTo>
                  <a:lnTo>
                    <a:pt x="6883" y="1070"/>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39" name="Google Shape;439;p32"/>
            <p:cNvSpPr/>
            <p:nvPr/>
          </p:nvSpPr>
          <p:spPr>
            <a:xfrm>
              <a:off x="3412975" y="2759825"/>
              <a:ext cx="174425" cy="68600"/>
            </a:xfrm>
            <a:custGeom>
              <a:rect b="b" l="l" r="r" t="t"/>
              <a:pathLst>
                <a:path extrusionOk="0" fill="none" h="2744" w="6977">
                  <a:moveTo>
                    <a:pt x="5534" y="2697"/>
                  </a:moveTo>
                  <a:lnTo>
                    <a:pt x="5534" y="2697"/>
                  </a:lnTo>
                  <a:lnTo>
                    <a:pt x="5302" y="2744"/>
                  </a:lnTo>
                  <a:lnTo>
                    <a:pt x="5069" y="2744"/>
                  </a:lnTo>
                  <a:lnTo>
                    <a:pt x="5069" y="2744"/>
                  </a:lnTo>
                  <a:lnTo>
                    <a:pt x="4837" y="2744"/>
                  </a:lnTo>
                  <a:lnTo>
                    <a:pt x="4604" y="2697"/>
                  </a:lnTo>
                  <a:lnTo>
                    <a:pt x="4186" y="2558"/>
                  </a:lnTo>
                  <a:lnTo>
                    <a:pt x="3814" y="2279"/>
                  </a:lnTo>
                  <a:lnTo>
                    <a:pt x="3488" y="1953"/>
                  </a:lnTo>
                  <a:lnTo>
                    <a:pt x="3488" y="1953"/>
                  </a:lnTo>
                  <a:lnTo>
                    <a:pt x="3209" y="2279"/>
                  </a:lnTo>
                  <a:lnTo>
                    <a:pt x="2884" y="2511"/>
                  </a:lnTo>
                  <a:lnTo>
                    <a:pt x="2884" y="2511"/>
                  </a:lnTo>
                  <a:lnTo>
                    <a:pt x="2651" y="2604"/>
                  </a:lnTo>
                  <a:lnTo>
                    <a:pt x="2419" y="2697"/>
                  </a:lnTo>
                  <a:lnTo>
                    <a:pt x="2186" y="2744"/>
                  </a:lnTo>
                  <a:lnTo>
                    <a:pt x="1907" y="2744"/>
                  </a:lnTo>
                  <a:lnTo>
                    <a:pt x="1907" y="2744"/>
                  </a:lnTo>
                  <a:lnTo>
                    <a:pt x="1675" y="2744"/>
                  </a:lnTo>
                  <a:lnTo>
                    <a:pt x="1442" y="2697"/>
                  </a:lnTo>
                  <a:lnTo>
                    <a:pt x="1442" y="2697"/>
                  </a:lnTo>
                  <a:lnTo>
                    <a:pt x="1070" y="2558"/>
                  </a:lnTo>
                  <a:lnTo>
                    <a:pt x="745" y="2372"/>
                  </a:lnTo>
                  <a:lnTo>
                    <a:pt x="466" y="2093"/>
                  </a:lnTo>
                  <a:lnTo>
                    <a:pt x="280" y="1814"/>
                  </a:lnTo>
                  <a:lnTo>
                    <a:pt x="280" y="1814"/>
                  </a:lnTo>
                  <a:lnTo>
                    <a:pt x="94" y="1442"/>
                  </a:lnTo>
                  <a:lnTo>
                    <a:pt x="47" y="1070"/>
                  </a:lnTo>
                  <a:lnTo>
                    <a:pt x="1" y="698"/>
                  </a:lnTo>
                  <a:lnTo>
                    <a:pt x="94" y="326"/>
                  </a:lnTo>
                  <a:lnTo>
                    <a:pt x="94" y="326"/>
                  </a:lnTo>
                  <a:lnTo>
                    <a:pt x="140" y="186"/>
                  </a:lnTo>
                  <a:lnTo>
                    <a:pt x="326" y="47"/>
                  </a:lnTo>
                  <a:lnTo>
                    <a:pt x="326" y="47"/>
                  </a:lnTo>
                  <a:lnTo>
                    <a:pt x="512" y="0"/>
                  </a:lnTo>
                  <a:lnTo>
                    <a:pt x="698" y="0"/>
                  </a:lnTo>
                  <a:lnTo>
                    <a:pt x="3442" y="744"/>
                  </a:lnTo>
                  <a:lnTo>
                    <a:pt x="3442" y="744"/>
                  </a:lnTo>
                  <a:lnTo>
                    <a:pt x="3488" y="744"/>
                  </a:lnTo>
                  <a:lnTo>
                    <a:pt x="3488" y="744"/>
                  </a:lnTo>
                  <a:lnTo>
                    <a:pt x="3535" y="744"/>
                  </a:lnTo>
                  <a:lnTo>
                    <a:pt x="6279" y="0"/>
                  </a:lnTo>
                  <a:lnTo>
                    <a:pt x="6279" y="0"/>
                  </a:lnTo>
                  <a:lnTo>
                    <a:pt x="6511" y="0"/>
                  </a:lnTo>
                  <a:lnTo>
                    <a:pt x="6651" y="47"/>
                  </a:lnTo>
                  <a:lnTo>
                    <a:pt x="6651" y="47"/>
                  </a:lnTo>
                  <a:lnTo>
                    <a:pt x="6837" y="186"/>
                  </a:lnTo>
                  <a:lnTo>
                    <a:pt x="6883" y="326"/>
                  </a:lnTo>
                  <a:lnTo>
                    <a:pt x="6883" y="326"/>
                  </a:lnTo>
                  <a:lnTo>
                    <a:pt x="6976" y="744"/>
                  </a:lnTo>
                  <a:lnTo>
                    <a:pt x="6930" y="1116"/>
                  </a:lnTo>
                  <a:lnTo>
                    <a:pt x="6883" y="1442"/>
                  </a:lnTo>
                  <a:lnTo>
                    <a:pt x="6697" y="1814"/>
                  </a:lnTo>
                  <a:lnTo>
                    <a:pt x="6511" y="2093"/>
                  </a:lnTo>
                  <a:lnTo>
                    <a:pt x="6232" y="2372"/>
                  </a:lnTo>
                  <a:lnTo>
                    <a:pt x="5906" y="2558"/>
                  </a:lnTo>
                  <a:lnTo>
                    <a:pt x="5534" y="2697"/>
                  </a:lnTo>
                  <a:lnTo>
                    <a:pt x="5534" y="2697"/>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40" name="Google Shape;440;p32"/>
            <p:cNvSpPr/>
            <p:nvPr/>
          </p:nvSpPr>
          <p:spPr>
            <a:xfrm>
              <a:off x="3551325" y="2827250"/>
              <a:ext cx="25" cy="25"/>
            </a:xfrm>
            <a:custGeom>
              <a:rect b="b" l="l" r="r" t="t"/>
              <a:pathLst>
                <a:path extrusionOk="0" fill="none" h="1" w="1">
                  <a:moveTo>
                    <a:pt x="0" y="0"/>
                  </a:moveTo>
                  <a:lnTo>
                    <a:pt x="0" y="0"/>
                  </a:lnTo>
                </a:path>
              </a:pathLst>
            </a:custGeom>
            <a:solidFill>
              <a:srgbClr val="E8B0A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441" name="Google Shape;441;p32"/>
          <p:cNvSpPr txBox="1"/>
          <p:nvPr/>
        </p:nvSpPr>
        <p:spPr>
          <a:xfrm>
            <a:off x="0" y="4835700"/>
            <a:ext cx="3751800" cy="307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800">
                <a:solidFill>
                  <a:schemeClr val="dk1"/>
                </a:solidFill>
                <a:latin typeface="Hind"/>
                <a:ea typeface="Hind"/>
                <a:cs typeface="Hind"/>
                <a:sym typeface="Hind"/>
              </a:rPr>
              <a:t>Tan et al. </a:t>
            </a:r>
            <a:r>
              <a:rPr i="1" lang="en" sz="800">
                <a:solidFill>
                  <a:schemeClr val="dk1"/>
                </a:solidFill>
                <a:latin typeface="Hind"/>
                <a:ea typeface="Hind"/>
                <a:cs typeface="Hind"/>
                <a:sym typeface="Hind"/>
              </a:rPr>
              <a:t>AAPI Data, UCLA Center for Health Policy Research.</a:t>
            </a:r>
            <a:r>
              <a:rPr lang="en" sz="800">
                <a:solidFill>
                  <a:schemeClr val="dk1"/>
                </a:solidFill>
                <a:latin typeface="Hind"/>
                <a:ea typeface="Hind"/>
                <a:cs typeface="Hind"/>
                <a:sym typeface="Hind"/>
              </a:rPr>
              <a:t> 2024.</a:t>
            </a:r>
            <a:endParaRPr sz="800">
              <a:solidFill>
                <a:schemeClr val="dk1"/>
              </a:solidFill>
              <a:latin typeface="Hind"/>
              <a:ea typeface="Hind"/>
              <a:cs typeface="Hind"/>
              <a:sym typeface="Hind"/>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45" name="Shape 445"/>
        <p:cNvGrpSpPr/>
        <p:nvPr/>
      </p:nvGrpSpPr>
      <p:grpSpPr>
        <a:xfrm>
          <a:off x="0" y="0"/>
          <a:ext cx="0" cy="0"/>
          <a:chOff x="0" y="0"/>
          <a:chExt cx="0" cy="0"/>
        </a:xfrm>
      </p:grpSpPr>
      <p:sp>
        <p:nvSpPr>
          <p:cNvPr id="446" name="Google Shape;446;p33"/>
          <p:cNvSpPr/>
          <p:nvPr/>
        </p:nvSpPr>
        <p:spPr>
          <a:xfrm>
            <a:off x="712625" y="1514630"/>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47" name="Google Shape;447;p33"/>
          <p:cNvSpPr txBox="1"/>
          <p:nvPr>
            <p:ph idx="1" type="body"/>
          </p:nvPr>
        </p:nvSpPr>
        <p:spPr>
          <a:xfrm>
            <a:off x="1426225" y="1484330"/>
            <a:ext cx="7190700" cy="7062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b="1" lang="en">
                <a:latin typeface="Hind"/>
                <a:ea typeface="Hind"/>
                <a:cs typeface="Hind"/>
                <a:sym typeface="Hind"/>
              </a:rPr>
              <a:t>Korean Americans</a:t>
            </a:r>
            <a:r>
              <a:rPr lang="en">
                <a:latin typeface="Hind"/>
                <a:ea typeface="Hind"/>
                <a:cs typeface="Hind"/>
                <a:sym typeface="Hind"/>
              </a:rPr>
              <a:t>: There are common misconceptions that medication treatments are addictive.</a:t>
            </a:r>
            <a:endParaRPr>
              <a:latin typeface="Hind"/>
              <a:ea typeface="Hind"/>
              <a:cs typeface="Hind"/>
              <a:sym typeface="Hind"/>
            </a:endParaRPr>
          </a:p>
          <a:p>
            <a:pPr indent="0" lvl="0" marL="0" rtl="0" algn="l">
              <a:spcBef>
                <a:spcPts val="1200"/>
              </a:spcBef>
              <a:spcAft>
                <a:spcPts val="0"/>
              </a:spcAft>
              <a:buNone/>
            </a:pPr>
            <a:r>
              <a:t/>
            </a:r>
            <a:endParaRPr>
              <a:latin typeface="Hind"/>
              <a:ea typeface="Hind"/>
              <a:cs typeface="Hind"/>
              <a:sym typeface="Hind"/>
            </a:endParaRPr>
          </a:p>
          <a:p>
            <a:pPr indent="0" lvl="0" marL="0" rtl="0" algn="l">
              <a:spcBef>
                <a:spcPts val="1200"/>
              </a:spcBef>
              <a:spcAft>
                <a:spcPts val="1200"/>
              </a:spcAft>
              <a:buNone/>
            </a:pPr>
            <a:r>
              <a:t/>
            </a:r>
            <a:endParaRPr>
              <a:latin typeface="Hind"/>
              <a:ea typeface="Hind"/>
              <a:cs typeface="Hind"/>
              <a:sym typeface="Hind"/>
            </a:endParaRPr>
          </a:p>
        </p:txBody>
      </p:sp>
      <p:sp>
        <p:nvSpPr>
          <p:cNvPr id="448" name="Google Shape;448;p3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449" name="Google Shape;449;p33"/>
          <p:cNvSpPr txBox="1"/>
          <p:nvPr/>
        </p:nvSpPr>
        <p:spPr>
          <a:xfrm>
            <a:off x="1426225" y="3278425"/>
            <a:ext cx="7190700" cy="1015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1600"/>
              </a:spcAft>
              <a:buNone/>
            </a:pPr>
            <a:r>
              <a:rPr b="1" lang="en" sz="1800">
                <a:solidFill>
                  <a:srgbClr val="434343"/>
                </a:solidFill>
                <a:latin typeface="Hind"/>
                <a:ea typeface="Hind"/>
                <a:cs typeface="Hind"/>
                <a:sym typeface="Hind"/>
              </a:rPr>
              <a:t>Vietnamese Americans</a:t>
            </a:r>
            <a:r>
              <a:rPr lang="en" sz="1800">
                <a:solidFill>
                  <a:srgbClr val="434343"/>
                </a:solidFill>
                <a:latin typeface="Hind"/>
                <a:ea typeface="Hind"/>
                <a:cs typeface="Hind"/>
                <a:sym typeface="Hind"/>
              </a:rPr>
              <a:t>: Studies highlight importance of involving the family and community in understanding and treating mental health conditions.</a:t>
            </a:r>
            <a:endParaRPr sz="1800">
              <a:solidFill>
                <a:srgbClr val="434343"/>
              </a:solidFill>
              <a:latin typeface="Hind"/>
              <a:ea typeface="Hind"/>
              <a:cs typeface="Hind"/>
              <a:sym typeface="Hind"/>
            </a:endParaRPr>
          </a:p>
        </p:txBody>
      </p:sp>
      <p:sp>
        <p:nvSpPr>
          <p:cNvPr id="450" name="Google Shape;450;p33"/>
          <p:cNvSpPr txBox="1"/>
          <p:nvPr/>
        </p:nvSpPr>
        <p:spPr>
          <a:xfrm>
            <a:off x="1426225" y="2403125"/>
            <a:ext cx="68244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1600"/>
              </a:spcAft>
              <a:buNone/>
            </a:pPr>
            <a:r>
              <a:rPr b="1" lang="en" sz="1800">
                <a:solidFill>
                  <a:srgbClr val="434343"/>
                </a:solidFill>
                <a:latin typeface="Hind"/>
                <a:ea typeface="Hind"/>
                <a:cs typeface="Hind"/>
                <a:sym typeface="Hind"/>
              </a:rPr>
              <a:t>Chinese Americans</a:t>
            </a:r>
            <a:r>
              <a:rPr lang="en" sz="1800">
                <a:solidFill>
                  <a:srgbClr val="434343"/>
                </a:solidFill>
                <a:latin typeface="Hind"/>
                <a:ea typeface="Hind"/>
                <a:cs typeface="Hind"/>
                <a:sym typeface="Hind"/>
              </a:rPr>
              <a:t>: </a:t>
            </a:r>
            <a:r>
              <a:rPr lang="en" sz="1800">
                <a:solidFill>
                  <a:srgbClr val="434343"/>
                </a:solidFill>
                <a:latin typeface="Hind"/>
                <a:ea typeface="Hind"/>
                <a:cs typeface="Hind"/>
                <a:sym typeface="Hind"/>
              </a:rPr>
              <a:t>Adults often noted mental health disorders, such as social anxiety, to cultural and personality differences.</a:t>
            </a:r>
            <a:endParaRPr sz="1800">
              <a:solidFill>
                <a:srgbClr val="434343"/>
              </a:solidFill>
              <a:latin typeface="Hind"/>
              <a:ea typeface="Hind"/>
              <a:cs typeface="Hind"/>
              <a:sym typeface="Hind"/>
            </a:endParaRPr>
          </a:p>
        </p:txBody>
      </p:sp>
      <p:sp>
        <p:nvSpPr>
          <p:cNvPr id="451" name="Google Shape;451;p33"/>
          <p:cNvSpPr/>
          <p:nvPr/>
        </p:nvSpPr>
        <p:spPr>
          <a:xfrm>
            <a:off x="8619350" y="362675"/>
            <a:ext cx="417600" cy="393600"/>
          </a:xfrm>
          <a:prstGeom prst="rect">
            <a:avLst/>
          </a:prstGeom>
          <a:solidFill>
            <a:schemeClr val="accent6"/>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452" name="Google Shape;452;p33"/>
          <p:cNvSpPr txBox="1"/>
          <p:nvPr>
            <p:ph type="title"/>
          </p:nvPr>
        </p:nvSpPr>
        <p:spPr>
          <a:xfrm>
            <a:off x="93900" y="362675"/>
            <a:ext cx="89562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100"/>
              <a:t>Examples of differing subgroup </a:t>
            </a:r>
            <a:r>
              <a:rPr lang="en" sz="3100">
                <a:solidFill>
                  <a:schemeClr val="accent1"/>
                </a:solidFill>
              </a:rPr>
              <a:t>perceptions</a:t>
            </a:r>
            <a:r>
              <a:rPr lang="en" sz="3100"/>
              <a:t> </a:t>
            </a:r>
            <a:endParaRPr sz="3100"/>
          </a:p>
        </p:txBody>
      </p:sp>
      <p:sp>
        <p:nvSpPr>
          <p:cNvPr id="453" name="Google Shape;453;p33"/>
          <p:cNvSpPr/>
          <p:nvPr/>
        </p:nvSpPr>
        <p:spPr>
          <a:xfrm rot="-5971637">
            <a:off x="209997" y="3469712"/>
            <a:ext cx="435000" cy="603526"/>
          </a:xfrm>
          <a:prstGeom prst="rtTriangle">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454" name="Google Shape;454;p33"/>
          <p:cNvSpPr/>
          <p:nvPr/>
        </p:nvSpPr>
        <p:spPr>
          <a:xfrm>
            <a:off x="712625" y="2449775"/>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5" name="Google Shape;455;p33"/>
          <p:cNvSpPr/>
          <p:nvPr/>
        </p:nvSpPr>
        <p:spPr>
          <a:xfrm>
            <a:off x="712625" y="3384925"/>
            <a:ext cx="645600" cy="645600"/>
          </a:xfrm>
          <a:prstGeom prst="ellipse">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nvGrpSpPr>
          <p:cNvPr id="456" name="Google Shape;456;p33"/>
          <p:cNvGrpSpPr/>
          <p:nvPr/>
        </p:nvGrpSpPr>
        <p:grpSpPr>
          <a:xfrm flipH="1">
            <a:off x="831544" y="3508075"/>
            <a:ext cx="403431" cy="399140"/>
            <a:chOff x="4263650" y="3963700"/>
            <a:chExt cx="298550" cy="295375"/>
          </a:xfrm>
        </p:grpSpPr>
        <p:sp>
          <p:nvSpPr>
            <p:cNvPr id="457" name="Google Shape;457;p33"/>
            <p:cNvSpPr/>
            <p:nvPr/>
          </p:nvSpPr>
          <p:spPr>
            <a:xfrm>
              <a:off x="4384950" y="3963700"/>
              <a:ext cx="53575" cy="51225"/>
            </a:xfrm>
            <a:custGeom>
              <a:rect b="b" l="l" r="r" t="t"/>
              <a:pathLst>
                <a:path extrusionOk="0" h="2049" w="2143">
                  <a:moveTo>
                    <a:pt x="1072" y="1"/>
                  </a:moveTo>
                  <a:cubicBezTo>
                    <a:pt x="473" y="1"/>
                    <a:pt x="1" y="473"/>
                    <a:pt x="1" y="1040"/>
                  </a:cubicBezTo>
                  <a:cubicBezTo>
                    <a:pt x="1" y="1607"/>
                    <a:pt x="473" y="2048"/>
                    <a:pt x="1072" y="2048"/>
                  </a:cubicBezTo>
                  <a:cubicBezTo>
                    <a:pt x="1670" y="2048"/>
                    <a:pt x="2143" y="1576"/>
                    <a:pt x="2143" y="1040"/>
                  </a:cubicBezTo>
                  <a:cubicBezTo>
                    <a:pt x="2143" y="442"/>
                    <a:pt x="1670" y="1"/>
                    <a:pt x="1072" y="1"/>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8" name="Google Shape;458;p33"/>
            <p:cNvSpPr/>
            <p:nvPr/>
          </p:nvSpPr>
          <p:spPr>
            <a:xfrm>
              <a:off x="4315650" y="4136975"/>
              <a:ext cx="51200" cy="51225"/>
            </a:xfrm>
            <a:custGeom>
              <a:rect b="b" l="l" r="r" t="t"/>
              <a:pathLst>
                <a:path extrusionOk="0" h="2049" w="2048">
                  <a:moveTo>
                    <a:pt x="1040" y="1"/>
                  </a:moveTo>
                  <a:cubicBezTo>
                    <a:pt x="473" y="1"/>
                    <a:pt x="0" y="473"/>
                    <a:pt x="0" y="1040"/>
                  </a:cubicBezTo>
                  <a:cubicBezTo>
                    <a:pt x="0" y="1576"/>
                    <a:pt x="473" y="2048"/>
                    <a:pt x="1040" y="2048"/>
                  </a:cubicBezTo>
                  <a:cubicBezTo>
                    <a:pt x="1607" y="2048"/>
                    <a:pt x="2048" y="1576"/>
                    <a:pt x="2048" y="1040"/>
                  </a:cubicBezTo>
                  <a:cubicBezTo>
                    <a:pt x="2048" y="473"/>
                    <a:pt x="1607" y="1"/>
                    <a:pt x="1040" y="1"/>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9" name="Google Shape;459;p33"/>
            <p:cNvSpPr/>
            <p:nvPr/>
          </p:nvSpPr>
          <p:spPr>
            <a:xfrm>
              <a:off x="4455850" y="4136975"/>
              <a:ext cx="51200" cy="51225"/>
            </a:xfrm>
            <a:custGeom>
              <a:rect b="b" l="l" r="r" t="t"/>
              <a:pathLst>
                <a:path extrusionOk="0" h="2049" w="2048">
                  <a:moveTo>
                    <a:pt x="1040" y="1"/>
                  </a:moveTo>
                  <a:cubicBezTo>
                    <a:pt x="473" y="1"/>
                    <a:pt x="0" y="473"/>
                    <a:pt x="0" y="1040"/>
                  </a:cubicBezTo>
                  <a:cubicBezTo>
                    <a:pt x="0" y="1576"/>
                    <a:pt x="473" y="2048"/>
                    <a:pt x="1040" y="2048"/>
                  </a:cubicBezTo>
                  <a:cubicBezTo>
                    <a:pt x="1575" y="2048"/>
                    <a:pt x="2048" y="1576"/>
                    <a:pt x="2048" y="1040"/>
                  </a:cubicBezTo>
                  <a:cubicBezTo>
                    <a:pt x="2048" y="473"/>
                    <a:pt x="1575" y="1"/>
                    <a:pt x="1040" y="1"/>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0" name="Google Shape;460;p33"/>
            <p:cNvSpPr/>
            <p:nvPr/>
          </p:nvSpPr>
          <p:spPr>
            <a:xfrm>
              <a:off x="4431425" y="4196825"/>
              <a:ext cx="104000" cy="62250"/>
            </a:xfrm>
            <a:custGeom>
              <a:rect b="b" l="l" r="r" t="t"/>
              <a:pathLst>
                <a:path extrusionOk="0" h="2490" w="4160">
                  <a:moveTo>
                    <a:pt x="977" y="1"/>
                  </a:moveTo>
                  <a:cubicBezTo>
                    <a:pt x="536" y="284"/>
                    <a:pt x="189" y="694"/>
                    <a:pt x="63" y="1198"/>
                  </a:cubicBezTo>
                  <a:cubicBezTo>
                    <a:pt x="32" y="1387"/>
                    <a:pt x="0" y="1576"/>
                    <a:pt x="0" y="1797"/>
                  </a:cubicBezTo>
                  <a:lnTo>
                    <a:pt x="0" y="2143"/>
                  </a:lnTo>
                  <a:cubicBezTo>
                    <a:pt x="0" y="2332"/>
                    <a:pt x="158" y="2490"/>
                    <a:pt x="347" y="2490"/>
                  </a:cubicBezTo>
                  <a:lnTo>
                    <a:pt x="3813" y="2490"/>
                  </a:lnTo>
                  <a:cubicBezTo>
                    <a:pt x="4002" y="2490"/>
                    <a:pt x="4159" y="2332"/>
                    <a:pt x="4159" y="2143"/>
                  </a:cubicBezTo>
                  <a:lnTo>
                    <a:pt x="4159" y="1797"/>
                  </a:lnTo>
                  <a:cubicBezTo>
                    <a:pt x="4096" y="1576"/>
                    <a:pt x="4065" y="1356"/>
                    <a:pt x="4002" y="1198"/>
                  </a:cubicBezTo>
                  <a:cubicBezTo>
                    <a:pt x="3844" y="694"/>
                    <a:pt x="3529" y="284"/>
                    <a:pt x="3119" y="1"/>
                  </a:cubicBezTo>
                  <a:cubicBezTo>
                    <a:pt x="2804" y="253"/>
                    <a:pt x="2426" y="410"/>
                    <a:pt x="2048" y="410"/>
                  </a:cubicBezTo>
                  <a:cubicBezTo>
                    <a:pt x="1639" y="410"/>
                    <a:pt x="1261" y="253"/>
                    <a:pt x="977" y="1"/>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1" name="Google Shape;461;p33"/>
            <p:cNvSpPr/>
            <p:nvPr/>
          </p:nvSpPr>
          <p:spPr>
            <a:xfrm>
              <a:off x="4359750" y="4022775"/>
              <a:ext cx="104775" cy="44125"/>
            </a:xfrm>
            <a:custGeom>
              <a:rect b="b" l="l" r="r" t="t"/>
              <a:pathLst>
                <a:path extrusionOk="0" h="1765" w="4191">
                  <a:moveTo>
                    <a:pt x="1009" y="0"/>
                  </a:moveTo>
                  <a:cubicBezTo>
                    <a:pt x="379" y="347"/>
                    <a:pt x="0" y="1040"/>
                    <a:pt x="0" y="1765"/>
                  </a:cubicBezTo>
                  <a:lnTo>
                    <a:pt x="4191" y="1765"/>
                  </a:lnTo>
                  <a:cubicBezTo>
                    <a:pt x="4191" y="1040"/>
                    <a:pt x="3813" y="347"/>
                    <a:pt x="3214" y="0"/>
                  </a:cubicBezTo>
                  <a:cubicBezTo>
                    <a:pt x="2899" y="252"/>
                    <a:pt x="2521" y="378"/>
                    <a:pt x="2111" y="378"/>
                  </a:cubicBezTo>
                  <a:cubicBezTo>
                    <a:pt x="1733" y="378"/>
                    <a:pt x="1324" y="252"/>
                    <a:pt x="1009" y="0"/>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2" name="Google Shape;462;p33"/>
            <p:cNvSpPr/>
            <p:nvPr/>
          </p:nvSpPr>
          <p:spPr>
            <a:xfrm>
              <a:off x="4291225" y="4196825"/>
              <a:ext cx="102425" cy="62250"/>
            </a:xfrm>
            <a:custGeom>
              <a:rect b="b" l="l" r="r" t="t"/>
              <a:pathLst>
                <a:path extrusionOk="0" h="2490" w="4097">
                  <a:moveTo>
                    <a:pt x="1009" y="1"/>
                  </a:moveTo>
                  <a:cubicBezTo>
                    <a:pt x="568" y="284"/>
                    <a:pt x="221" y="694"/>
                    <a:pt x="95" y="1198"/>
                  </a:cubicBezTo>
                  <a:cubicBezTo>
                    <a:pt x="64" y="1387"/>
                    <a:pt x="1" y="1576"/>
                    <a:pt x="1" y="1797"/>
                  </a:cubicBezTo>
                  <a:lnTo>
                    <a:pt x="1" y="2143"/>
                  </a:lnTo>
                  <a:cubicBezTo>
                    <a:pt x="1" y="2332"/>
                    <a:pt x="158" y="2490"/>
                    <a:pt x="379" y="2490"/>
                  </a:cubicBezTo>
                  <a:lnTo>
                    <a:pt x="3844" y="2490"/>
                  </a:lnTo>
                  <a:cubicBezTo>
                    <a:pt x="3939" y="2490"/>
                    <a:pt x="4096" y="2332"/>
                    <a:pt x="4096" y="2143"/>
                  </a:cubicBezTo>
                  <a:lnTo>
                    <a:pt x="4096" y="1797"/>
                  </a:lnTo>
                  <a:cubicBezTo>
                    <a:pt x="4096" y="1576"/>
                    <a:pt x="4065" y="1356"/>
                    <a:pt x="4033" y="1198"/>
                  </a:cubicBezTo>
                  <a:cubicBezTo>
                    <a:pt x="3876" y="694"/>
                    <a:pt x="3561" y="284"/>
                    <a:pt x="3120" y="1"/>
                  </a:cubicBezTo>
                  <a:cubicBezTo>
                    <a:pt x="2804" y="253"/>
                    <a:pt x="2458" y="410"/>
                    <a:pt x="2048" y="410"/>
                  </a:cubicBezTo>
                  <a:cubicBezTo>
                    <a:pt x="1670" y="410"/>
                    <a:pt x="1261" y="253"/>
                    <a:pt x="1009" y="1"/>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3" name="Google Shape;463;p33"/>
            <p:cNvSpPr/>
            <p:nvPr/>
          </p:nvSpPr>
          <p:spPr>
            <a:xfrm>
              <a:off x="4263650" y="4085000"/>
              <a:ext cx="298550" cy="122100"/>
            </a:xfrm>
            <a:custGeom>
              <a:rect b="b" l="l" r="r" t="t"/>
              <a:pathLst>
                <a:path extrusionOk="0" h="4884" w="11942">
                  <a:moveTo>
                    <a:pt x="1545" y="0"/>
                  </a:moveTo>
                  <a:cubicBezTo>
                    <a:pt x="1041" y="0"/>
                    <a:pt x="599" y="347"/>
                    <a:pt x="505" y="851"/>
                  </a:cubicBezTo>
                  <a:lnTo>
                    <a:pt x="64" y="3655"/>
                  </a:lnTo>
                  <a:cubicBezTo>
                    <a:pt x="1" y="3970"/>
                    <a:pt x="95" y="4253"/>
                    <a:pt x="284" y="4474"/>
                  </a:cubicBezTo>
                  <a:cubicBezTo>
                    <a:pt x="410" y="4631"/>
                    <a:pt x="599" y="4757"/>
                    <a:pt x="788" y="4789"/>
                  </a:cubicBezTo>
                  <a:cubicBezTo>
                    <a:pt x="1009" y="4442"/>
                    <a:pt x="1324" y="4127"/>
                    <a:pt x="1639" y="3938"/>
                  </a:cubicBezTo>
                  <a:cubicBezTo>
                    <a:pt x="1513" y="3686"/>
                    <a:pt x="1419" y="3434"/>
                    <a:pt x="1419" y="3151"/>
                  </a:cubicBezTo>
                  <a:cubicBezTo>
                    <a:pt x="1419" y="2206"/>
                    <a:pt x="2206" y="1418"/>
                    <a:pt x="3151" y="1418"/>
                  </a:cubicBezTo>
                  <a:cubicBezTo>
                    <a:pt x="4097" y="1418"/>
                    <a:pt x="4884" y="2206"/>
                    <a:pt x="4884" y="3151"/>
                  </a:cubicBezTo>
                  <a:cubicBezTo>
                    <a:pt x="4884" y="3434"/>
                    <a:pt x="4821" y="3686"/>
                    <a:pt x="4695" y="3938"/>
                  </a:cubicBezTo>
                  <a:cubicBezTo>
                    <a:pt x="5042" y="4159"/>
                    <a:pt x="5325" y="4474"/>
                    <a:pt x="5577" y="4883"/>
                  </a:cubicBezTo>
                  <a:lnTo>
                    <a:pt x="6396" y="4883"/>
                  </a:lnTo>
                  <a:cubicBezTo>
                    <a:pt x="6585" y="4537"/>
                    <a:pt x="6900" y="4159"/>
                    <a:pt x="7247" y="3938"/>
                  </a:cubicBezTo>
                  <a:cubicBezTo>
                    <a:pt x="7152" y="3686"/>
                    <a:pt x="7058" y="3434"/>
                    <a:pt x="7058" y="3151"/>
                  </a:cubicBezTo>
                  <a:cubicBezTo>
                    <a:pt x="7058" y="2206"/>
                    <a:pt x="7846" y="1418"/>
                    <a:pt x="8791" y="1418"/>
                  </a:cubicBezTo>
                  <a:cubicBezTo>
                    <a:pt x="9736" y="1418"/>
                    <a:pt x="10524" y="2206"/>
                    <a:pt x="10524" y="3151"/>
                  </a:cubicBezTo>
                  <a:cubicBezTo>
                    <a:pt x="10524" y="3434"/>
                    <a:pt x="10461" y="3686"/>
                    <a:pt x="10334" y="3938"/>
                  </a:cubicBezTo>
                  <a:cubicBezTo>
                    <a:pt x="10681" y="4159"/>
                    <a:pt x="10965" y="4442"/>
                    <a:pt x="11154" y="4789"/>
                  </a:cubicBezTo>
                  <a:cubicBezTo>
                    <a:pt x="11343" y="4757"/>
                    <a:pt x="11563" y="4631"/>
                    <a:pt x="11658" y="4474"/>
                  </a:cubicBezTo>
                  <a:cubicBezTo>
                    <a:pt x="11878" y="4253"/>
                    <a:pt x="11941" y="3938"/>
                    <a:pt x="11910" y="3655"/>
                  </a:cubicBezTo>
                  <a:lnTo>
                    <a:pt x="11343" y="851"/>
                  </a:lnTo>
                  <a:cubicBezTo>
                    <a:pt x="11280" y="347"/>
                    <a:pt x="10839" y="0"/>
                    <a:pt x="10334" y="0"/>
                  </a:cubicBezTo>
                  <a:close/>
                </a:path>
              </a:pathLst>
            </a:custGeom>
            <a:solidFill>
              <a:schemeClr val="dk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464" name="Google Shape;464;p33"/>
          <p:cNvGrpSpPr/>
          <p:nvPr/>
        </p:nvGrpSpPr>
        <p:grpSpPr>
          <a:xfrm>
            <a:off x="882203" y="2584272"/>
            <a:ext cx="302133" cy="376626"/>
            <a:chOff x="4801050" y="1260175"/>
            <a:chExt cx="339475" cy="423175"/>
          </a:xfrm>
        </p:grpSpPr>
        <p:sp>
          <p:nvSpPr>
            <p:cNvPr id="465" name="Google Shape;465;p33"/>
            <p:cNvSpPr/>
            <p:nvPr/>
          </p:nvSpPr>
          <p:spPr>
            <a:xfrm>
              <a:off x="4916125" y="1333400"/>
              <a:ext cx="147675" cy="82575"/>
            </a:xfrm>
            <a:custGeom>
              <a:rect b="b" l="l" r="r" t="t"/>
              <a:pathLst>
                <a:path extrusionOk="0" h="3303" w="5907">
                  <a:moveTo>
                    <a:pt x="2744" y="1"/>
                  </a:moveTo>
                  <a:lnTo>
                    <a:pt x="2512" y="47"/>
                  </a:lnTo>
                  <a:lnTo>
                    <a:pt x="2326" y="187"/>
                  </a:lnTo>
                  <a:lnTo>
                    <a:pt x="2140" y="326"/>
                  </a:lnTo>
                  <a:lnTo>
                    <a:pt x="2000" y="466"/>
                  </a:lnTo>
                  <a:lnTo>
                    <a:pt x="1907" y="652"/>
                  </a:lnTo>
                  <a:lnTo>
                    <a:pt x="1814" y="884"/>
                  </a:lnTo>
                  <a:lnTo>
                    <a:pt x="1768" y="1117"/>
                  </a:lnTo>
                  <a:lnTo>
                    <a:pt x="1768" y="1303"/>
                  </a:lnTo>
                  <a:lnTo>
                    <a:pt x="1628" y="1442"/>
                  </a:lnTo>
                  <a:lnTo>
                    <a:pt x="1489" y="1582"/>
                  </a:lnTo>
                  <a:lnTo>
                    <a:pt x="884" y="1582"/>
                  </a:lnTo>
                  <a:lnTo>
                    <a:pt x="698" y="1628"/>
                  </a:lnTo>
                  <a:lnTo>
                    <a:pt x="559" y="1675"/>
                  </a:lnTo>
                  <a:lnTo>
                    <a:pt x="373" y="1721"/>
                  </a:lnTo>
                  <a:lnTo>
                    <a:pt x="280" y="1861"/>
                  </a:lnTo>
                  <a:lnTo>
                    <a:pt x="187" y="1954"/>
                  </a:lnTo>
                  <a:lnTo>
                    <a:pt x="94" y="2093"/>
                  </a:lnTo>
                  <a:lnTo>
                    <a:pt x="47" y="2279"/>
                  </a:lnTo>
                  <a:lnTo>
                    <a:pt x="1" y="2419"/>
                  </a:lnTo>
                  <a:lnTo>
                    <a:pt x="47" y="2605"/>
                  </a:lnTo>
                  <a:lnTo>
                    <a:pt x="94" y="2791"/>
                  </a:lnTo>
                  <a:lnTo>
                    <a:pt x="187" y="2930"/>
                  </a:lnTo>
                  <a:lnTo>
                    <a:pt x="280" y="3023"/>
                  </a:lnTo>
                  <a:lnTo>
                    <a:pt x="373" y="3116"/>
                  </a:lnTo>
                  <a:lnTo>
                    <a:pt x="559" y="3209"/>
                  </a:lnTo>
                  <a:lnTo>
                    <a:pt x="698" y="3256"/>
                  </a:lnTo>
                  <a:lnTo>
                    <a:pt x="884" y="3302"/>
                  </a:lnTo>
                  <a:lnTo>
                    <a:pt x="5023" y="3302"/>
                  </a:lnTo>
                  <a:lnTo>
                    <a:pt x="5209" y="3256"/>
                  </a:lnTo>
                  <a:lnTo>
                    <a:pt x="5395" y="3209"/>
                  </a:lnTo>
                  <a:lnTo>
                    <a:pt x="5535" y="3116"/>
                  </a:lnTo>
                  <a:lnTo>
                    <a:pt x="5628" y="3023"/>
                  </a:lnTo>
                  <a:lnTo>
                    <a:pt x="5767" y="2930"/>
                  </a:lnTo>
                  <a:lnTo>
                    <a:pt x="5814" y="2791"/>
                  </a:lnTo>
                  <a:lnTo>
                    <a:pt x="5860" y="2605"/>
                  </a:lnTo>
                  <a:lnTo>
                    <a:pt x="5907" y="2419"/>
                  </a:lnTo>
                  <a:lnTo>
                    <a:pt x="5860" y="2279"/>
                  </a:lnTo>
                  <a:lnTo>
                    <a:pt x="5814" y="2093"/>
                  </a:lnTo>
                  <a:lnTo>
                    <a:pt x="5767" y="1954"/>
                  </a:lnTo>
                  <a:lnTo>
                    <a:pt x="5628" y="1861"/>
                  </a:lnTo>
                  <a:lnTo>
                    <a:pt x="5535" y="1721"/>
                  </a:lnTo>
                  <a:lnTo>
                    <a:pt x="5395" y="1675"/>
                  </a:lnTo>
                  <a:lnTo>
                    <a:pt x="5209" y="1628"/>
                  </a:lnTo>
                  <a:lnTo>
                    <a:pt x="5023" y="1582"/>
                  </a:lnTo>
                  <a:lnTo>
                    <a:pt x="4419" y="1582"/>
                  </a:lnTo>
                  <a:lnTo>
                    <a:pt x="4279" y="1442"/>
                  </a:lnTo>
                  <a:lnTo>
                    <a:pt x="4140" y="1303"/>
                  </a:lnTo>
                  <a:lnTo>
                    <a:pt x="4140" y="1117"/>
                  </a:lnTo>
                  <a:lnTo>
                    <a:pt x="4093" y="884"/>
                  </a:lnTo>
                  <a:lnTo>
                    <a:pt x="4000" y="652"/>
                  </a:lnTo>
                  <a:lnTo>
                    <a:pt x="3907" y="466"/>
                  </a:lnTo>
                  <a:lnTo>
                    <a:pt x="3768" y="326"/>
                  </a:lnTo>
                  <a:lnTo>
                    <a:pt x="3582" y="187"/>
                  </a:lnTo>
                  <a:lnTo>
                    <a:pt x="3396" y="47"/>
                  </a:lnTo>
                  <a:lnTo>
                    <a:pt x="3163"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6" name="Google Shape;466;p33"/>
            <p:cNvSpPr/>
            <p:nvPr/>
          </p:nvSpPr>
          <p:spPr>
            <a:xfrm>
              <a:off x="4916125" y="1333400"/>
              <a:ext cx="147675" cy="82575"/>
            </a:xfrm>
            <a:custGeom>
              <a:rect b="b" l="l" r="r" t="t"/>
              <a:pathLst>
                <a:path extrusionOk="0" fill="none" h="3303" w="5907">
                  <a:moveTo>
                    <a:pt x="5023" y="1582"/>
                  </a:moveTo>
                  <a:lnTo>
                    <a:pt x="4605" y="1582"/>
                  </a:lnTo>
                  <a:lnTo>
                    <a:pt x="4605" y="1582"/>
                  </a:lnTo>
                  <a:lnTo>
                    <a:pt x="4419" y="1582"/>
                  </a:lnTo>
                  <a:lnTo>
                    <a:pt x="4279" y="1442"/>
                  </a:lnTo>
                  <a:lnTo>
                    <a:pt x="4140" y="1303"/>
                  </a:lnTo>
                  <a:lnTo>
                    <a:pt x="4140" y="1117"/>
                  </a:lnTo>
                  <a:lnTo>
                    <a:pt x="4140" y="1117"/>
                  </a:lnTo>
                  <a:lnTo>
                    <a:pt x="4093" y="884"/>
                  </a:lnTo>
                  <a:lnTo>
                    <a:pt x="4000" y="652"/>
                  </a:lnTo>
                  <a:lnTo>
                    <a:pt x="3907" y="466"/>
                  </a:lnTo>
                  <a:lnTo>
                    <a:pt x="3768" y="326"/>
                  </a:lnTo>
                  <a:lnTo>
                    <a:pt x="3582" y="187"/>
                  </a:lnTo>
                  <a:lnTo>
                    <a:pt x="3396" y="47"/>
                  </a:lnTo>
                  <a:lnTo>
                    <a:pt x="3163" y="1"/>
                  </a:lnTo>
                  <a:lnTo>
                    <a:pt x="2977" y="1"/>
                  </a:lnTo>
                  <a:lnTo>
                    <a:pt x="2977" y="1"/>
                  </a:lnTo>
                  <a:lnTo>
                    <a:pt x="2744" y="1"/>
                  </a:lnTo>
                  <a:lnTo>
                    <a:pt x="2512" y="47"/>
                  </a:lnTo>
                  <a:lnTo>
                    <a:pt x="2326" y="187"/>
                  </a:lnTo>
                  <a:lnTo>
                    <a:pt x="2140" y="326"/>
                  </a:lnTo>
                  <a:lnTo>
                    <a:pt x="2000" y="466"/>
                  </a:lnTo>
                  <a:lnTo>
                    <a:pt x="1907" y="652"/>
                  </a:lnTo>
                  <a:lnTo>
                    <a:pt x="1814" y="884"/>
                  </a:lnTo>
                  <a:lnTo>
                    <a:pt x="1768" y="1117"/>
                  </a:lnTo>
                  <a:lnTo>
                    <a:pt x="1768" y="1117"/>
                  </a:lnTo>
                  <a:lnTo>
                    <a:pt x="1768" y="1303"/>
                  </a:lnTo>
                  <a:lnTo>
                    <a:pt x="1628" y="1442"/>
                  </a:lnTo>
                  <a:lnTo>
                    <a:pt x="1489" y="1582"/>
                  </a:lnTo>
                  <a:lnTo>
                    <a:pt x="1303" y="1582"/>
                  </a:lnTo>
                  <a:lnTo>
                    <a:pt x="884" y="1582"/>
                  </a:lnTo>
                  <a:lnTo>
                    <a:pt x="884" y="1582"/>
                  </a:lnTo>
                  <a:lnTo>
                    <a:pt x="698" y="1628"/>
                  </a:lnTo>
                  <a:lnTo>
                    <a:pt x="559" y="1675"/>
                  </a:lnTo>
                  <a:lnTo>
                    <a:pt x="373" y="1721"/>
                  </a:lnTo>
                  <a:lnTo>
                    <a:pt x="280" y="1861"/>
                  </a:lnTo>
                  <a:lnTo>
                    <a:pt x="187" y="1954"/>
                  </a:lnTo>
                  <a:lnTo>
                    <a:pt x="94" y="2093"/>
                  </a:lnTo>
                  <a:lnTo>
                    <a:pt x="47" y="2279"/>
                  </a:lnTo>
                  <a:lnTo>
                    <a:pt x="1" y="2419"/>
                  </a:lnTo>
                  <a:lnTo>
                    <a:pt x="1" y="2419"/>
                  </a:lnTo>
                  <a:lnTo>
                    <a:pt x="47" y="2605"/>
                  </a:lnTo>
                  <a:lnTo>
                    <a:pt x="94" y="2791"/>
                  </a:lnTo>
                  <a:lnTo>
                    <a:pt x="187" y="2930"/>
                  </a:lnTo>
                  <a:lnTo>
                    <a:pt x="280" y="3023"/>
                  </a:lnTo>
                  <a:lnTo>
                    <a:pt x="373" y="3116"/>
                  </a:lnTo>
                  <a:lnTo>
                    <a:pt x="559" y="3209"/>
                  </a:lnTo>
                  <a:lnTo>
                    <a:pt x="698" y="3256"/>
                  </a:lnTo>
                  <a:lnTo>
                    <a:pt x="884" y="3302"/>
                  </a:lnTo>
                  <a:lnTo>
                    <a:pt x="5023" y="3302"/>
                  </a:lnTo>
                  <a:lnTo>
                    <a:pt x="5023" y="3302"/>
                  </a:lnTo>
                  <a:lnTo>
                    <a:pt x="5209" y="3256"/>
                  </a:lnTo>
                  <a:lnTo>
                    <a:pt x="5395" y="3209"/>
                  </a:lnTo>
                  <a:lnTo>
                    <a:pt x="5535" y="3116"/>
                  </a:lnTo>
                  <a:lnTo>
                    <a:pt x="5628" y="3023"/>
                  </a:lnTo>
                  <a:lnTo>
                    <a:pt x="5767" y="2930"/>
                  </a:lnTo>
                  <a:lnTo>
                    <a:pt x="5814" y="2791"/>
                  </a:lnTo>
                  <a:lnTo>
                    <a:pt x="5860" y="2605"/>
                  </a:lnTo>
                  <a:lnTo>
                    <a:pt x="5907" y="2419"/>
                  </a:lnTo>
                  <a:lnTo>
                    <a:pt x="5907" y="2419"/>
                  </a:lnTo>
                  <a:lnTo>
                    <a:pt x="5860" y="2279"/>
                  </a:lnTo>
                  <a:lnTo>
                    <a:pt x="5814" y="2093"/>
                  </a:lnTo>
                  <a:lnTo>
                    <a:pt x="5767" y="1954"/>
                  </a:lnTo>
                  <a:lnTo>
                    <a:pt x="5628" y="1861"/>
                  </a:lnTo>
                  <a:lnTo>
                    <a:pt x="5535" y="1721"/>
                  </a:lnTo>
                  <a:lnTo>
                    <a:pt x="5395" y="1675"/>
                  </a:lnTo>
                  <a:lnTo>
                    <a:pt x="5209" y="1628"/>
                  </a:lnTo>
                  <a:lnTo>
                    <a:pt x="5023" y="1582"/>
                  </a:lnTo>
                  <a:lnTo>
                    <a:pt x="5023" y="1582"/>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7" name="Google Shape;467;p33"/>
            <p:cNvSpPr/>
            <p:nvPr/>
          </p:nvSpPr>
          <p:spPr>
            <a:xfrm>
              <a:off x="5041700" y="137292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8" name="Google Shape;468;p33"/>
            <p:cNvSpPr/>
            <p:nvPr/>
          </p:nvSpPr>
          <p:spPr>
            <a:xfrm>
              <a:off x="4801050" y="1260175"/>
              <a:ext cx="339475" cy="423175"/>
            </a:xfrm>
            <a:custGeom>
              <a:rect b="b" l="l" r="r" t="t"/>
              <a:pathLst>
                <a:path extrusionOk="0" h="16927" w="13579">
                  <a:moveTo>
                    <a:pt x="7580" y="1907"/>
                  </a:moveTo>
                  <a:lnTo>
                    <a:pt x="7999" y="1953"/>
                  </a:lnTo>
                  <a:lnTo>
                    <a:pt x="8371" y="2093"/>
                  </a:lnTo>
                  <a:lnTo>
                    <a:pt x="8743" y="2279"/>
                  </a:lnTo>
                  <a:lnTo>
                    <a:pt x="9068" y="2511"/>
                  </a:lnTo>
                  <a:lnTo>
                    <a:pt x="9254" y="2744"/>
                  </a:lnTo>
                  <a:lnTo>
                    <a:pt x="9440" y="2976"/>
                  </a:lnTo>
                  <a:lnTo>
                    <a:pt x="9533" y="3255"/>
                  </a:lnTo>
                  <a:lnTo>
                    <a:pt x="9626" y="3534"/>
                  </a:lnTo>
                  <a:lnTo>
                    <a:pt x="9998" y="3581"/>
                  </a:lnTo>
                  <a:lnTo>
                    <a:pt x="10370" y="3674"/>
                  </a:lnTo>
                  <a:lnTo>
                    <a:pt x="10696" y="3860"/>
                  </a:lnTo>
                  <a:lnTo>
                    <a:pt x="10928" y="4092"/>
                  </a:lnTo>
                  <a:lnTo>
                    <a:pt x="11161" y="4325"/>
                  </a:lnTo>
                  <a:lnTo>
                    <a:pt x="11347" y="4650"/>
                  </a:lnTo>
                  <a:lnTo>
                    <a:pt x="11440" y="5022"/>
                  </a:lnTo>
                  <a:lnTo>
                    <a:pt x="11486" y="5348"/>
                  </a:lnTo>
                  <a:lnTo>
                    <a:pt x="11440" y="5720"/>
                  </a:lnTo>
                  <a:lnTo>
                    <a:pt x="11347" y="6092"/>
                  </a:lnTo>
                  <a:lnTo>
                    <a:pt x="11161" y="6371"/>
                  </a:lnTo>
                  <a:lnTo>
                    <a:pt x="10928" y="6650"/>
                  </a:lnTo>
                  <a:lnTo>
                    <a:pt x="10696" y="6882"/>
                  </a:lnTo>
                  <a:lnTo>
                    <a:pt x="10370" y="7068"/>
                  </a:lnTo>
                  <a:lnTo>
                    <a:pt x="9998" y="7161"/>
                  </a:lnTo>
                  <a:lnTo>
                    <a:pt x="9626" y="7208"/>
                  </a:lnTo>
                  <a:lnTo>
                    <a:pt x="7626" y="7208"/>
                  </a:lnTo>
                  <a:lnTo>
                    <a:pt x="7254" y="7952"/>
                  </a:lnTo>
                  <a:lnTo>
                    <a:pt x="8092" y="7952"/>
                  </a:lnTo>
                  <a:lnTo>
                    <a:pt x="8231" y="7998"/>
                  </a:lnTo>
                  <a:lnTo>
                    <a:pt x="8371" y="7998"/>
                  </a:lnTo>
                  <a:lnTo>
                    <a:pt x="8464" y="8091"/>
                  </a:lnTo>
                  <a:lnTo>
                    <a:pt x="8510" y="8184"/>
                  </a:lnTo>
                  <a:lnTo>
                    <a:pt x="8603" y="8324"/>
                  </a:lnTo>
                  <a:lnTo>
                    <a:pt x="8603" y="8417"/>
                  </a:lnTo>
                  <a:lnTo>
                    <a:pt x="8603" y="8556"/>
                  </a:lnTo>
                  <a:lnTo>
                    <a:pt x="8557" y="8649"/>
                  </a:lnTo>
                  <a:lnTo>
                    <a:pt x="7859" y="10091"/>
                  </a:lnTo>
                  <a:lnTo>
                    <a:pt x="7766" y="10230"/>
                  </a:lnTo>
                  <a:lnTo>
                    <a:pt x="7673" y="10323"/>
                  </a:lnTo>
                  <a:lnTo>
                    <a:pt x="7533" y="10370"/>
                  </a:lnTo>
                  <a:lnTo>
                    <a:pt x="7394" y="10370"/>
                  </a:lnTo>
                  <a:lnTo>
                    <a:pt x="7208" y="10323"/>
                  </a:lnTo>
                  <a:lnTo>
                    <a:pt x="7022" y="10230"/>
                  </a:lnTo>
                  <a:lnTo>
                    <a:pt x="6929" y="10044"/>
                  </a:lnTo>
                  <a:lnTo>
                    <a:pt x="6929" y="9858"/>
                  </a:lnTo>
                  <a:lnTo>
                    <a:pt x="6975" y="9672"/>
                  </a:lnTo>
                  <a:lnTo>
                    <a:pt x="7301" y="8928"/>
                  </a:lnTo>
                  <a:lnTo>
                    <a:pt x="6371" y="8928"/>
                  </a:lnTo>
                  <a:lnTo>
                    <a:pt x="6231" y="8882"/>
                  </a:lnTo>
                  <a:lnTo>
                    <a:pt x="6138" y="8835"/>
                  </a:lnTo>
                  <a:lnTo>
                    <a:pt x="6045" y="8696"/>
                  </a:lnTo>
                  <a:lnTo>
                    <a:pt x="5999" y="8603"/>
                  </a:lnTo>
                  <a:lnTo>
                    <a:pt x="5999" y="8463"/>
                  </a:lnTo>
                  <a:lnTo>
                    <a:pt x="5999" y="8370"/>
                  </a:lnTo>
                  <a:lnTo>
                    <a:pt x="6045" y="8231"/>
                  </a:lnTo>
                  <a:lnTo>
                    <a:pt x="6557" y="7208"/>
                  </a:lnTo>
                  <a:lnTo>
                    <a:pt x="5487" y="7208"/>
                  </a:lnTo>
                  <a:lnTo>
                    <a:pt x="5115" y="7161"/>
                  </a:lnTo>
                  <a:lnTo>
                    <a:pt x="4743" y="7068"/>
                  </a:lnTo>
                  <a:lnTo>
                    <a:pt x="4464" y="6882"/>
                  </a:lnTo>
                  <a:lnTo>
                    <a:pt x="4185" y="6650"/>
                  </a:lnTo>
                  <a:lnTo>
                    <a:pt x="3953" y="6371"/>
                  </a:lnTo>
                  <a:lnTo>
                    <a:pt x="3767" y="6092"/>
                  </a:lnTo>
                  <a:lnTo>
                    <a:pt x="3674" y="5720"/>
                  </a:lnTo>
                  <a:lnTo>
                    <a:pt x="3627" y="5348"/>
                  </a:lnTo>
                  <a:lnTo>
                    <a:pt x="3674" y="5022"/>
                  </a:lnTo>
                  <a:lnTo>
                    <a:pt x="3767" y="4650"/>
                  </a:lnTo>
                  <a:lnTo>
                    <a:pt x="3953" y="4325"/>
                  </a:lnTo>
                  <a:lnTo>
                    <a:pt x="4185" y="4092"/>
                  </a:lnTo>
                  <a:lnTo>
                    <a:pt x="4464" y="3860"/>
                  </a:lnTo>
                  <a:lnTo>
                    <a:pt x="4743" y="3674"/>
                  </a:lnTo>
                  <a:lnTo>
                    <a:pt x="5115" y="3581"/>
                  </a:lnTo>
                  <a:lnTo>
                    <a:pt x="5487" y="3534"/>
                  </a:lnTo>
                  <a:lnTo>
                    <a:pt x="5580" y="3255"/>
                  </a:lnTo>
                  <a:lnTo>
                    <a:pt x="5673" y="2976"/>
                  </a:lnTo>
                  <a:lnTo>
                    <a:pt x="5859" y="2744"/>
                  </a:lnTo>
                  <a:lnTo>
                    <a:pt x="6045" y="2511"/>
                  </a:lnTo>
                  <a:lnTo>
                    <a:pt x="6371" y="2279"/>
                  </a:lnTo>
                  <a:lnTo>
                    <a:pt x="6743" y="2093"/>
                  </a:lnTo>
                  <a:lnTo>
                    <a:pt x="7161" y="1953"/>
                  </a:lnTo>
                  <a:lnTo>
                    <a:pt x="7580" y="1907"/>
                  </a:lnTo>
                  <a:close/>
                  <a:moveTo>
                    <a:pt x="7580" y="0"/>
                  </a:moveTo>
                  <a:lnTo>
                    <a:pt x="6975" y="47"/>
                  </a:lnTo>
                  <a:lnTo>
                    <a:pt x="6371" y="93"/>
                  </a:lnTo>
                  <a:lnTo>
                    <a:pt x="5813" y="279"/>
                  </a:lnTo>
                  <a:lnTo>
                    <a:pt x="5255" y="465"/>
                  </a:lnTo>
                  <a:lnTo>
                    <a:pt x="4743" y="698"/>
                  </a:lnTo>
                  <a:lnTo>
                    <a:pt x="4232" y="1023"/>
                  </a:lnTo>
                  <a:lnTo>
                    <a:pt x="3767" y="1349"/>
                  </a:lnTo>
                  <a:lnTo>
                    <a:pt x="3348" y="1767"/>
                  </a:lnTo>
                  <a:lnTo>
                    <a:pt x="2930" y="2186"/>
                  </a:lnTo>
                  <a:lnTo>
                    <a:pt x="2558" y="2697"/>
                  </a:lnTo>
                  <a:lnTo>
                    <a:pt x="2279" y="3162"/>
                  </a:lnTo>
                  <a:lnTo>
                    <a:pt x="2000" y="3720"/>
                  </a:lnTo>
                  <a:lnTo>
                    <a:pt x="1814" y="4278"/>
                  </a:lnTo>
                  <a:lnTo>
                    <a:pt x="1674" y="4836"/>
                  </a:lnTo>
                  <a:lnTo>
                    <a:pt x="1581" y="5394"/>
                  </a:lnTo>
                  <a:lnTo>
                    <a:pt x="1581" y="5999"/>
                  </a:lnTo>
                  <a:lnTo>
                    <a:pt x="1581" y="7254"/>
                  </a:lnTo>
                  <a:lnTo>
                    <a:pt x="93" y="10044"/>
                  </a:lnTo>
                  <a:lnTo>
                    <a:pt x="47" y="10184"/>
                  </a:lnTo>
                  <a:lnTo>
                    <a:pt x="0" y="10277"/>
                  </a:lnTo>
                  <a:lnTo>
                    <a:pt x="47" y="10416"/>
                  </a:lnTo>
                  <a:lnTo>
                    <a:pt x="93" y="10556"/>
                  </a:lnTo>
                  <a:lnTo>
                    <a:pt x="140" y="10649"/>
                  </a:lnTo>
                  <a:lnTo>
                    <a:pt x="279" y="10695"/>
                  </a:lnTo>
                  <a:lnTo>
                    <a:pt x="372" y="10742"/>
                  </a:lnTo>
                  <a:lnTo>
                    <a:pt x="512" y="10788"/>
                  </a:lnTo>
                  <a:lnTo>
                    <a:pt x="1581" y="10788"/>
                  </a:lnTo>
                  <a:lnTo>
                    <a:pt x="1581" y="11997"/>
                  </a:lnTo>
                  <a:lnTo>
                    <a:pt x="1581" y="12323"/>
                  </a:lnTo>
                  <a:lnTo>
                    <a:pt x="1628" y="12648"/>
                  </a:lnTo>
                  <a:lnTo>
                    <a:pt x="1721" y="12927"/>
                  </a:lnTo>
                  <a:lnTo>
                    <a:pt x="1814" y="13206"/>
                  </a:lnTo>
                  <a:lnTo>
                    <a:pt x="1953" y="13485"/>
                  </a:lnTo>
                  <a:lnTo>
                    <a:pt x="2093" y="13718"/>
                  </a:lnTo>
                  <a:lnTo>
                    <a:pt x="2279" y="13997"/>
                  </a:lnTo>
                  <a:lnTo>
                    <a:pt x="2465" y="14183"/>
                  </a:lnTo>
                  <a:lnTo>
                    <a:pt x="2697" y="14415"/>
                  </a:lnTo>
                  <a:lnTo>
                    <a:pt x="2930" y="14555"/>
                  </a:lnTo>
                  <a:lnTo>
                    <a:pt x="3209" y="14741"/>
                  </a:lnTo>
                  <a:lnTo>
                    <a:pt x="3488" y="14880"/>
                  </a:lnTo>
                  <a:lnTo>
                    <a:pt x="3767" y="14973"/>
                  </a:lnTo>
                  <a:lnTo>
                    <a:pt x="4046" y="15066"/>
                  </a:lnTo>
                  <a:lnTo>
                    <a:pt x="4371" y="15113"/>
                  </a:lnTo>
                  <a:lnTo>
                    <a:pt x="6510" y="15113"/>
                  </a:lnTo>
                  <a:lnTo>
                    <a:pt x="6510" y="16415"/>
                  </a:lnTo>
                  <a:lnTo>
                    <a:pt x="6557" y="16601"/>
                  </a:lnTo>
                  <a:lnTo>
                    <a:pt x="6650" y="16787"/>
                  </a:lnTo>
                  <a:lnTo>
                    <a:pt x="6836" y="16880"/>
                  </a:lnTo>
                  <a:lnTo>
                    <a:pt x="7022" y="16926"/>
                  </a:lnTo>
                  <a:lnTo>
                    <a:pt x="13067" y="16926"/>
                  </a:lnTo>
                  <a:lnTo>
                    <a:pt x="13253" y="16880"/>
                  </a:lnTo>
                  <a:lnTo>
                    <a:pt x="13439" y="16787"/>
                  </a:lnTo>
                  <a:lnTo>
                    <a:pt x="13532" y="16601"/>
                  </a:lnTo>
                  <a:lnTo>
                    <a:pt x="13579" y="16415"/>
                  </a:lnTo>
                  <a:lnTo>
                    <a:pt x="13579" y="5999"/>
                  </a:lnTo>
                  <a:lnTo>
                    <a:pt x="13532" y="5394"/>
                  </a:lnTo>
                  <a:lnTo>
                    <a:pt x="13439" y="4836"/>
                  </a:lnTo>
                  <a:lnTo>
                    <a:pt x="13300" y="4278"/>
                  </a:lnTo>
                  <a:lnTo>
                    <a:pt x="13114" y="3720"/>
                  </a:lnTo>
                  <a:lnTo>
                    <a:pt x="12881" y="3162"/>
                  </a:lnTo>
                  <a:lnTo>
                    <a:pt x="12556" y="2697"/>
                  </a:lnTo>
                  <a:lnTo>
                    <a:pt x="12184" y="2186"/>
                  </a:lnTo>
                  <a:lnTo>
                    <a:pt x="11812" y="1767"/>
                  </a:lnTo>
                  <a:lnTo>
                    <a:pt x="11347" y="1349"/>
                  </a:lnTo>
                  <a:lnTo>
                    <a:pt x="10882" y="1023"/>
                  </a:lnTo>
                  <a:lnTo>
                    <a:pt x="10370" y="698"/>
                  </a:lnTo>
                  <a:lnTo>
                    <a:pt x="9859" y="465"/>
                  </a:lnTo>
                  <a:lnTo>
                    <a:pt x="9301" y="279"/>
                  </a:lnTo>
                  <a:lnTo>
                    <a:pt x="8743" y="93"/>
                  </a:lnTo>
                  <a:lnTo>
                    <a:pt x="8138" y="47"/>
                  </a:lnTo>
                  <a:lnTo>
                    <a:pt x="7580"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69" name="Google Shape;469;p33"/>
            <p:cNvSpPr/>
            <p:nvPr/>
          </p:nvSpPr>
          <p:spPr>
            <a:xfrm>
              <a:off x="5041700" y="14403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grpSp>
        <p:nvGrpSpPr>
          <p:cNvPr id="470" name="Google Shape;470;p33"/>
          <p:cNvGrpSpPr/>
          <p:nvPr/>
        </p:nvGrpSpPr>
        <p:grpSpPr>
          <a:xfrm>
            <a:off x="860039" y="1660447"/>
            <a:ext cx="350771" cy="376626"/>
            <a:chOff x="253225" y="1260175"/>
            <a:chExt cx="394125" cy="423175"/>
          </a:xfrm>
        </p:grpSpPr>
        <p:sp>
          <p:nvSpPr>
            <p:cNvPr id="471" name="Google Shape;471;p33"/>
            <p:cNvSpPr/>
            <p:nvPr/>
          </p:nvSpPr>
          <p:spPr>
            <a:xfrm>
              <a:off x="298575" y="1260175"/>
              <a:ext cx="93025" cy="50000"/>
            </a:xfrm>
            <a:custGeom>
              <a:rect b="b" l="l" r="r" t="t"/>
              <a:pathLst>
                <a:path extrusionOk="0" h="2000" w="3721">
                  <a:moveTo>
                    <a:pt x="465" y="0"/>
                  </a:moveTo>
                  <a:lnTo>
                    <a:pt x="279" y="47"/>
                  </a:lnTo>
                  <a:lnTo>
                    <a:pt x="140" y="140"/>
                  </a:lnTo>
                  <a:lnTo>
                    <a:pt x="0" y="326"/>
                  </a:lnTo>
                  <a:lnTo>
                    <a:pt x="0" y="512"/>
                  </a:lnTo>
                  <a:lnTo>
                    <a:pt x="0" y="2000"/>
                  </a:lnTo>
                  <a:lnTo>
                    <a:pt x="3720" y="2000"/>
                  </a:lnTo>
                  <a:lnTo>
                    <a:pt x="3720" y="512"/>
                  </a:lnTo>
                  <a:lnTo>
                    <a:pt x="3674" y="326"/>
                  </a:lnTo>
                  <a:lnTo>
                    <a:pt x="3581" y="140"/>
                  </a:lnTo>
                  <a:lnTo>
                    <a:pt x="3395" y="47"/>
                  </a:lnTo>
                  <a:lnTo>
                    <a:pt x="3209"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2" name="Google Shape;472;p33"/>
            <p:cNvSpPr/>
            <p:nvPr/>
          </p:nvSpPr>
          <p:spPr>
            <a:xfrm>
              <a:off x="298575" y="1260175"/>
              <a:ext cx="93025" cy="50000"/>
            </a:xfrm>
            <a:custGeom>
              <a:rect b="b" l="l" r="r" t="t"/>
              <a:pathLst>
                <a:path extrusionOk="0" fill="none" h="2000" w="3721">
                  <a:moveTo>
                    <a:pt x="3720" y="512"/>
                  </a:moveTo>
                  <a:lnTo>
                    <a:pt x="3720" y="512"/>
                  </a:lnTo>
                  <a:lnTo>
                    <a:pt x="3674" y="326"/>
                  </a:lnTo>
                  <a:lnTo>
                    <a:pt x="3581" y="140"/>
                  </a:lnTo>
                  <a:lnTo>
                    <a:pt x="3395" y="47"/>
                  </a:lnTo>
                  <a:lnTo>
                    <a:pt x="3209" y="0"/>
                  </a:lnTo>
                  <a:lnTo>
                    <a:pt x="465" y="0"/>
                  </a:lnTo>
                  <a:lnTo>
                    <a:pt x="465" y="0"/>
                  </a:lnTo>
                  <a:lnTo>
                    <a:pt x="279" y="47"/>
                  </a:lnTo>
                  <a:lnTo>
                    <a:pt x="140" y="140"/>
                  </a:lnTo>
                  <a:lnTo>
                    <a:pt x="0" y="326"/>
                  </a:lnTo>
                  <a:lnTo>
                    <a:pt x="0" y="512"/>
                  </a:lnTo>
                  <a:lnTo>
                    <a:pt x="0" y="2000"/>
                  </a:lnTo>
                  <a:lnTo>
                    <a:pt x="3720" y="2000"/>
                  </a:lnTo>
                  <a:lnTo>
                    <a:pt x="3720" y="512"/>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3" name="Google Shape;473;p33"/>
            <p:cNvSpPr/>
            <p:nvPr/>
          </p:nvSpPr>
          <p:spPr>
            <a:xfrm>
              <a:off x="391575" y="12729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4" name="Google Shape;474;p33"/>
            <p:cNvSpPr/>
            <p:nvPr/>
          </p:nvSpPr>
          <p:spPr>
            <a:xfrm>
              <a:off x="253225" y="1477550"/>
              <a:ext cx="182550" cy="100000"/>
            </a:xfrm>
            <a:custGeom>
              <a:rect b="b" l="l" r="r" t="t"/>
              <a:pathLst>
                <a:path extrusionOk="0" h="4000" w="7302">
                  <a:moveTo>
                    <a:pt x="1" y="1"/>
                  </a:moveTo>
                  <a:lnTo>
                    <a:pt x="1" y="4000"/>
                  </a:lnTo>
                  <a:lnTo>
                    <a:pt x="7301" y="4000"/>
                  </a:lnTo>
                  <a:lnTo>
                    <a:pt x="7301"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5" name="Google Shape;475;p33"/>
            <p:cNvSpPr/>
            <p:nvPr/>
          </p:nvSpPr>
          <p:spPr>
            <a:xfrm>
              <a:off x="253225" y="1334575"/>
              <a:ext cx="182550" cy="118600"/>
            </a:xfrm>
            <a:custGeom>
              <a:rect b="b" l="l" r="r" t="t"/>
              <a:pathLst>
                <a:path extrusionOk="0" h="4744" w="7302">
                  <a:moveTo>
                    <a:pt x="1814" y="0"/>
                  </a:moveTo>
                  <a:lnTo>
                    <a:pt x="1814" y="1674"/>
                  </a:lnTo>
                  <a:lnTo>
                    <a:pt x="1489" y="1674"/>
                  </a:lnTo>
                  <a:lnTo>
                    <a:pt x="1210" y="1721"/>
                  </a:lnTo>
                  <a:lnTo>
                    <a:pt x="931" y="1814"/>
                  </a:lnTo>
                  <a:lnTo>
                    <a:pt x="652" y="1953"/>
                  </a:lnTo>
                  <a:lnTo>
                    <a:pt x="419" y="2139"/>
                  </a:lnTo>
                  <a:lnTo>
                    <a:pt x="280" y="2325"/>
                  </a:lnTo>
                  <a:lnTo>
                    <a:pt x="140" y="2604"/>
                  </a:lnTo>
                  <a:lnTo>
                    <a:pt x="47" y="2883"/>
                  </a:lnTo>
                  <a:lnTo>
                    <a:pt x="1" y="3162"/>
                  </a:lnTo>
                  <a:lnTo>
                    <a:pt x="1" y="4743"/>
                  </a:lnTo>
                  <a:lnTo>
                    <a:pt x="7301" y="4743"/>
                  </a:lnTo>
                  <a:lnTo>
                    <a:pt x="7301" y="3162"/>
                  </a:lnTo>
                  <a:lnTo>
                    <a:pt x="7301" y="2883"/>
                  </a:lnTo>
                  <a:lnTo>
                    <a:pt x="7208" y="2604"/>
                  </a:lnTo>
                  <a:lnTo>
                    <a:pt x="7069" y="2325"/>
                  </a:lnTo>
                  <a:lnTo>
                    <a:pt x="6883" y="2139"/>
                  </a:lnTo>
                  <a:lnTo>
                    <a:pt x="6650" y="1953"/>
                  </a:lnTo>
                  <a:lnTo>
                    <a:pt x="6418" y="1814"/>
                  </a:lnTo>
                  <a:lnTo>
                    <a:pt x="6139" y="1721"/>
                  </a:lnTo>
                  <a:lnTo>
                    <a:pt x="5813" y="1674"/>
                  </a:lnTo>
                  <a:lnTo>
                    <a:pt x="5534" y="1674"/>
                  </a:lnTo>
                  <a:lnTo>
                    <a:pt x="5534"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6" name="Google Shape;476;p33"/>
            <p:cNvSpPr/>
            <p:nvPr/>
          </p:nvSpPr>
          <p:spPr>
            <a:xfrm>
              <a:off x="253225" y="1334575"/>
              <a:ext cx="182550" cy="118600"/>
            </a:xfrm>
            <a:custGeom>
              <a:rect b="b" l="l" r="r" t="t"/>
              <a:pathLst>
                <a:path extrusionOk="0" fill="none" h="4744" w="7302">
                  <a:moveTo>
                    <a:pt x="5813" y="1674"/>
                  </a:moveTo>
                  <a:lnTo>
                    <a:pt x="5534" y="1674"/>
                  </a:lnTo>
                  <a:lnTo>
                    <a:pt x="5534" y="0"/>
                  </a:lnTo>
                  <a:lnTo>
                    <a:pt x="1814" y="0"/>
                  </a:lnTo>
                  <a:lnTo>
                    <a:pt x="1814" y="1674"/>
                  </a:lnTo>
                  <a:lnTo>
                    <a:pt x="1489" y="1674"/>
                  </a:lnTo>
                  <a:lnTo>
                    <a:pt x="1489" y="1674"/>
                  </a:lnTo>
                  <a:lnTo>
                    <a:pt x="1210" y="1721"/>
                  </a:lnTo>
                  <a:lnTo>
                    <a:pt x="931" y="1814"/>
                  </a:lnTo>
                  <a:lnTo>
                    <a:pt x="652" y="1953"/>
                  </a:lnTo>
                  <a:lnTo>
                    <a:pt x="419" y="2139"/>
                  </a:lnTo>
                  <a:lnTo>
                    <a:pt x="280" y="2325"/>
                  </a:lnTo>
                  <a:lnTo>
                    <a:pt x="140" y="2604"/>
                  </a:lnTo>
                  <a:lnTo>
                    <a:pt x="47" y="2883"/>
                  </a:lnTo>
                  <a:lnTo>
                    <a:pt x="1" y="3162"/>
                  </a:lnTo>
                  <a:lnTo>
                    <a:pt x="1" y="4743"/>
                  </a:lnTo>
                  <a:lnTo>
                    <a:pt x="7301" y="4743"/>
                  </a:lnTo>
                  <a:lnTo>
                    <a:pt x="7301" y="3162"/>
                  </a:lnTo>
                  <a:lnTo>
                    <a:pt x="7301" y="3162"/>
                  </a:lnTo>
                  <a:lnTo>
                    <a:pt x="7301" y="2883"/>
                  </a:lnTo>
                  <a:lnTo>
                    <a:pt x="7208" y="2604"/>
                  </a:lnTo>
                  <a:lnTo>
                    <a:pt x="7069" y="2325"/>
                  </a:lnTo>
                  <a:lnTo>
                    <a:pt x="6883" y="2139"/>
                  </a:lnTo>
                  <a:lnTo>
                    <a:pt x="6650" y="1953"/>
                  </a:lnTo>
                  <a:lnTo>
                    <a:pt x="6418" y="1814"/>
                  </a:lnTo>
                  <a:lnTo>
                    <a:pt x="6139" y="1721"/>
                  </a:lnTo>
                  <a:lnTo>
                    <a:pt x="5813" y="1674"/>
                  </a:lnTo>
                  <a:lnTo>
                    <a:pt x="5813" y="1674"/>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7" name="Google Shape;477;p33"/>
            <p:cNvSpPr/>
            <p:nvPr/>
          </p:nvSpPr>
          <p:spPr>
            <a:xfrm>
              <a:off x="398550" y="1376425"/>
              <a:ext cx="25" cy="25"/>
            </a:xfrm>
            <a:custGeom>
              <a:rect b="b" l="l" r="r" t="t"/>
              <a:pathLst>
                <a:path extrusionOk="0" fill="none" h="1" w="1">
                  <a:moveTo>
                    <a:pt x="0" y="0"/>
                  </a:moveTo>
                  <a:lnTo>
                    <a:pt x="0"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8" name="Google Shape;478;p33"/>
            <p:cNvSpPr/>
            <p:nvPr/>
          </p:nvSpPr>
          <p:spPr>
            <a:xfrm>
              <a:off x="253225" y="1603100"/>
              <a:ext cx="182550" cy="80250"/>
            </a:xfrm>
            <a:custGeom>
              <a:rect b="b" l="l" r="r" t="t"/>
              <a:pathLst>
                <a:path extrusionOk="0" h="3210" w="7302">
                  <a:moveTo>
                    <a:pt x="1" y="1"/>
                  </a:moveTo>
                  <a:lnTo>
                    <a:pt x="1" y="1721"/>
                  </a:lnTo>
                  <a:lnTo>
                    <a:pt x="47" y="2000"/>
                  </a:lnTo>
                  <a:lnTo>
                    <a:pt x="140" y="2279"/>
                  </a:lnTo>
                  <a:lnTo>
                    <a:pt x="280" y="2558"/>
                  </a:lnTo>
                  <a:lnTo>
                    <a:pt x="419" y="2791"/>
                  </a:lnTo>
                  <a:lnTo>
                    <a:pt x="652" y="2977"/>
                  </a:lnTo>
                  <a:lnTo>
                    <a:pt x="931" y="3070"/>
                  </a:lnTo>
                  <a:lnTo>
                    <a:pt x="1210" y="3163"/>
                  </a:lnTo>
                  <a:lnTo>
                    <a:pt x="1489" y="3209"/>
                  </a:lnTo>
                  <a:lnTo>
                    <a:pt x="5813" y="3209"/>
                  </a:lnTo>
                  <a:lnTo>
                    <a:pt x="6139" y="3163"/>
                  </a:lnTo>
                  <a:lnTo>
                    <a:pt x="6418" y="3070"/>
                  </a:lnTo>
                  <a:lnTo>
                    <a:pt x="6650" y="2977"/>
                  </a:lnTo>
                  <a:lnTo>
                    <a:pt x="6883" y="2791"/>
                  </a:lnTo>
                  <a:lnTo>
                    <a:pt x="7069" y="2558"/>
                  </a:lnTo>
                  <a:lnTo>
                    <a:pt x="7208" y="2279"/>
                  </a:lnTo>
                  <a:lnTo>
                    <a:pt x="7301" y="2000"/>
                  </a:lnTo>
                  <a:lnTo>
                    <a:pt x="7301" y="1721"/>
                  </a:lnTo>
                  <a:lnTo>
                    <a:pt x="7301"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79" name="Google Shape;479;p33"/>
            <p:cNvSpPr/>
            <p:nvPr/>
          </p:nvSpPr>
          <p:spPr>
            <a:xfrm>
              <a:off x="253225" y="1603100"/>
              <a:ext cx="182550" cy="80250"/>
            </a:xfrm>
            <a:custGeom>
              <a:rect b="b" l="l" r="r" t="t"/>
              <a:pathLst>
                <a:path extrusionOk="0" fill="none" h="3210" w="7302">
                  <a:moveTo>
                    <a:pt x="1" y="1721"/>
                  </a:moveTo>
                  <a:lnTo>
                    <a:pt x="1" y="1721"/>
                  </a:lnTo>
                  <a:lnTo>
                    <a:pt x="47" y="2000"/>
                  </a:lnTo>
                  <a:lnTo>
                    <a:pt x="140" y="2279"/>
                  </a:lnTo>
                  <a:lnTo>
                    <a:pt x="280" y="2558"/>
                  </a:lnTo>
                  <a:lnTo>
                    <a:pt x="419" y="2791"/>
                  </a:lnTo>
                  <a:lnTo>
                    <a:pt x="652" y="2977"/>
                  </a:lnTo>
                  <a:lnTo>
                    <a:pt x="931" y="3070"/>
                  </a:lnTo>
                  <a:lnTo>
                    <a:pt x="1210" y="3163"/>
                  </a:lnTo>
                  <a:lnTo>
                    <a:pt x="1489" y="3209"/>
                  </a:lnTo>
                  <a:lnTo>
                    <a:pt x="5813" y="3209"/>
                  </a:lnTo>
                  <a:lnTo>
                    <a:pt x="5813" y="3209"/>
                  </a:lnTo>
                  <a:lnTo>
                    <a:pt x="6139" y="3163"/>
                  </a:lnTo>
                  <a:lnTo>
                    <a:pt x="6418" y="3070"/>
                  </a:lnTo>
                  <a:lnTo>
                    <a:pt x="6650" y="2977"/>
                  </a:lnTo>
                  <a:lnTo>
                    <a:pt x="6883" y="2791"/>
                  </a:lnTo>
                  <a:lnTo>
                    <a:pt x="7069" y="2558"/>
                  </a:lnTo>
                  <a:lnTo>
                    <a:pt x="7208" y="2279"/>
                  </a:lnTo>
                  <a:lnTo>
                    <a:pt x="7301" y="2000"/>
                  </a:lnTo>
                  <a:lnTo>
                    <a:pt x="7301" y="1721"/>
                  </a:lnTo>
                  <a:lnTo>
                    <a:pt x="7301" y="1"/>
                  </a:lnTo>
                  <a:lnTo>
                    <a:pt x="1" y="1"/>
                  </a:lnTo>
                  <a:lnTo>
                    <a:pt x="1" y="172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0" name="Google Shape;480;p33"/>
            <p:cNvSpPr/>
            <p:nvPr/>
          </p:nvSpPr>
          <p:spPr>
            <a:xfrm>
              <a:off x="253225" y="1646125"/>
              <a:ext cx="25" cy="25"/>
            </a:xfrm>
            <a:custGeom>
              <a:rect b="b" l="l" r="r" t="t"/>
              <a:pathLst>
                <a:path extrusionOk="0" fill="none" h="1" w="1">
                  <a:moveTo>
                    <a:pt x="1" y="0"/>
                  </a:moveTo>
                  <a:lnTo>
                    <a:pt x="1"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1" name="Google Shape;481;p33"/>
            <p:cNvSpPr/>
            <p:nvPr/>
          </p:nvSpPr>
          <p:spPr>
            <a:xfrm>
              <a:off x="503175" y="1260175"/>
              <a:ext cx="123250" cy="68600"/>
            </a:xfrm>
            <a:custGeom>
              <a:rect b="b" l="l" r="r" t="t"/>
              <a:pathLst>
                <a:path extrusionOk="0" h="2744" w="4930">
                  <a:moveTo>
                    <a:pt x="465" y="0"/>
                  </a:moveTo>
                  <a:lnTo>
                    <a:pt x="279" y="47"/>
                  </a:lnTo>
                  <a:lnTo>
                    <a:pt x="140" y="140"/>
                  </a:lnTo>
                  <a:lnTo>
                    <a:pt x="47" y="326"/>
                  </a:lnTo>
                  <a:lnTo>
                    <a:pt x="0" y="512"/>
                  </a:lnTo>
                  <a:lnTo>
                    <a:pt x="47" y="698"/>
                  </a:lnTo>
                  <a:lnTo>
                    <a:pt x="140" y="837"/>
                  </a:lnTo>
                  <a:lnTo>
                    <a:pt x="279" y="930"/>
                  </a:lnTo>
                  <a:lnTo>
                    <a:pt x="465" y="977"/>
                  </a:lnTo>
                  <a:lnTo>
                    <a:pt x="977" y="977"/>
                  </a:lnTo>
                  <a:lnTo>
                    <a:pt x="977" y="2744"/>
                  </a:lnTo>
                  <a:lnTo>
                    <a:pt x="3953" y="2744"/>
                  </a:lnTo>
                  <a:lnTo>
                    <a:pt x="3953" y="977"/>
                  </a:lnTo>
                  <a:lnTo>
                    <a:pt x="4464" y="977"/>
                  </a:lnTo>
                  <a:lnTo>
                    <a:pt x="4650" y="930"/>
                  </a:lnTo>
                  <a:lnTo>
                    <a:pt x="4790" y="837"/>
                  </a:lnTo>
                  <a:lnTo>
                    <a:pt x="4929" y="698"/>
                  </a:lnTo>
                  <a:lnTo>
                    <a:pt x="4929" y="512"/>
                  </a:lnTo>
                  <a:lnTo>
                    <a:pt x="4929" y="326"/>
                  </a:lnTo>
                  <a:lnTo>
                    <a:pt x="4790" y="140"/>
                  </a:lnTo>
                  <a:lnTo>
                    <a:pt x="4650" y="47"/>
                  </a:lnTo>
                  <a:lnTo>
                    <a:pt x="4464"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2" name="Google Shape;482;p33"/>
            <p:cNvSpPr/>
            <p:nvPr/>
          </p:nvSpPr>
          <p:spPr>
            <a:xfrm>
              <a:off x="503175" y="1260175"/>
              <a:ext cx="123250" cy="68600"/>
            </a:xfrm>
            <a:custGeom>
              <a:rect b="b" l="l" r="r" t="t"/>
              <a:pathLst>
                <a:path extrusionOk="0" fill="none" h="2744" w="4930">
                  <a:moveTo>
                    <a:pt x="465" y="977"/>
                  </a:moveTo>
                  <a:lnTo>
                    <a:pt x="977" y="977"/>
                  </a:lnTo>
                  <a:lnTo>
                    <a:pt x="977" y="2744"/>
                  </a:lnTo>
                  <a:lnTo>
                    <a:pt x="3953" y="2744"/>
                  </a:lnTo>
                  <a:lnTo>
                    <a:pt x="3953" y="977"/>
                  </a:lnTo>
                  <a:lnTo>
                    <a:pt x="4464" y="977"/>
                  </a:lnTo>
                  <a:lnTo>
                    <a:pt x="4464" y="977"/>
                  </a:lnTo>
                  <a:lnTo>
                    <a:pt x="4650" y="930"/>
                  </a:lnTo>
                  <a:lnTo>
                    <a:pt x="4790" y="837"/>
                  </a:lnTo>
                  <a:lnTo>
                    <a:pt x="4929" y="698"/>
                  </a:lnTo>
                  <a:lnTo>
                    <a:pt x="4929" y="512"/>
                  </a:lnTo>
                  <a:lnTo>
                    <a:pt x="4929" y="512"/>
                  </a:lnTo>
                  <a:lnTo>
                    <a:pt x="4929" y="326"/>
                  </a:lnTo>
                  <a:lnTo>
                    <a:pt x="4790" y="140"/>
                  </a:lnTo>
                  <a:lnTo>
                    <a:pt x="4650" y="47"/>
                  </a:lnTo>
                  <a:lnTo>
                    <a:pt x="4464" y="0"/>
                  </a:lnTo>
                  <a:lnTo>
                    <a:pt x="465" y="0"/>
                  </a:lnTo>
                  <a:lnTo>
                    <a:pt x="465" y="0"/>
                  </a:lnTo>
                  <a:lnTo>
                    <a:pt x="279" y="47"/>
                  </a:lnTo>
                  <a:lnTo>
                    <a:pt x="140" y="140"/>
                  </a:lnTo>
                  <a:lnTo>
                    <a:pt x="47" y="326"/>
                  </a:lnTo>
                  <a:lnTo>
                    <a:pt x="0" y="512"/>
                  </a:lnTo>
                  <a:lnTo>
                    <a:pt x="0" y="512"/>
                  </a:lnTo>
                  <a:lnTo>
                    <a:pt x="47" y="698"/>
                  </a:lnTo>
                  <a:lnTo>
                    <a:pt x="140" y="837"/>
                  </a:lnTo>
                  <a:lnTo>
                    <a:pt x="279" y="930"/>
                  </a:lnTo>
                  <a:lnTo>
                    <a:pt x="465" y="977"/>
                  </a:lnTo>
                  <a:lnTo>
                    <a:pt x="465" y="977"/>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3" name="Google Shape;483;p33"/>
            <p:cNvSpPr/>
            <p:nvPr/>
          </p:nvSpPr>
          <p:spPr>
            <a:xfrm>
              <a:off x="514800" y="128457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4" name="Google Shape;484;p33"/>
            <p:cNvSpPr/>
            <p:nvPr/>
          </p:nvSpPr>
          <p:spPr>
            <a:xfrm>
              <a:off x="527575" y="1585675"/>
              <a:ext cx="74425" cy="25600"/>
            </a:xfrm>
            <a:custGeom>
              <a:rect b="b" l="l" r="r" t="t"/>
              <a:pathLst>
                <a:path extrusionOk="0" h="1024" w="2977">
                  <a:moveTo>
                    <a:pt x="1" y="0"/>
                  </a:moveTo>
                  <a:lnTo>
                    <a:pt x="1" y="1023"/>
                  </a:lnTo>
                  <a:lnTo>
                    <a:pt x="2977" y="1023"/>
                  </a:lnTo>
                  <a:lnTo>
                    <a:pt x="2977"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5" name="Google Shape;485;p33"/>
            <p:cNvSpPr/>
            <p:nvPr/>
          </p:nvSpPr>
          <p:spPr>
            <a:xfrm>
              <a:off x="503175" y="1477550"/>
              <a:ext cx="123250" cy="83725"/>
            </a:xfrm>
            <a:custGeom>
              <a:rect b="b" l="l" r="r" t="t"/>
              <a:pathLst>
                <a:path extrusionOk="0" h="3349" w="4930">
                  <a:moveTo>
                    <a:pt x="0" y="1"/>
                  </a:moveTo>
                  <a:lnTo>
                    <a:pt x="0" y="3349"/>
                  </a:lnTo>
                  <a:lnTo>
                    <a:pt x="4929" y="3349"/>
                  </a:lnTo>
                  <a:lnTo>
                    <a:pt x="4929" y="2000"/>
                  </a:lnTo>
                  <a:lnTo>
                    <a:pt x="3116" y="2000"/>
                  </a:lnTo>
                  <a:lnTo>
                    <a:pt x="2883" y="1954"/>
                  </a:lnTo>
                  <a:lnTo>
                    <a:pt x="2744" y="1861"/>
                  </a:lnTo>
                  <a:lnTo>
                    <a:pt x="2651" y="1675"/>
                  </a:lnTo>
                  <a:lnTo>
                    <a:pt x="2604" y="1489"/>
                  </a:lnTo>
                  <a:lnTo>
                    <a:pt x="2651" y="1303"/>
                  </a:lnTo>
                  <a:lnTo>
                    <a:pt x="2744" y="1117"/>
                  </a:lnTo>
                  <a:lnTo>
                    <a:pt x="2883" y="1024"/>
                  </a:lnTo>
                  <a:lnTo>
                    <a:pt x="3116" y="977"/>
                  </a:lnTo>
                  <a:lnTo>
                    <a:pt x="4929" y="977"/>
                  </a:lnTo>
                  <a:lnTo>
                    <a:pt x="4929"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6" name="Google Shape;486;p33"/>
            <p:cNvSpPr/>
            <p:nvPr/>
          </p:nvSpPr>
          <p:spPr>
            <a:xfrm>
              <a:off x="503175" y="1477550"/>
              <a:ext cx="123250" cy="83725"/>
            </a:xfrm>
            <a:custGeom>
              <a:rect b="b" l="l" r="r" t="t"/>
              <a:pathLst>
                <a:path extrusionOk="0" fill="none" h="3349" w="4930">
                  <a:moveTo>
                    <a:pt x="0" y="3349"/>
                  </a:moveTo>
                  <a:lnTo>
                    <a:pt x="4929" y="3349"/>
                  </a:lnTo>
                  <a:lnTo>
                    <a:pt x="4929" y="2000"/>
                  </a:lnTo>
                  <a:lnTo>
                    <a:pt x="3116" y="2000"/>
                  </a:lnTo>
                  <a:lnTo>
                    <a:pt x="3116" y="2000"/>
                  </a:lnTo>
                  <a:lnTo>
                    <a:pt x="2883" y="1954"/>
                  </a:lnTo>
                  <a:lnTo>
                    <a:pt x="2744" y="1861"/>
                  </a:lnTo>
                  <a:lnTo>
                    <a:pt x="2651" y="1675"/>
                  </a:lnTo>
                  <a:lnTo>
                    <a:pt x="2604" y="1489"/>
                  </a:lnTo>
                  <a:lnTo>
                    <a:pt x="2604" y="1489"/>
                  </a:lnTo>
                  <a:lnTo>
                    <a:pt x="2651" y="1303"/>
                  </a:lnTo>
                  <a:lnTo>
                    <a:pt x="2744" y="1117"/>
                  </a:lnTo>
                  <a:lnTo>
                    <a:pt x="2883" y="1024"/>
                  </a:lnTo>
                  <a:lnTo>
                    <a:pt x="3116" y="977"/>
                  </a:lnTo>
                  <a:lnTo>
                    <a:pt x="4929" y="977"/>
                  </a:lnTo>
                  <a:lnTo>
                    <a:pt x="4929" y="1"/>
                  </a:lnTo>
                  <a:lnTo>
                    <a:pt x="0" y="1"/>
                  </a:lnTo>
                  <a:lnTo>
                    <a:pt x="0" y="3349"/>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7" name="Google Shape;487;p33"/>
            <p:cNvSpPr/>
            <p:nvPr/>
          </p:nvSpPr>
          <p:spPr>
            <a:xfrm>
              <a:off x="503175" y="1561250"/>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8" name="Google Shape;488;p33"/>
            <p:cNvSpPr/>
            <p:nvPr/>
          </p:nvSpPr>
          <p:spPr>
            <a:xfrm>
              <a:off x="483400" y="1353175"/>
              <a:ext cx="163950" cy="100000"/>
            </a:xfrm>
            <a:custGeom>
              <a:rect b="b" l="l" r="r" t="t"/>
              <a:pathLst>
                <a:path extrusionOk="0" h="4000" w="6558">
                  <a:moveTo>
                    <a:pt x="466" y="0"/>
                  </a:moveTo>
                  <a:lnTo>
                    <a:pt x="280" y="47"/>
                  </a:lnTo>
                  <a:lnTo>
                    <a:pt x="140" y="140"/>
                  </a:lnTo>
                  <a:lnTo>
                    <a:pt x="47" y="326"/>
                  </a:lnTo>
                  <a:lnTo>
                    <a:pt x="1" y="512"/>
                  </a:lnTo>
                  <a:lnTo>
                    <a:pt x="47" y="698"/>
                  </a:lnTo>
                  <a:lnTo>
                    <a:pt x="140" y="884"/>
                  </a:lnTo>
                  <a:lnTo>
                    <a:pt x="280" y="977"/>
                  </a:lnTo>
                  <a:lnTo>
                    <a:pt x="466" y="1023"/>
                  </a:lnTo>
                  <a:lnTo>
                    <a:pt x="791" y="1023"/>
                  </a:lnTo>
                  <a:lnTo>
                    <a:pt x="791" y="3999"/>
                  </a:lnTo>
                  <a:lnTo>
                    <a:pt x="5720" y="3999"/>
                  </a:lnTo>
                  <a:lnTo>
                    <a:pt x="5720" y="2976"/>
                  </a:lnTo>
                  <a:lnTo>
                    <a:pt x="3907" y="2976"/>
                  </a:lnTo>
                  <a:lnTo>
                    <a:pt x="3674" y="2930"/>
                  </a:lnTo>
                  <a:lnTo>
                    <a:pt x="3535" y="2837"/>
                  </a:lnTo>
                  <a:lnTo>
                    <a:pt x="3442" y="2697"/>
                  </a:lnTo>
                  <a:lnTo>
                    <a:pt x="3395" y="2511"/>
                  </a:lnTo>
                  <a:lnTo>
                    <a:pt x="3442" y="2325"/>
                  </a:lnTo>
                  <a:lnTo>
                    <a:pt x="3535" y="2139"/>
                  </a:lnTo>
                  <a:lnTo>
                    <a:pt x="3674" y="2046"/>
                  </a:lnTo>
                  <a:lnTo>
                    <a:pt x="3907" y="2000"/>
                  </a:lnTo>
                  <a:lnTo>
                    <a:pt x="5720" y="2000"/>
                  </a:lnTo>
                  <a:lnTo>
                    <a:pt x="5720" y="1023"/>
                  </a:lnTo>
                  <a:lnTo>
                    <a:pt x="6046" y="1023"/>
                  </a:lnTo>
                  <a:lnTo>
                    <a:pt x="6232" y="977"/>
                  </a:lnTo>
                  <a:lnTo>
                    <a:pt x="6371" y="884"/>
                  </a:lnTo>
                  <a:lnTo>
                    <a:pt x="6511" y="698"/>
                  </a:lnTo>
                  <a:lnTo>
                    <a:pt x="6557" y="512"/>
                  </a:lnTo>
                  <a:lnTo>
                    <a:pt x="6511" y="326"/>
                  </a:lnTo>
                  <a:lnTo>
                    <a:pt x="6371" y="140"/>
                  </a:lnTo>
                  <a:lnTo>
                    <a:pt x="6232" y="47"/>
                  </a:lnTo>
                  <a:lnTo>
                    <a:pt x="6046" y="0"/>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89" name="Google Shape;489;p33"/>
            <p:cNvSpPr/>
            <p:nvPr/>
          </p:nvSpPr>
          <p:spPr>
            <a:xfrm>
              <a:off x="483400" y="1353175"/>
              <a:ext cx="163950" cy="100000"/>
            </a:xfrm>
            <a:custGeom>
              <a:rect b="b" l="l" r="r" t="t"/>
              <a:pathLst>
                <a:path extrusionOk="0" fill="none" h="4000" w="6558">
                  <a:moveTo>
                    <a:pt x="6046" y="0"/>
                  </a:moveTo>
                  <a:lnTo>
                    <a:pt x="466" y="0"/>
                  </a:lnTo>
                  <a:lnTo>
                    <a:pt x="466" y="0"/>
                  </a:lnTo>
                  <a:lnTo>
                    <a:pt x="280" y="47"/>
                  </a:lnTo>
                  <a:lnTo>
                    <a:pt x="140" y="140"/>
                  </a:lnTo>
                  <a:lnTo>
                    <a:pt x="47" y="326"/>
                  </a:lnTo>
                  <a:lnTo>
                    <a:pt x="1" y="512"/>
                  </a:lnTo>
                  <a:lnTo>
                    <a:pt x="1" y="512"/>
                  </a:lnTo>
                  <a:lnTo>
                    <a:pt x="47" y="698"/>
                  </a:lnTo>
                  <a:lnTo>
                    <a:pt x="140" y="884"/>
                  </a:lnTo>
                  <a:lnTo>
                    <a:pt x="280" y="977"/>
                  </a:lnTo>
                  <a:lnTo>
                    <a:pt x="466" y="1023"/>
                  </a:lnTo>
                  <a:lnTo>
                    <a:pt x="791" y="1023"/>
                  </a:lnTo>
                  <a:lnTo>
                    <a:pt x="791" y="3999"/>
                  </a:lnTo>
                  <a:lnTo>
                    <a:pt x="5720" y="3999"/>
                  </a:lnTo>
                  <a:lnTo>
                    <a:pt x="5720" y="2976"/>
                  </a:lnTo>
                  <a:lnTo>
                    <a:pt x="3907" y="2976"/>
                  </a:lnTo>
                  <a:lnTo>
                    <a:pt x="3907" y="2976"/>
                  </a:lnTo>
                  <a:lnTo>
                    <a:pt x="3674" y="2930"/>
                  </a:lnTo>
                  <a:lnTo>
                    <a:pt x="3535" y="2837"/>
                  </a:lnTo>
                  <a:lnTo>
                    <a:pt x="3442" y="2697"/>
                  </a:lnTo>
                  <a:lnTo>
                    <a:pt x="3395" y="2511"/>
                  </a:lnTo>
                  <a:lnTo>
                    <a:pt x="3395" y="2511"/>
                  </a:lnTo>
                  <a:lnTo>
                    <a:pt x="3442" y="2325"/>
                  </a:lnTo>
                  <a:lnTo>
                    <a:pt x="3535" y="2139"/>
                  </a:lnTo>
                  <a:lnTo>
                    <a:pt x="3674" y="2046"/>
                  </a:lnTo>
                  <a:lnTo>
                    <a:pt x="3907" y="2000"/>
                  </a:lnTo>
                  <a:lnTo>
                    <a:pt x="5720" y="2000"/>
                  </a:lnTo>
                  <a:lnTo>
                    <a:pt x="5720" y="1023"/>
                  </a:lnTo>
                  <a:lnTo>
                    <a:pt x="6046" y="1023"/>
                  </a:lnTo>
                  <a:lnTo>
                    <a:pt x="6046" y="1023"/>
                  </a:lnTo>
                  <a:lnTo>
                    <a:pt x="6232" y="977"/>
                  </a:lnTo>
                  <a:lnTo>
                    <a:pt x="6371" y="884"/>
                  </a:lnTo>
                  <a:lnTo>
                    <a:pt x="6511" y="698"/>
                  </a:lnTo>
                  <a:lnTo>
                    <a:pt x="6557" y="512"/>
                  </a:lnTo>
                  <a:lnTo>
                    <a:pt x="6557" y="512"/>
                  </a:lnTo>
                  <a:lnTo>
                    <a:pt x="6511" y="326"/>
                  </a:lnTo>
                  <a:lnTo>
                    <a:pt x="6371" y="140"/>
                  </a:lnTo>
                  <a:lnTo>
                    <a:pt x="6232" y="47"/>
                  </a:lnTo>
                  <a:lnTo>
                    <a:pt x="6046" y="0"/>
                  </a:lnTo>
                  <a:lnTo>
                    <a:pt x="6046"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0" name="Google Shape;490;p33"/>
            <p:cNvSpPr/>
            <p:nvPr/>
          </p:nvSpPr>
          <p:spPr>
            <a:xfrm>
              <a:off x="634525" y="1353175"/>
              <a:ext cx="25" cy="25"/>
            </a:xfrm>
            <a:custGeom>
              <a:rect b="b" l="l" r="r" t="t"/>
              <a:pathLst>
                <a:path extrusionOk="0" fill="none" h="1" w="1">
                  <a:moveTo>
                    <a:pt x="1" y="0"/>
                  </a:moveTo>
                  <a:lnTo>
                    <a:pt x="1" y="0"/>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1" name="Google Shape;491;p33"/>
            <p:cNvSpPr/>
            <p:nvPr/>
          </p:nvSpPr>
          <p:spPr>
            <a:xfrm>
              <a:off x="552000" y="1635650"/>
              <a:ext cx="25600" cy="47700"/>
            </a:xfrm>
            <a:custGeom>
              <a:rect b="b" l="l" r="r" t="t"/>
              <a:pathLst>
                <a:path extrusionOk="0" h="1908" w="1024">
                  <a:moveTo>
                    <a:pt x="0" y="1"/>
                  </a:moveTo>
                  <a:lnTo>
                    <a:pt x="0" y="1396"/>
                  </a:lnTo>
                  <a:lnTo>
                    <a:pt x="47" y="1582"/>
                  </a:lnTo>
                  <a:lnTo>
                    <a:pt x="186" y="1768"/>
                  </a:lnTo>
                  <a:lnTo>
                    <a:pt x="326" y="1861"/>
                  </a:lnTo>
                  <a:lnTo>
                    <a:pt x="512" y="1907"/>
                  </a:lnTo>
                  <a:lnTo>
                    <a:pt x="698" y="1861"/>
                  </a:lnTo>
                  <a:lnTo>
                    <a:pt x="884" y="1768"/>
                  </a:lnTo>
                  <a:lnTo>
                    <a:pt x="977" y="1582"/>
                  </a:lnTo>
                  <a:lnTo>
                    <a:pt x="1023" y="1396"/>
                  </a:lnTo>
                  <a:lnTo>
                    <a:pt x="1023" y="1"/>
                  </a:lnTo>
                  <a:close/>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2" name="Google Shape;492;p33"/>
            <p:cNvSpPr/>
            <p:nvPr/>
          </p:nvSpPr>
          <p:spPr>
            <a:xfrm>
              <a:off x="552000" y="1635650"/>
              <a:ext cx="25600" cy="47700"/>
            </a:xfrm>
            <a:custGeom>
              <a:rect b="b" l="l" r="r" t="t"/>
              <a:pathLst>
                <a:path extrusionOk="0" fill="none" h="1908" w="1024">
                  <a:moveTo>
                    <a:pt x="0" y="1396"/>
                  </a:moveTo>
                  <a:lnTo>
                    <a:pt x="0" y="1396"/>
                  </a:lnTo>
                  <a:lnTo>
                    <a:pt x="47" y="1582"/>
                  </a:lnTo>
                  <a:lnTo>
                    <a:pt x="186" y="1768"/>
                  </a:lnTo>
                  <a:lnTo>
                    <a:pt x="326" y="1861"/>
                  </a:lnTo>
                  <a:lnTo>
                    <a:pt x="512" y="1907"/>
                  </a:lnTo>
                  <a:lnTo>
                    <a:pt x="512" y="1907"/>
                  </a:lnTo>
                  <a:lnTo>
                    <a:pt x="698" y="1861"/>
                  </a:lnTo>
                  <a:lnTo>
                    <a:pt x="884" y="1768"/>
                  </a:lnTo>
                  <a:lnTo>
                    <a:pt x="977" y="1582"/>
                  </a:lnTo>
                  <a:lnTo>
                    <a:pt x="1023" y="1396"/>
                  </a:lnTo>
                  <a:lnTo>
                    <a:pt x="1023" y="1"/>
                  </a:lnTo>
                  <a:lnTo>
                    <a:pt x="0" y="1"/>
                  </a:lnTo>
                  <a:lnTo>
                    <a:pt x="0" y="1396"/>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3" name="Google Shape;493;p33"/>
            <p:cNvSpPr/>
            <p:nvPr/>
          </p:nvSpPr>
          <p:spPr>
            <a:xfrm>
              <a:off x="552000" y="1670525"/>
              <a:ext cx="25" cy="25"/>
            </a:xfrm>
            <a:custGeom>
              <a:rect b="b" l="l" r="r" t="t"/>
              <a:pathLst>
                <a:path extrusionOk="0" fill="none" h="1" w="1">
                  <a:moveTo>
                    <a:pt x="0" y="1"/>
                  </a:moveTo>
                  <a:lnTo>
                    <a:pt x="0" y="1"/>
                  </a:lnTo>
                </a:path>
              </a:pathLst>
            </a:custGeom>
            <a:solidFill>
              <a:srgbClr val="332C27"/>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grpSp>
      <p:sp>
        <p:nvSpPr>
          <p:cNvPr id="494" name="Google Shape;494;p33"/>
          <p:cNvSpPr txBox="1"/>
          <p:nvPr/>
        </p:nvSpPr>
        <p:spPr>
          <a:xfrm>
            <a:off x="0" y="4835700"/>
            <a:ext cx="4888200" cy="307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800">
                <a:solidFill>
                  <a:schemeClr val="dk1"/>
                </a:solidFill>
                <a:latin typeface="Hind"/>
                <a:ea typeface="Hind"/>
                <a:cs typeface="Hind"/>
                <a:sym typeface="Hind"/>
              </a:rPr>
              <a:t>Liu et al. </a:t>
            </a:r>
            <a:r>
              <a:rPr i="1" lang="en" sz="800">
                <a:solidFill>
                  <a:schemeClr val="dk1"/>
                </a:solidFill>
                <a:latin typeface="Hind"/>
                <a:ea typeface="Hind"/>
                <a:cs typeface="Hind"/>
                <a:sym typeface="Hind"/>
              </a:rPr>
              <a:t>Asian J Psych</a:t>
            </a:r>
            <a:r>
              <a:rPr lang="en" sz="800">
                <a:solidFill>
                  <a:schemeClr val="dk1"/>
                </a:solidFill>
                <a:latin typeface="Hind"/>
                <a:ea typeface="Hind"/>
                <a:cs typeface="Hind"/>
                <a:sym typeface="Hind"/>
              </a:rPr>
              <a:t>. 2020; Oh et al. </a:t>
            </a:r>
            <a:r>
              <a:rPr i="1" lang="en" sz="800">
                <a:solidFill>
                  <a:schemeClr val="dk1"/>
                </a:solidFill>
                <a:latin typeface="Hind"/>
                <a:ea typeface="Hind"/>
                <a:cs typeface="Hind"/>
                <a:sym typeface="Hind"/>
              </a:rPr>
              <a:t>J Cross Cult Gerontol</a:t>
            </a:r>
            <a:r>
              <a:rPr lang="en" sz="800">
                <a:solidFill>
                  <a:schemeClr val="dk1"/>
                </a:solidFill>
                <a:latin typeface="Hind"/>
                <a:ea typeface="Hind"/>
                <a:cs typeface="Hind"/>
                <a:sym typeface="Hind"/>
              </a:rPr>
              <a:t>. 2022; Fancher et al. </a:t>
            </a:r>
            <a:r>
              <a:rPr i="1" lang="en" sz="800">
                <a:solidFill>
                  <a:schemeClr val="dk1"/>
                </a:solidFill>
                <a:latin typeface="Hind"/>
                <a:ea typeface="Hind"/>
                <a:cs typeface="Hind"/>
                <a:sym typeface="Hind"/>
              </a:rPr>
              <a:t>J Immigr Minor Health</a:t>
            </a:r>
            <a:r>
              <a:rPr lang="en" sz="800">
                <a:solidFill>
                  <a:schemeClr val="dk1"/>
                </a:solidFill>
                <a:latin typeface="Hind"/>
                <a:ea typeface="Hind"/>
                <a:cs typeface="Hind"/>
                <a:sym typeface="Hind"/>
              </a:rPr>
              <a:t>. 2010.</a:t>
            </a:r>
            <a:endParaRPr sz="800">
              <a:solidFill>
                <a:schemeClr val="dk1"/>
              </a:solidFill>
              <a:latin typeface="Hind"/>
              <a:ea typeface="Hind"/>
              <a:cs typeface="Hind"/>
              <a:sym typeface="Hind"/>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98" name="Shape 498"/>
        <p:cNvGrpSpPr/>
        <p:nvPr/>
      </p:nvGrpSpPr>
      <p:grpSpPr>
        <a:xfrm>
          <a:off x="0" y="0"/>
          <a:ext cx="0" cy="0"/>
          <a:chOff x="0" y="0"/>
          <a:chExt cx="0" cy="0"/>
        </a:xfrm>
      </p:grpSpPr>
      <p:sp>
        <p:nvSpPr>
          <p:cNvPr id="499" name="Google Shape;499;p34"/>
          <p:cNvSpPr txBox="1"/>
          <p:nvPr>
            <p:ph type="title"/>
          </p:nvPr>
        </p:nvSpPr>
        <p:spPr>
          <a:xfrm>
            <a:off x="645575" y="2060925"/>
            <a:ext cx="7704000" cy="11817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a:t>Part 2: Barriers to AANHPI Mental Health Care</a:t>
            </a:r>
            <a:endParaRPr/>
          </a:p>
        </p:txBody>
      </p:sp>
      <p:sp>
        <p:nvSpPr>
          <p:cNvPr id="500" name="Google Shape;500;p3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04" name="Shape 504"/>
        <p:cNvGrpSpPr/>
        <p:nvPr/>
      </p:nvGrpSpPr>
      <p:grpSpPr>
        <a:xfrm>
          <a:off x="0" y="0"/>
          <a:ext cx="0" cy="0"/>
          <a:chOff x="0" y="0"/>
          <a:chExt cx="0" cy="0"/>
        </a:xfrm>
      </p:grpSpPr>
      <p:sp>
        <p:nvSpPr>
          <p:cNvPr id="505" name="Google Shape;505;p35"/>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Reflection</a:t>
            </a:r>
            <a:endParaRPr/>
          </a:p>
        </p:txBody>
      </p:sp>
      <p:sp>
        <p:nvSpPr>
          <p:cNvPr id="506" name="Google Shape;506;p35"/>
          <p:cNvSpPr txBox="1"/>
          <p:nvPr>
            <p:ph idx="1" type="body"/>
          </p:nvPr>
        </p:nvSpPr>
        <p:spPr>
          <a:xfrm>
            <a:off x="720000" y="1546501"/>
            <a:ext cx="7704000" cy="2050500"/>
          </a:xfrm>
          <a:prstGeom prst="rect">
            <a:avLst/>
          </a:prstGeom>
        </p:spPr>
        <p:txBody>
          <a:bodyPr anchorCtr="0" anchor="t" bIns="91425" lIns="91425" spcFirstLastPara="1" rIns="91425" wrap="square" tIns="91425">
            <a:normAutofit/>
          </a:bodyPr>
          <a:lstStyle/>
          <a:p>
            <a:pPr indent="0" lvl="0" marL="0" rtl="0" algn="ctr">
              <a:spcBef>
                <a:spcPts val="0"/>
              </a:spcBef>
              <a:spcAft>
                <a:spcPts val="1200"/>
              </a:spcAft>
              <a:buNone/>
            </a:pPr>
            <a:r>
              <a:rPr lang="en" sz="3600"/>
              <a:t>What are some potential barriers to mental </a:t>
            </a:r>
            <a:r>
              <a:rPr lang="en" sz="3600"/>
              <a:t>healthcare</a:t>
            </a:r>
            <a:r>
              <a:rPr lang="en" sz="3600"/>
              <a:t> in AANHPI populations?</a:t>
            </a:r>
            <a:endParaRPr sz="3600"/>
          </a:p>
        </p:txBody>
      </p:sp>
      <p:sp>
        <p:nvSpPr>
          <p:cNvPr id="507" name="Google Shape;507;p3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11" name="Shape 511"/>
        <p:cNvGrpSpPr/>
        <p:nvPr/>
      </p:nvGrpSpPr>
      <p:grpSpPr>
        <a:xfrm>
          <a:off x="0" y="0"/>
          <a:ext cx="0" cy="0"/>
          <a:chOff x="0" y="0"/>
          <a:chExt cx="0" cy="0"/>
        </a:xfrm>
      </p:grpSpPr>
      <p:sp>
        <p:nvSpPr>
          <p:cNvPr id="512" name="Google Shape;512;p36"/>
          <p:cNvSpPr txBox="1"/>
          <p:nvPr>
            <p:ph type="title"/>
          </p:nvPr>
        </p:nvSpPr>
        <p:spPr>
          <a:xfrm>
            <a:off x="379650" y="191225"/>
            <a:ext cx="83847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300"/>
              <a:t>Lack of Access to Mental Health Care</a:t>
            </a:r>
            <a:endParaRPr sz="3300"/>
          </a:p>
        </p:txBody>
      </p:sp>
      <p:sp>
        <p:nvSpPr>
          <p:cNvPr id="513" name="Google Shape;513;p36"/>
          <p:cNvSpPr txBox="1"/>
          <p:nvPr/>
        </p:nvSpPr>
        <p:spPr>
          <a:xfrm>
            <a:off x="6651075" y="4435500"/>
            <a:ext cx="2541900" cy="646500"/>
          </a:xfrm>
          <a:prstGeom prst="rect">
            <a:avLst/>
          </a:prstGeom>
          <a:solidFill>
            <a:srgbClr val="EAB570">
              <a:alpha val="75320"/>
            </a:srgbClr>
          </a:solid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000">
                <a:solidFill>
                  <a:schemeClr val="dk1"/>
                </a:solidFill>
                <a:latin typeface="Hind"/>
                <a:ea typeface="Hind"/>
                <a:cs typeface="Hind"/>
                <a:sym typeface="Hind"/>
              </a:rPr>
              <a:t>NAMI: National Alliance on Mental Illness</a:t>
            </a:r>
            <a:endParaRPr sz="1000">
              <a:solidFill>
                <a:schemeClr val="dk1"/>
              </a:solidFill>
              <a:latin typeface="Hind"/>
              <a:ea typeface="Hind"/>
              <a:cs typeface="Hind"/>
              <a:sym typeface="Hind"/>
            </a:endParaRPr>
          </a:p>
          <a:p>
            <a:pPr indent="0" lvl="0" marL="0" rtl="0" algn="l">
              <a:spcBef>
                <a:spcPts val="0"/>
              </a:spcBef>
              <a:spcAft>
                <a:spcPts val="0"/>
              </a:spcAft>
              <a:buNone/>
            </a:pPr>
            <a:r>
              <a:rPr lang="en" sz="1000">
                <a:solidFill>
                  <a:schemeClr val="dk1"/>
                </a:solidFill>
                <a:latin typeface="Hind"/>
                <a:ea typeface="Hind"/>
                <a:cs typeface="Hind"/>
                <a:sym typeface="Hind"/>
              </a:rPr>
              <a:t>CAP: Center for American Progress</a:t>
            </a:r>
            <a:endParaRPr sz="1000">
              <a:solidFill>
                <a:schemeClr val="dk1"/>
              </a:solidFill>
              <a:latin typeface="Hind"/>
              <a:ea typeface="Hind"/>
              <a:cs typeface="Hind"/>
              <a:sym typeface="Hind"/>
            </a:endParaRPr>
          </a:p>
          <a:p>
            <a:pPr indent="0" lvl="0" marL="0" rtl="0" algn="l">
              <a:spcBef>
                <a:spcPts val="0"/>
              </a:spcBef>
              <a:spcAft>
                <a:spcPts val="0"/>
              </a:spcAft>
              <a:buNone/>
            </a:pPr>
            <a:r>
              <a:rPr lang="en" sz="1000">
                <a:solidFill>
                  <a:schemeClr val="dk1"/>
                </a:solidFill>
                <a:latin typeface="Hind"/>
                <a:ea typeface="Hind"/>
                <a:cs typeface="Hind"/>
                <a:sym typeface="Hind"/>
              </a:rPr>
              <a:t>NPR: National Public Radio</a:t>
            </a:r>
            <a:endParaRPr sz="1000">
              <a:solidFill>
                <a:schemeClr val="dk1"/>
              </a:solidFill>
              <a:latin typeface="Hind"/>
              <a:ea typeface="Hind"/>
              <a:cs typeface="Hind"/>
              <a:sym typeface="Hind"/>
            </a:endParaRPr>
          </a:p>
        </p:txBody>
      </p:sp>
      <p:sp>
        <p:nvSpPr>
          <p:cNvPr id="514" name="Google Shape;514;p36"/>
          <p:cNvSpPr txBox="1"/>
          <p:nvPr/>
        </p:nvSpPr>
        <p:spPr>
          <a:xfrm>
            <a:off x="0" y="4743300"/>
            <a:ext cx="3852600" cy="3387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000">
                <a:solidFill>
                  <a:schemeClr val="dk1"/>
                </a:solidFill>
                <a:latin typeface="Hind"/>
                <a:ea typeface="Hind"/>
                <a:cs typeface="Hind"/>
                <a:sym typeface="Hind"/>
              </a:rPr>
              <a:t>(NAMI, 2021; NPR, 2017) </a:t>
            </a:r>
            <a:endParaRPr sz="1000">
              <a:solidFill>
                <a:schemeClr val="dk1"/>
              </a:solidFill>
              <a:latin typeface="Hind"/>
              <a:ea typeface="Hind"/>
              <a:cs typeface="Hind"/>
              <a:sym typeface="Hind"/>
            </a:endParaRPr>
          </a:p>
        </p:txBody>
      </p:sp>
      <p:sp>
        <p:nvSpPr>
          <p:cNvPr id="515" name="Google Shape;515;p3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516" name="Google Shape;516;p36"/>
          <p:cNvSpPr txBox="1"/>
          <p:nvPr/>
        </p:nvSpPr>
        <p:spPr>
          <a:xfrm>
            <a:off x="1112550" y="897775"/>
            <a:ext cx="36756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i="1" lang="en">
                <a:solidFill>
                  <a:schemeClr val="dk1"/>
                </a:solidFill>
                <a:latin typeface="Hind"/>
                <a:ea typeface="Hind"/>
                <a:cs typeface="Hind"/>
                <a:sym typeface="Hind"/>
              </a:rPr>
              <a:t>In the </a:t>
            </a:r>
            <a:r>
              <a:rPr b="1" i="1" lang="en">
                <a:solidFill>
                  <a:schemeClr val="dk1"/>
                </a:solidFill>
                <a:latin typeface="Hind"/>
                <a:ea typeface="Hind"/>
                <a:cs typeface="Hind"/>
                <a:sym typeface="Hind"/>
              </a:rPr>
              <a:t>2021 NAMI Mood Disorder Survey</a:t>
            </a:r>
            <a:r>
              <a:rPr i="1" lang="en">
                <a:solidFill>
                  <a:schemeClr val="dk1"/>
                </a:solidFill>
                <a:latin typeface="Hind"/>
                <a:ea typeface="Hind"/>
                <a:cs typeface="Hind"/>
                <a:sym typeface="Hind"/>
              </a:rPr>
              <a:t>:</a:t>
            </a:r>
            <a:endParaRPr i="1">
              <a:solidFill>
                <a:schemeClr val="dk1"/>
              </a:solidFill>
              <a:latin typeface="Hind"/>
              <a:ea typeface="Hind"/>
              <a:cs typeface="Hind"/>
              <a:sym typeface="Hind"/>
            </a:endParaRPr>
          </a:p>
        </p:txBody>
      </p:sp>
      <p:sp>
        <p:nvSpPr>
          <p:cNvPr id="517" name="Google Shape;517;p36"/>
          <p:cNvSpPr txBox="1"/>
          <p:nvPr/>
        </p:nvSpPr>
        <p:spPr>
          <a:xfrm>
            <a:off x="1112550" y="2100175"/>
            <a:ext cx="55794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i="1" lang="en">
                <a:solidFill>
                  <a:schemeClr val="dk1"/>
                </a:solidFill>
                <a:latin typeface="Hind"/>
                <a:ea typeface="Hind"/>
                <a:cs typeface="Hind"/>
                <a:sym typeface="Hind"/>
              </a:rPr>
              <a:t>In the </a:t>
            </a:r>
            <a:r>
              <a:rPr b="1" i="1" lang="en">
                <a:solidFill>
                  <a:schemeClr val="dk1"/>
                </a:solidFill>
                <a:latin typeface="Hind"/>
                <a:ea typeface="Hind"/>
                <a:cs typeface="Hind"/>
                <a:sym typeface="Hind"/>
              </a:rPr>
              <a:t>2024 California Health Interview Survey</a:t>
            </a:r>
            <a:r>
              <a:rPr i="1" lang="en">
                <a:solidFill>
                  <a:schemeClr val="dk1"/>
                </a:solidFill>
                <a:latin typeface="Hind"/>
                <a:ea typeface="Hind"/>
                <a:cs typeface="Hind"/>
                <a:sym typeface="Hind"/>
              </a:rPr>
              <a:t>: </a:t>
            </a:r>
            <a:endParaRPr i="1">
              <a:solidFill>
                <a:schemeClr val="dk1"/>
              </a:solidFill>
              <a:latin typeface="Hind"/>
              <a:ea typeface="Hind"/>
              <a:cs typeface="Hind"/>
              <a:sym typeface="Hind"/>
            </a:endParaRPr>
          </a:p>
        </p:txBody>
      </p:sp>
      <p:sp>
        <p:nvSpPr>
          <p:cNvPr id="518" name="Google Shape;518;p36"/>
          <p:cNvSpPr txBox="1"/>
          <p:nvPr/>
        </p:nvSpPr>
        <p:spPr>
          <a:xfrm>
            <a:off x="1112550" y="1226238"/>
            <a:ext cx="1592700" cy="7689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6000">
                <a:solidFill>
                  <a:schemeClr val="accent1"/>
                </a:solidFill>
                <a:latin typeface="Hind"/>
                <a:ea typeface="Hind"/>
                <a:cs typeface="Hind"/>
                <a:sym typeface="Hind"/>
              </a:rPr>
              <a:t>55</a:t>
            </a:r>
            <a:r>
              <a:rPr lang="en" sz="6000">
                <a:solidFill>
                  <a:schemeClr val="accent1"/>
                </a:solidFill>
                <a:latin typeface="Hind"/>
                <a:ea typeface="Hind"/>
                <a:cs typeface="Hind"/>
                <a:sym typeface="Hind"/>
              </a:rPr>
              <a:t>%</a:t>
            </a:r>
            <a:endParaRPr sz="6000">
              <a:solidFill>
                <a:schemeClr val="accent1"/>
              </a:solidFill>
              <a:latin typeface="Hind"/>
              <a:ea typeface="Hind"/>
              <a:cs typeface="Hind"/>
              <a:sym typeface="Hind"/>
            </a:endParaRPr>
          </a:p>
        </p:txBody>
      </p:sp>
      <p:sp>
        <p:nvSpPr>
          <p:cNvPr id="519" name="Google Shape;519;p36"/>
          <p:cNvSpPr txBox="1"/>
          <p:nvPr/>
        </p:nvSpPr>
        <p:spPr>
          <a:xfrm>
            <a:off x="1112550" y="1924050"/>
            <a:ext cx="3675600" cy="9609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b="1" sz="6000">
              <a:solidFill>
                <a:schemeClr val="accent1"/>
              </a:solidFill>
              <a:latin typeface="Hind"/>
              <a:ea typeface="Hind"/>
              <a:cs typeface="Hind"/>
              <a:sym typeface="Hind"/>
            </a:endParaRPr>
          </a:p>
          <a:p>
            <a:pPr indent="0" lvl="0" marL="0" rtl="0" algn="l">
              <a:spcBef>
                <a:spcPts val="0"/>
              </a:spcBef>
              <a:spcAft>
                <a:spcPts val="0"/>
              </a:spcAft>
              <a:buNone/>
            </a:pPr>
            <a:r>
              <a:rPr b="1" lang="en" sz="6000">
                <a:solidFill>
                  <a:schemeClr val="accent1"/>
                </a:solidFill>
                <a:latin typeface="Hind"/>
                <a:ea typeface="Hind"/>
                <a:cs typeface="Hind"/>
                <a:sym typeface="Hind"/>
              </a:rPr>
              <a:t>42</a:t>
            </a:r>
            <a:r>
              <a:rPr lang="en" sz="6000">
                <a:solidFill>
                  <a:schemeClr val="accent1"/>
                </a:solidFill>
                <a:latin typeface="Hind"/>
                <a:ea typeface="Hind"/>
                <a:cs typeface="Hind"/>
                <a:sym typeface="Hind"/>
              </a:rPr>
              <a:t>%</a:t>
            </a:r>
            <a:r>
              <a:rPr lang="en" sz="6000">
                <a:solidFill>
                  <a:schemeClr val="dk1"/>
                </a:solidFill>
                <a:latin typeface="Hind"/>
                <a:ea typeface="Hind"/>
                <a:cs typeface="Hind"/>
                <a:sym typeface="Hind"/>
              </a:rPr>
              <a:t>&amp;</a:t>
            </a:r>
            <a:r>
              <a:rPr lang="en" sz="6000">
                <a:solidFill>
                  <a:schemeClr val="accent1"/>
                </a:solidFill>
                <a:latin typeface="Hind"/>
                <a:ea typeface="Hind"/>
                <a:cs typeface="Hind"/>
                <a:sym typeface="Hind"/>
              </a:rPr>
              <a:t> </a:t>
            </a:r>
            <a:r>
              <a:rPr b="1" lang="en" sz="6000">
                <a:solidFill>
                  <a:schemeClr val="accent1"/>
                </a:solidFill>
                <a:latin typeface="Hind"/>
                <a:ea typeface="Hind"/>
                <a:cs typeface="Hind"/>
                <a:sym typeface="Hind"/>
              </a:rPr>
              <a:t>31</a:t>
            </a:r>
            <a:r>
              <a:rPr lang="en" sz="6000">
                <a:solidFill>
                  <a:schemeClr val="accent1"/>
                </a:solidFill>
                <a:latin typeface="Hind"/>
                <a:ea typeface="Hind"/>
                <a:cs typeface="Hind"/>
                <a:sym typeface="Hind"/>
              </a:rPr>
              <a:t>%</a:t>
            </a:r>
            <a:endParaRPr sz="6000">
              <a:solidFill>
                <a:schemeClr val="accent1"/>
              </a:solidFill>
              <a:latin typeface="Hind"/>
              <a:ea typeface="Hind"/>
              <a:cs typeface="Hind"/>
              <a:sym typeface="Hind"/>
            </a:endParaRPr>
          </a:p>
        </p:txBody>
      </p:sp>
      <p:sp>
        <p:nvSpPr>
          <p:cNvPr id="520" name="Google Shape;520;p36"/>
          <p:cNvSpPr txBox="1"/>
          <p:nvPr/>
        </p:nvSpPr>
        <p:spPr>
          <a:xfrm>
            <a:off x="2705250" y="1241238"/>
            <a:ext cx="36756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b="1" lang="en" sz="1800">
                <a:solidFill>
                  <a:schemeClr val="dk1"/>
                </a:solidFill>
                <a:latin typeface="Hind"/>
                <a:ea typeface="Hind"/>
                <a:cs typeface="Hind"/>
                <a:sym typeface="Hind"/>
              </a:rPr>
              <a:t>of AAs needed mental health support but did not receive it</a:t>
            </a:r>
            <a:endParaRPr b="1" sz="1800">
              <a:solidFill>
                <a:schemeClr val="dk1"/>
              </a:solidFill>
              <a:latin typeface="Hind"/>
              <a:ea typeface="Hind"/>
              <a:cs typeface="Hind"/>
              <a:sym typeface="Hind"/>
            </a:endParaRPr>
          </a:p>
        </p:txBody>
      </p:sp>
      <p:sp>
        <p:nvSpPr>
          <p:cNvPr id="521" name="Google Shape;521;p36"/>
          <p:cNvSpPr txBox="1"/>
          <p:nvPr/>
        </p:nvSpPr>
        <p:spPr>
          <a:xfrm>
            <a:off x="1254750" y="3124288"/>
            <a:ext cx="1308300" cy="4617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b="1" lang="en" sz="1800">
                <a:solidFill>
                  <a:schemeClr val="dk1"/>
                </a:solidFill>
                <a:latin typeface="Hind"/>
                <a:ea typeface="Hind"/>
                <a:cs typeface="Hind"/>
                <a:sym typeface="Hind"/>
              </a:rPr>
              <a:t>of NHPIs</a:t>
            </a:r>
            <a:endParaRPr b="1" sz="1800">
              <a:solidFill>
                <a:schemeClr val="dk1"/>
              </a:solidFill>
              <a:latin typeface="Hind"/>
              <a:ea typeface="Hind"/>
              <a:cs typeface="Hind"/>
              <a:sym typeface="Hind"/>
            </a:endParaRPr>
          </a:p>
        </p:txBody>
      </p:sp>
      <p:sp>
        <p:nvSpPr>
          <p:cNvPr id="522" name="Google Shape;522;p36"/>
          <p:cNvSpPr txBox="1"/>
          <p:nvPr/>
        </p:nvSpPr>
        <p:spPr>
          <a:xfrm>
            <a:off x="3331200" y="3124275"/>
            <a:ext cx="1308300" cy="4617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b="1" lang="en" sz="1800">
                <a:solidFill>
                  <a:schemeClr val="dk1"/>
                </a:solidFill>
                <a:latin typeface="Hind"/>
                <a:ea typeface="Hind"/>
                <a:cs typeface="Hind"/>
                <a:sym typeface="Hind"/>
              </a:rPr>
              <a:t>of AAs</a:t>
            </a:r>
            <a:endParaRPr b="1" sz="1800">
              <a:solidFill>
                <a:schemeClr val="dk1"/>
              </a:solidFill>
              <a:latin typeface="Hind"/>
              <a:ea typeface="Hind"/>
              <a:cs typeface="Hind"/>
              <a:sym typeface="Hind"/>
            </a:endParaRPr>
          </a:p>
        </p:txBody>
      </p:sp>
      <p:sp>
        <p:nvSpPr>
          <p:cNvPr id="523" name="Google Shape;523;p36"/>
          <p:cNvSpPr txBox="1"/>
          <p:nvPr/>
        </p:nvSpPr>
        <p:spPr>
          <a:xfrm>
            <a:off x="4639500" y="2524725"/>
            <a:ext cx="36756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b="1" lang="en" sz="1800">
                <a:solidFill>
                  <a:schemeClr val="dk1"/>
                </a:solidFill>
                <a:latin typeface="Hind"/>
                <a:ea typeface="Hind"/>
                <a:cs typeface="Hind"/>
                <a:sym typeface="Hind"/>
              </a:rPr>
              <a:t>experienced difficulties accessing </a:t>
            </a:r>
            <a:br>
              <a:rPr b="1" lang="en" sz="1800">
                <a:solidFill>
                  <a:schemeClr val="dk1"/>
                </a:solidFill>
                <a:latin typeface="Hind"/>
                <a:ea typeface="Hind"/>
                <a:cs typeface="Hind"/>
                <a:sym typeface="Hind"/>
              </a:rPr>
            </a:br>
            <a:r>
              <a:rPr b="1" lang="en" sz="1800">
                <a:solidFill>
                  <a:schemeClr val="dk1"/>
                </a:solidFill>
                <a:latin typeface="Hind"/>
                <a:ea typeface="Hind"/>
                <a:cs typeface="Hind"/>
                <a:sym typeface="Hind"/>
              </a:rPr>
              <a:t>mental health services</a:t>
            </a:r>
            <a:endParaRPr b="1" sz="1800">
              <a:solidFill>
                <a:schemeClr val="dk1"/>
              </a:solidFill>
              <a:latin typeface="Hind"/>
              <a:ea typeface="Hind"/>
              <a:cs typeface="Hind"/>
              <a:sym typeface="Hind"/>
            </a:endParaRPr>
          </a:p>
        </p:txBody>
      </p:sp>
      <p:grpSp>
        <p:nvGrpSpPr>
          <p:cNvPr id="524" name="Google Shape;524;p36"/>
          <p:cNvGrpSpPr/>
          <p:nvPr/>
        </p:nvGrpSpPr>
        <p:grpSpPr>
          <a:xfrm>
            <a:off x="2449275" y="3460800"/>
            <a:ext cx="4245450" cy="1621200"/>
            <a:chOff x="2449275" y="3403000"/>
            <a:chExt cx="4245450" cy="1621200"/>
          </a:xfrm>
        </p:grpSpPr>
        <p:sp>
          <p:nvSpPr>
            <p:cNvPr id="525" name="Google Shape;525;p36"/>
            <p:cNvSpPr txBox="1"/>
            <p:nvPr/>
          </p:nvSpPr>
          <p:spPr>
            <a:xfrm>
              <a:off x="2449275" y="3403000"/>
              <a:ext cx="1592700" cy="1621200"/>
            </a:xfrm>
            <a:prstGeom prst="rect">
              <a:avLst/>
            </a:prstGeom>
            <a:noFill/>
            <a:ln>
              <a:noFill/>
            </a:ln>
          </p:spPr>
          <p:txBody>
            <a:bodyPr anchorCtr="0" anchor="ctr" bIns="91425" lIns="91425" spcFirstLastPara="1" rIns="91425" wrap="square" tIns="91425">
              <a:spAutoFit/>
            </a:bodyPr>
            <a:lstStyle/>
            <a:p>
              <a:pPr indent="0" lvl="0" marL="0" rtl="0" algn="ctr">
                <a:spcBef>
                  <a:spcPts val="0"/>
                </a:spcBef>
                <a:spcAft>
                  <a:spcPts val="0"/>
                </a:spcAft>
                <a:buNone/>
              </a:pPr>
              <a:r>
                <a:rPr b="1" lang="en" sz="3000">
                  <a:solidFill>
                    <a:schemeClr val="accent1"/>
                  </a:solidFill>
                  <a:latin typeface="Hind"/>
                  <a:ea typeface="Hind"/>
                  <a:cs typeface="Hind"/>
                  <a:sym typeface="Hind"/>
                </a:rPr>
                <a:t>53</a:t>
              </a:r>
              <a:r>
                <a:rPr lang="en" sz="3000">
                  <a:solidFill>
                    <a:schemeClr val="accent1"/>
                  </a:solidFill>
                  <a:latin typeface="Hind"/>
                  <a:ea typeface="Hind"/>
                  <a:cs typeface="Hind"/>
                  <a:sym typeface="Hind"/>
                </a:rPr>
                <a:t>%</a:t>
              </a:r>
              <a:endParaRPr sz="3000">
                <a:solidFill>
                  <a:schemeClr val="accent1"/>
                </a:solidFill>
                <a:latin typeface="Hind"/>
                <a:ea typeface="Hind"/>
                <a:cs typeface="Hind"/>
                <a:sym typeface="Hind"/>
              </a:endParaRPr>
            </a:p>
            <a:p>
              <a:pPr indent="0" lvl="0" marL="0" rtl="0" algn="ctr">
                <a:spcBef>
                  <a:spcPts val="300"/>
                </a:spcBef>
                <a:spcAft>
                  <a:spcPts val="0"/>
                </a:spcAft>
                <a:buNone/>
              </a:pPr>
              <a:r>
                <a:rPr b="1" lang="en" sz="3000">
                  <a:solidFill>
                    <a:schemeClr val="accent1"/>
                  </a:solidFill>
                  <a:latin typeface="Hind"/>
                  <a:ea typeface="Hind"/>
                  <a:cs typeface="Hind"/>
                  <a:sym typeface="Hind"/>
                </a:rPr>
                <a:t>37</a:t>
              </a:r>
              <a:r>
                <a:rPr lang="en" sz="3000">
                  <a:solidFill>
                    <a:schemeClr val="accent1"/>
                  </a:solidFill>
                  <a:latin typeface="Hind"/>
                  <a:ea typeface="Hind"/>
                  <a:cs typeface="Hind"/>
                  <a:sym typeface="Hind"/>
                </a:rPr>
                <a:t>%</a:t>
              </a:r>
              <a:endParaRPr sz="3000">
                <a:solidFill>
                  <a:schemeClr val="accent1"/>
                </a:solidFill>
                <a:latin typeface="Hind"/>
                <a:ea typeface="Hind"/>
                <a:cs typeface="Hind"/>
                <a:sym typeface="Hind"/>
              </a:endParaRPr>
            </a:p>
            <a:p>
              <a:pPr indent="0" lvl="0" marL="0" rtl="0" algn="ctr">
                <a:spcBef>
                  <a:spcPts val="100"/>
                </a:spcBef>
                <a:spcAft>
                  <a:spcPts val="100"/>
                </a:spcAft>
                <a:buNone/>
              </a:pPr>
              <a:r>
                <a:rPr b="1" lang="en" sz="3000">
                  <a:solidFill>
                    <a:schemeClr val="accent1"/>
                  </a:solidFill>
                  <a:latin typeface="Hind"/>
                  <a:ea typeface="Hind"/>
                  <a:cs typeface="Hind"/>
                  <a:sym typeface="Hind"/>
                </a:rPr>
                <a:t>35</a:t>
              </a:r>
              <a:r>
                <a:rPr lang="en" sz="3000">
                  <a:solidFill>
                    <a:schemeClr val="accent1"/>
                  </a:solidFill>
                  <a:latin typeface="Hind"/>
                  <a:ea typeface="Hind"/>
                  <a:cs typeface="Hind"/>
                  <a:sym typeface="Hind"/>
                </a:rPr>
                <a:t>%</a:t>
              </a:r>
              <a:endParaRPr sz="3000">
                <a:solidFill>
                  <a:schemeClr val="accent1"/>
                </a:solidFill>
                <a:latin typeface="Hind"/>
                <a:ea typeface="Hind"/>
                <a:cs typeface="Hind"/>
                <a:sym typeface="Hind"/>
              </a:endParaRPr>
            </a:p>
          </p:txBody>
        </p:sp>
        <p:sp>
          <p:nvSpPr>
            <p:cNvPr id="526" name="Google Shape;526;p36"/>
            <p:cNvSpPr txBox="1"/>
            <p:nvPr/>
          </p:nvSpPr>
          <p:spPr>
            <a:xfrm>
              <a:off x="3694725" y="3449200"/>
              <a:ext cx="2765100" cy="631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b="1" lang="en" sz="1600">
                  <a:solidFill>
                    <a:schemeClr val="dk1"/>
                  </a:solidFill>
                  <a:latin typeface="Hind"/>
                  <a:ea typeface="Hind"/>
                  <a:cs typeface="Hind"/>
                  <a:sym typeface="Hind"/>
                </a:rPr>
                <a:t>of Other South East Asians </a:t>
              </a:r>
              <a:r>
                <a:rPr b="1" lang="en" sz="1300">
                  <a:solidFill>
                    <a:schemeClr val="dk1"/>
                  </a:solidFill>
                  <a:latin typeface="Hind"/>
                  <a:ea typeface="Hind"/>
                  <a:cs typeface="Hind"/>
                  <a:sym typeface="Hind"/>
                </a:rPr>
                <a:t>(excluding Philippines &amp; Vietnam)</a:t>
              </a:r>
              <a:endParaRPr b="1" sz="1600">
                <a:solidFill>
                  <a:schemeClr val="dk1"/>
                </a:solidFill>
                <a:latin typeface="Hind"/>
                <a:ea typeface="Hind"/>
                <a:cs typeface="Hind"/>
                <a:sym typeface="Hind"/>
              </a:endParaRPr>
            </a:p>
          </p:txBody>
        </p:sp>
        <p:sp>
          <p:nvSpPr>
            <p:cNvPr id="527" name="Google Shape;527;p36"/>
            <p:cNvSpPr txBox="1"/>
            <p:nvPr/>
          </p:nvSpPr>
          <p:spPr>
            <a:xfrm>
              <a:off x="3694725" y="4010950"/>
              <a:ext cx="3000000" cy="4311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b="1" lang="en" sz="1600">
                  <a:solidFill>
                    <a:schemeClr val="dk1"/>
                  </a:solidFill>
                  <a:latin typeface="Hind"/>
                  <a:ea typeface="Hind"/>
                  <a:cs typeface="Hind"/>
                  <a:sym typeface="Hind"/>
                </a:rPr>
                <a:t>of Vietnamese</a:t>
              </a:r>
              <a:endParaRPr>
                <a:latin typeface="Hind"/>
                <a:ea typeface="Hind"/>
                <a:cs typeface="Hind"/>
                <a:sym typeface="Hind"/>
              </a:endParaRPr>
            </a:p>
          </p:txBody>
        </p:sp>
        <p:sp>
          <p:nvSpPr>
            <p:cNvPr id="528" name="Google Shape;528;p36"/>
            <p:cNvSpPr txBox="1"/>
            <p:nvPr/>
          </p:nvSpPr>
          <p:spPr>
            <a:xfrm>
              <a:off x="3694725" y="4490375"/>
              <a:ext cx="3000000" cy="4311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b="1" lang="en" sz="1600">
                  <a:solidFill>
                    <a:schemeClr val="dk1"/>
                  </a:solidFill>
                  <a:latin typeface="Hind"/>
                  <a:ea typeface="Hind"/>
                  <a:cs typeface="Hind"/>
                  <a:sym typeface="Hind"/>
                </a:rPr>
                <a:t>of Koreans</a:t>
              </a:r>
              <a:endParaRPr>
                <a:latin typeface="Hind"/>
                <a:ea typeface="Hind"/>
                <a:cs typeface="Hind"/>
                <a:sym typeface="Hind"/>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8" name="Shape 228"/>
        <p:cNvGrpSpPr/>
        <p:nvPr/>
      </p:nvGrpSpPr>
      <p:grpSpPr>
        <a:xfrm>
          <a:off x="0" y="0"/>
          <a:ext cx="0" cy="0"/>
          <a:chOff x="0" y="0"/>
          <a:chExt cx="0" cy="0"/>
        </a:xfrm>
      </p:grpSpPr>
      <p:sp>
        <p:nvSpPr>
          <p:cNvPr id="229" name="Google Shape;229;p19"/>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Learning Objectives</a:t>
            </a:r>
            <a:endParaRPr/>
          </a:p>
        </p:txBody>
      </p:sp>
      <p:sp>
        <p:nvSpPr>
          <p:cNvPr id="230" name="Google Shape;230;p19"/>
          <p:cNvSpPr txBox="1"/>
          <p:nvPr>
            <p:ph idx="1" type="body"/>
          </p:nvPr>
        </p:nvSpPr>
        <p:spPr>
          <a:xfrm>
            <a:off x="720000" y="1247575"/>
            <a:ext cx="7903200" cy="3416400"/>
          </a:xfrm>
          <a:prstGeom prst="rect">
            <a:avLst/>
          </a:prstGeom>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sz="2100">
                <a:solidFill>
                  <a:schemeClr val="dk1"/>
                </a:solidFill>
              </a:rPr>
              <a:t>1. </a:t>
            </a:r>
            <a:r>
              <a:rPr b="1" lang="en" sz="2100">
                <a:solidFill>
                  <a:schemeClr val="dk1"/>
                </a:solidFill>
              </a:rPr>
              <a:t>Describe</a:t>
            </a:r>
            <a:r>
              <a:rPr lang="en" sz="2100">
                <a:solidFill>
                  <a:schemeClr val="dk1"/>
                </a:solidFill>
              </a:rPr>
              <a:t> the cultural influences and social determinants that impact mental health perceptions within AANHPI communities.</a:t>
            </a:r>
            <a:endParaRPr sz="2100">
              <a:solidFill>
                <a:schemeClr val="dk1"/>
              </a:solidFill>
            </a:endParaRPr>
          </a:p>
          <a:p>
            <a:pPr indent="0" lvl="0" marL="0" rtl="0" algn="l">
              <a:lnSpc>
                <a:spcPct val="115000"/>
              </a:lnSpc>
              <a:spcBef>
                <a:spcPts val="1000"/>
              </a:spcBef>
              <a:spcAft>
                <a:spcPts val="0"/>
              </a:spcAft>
              <a:buClr>
                <a:schemeClr val="dk1"/>
              </a:buClr>
              <a:buSzPts val="1100"/>
              <a:buFont typeface="Arial"/>
              <a:buNone/>
            </a:pPr>
            <a:r>
              <a:rPr lang="en" sz="2100">
                <a:solidFill>
                  <a:schemeClr val="dk1"/>
                </a:solidFill>
              </a:rPr>
              <a:t>2. </a:t>
            </a:r>
            <a:r>
              <a:rPr b="1" lang="en" sz="2100">
                <a:solidFill>
                  <a:schemeClr val="dk1"/>
                </a:solidFill>
              </a:rPr>
              <a:t>Assess</a:t>
            </a:r>
            <a:r>
              <a:rPr lang="en" sz="2100">
                <a:solidFill>
                  <a:schemeClr val="dk1"/>
                </a:solidFill>
              </a:rPr>
              <a:t> the mental health needs specific to AANHPI subgroups through analysis of demographic data and health service utilization.</a:t>
            </a:r>
            <a:endParaRPr sz="2100">
              <a:solidFill>
                <a:schemeClr val="dk1"/>
              </a:solidFill>
            </a:endParaRPr>
          </a:p>
          <a:p>
            <a:pPr indent="0" lvl="0" marL="0" rtl="0" algn="l">
              <a:lnSpc>
                <a:spcPct val="115000"/>
              </a:lnSpc>
              <a:spcBef>
                <a:spcPts val="1000"/>
              </a:spcBef>
              <a:spcAft>
                <a:spcPts val="0"/>
              </a:spcAft>
              <a:buClr>
                <a:schemeClr val="dk1"/>
              </a:buClr>
              <a:buSzPts val="1100"/>
              <a:buFont typeface="Arial"/>
              <a:buNone/>
            </a:pPr>
            <a:r>
              <a:rPr lang="en" sz="2100">
                <a:solidFill>
                  <a:schemeClr val="dk1"/>
                </a:solidFill>
              </a:rPr>
              <a:t>3. </a:t>
            </a:r>
            <a:r>
              <a:rPr b="1" lang="en" sz="2100">
                <a:solidFill>
                  <a:schemeClr val="dk1"/>
                </a:solidFill>
              </a:rPr>
              <a:t>Explain</a:t>
            </a:r>
            <a:r>
              <a:rPr lang="en" sz="2100">
                <a:solidFill>
                  <a:schemeClr val="dk1"/>
                </a:solidFill>
              </a:rPr>
              <a:t> culturally responsive strategies for engaging AANHPI patients in mental health care.</a:t>
            </a:r>
            <a:endParaRPr sz="2100">
              <a:solidFill>
                <a:schemeClr val="dk1"/>
              </a:solidFill>
            </a:endParaRPr>
          </a:p>
          <a:p>
            <a:pPr indent="0" lvl="0" marL="0" rtl="0" algn="l">
              <a:lnSpc>
                <a:spcPct val="115000"/>
              </a:lnSpc>
              <a:spcBef>
                <a:spcPts val="1000"/>
              </a:spcBef>
              <a:spcAft>
                <a:spcPts val="1000"/>
              </a:spcAft>
              <a:buClr>
                <a:schemeClr val="dk1"/>
              </a:buClr>
              <a:buSzPts val="1100"/>
              <a:buFont typeface="Arial"/>
              <a:buNone/>
            </a:pPr>
            <a:r>
              <a:t/>
            </a:r>
            <a:endParaRPr b="1" sz="2100">
              <a:solidFill>
                <a:schemeClr val="dk1"/>
              </a:solidFill>
            </a:endParaRPr>
          </a:p>
        </p:txBody>
      </p:sp>
      <p:sp>
        <p:nvSpPr>
          <p:cNvPr id="231" name="Google Shape;231;p1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32" name="Shape 532"/>
        <p:cNvGrpSpPr/>
        <p:nvPr/>
      </p:nvGrpSpPr>
      <p:grpSpPr>
        <a:xfrm>
          <a:off x="0" y="0"/>
          <a:ext cx="0" cy="0"/>
          <a:chOff x="0" y="0"/>
          <a:chExt cx="0" cy="0"/>
        </a:xfrm>
      </p:grpSpPr>
      <p:sp>
        <p:nvSpPr>
          <p:cNvPr id="533" name="Google Shape;533;p37"/>
          <p:cNvSpPr txBox="1"/>
          <p:nvPr/>
        </p:nvSpPr>
        <p:spPr>
          <a:xfrm>
            <a:off x="6959600" y="4281600"/>
            <a:ext cx="2184300" cy="800400"/>
          </a:xfrm>
          <a:prstGeom prst="rect">
            <a:avLst/>
          </a:prstGeom>
          <a:solidFill>
            <a:srgbClr val="EAB570">
              <a:alpha val="75320"/>
            </a:srgbClr>
          </a:solid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000">
                <a:solidFill>
                  <a:schemeClr val="dk1"/>
                </a:solidFill>
                <a:latin typeface="Hind"/>
                <a:ea typeface="Hind"/>
                <a:cs typeface="Hind"/>
                <a:sym typeface="Hind"/>
              </a:rPr>
              <a:t>CAP: Center for American Progress</a:t>
            </a:r>
            <a:endParaRPr sz="1000">
              <a:solidFill>
                <a:schemeClr val="dk1"/>
              </a:solidFill>
              <a:latin typeface="Hind"/>
              <a:ea typeface="Hind"/>
              <a:cs typeface="Hind"/>
              <a:sym typeface="Hind"/>
            </a:endParaRPr>
          </a:p>
          <a:p>
            <a:pPr indent="0" lvl="0" marL="0" rtl="0" algn="l">
              <a:spcBef>
                <a:spcPts val="0"/>
              </a:spcBef>
              <a:spcAft>
                <a:spcPts val="0"/>
              </a:spcAft>
              <a:buNone/>
            </a:pPr>
            <a:r>
              <a:rPr lang="en" sz="1000">
                <a:solidFill>
                  <a:schemeClr val="dk1"/>
                </a:solidFill>
                <a:latin typeface="Hind"/>
                <a:ea typeface="Hind"/>
                <a:cs typeface="Hind"/>
                <a:sym typeface="Hind"/>
              </a:rPr>
              <a:t>NPR: National Public Radio</a:t>
            </a:r>
            <a:endParaRPr sz="1000">
              <a:solidFill>
                <a:schemeClr val="dk1"/>
              </a:solidFill>
              <a:latin typeface="Hind"/>
              <a:ea typeface="Hind"/>
              <a:cs typeface="Hind"/>
              <a:sym typeface="Hind"/>
            </a:endParaRPr>
          </a:p>
          <a:p>
            <a:pPr indent="0" lvl="0" marL="0" rtl="0" algn="l">
              <a:spcBef>
                <a:spcPts val="0"/>
              </a:spcBef>
              <a:spcAft>
                <a:spcPts val="0"/>
              </a:spcAft>
              <a:buNone/>
            </a:pPr>
            <a:r>
              <a:rPr lang="en" sz="1000">
                <a:solidFill>
                  <a:schemeClr val="dk1"/>
                </a:solidFill>
                <a:latin typeface="Hind"/>
                <a:ea typeface="Hind"/>
                <a:cs typeface="Hind"/>
                <a:sym typeface="Hind"/>
              </a:rPr>
              <a:t>ASPE: Assistant Secretary for </a:t>
            </a:r>
            <a:br>
              <a:rPr lang="en" sz="1000">
                <a:solidFill>
                  <a:schemeClr val="dk1"/>
                </a:solidFill>
                <a:latin typeface="Hind"/>
                <a:ea typeface="Hind"/>
                <a:cs typeface="Hind"/>
                <a:sym typeface="Hind"/>
              </a:rPr>
            </a:br>
            <a:r>
              <a:rPr lang="en" sz="1000">
                <a:solidFill>
                  <a:schemeClr val="dk1"/>
                </a:solidFill>
                <a:latin typeface="Hind"/>
                <a:ea typeface="Hind"/>
                <a:cs typeface="Hind"/>
                <a:sym typeface="Hind"/>
              </a:rPr>
              <a:t>           Planning and Evaluation</a:t>
            </a:r>
            <a:endParaRPr sz="1000">
              <a:solidFill>
                <a:schemeClr val="dk1"/>
              </a:solidFill>
              <a:latin typeface="Hind"/>
              <a:ea typeface="Hind"/>
              <a:cs typeface="Hind"/>
              <a:sym typeface="Hind"/>
            </a:endParaRPr>
          </a:p>
        </p:txBody>
      </p:sp>
      <p:sp>
        <p:nvSpPr>
          <p:cNvPr id="534" name="Google Shape;534;p37"/>
          <p:cNvSpPr/>
          <p:nvPr/>
        </p:nvSpPr>
        <p:spPr>
          <a:xfrm>
            <a:off x="6034100" y="4667250"/>
            <a:ext cx="152400" cy="123900"/>
          </a:xfrm>
          <a:prstGeom prst="ellipse">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535" name="Google Shape;535;p37"/>
          <p:cNvSpPr txBox="1"/>
          <p:nvPr>
            <p:ph type="title"/>
          </p:nvPr>
        </p:nvSpPr>
        <p:spPr>
          <a:xfrm>
            <a:off x="379650" y="191225"/>
            <a:ext cx="83847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200"/>
              <a:t>Lack</a:t>
            </a:r>
            <a:r>
              <a:rPr lang="en" sz="3200"/>
              <a:t> </a:t>
            </a:r>
            <a:r>
              <a:rPr lang="en" sz="3200"/>
              <a:t>of</a:t>
            </a:r>
            <a:r>
              <a:rPr lang="en" sz="3200"/>
              <a:t> Access to Mental Health Care</a:t>
            </a:r>
            <a:endParaRPr sz="3200"/>
          </a:p>
        </p:txBody>
      </p:sp>
      <p:sp>
        <p:nvSpPr>
          <p:cNvPr id="536" name="Google Shape;536;p37"/>
          <p:cNvSpPr txBox="1"/>
          <p:nvPr/>
        </p:nvSpPr>
        <p:spPr>
          <a:xfrm>
            <a:off x="0" y="4743300"/>
            <a:ext cx="3852600" cy="3387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000">
                <a:solidFill>
                  <a:schemeClr val="dk1"/>
                </a:solidFill>
                <a:latin typeface="Hind"/>
                <a:ea typeface="Hind"/>
                <a:cs typeface="Hind"/>
                <a:sym typeface="Hind"/>
              </a:rPr>
              <a:t>(NAMI, 2021; NPR, 2017; ASPE, 2019) </a:t>
            </a:r>
            <a:endParaRPr sz="1000">
              <a:solidFill>
                <a:schemeClr val="dk1"/>
              </a:solidFill>
              <a:latin typeface="Hind"/>
              <a:ea typeface="Hind"/>
              <a:cs typeface="Hind"/>
              <a:sym typeface="Hind"/>
            </a:endParaRPr>
          </a:p>
        </p:txBody>
      </p:sp>
      <p:sp>
        <p:nvSpPr>
          <p:cNvPr id="537" name="Google Shape;537;p3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538" name="Google Shape;538;p37"/>
          <p:cNvSpPr/>
          <p:nvPr/>
        </p:nvSpPr>
        <p:spPr>
          <a:xfrm>
            <a:off x="1712825" y="967450"/>
            <a:ext cx="5798700" cy="800400"/>
          </a:xfrm>
          <a:prstGeom prst="roundRect">
            <a:avLst>
              <a:gd fmla="val 16667" name="adj"/>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rPr b="1" lang="en">
                <a:latin typeface="Yusei Magic"/>
                <a:ea typeface="Yusei Magic"/>
                <a:cs typeface="Yusei Magic"/>
                <a:sym typeface="Yusei Magic"/>
              </a:rPr>
              <a:t>  Financial Cost</a:t>
            </a:r>
            <a:endParaRPr b="1">
              <a:latin typeface="Yusei Magic"/>
              <a:ea typeface="Yusei Magic"/>
              <a:cs typeface="Yusei Magic"/>
              <a:sym typeface="Yusei Magic"/>
            </a:endParaRPr>
          </a:p>
          <a:p>
            <a:pPr indent="0" lvl="0" marL="0" rtl="0" algn="l">
              <a:spcBef>
                <a:spcPts val="0"/>
              </a:spcBef>
              <a:spcAft>
                <a:spcPts val="0"/>
              </a:spcAft>
              <a:buNone/>
            </a:pPr>
            <a:r>
              <a:rPr i="1" lang="en" sz="1100">
                <a:latin typeface="Hind"/>
                <a:ea typeface="Hind"/>
                <a:cs typeface="Hind"/>
                <a:sym typeface="Hind"/>
              </a:rPr>
              <a:t>    cited by 33% of AAs diagnosed with depression (CAP analysis of </a:t>
            </a:r>
            <a:r>
              <a:rPr i="1" lang="en" sz="1100">
                <a:latin typeface="Hind"/>
                <a:ea typeface="Hind"/>
                <a:cs typeface="Hind"/>
                <a:sym typeface="Hind"/>
              </a:rPr>
              <a:t>2017 </a:t>
            </a:r>
            <a:r>
              <a:rPr i="1" lang="en" sz="1100">
                <a:latin typeface="Hind"/>
                <a:ea typeface="Hind"/>
                <a:cs typeface="Hind"/>
                <a:sym typeface="Hind"/>
              </a:rPr>
              <a:t>CDC data) and </a:t>
            </a:r>
            <a:br>
              <a:rPr i="1" lang="en" sz="1100">
                <a:latin typeface="Hind"/>
                <a:ea typeface="Hind"/>
                <a:cs typeface="Hind"/>
                <a:sym typeface="Hind"/>
              </a:rPr>
            </a:br>
            <a:r>
              <a:rPr i="1" lang="en" sz="1100">
                <a:latin typeface="Hind"/>
                <a:ea typeface="Hind"/>
                <a:cs typeface="Hind"/>
                <a:sym typeface="Hind"/>
              </a:rPr>
              <a:t>    40% of AAs for accessing medical care in general (NPR 2017</a:t>
            </a:r>
            <a:r>
              <a:rPr i="1" lang="en" sz="1100">
                <a:latin typeface="Hind"/>
                <a:ea typeface="Hind"/>
                <a:cs typeface="Hind"/>
                <a:sym typeface="Hind"/>
              </a:rPr>
              <a:t> study</a:t>
            </a:r>
            <a:r>
              <a:rPr i="1" lang="en" sz="1100">
                <a:latin typeface="Hind"/>
                <a:ea typeface="Hind"/>
                <a:cs typeface="Hind"/>
                <a:sym typeface="Hind"/>
              </a:rPr>
              <a:t>)</a:t>
            </a:r>
            <a:endParaRPr>
              <a:latin typeface="Hind"/>
              <a:ea typeface="Hind"/>
              <a:cs typeface="Hind"/>
              <a:sym typeface="Hind"/>
            </a:endParaRPr>
          </a:p>
        </p:txBody>
      </p:sp>
      <p:sp>
        <p:nvSpPr>
          <p:cNvPr id="539" name="Google Shape;539;p37"/>
          <p:cNvSpPr/>
          <p:nvPr/>
        </p:nvSpPr>
        <p:spPr>
          <a:xfrm>
            <a:off x="1712825" y="1931139"/>
            <a:ext cx="5798700" cy="790800"/>
          </a:xfrm>
          <a:prstGeom prst="roundRect">
            <a:avLst>
              <a:gd fmla="val 16667" name="adj"/>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rPr b="1" lang="en">
                <a:latin typeface="Yusei Magic"/>
                <a:ea typeface="Yusei Magic"/>
                <a:cs typeface="Yusei Magic"/>
                <a:sym typeface="Yusei Magic"/>
              </a:rPr>
              <a:t>  Lack of Insurance</a:t>
            </a:r>
            <a:endParaRPr b="1">
              <a:latin typeface="Yusei Magic"/>
              <a:ea typeface="Yusei Magic"/>
              <a:cs typeface="Yusei Magic"/>
              <a:sym typeface="Yusei Magic"/>
            </a:endParaRPr>
          </a:p>
          <a:p>
            <a:pPr indent="0" lvl="0" marL="0" rtl="0" algn="l">
              <a:spcBef>
                <a:spcPts val="0"/>
              </a:spcBef>
              <a:spcAft>
                <a:spcPts val="0"/>
              </a:spcAft>
              <a:buNone/>
            </a:pPr>
            <a:r>
              <a:rPr i="1" lang="en" sz="1100">
                <a:latin typeface="Hind"/>
                <a:ea typeface="Hind"/>
                <a:cs typeface="Hind"/>
                <a:sym typeface="Hind"/>
              </a:rPr>
              <a:t>    </a:t>
            </a:r>
            <a:r>
              <a:rPr i="1" lang="en" sz="1100">
                <a:latin typeface="Hind"/>
                <a:ea typeface="Hind"/>
                <a:cs typeface="Hind"/>
                <a:sym typeface="Hind"/>
              </a:rPr>
              <a:t>6.8% of all AANHPIs are uninsured but this ranges from 2.3% in Japanese Americans to </a:t>
            </a:r>
            <a:br>
              <a:rPr i="1" lang="en" sz="1100">
                <a:latin typeface="Hind"/>
                <a:ea typeface="Hind"/>
                <a:cs typeface="Hind"/>
                <a:sym typeface="Hind"/>
              </a:rPr>
            </a:br>
            <a:r>
              <a:rPr i="1" lang="en" sz="1100">
                <a:latin typeface="Hind"/>
                <a:ea typeface="Hind"/>
                <a:cs typeface="Hind"/>
                <a:sym typeface="Hind"/>
              </a:rPr>
              <a:t>    12.3% of NHPIs (ASPE Office of Health Policy 2019 analysis)</a:t>
            </a:r>
            <a:endParaRPr b="1">
              <a:latin typeface="Yusei Magic"/>
              <a:ea typeface="Yusei Magic"/>
              <a:cs typeface="Yusei Magic"/>
              <a:sym typeface="Yusei Magic"/>
            </a:endParaRPr>
          </a:p>
        </p:txBody>
      </p:sp>
      <p:sp>
        <p:nvSpPr>
          <p:cNvPr id="540" name="Google Shape;540;p37"/>
          <p:cNvSpPr/>
          <p:nvPr/>
        </p:nvSpPr>
        <p:spPr>
          <a:xfrm>
            <a:off x="1712825" y="2861622"/>
            <a:ext cx="5798700" cy="800400"/>
          </a:xfrm>
          <a:prstGeom prst="roundRect">
            <a:avLst>
              <a:gd fmla="val 16667" name="adj"/>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rPr b="1" lang="en">
                <a:latin typeface="Yusei Magic"/>
                <a:ea typeface="Yusei Magic"/>
                <a:cs typeface="Yusei Magic"/>
                <a:sym typeface="Yusei Magic"/>
              </a:rPr>
              <a:t>  Not Knowing their Options</a:t>
            </a:r>
            <a:endParaRPr b="1">
              <a:latin typeface="Yusei Magic"/>
              <a:ea typeface="Yusei Magic"/>
              <a:cs typeface="Yusei Magic"/>
              <a:sym typeface="Yusei Magic"/>
            </a:endParaRPr>
          </a:p>
          <a:p>
            <a:pPr indent="0" lvl="0" marL="0" rtl="0" algn="l">
              <a:spcBef>
                <a:spcPts val="0"/>
              </a:spcBef>
              <a:spcAft>
                <a:spcPts val="0"/>
              </a:spcAft>
              <a:buNone/>
            </a:pPr>
            <a:r>
              <a:rPr i="1" lang="en" sz="1100">
                <a:latin typeface="Hind"/>
                <a:ea typeface="Hind"/>
                <a:cs typeface="Hind"/>
                <a:sym typeface="Hind"/>
              </a:rPr>
              <a:t>    </a:t>
            </a:r>
            <a:r>
              <a:rPr i="1" lang="en" sz="1100">
                <a:latin typeface="Hind"/>
                <a:ea typeface="Hind"/>
                <a:cs typeface="Hind"/>
                <a:sym typeface="Hind"/>
              </a:rPr>
              <a:t>cited by 13% of all AANHPIs and up to 26% of Other SE Asians (2022 CHIS study)</a:t>
            </a:r>
            <a:endParaRPr b="1">
              <a:latin typeface="Yusei Magic"/>
              <a:ea typeface="Yusei Magic"/>
              <a:cs typeface="Yusei Magic"/>
              <a:sym typeface="Yusei Magic"/>
            </a:endParaRPr>
          </a:p>
        </p:txBody>
      </p:sp>
      <p:sp>
        <p:nvSpPr>
          <p:cNvPr id="541" name="Google Shape;541;p37"/>
          <p:cNvSpPr/>
          <p:nvPr/>
        </p:nvSpPr>
        <p:spPr>
          <a:xfrm>
            <a:off x="2547950" y="3808225"/>
            <a:ext cx="3998400" cy="935100"/>
          </a:xfrm>
          <a:prstGeom prst="roundRect">
            <a:avLst>
              <a:gd fmla="val 16667" name="adj"/>
            </a:avLst>
          </a:prstGeom>
          <a:noFill/>
          <a:ln cap="flat" cmpd="sng" w="2857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lnSpc>
                <a:spcPct val="115000"/>
              </a:lnSpc>
              <a:spcBef>
                <a:spcPts val="0"/>
              </a:spcBef>
              <a:spcAft>
                <a:spcPts val="0"/>
              </a:spcAft>
              <a:buNone/>
            </a:pPr>
            <a:r>
              <a:rPr lang="en">
                <a:solidFill>
                  <a:schemeClr val="dk1"/>
                </a:solidFill>
                <a:latin typeface="Hind"/>
                <a:ea typeface="Hind"/>
                <a:cs typeface="Hind"/>
                <a:sym typeface="Hind"/>
              </a:rPr>
              <a:t>Part</a:t>
            </a:r>
            <a:r>
              <a:rPr lang="en">
                <a:solidFill>
                  <a:schemeClr val="dk1"/>
                </a:solidFill>
                <a:latin typeface="Hind"/>
                <a:ea typeface="Hind"/>
                <a:cs typeface="Hind"/>
                <a:sym typeface="Hind"/>
              </a:rPr>
              <a:t>icularly vulnerable groups include those with </a:t>
            </a:r>
            <a:r>
              <a:rPr b="1" lang="en">
                <a:solidFill>
                  <a:schemeClr val="dk1"/>
                </a:solidFill>
                <a:latin typeface="Hind"/>
                <a:ea typeface="Hind"/>
                <a:cs typeface="Hind"/>
                <a:sym typeface="Hind"/>
              </a:rPr>
              <a:t>Limited English Proficiency, first generation immigrants, and older generations</a:t>
            </a:r>
            <a:endParaRPr>
              <a:latin typeface="Hind"/>
              <a:ea typeface="Hind"/>
              <a:cs typeface="Hind"/>
              <a:sym typeface="Hind"/>
            </a:endParaRPr>
          </a:p>
        </p:txBody>
      </p:sp>
      <p:sp>
        <p:nvSpPr>
          <p:cNvPr id="542" name="Google Shape;542;p37"/>
          <p:cNvSpPr/>
          <p:nvPr/>
        </p:nvSpPr>
        <p:spPr>
          <a:xfrm>
            <a:off x="1111150" y="989600"/>
            <a:ext cx="790800" cy="790800"/>
          </a:xfrm>
          <a:prstGeom prst="ellipse">
            <a:avLst/>
          </a:prstGeom>
          <a:solidFill>
            <a:schemeClr val="lt2"/>
          </a:solidFill>
          <a:ln cap="flat" cmpd="sng" w="28575">
            <a:solidFill>
              <a:srgbClr val="E8B0A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543" name="Google Shape;543;p37"/>
          <p:cNvSpPr/>
          <p:nvPr/>
        </p:nvSpPr>
        <p:spPr>
          <a:xfrm>
            <a:off x="1111150" y="1930900"/>
            <a:ext cx="790800" cy="790800"/>
          </a:xfrm>
          <a:prstGeom prst="ellipse">
            <a:avLst/>
          </a:prstGeom>
          <a:solidFill>
            <a:schemeClr val="lt2"/>
          </a:solidFill>
          <a:ln cap="flat" cmpd="sng" w="28575">
            <a:solidFill>
              <a:srgbClr val="E8B0A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sp>
        <p:nvSpPr>
          <p:cNvPr id="544" name="Google Shape;544;p37"/>
          <p:cNvSpPr/>
          <p:nvPr/>
        </p:nvSpPr>
        <p:spPr>
          <a:xfrm>
            <a:off x="1111150" y="2872438"/>
            <a:ext cx="790800" cy="790800"/>
          </a:xfrm>
          <a:prstGeom prst="ellipse">
            <a:avLst/>
          </a:prstGeom>
          <a:solidFill>
            <a:schemeClr val="lt2"/>
          </a:solidFill>
          <a:ln cap="flat" cmpd="sng" w="28575">
            <a:solidFill>
              <a:srgbClr val="E8B0A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pic>
        <p:nvPicPr>
          <p:cNvPr id="545" name="Google Shape;545;p37"/>
          <p:cNvPicPr preferRelativeResize="0"/>
          <p:nvPr/>
        </p:nvPicPr>
        <p:blipFill>
          <a:blip r:embed="rId3">
            <a:alphaModFix/>
          </a:blip>
          <a:stretch>
            <a:fillRect/>
          </a:stretch>
        </p:blipFill>
        <p:spPr>
          <a:xfrm>
            <a:off x="1284650" y="2104637"/>
            <a:ext cx="443800" cy="443800"/>
          </a:xfrm>
          <a:prstGeom prst="rect">
            <a:avLst/>
          </a:prstGeom>
          <a:noFill/>
          <a:ln>
            <a:noFill/>
          </a:ln>
        </p:spPr>
      </p:pic>
      <p:pic>
        <p:nvPicPr>
          <p:cNvPr id="546" name="Google Shape;546;p37"/>
          <p:cNvPicPr preferRelativeResize="0"/>
          <p:nvPr/>
        </p:nvPicPr>
        <p:blipFill>
          <a:blip r:embed="rId4">
            <a:alphaModFix/>
          </a:blip>
          <a:stretch>
            <a:fillRect/>
          </a:stretch>
        </p:blipFill>
        <p:spPr>
          <a:xfrm>
            <a:off x="1284650" y="1157721"/>
            <a:ext cx="443800" cy="443780"/>
          </a:xfrm>
          <a:prstGeom prst="rect">
            <a:avLst/>
          </a:prstGeom>
          <a:noFill/>
          <a:ln>
            <a:noFill/>
          </a:ln>
        </p:spPr>
      </p:pic>
      <p:pic>
        <p:nvPicPr>
          <p:cNvPr id="547" name="Google Shape;547;p37"/>
          <p:cNvPicPr preferRelativeResize="0"/>
          <p:nvPr/>
        </p:nvPicPr>
        <p:blipFill>
          <a:blip r:embed="rId5">
            <a:alphaModFix/>
          </a:blip>
          <a:stretch>
            <a:fillRect/>
          </a:stretch>
        </p:blipFill>
        <p:spPr>
          <a:xfrm>
            <a:off x="1284650" y="3080300"/>
            <a:ext cx="443800" cy="443800"/>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51" name="Shape 551"/>
        <p:cNvGrpSpPr/>
        <p:nvPr/>
      </p:nvGrpSpPr>
      <p:grpSpPr>
        <a:xfrm>
          <a:off x="0" y="0"/>
          <a:ext cx="0" cy="0"/>
          <a:chOff x="0" y="0"/>
          <a:chExt cx="0" cy="0"/>
        </a:xfrm>
      </p:grpSpPr>
      <p:sp>
        <p:nvSpPr>
          <p:cNvPr id="552" name="Google Shape;552;p38"/>
          <p:cNvSpPr/>
          <p:nvPr/>
        </p:nvSpPr>
        <p:spPr>
          <a:xfrm>
            <a:off x="483150" y="1057125"/>
            <a:ext cx="4236900" cy="3257100"/>
          </a:xfrm>
          <a:prstGeom prst="roundRect">
            <a:avLst>
              <a:gd fmla="val 9074" name="adj"/>
            </a:avLst>
          </a:prstGeom>
          <a:noFill/>
          <a:ln cap="flat" cmpd="sng" w="2857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b="1" sz="400">
              <a:solidFill>
                <a:schemeClr val="dk1"/>
              </a:solidFill>
              <a:latin typeface="Yusei Magic"/>
              <a:ea typeface="Yusei Magic"/>
              <a:cs typeface="Yusei Magic"/>
              <a:sym typeface="Yusei Magic"/>
            </a:endParaRPr>
          </a:p>
          <a:p>
            <a:pPr indent="0" lvl="0" marL="0" rtl="0" algn="l">
              <a:spcBef>
                <a:spcPts val="0"/>
              </a:spcBef>
              <a:spcAft>
                <a:spcPts val="0"/>
              </a:spcAft>
              <a:buNone/>
            </a:pPr>
            <a:r>
              <a:rPr b="1" lang="en" sz="2000">
                <a:solidFill>
                  <a:schemeClr val="dk1"/>
                </a:solidFill>
                <a:latin typeface="Yusei Magic"/>
                <a:ea typeface="Yusei Magic"/>
                <a:cs typeface="Yusei Magic"/>
                <a:sym typeface="Yusei Magic"/>
              </a:rPr>
              <a:t>Social &amp; Self Stigma</a:t>
            </a:r>
            <a:br>
              <a:rPr b="1" lang="en" sz="2000">
                <a:solidFill>
                  <a:schemeClr val="dk1"/>
                </a:solidFill>
                <a:latin typeface="Yusei Magic"/>
                <a:ea typeface="Yusei Magic"/>
                <a:cs typeface="Yusei Magic"/>
                <a:sym typeface="Yusei Magic"/>
              </a:rPr>
            </a:br>
            <a:endParaRPr sz="100">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a:solidFill>
                <a:schemeClr val="dk1"/>
              </a:solidFill>
              <a:latin typeface="Hind"/>
              <a:ea typeface="Hind"/>
              <a:cs typeface="Hind"/>
              <a:sym typeface="Hind"/>
            </a:endParaRPr>
          </a:p>
          <a:p>
            <a:pPr indent="0" lvl="0" marL="0" rtl="0" algn="l">
              <a:spcBef>
                <a:spcPts val="0"/>
              </a:spcBef>
              <a:spcAft>
                <a:spcPts val="0"/>
              </a:spcAft>
              <a:buNone/>
            </a:pPr>
            <a:r>
              <a:t/>
            </a:r>
            <a:endParaRPr sz="1200">
              <a:solidFill>
                <a:schemeClr val="dk1"/>
              </a:solidFill>
              <a:latin typeface="Hind"/>
              <a:ea typeface="Hind"/>
              <a:cs typeface="Hind"/>
              <a:sym typeface="Hind"/>
            </a:endParaRPr>
          </a:p>
          <a:p>
            <a:pPr indent="0" lvl="0" marL="0" rtl="0" algn="l">
              <a:spcBef>
                <a:spcPts val="0"/>
              </a:spcBef>
              <a:spcAft>
                <a:spcPts val="0"/>
              </a:spcAft>
              <a:buNone/>
            </a:pPr>
            <a:r>
              <a:t/>
            </a:r>
            <a:endParaRPr sz="1200">
              <a:solidFill>
                <a:schemeClr val="dk1"/>
              </a:solidFill>
              <a:latin typeface="Hind"/>
              <a:ea typeface="Hind"/>
              <a:cs typeface="Hind"/>
              <a:sym typeface="Hind"/>
            </a:endParaRPr>
          </a:p>
          <a:p>
            <a:pPr indent="0" lvl="0" marL="0" rtl="0" algn="l">
              <a:spcBef>
                <a:spcPts val="0"/>
              </a:spcBef>
              <a:spcAft>
                <a:spcPts val="0"/>
              </a:spcAft>
              <a:buNone/>
            </a:pPr>
            <a:r>
              <a:rPr b="1" i="1" lang="en">
                <a:solidFill>
                  <a:schemeClr val="dk1"/>
                </a:solidFill>
                <a:latin typeface="Hind"/>
                <a:ea typeface="Hind"/>
                <a:cs typeface="Hind"/>
                <a:sym typeface="Hind"/>
              </a:rPr>
              <a:t>*Mental health disorders may be underdiagnosed in AANHPI populations due to underreporting resulting from stigma.</a:t>
            </a:r>
            <a:endParaRPr>
              <a:latin typeface="Hind"/>
              <a:ea typeface="Hind"/>
              <a:cs typeface="Hind"/>
              <a:sym typeface="Hind"/>
            </a:endParaRPr>
          </a:p>
        </p:txBody>
      </p:sp>
      <p:sp>
        <p:nvSpPr>
          <p:cNvPr id="553" name="Google Shape;553;p38"/>
          <p:cNvSpPr txBox="1"/>
          <p:nvPr>
            <p:ph type="title"/>
          </p:nvPr>
        </p:nvSpPr>
        <p:spPr>
          <a:xfrm>
            <a:off x="483150" y="123375"/>
            <a:ext cx="81777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100"/>
              <a:t>Barriers to seeking Mental Health Care</a:t>
            </a:r>
            <a:endParaRPr sz="3100"/>
          </a:p>
        </p:txBody>
      </p:sp>
      <p:sp>
        <p:nvSpPr>
          <p:cNvPr id="554" name="Google Shape;554;p3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555" name="Google Shape;555;p38"/>
          <p:cNvSpPr txBox="1"/>
          <p:nvPr/>
        </p:nvSpPr>
        <p:spPr>
          <a:xfrm>
            <a:off x="0" y="4777300"/>
            <a:ext cx="3852600" cy="3387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000">
                <a:solidFill>
                  <a:schemeClr val="dk1"/>
                </a:solidFill>
                <a:latin typeface="Hind"/>
                <a:ea typeface="Hind"/>
                <a:cs typeface="Hind"/>
                <a:sym typeface="Hind"/>
              </a:rPr>
              <a:t>(Huang et. al, 2020; Huff, 2023; Subica et. al, 2019; Tan et. al, 2024)</a:t>
            </a:r>
            <a:endParaRPr sz="1000">
              <a:solidFill>
                <a:schemeClr val="dk1"/>
              </a:solidFill>
              <a:latin typeface="Hind"/>
              <a:ea typeface="Hind"/>
              <a:cs typeface="Hind"/>
              <a:sym typeface="Hind"/>
            </a:endParaRPr>
          </a:p>
        </p:txBody>
      </p:sp>
      <p:sp>
        <p:nvSpPr>
          <p:cNvPr id="556" name="Google Shape;556;p38"/>
          <p:cNvSpPr/>
          <p:nvPr/>
        </p:nvSpPr>
        <p:spPr>
          <a:xfrm>
            <a:off x="4967750" y="1057125"/>
            <a:ext cx="3725400" cy="1100700"/>
          </a:xfrm>
          <a:prstGeom prst="roundRect">
            <a:avLst>
              <a:gd fmla="val 16667" name="adj"/>
            </a:avLst>
          </a:prstGeom>
          <a:noFill/>
          <a:ln cap="flat" cmpd="sng" w="2857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b="1" lang="en" sz="1800">
                <a:solidFill>
                  <a:schemeClr val="dk1"/>
                </a:solidFill>
                <a:latin typeface="Yusei Magic"/>
                <a:ea typeface="Yusei Magic"/>
                <a:cs typeface="Yusei Magic"/>
                <a:sym typeface="Yusei Magic"/>
              </a:rPr>
              <a:t>Lack of Culturally Specific Awareness Campaigns &amp; </a:t>
            </a:r>
            <a:br>
              <a:rPr b="1" lang="en" sz="1800">
                <a:solidFill>
                  <a:schemeClr val="dk1"/>
                </a:solidFill>
                <a:latin typeface="Yusei Magic"/>
                <a:ea typeface="Yusei Magic"/>
                <a:cs typeface="Yusei Magic"/>
                <a:sym typeface="Yusei Magic"/>
              </a:rPr>
            </a:br>
            <a:r>
              <a:rPr b="1" lang="en" sz="1800">
                <a:solidFill>
                  <a:schemeClr val="dk1"/>
                </a:solidFill>
                <a:latin typeface="Yusei Magic"/>
                <a:ea typeface="Yusei Magic"/>
                <a:cs typeface="Yusei Magic"/>
                <a:sym typeface="Yusei Magic"/>
              </a:rPr>
              <a:t>Mental Health Literacy</a:t>
            </a:r>
            <a:endParaRPr b="1" sz="1200">
              <a:latin typeface="Hind"/>
              <a:ea typeface="Hind"/>
              <a:cs typeface="Hind"/>
              <a:sym typeface="Hind"/>
            </a:endParaRPr>
          </a:p>
        </p:txBody>
      </p:sp>
      <p:sp>
        <p:nvSpPr>
          <p:cNvPr id="557" name="Google Shape;557;p38"/>
          <p:cNvSpPr/>
          <p:nvPr/>
        </p:nvSpPr>
        <p:spPr>
          <a:xfrm>
            <a:off x="4967750" y="2324738"/>
            <a:ext cx="3725400" cy="708300"/>
          </a:xfrm>
          <a:prstGeom prst="roundRect">
            <a:avLst>
              <a:gd fmla="val 16667" name="adj"/>
            </a:avLst>
          </a:prstGeom>
          <a:noFill/>
          <a:ln cap="flat" cmpd="sng" w="2857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b="1" lang="en" sz="1800">
                <a:solidFill>
                  <a:schemeClr val="dk1"/>
                </a:solidFill>
                <a:latin typeface="Yusei Magic"/>
                <a:ea typeface="Yusei Magic"/>
                <a:cs typeface="Yusei Magic"/>
                <a:sym typeface="Yusei Magic"/>
              </a:rPr>
              <a:t>Language Barriers</a:t>
            </a:r>
            <a:endParaRPr b="1" sz="1200">
              <a:latin typeface="Hind"/>
              <a:ea typeface="Hind"/>
              <a:cs typeface="Hind"/>
              <a:sym typeface="Hind"/>
            </a:endParaRPr>
          </a:p>
        </p:txBody>
      </p:sp>
      <p:sp>
        <p:nvSpPr>
          <p:cNvPr id="558" name="Google Shape;558;p38"/>
          <p:cNvSpPr/>
          <p:nvPr/>
        </p:nvSpPr>
        <p:spPr>
          <a:xfrm>
            <a:off x="4967750" y="3199950"/>
            <a:ext cx="3725400" cy="1100700"/>
          </a:xfrm>
          <a:prstGeom prst="roundRect">
            <a:avLst>
              <a:gd fmla="val 16667" name="adj"/>
            </a:avLst>
          </a:prstGeom>
          <a:noFill/>
          <a:ln cap="flat" cmpd="sng" w="2857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b="1" lang="en" sz="1800">
                <a:solidFill>
                  <a:schemeClr val="dk1"/>
                </a:solidFill>
                <a:latin typeface="Yusei Magic"/>
                <a:ea typeface="Yusei Magic"/>
                <a:cs typeface="Yusei Magic"/>
                <a:sym typeface="Yusei Magic"/>
              </a:rPr>
              <a:t>Lack of Cultural Competency trainings &amp; AANHPI mental health providers</a:t>
            </a:r>
            <a:endParaRPr b="1" sz="1200">
              <a:latin typeface="Hind"/>
              <a:ea typeface="Hind"/>
              <a:cs typeface="Hind"/>
              <a:sym typeface="Hind"/>
            </a:endParaRPr>
          </a:p>
        </p:txBody>
      </p:sp>
      <p:sp>
        <p:nvSpPr>
          <p:cNvPr id="559" name="Google Shape;559;p38"/>
          <p:cNvSpPr/>
          <p:nvPr/>
        </p:nvSpPr>
        <p:spPr>
          <a:xfrm>
            <a:off x="827625" y="1629125"/>
            <a:ext cx="3783000" cy="338700"/>
          </a:xfrm>
          <a:prstGeom prst="roundRect">
            <a:avLst>
              <a:gd fmla="val 16667" name="adj"/>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rPr lang="en">
                <a:latin typeface="Hind"/>
                <a:ea typeface="Hind"/>
                <a:cs typeface="Hind"/>
                <a:sym typeface="Hind"/>
              </a:rPr>
              <a:t>Model Minority Stereotype</a:t>
            </a:r>
            <a:endParaRPr>
              <a:latin typeface="Hind"/>
              <a:ea typeface="Hind"/>
              <a:cs typeface="Hind"/>
              <a:sym typeface="Hind"/>
            </a:endParaRPr>
          </a:p>
        </p:txBody>
      </p:sp>
      <p:sp>
        <p:nvSpPr>
          <p:cNvPr id="560" name="Google Shape;560;p38"/>
          <p:cNvSpPr/>
          <p:nvPr/>
        </p:nvSpPr>
        <p:spPr>
          <a:xfrm>
            <a:off x="827625" y="2073600"/>
            <a:ext cx="3783000" cy="338700"/>
          </a:xfrm>
          <a:prstGeom prst="roundRect">
            <a:avLst>
              <a:gd fmla="val 16667" name="adj"/>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rPr lang="en">
                <a:latin typeface="Hind"/>
                <a:ea typeface="Hind"/>
                <a:cs typeface="Hind"/>
                <a:sym typeface="Hind"/>
              </a:rPr>
              <a:t>Taboo Topic in Vietnamese Culture</a:t>
            </a:r>
            <a:endParaRPr>
              <a:latin typeface="Hind"/>
              <a:ea typeface="Hind"/>
              <a:cs typeface="Hind"/>
              <a:sym typeface="Hind"/>
            </a:endParaRPr>
          </a:p>
        </p:txBody>
      </p:sp>
      <p:sp>
        <p:nvSpPr>
          <p:cNvPr id="561" name="Google Shape;561;p38"/>
          <p:cNvSpPr/>
          <p:nvPr/>
        </p:nvSpPr>
        <p:spPr>
          <a:xfrm>
            <a:off x="827625" y="2518075"/>
            <a:ext cx="3783000" cy="338700"/>
          </a:xfrm>
          <a:prstGeom prst="roundRect">
            <a:avLst>
              <a:gd fmla="val 16667" name="adj"/>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rPr lang="en">
                <a:latin typeface="Hind"/>
                <a:ea typeface="Hind"/>
                <a:cs typeface="Hind"/>
                <a:sym typeface="Hind"/>
              </a:rPr>
              <a:t>Survivor Mentality in Filipino Culture</a:t>
            </a:r>
            <a:endParaRPr>
              <a:latin typeface="Hind"/>
              <a:ea typeface="Hind"/>
              <a:cs typeface="Hind"/>
              <a:sym typeface="Hind"/>
            </a:endParaRPr>
          </a:p>
        </p:txBody>
      </p:sp>
      <p:sp>
        <p:nvSpPr>
          <p:cNvPr id="562" name="Google Shape;562;p38"/>
          <p:cNvSpPr/>
          <p:nvPr/>
        </p:nvSpPr>
        <p:spPr>
          <a:xfrm>
            <a:off x="827625" y="2962550"/>
            <a:ext cx="3783000" cy="338700"/>
          </a:xfrm>
          <a:prstGeom prst="roundRect">
            <a:avLst>
              <a:gd fmla="val 16667" name="adj"/>
            </a:avLst>
          </a:prstGeom>
          <a:solidFill>
            <a:schemeClr val="lt1"/>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rPr lang="en">
                <a:latin typeface="Hind"/>
                <a:ea typeface="Hind"/>
                <a:cs typeface="Hind"/>
                <a:sym typeface="Hind"/>
              </a:rPr>
              <a:t>Endorsement of Stigma in Samoan Culture</a:t>
            </a:r>
            <a:endParaRPr>
              <a:latin typeface="Hind"/>
              <a:ea typeface="Hind"/>
              <a:cs typeface="Hind"/>
              <a:sym typeface="Hind"/>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66" name="Shape 566"/>
        <p:cNvGrpSpPr/>
        <p:nvPr/>
      </p:nvGrpSpPr>
      <p:grpSpPr>
        <a:xfrm>
          <a:off x="0" y="0"/>
          <a:ext cx="0" cy="0"/>
          <a:chOff x="0" y="0"/>
          <a:chExt cx="0" cy="0"/>
        </a:xfrm>
      </p:grpSpPr>
      <p:grpSp>
        <p:nvGrpSpPr>
          <p:cNvPr id="567" name="Google Shape;567;p39"/>
          <p:cNvGrpSpPr/>
          <p:nvPr/>
        </p:nvGrpSpPr>
        <p:grpSpPr>
          <a:xfrm>
            <a:off x="1705748" y="1500249"/>
            <a:ext cx="5255400" cy="3249600"/>
            <a:chOff x="1748073" y="1504999"/>
            <a:chExt cx="5255400" cy="3249600"/>
          </a:xfrm>
        </p:grpSpPr>
        <p:pic>
          <p:nvPicPr>
            <p:cNvPr id="568" name="Google Shape;568;p39" title="Points scored"/>
            <p:cNvPicPr preferRelativeResize="0"/>
            <p:nvPr/>
          </p:nvPicPr>
          <p:blipFill>
            <a:blip r:embed="rId3">
              <a:alphaModFix/>
            </a:blip>
            <a:stretch>
              <a:fillRect/>
            </a:stretch>
          </p:blipFill>
          <p:spPr>
            <a:xfrm>
              <a:off x="1748073" y="1504999"/>
              <a:ext cx="5255400" cy="3249600"/>
            </a:xfrm>
            <a:prstGeom prst="rect">
              <a:avLst/>
            </a:prstGeom>
            <a:noFill/>
            <a:ln>
              <a:noFill/>
            </a:ln>
          </p:spPr>
        </p:pic>
        <p:pic>
          <p:nvPicPr>
            <p:cNvPr id="569" name="Google Shape;569;p39"/>
            <p:cNvPicPr preferRelativeResize="0"/>
            <p:nvPr/>
          </p:nvPicPr>
          <p:blipFill>
            <a:blip r:embed="rId4">
              <a:alphaModFix/>
            </a:blip>
            <a:stretch>
              <a:fillRect/>
            </a:stretch>
          </p:blipFill>
          <p:spPr>
            <a:xfrm>
              <a:off x="3117716" y="3202229"/>
              <a:ext cx="456274" cy="456276"/>
            </a:xfrm>
            <a:prstGeom prst="rect">
              <a:avLst/>
            </a:prstGeom>
            <a:noFill/>
            <a:ln>
              <a:noFill/>
            </a:ln>
          </p:spPr>
        </p:pic>
        <p:pic>
          <p:nvPicPr>
            <p:cNvPr id="570" name="Google Shape;570;p39"/>
            <p:cNvPicPr preferRelativeResize="0"/>
            <p:nvPr/>
          </p:nvPicPr>
          <p:blipFill>
            <a:blip r:embed="rId5">
              <a:alphaModFix/>
            </a:blip>
            <a:stretch>
              <a:fillRect/>
            </a:stretch>
          </p:blipFill>
          <p:spPr>
            <a:xfrm>
              <a:off x="3529273" y="2039670"/>
              <a:ext cx="456274" cy="456276"/>
            </a:xfrm>
            <a:prstGeom prst="rect">
              <a:avLst/>
            </a:prstGeom>
            <a:noFill/>
            <a:ln>
              <a:noFill/>
            </a:ln>
          </p:spPr>
        </p:pic>
        <p:pic>
          <p:nvPicPr>
            <p:cNvPr id="571" name="Google Shape;571;p39"/>
            <p:cNvPicPr preferRelativeResize="0"/>
            <p:nvPr/>
          </p:nvPicPr>
          <p:blipFill>
            <a:blip r:embed="rId6">
              <a:alphaModFix/>
            </a:blip>
            <a:stretch>
              <a:fillRect/>
            </a:stretch>
          </p:blipFill>
          <p:spPr>
            <a:xfrm>
              <a:off x="4813110" y="2039670"/>
              <a:ext cx="456274" cy="456276"/>
            </a:xfrm>
            <a:prstGeom prst="rect">
              <a:avLst/>
            </a:prstGeom>
            <a:noFill/>
            <a:ln>
              <a:noFill/>
            </a:ln>
          </p:spPr>
        </p:pic>
        <p:pic>
          <p:nvPicPr>
            <p:cNvPr id="572" name="Google Shape;572;p39"/>
            <p:cNvPicPr preferRelativeResize="0"/>
            <p:nvPr/>
          </p:nvPicPr>
          <p:blipFill>
            <a:blip r:embed="rId7">
              <a:alphaModFix/>
            </a:blip>
            <a:stretch>
              <a:fillRect/>
            </a:stretch>
          </p:blipFill>
          <p:spPr>
            <a:xfrm>
              <a:off x="5165439" y="3163852"/>
              <a:ext cx="456274" cy="456276"/>
            </a:xfrm>
            <a:prstGeom prst="rect">
              <a:avLst/>
            </a:prstGeom>
            <a:noFill/>
            <a:ln>
              <a:noFill/>
            </a:ln>
          </p:spPr>
        </p:pic>
        <p:pic>
          <p:nvPicPr>
            <p:cNvPr id="573" name="Google Shape;573;p39"/>
            <p:cNvPicPr preferRelativeResize="0"/>
            <p:nvPr/>
          </p:nvPicPr>
          <p:blipFill>
            <a:blip r:embed="rId8">
              <a:alphaModFix/>
            </a:blip>
            <a:stretch>
              <a:fillRect/>
            </a:stretch>
          </p:blipFill>
          <p:spPr>
            <a:xfrm>
              <a:off x="4102609" y="3912150"/>
              <a:ext cx="546332" cy="546333"/>
            </a:xfrm>
            <a:prstGeom prst="rect">
              <a:avLst/>
            </a:prstGeom>
            <a:noFill/>
            <a:ln>
              <a:noFill/>
            </a:ln>
          </p:spPr>
        </p:pic>
        <p:sp>
          <p:nvSpPr>
            <p:cNvPr id="574" name="Google Shape;574;p39"/>
            <p:cNvSpPr/>
            <p:nvPr/>
          </p:nvSpPr>
          <p:spPr>
            <a:xfrm>
              <a:off x="3750945" y="2494781"/>
              <a:ext cx="1269900" cy="1269900"/>
            </a:xfrm>
            <a:prstGeom prst="ellipse">
              <a:avLst/>
            </a:prstGeom>
            <a:solidFill>
              <a:schemeClr val="lt2"/>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t/>
              </a:r>
              <a:endParaRPr>
                <a:latin typeface="Hind"/>
                <a:ea typeface="Hind"/>
                <a:cs typeface="Hind"/>
                <a:sym typeface="Hind"/>
              </a:endParaRPr>
            </a:p>
          </p:txBody>
        </p:sp>
      </p:grpSp>
      <p:sp>
        <p:nvSpPr>
          <p:cNvPr id="575" name="Google Shape;575;p39"/>
          <p:cNvSpPr txBox="1"/>
          <p:nvPr>
            <p:ph type="title"/>
          </p:nvPr>
        </p:nvSpPr>
        <p:spPr>
          <a:xfrm>
            <a:off x="483150" y="225275"/>
            <a:ext cx="81777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Social Determinants of Health</a:t>
            </a:r>
            <a:endParaRPr/>
          </a:p>
        </p:txBody>
      </p:sp>
      <p:sp>
        <p:nvSpPr>
          <p:cNvPr id="576" name="Google Shape;576;p3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577" name="Google Shape;577;p39"/>
          <p:cNvSpPr/>
          <p:nvPr/>
        </p:nvSpPr>
        <p:spPr>
          <a:xfrm>
            <a:off x="85825" y="3079750"/>
            <a:ext cx="2729400" cy="1965600"/>
          </a:xfrm>
          <a:prstGeom prst="flowChartAlternateProcess">
            <a:avLst/>
          </a:prstGeom>
          <a:solidFill>
            <a:srgbClr val="C9DAF9"/>
          </a:solidFill>
          <a:ln>
            <a:noFill/>
          </a:ln>
        </p:spPr>
        <p:txBody>
          <a:bodyPr anchorCtr="0" anchor="ctr" bIns="91425" lIns="91425" spcFirstLastPara="1" rIns="91425" wrap="square" tIns="91425">
            <a:noAutofit/>
          </a:bodyPr>
          <a:lstStyle/>
          <a:p>
            <a:pPr indent="0" lvl="0" marL="0" marR="0" rtl="0" algn="ctr">
              <a:lnSpc>
                <a:spcPct val="100000"/>
              </a:lnSpc>
              <a:spcBef>
                <a:spcPts val="0"/>
              </a:spcBef>
              <a:spcAft>
                <a:spcPts val="0"/>
              </a:spcAft>
              <a:buClr>
                <a:srgbClr val="000000"/>
              </a:buClr>
              <a:buSzPts val="2400"/>
              <a:buFont typeface="Arial"/>
              <a:buNone/>
            </a:pPr>
            <a:r>
              <a:rPr b="1" lang="en">
                <a:solidFill>
                  <a:schemeClr val="dk1"/>
                </a:solidFill>
                <a:latin typeface="Yusei Magic"/>
                <a:ea typeface="Yusei Magic"/>
                <a:cs typeface="Yusei Magic"/>
                <a:sym typeface="Yusei Magic"/>
              </a:rPr>
              <a:t>Economic Stability</a:t>
            </a:r>
            <a:endParaRPr b="1">
              <a:solidFill>
                <a:schemeClr val="dk1"/>
              </a:solidFill>
              <a:latin typeface="Yusei Magic"/>
              <a:ea typeface="Yusei Magic"/>
              <a:cs typeface="Yusei Magic"/>
              <a:sym typeface="Yusei Magic"/>
            </a:endParaRPr>
          </a:p>
          <a:p>
            <a:pPr indent="0" lvl="0" marL="0" rtl="0" algn="l">
              <a:spcBef>
                <a:spcPts val="0"/>
              </a:spcBef>
              <a:spcAft>
                <a:spcPts val="0"/>
              </a:spcAft>
              <a:buNone/>
            </a:pPr>
            <a:r>
              <a:rPr lang="en" sz="1100">
                <a:solidFill>
                  <a:schemeClr val="dk1"/>
                </a:solidFill>
                <a:latin typeface="Hind"/>
                <a:ea typeface="Hind"/>
                <a:cs typeface="Hind"/>
                <a:sym typeface="Hind"/>
              </a:rPr>
              <a:t>Economic stability significantly impacts mental health, with financial stress leading to anxiety and depression. </a:t>
            </a:r>
            <a:r>
              <a:rPr lang="en" sz="1100" u="sng">
                <a:solidFill>
                  <a:schemeClr val="dk1"/>
                </a:solidFill>
                <a:latin typeface="Hind"/>
                <a:ea typeface="Hind"/>
                <a:cs typeface="Hind"/>
                <a:sym typeface="Hind"/>
              </a:rPr>
              <a:t>Asian Americans experience a wider range of economic outcomes than any other racial group in the US – for example, Burmese Americans have a median income of $36,000 v. Indian Americans with $119,000.</a:t>
            </a:r>
            <a:r>
              <a:rPr lang="en" sz="1300" u="sng">
                <a:solidFill>
                  <a:schemeClr val="dk1"/>
                </a:solidFill>
                <a:latin typeface="Yusei Magic"/>
                <a:ea typeface="Yusei Magic"/>
                <a:cs typeface="Yusei Magic"/>
                <a:sym typeface="Yusei Magic"/>
              </a:rPr>
              <a:t> </a:t>
            </a:r>
            <a:endParaRPr sz="1300" u="sng">
              <a:solidFill>
                <a:schemeClr val="dk1"/>
              </a:solidFill>
              <a:latin typeface="Yusei Magic"/>
              <a:ea typeface="Yusei Magic"/>
              <a:cs typeface="Yusei Magic"/>
              <a:sym typeface="Yusei Magic"/>
            </a:endParaRPr>
          </a:p>
        </p:txBody>
      </p:sp>
      <p:sp>
        <p:nvSpPr>
          <p:cNvPr id="578" name="Google Shape;578;p39"/>
          <p:cNvSpPr/>
          <p:nvPr/>
        </p:nvSpPr>
        <p:spPr>
          <a:xfrm>
            <a:off x="5502025" y="856575"/>
            <a:ext cx="3462000" cy="1323300"/>
          </a:xfrm>
          <a:prstGeom prst="flowChartAlternateProcess">
            <a:avLst/>
          </a:prstGeom>
          <a:solidFill>
            <a:srgbClr val="EEC591"/>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a:solidFill>
                  <a:srgbClr val="434343"/>
                </a:solidFill>
                <a:latin typeface="Yusei Magic"/>
                <a:ea typeface="Yusei Magic"/>
                <a:cs typeface="Yusei Magic"/>
                <a:sym typeface="Yusei Magic"/>
              </a:rPr>
              <a:t>Education Access and Quality</a:t>
            </a:r>
            <a:endParaRPr b="1">
              <a:solidFill>
                <a:srgbClr val="434343"/>
              </a:solidFill>
              <a:latin typeface="Yusei Magic"/>
              <a:ea typeface="Yusei Magic"/>
              <a:cs typeface="Yusei Magic"/>
              <a:sym typeface="Yusei Magic"/>
            </a:endParaRPr>
          </a:p>
          <a:p>
            <a:pPr indent="0" lvl="0" marL="0" rtl="0" algn="l">
              <a:spcBef>
                <a:spcPts val="0"/>
              </a:spcBef>
              <a:spcAft>
                <a:spcPts val="0"/>
              </a:spcAft>
              <a:buNone/>
            </a:pPr>
            <a:r>
              <a:rPr lang="en" sz="1100">
                <a:solidFill>
                  <a:srgbClr val="434343"/>
                </a:solidFill>
                <a:latin typeface="Avenir"/>
                <a:ea typeface="Avenir"/>
                <a:cs typeface="Avenir"/>
                <a:sym typeface="Avenir"/>
              </a:rPr>
              <a:t>Higher educational attainment often leads to better mental health outcomes​. Language barriers and discrimination can hinder Asian students.</a:t>
            </a:r>
            <a:endParaRPr sz="1100" u="sng">
              <a:solidFill>
                <a:srgbClr val="434343"/>
              </a:solidFill>
              <a:latin typeface="Avenir"/>
              <a:ea typeface="Avenir"/>
              <a:cs typeface="Avenir"/>
              <a:sym typeface="Avenir"/>
            </a:endParaRPr>
          </a:p>
          <a:p>
            <a:pPr indent="0" lvl="0" marL="0" rtl="0" algn="l">
              <a:spcBef>
                <a:spcPts val="0"/>
              </a:spcBef>
              <a:spcAft>
                <a:spcPts val="0"/>
              </a:spcAft>
              <a:buNone/>
            </a:pPr>
            <a:r>
              <a:rPr lang="en" sz="1100" u="sng">
                <a:solidFill>
                  <a:srgbClr val="434343"/>
                </a:solidFill>
                <a:latin typeface="Avenir"/>
                <a:ea typeface="Avenir"/>
                <a:cs typeface="Avenir"/>
                <a:sym typeface="Avenir"/>
              </a:rPr>
              <a:t>75% of Taiwanese Americans have at least a bachelor's degree, compared to only 11% of Bhutanese Americans. </a:t>
            </a:r>
            <a:endParaRPr b="1">
              <a:solidFill>
                <a:srgbClr val="434343"/>
              </a:solidFill>
              <a:latin typeface="Yusei Magic"/>
              <a:ea typeface="Yusei Magic"/>
              <a:cs typeface="Yusei Magic"/>
              <a:sym typeface="Yusei Magic"/>
            </a:endParaRPr>
          </a:p>
        </p:txBody>
      </p:sp>
      <p:sp>
        <p:nvSpPr>
          <p:cNvPr id="579" name="Google Shape;579;p39"/>
          <p:cNvSpPr/>
          <p:nvPr/>
        </p:nvSpPr>
        <p:spPr>
          <a:xfrm>
            <a:off x="5924575" y="2329000"/>
            <a:ext cx="3180900" cy="1165200"/>
          </a:xfrm>
          <a:prstGeom prst="flowChartAlternateProcess">
            <a:avLst/>
          </a:prstGeom>
          <a:solidFill>
            <a:schemeClr val="lt1"/>
          </a:solidFill>
          <a:ln cap="flat" cmpd="sng" w="1905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b="1" lang="en">
                <a:solidFill>
                  <a:srgbClr val="434343"/>
                </a:solidFill>
                <a:latin typeface="Yusei Magic"/>
                <a:ea typeface="Yusei Magic"/>
                <a:cs typeface="Yusei Magic"/>
                <a:sym typeface="Yusei Magic"/>
              </a:rPr>
              <a:t>Health Care Access</a:t>
            </a:r>
            <a:endParaRPr b="1">
              <a:solidFill>
                <a:srgbClr val="434343"/>
              </a:solidFill>
              <a:latin typeface="Yusei Magic"/>
              <a:ea typeface="Yusei Magic"/>
              <a:cs typeface="Yusei Magic"/>
              <a:sym typeface="Yusei Magic"/>
            </a:endParaRPr>
          </a:p>
          <a:p>
            <a:pPr indent="0" lvl="0" marL="0" rtl="0" algn="l">
              <a:spcBef>
                <a:spcPts val="0"/>
              </a:spcBef>
              <a:spcAft>
                <a:spcPts val="0"/>
              </a:spcAft>
              <a:buNone/>
            </a:pPr>
            <a:r>
              <a:rPr lang="en" sz="1100">
                <a:solidFill>
                  <a:srgbClr val="434343"/>
                </a:solidFill>
                <a:latin typeface="Avenir"/>
                <a:ea typeface="Avenir"/>
                <a:cs typeface="Avenir"/>
                <a:sym typeface="Avenir"/>
              </a:rPr>
              <a:t>Many Asians face barriers like lack of insurance and culturally competent care, hindering mental health service access. </a:t>
            </a:r>
            <a:r>
              <a:rPr lang="en" sz="1100" u="sng">
                <a:solidFill>
                  <a:srgbClr val="434343"/>
                </a:solidFill>
                <a:latin typeface="Avenir"/>
                <a:ea typeface="Avenir"/>
                <a:cs typeface="Avenir"/>
                <a:sym typeface="Avenir"/>
              </a:rPr>
              <a:t>Approximately 12.3% of Pacific Islanders were uninsured in 2019​ v. 10.3% in the US</a:t>
            </a:r>
            <a:endParaRPr b="1">
              <a:solidFill>
                <a:srgbClr val="434343"/>
              </a:solidFill>
              <a:latin typeface="Yusei Magic"/>
              <a:ea typeface="Yusei Magic"/>
              <a:cs typeface="Yusei Magic"/>
              <a:sym typeface="Yusei Magic"/>
            </a:endParaRPr>
          </a:p>
        </p:txBody>
      </p:sp>
      <p:sp>
        <p:nvSpPr>
          <p:cNvPr id="580" name="Google Shape;580;p39"/>
          <p:cNvSpPr/>
          <p:nvPr/>
        </p:nvSpPr>
        <p:spPr>
          <a:xfrm>
            <a:off x="289225" y="1091075"/>
            <a:ext cx="2383800" cy="1809000"/>
          </a:xfrm>
          <a:prstGeom prst="flowChartAlternateProcess">
            <a:avLst/>
          </a:prstGeom>
          <a:solidFill>
            <a:srgbClr val="FEF8BE"/>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a:solidFill>
                  <a:srgbClr val="434343"/>
                </a:solidFill>
                <a:latin typeface="Yusei Magic"/>
                <a:ea typeface="Yusei Magic"/>
                <a:cs typeface="Yusei Magic"/>
                <a:sym typeface="Yusei Magic"/>
              </a:rPr>
              <a:t> Neighborhood and Built Environment</a:t>
            </a:r>
            <a:endParaRPr b="1">
              <a:solidFill>
                <a:srgbClr val="434343"/>
              </a:solidFill>
              <a:latin typeface="Yusei Magic"/>
              <a:ea typeface="Yusei Magic"/>
              <a:cs typeface="Yusei Magic"/>
              <a:sym typeface="Yusei Magic"/>
            </a:endParaRPr>
          </a:p>
          <a:p>
            <a:pPr indent="0" lvl="0" marL="0" rtl="0" algn="l">
              <a:spcBef>
                <a:spcPts val="0"/>
              </a:spcBef>
              <a:spcAft>
                <a:spcPts val="0"/>
              </a:spcAft>
              <a:buNone/>
            </a:pPr>
            <a:r>
              <a:rPr lang="en" sz="1100">
                <a:solidFill>
                  <a:srgbClr val="434343"/>
                </a:solidFill>
                <a:latin typeface="Hind"/>
                <a:ea typeface="Hind"/>
                <a:cs typeface="Hind"/>
                <a:sym typeface="Hind"/>
              </a:rPr>
              <a:t>Housing quality and neighborhood safety significantly influence well-being. </a:t>
            </a:r>
            <a:r>
              <a:rPr lang="en" sz="1100" u="sng">
                <a:solidFill>
                  <a:srgbClr val="434343"/>
                </a:solidFill>
                <a:latin typeface="Hind"/>
                <a:ea typeface="Hind"/>
                <a:cs typeface="Hind"/>
                <a:sym typeface="Hind"/>
              </a:rPr>
              <a:t>NHPI individuals identified social cohesion and access to healthy foods as integral to their health.</a:t>
            </a:r>
            <a:endParaRPr b="1">
              <a:solidFill>
                <a:srgbClr val="434343"/>
              </a:solidFill>
              <a:latin typeface="Yusei Magic"/>
              <a:ea typeface="Yusei Magic"/>
              <a:cs typeface="Yusei Magic"/>
              <a:sym typeface="Yusei Magic"/>
            </a:endParaRPr>
          </a:p>
        </p:txBody>
      </p:sp>
      <p:sp>
        <p:nvSpPr>
          <p:cNvPr id="581" name="Google Shape;581;p39"/>
          <p:cNvSpPr/>
          <p:nvPr/>
        </p:nvSpPr>
        <p:spPr>
          <a:xfrm>
            <a:off x="5755975" y="3643450"/>
            <a:ext cx="2948400" cy="1449000"/>
          </a:xfrm>
          <a:prstGeom prst="flowChartAlternateProcess">
            <a:avLst/>
          </a:prstGeom>
          <a:solidFill>
            <a:srgbClr val="C4B08D"/>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a:solidFill>
                  <a:srgbClr val="434343"/>
                </a:solidFill>
                <a:latin typeface="Yusei Magic"/>
                <a:ea typeface="Yusei Magic"/>
                <a:cs typeface="Yusei Magic"/>
                <a:sym typeface="Yusei Magic"/>
              </a:rPr>
              <a:t>Social and Community Context</a:t>
            </a:r>
            <a:endParaRPr b="1">
              <a:solidFill>
                <a:srgbClr val="434343"/>
              </a:solidFill>
              <a:latin typeface="Yusei Magic"/>
              <a:ea typeface="Yusei Magic"/>
              <a:cs typeface="Yusei Magic"/>
              <a:sym typeface="Yusei Magic"/>
            </a:endParaRPr>
          </a:p>
          <a:p>
            <a:pPr indent="0" lvl="0" marL="0" rtl="0" algn="l">
              <a:spcBef>
                <a:spcPts val="0"/>
              </a:spcBef>
              <a:spcAft>
                <a:spcPts val="0"/>
              </a:spcAft>
              <a:buNone/>
            </a:pPr>
            <a:r>
              <a:rPr lang="en" sz="1100">
                <a:solidFill>
                  <a:srgbClr val="434343"/>
                </a:solidFill>
                <a:latin typeface="Avenir"/>
                <a:ea typeface="Avenir"/>
                <a:cs typeface="Avenir"/>
                <a:sym typeface="Avenir"/>
              </a:rPr>
              <a:t>Many Asian Americans live in multigenerational households, which can provide support but also stress​. </a:t>
            </a:r>
            <a:endParaRPr sz="1100" u="sng">
              <a:solidFill>
                <a:srgbClr val="434343"/>
              </a:solidFill>
              <a:latin typeface="Avenir"/>
              <a:ea typeface="Avenir"/>
              <a:cs typeface="Avenir"/>
              <a:sym typeface="Avenir"/>
            </a:endParaRPr>
          </a:p>
          <a:p>
            <a:pPr indent="0" lvl="0" marL="0" rtl="0" algn="l">
              <a:spcBef>
                <a:spcPts val="0"/>
              </a:spcBef>
              <a:spcAft>
                <a:spcPts val="0"/>
              </a:spcAft>
              <a:buNone/>
            </a:pPr>
            <a:r>
              <a:rPr lang="en" sz="1100" u="sng">
                <a:solidFill>
                  <a:srgbClr val="434343"/>
                </a:solidFill>
                <a:latin typeface="Avenir"/>
                <a:ea typeface="Avenir"/>
                <a:cs typeface="Avenir"/>
                <a:sym typeface="Avenir"/>
              </a:rPr>
              <a:t>Approximately 24% of Asian Americans live in multigenerational households, compared to 13% of White Americans.</a:t>
            </a:r>
            <a:endParaRPr b="1">
              <a:solidFill>
                <a:srgbClr val="434343"/>
              </a:solidFill>
              <a:latin typeface="Yusei Magic"/>
              <a:ea typeface="Yusei Magic"/>
              <a:cs typeface="Yusei Magic"/>
              <a:sym typeface="Yusei Magic"/>
            </a:endParaRPr>
          </a:p>
        </p:txBody>
      </p:sp>
      <p:sp>
        <p:nvSpPr>
          <p:cNvPr id="582" name="Google Shape;582;p39"/>
          <p:cNvSpPr txBox="1"/>
          <p:nvPr/>
        </p:nvSpPr>
        <p:spPr>
          <a:xfrm>
            <a:off x="3300088" y="4715800"/>
            <a:ext cx="1971000" cy="4617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i="1" lang="en" sz="900">
                <a:solidFill>
                  <a:schemeClr val="dk1"/>
                </a:solidFill>
                <a:latin typeface="Hind"/>
                <a:ea typeface="Hind"/>
                <a:cs typeface="Hind"/>
                <a:sym typeface="Hind"/>
              </a:rPr>
              <a:t>Sourced from: Pew Research Center; HHS Office of Minority Health</a:t>
            </a:r>
            <a:endParaRPr i="1" sz="900">
              <a:solidFill>
                <a:schemeClr val="dk1"/>
              </a:solidFill>
              <a:latin typeface="Hind"/>
              <a:ea typeface="Hind"/>
              <a:cs typeface="Hind"/>
              <a:sym typeface="Hind"/>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577"/>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580"/>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578"/>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579"/>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581"/>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86" name="Shape 586"/>
        <p:cNvGrpSpPr/>
        <p:nvPr/>
      </p:nvGrpSpPr>
      <p:grpSpPr>
        <a:xfrm>
          <a:off x="0" y="0"/>
          <a:ext cx="0" cy="0"/>
          <a:chOff x="0" y="0"/>
          <a:chExt cx="0" cy="0"/>
        </a:xfrm>
      </p:grpSpPr>
      <p:sp>
        <p:nvSpPr>
          <p:cNvPr id="587" name="Google Shape;587;p40"/>
          <p:cNvSpPr txBox="1"/>
          <p:nvPr>
            <p:ph type="title"/>
          </p:nvPr>
        </p:nvSpPr>
        <p:spPr>
          <a:xfrm>
            <a:off x="514200" y="1981800"/>
            <a:ext cx="8115600" cy="11799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2500"/>
              <a:t>Part 3: Mental Health Disorders in AANHPI Populations</a:t>
            </a:r>
            <a:endParaRPr sz="2500"/>
          </a:p>
        </p:txBody>
      </p:sp>
      <p:sp>
        <p:nvSpPr>
          <p:cNvPr id="588" name="Google Shape;588;p4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92" name="Shape 592"/>
        <p:cNvGrpSpPr/>
        <p:nvPr/>
      </p:nvGrpSpPr>
      <p:grpSpPr>
        <a:xfrm>
          <a:off x="0" y="0"/>
          <a:ext cx="0" cy="0"/>
          <a:chOff x="0" y="0"/>
          <a:chExt cx="0" cy="0"/>
        </a:xfrm>
      </p:grpSpPr>
      <p:sp>
        <p:nvSpPr>
          <p:cNvPr id="593" name="Google Shape;593;p41"/>
          <p:cNvSpPr txBox="1"/>
          <p:nvPr>
            <p:ph type="title"/>
          </p:nvPr>
        </p:nvSpPr>
        <p:spPr>
          <a:xfrm>
            <a:off x="3508850" y="747300"/>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latin typeface="Hind"/>
                <a:ea typeface="Hind"/>
                <a:cs typeface="Hind"/>
                <a:sym typeface="Hind"/>
              </a:rPr>
              <a:t>Depression</a:t>
            </a:r>
            <a:endParaRPr>
              <a:latin typeface="Hind"/>
              <a:ea typeface="Hind"/>
              <a:cs typeface="Hind"/>
              <a:sym typeface="Hind"/>
            </a:endParaRPr>
          </a:p>
        </p:txBody>
      </p:sp>
      <p:sp>
        <p:nvSpPr>
          <p:cNvPr id="594" name="Google Shape;594;p41"/>
          <p:cNvSpPr txBox="1"/>
          <p:nvPr>
            <p:ph idx="1" type="body"/>
          </p:nvPr>
        </p:nvSpPr>
        <p:spPr>
          <a:xfrm>
            <a:off x="1099888" y="1943675"/>
            <a:ext cx="3260700" cy="2000100"/>
          </a:xfrm>
          <a:prstGeom prst="rect">
            <a:avLst/>
          </a:prstGeom>
        </p:spPr>
        <p:txBody>
          <a:bodyPr anchorCtr="0" anchor="t" bIns="91425" lIns="91425" spcFirstLastPara="1" rIns="91425" wrap="square" tIns="91425">
            <a:normAutofit lnSpcReduction="10000"/>
          </a:bodyPr>
          <a:lstStyle/>
          <a:p>
            <a:pPr indent="-330200" lvl="0" marL="457200" rtl="0" algn="l">
              <a:spcBef>
                <a:spcPts val="0"/>
              </a:spcBef>
              <a:spcAft>
                <a:spcPts val="0"/>
              </a:spcAft>
              <a:buSzPts val="1600"/>
              <a:buChar char="●"/>
            </a:pPr>
            <a:r>
              <a:rPr b="1" lang="en" sz="1600">
                <a:latin typeface="Hind"/>
                <a:ea typeface="Hind"/>
                <a:cs typeface="Hind"/>
                <a:sym typeface="Hind"/>
              </a:rPr>
              <a:t>AA:</a:t>
            </a:r>
            <a:r>
              <a:rPr lang="en" sz="1600">
                <a:latin typeface="Hind"/>
                <a:ea typeface="Hind"/>
                <a:cs typeface="Hind"/>
                <a:sym typeface="Hind"/>
              </a:rPr>
              <a:t> </a:t>
            </a:r>
            <a:r>
              <a:rPr lang="en" sz="1600">
                <a:latin typeface="Hind"/>
                <a:ea typeface="Hind"/>
                <a:cs typeface="Hind"/>
                <a:sym typeface="Hind"/>
              </a:rPr>
              <a:t>~</a:t>
            </a:r>
            <a:r>
              <a:rPr lang="en" sz="1600">
                <a:latin typeface="Hind"/>
                <a:ea typeface="Hind"/>
                <a:cs typeface="Hind"/>
                <a:sym typeface="Hind"/>
              </a:rPr>
              <a:t>7-10% </a:t>
            </a:r>
            <a:endParaRPr sz="1600">
              <a:latin typeface="Hind"/>
              <a:ea typeface="Hind"/>
              <a:cs typeface="Hind"/>
              <a:sym typeface="Hind"/>
            </a:endParaRPr>
          </a:p>
          <a:p>
            <a:pPr indent="-330200" lvl="1" marL="914400" rtl="0" algn="l">
              <a:spcBef>
                <a:spcPts val="0"/>
              </a:spcBef>
              <a:spcAft>
                <a:spcPts val="0"/>
              </a:spcAft>
              <a:buSzPts val="1600"/>
              <a:buFont typeface="Hind"/>
              <a:buChar char="○"/>
            </a:pPr>
            <a:r>
              <a:rPr lang="en" sz="1600">
                <a:latin typeface="Hind"/>
                <a:ea typeface="Hind"/>
                <a:cs typeface="Hind"/>
                <a:sym typeface="Hind"/>
              </a:rPr>
              <a:t>Southeast Asian: 19%</a:t>
            </a:r>
            <a:endParaRPr sz="1600">
              <a:latin typeface="Hind"/>
              <a:ea typeface="Hind"/>
              <a:cs typeface="Hind"/>
              <a:sym typeface="Hind"/>
            </a:endParaRPr>
          </a:p>
          <a:p>
            <a:pPr indent="-330200" lvl="1" marL="914400" rtl="0" algn="l">
              <a:spcBef>
                <a:spcPts val="0"/>
              </a:spcBef>
              <a:spcAft>
                <a:spcPts val="0"/>
              </a:spcAft>
              <a:buSzPts val="1600"/>
              <a:buFont typeface="Hind"/>
              <a:buChar char="○"/>
            </a:pPr>
            <a:r>
              <a:rPr lang="en" sz="1600">
                <a:latin typeface="Hind"/>
                <a:ea typeface="Hind"/>
                <a:cs typeface="Hind"/>
                <a:sym typeface="Hind"/>
              </a:rPr>
              <a:t>South Asian: 11%</a:t>
            </a:r>
            <a:endParaRPr sz="1600">
              <a:latin typeface="Hind"/>
              <a:ea typeface="Hind"/>
              <a:cs typeface="Hind"/>
              <a:sym typeface="Hind"/>
            </a:endParaRPr>
          </a:p>
          <a:p>
            <a:pPr indent="-330200" lvl="1" marL="914400" rtl="0" algn="l">
              <a:spcBef>
                <a:spcPts val="0"/>
              </a:spcBef>
              <a:spcAft>
                <a:spcPts val="0"/>
              </a:spcAft>
              <a:buSzPts val="1600"/>
              <a:buFont typeface="Hind"/>
              <a:buChar char="○"/>
            </a:pPr>
            <a:r>
              <a:rPr lang="en" sz="1600">
                <a:latin typeface="Hind"/>
                <a:ea typeface="Hind"/>
                <a:cs typeface="Hind"/>
                <a:sym typeface="Hind"/>
              </a:rPr>
              <a:t>East Asian: 9%</a:t>
            </a:r>
            <a:endParaRPr sz="1600">
              <a:latin typeface="Hind"/>
              <a:ea typeface="Hind"/>
              <a:cs typeface="Hind"/>
              <a:sym typeface="Hind"/>
            </a:endParaRPr>
          </a:p>
          <a:p>
            <a:pPr indent="-330200" lvl="0" marL="457200" rtl="0" algn="l">
              <a:spcBef>
                <a:spcPts val="0"/>
              </a:spcBef>
              <a:spcAft>
                <a:spcPts val="0"/>
              </a:spcAft>
              <a:buSzPts val="1600"/>
              <a:buChar char="●"/>
            </a:pPr>
            <a:r>
              <a:rPr b="1" lang="en" sz="1600">
                <a:latin typeface="Hind"/>
                <a:ea typeface="Hind"/>
                <a:cs typeface="Hind"/>
                <a:sym typeface="Hind"/>
              </a:rPr>
              <a:t>NHPI:</a:t>
            </a:r>
            <a:r>
              <a:rPr lang="en" sz="1600">
                <a:latin typeface="Hind"/>
                <a:ea typeface="Hind"/>
                <a:cs typeface="Hind"/>
                <a:sym typeface="Hind"/>
              </a:rPr>
              <a:t> 36.1%</a:t>
            </a:r>
            <a:endParaRPr sz="1600">
              <a:latin typeface="Hind"/>
              <a:ea typeface="Hind"/>
              <a:cs typeface="Hind"/>
              <a:sym typeface="Hind"/>
            </a:endParaRPr>
          </a:p>
          <a:p>
            <a:pPr indent="-330200" lvl="1" marL="914400" rtl="0" algn="l">
              <a:spcBef>
                <a:spcPts val="0"/>
              </a:spcBef>
              <a:spcAft>
                <a:spcPts val="0"/>
              </a:spcAft>
              <a:buSzPts val="1600"/>
              <a:buChar char="○"/>
            </a:pPr>
            <a:r>
              <a:rPr b="1" lang="en" sz="1600">
                <a:latin typeface="Hind"/>
                <a:ea typeface="Hind"/>
                <a:cs typeface="Hind"/>
                <a:sym typeface="Hind"/>
              </a:rPr>
              <a:t>Hi</a:t>
            </a:r>
            <a:r>
              <a:rPr b="1" lang="en" sz="1600">
                <a:latin typeface="Hind"/>
                <a:ea typeface="Hind"/>
                <a:cs typeface="Hind"/>
                <a:sym typeface="Hind"/>
              </a:rPr>
              <a:t>ghest prevalence</a:t>
            </a:r>
            <a:r>
              <a:rPr lang="en" sz="1600">
                <a:latin typeface="Hind"/>
                <a:ea typeface="Hind"/>
                <a:cs typeface="Hind"/>
                <a:sym typeface="Hind"/>
              </a:rPr>
              <a:t> of all US racial groups</a:t>
            </a:r>
            <a:endParaRPr sz="1600">
              <a:latin typeface="Hind"/>
              <a:ea typeface="Hind"/>
              <a:cs typeface="Hind"/>
              <a:sym typeface="Hind"/>
            </a:endParaRPr>
          </a:p>
        </p:txBody>
      </p:sp>
      <p:sp>
        <p:nvSpPr>
          <p:cNvPr id="595" name="Google Shape;595;p4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596" name="Google Shape;596;p41"/>
          <p:cNvSpPr txBox="1"/>
          <p:nvPr/>
        </p:nvSpPr>
        <p:spPr>
          <a:xfrm>
            <a:off x="1871625" y="1434918"/>
            <a:ext cx="19860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Prevalence</a:t>
            </a:r>
            <a:endParaRPr b="1" sz="2400">
              <a:solidFill>
                <a:srgbClr val="EAB56F"/>
              </a:solidFill>
              <a:latin typeface="Hind"/>
              <a:ea typeface="Hind"/>
              <a:cs typeface="Hind"/>
              <a:sym typeface="Hind"/>
            </a:endParaRPr>
          </a:p>
        </p:txBody>
      </p:sp>
      <p:sp>
        <p:nvSpPr>
          <p:cNvPr id="597" name="Google Shape;597;p41"/>
          <p:cNvSpPr txBox="1"/>
          <p:nvPr/>
        </p:nvSpPr>
        <p:spPr>
          <a:xfrm>
            <a:off x="4813112" y="1434925"/>
            <a:ext cx="29325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Barriers to Care</a:t>
            </a:r>
            <a:endParaRPr b="1" sz="2400">
              <a:solidFill>
                <a:srgbClr val="EAB56F"/>
              </a:solidFill>
              <a:latin typeface="Hind"/>
              <a:ea typeface="Hind"/>
              <a:cs typeface="Hind"/>
              <a:sym typeface="Hind"/>
            </a:endParaRPr>
          </a:p>
        </p:txBody>
      </p:sp>
      <p:sp>
        <p:nvSpPr>
          <p:cNvPr id="598" name="Google Shape;598;p41"/>
          <p:cNvSpPr txBox="1"/>
          <p:nvPr>
            <p:ph idx="1" type="body"/>
          </p:nvPr>
        </p:nvSpPr>
        <p:spPr>
          <a:xfrm>
            <a:off x="4514613" y="1943675"/>
            <a:ext cx="3529500" cy="1956900"/>
          </a:xfrm>
          <a:prstGeom prst="rect">
            <a:avLst/>
          </a:prstGeom>
        </p:spPr>
        <p:txBody>
          <a:bodyPr anchorCtr="0" anchor="t" bIns="91425" lIns="91425" spcFirstLastPara="1" rIns="91425" wrap="square" tIns="91425">
            <a:normAutofit lnSpcReduction="20000"/>
          </a:bodyPr>
          <a:lstStyle/>
          <a:p>
            <a:pPr indent="-330200" lvl="0" marL="457200" rtl="0" algn="l">
              <a:spcBef>
                <a:spcPts val="0"/>
              </a:spcBef>
              <a:spcAft>
                <a:spcPts val="0"/>
              </a:spcAft>
              <a:buSzPts val="1600"/>
              <a:buFont typeface="Hind"/>
              <a:buChar char="●"/>
            </a:pPr>
            <a:r>
              <a:rPr lang="en" sz="1600">
                <a:latin typeface="Hind"/>
                <a:ea typeface="Hind"/>
                <a:cs typeface="Hind"/>
                <a:sym typeface="Hind"/>
              </a:rPr>
              <a:t>Stigma towards self &amp; others</a:t>
            </a:r>
            <a:endParaRPr sz="1600">
              <a:latin typeface="Hind"/>
              <a:ea typeface="Hind"/>
              <a:cs typeface="Hind"/>
              <a:sym typeface="Hind"/>
            </a:endParaRPr>
          </a:p>
          <a:p>
            <a:pPr indent="-330200" lvl="0" marL="457200" rtl="0" algn="l">
              <a:spcBef>
                <a:spcPts val="0"/>
              </a:spcBef>
              <a:spcAft>
                <a:spcPts val="0"/>
              </a:spcAft>
              <a:buSzPts val="1600"/>
              <a:buFont typeface="Hind"/>
              <a:buChar char="●"/>
            </a:pPr>
            <a:r>
              <a:rPr lang="en" sz="1600">
                <a:latin typeface="Hind"/>
                <a:ea typeface="Hind"/>
                <a:cs typeface="Hind"/>
                <a:sym typeface="Hind"/>
              </a:rPr>
              <a:t>Language</a:t>
            </a:r>
            <a:endParaRPr sz="1600">
              <a:latin typeface="Hind"/>
              <a:ea typeface="Hind"/>
              <a:cs typeface="Hind"/>
              <a:sym typeface="Hind"/>
            </a:endParaRPr>
          </a:p>
          <a:p>
            <a:pPr indent="-330200" lvl="0" marL="457200" rtl="0" algn="l">
              <a:spcBef>
                <a:spcPts val="0"/>
              </a:spcBef>
              <a:spcAft>
                <a:spcPts val="0"/>
              </a:spcAft>
              <a:buSzPts val="1600"/>
              <a:buFont typeface="Hind"/>
              <a:buChar char="●"/>
            </a:pPr>
            <a:r>
              <a:rPr lang="en" sz="1600">
                <a:latin typeface="Hind"/>
                <a:ea typeface="Hind"/>
                <a:cs typeface="Hind"/>
                <a:sym typeface="Hind"/>
              </a:rPr>
              <a:t>Insurance &amp; Cost</a:t>
            </a:r>
            <a:endParaRPr sz="1600">
              <a:latin typeface="Hind"/>
              <a:ea typeface="Hind"/>
              <a:cs typeface="Hind"/>
              <a:sym typeface="Hind"/>
            </a:endParaRPr>
          </a:p>
          <a:p>
            <a:pPr indent="-330200" lvl="1" marL="914400" rtl="0" algn="l">
              <a:spcBef>
                <a:spcPts val="0"/>
              </a:spcBef>
              <a:spcAft>
                <a:spcPts val="0"/>
              </a:spcAft>
              <a:buSzPts val="1600"/>
              <a:buChar char="○"/>
            </a:pPr>
            <a:r>
              <a:rPr b="1" lang="en" sz="1600">
                <a:latin typeface="Hind"/>
                <a:ea typeface="Hind"/>
                <a:cs typeface="Hind"/>
                <a:sym typeface="Hind"/>
              </a:rPr>
              <a:t>1 in 3</a:t>
            </a:r>
            <a:r>
              <a:rPr lang="en" sz="1600">
                <a:latin typeface="Hind"/>
                <a:ea typeface="Hind"/>
                <a:cs typeface="Hind"/>
                <a:sym typeface="Hind"/>
              </a:rPr>
              <a:t> Asian Americans diagnosed with depression were unable to see a doctor due to </a:t>
            </a:r>
            <a:r>
              <a:rPr b="1" lang="en" sz="1600">
                <a:latin typeface="Hind"/>
                <a:ea typeface="Hind"/>
                <a:cs typeface="Hind"/>
                <a:sym typeface="Hind"/>
              </a:rPr>
              <a:t>cost</a:t>
            </a:r>
            <a:r>
              <a:rPr lang="en" sz="1600">
                <a:latin typeface="Hind"/>
                <a:ea typeface="Hind"/>
                <a:cs typeface="Hind"/>
                <a:sym typeface="Hind"/>
              </a:rPr>
              <a:t>.</a:t>
            </a:r>
            <a:endParaRPr sz="1600">
              <a:latin typeface="Hind"/>
              <a:ea typeface="Hind"/>
              <a:cs typeface="Hind"/>
              <a:sym typeface="Hind"/>
            </a:endParaRPr>
          </a:p>
        </p:txBody>
      </p:sp>
      <p:sp>
        <p:nvSpPr>
          <p:cNvPr id="599" name="Google Shape;599;p41"/>
          <p:cNvSpPr txBox="1"/>
          <p:nvPr/>
        </p:nvSpPr>
        <p:spPr>
          <a:xfrm>
            <a:off x="0" y="4835700"/>
            <a:ext cx="41493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Misra et al. </a:t>
            </a:r>
            <a:r>
              <a:rPr i="1" lang="en" sz="800">
                <a:solidFill>
                  <a:schemeClr val="dk1"/>
                </a:solidFill>
                <a:latin typeface="Hind"/>
                <a:ea typeface="Hind"/>
                <a:cs typeface="Hind"/>
                <a:sym typeface="Hind"/>
              </a:rPr>
              <a:t>Ethn Dis. </a:t>
            </a:r>
            <a:r>
              <a:rPr lang="en" sz="800">
                <a:solidFill>
                  <a:schemeClr val="dk1"/>
                </a:solidFill>
                <a:latin typeface="Hind"/>
                <a:ea typeface="Hind"/>
                <a:cs typeface="Hind"/>
                <a:sym typeface="Hind"/>
              </a:rPr>
              <a:t>2020; Subica et al. </a:t>
            </a:r>
            <a:r>
              <a:rPr i="1" lang="en" sz="800">
                <a:solidFill>
                  <a:schemeClr val="dk1"/>
                </a:solidFill>
                <a:latin typeface="Hind"/>
                <a:ea typeface="Hind"/>
                <a:cs typeface="Hind"/>
                <a:sym typeface="Hind"/>
              </a:rPr>
              <a:t>Psychiatry Res. </a:t>
            </a:r>
            <a:r>
              <a:rPr lang="en" sz="800">
                <a:solidFill>
                  <a:schemeClr val="dk1"/>
                </a:solidFill>
                <a:latin typeface="Hind"/>
                <a:ea typeface="Hind"/>
                <a:cs typeface="Hind"/>
                <a:sym typeface="Hind"/>
              </a:rPr>
              <a:t>2019; Schlossberg. </a:t>
            </a:r>
            <a:r>
              <a:rPr i="1" lang="en" sz="800">
                <a:solidFill>
                  <a:schemeClr val="dk1"/>
                </a:solidFill>
                <a:latin typeface="Hind"/>
                <a:ea typeface="Hind"/>
                <a:cs typeface="Hind"/>
                <a:sym typeface="Hind"/>
              </a:rPr>
              <a:t>UCLA Health. </a:t>
            </a:r>
            <a:r>
              <a:rPr lang="en" sz="800">
                <a:solidFill>
                  <a:schemeClr val="dk1"/>
                </a:solidFill>
                <a:latin typeface="Hind"/>
                <a:ea typeface="Hind"/>
                <a:cs typeface="Hind"/>
                <a:sym typeface="Hind"/>
              </a:rPr>
              <a:t>2021.</a:t>
            </a:r>
            <a:endParaRPr baseline="30000" sz="800">
              <a:solidFill>
                <a:schemeClr val="dk1"/>
              </a:solidFill>
              <a:latin typeface="Hind"/>
              <a:ea typeface="Hind"/>
              <a:cs typeface="Hind"/>
              <a:sym typeface="Hind"/>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 presetSubtype="0">
                                  <p:stCondLst>
                                    <p:cond delay="0"/>
                                  </p:stCondLst>
                                  <p:childTnLst>
                                    <p:set>
                                      <p:cBhvr>
                                        <p:cTn dur="1" fill="hold">
                                          <p:stCondLst>
                                            <p:cond delay="0"/>
                                          </p:stCondLst>
                                        </p:cTn>
                                        <p:tgtEl>
                                          <p:spTgt spid="597"/>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598"/>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03" name="Shape 603"/>
        <p:cNvGrpSpPr/>
        <p:nvPr/>
      </p:nvGrpSpPr>
      <p:grpSpPr>
        <a:xfrm>
          <a:off x="0" y="0"/>
          <a:ext cx="0" cy="0"/>
          <a:chOff x="0" y="0"/>
          <a:chExt cx="0" cy="0"/>
        </a:xfrm>
      </p:grpSpPr>
      <p:sp>
        <p:nvSpPr>
          <p:cNvPr id="604" name="Google Shape;604;p42"/>
          <p:cNvSpPr txBox="1"/>
          <p:nvPr>
            <p:ph type="title"/>
          </p:nvPr>
        </p:nvSpPr>
        <p:spPr>
          <a:xfrm>
            <a:off x="3743310" y="757025"/>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latin typeface="Hind"/>
                <a:ea typeface="Hind"/>
                <a:cs typeface="Hind"/>
                <a:sym typeface="Hind"/>
              </a:rPr>
              <a:t>Suicide</a:t>
            </a:r>
            <a:endParaRPr>
              <a:latin typeface="Hind"/>
              <a:ea typeface="Hind"/>
              <a:cs typeface="Hind"/>
              <a:sym typeface="Hind"/>
            </a:endParaRPr>
          </a:p>
        </p:txBody>
      </p:sp>
      <p:sp>
        <p:nvSpPr>
          <p:cNvPr id="605" name="Google Shape;605;p4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606" name="Google Shape;606;p42"/>
          <p:cNvSpPr txBox="1"/>
          <p:nvPr/>
        </p:nvSpPr>
        <p:spPr>
          <a:xfrm>
            <a:off x="1132050" y="1869664"/>
            <a:ext cx="3303300" cy="23397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rgbClr val="434343"/>
              </a:buClr>
              <a:buSzPts val="1400"/>
              <a:buFont typeface="Hind"/>
              <a:buChar char="●"/>
            </a:pPr>
            <a:r>
              <a:rPr b="1" lang="en">
                <a:solidFill>
                  <a:srgbClr val="434343"/>
                </a:solidFill>
                <a:latin typeface="Hind"/>
                <a:ea typeface="Hind"/>
                <a:cs typeface="Hind"/>
                <a:sym typeface="Hind"/>
              </a:rPr>
              <a:t>L</a:t>
            </a:r>
            <a:r>
              <a:rPr b="1" lang="en">
                <a:solidFill>
                  <a:srgbClr val="434343"/>
                </a:solidFill>
                <a:latin typeface="Hind"/>
                <a:ea typeface="Hind"/>
                <a:cs typeface="Hind"/>
                <a:sym typeface="Hind"/>
              </a:rPr>
              <a:t>eading cause of death</a:t>
            </a:r>
            <a:r>
              <a:rPr lang="en">
                <a:solidFill>
                  <a:srgbClr val="434343"/>
                </a:solidFill>
                <a:latin typeface="Hind"/>
                <a:ea typeface="Hind"/>
                <a:cs typeface="Hind"/>
                <a:sym typeface="Hind"/>
              </a:rPr>
              <a:t> for AANHPI youth </a:t>
            </a:r>
            <a:r>
              <a:rPr lang="en">
                <a:solidFill>
                  <a:srgbClr val="434343"/>
                </a:solidFill>
                <a:latin typeface="Hind"/>
                <a:ea typeface="Hind"/>
                <a:cs typeface="Hind"/>
                <a:sym typeface="Hind"/>
              </a:rPr>
              <a:t>ages </a:t>
            </a:r>
            <a:r>
              <a:rPr lang="en">
                <a:solidFill>
                  <a:srgbClr val="434343"/>
                </a:solidFill>
                <a:latin typeface="Hind"/>
                <a:ea typeface="Hind"/>
                <a:cs typeface="Hind"/>
                <a:sym typeface="Hind"/>
              </a:rPr>
              <a:t>15–24</a:t>
            </a:r>
            <a:endParaRPr>
              <a:solidFill>
                <a:srgbClr val="434343"/>
              </a:solidFill>
              <a:latin typeface="Hind"/>
              <a:ea typeface="Hind"/>
              <a:cs typeface="Hind"/>
              <a:sym typeface="Hind"/>
            </a:endParaRPr>
          </a:p>
          <a:p>
            <a:pPr indent="-317500" lvl="1" marL="9144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Leading causes of death in all youth 15-24:</a:t>
            </a:r>
            <a:endParaRPr>
              <a:solidFill>
                <a:srgbClr val="434343"/>
              </a:solidFill>
              <a:latin typeface="Hind"/>
              <a:ea typeface="Hind"/>
              <a:cs typeface="Hind"/>
              <a:sym typeface="Hind"/>
            </a:endParaRPr>
          </a:p>
          <a:p>
            <a:pPr indent="0" lvl="0" marL="914400" rtl="0" algn="l">
              <a:spcBef>
                <a:spcPts val="0"/>
              </a:spcBef>
              <a:spcAft>
                <a:spcPts val="0"/>
              </a:spcAft>
              <a:buNone/>
            </a:pPr>
            <a:r>
              <a:rPr lang="en">
                <a:solidFill>
                  <a:srgbClr val="434343"/>
                </a:solidFill>
                <a:latin typeface="Hind"/>
                <a:ea typeface="Hind"/>
                <a:cs typeface="Hind"/>
                <a:sym typeface="Hind"/>
              </a:rPr>
              <a:t>1. Unintentional injury (motor vehicle accidents, drowning)</a:t>
            </a:r>
            <a:endParaRPr>
              <a:solidFill>
                <a:srgbClr val="434343"/>
              </a:solidFill>
              <a:latin typeface="Hind"/>
              <a:ea typeface="Hind"/>
              <a:cs typeface="Hind"/>
              <a:sym typeface="Hind"/>
            </a:endParaRPr>
          </a:p>
          <a:p>
            <a:pPr indent="0" lvl="0" marL="914400" rtl="0" algn="l">
              <a:spcBef>
                <a:spcPts val="0"/>
              </a:spcBef>
              <a:spcAft>
                <a:spcPts val="0"/>
              </a:spcAft>
              <a:buNone/>
            </a:pPr>
            <a:r>
              <a:rPr lang="en">
                <a:solidFill>
                  <a:srgbClr val="434343"/>
                </a:solidFill>
                <a:latin typeface="Hind"/>
                <a:ea typeface="Hind"/>
                <a:cs typeface="Hind"/>
                <a:sym typeface="Hind"/>
              </a:rPr>
              <a:t>2. Homicide</a:t>
            </a:r>
            <a:endParaRPr>
              <a:solidFill>
                <a:srgbClr val="434343"/>
              </a:solidFill>
              <a:latin typeface="Hind"/>
              <a:ea typeface="Hind"/>
              <a:cs typeface="Hind"/>
              <a:sym typeface="Hind"/>
            </a:endParaRPr>
          </a:p>
          <a:p>
            <a:pPr indent="0" lvl="0" marL="914400" rtl="0" algn="l">
              <a:spcBef>
                <a:spcPts val="0"/>
              </a:spcBef>
              <a:spcAft>
                <a:spcPts val="0"/>
              </a:spcAft>
              <a:buNone/>
            </a:pPr>
            <a:r>
              <a:rPr lang="en">
                <a:solidFill>
                  <a:srgbClr val="434343"/>
                </a:solidFill>
                <a:latin typeface="Hind"/>
                <a:ea typeface="Hind"/>
                <a:cs typeface="Hind"/>
                <a:sym typeface="Hind"/>
              </a:rPr>
              <a:t>3. Suicide</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Rates in AANHPI youth doubled from 1999-2021</a:t>
            </a:r>
            <a:endParaRPr>
              <a:solidFill>
                <a:srgbClr val="434343"/>
              </a:solidFill>
              <a:latin typeface="Hind"/>
              <a:ea typeface="Hind"/>
              <a:cs typeface="Hind"/>
              <a:sym typeface="Hind"/>
            </a:endParaRPr>
          </a:p>
        </p:txBody>
      </p:sp>
      <p:sp>
        <p:nvSpPr>
          <p:cNvPr id="607" name="Google Shape;607;p42"/>
          <p:cNvSpPr txBox="1"/>
          <p:nvPr/>
        </p:nvSpPr>
        <p:spPr>
          <a:xfrm>
            <a:off x="1838688" y="1389293"/>
            <a:ext cx="19860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Prevalence</a:t>
            </a:r>
            <a:endParaRPr b="1" sz="2400">
              <a:solidFill>
                <a:srgbClr val="EAB56F"/>
              </a:solidFill>
              <a:latin typeface="Hind"/>
              <a:ea typeface="Hind"/>
              <a:cs typeface="Hind"/>
              <a:sym typeface="Hind"/>
            </a:endParaRPr>
          </a:p>
        </p:txBody>
      </p:sp>
      <p:sp>
        <p:nvSpPr>
          <p:cNvPr id="608" name="Google Shape;608;p42"/>
          <p:cNvSpPr txBox="1"/>
          <p:nvPr/>
        </p:nvSpPr>
        <p:spPr>
          <a:xfrm>
            <a:off x="4780175" y="1389300"/>
            <a:ext cx="29325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Cultural Factors</a:t>
            </a:r>
            <a:endParaRPr b="1" sz="2400">
              <a:solidFill>
                <a:srgbClr val="EAB56F"/>
              </a:solidFill>
              <a:latin typeface="Hind"/>
              <a:ea typeface="Hind"/>
              <a:cs typeface="Hind"/>
              <a:sym typeface="Hind"/>
            </a:endParaRPr>
          </a:p>
        </p:txBody>
      </p:sp>
      <p:sp>
        <p:nvSpPr>
          <p:cNvPr id="609" name="Google Shape;609;p42"/>
          <p:cNvSpPr txBox="1"/>
          <p:nvPr/>
        </p:nvSpPr>
        <p:spPr>
          <a:xfrm>
            <a:off x="4780175" y="1869664"/>
            <a:ext cx="2796300" cy="14775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COVID-19 discrimination: hate crimes &amp; verbal abuse</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Familial pressure to succeed in academics</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Cultural shame</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Mental health stigma</a:t>
            </a:r>
            <a:endParaRPr>
              <a:solidFill>
                <a:srgbClr val="434343"/>
              </a:solidFill>
              <a:latin typeface="Hind"/>
              <a:ea typeface="Hind"/>
              <a:cs typeface="Hind"/>
              <a:sym typeface="Hind"/>
            </a:endParaRPr>
          </a:p>
        </p:txBody>
      </p:sp>
      <p:sp>
        <p:nvSpPr>
          <p:cNvPr id="610" name="Google Shape;610;p42"/>
          <p:cNvSpPr txBox="1"/>
          <p:nvPr/>
        </p:nvSpPr>
        <p:spPr>
          <a:xfrm>
            <a:off x="0" y="4835700"/>
            <a:ext cx="41493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Reyes et al. </a:t>
            </a:r>
            <a:r>
              <a:rPr i="1" lang="en" sz="800">
                <a:solidFill>
                  <a:schemeClr val="dk1"/>
                </a:solidFill>
                <a:latin typeface="Hind"/>
                <a:ea typeface="Hind"/>
                <a:cs typeface="Hind"/>
                <a:sym typeface="Hind"/>
              </a:rPr>
              <a:t>Child Adolesc Ment Health. </a:t>
            </a:r>
            <a:r>
              <a:rPr lang="en" sz="800">
                <a:solidFill>
                  <a:schemeClr val="dk1"/>
                </a:solidFill>
                <a:latin typeface="Hind"/>
                <a:ea typeface="Hind"/>
                <a:cs typeface="Hind"/>
                <a:sym typeface="Hind"/>
              </a:rPr>
              <a:t>2024.</a:t>
            </a:r>
            <a:endParaRPr baseline="30000" sz="800">
              <a:solidFill>
                <a:schemeClr val="dk1"/>
              </a:solidFill>
              <a:latin typeface="Hind"/>
              <a:ea typeface="Hind"/>
              <a:cs typeface="Hind"/>
              <a:sym typeface="Hind"/>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608"/>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609"/>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14" name="Shape 614"/>
        <p:cNvGrpSpPr/>
        <p:nvPr/>
      </p:nvGrpSpPr>
      <p:grpSpPr>
        <a:xfrm>
          <a:off x="0" y="0"/>
          <a:ext cx="0" cy="0"/>
          <a:chOff x="0" y="0"/>
          <a:chExt cx="0" cy="0"/>
        </a:xfrm>
      </p:grpSpPr>
      <p:sp>
        <p:nvSpPr>
          <p:cNvPr id="615" name="Google Shape;615;p43"/>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b="1" lang="en" sz="1800"/>
              <a:t>True or False</a:t>
            </a:r>
            <a:r>
              <a:rPr lang="en" sz="1800"/>
              <a:t>: Asian Americans report </a:t>
            </a:r>
            <a:r>
              <a:rPr lang="en" sz="1800"/>
              <a:t>lower</a:t>
            </a:r>
            <a:r>
              <a:rPr b="1" lang="en" sz="1800"/>
              <a:t> </a:t>
            </a:r>
            <a:r>
              <a:rPr lang="en" sz="1800"/>
              <a:t>rates</a:t>
            </a:r>
            <a:r>
              <a:rPr lang="en" sz="1800"/>
              <a:t> of </a:t>
            </a:r>
            <a:r>
              <a:rPr lang="en" sz="1800"/>
              <a:t>anxiety as compared to White Americans, which is consistent with rates of anxiety in epidemiological studies.</a:t>
            </a:r>
            <a:endParaRPr sz="1800"/>
          </a:p>
          <a:p>
            <a:pPr indent="0" lvl="0" marL="0" rtl="0" algn="l">
              <a:spcBef>
                <a:spcPts val="1200"/>
              </a:spcBef>
              <a:spcAft>
                <a:spcPts val="0"/>
              </a:spcAft>
              <a:buNone/>
            </a:pPr>
            <a:r>
              <a:t/>
            </a:r>
            <a:endParaRPr sz="1800"/>
          </a:p>
          <a:p>
            <a:pPr indent="0" lvl="0" marL="0" rtl="0" algn="l">
              <a:spcBef>
                <a:spcPts val="1200"/>
              </a:spcBef>
              <a:spcAft>
                <a:spcPts val="1200"/>
              </a:spcAft>
              <a:buNone/>
            </a:pPr>
            <a:r>
              <a:t/>
            </a:r>
            <a:endParaRPr i="1" sz="1800"/>
          </a:p>
        </p:txBody>
      </p:sp>
      <p:sp>
        <p:nvSpPr>
          <p:cNvPr id="616" name="Google Shape;616;p43"/>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Anxiety</a:t>
            </a:r>
            <a:endParaRPr/>
          </a:p>
        </p:txBody>
      </p:sp>
      <p:sp>
        <p:nvSpPr>
          <p:cNvPr id="617" name="Google Shape;617;p4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pic>
        <p:nvPicPr>
          <p:cNvPr descr="Psychotherapy Practice,Psychiatrist Consultation.Psychologist Session.Child Kid Psychotherapy.Worried Mother Maintain,Support Disappointed Depressed Son Boy. Stress Adolescent.Flat Vector Illustration (Provided by Getty Images)" id="618" name="Google Shape;618;p43"/>
          <p:cNvPicPr preferRelativeResize="0"/>
          <p:nvPr/>
        </p:nvPicPr>
        <p:blipFill rotWithShape="1">
          <a:blip r:embed="rId3">
            <a:alphaModFix/>
          </a:blip>
          <a:srcRect b="10472" l="0" r="0" t="13920"/>
          <a:stretch/>
        </p:blipFill>
        <p:spPr>
          <a:xfrm>
            <a:off x="2036100" y="2097825"/>
            <a:ext cx="4585999" cy="2675201"/>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22" name="Shape 622"/>
        <p:cNvGrpSpPr/>
        <p:nvPr/>
      </p:nvGrpSpPr>
      <p:grpSpPr>
        <a:xfrm>
          <a:off x="0" y="0"/>
          <a:ext cx="0" cy="0"/>
          <a:chOff x="0" y="0"/>
          <a:chExt cx="0" cy="0"/>
        </a:xfrm>
      </p:grpSpPr>
      <p:sp>
        <p:nvSpPr>
          <p:cNvPr id="623" name="Google Shape;623;p44"/>
          <p:cNvSpPr txBox="1"/>
          <p:nvPr>
            <p:ph type="title"/>
          </p:nvPr>
        </p:nvSpPr>
        <p:spPr>
          <a:xfrm>
            <a:off x="4125875" y="860050"/>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latin typeface="Hind"/>
                <a:ea typeface="Hind"/>
                <a:cs typeface="Hind"/>
                <a:sym typeface="Hind"/>
              </a:rPr>
              <a:t>Anxiety</a:t>
            </a:r>
            <a:endParaRPr>
              <a:latin typeface="Hind"/>
              <a:ea typeface="Hind"/>
              <a:cs typeface="Hind"/>
              <a:sym typeface="Hind"/>
            </a:endParaRPr>
          </a:p>
        </p:txBody>
      </p:sp>
      <p:sp>
        <p:nvSpPr>
          <p:cNvPr id="624" name="Google Shape;624;p4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625" name="Google Shape;625;p44"/>
          <p:cNvSpPr txBox="1"/>
          <p:nvPr/>
        </p:nvSpPr>
        <p:spPr>
          <a:xfrm>
            <a:off x="4856937" y="1902450"/>
            <a:ext cx="3303300" cy="16932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2019: 14.1% of AAs reported anxiety disorder</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2020: </a:t>
            </a:r>
            <a:r>
              <a:rPr b="1" lang="en">
                <a:solidFill>
                  <a:schemeClr val="dk1"/>
                </a:solidFill>
                <a:latin typeface="Hind"/>
                <a:ea typeface="Hind"/>
                <a:cs typeface="Hind"/>
                <a:sym typeface="Hind"/>
              </a:rPr>
              <a:t>97% greater chance of being diagnosed with anxiety disorder </a:t>
            </a:r>
            <a:r>
              <a:rPr lang="en">
                <a:solidFill>
                  <a:schemeClr val="dk1"/>
                </a:solidFill>
                <a:latin typeface="Hind"/>
                <a:ea typeface="Hind"/>
                <a:cs typeface="Hind"/>
                <a:sym typeface="Hind"/>
              </a:rPr>
              <a:t>as compared to 2019 </a:t>
            </a:r>
            <a:endParaRPr>
              <a:solidFill>
                <a:srgbClr val="434343"/>
              </a:solidFill>
              <a:latin typeface="Hind"/>
              <a:ea typeface="Hind"/>
              <a:cs typeface="Hind"/>
              <a:sym typeface="Hind"/>
            </a:endParaRPr>
          </a:p>
          <a:p>
            <a:pPr indent="-317500" lvl="1" marL="9144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40% increase in Hispanics and Whites</a:t>
            </a:r>
            <a:endParaRPr>
              <a:solidFill>
                <a:srgbClr val="434343"/>
              </a:solidFill>
              <a:latin typeface="Hind"/>
              <a:ea typeface="Hind"/>
              <a:cs typeface="Hind"/>
              <a:sym typeface="Hind"/>
            </a:endParaRPr>
          </a:p>
        </p:txBody>
      </p:sp>
      <p:sp>
        <p:nvSpPr>
          <p:cNvPr id="626" name="Google Shape;626;p44"/>
          <p:cNvSpPr txBox="1"/>
          <p:nvPr/>
        </p:nvSpPr>
        <p:spPr>
          <a:xfrm>
            <a:off x="5515575" y="1432743"/>
            <a:ext cx="19860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COVID-19</a:t>
            </a:r>
            <a:endParaRPr b="1" sz="2400">
              <a:solidFill>
                <a:srgbClr val="EAB56F"/>
              </a:solidFill>
              <a:latin typeface="Hind"/>
              <a:ea typeface="Hind"/>
              <a:cs typeface="Hind"/>
              <a:sym typeface="Hind"/>
            </a:endParaRPr>
          </a:p>
        </p:txBody>
      </p:sp>
      <p:sp>
        <p:nvSpPr>
          <p:cNvPr id="627" name="Google Shape;627;p44"/>
          <p:cNvSpPr txBox="1"/>
          <p:nvPr/>
        </p:nvSpPr>
        <p:spPr>
          <a:xfrm>
            <a:off x="1332213" y="1432750"/>
            <a:ext cx="30546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Historical Trends</a:t>
            </a:r>
            <a:endParaRPr b="1" sz="2400">
              <a:solidFill>
                <a:srgbClr val="EAB56F"/>
              </a:solidFill>
              <a:latin typeface="Hind"/>
              <a:ea typeface="Hind"/>
              <a:cs typeface="Hind"/>
              <a:sym typeface="Hind"/>
            </a:endParaRPr>
          </a:p>
        </p:txBody>
      </p:sp>
      <p:sp>
        <p:nvSpPr>
          <p:cNvPr id="628" name="Google Shape;628;p44"/>
          <p:cNvSpPr txBox="1"/>
          <p:nvPr/>
        </p:nvSpPr>
        <p:spPr>
          <a:xfrm>
            <a:off x="983763" y="1902450"/>
            <a:ext cx="3751500" cy="23397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chemeClr val="dk1"/>
              </a:buClr>
              <a:buSzPts val="1400"/>
              <a:buFont typeface="Hind"/>
              <a:buChar char="●"/>
            </a:pPr>
            <a:r>
              <a:rPr b="1" lang="en">
                <a:solidFill>
                  <a:schemeClr val="dk1"/>
                </a:solidFill>
                <a:latin typeface="Hind"/>
                <a:ea typeface="Hind"/>
                <a:cs typeface="Hind"/>
                <a:sym typeface="Hind"/>
              </a:rPr>
              <a:t>H</a:t>
            </a:r>
            <a:r>
              <a:rPr b="1" lang="en">
                <a:solidFill>
                  <a:schemeClr val="dk1"/>
                </a:solidFill>
                <a:latin typeface="Hind"/>
                <a:ea typeface="Hind"/>
                <a:cs typeface="Hind"/>
                <a:sym typeface="Hind"/>
              </a:rPr>
              <a:t>igher levels of social anxiety</a:t>
            </a:r>
            <a:r>
              <a:rPr lang="en">
                <a:solidFill>
                  <a:schemeClr val="dk1"/>
                </a:solidFill>
                <a:latin typeface="Hind"/>
                <a:ea typeface="Hind"/>
                <a:cs typeface="Hind"/>
                <a:sym typeface="Hind"/>
              </a:rPr>
              <a:t> compared to White Americans, but </a:t>
            </a:r>
            <a:r>
              <a:rPr b="1" lang="en">
                <a:solidFill>
                  <a:schemeClr val="dk1"/>
                </a:solidFill>
                <a:latin typeface="Hind"/>
                <a:ea typeface="Hind"/>
                <a:cs typeface="Hind"/>
                <a:sym typeface="Hind"/>
              </a:rPr>
              <a:t>lower levels of lifelong prevalence </a:t>
            </a:r>
            <a:r>
              <a:rPr lang="en">
                <a:solidFill>
                  <a:schemeClr val="dk1"/>
                </a:solidFill>
                <a:latin typeface="Hind"/>
                <a:ea typeface="Hind"/>
                <a:cs typeface="Hind"/>
                <a:sym typeface="Hind"/>
              </a:rPr>
              <a:t>when using Western measures of anxiety</a:t>
            </a:r>
            <a:endParaRPr>
              <a:solidFill>
                <a:schemeClr val="dk1"/>
              </a:solidFill>
              <a:latin typeface="Hind"/>
              <a:ea typeface="Hind"/>
              <a:cs typeface="Hind"/>
              <a:sym typeface="Hind"/>
            </a:endParaRPr>
          </a:p>
          <a:p>
            <a:pPr indent="-317500" lvl="1" marL="914400" rtl="0" algn="l">
              <a:spcBef>
                <a:spcPts val="0"/>
              </a:spcBef>
              <a:spcAft>
                <a:spcPts val="0"/>
              </a:spcAft>
              <a:buClr>
                <a:schemeClr val="dk1"/>
              </a:buClr>
              <a:buSzPts val="1400"/>
              <a:buFont typeface="Hind Light"/>
              <a:buChar char="○"/>
            </a:pPr>
            <a:r>
              <a:rPr lang="en">
                <a:solidFill>
                  <a:schemeClr val="dk1"/>
                </a:solidFill>
                <a:latin typeface="Hind"/>
                <a:ea typeface="Hind"/>
                <a:cs typeface="Hind"/>
                <a:sym typeface="Hind"/>
              </a:rPr>
              <a:t>Differences in understanding of diagnostic questionnaires</a:t>
            </a:r>
            <a:endParaRPr>
              <a:solidFill>
                <a:schemeClr val="dk1"/>
              </a:solidFill>
              <a:latin typeface="Hind"/>
              <a:ea typeface="Hind"/>
              <a:cs typeface="Hind"/>
              <a:sym typeface="Hind"/>
            </a:endParaRPr>
          </a:p>
          <a:p>
            <a:pPr indent="-317500" lvl="1" marL="914400" rtl="0" algn="l">
              <a:spcBef>
                <a:spcPts val="0"/>
              </a:spcBef>
              <a:spcAft>
                <a:spcPts val="0"/>
              </a:spcAft>
              <a:buClr>
                <a:schemeClr val="dk1"/>
              </a:buClr>
              <a:buSzPts val="1400"/>
              <a:buFont typeface="Hind Light"/>
              <a:buChar char="○"/>
            </a:pPr>
            <a:r>
              <a:rPr lang="en">
                <a:solidFill>
                  <a:schemeClr val="dk1"/>
                </a:solidFill>
                <a:latin typeface="Hind"/>
                <a:ea typeface="Hind"/>
                <a:cs typeface="Hind"/>
                <a:sym typeface="Hind"/>
              </a:rPr>
              <a:t>Cultural emphasis on sensitivity to others’ emotions and not showing strong emotions to others</a:t>
            </a:r>
            <a:endParaRPr>
              <a:solidFill>
                <a:schemeClr val="dk1"/>
              </a:solidFill>
              <a:latin typeface="Hind"/>
              <a:ea typeface="Hind"/>
              <a:cs typeface="Hind"/>
              <a:sym typeface="Hind"/>
            </a:endParaRPr>
          </a:p>
        </p:txBody>
      </p:sp>
      <p:sp>
        <p:nvSpPr>
          <p:cNvPr id="629" name="Google Shape;629;p44"/>
          <p:cNvSpPr txBox="1"/>
          <p:nvPr/>
        </p:nvSpPr>
        <p:spPr>
          <a:xfrm>
            <a:off x="-150" y="4835700"/>
            <a:ext cx="61611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Lau et al. </a:t>
            </a:r>
            <a:r>
              <a:rPr i="1" lang="en" sz="800">
                <a:solidFill>
                  <a:schemeClr val="dk1"/>
                </a:solidFill>
                <a:latin typeface="Hind"/>
                <a:ea typeface="Hind"/>
                <a:cs typeface="Hind"/>
                <a:sym typeface="Hind"/>
              </a:rPr>
              <a:t>Cultur Divers Ethnic Minor Psychol</a:t>
            </a:r>
            <a:r>
              <a:rPr lang="en" sz="800">
                <a:solidFill>
                  <a:schemeClr val="dk1"/>
                </a:solidFill>
                <a:latin typeface="Hind"/>
                <a:ea typeface="Hind"/>
                <a:cs typeface="Hind"/>
                <a:sym typeface="Hind"/>
              </a:rPr>
              <a:t>. 2009; Krieg et al. </a:t>
            </a:r>
            <a:r>
              <a:rPr i="1" lang="en" sz="800">
                <a:solidFill>
                  <a:schemeClr val="dk1"/>
                </a:solidFill>
                <a:latin typeface="Hind"/>
                <a:ea typeface="Hind"/>
                <a:cs typeface="Hind"/>
                <a:sym typeface="Hind"/>
              </a:rPr>
              <a:t>Assessment</a:t>
            </a:r>
            <a:r>
              <a:rPr lang="en" sz="800">
                <a:solidFill>
                  <a:schemeClr val="dk1"/>
                </a:solidFill>
                <a:latin typeface="Hind"/>
                <a:ea typeface="Hind"/>
                <a:cs typeface="Hind"/>
                <a:sym typeface="Hind"/>
              </a:rPr>
              <a:t>. 2018; Lee and Howard.</a:t>
            </a:r>
            <a:r>
              <a:rPr i="1" lang="en" sz="800">
                <a:solidFill>
                  <a:schemeClr val="dk1"/>
                </a:solidFill>
                <a:latin typeface="Hind"/>
                <a:ea typeface="Hind"/>
                <a:cs typeface="Hind"/>
                <a:sym typeface="Hind"/>
              </a:rPr>
              <a:t> </a:t>
            </a:r>
            <a:r>
              <a:rPr i="1" lang="en" sz="800">
                <a:solidFill>
                  <a:schemeClr val="dk1"/>
                </a:solidFill>
                <a:latin typeface="Hind"/>
                <a:ea typeface="Hind"/>
                <a:cs typeface="Hind"/>
                <a:sym typeface="Hind"/>
              </a:rPr>
              <a:t>J Racial Ethn Health Disparities. </a:t>
            </a:r>
            <a:r>
              <a:rPr lang="en" sz="800">
                <a:solidFill>
                  <a:schemeClr val="dk1"/>
                </a:solidFill>
                <a:latin typeface="Hind"/>
                <a:ea typeface="Hind"/>
                <a:cs typeface="Hind"/>
                <a:sym typeface="Hind"/>
              </a:rPr>
              <a:t>2023.</a:t>
            </a:r>
            <a:endParaRPr baseline="30000" sz="800">
              <a:solidFill>
                <a:schemeClr val="dk1"/>
              </a:solidFill>
              <a:latin typeface="Hind"/>
              <a:ea typeface="Hind"/>
              <a:cs typeface="Hind"/>
              <a:sym typeface="Hind"/>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626"/>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625"/>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33" name="Shape 633"/>
        <p:cNvGrpSpPr/>
        <p:nvPr/>
      </p:nvGrpSpPr>
      <p:grpSpPr>
        <a:xfrm>
          <a:off x="0" y="0"/>
          <a:ext cx="0" cy="0"/>
          <a:chOff x="0" y="0"/>
          <a:chExt cx="0" cy="0"/>
        </a:xfrm>
      </p:grpSpPr>
      <p:sp>
        <p:nvSpPr>
          <p:cNvPr id="634" name="Google Shape;634;p45"/>
          <p:cNvSpPr txBox="1"/>
          <p:nvPr>
            <p:ph type="title"/>
          </p:nvPr>
        </p:nvSpPr>
        <p:spPr>
          <a:xfrm>
            <a:off x="3692900" y="89027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latin typeface="Hind"/>
                <a:ea typeface="Hind"/>
                <a:cs typeface="Hind"/>
                <a:sym typeface="Hind"/>
              </a:rPr>
              <a:t>Schizophrenia</a:t>
            </a:r>
            <a:endParaRPr>
              <a:latin typeface="Hind"/>
              <a:ea typeface="Hind"/>
              <a:cs typeface="Hind"/>
              <a:sym typeface="Hind"/>
            </a:endParaRPr>
          </a:p>
        </p:txBody>
      </p:sp>
      <p:sp>
        <p:nvSpPr>
          <p:cNvPr id="635" name="Google Shape;635;p4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636" name="Google Shape;636;p45"/>
          <p:cNvSpPr txBox="1"/>
          <p:nvPr/>
        </p:nvSpPr>
        <p:spPr>
          <a:xfrm>
            <a:off x="4856937" y="1932675"/>
            <a:ext cx="3303300" cy="21240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rgbClr val="434343"/>
              </a:buClr>
              <a:buSzPts val="1400"/>
              <a:buFont typeface="Hind"/>
              <a:buChar char="●"/>
            </a:pPr>
            <a:r>
              <a:rPr b="1" lang="en">
                <a:solidFill>
                  <a:srgbClr val="434343"/>
                </a:solidFill>
                <a:latin typeface="Hind"/>
                <a:ea typeface="Hind"/>
                <a:cs typeface="Hind"/>
                <a:sym typeface="Hind"/>
              </a:rPr>
              <a:t>Longer duration of untreated psychosis</a:t>
            </a:r>
            <a:r>
              <a:rPr lang="en">
                <a:solidFill>
                  <a:srgbClr val="434343"/>
                </a:solidFill>
                <a:latin typeface="Hind"/>
                <a:ea typeface="Hind"/>
                <a:cs typeface="Hind"/>
                <a:sym typeface="Hind"/>
              </a:rPr>
              <a:t> in AA compared to other ethnic groups</a:t>
            </a:r>
            <a:endParaRPr>
              <a:solidFill>
                <a:srgbClr val="434343"/>
              </a:solidFill>
              <a:latin typeface="Hind"/>
              <a:ea typeface="Hind"/>
              <a:cs typeface="Hind"/>
              <a:sym typeface="Hind"/>
            </a:endParaRPr>
          </a:p>
          <a:p>
            <a:pPr indent="-317500" lvl="0" marL="4572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Limited research on schizophrenia in AANHPI populations</a:t>
            </a:r>
            <a:endParaRPr>
              <a:solidFill>
                <a:srgbClr val="434343"/>
              </a:solidFill>
              <a:latin typeface="Hind"/>
              <a:ea typeface="Hind"/>
              <a:cs typeface="Hind"/>
              <a:sym typeface="Hind"/>
            </a:endParaRPr>
          </a:p>
          <a:p>
            <a:pPr indent="-317500" lvl="1" marL="914400" rtl="0" algn="l">
              <a:spcBef>
                <a:spcPts val="0"/>
              </a:spcBef>
              <a:spcAft>
                <a:spcPts val="0"/>
              </a:spcAft>
              <a:buClr>
                <a:srgbClr val="434343"/>
              </a:buClr>
              <a:buSzPts val="1400"/>
              <a:buFont typeface="Hind"/>
              <a:buChar char="○"/>
            </a:pPr>
            <a:r>
              <a:rPr lang="en">
                <a:solidFill>
                  <a:srgbClr val="434343"/>
                </a:solidFill>
                <a:latin typeface="Hind"/>
                <a:ea typeface="Hind"/>
                <a:cs typeface="Hind"/>
                <a:sym typeface="Hind"/>
              </a:rPr>
              <a:t>Smaller sample sizes and subpopulation data compared to other races and ethnicities</a:t>
            </a:r>
            <a:endParaRPr>
              <a:solidFill>
                <a:srgbClr val="434343"/>
              </a:solidFill>
              <a:latin typeface="Hind"/>
              <a:ea typeface="Hind"/>
              <a:cs typeface="Hind"/>
              <a:sym typeface="Hind"/>
            </a:endParaRPr>
          </a:p>
        </p:txBody>
      </p:sp>
      <p:sp>
        <p:nvSpPr>
          <p:cNvPr id="637" name="Google Shape;637;p45"/>
          <p:cNvSpPr txBox="1"/>
          <p:nvPr/>
        </p:nvSpPr>
        <p:spPr>
          <a:xfrm>
            <a:off x="5515575" y="1462968"/>
            <a:ext cx="19860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Severity</a:t>
            </a:r>
            <a:endParaRPr b="1" sz="2400">
              <a:solidFill>
                <a:srgbClr val="EAB56F"/>
              </a:solidFill>
              <a:latin typeface="Hind"/>
              <a:ea typeface="Hind"/>
              <a:cs typeface="Hind"/>
              <a:sym typeface="Hind"/>
            </a:endParaRPr>
          </a:p>
        </p:txBody>
      </p:sp>
      <p:sp>
        <p:nvSpPr>
          <p:cNvPr id="638" name="Google Shape;638;p45"/>
          <p:cNvSpPr txBox="1"/>
          <p:nvPr/>
        </p:nvSpPr>
        <p:spPr>
          <a:xfrm>
            <a:off x="1332213" y="1462975"/>
            <a:ext cx="3054600" cy="527700"/>
          </a:xfrm>
          <a:prstGeom prst="rect">
            <a:avLst/>
          </a:prstGeom>
          <a:no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b="1" lang="en" sz="2400">
                <a:solidFill>
                  <a:srgbClr val="EAB56F"/>
                </a:solidFill>
                <a:latin typeface="Hind"/>
                <a:ea typeface="Hind"/>
                <a:cs typeface="Hind"/>
                <a:sym typeface="Hind"/>
              </a:rPr>
              <a:t>Prevalence</a:t>
            </a:r>
            <a:endParaRPr b="1" sz="2400">
              <a:solidFill>
                <a:srgbClr val="EAB56F"/>
              </a:solidFill>
              <a:latin typeface="Hind"/>
              <a:ea typeface="Hind"/>
              <a:cs typeface="Hind"/>
              <a:sym typeface="Hind"/>
            </a:endParaRPr>
          </a:p>
        </p:txBody>
      </p:sp>
      <p:sp>
        <p:nvSpPr>
          <p:cNvPr id="639" name="Google Shape;639;p45"/>
          <p:cNvSpPr txBox="1"/>
          <p:nvPr/>
        </p:nvSpPr>
        <p:spPr>
          <a:xfrm>
            <a:off x="983763" y="1932675"/>
            <a:ext cx="3751500" cy="1908600"/>
          </a:xfrm>
          <a:prstGeom prst="rect">
            <a:avLst/>
          </a:prstGeom>
          <a:noFill/>
          <a:ln>
            <a:noFill/>
          </a:ln>
        </p:spPr>
        <p:txBody>
          <a:bodyPr anchorCtr="0" anchor="t" bIns="91425" lIns="91425" spcFirstLastPara="1" rIns="91425" wrap="square" tIns="91425">
            <a:spAutoFit/>
          </a:bodyPr>
          <a:lstStyle/>
          <a:p>
            <a:pPr indent="-317500" lvl="0" marL="457200" rtl="0" algn="l">
              <a:spcBef>
                <a:spcPts val="0"/>
              </a:spcBef>
              <a:spcAft>
                <a:spcPts val="0"/>
              </a:spcAft>
              <a:buClr>
                <a:schemeClr val="dk1"/>
              </a:buClr>
              <a:buSzPts val="1400"/>
              <a:buFont typeface="Hind"/>
              <a:buChar char="●"/>
            </a:pPr>
            <a:r>
              <a:rPr lang="en">
                <a:solidFill>
                  <a:schemeClr val="dk1"/>
                </a:solidFill>
                <a:latin typeface="Hind"/>
                <a:ea typeface="Hind"/>
                <a:cs typeface="Hind"/>
                <a:sym typeface="Hind"/>
              </a:rPr>
              <a:t>Lifetime prevalence of psychotic symptoms in AAs around </a:t>
            </a:r>
            <a:r>
              <a:rPr b="1" lang="en">
                <a:solidFill>
                  <a:schemeClr val="dk1"/>
                </a:solidFill>
                <a:latin typeface="Hind"/>
                <a:ea typeface="Hind"/>
                <a:cs typeface="Hind"/>
                <a:sym typeface="Hind"/>
              </a:rPr>
              <a:t>~9.6%</a:t>
            </a:r>
            <a:endParaRPr b="1">
              <a:solidFill>
                <a:schemeClr val="dk1"/>
              </a:solidFill>
              <a:latin typeface="Hind"/>
              <a:ea typeface="Hind"/>
              <a:cs typeface="Hind"/>
              <a:sym typeface="Hind"/>
            </a:endParaRPr>
          </a:p>
          <a:p>
            <a:pPr indent="-304800" lvl="0" marL="457200" rtl="0" algn="l">
              <a:spcBef>
                <a:spcPts val="0"/>
              </a:spcBef>
              <a:spcAft>
                <a:spcPts val="0"/>
              </a:spcAft>
              <a:buClr>
                <a:schemeClr val="dk1"/>
              </a:buClr>
              <a:buSzPts val="1200"/>
              <a:buFont typeface="Hind"/>
              <a:buChar char="●"/>
            </a:pPr>
            <a:r>
              <a:rPr lang="en">
                <a:solidFill>
                  <a:schemeClr val="dk1"/>
                </a:solidFill>
                <a:latin typeface="Hind"/>
                <a:ea typeface="Hind"/>
                <a:cs typeface="Hind"/>
                <a:sym typeface="Hind"/>
              </a:rPr>
              <a:t>Subgroup variations:</a:t>
            </a:r>
            <a:endParaRPr>
              <a:solidFill>
                <a:schemeClr val="dk1"/>
              </a:solidFill>
              <a:latin typeface="Hind"/>
              <a:ea typeface="Hind"/>
              <a:cs typeface="Hind"/>
              <a:sym typeface="Hind"/>
            </a:endParaRPr>
          </a:p>
          <a:p>
            <a:pPr indent="-304800" lvl="1" marL="914400" rtl="0" algn="l">
              <a:spcBef>
                <a:spcPts val="0"/>
              </a:spcBef>
              <a:spcAft>
                <a:spcPts val="0"/>
              </a:spcAft>
              <a:buClr>
                <a:schemeClr val="dk1"/>
              </a:buClr>
              <a:buSzPts val="1200"/>
              <a:buFont typeface="Hind Light"/>
              <a:buChar char="○"/>
            </a:pPr>
            <a:r>
              <a:rPr lang="en">
                <a:solidFill>
                  <a:schemeClr val="dk1"/>
                </a:solidFill>
                <a:latin typeface="Hind"/>
                <a:ea typeface="Hind"/>
                <a:cs typeface="Hind"/>
                <a:sym typeface="Hind"/>
              </a:rPr>
              <a:t>Filipino and ‘Other Asians’ had significantly greater odds of lifetime psychotic experiences compared to Chinese</a:t>
            </a:r>
            <a:endParaRPr>
              <a:solidFill>
                <a:schemeClr val="dk1"/>
              </a:solidFill>
              <a:latin typeface="Hind"/>
              <a:ea typeface="Hind"/>
              <a:cs typeface="Hind"/>
              <a:sym typeface="Hind"/>
            </a:endParaRPr>
          </a:p>
          <a:p>
            <a:pPr indent="-304800" lvl="1" marL="914400" rtl="0" algn="l">
              <a:spcBef>
                <a:spcPts val="0"/>
              </a:spcBef>
              <a:spcAft>
                <a:spcPts val="0"/>
              </a:spcAft>
              <a:buClr>
                <a:schemeClr val="dk1"/>
              </a:buClr>
              <a:buSzPts val="1200"/>
              <a:buFont typeface="Hind"/>
              <a:buChar char="○"/>
            </a:pPr>
            <a:r>
              <a:rPr lang="en">
                <a:solidFill>
                  <a:schemeClr val="dk1"/>
                </a:solidFill>
                <a:latin typeface="Hind"/>
                <a:ea typeface="Hind"/>
                <a:cs typeface="Hind"/>
                <a:sym typeface="Hind"/>
              </a:rPr>
              <a:t>Vietnamese had lowest levels	</a:t>
            </a:r>
            <a:endParaRPr>
              <a:solidFill>
                <a:schemeClr val="dk1"/>
              </a:solidFill>
              <a:latin typeface="Hind"/>
              <a:ea typeface="Hind"/>
              <a:cs typeface="Hind"/>
              <a:sym typeface="Hind"/>
            </a:endParaRPr>
          </a:p>
        </p:txBody>
      </p:sp>
      <p:sp>
        <p:nvSpPr>
          <p:cNvPr id="640" name="Google Shape;640;p45"/>
          <p:cNvSpPr txBox="1"/>
          <p:nvPr/>
        </p:nvSpPr>
        <p:spPr>
          <a:xfrm>
            <a:off x="-150" y="4835700"/>
            <a:ext cx="61611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Li et al. </a:t>
            </a:r>
            <a:r>
              <a:rPr i="1" lang="en" sz="800">
                <a:solidFill>
                  <a:schemeClr val="dk1"/>
                </a:solidFill>
                <a:latin typeface="Hind"/>
                <a:ea typeface="Hind"/>
                <a:cs typeface="Hind"/>
                <a:sym typeface="Hind"/>
              </a:rPr>
              <a:t>J Nerv Ment Dis. </a:t>
            </a:r>
            <a:r>
              <a:rPr lang="en" sz="800">
                <a:solidFill>
                  <a:schemeClr val="dk1"/>
                </a:solidFill>
                <a:latin typeface="Hind"/>
                <a:ea typeface="Hind"/>
                <a:cs typeface="Hind"/>
                <a:sym typeface="Hind"/>
              </a:rPr>
              <a:t>2013; Oh et al. </a:t>
            </a:r>
            <a:r>
              <a:rPr i="1" lang="en" sz="800">
                <a:solidFill>
                  <a:schemeClr val="dk1"/>
                </a:solidFill>
                <a:latin typeface="Hind"/>
                <a:ea typeface="Hind"/>
                <a:cs typeface="Hind"/>
                <a:sym typeface="Hind"/>
              </a:rPr>
              <a:t>Schizophr Res.</a:t>
            </a:r>
            <a:r>
              <a:rPr lang="en" sz="800">
                <a:solidFill>
                  <a:schemeClr val="dk1"/>
                </a:solidFill>
                <a:latin typeface="Hind"/>
                <a:ea typeface="Hind"/>
                <a:cs typeface="Hind"/>
                <a:sym typeface="Hind"/>
              </a:rPr>
              <a:t> 2023.; Lim et al. </a:t>
            </a:r>
            <a:r>
              <a:rPr i="1" lang="en" sz="800">
                <a:solidFill>
                  <a:schemeClr val="dk1"/>
                </a:solidFill>
                <a:latin typeface="Hind"/>
                <a:ea typeface="Hind"/>
                <a:cs typeface="Hind"/>
                <a:sym typeface="Hind"/>
              </a:rPr>
              <a:t>Community Ment Health J.</a:t>
            </a:r>
            <a:r>
              <a:rPr lang="en" sz="800">
                <a:solidFill>
                  <a:schemeClr val="dk1"/>
                </a:solidFill>
                <a:latin typeface="Hind"/>
                <a:ea typeface="Hind"/>
                <a:cs typeface="Hind"/>
                <a:sym typeface="Hind"/>
              </a:rPr>
              <a:t> 2021.</a:t>
            </a:r>
            <a:endParaRPr sz="800">
              <a:solidFill>
                <a:schemeClr val="dk1"/>
              </a:solidFill>
              <a:latin typeface="Hind"/>
              <a:ea typeface="Hind"/>
              <a:cs typeface="Hind"/>
              <a:sym typeface="Hind"/>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636"/>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637"/>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44" name="Shape 644"/>
        <p:cNvGrpSpPr/>
        <p:nvPr/>
      </p:nvGrpSpPr>
      <p:grpSpPr>
        <a:xfrm>
          <a:off x="0" y="0"/>
          <a:ext cx="0" cy="0"/>
          <a:chOff x="0" y="0"/>
          <a:chExt cx="0" cy="0"/>
        </a:xfrm>
      </p:grpSpPr>
      <p:sp>
        <p:nvSpPr>
          <p:cNvPr id="645" name="Google Shape;645;p46"/>
          <p:cNvSpPr txBox="1"/>
          <p:nvPr>
            <p:ph type="title"/>
          </p:nvPr>
        </p:nvSpPr>
        <p:spPr>
          <a:xfrm>
            <a:off x="720000" y="2148675"/>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Part 4: Considerations for Healthcare Providers</a:t>
            </a:r>
            <a:endParaRPr/>
          </a:p>
        </p:txBody>
      </p:sp>
      <p:sp>
        <p:nvSpPr>
          <p:cNvPr id="646" name="Google Shape;646;p4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5" name="Shape 235"/>
        <p:cNvGrpSpPr/>
        <p:nvPr/>
      </p:nvGrpSpPr>
      <p:grpSpPr>
        <a:xfrm>
          <a:off x="0" y="0"/>
          <a:ext cx="0" cy="0"/>
          <a:chOff x="0" y="0"/>
          <a:chExt cx="0" cy="0"/>
        </a:xfrm>
      </p:grpSpPr>
      <p:sp>
        <p:nvSpPr>
          <p:cNvPr id="236" name="Google Shape;236;p20"/>
          <p:cNvSpPr txBox="1"/>
          <p:nvPr>
            <p:ph type="title"/>
          </p:nvPr>
        </p:nvSpPr>
        <p:spPr>
          <a:xfrm>
            <a:off x="319850" y="312050"/>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What is AANHPI?</a:t>
            </a:r>
            <a:endParaRPr/>
          </a:p>
        </p:txBody>
      </p:sp>
      <p:sp>
        <p:nvSpPr>
          <p:cNvPr id="237" name="Google Shape;237;p20"/>
          <p:cNvSpPr txBox="1"/>
          <p:nvPr>
            <p:ph idx="1" type="body"/>
          </p:nvPr>
        </p:nvSpPr>
        <p:spPr>
          <a:xfrm>
            <a:off x="295170" y="1056600"/>
            <a:ext cx="52923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b="1" lang="en" sz="1500"/>
              <a:t>AANHPI - Asian American, Native Hawaiian, and Pacific</a:t>
            </a:r>
            <a:r>
              <a:rPr b="1" lang="en" sz="1500"/>
              <a:t> </a:t>
            </a:r>
            <a:r>
              <a:rPr b="1" lang="en" sz="1500"/>
              <a:t>Islander</a:t>
            </a:r>
            <a:endParaRPr b="1" sz="1500"/>
          </a:p>
          <a:p>
            <a:pPr indent="0" lvl="0" marL="0" rtl="0" algn="l">
              <a:spcBef>
                <a:spcPts val="1200"/>
              </a:spcBef>
              <a:spcAft>
                <a:spcPts val="0"/>
              </a:spcAft>
              <a:buNone/>
            </a:pPr>
            <a:r>
              <a:rPr b="1" lang="en" sz="1500"/>
              <a:t>20.6 million </a:t>
            </a:r>
            <a:r>
              <a:rPr lang="en" sz="1500"/>
              <a:t>people from the 2020 census identify as AANHPI</a:t>
            </a:r>
            <a:endParaRPr sz="1500"/>
          </a:p>
          <a:p>
            <a:pPr indent="-323850" lvl="0" marL="457200" rtl="0" algn="l">
              <a:spcBef>
                <a:spcPts val="1200"/>
              </a:spcBef>
              <a:spcAft>
                <a:spcPts val="0"/>
              </a:spcAft>
              <a:buSzPts val="1500"/>
              <a:buChar char="-"/>
            </a:pPr>
            <a:r>
              <a:rPr lang="en" sz="1500"/>
              <a:t>24 million people identify as Asian*</a:t>
            </a:r>
            <a:endParaRPr sz="1500"/>
          </a:p>
          <a:p>
            <a:pPr indent="-323850" lvl="0" marL="457200" rtl="0" algn="l">
              <a:spcBef>
                <a:spcPts val="0"/>
              </a:spcBef>
              <a:spcAft>
                <a:spcPts val="0"/>
              </a:spcAft>
              <a:buSzPts val="1500"/>
              <a:buChar char="-"/>
            </a:pPr>
            <a:r>
              <a:rPr lang="en" sz="1500"/>
              <a:t>1.6 million people identify as Native Hawaiian or other P</a:t>
            </a:r>
            <a:r>
              <a:rPr lang="en" sz="1500"/>
              <a:t>acific</a:t>
            </a:r>
            <a:r>
              <a:rPr lang="en" sz="1500"/>
              <a:t> Islander* </a:t>
            </a:r>
            <a:endParaRPr sz="1500"/>
          </a:p>
          <a:p>
            <a:pPr indent="0" lvl="0" marL="0" rtl="0" algn="l">
              <a:spcBef>
                <a:spcPts val="1200"/>
              </a:spcBef>
              <a:spcAft>
                <a:spcPts val="0"/>
              </a:spcAft>
              <a:buNone/>
            </a:pPr>
            <a:r>
              <a:rPr lang="en" sz="1500"/>
              <a:t>AANHPI is incredibly </a:t>
            </a:r>
            <a:r>
              <a:rPr b="1" lang="en" sz="1500"/>
              <a:t>diverse</a:t>
            </a:r>
            <a:r>
              <a:rPr lang="en" sz="1500"/>
              <a:t>, </a:t>
            </a:r>
            <a:r>
              <a:rPr lang="en" sz="1500"/>
              <a:t>with over</a:t>
            </a:r>
            <a:r>
              <a:rPr lang="en" sz="1500"/>
              <a:t> </a:t>
            </a:r>
            <a:r>
              <a:rPr b="1" lang="en" sz="1500"/>
              <a:t>50 distinct </a:t>
            </a:r>
            <a:r>
              <a:rPr b="1" lang="en" sz="1500"/>
              <a:t>ethnic</a:t>
            </a:r>
            <a:r>
              <a:rPr b="1" lang="en" sz="1500"/>
              <a:t> groups</a:t>
            </a:r>
            <a:r>
              <a:rPr lang="en" sz="1500"/>
              <a:t> and </a:t>
            </a:r>
            <a:r>
              <a:rPr b="1" lang="en" sz="1500"/>
              <a:t>over 100 languages</a:t>
            </a:r>
            <a:endParaRPr b="1" sz="1500"/>
          </a:p>
          <a:p>
            <a:pPr indent="0" lvl="0" marL="0" rtl="0" algn="l">
              <a:spcBef>
                <a:spcPts val="1200"/>
              </a:spcBef>
              <a:spcAft>
                <a:spcPts val="1200"/>
              </a:spcAft>
              <a:buNone/>
            </a:pPr>
            <a:r>
              <a:rPr i="1" lang="en" sz="1300"/>
              <a:t>*Both alone or in combination with another race</a:t>
            </a:r>
            <a:r>
              <a:rPr lang="en" sz="1500"/>
              <a:t> </a:t>
            </a:r>
            <a:endParaRPr sz="1500"/>
          </a:p>
        </p:txBody>
      </p:sp>
      <p:sp>
        <p:nvSpPr>
          <p:cNvPr id="238" name="Google Shape;238;p2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239" name="Google Shape;239;p20"/>
          <p:cNvSpPr txBox="1"/>
          <p:nvPr/>
        </p:nvSpPr>
        <p:spPr>
          <a:xfrm>
            <a:off x="0" y="4851000"/>
            <a:ext cx="22200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Monte and Shin. </a:t>
            </a:r>
            <a:r>
              <a:rPr i="1" lang="en" sz="800">
                <a:solidFill>
                  <a:schemeClr val="dk1"/>
                </a:solidFill>
                <a:latin typeface="Hind"/>
                <a:ea typeface="Hind"/>
                <a:cs typeface="Hind"/>
                <a:sym typeface="Hind"/>
              </a:rPr>
              <a:t>US Census Bureau. </a:t>
            </a:r>
            <a:r>
              <a:rPr lang="en" sz="800">
                <a:solidFill>
                  <a:schemeClr val="dk1"/>
                </a:solidFill>
                <a:latin typeface="Hind"/>
                <a:ea typeface="Hind"/>
                <a:cs typeface="Hind"/>
                <a:sym typeface="Hind"/>
              </a:rPr>
              <a:t>2022.</a:t>
            </a:r>
            <a:endParaRPr sz="800">
              <a:solidFill>
                <a:schemeClr val="dk1"/>
              </a:solidFill>
              <a:latin typeface="Hind"/>
              <a:ea typeface="Hind"/>
              <a:cs typeface="Hind"/>
              <a:sym typeface="Hind"/>
            </a:endParaRPr>
          </a:p>
        </p:txBody>
      </p:sp>
      <p:sp>
        <p:nvSpPr>
          <p:cNvPr id="240" name="Google Shape;240;p20"/>
          <p:cNvSpPr/>
          <p:nvPr/>
        </p:nvSpPr>
        <p:spPr>
          <a:xfrm>
            <a:off x="6525575" y="312050"/>
            <a:ext cx="2031300" cy="2031300"/>
          </a:xfrm>
          <a:prstGeom prst="ellipse">
            <a:avLst/>
          </a:prstGeom>
          <a:solidFill>
            <a:schemeClr val="accent1"/>
          </a:solidFill>
          <a:ln cap="flat" cmpd="sng" w="9525">
            <a:solidFill>
              <a:schemeClr val="dk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latin typeface="Hind"/>
                <a:ea typeface="Hind"/>
                <a:cs typeface="Hind"/>
                <a:sym typeface="Hind"/>
              </a:rPr>
              <a:t>Chinese</a:t>
            </a:r>
            <a:endParaRPr>
              <a:latin typeface="Hind"/>
              <a:ea typeface="Hind"/>
              <a:cs typeface="Hind"/>
              <a:sym typeface="Hind"/>
            </a:endParaRPr>
          </a:p>
        </p:txBody>
      </p:sp>
      <p:sp>
        <p:nvSpPr>
          <p:cNvPr id="241" name="Google Shape;241;p20"/>
          <p:cNvSpPr/>
          <p:nvPr/>
        </p:nvSpPr>
        <p:spPr>
          <a:xfrm>
            <a:off x="5777199" y="1629000"/>
            <a:ext cx="1832400" cy="1785600"/>
          </a:xfrm>
          <a:prstGeom prst="ellipse">
            <a:avLst/>
          </a:prstGeom>
          <a:solidFill>
            <a:schemeClr val="lt1"/>
          </a:solidFill>
          <a:ln cap="flat" cmpd="sng" w="9525">
            <a:solidFill>
              <a:schemeClr val="dk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latin typeface="Hind"/>
                <a:ea typeface="Hind"/>
                <a:cs typeface="Hind"/>
                <a:sym typeface="Hind"/>
              </a:rPr>
              <a:t>Indian</a:t>
            </a:r>
            <a:endParaRPr>
              <a:latin typeface="Hind"/>
              <a:ea typeface="Hind"/>
              <a:cs typeface="Hind"/>
              <a:sym typeface="Hind"/>
            </a:endParaRPr>
          </a:p>
        </p:txBody>
      </p:sp>
      <p:sp>
        <p:nvSpPr>
          <p:cNvPr id="242" name="Google Shape;242;p20"/>
          <p:cNvSpPr/>
          <p:nvPr/>
        </p:nvSpPr>
        <p:spPr>
          <a:xfrm>
            <a:off x="5403825" y="3103975"/>
            <a:ext cx="1605300" cy="1605300"/>
          </a:xfrm>
          <a:prstGeom prst="ellipse">
            <a:avLst/>
          </a:prstGeom>
          <a:solidFill>
            <a:srgbClr val="FFF2CC"/>
          </a:solidFill>
          <a:ln cap="flat" cmpd="sng" w="9525">
            <a:solidFill>
              <a:schemeClr val="dk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latin typeface="Hind"/>
                <a:ea typeface="Hind"/>
                <a:cs typeface="Hind"/>
                <a:sym typeface="Hind"/>
              </a:rPr>
              <a:t>Korean</a:t>
            </a:r>
            <a:endParaRPr>
              <a:latin typeface="Hind"/>
              <a:ea typeface="Hind"/>
              <a:cs typeface="Hind"/>
              <a:sym typeface="Hind"/>
            </a:endParaRPr>
          </a:p>
        </p:txBody>
      </p:sp>
      <p:sp>
        <p:nvSpPr>
          <p:cNvPr id="243" name="Google Shape;243;p20"/>
          <p:cNvSpPr/>
          <p:nvPr/>
        </p:nvSpPr>
        <p:spPr>
          <a:xfrm>
            <a:off x="6691975" y="3027775"/>
            <a:ext cx="1605300" cy="1605300"/>
          </a:xfrm>
          <a:prstGeom prst="ellipse">
            <a:avLst/>
          </a:prstGeom>
          <a:solidFill>
            <a:srgbClr val="FCE5CD"/>
          </a:solidFill>
          <a:ln cap="flat" cmpd="sng" w="9525">
            <a:solidFill>
              <a:schemeClr val="lt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latin typeface="Hind"/>
                <a:ea typeface="Hind"/>
                <a:cs typeface="Hind"/>
                <a:sym typeface="Hind"/>
              </a:rPr>
              <a:t>Vietnamese</a:t>
            </a:r>
            <a:endParaRPr>
              <a:latin typeface="Hind"/>
              <a:ea typeface="Hind"/>
              <a:cs typeface="Hind"/>
              <a:sym typeface="Hind"/>
            </a:endParaRPr>
          </a:p>
        </p:txBody>
      </p:sp>
      <p:sp>
        <p:nvSpPr>
          <p:cNvPr id="244" name="Google Shape;244;p20"/>
          <p:cNvSpPr/>
          <p:nvPr/>
        </p:nvSpPr>
        <p:spPr>
          <a:xfrm>
            <a:off x="7388525" y="1962150"/>
            <a:ext cx="1605300" cy="1605300"/>
          </a:xfrm>
          <a:prstGeom prst="ellipse">
            <a:avLst/>
          </a:prstGeom>
          <a:solidFill>
            <a:srgbClr val="FEF8BE"/>
          </a:solidFill>
          <a:ln cap="flat" cmpd="sng" w="9525">
            <a:solidFill>
              <a:schemeClr val="dk2"/>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latin typeface="Hind"/>
                <a:ea typeface="Hind"/>
                <a:cs typeface="Hind"/>
                <a:sym typeface="Hind"/>
              </a:rPr>
              <a:t>Filipino</a:t>
            </a:r>
            <a:endParaRPr>
              <a:latin typeface="Hind"/>
              <a:ea typeface="Hind"/>
              <a:cs typeface="Hind"/>
              <a:sym typeface="Hind"/>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0" name="Shape 650"/>
        <p:cNvGrpSpPr/>
        <p:nvPr/>
      </p:nvGrpSpPr>
      <p:grpSpPr>
        <a:xfrm>
          <a:off x="0" y="0"/>
          <a:ext cx="0" cy="0"/>
          <a:chOff x="0" y="0"/>
          <a:chExt cx="0" cy="0"/>
        </a:xfrm>
      </p:grpSpPr>
      <p:sp>
        <p:nvSpPr>
          <p:cNvPr id="651" name="Google Shape;651;p47"/>
          <p:cNvSpPr txBox="1"/>
          <p:nvPr>
            <p:ph idx="1" type="body"/>
          </p:nvPr>
        </p:nvSpPr>
        <p:spPr>
          <a:xfrm>
            <a:off x="360000" y="938750"/>
            <a:ext cx="8574300" cy="3416400"/>
          </a:xfrm>
          <a:prstGeom prst="rect">
            <a:avLst/>
          </a:prstGeom>
        </p:spPr>
        <p:txBody>
          <a:bodyPr anchorCtr="0" anchor="t" bIns="91425" lIns="91425" spcFirstLastPara="1" rIns="91425" wrap="square" tIns="91425">
            <a:noAutofit/>
          </a:bodyPr>
          <a:lstStyle/>
          <a:p>
            <a:pPr indent="0" lvl="0" marL="0" rtl="0" algn="l">
              <a:lnSpc>
                <a:spcPct val="115000"/>
              </a:lnSpc>
              <a:spcBef>
                <a:spcPts val="0"/>
              </a:spcBef>
              <a:spcAft>
                <a:spcPts val="0"/>
              </a:spcAft>
              <a:buNone/>
            </a:pPr>
            <a:r>
              <a:rPr b="1" lang="en" sz="1500">
                <a:solidFill>
                  <a:schemeClr val="dk1"/>
                </a:solidFill>
              </a:rPr>
              <a:t>American Psychological Association Recommendations:</a:t>
            </a:r>
            <a:endParaRPr b="1" sz="1500">
              <a:solidFill>
                <a:schemeClr val="dk1"/>
              </a:solidFill>
            </a:endParaRPr>
          </a:p>
          <a:p>
            <a:pPr indent="0" lvl="0" marL="0" rtl="0" algn="l">
              <a:lnSpc>
                <a:spcPct val="115000"/>
              </a:lnSpc>
              <a:spcBef>
                <a:spcPts val="1000"/>
              </a:spcBef>
              <a:spcAft>
                <a:spcPts val="0"/>
              </a:spcAft>
              <a:buNone/>
            </a:pPr>
            <a:r>
              <a:rPr lang="en" sz="1500">
                <a:solidFill>
                  <a:schemeClr val="dk1"/>
                </a:solidFill>
              </a:rPr>
              <a:t>Be aware of:</a:t>
            </a:r>
            <a:endParaRPr sz="1500">
              <a:solidFill>
                <a:schemeClr val="dk1"/>
              </a:solidFill>
            </a:endParaRPr>
          </a:p>
          <a:p>
            <a:pPr indent="-323850" lvl="0" marL="457200" rtl="0" algn="l">
              <a:lnSpc>
                <a:spcPct val="115000"/>
              </a:lnSpc>
              <a:spcBef>
                <a:spcPts val="0"/>
              </a:spcBef>
              <a:spcAft>
                <a:spcPts val="0"/>
              </a:spcAft>
              <a:buClr>
                <a:schemeClr val="dk1"/>
              </a:buClr>
              <a:buSzPts val="1500"/>
              <a:buChar char="-"/>
            </a:pPr>
            <a:r>
              <a:rPr lang="en" sz="1500">
                <a:solidFill>
                  <a:schemeClr val="dk1"/>
                </a:solidFill>
              </a:rPr>
              <a:t>H</a:t>
            </a:r>
            <a:r>
              <a:rPr lang="en" sz="1500">
                <a:solidFill>
                  <a:schemeClr val="dk1"/>
                </a:solidFill>
              </a:rPr>
              <a:t>istorical stereotypes and myths, and assess </a:t>
            </a:r>
            <a:r>
              <a:rPr lang="en" sz="1500">
                <a:solidFill>
                  <a:schemeClr val="dk1"/>
                </a:solidFill>
              </a:rPr>
              <a:t>one's</a:t>
            </a:r>
            <a:r>
              <a:rPr lang="en" sz="1500">
                <a:solidFill>
                  <a:schemeClr val="dk1"/>
                </a:solidFill>
              </a:rPr>
              <a:t> own biases</a:t>
            </a:r>
            <a:r>
              <a:rPr lang="en" sz="1500">
                <a:solidFill>
                  <a:schemeClr val="dk1"/>
                </a:solidFill>
              </a:rPr>
              <a:t> (e.g. </a:t>
            </a:r>
            <a:r>
              <a:rPr b="1" lang="en" sz="1500">
                <a:solidFill>
                  <a:schemeClr val="dk1"/>
                </a:solidFill>
              </a:rPr>
              <a:t>Myth of the Model Minority</a:t>
            </a:r>
            <a:r>
              <a:rPr lang="en" sz="1500">
                <a:solidFill>
                  <a:schemeClr val="dk1"/>
                </a:solidFill>
              </a:rPr>
              <a:t>)</a:t>
            </a:r>
            <a:endParaRPr sz="1500">
              <a:solidFill>
                <a:schemeClr val="dk1"/>
              </a:solidFill>
            </a:endParaRPr>
          </a:p>
          <a:p>
            <a:pPr indent="-323850" lvl="0" marL="457200" rtl="0" algn="l">
              <a:lnSpc>
                <a:spcPct val="115000"/>
              </a:lnSpc>
              <a:spcBef>
                <a:spcPts val="0"/>
              </a:spcBef>
              <a:spcAft>
                <a:spcPts val="0"/>
              </a:spcAft>
              <a:buClr>
                <a:schemeClr val="dk1"/>
              </a:buClr>
              <a:buSzPts val="1500"/>
              <a:buChar char="-"/>
            </a:pPr>
            <a:r>
              <a:rPr lang="en" sz="1500">
                <a:solidFill>
                  <a:schemeClr val="dk1"/>
                </a:solidFill>
              </a:rPr>
              <a:t>H</a:t>
            </a:r>
            <a:r>
              <a:rPr lang="en" sz="1500">
                <a:solidFill>
                  <a:schemeClr val="dk1"/>
                </a:solidFill>
              </a:rPr>
              <a:t>ow </a:t>
            </a:r>
            <a:r>
              <a:rPr b="1" lang="en" sz="1500">
                <a:solidFill>
                  <a:schemeClr val="dk1"/>
                </a:solidFill>
              </a:rPr>
              <a:t>historical and current racism</a:t>
            </a:r>
            <a:r>
              <a:rPr lang="en" sz="1500">
                <a:solidFill>
                  <a:schemeClr val="dk1"/>
                </a:solidFill>
              </a:rPr>
              <a:t> and oppression affect AANHPI patients</a:t>
            </a:r>
            <a:r>
              <a:rPr lang="en" sz="1500">
                <a:solidFill>
                  <a:schemeClr val="dk1"/>
                </a:solidFill>
              </a:rPr>
              <a:t> (e.g. US colonization, US policies </a:t>
            </a:r>
            <a:r>
              <a:rPr lang="en" sz="1500">
                <a:solidFill>
                  <a:schemeClr val="dk1"/>
                </a:solidFill>
              </a:rPr>
              <a:t>Japanese American internment, Chinese Exclusion Act, COVID-19 hate crimes)</a:t>
            </a:r>
            <a:endParaRPr sz="1500">
              <a:solidFill>
                <a:schemeClr val="dk1"/>
              </a:solidFill>
            </a:endParaRPr>
          </a:p>
          <a:p>
            <a:pPr indent="0" lvl="0" marL="1371600" rtl="0" algn="l">
              <a:lnSpc>
                <a:spcPct val="115000"/>
              </a:lnSpc>
              <a:spcBef>
                <a:spcPts val="0"/>
              </a:spcBef>
              <a:spcAft>
                <a:spcPts val="0"/>
              </a:spcAft>
              <a:buNone/>
            </a:pPr>
            <a:r>
              <a:t/>
            </a:r>
            <a:endParaRPr sz="1500">
              <a:solidFill>
                <a:schemeClr val="dk1"/>
              </a:solidFill>
            </a:endParaRPr>
          </a:p>
          <a:p>
            <a:pPr indent="0" lvl="0" marL="0" rtl="0" algn="l">
              <a:lnSpc>
                <a:spcPct val="115000"/>
              </a:lnSpc>
              <a:spcBef>
                <a:spcPts val="0"/>
              </a:spcBef>
              <a:spcAft>
                <a:spcPts val="0"/>
              </a:spcAft>
              <a:buNone/>
            </a:pPr>
            <a:r>
              <a:rPr lang="en" sz="1500">
                <a:solidFill>
                  <a:schemeClr val="dk1"/>
                </a:solidFill>
              </a:rPr>
              <a:t>Be knowledgeable and respectful of:</a:t>
            </a:r>
            <a:endParaRPr sz="1500">
              <a:solidFill>
                <a:schemeClr val="dk1"/>
              </a:solidFill>
            </a:endParaRPr>
          </a:p>
          <a:p>
            <a:pPr indent="-323850" lvl="0" marL="457200" rtl="0" algn="l">
              <a:lnSpc>
                <a:spcPct val="115000"/>
              </a:lnSpc>
              <a:spcBef>
                <a:spcPts val="0"/>
              </a:spcBef>
              <a:spcAft>
                <a:spcPts val="0"/>
              </a:spcAft>
              <a:buClr>
                <a:schemeClr val="dk1"/>
              </a:buClr>
              <a:buSzPts val="1500"/>
              <a:buChar char="-"/>
            </a:pPr>
            <a:r>
              <a:rPr b="1" lang="en" sz="1500">
                <a:solidFill>
                  <a:schemeClr val="dk1"/>
                </a:solidFill>
              </a:rPr>
              <a:t>Traditional practices</a:t>
            </a:r>
            <a:r>
              <a:rPr lang="en" sz="1500">
                <a:solidFill>
                  <a:schemeClr val="dk1"/>
                </a:solidFill>
              </a:rPr>
              <a:t> and cultural values</a:t>
            </a:r>
            <a:endParaRPr sz="1500">
              <a:solidFill>
                <a:schemeClr val="dk1"/>
              </a:solidFill>
            </a:endParaRPr>
          </a:p>
          <a:p>
            <a:pPr indent="-323850" lvl="0" marL="457200" rtl="0" algn="l">
              <a:lnSpc>
                <a:spcPct val="115000"/>
              </a:lnSpc>
              <a:spcBef>
                <a:spcPts val="0"/>
              </a:spcBef>
              <a:spcAft>
                <a:spcPts val="0"/>
              </a:spcAft>
              <a:buClr>
                <a:schemeClr val="dk1"/>
              </a:buClr>
              <a:buSzPts val="1500"/>
              <a:buChar char="-"/>
            </a:pPr>
            <a:r>
              <a:rPr lang="en" sz="1500">
                <a:solidFill>
                  <a:schemeClr val="dk1"/>
                </a:solidFill>
              </a:rPr>
              <a:t>Asian American/Pacific Islander indigenous practices</a:t>
            </a:r>
            <a:endParaRPr sz="1500">
              <a:solidFill>
                <a:schemeClr val="dk1"/>
              </a:solidFill>
            </a:endParaRPr>
          </a:p>
        </p:txBody>
      </p:sp>
      <p:sp>
        <p:nvSpPr>
          <p:cNvPr id="652" name="Google Shape;652;p47"/>
          <p:cNvSpPr txBox="1"/>
          <p:nvPr>
            <p:ph type="title"/>
          </p:nvPr>
        </p:nvSpPr>
        <p:spPr>
          <a:xfrm>
            <a:off x="360000" y="203925"/>
            <a:ext cx="842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100"/>
              <a:t>Considerations for Healthcare Providers</a:t>
            </a:r>
            <a:endParaRPr sz="3100"/>
          </a:p>
          <a:p>
            <a:pPr indent="0" lvl="0" marL="0" rtl="0" algn="l">
              <a:spcBef>
                <a:spcPts val="0"/>
              </a:spcBef>
              <a:spcAft>
                <a:spcPts val="0"/>
              </a:spcAft>
              <a:buNone/>
            </a:pPr>
            <a:r>
              <a:t/>
            </a:r>
            <a:endParaRPr sz="3100"/>
          </a:p>
        </p:txBody>
      </p:sp>
      <p:sp>
        <p:nvSpPr>
          <p:cNvPr id="653" name="Google Shape;653;p4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pic>
        <p:nvPicPr>
          <p:cNvPr descr="Man with Psychologist doctor online consultation. Psychotherapy practice, psychological help, psychiatrist consulting patient. (Provided by Getty Images)" id="654" name="Google Shape;654;p47"/>
          <p:cNvPicPr preferRelativeResize="0"/>
          <p:nvPr/>
        </p:nvPicPr>
        <p:blipFill rotWithShape="1">
          <a:blip r:embed="rId3">
            <a:alphaModFix/>
          </a:blip>
          <a:srcRect b="0" l="0" r="2248" t="0"/>
          <a:stretch/>
        </p:blipFill>
        <p:spPr>
          <a:xfrm>
            <a:off x="5429750" y="2722450"/>
            <a:ext cx="3042698" cy="2421049"/>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8" name="Shape 658"/>
        <p:cNvGrpSpPr/>
        <p:nvPr/>
      </p:nvGrpSpPr>
      <p:grpSpPr>
        <a:xfrm>
          <a:off x="0" y="0"/>
          <a:ext cx="0" cy="0"/>
          <a:chOff x="0" y="0"/>
          <a:chExt cx="0" cy="0"/>
        </a:xfrm>
      </p:grpSpPr>
      <p:sp>
        <p:nvSpPr>
          <p:cNvPr id="659" name="Google Shape;659;p48"/>
          <p:cNvSpPr txBox="1"/>
          <p:nvPr>
            <p:ph type="title"/>
          </p:nvPr>
        </p:nvSpPr>
        <p:spPr>
          <a:xfrm>
            <a:off x="360000" y="207450"/>
            <a:ext cx="842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onsiderations for Healthcare Providers</a:t>
            </a:r>
            <a:endParaRPr/>
          </a:p>
          <a:p>
            <a:pPr indent="0" lvl="0" marL="0" rtl="0" algn="l">
              <a:spcBef>
                <a:spcPts val="0"/>
              </a:spcBef>
              <a:spcAft>
                <a:spcPts val="0"/>
              </a:spcAft>
              <a:buNone/>
            </a:pPr>
            <a:r>
              <a:t/>
            </a:r>
            <a:endParaRPr/>
          </a:p>
        </p:txBody>
      </p:sp>
      <p:sp>
        <p:nvSpPr>
          <p:cNvPr id="660" name="Google Shape;660;p48"/>
          <p:cNvSpPr txBox="1"/>
          <p:nvPr>
            <p:ph idx="1" type="body"/>
          </p:nvPr>
        </p:nvSpPr>
        <p:spPr>
          <a:xfrm>
            <a:off x="404400" y="1418950"/>
            <a:ext cx="8625600" cy="3416400"/>
          </a:xfrm>
          <a:prstGeom prst="rect">
            <a:avLst/>
          </a:prstGeom>
        </p:spPr>
        <p:txBody>
          <a:bodyPr anchorCtr="0" anchor="t" bIns="91425" lIns="91425" spcFirstLastPara="1" rIns="91425" wrap="square" tIns="91425">
            <a:normAutofit lnSpcReduction="20000"/>
          </a:bodyPr>
          <a:lstStyle/>
          <a:p>
            <a:pPr indent="-317500" lvl="0" marL="457200" rtl="0" algn="l">
              <a:lnSpc>
                <a:spcPct val="115000"/>
              </a:lnSpc>
              <a:spcBef>
                <a:spcPts val="0"/>
              </a:spcBef>
              <a:spcAft>
                <a:spcPts val="0"/>
              </a:spcAft>
              <a:buClr>
                <a:schemeClr val="dk1"/>
              </a:buClr>
              <a:buSzPts val="1400"/>
              <a:buChar char="-"/>
            </a:pPr>
            <a:r>
              <a:rPr lang="en" sz="1400">
                <a:solidFill>
                  <a:schemeClr val="dk1"/>
                </a:solidFill>
              </a:rPr>
              <a:t>Be aware of </a:t>
            </a:r>
            <a:r>
              <a:rPr b="1" lang="en" sz="1400">
                <a:solidFill>
                  <a:schemeClr val="dk1"/>
                </a:solidFill>
              </a:rPr>
              <a:t>cultural beliefs related to psychological distress</a:t>
            </a:r>
            <a:r>
              <a:rPr lang="en" sz="1400">
                <a:solidFill>
                  <a:schemeClr val="dk1"/>
                </a:solidFill>
              </a:rPr>
              <a:t> and how it may </a:t>
            </a:r>
            <a:r>
              <a:rPr b="1" lang="en" sz="1400">
                <a:solidFill>
                  <a:schemeClr val="dk1"/>
                </a:solidFill>
              </a:rPr>
              <a:t>manifest differently</a:t>
            </a:r>
            <a:endParaRPr b="1" sz="1400">
              <a:solidFill>
                <a:schemeClr val="dk1"/>
              </a:solidFill>
            </a:endParaRPr>
          </a:p>
          <a:p>
            <a:pPr indent="-317500" lvl="1" marL="914400" rtl="0" algn="l">
              <a:lnSpc>
                <a:spcPct val="115000"/>
              </a:lnSpc>
              <a:spcBef>
                <a:spcPts val="0"/>
              </a:spcBef>
              <a:spcAft>
                <a:spcPts val="0"/>
              </a:spcAft>
              <a:buClr>
                <a:schemeClr val="dk1"/>
              </a:buClr>
              <a:buSzPts val="1400"/>
              <a:buChar char="○"/>
            </a:pPr>
            <a:r>
              <a:rPr lang="en">
                <a:solidFill>
                  <a:schemeClr val="dk1"/>
                </a:solidFill>
              </a:rPr>
              <a:t>Internalized and interpersonal stigma may hinder help-seeking</a:t>
            </a:r>
            <a:endParaRPr>
              <a:solidFill>
                <a:schemeClr val="dk1"/>
              </a:solidFill>
            </a:endParaRPr>
          </a:p>
          <a:p>
            <a:pPr indent="-317500" lvl="1" marL="914400" rtl="0" algn="l">
              <a:lnSpc>
                <a:spcPct val="115000"/>
              </a:lnSpc>
              <a:spcBef>
                <a:spcPts val="0"/>
              </a:spcBef>
              <a:spcAft>
                <a:spcPts val="0"/>
              </a:spcAft>
              <a:buClr>
                <a:schemeClr val="dk1"/>
              </a:buClr>
              <a:buSzPts val="1400"/>
              <a:buChar char="○"/>
            </a:pPr>
            <a:r>
              <a:rPr lang="en">
                <a:solidFill>
                  <a:schemeClr val="dk1"/>
                </a:solidFill>
              </a:rPr>
              <a:t>Physical and mental health are strongly related → Stress can present as somatic symptoms including body aches, insomnia, digestive problems</a:t>
            </a:r>
            <a:endParaRPr>
              <a:solidFill>
                <a:schemeClr val="dk1"/>
              </a:solidFill>
            </a:endParaRPr>
          </a:p>
          <a:p>
            <a:pPr indent="0" lvl="0" marL="0" rtl="0" algn="l">
              <a:lnSpc>
                <a:spcPct val="115000"/>
              </a:lnSpc>
              <a:spcBef>
                <a:spcPts val="0"/>
              </a:spcBef>
              <a:spcAft>
                <a:spcPts val="0"/>
              </a:spcAft>
              <a:buNone/>
            </a:pPr>
            <a:r>
              <a:t/>
            </a:r>
            <a:endParaRPr>
              <a:solidFill>
                <a:schemeClr val="dk1"/>
              </a:solidFill>
            </a:endParaRPr>
          </a:p>
          <a:p>
            <a:pPr indent="-317500" lvl="0" marL="457200" rtl="0" algn="l">
              <a:lnSpc>
                <a:spcPct val="115000"/>
              </a:lnSpc>
              <a:spcBef>
                <a:spcPts val="0"/>
              </a:spcBef>
              <a:spcAft>
                <a:spcPts val="0"/>
              </a:spcAft>
              <a:buClr>
                <a:schemeClr val="dk1"/>
              </a:buClr>
              <a:buSzPts val="1400"/>
              <a:buChar char="-"/>
            </a:pPr>
            <a:r>
              <a:rPr lang="en" sz="1400">
                <a:solidFill>
                  <a:schemeClr val="dk1"/>
                </a:solidFill>
              </a:rPr>
              <a:t>Be aware that the </a:t>
            </a:r>
            <a:r>
              <a:rPr b="1" lang="en" sz="1400">
                <a:solidFill>
                  <a:schemeClr val="dk1"/>
                </a:solidFill>
              </a:rPr>
              <a:t>experiences of AANHPI patients are immensely diverse </a:t>
            </a:r>
            <a:r>
              <a:rPr lang="en" sz="1400">
                <a:solidFill>
                  <a:schemeClr val="dk1"/>
                </a:solidFill>
              </a:rPr>
              <a:t>and one should not make assumptions about a patient’s experiences and adherence to cultural values and practices</a:t>
            </a:r>
            <a:endParaRPr sz="1400">
              <a:solidFill>
                <a:schemeClr val="dk1"/>
              </a:solidFill>
            </a:endParaRPr>
          </a:p>
          <a:p>
            <a:pPr indent="0" lvl="0" marL="457200" rtl="0" algn="l">
              <a:lnSpc>
                <a:spcPct val="115000"/>
              </a:lnSpc>
              <a:spcBef>
                <a:spcPts val="0"/>
              </a:spcBef>
              <a:spcAft>
                <a:spcPts val="0"/>
              </a:spcAft>
              <a:buNone/>
            </a:pPr>
            <a:r>
              <a:t/>
            </a:r>
            <a:endParaRPr sz="1400">
              <a:solidFill>
                <a:schemeClr val="dk1"/>
              </a:solidFill>
            </a:endParaRPr>
          </a:p>
          <a:p>
            <a:pPr indent="-317500" lvl="0" marL="457200" rtl="0" algn="l">
              <a:lnSpc>
                <a:spcPct val="115000"/>
              </a:lnSpc>
              <a:spcBef>
                <a:spcPts val="0"/>
              </a:spcBef>
              <a:spcAft>
                <a:spcPts val="0"/>
              </a:spcAft>
              <a:buClr>
                <a:schemeClr val="dk1"/>
              </a:buClr>
              <a:buSzPts val="1400"/>
              <a:buChar char="-"/>
            </a:pPr>
            <a:r>
              <a:rPr lang="en" sz="1400">
                <a:solidFill>
                  <a:schemeClr val="dk1"/>
                </a:solidFill>
              </a:rPr>
              <a:t>Develop </a:t>
            </a:r>
            <a:r>
              <a:rPr b="1" lang="en" sz="1400">
                <a:solidFill>
                  <a:schemeClr val="dk1"/>
                </a:solidFill>
              </a:rPr>
              <a:t>treatment plans that align with the explanatory models</a:t>
            </a:r>
            <a:r>
              <a:rPr lang="en" sz="1400">
                <a:solidFill>
                  <a:schemeClr val="dk1"/>
                </a:solidFill>
              </a:rPr>
              <a:t> of patients and be cognizant of the </a:t>
            </a:r>
            <a:r>
              <a:rPr b="1" lang="en" sz="1400">
                <a:solidFill>
                  <a:schemeClr val="dk1"/>
                </a:solidFill>
              </a:rPr>
              <a:t>environmental context of treatment options</a:t>
            </a:r>
            <a:r>
              <a:rPr lang="en" sz="1400">
                <a:solidFill>
                  <a:schemeClr val="dk1"/>
                </a:solidFill>
              </a:rPr>
              <a:t> (affordability, effect on family members)</a:t>
            </a:r>
            <a:endParaRPr sz="1400">
              <a:solidFill>
                <a:schemeClr val="dk1"/>
              </a:solidFill>
            </a:endParaRPr>
          </a:p>
          <a:p>
            <a:pPr indent="-317500" lvl="1" marL="914400" rtl="0" algn="l">
              <a:lnSpc>
                <a:spcPct val="115000"/>
              </a:lnSpc>
              <a:spcBef>
                <a:spcPts val="0"/>
              </a:spcBef>
              <a:spcAft>
                <a:spcPts val="0"/>
              </a:spcAft>
              <a:buClr>
                <a:schemeClr val="dk1"/>
              </a:buClr>
              <a:buSzPts val="1400"/>
              <a:buChar char="○"/>
            </a:pPr>
            <a:r>
              <a:rPr lang="en">
                <a:solidFill>
                  <a:schemeClr val="dk1"/>
                </a:solidFill>
              </a:rPr>
              <a:t>Concerns about adherence due to familial stigma</a:t>
            </a:r>
            <a:endParaRPr sz="1400">
              <a:solidFill>
                <a:schemeClr val="dk1"/>
              </a:solidFill>
            </a:endParaRPr>
          </a:p>
          <a:p>
            <a:pPr indent="0" lvl="0" marL="0" rtl="0" algn="l">
              <a:lnSpc>
                <a:spcPct val="115000"/>
              </a:lnSpc>
              <a:spcBef>
                <a:spcPts val="0"/>
              </a:spcBef>
              <a:spcAft>
                <a:spcPts val="0"/>
              </a:spcAft>
              <a:buNone/>
            </a:pPr>
            <a:r>
              <a:t/>
            </a:r>
            <a:endParaRPr>
              <a:solidFill>
                <a:schemeClr val="dk1"/>
              </a:solidFill>
            </a:endParaRPr>
          </a:p>
          <a:p>
            <a:pPr indent="0" lvl="0" marL="0" rtl="0" algn="l">
              <a:spcBef>
                <a:spcPts val="0"/>
              </a:spcBef>
              <a:spcAft>
                <a:spcPts val="1200"/>
              </a:spcAft>
              <a:buNone/>
            </a:pPr>
            <a:r>
              <a:t/>
            </a:r>
            <a:endParaRPr/>
          </a:p>
        </p:txBody>
      </p:sp>
      <p:sp>
        <p:nvSpPr>
          <p:cNvPr id="661" name="Google Shape;661;p4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3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65" name="Shape 665"/>
        <p:cNvGrpSpPr/>
        <p:nvPr/>
      </p:nvGrpSpPr>
      <p:grpSpPr>
        <a:xfrm>
          <a:off x="0" y="0"/>
          <a:ext cx="0" cy="0"/>
          <a:chOff x="0" y="0"/>
          <a:chExt cx="0" cy="0"/>
        </a:xfrm>
      </p:grpSpPr>
      <p:sp>
        <p:nvSpPr>
          <p:cNvPr id="666" name="Google Shape;666;p49"/>
          <p:cNvSpPr txBox="1"/>
          <p:nvPr>
            <p:ph type="title"/>
          </p:nvPr>
        </p:nvSpPr>
        <p:spPr>
          <a:xfrm>
            <a:off x="720000" y="1999050"/>
            <a:ext cx="77040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Part 5: Clinical Cases</a:t>
            </a:r>
            <a:endParaRPr/>
          </a:p>
        </p:txBody>
      </p:sp>
      <p:sp>
        <p:nvSpPr>
          <p:cNvPr id="667" name="Google Shape;667;p4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3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71" name="Shape 671"/>
        <p:cNvGrpSpPr/>
        <p:nvPr/>
      </p:nvGrpSpPr>
      <p:grpSpPr>
        <a:xfrm>
          <a:off x="0" y="0"/>
          <a:ext cx="0" cy="0"/>
          <a:chOff x="0" y="0"/>
          <a:chExt cx="0" cy="0"/>
        </a:xfrm>
      </p:grpSpPr>
      <p:sp>
        <p:nvSpPr>
          <p:cNvPr id="672" name="Google Shape;672;p50"/>
          <p:cNvSpPr txBox="1"/>
          <p:nvPr>
            <p:ph type="title"/>
          </p:nvPr>
        </p:nvSpPr>
        <p:spPr>
          <a:xfrm>
            <a:off x="211800" y="984675"/>
            <a:ext cx="8720400" cy="2445900"/>
          </a:xfrm>
          <a:prstGeom prst="rect">
            <a:avLst/>
          </a:prstGeom>
        </p:spPr>
        <p:txBody>
          <a:bodyPr anchorCtr="0" anchor="b" bIns="91425" lIns="91425" spcFirstLastPara="1" rIns="91425" wrap="square" tIns="91425">
            <a:normAutofit/>
          </a:bodyPr>
          <a:lstStyle/>
          <a:p>
            <a:pPr indent="0" lvl="0" marL="0" rtl="0" algn="l">
              <a:spcBef>
                <a:spcPts val="0"/>
              </a:spcBef>
              <a:spcAft>
                <a:spcPts val="0"/>
              </a:spcAft>
              <a:buNone/>
            </a:pPr>
            <a:r>
              <a:rPr lang="en" sz="4800"/>
              <a:t>Clinical Case:</a:t>
            </a:r>
            <a:endParaRPr sz="4800"/>
          </a:p>
          <a:p>
            <a:pPr indent="0" lvl="0" marL="0" rtl="0" algn="l">
              <a:spcBef>
                <a:spcPts val="0"/>
              </a:spcBef>
              <a:spcAft>
                <a:spcPts val="0"/>
              </a:spcAft>
              <a:buNone/>
            </a:pPr>
            <a:r>
              <a:rPr lang="en" sz="4800"/>
              <a:t>Leila</a:t>
            </a:r>
            <a:r>
              <a:rPr lang="en" sz="4800"/>
              <a:t>, 56y/o F</a:t>
            </a:r>
            <a:endParaRPr sz="4800"/>
          </a:p>
        </p:txBody>
      </p:sp>
      <p:sp>
        <p:nvSpPr>
          <p:cNvPr id="673" name="Google Shape;673;p5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
</file>

<file path=ppt/slides/slide3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77" name="Shape 677"/>
        <p:cNvGrpSpPr/>
        <p:nvPr/>
      </p:nvGrpSpPr>
      <p:grpSpPr>
        <a:xfrm>
          <a:off x="0" y="0"/>
          <a:ext cx="0" cy="0"/>
          <a:chOff x="0" y="0"/>
          <a:chExt cx="0" cy="0"/>
        </a:xfrm>
      </p:grpSpPr>
      <p:sp>
        <p:nvSpPr>
          <p:cNvPr id="678" name="Google Shape;678;p51"/>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Leila</a:t>
            </a:r>
            <a:endParaRPr/>
          </a:p>
        </p:txBody>
      </p:sp>
      <p:sp>
        <p:nvSpPr>
          <p:cNvPr id="679" name="Google Shape;679;p51"/>
          <p:cNvSpPr txBox="1"/>
          <p:nvPr>
            <p:ph idx="1" type="body"/>
          </p:nvPr>
        </p:nvSpPr>
        <p:spPr>
          <a:xfrm>
            <a:off x="311700" y="1152475"/>
            <a:ext cx="8520600" cy="3416400"/>
          </a:xfrm>
          <a:prstGeom prst="rect">
            <a:avLst/>
          </a:prstGeom>
        </p:spPr>
        <p:txBody>
          <a:bodyPr anchorCtr="0" anchor="t" bIns="91425" lIns="91425" spcFirstLastPara="1" rIns="91425" wrap="square" tIns="91425">
            <a:normAutofit lnSpcReduction="10000"/>
          </a:bodyPr>
          <a:lstStyle/>
          <a:p>
            <a:pPr indent="0" lvl="0" marL="0" rtl="0" algn="l">
              <a:spcBef>
                <a:spcPts val="0"/>
              </a:spcBef>
              <a:spcAft>
                <a:spcPts val="0"/>
              </a:spcAft>
              <a:buNone/>
            </a:pPr>
            <a:r>
              <a:rPr lang="en" sz="2400"/>
              <a:t>While you are on your </a:t>
            </a:r>
            <a:r>
              <a:rPr b="1" lang="en" sz="2400"/>
              <a:t>Obstetrics &amp; Gynecology</a:t>
            </a:r>
            <a:r>
              <a:rPr b="1" lang="en" sz="2400"/>
              <a:t> </a:t>
            </a:r>
            <a:r>
              <a:rPr lang="en" sz="2400"/>
              <a:t>rotation, you are assigned to a patient named </a:t>
            </a:r>
            <a:r>
              <a:rPr lang="en" sz="2400"/>
              <a:t>Leila</a:t>
            </a:r>
            <a:r>
              <a:rPr lang="en" sz="2400"/>
              <a:t> Singh</a:t>
            </a:r>
            <a:r>
              <a:rPr lang="en" sz="2400"/>
              <a:t>. She is a </a:t>
            </a:r>
            <a:r>
              <a:rPr b="1" lang="en" sz="2400"/>
              <a:t>56-year-old woman</a:t>
            </a:r>
            <a:r>
              <a:rPr lang="en" sz="2400"/>
              <a:t> who is presenting for a check up and describes </a:t>
            </a:r>
            <a:r>
              <a:rPr b="1" lang="en" sz="2400"/>
              <a:t>“feeling off” </a:t>
            </a:r>
            <a:r>
              <a:rPr lang="en" sz="2400"/>
              <a:t>recently.</a:t>
            </a:r>
            <a:endParaRPr sz="2400"/>
          </a:p>
          <a:p>
            <a:pPr indent="0" lvl="0" marL="0" rtl="0" algn="l">
              <a:spcBef>
                <a:spcPts val="1200"/>
              </a:spcBef>
              <a:spcAft>
                <a:spcPts val="0"/>
              </a:spcAft>
              <a:buNone/>
            </a:pPr>
            <a:r>
              <a:t/>
            </a:r>
            <a:endParaRPr sz="2400"/>
          </a:p>
          <a:p>
            <a:pPr indent="0" lvl="0" marL="0" rtl="0" algn="l">
              <a:spcBef>
                <a:spcPts val="1200"/>
              </a:spcBef>
              <a:spcAft>
                <a:spcPts val="0"/>
              </a:spcAft>
              <a:buNone/>
            </a:pPr>
            <a:r>
              <a:t/>
            </a:r>
            <a:endParaRPr sz="2400"/>
          </a:p>
          <a:p>
            <a:pPr indent="0" lvl="0" marL="0" rtl="0" algn="l">
              <a:spcBef>
                <a:spcPts val="1200"/>
              </a:spcBef>
              <a:spcAft>
                <a:spcPts val="1200"/>
              </a:spcAft>
              <a:buNone/>
            </a:pPr>
            <a:r>
              <a:t/>
            </a:r>
            <a:endParaRPr sz="2400"/>
          </a:p>
        </p:txBody>
      </p:sp>
      <p:sp>
        <p:nvSpPr>
          <p:cNvPr id="680" name="Google Shape;680;p5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pic>
        <p:nvPicPr>
          <p:cNvPr descr="Conversation of professional psychologist and patient in office, woman counseling girl (Provided by Getty Images)" id="681" name="Google Shape;681;p51"/>
          <p:cNvPicPr preferRelativeResize="0"/>
          <p:nvPr/>
        </p:nvPicPr>
        <p:blipFill>
          <a:blip r:embed="rId3">
            <a:alphaModFix/>
          </a:blip>
          <a:stretch>
            <a:fillRect/>
          </a:stretch>
        </p:blipFill>
        <p:spPr>
          <a:xfrm>
            <a:off x="4881375" y="2386957"/>
            <a:ext cx="3780823" cy="2521769"/>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85" name="Shape 685"/>
        <p:cNvGrpSpPr/>
        <p:nvPr/>
      </p:nvGrpSpPr>
      <p:grpSpPr>
        <a:xfrm>
          <a:off x="0" y="0"/>
          <a:ext cx="0" cy="0"/>
          <a:chOff x="0" y="0"/>
          <a:chExt cx="0" cy="0"/>
        </a:xfrm>
      </p:grpSpPr>
      <p:sp>
        <p:nvSpPr>
          <p:cNvPr id="686" name="Google Shape;686;p52"/>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What are some cultural considerations to keep in mind when interviewing Leila?</a:t>
            </a:r>
            <a:endParaRPr/>
          </a:p>
          <a:p>
            <a:pPr indent="0" lvl="0" marL="0" rtl="0" algn="l">
              <a:spcBef>
                <a:spcPts val="0"/>
              </a:spcBef>
              <a:spcAft>
                <a:spcPts val="0"/>
              </a:spcAft>
              <a:buNone/>
            </a:pPr>
            <a:r>
              <a:t/>
            </a:r>
            <a:endParaRPr/>
          </a:p>
        </p:txBody>
      </p:sp>
      <p:sp>
        <p:nvSpPr>
          <p:cNvPr id="687" name="Google Shape;687;p52"/>
          <p:cNvSpPr txBox="1"/>
          <p:nvPr>
            <p:ph idx="1" type="body"/>
          </p:nvPr>
        </p:nvSpPr>
        <p:spPr>
          <a:xfrm>
            <a:off x="720000" y="2109652"/>
            <a:ext cx="7704000" cy="3416400"/>
          </a:xfrm>
          <a:prstGeom prst="rect">
            <a:avLst/>
          </a:prstGeom>
        </p:spPr>
        <p:txBody>
          <a:bodyPr anchorCtr="0" anchor="t" bIns="91425" lIns="91425" spcFirstLastPara="1" rIns="91425" wrap="square" tIns="91425">
            <a:normAutofit/>
          </a:bodyPr>
          <a:lstStyle/>
          <a:p>
            <a:pPr indent="0" lvl="0" marL="0" rtl="0" algn="ctr">
              <a:lnSpc>
                <a:spcPct val="100000"/>
              </a:lnSpc>
              <a:spcBef>
                <a:spcPts val="0"/>
              </a:spcBef>
              <a:spcAft>
                <a:spcPts val="0"/>
              </a:spcAft>
              <a:buNone/>
            </a:pPr>
            <a:r>
              <a:rPr lang="en" sz="1800"/>
              <a:t>Family Dynamics </a:t>
            </a:r>
            <a:endParaRPr sz="1800"/>
          </a:p>
          <a:p>
            <a:pPr indent="0" lvl="0" marL="0" rtl="0" algn="ctr">
              <a:lnSpc>
                <a:spcPct val="100000"/>
              </a:lnSpc>
              <a:spcBef>
                <a:spcPts val="0"/>
              </a:spcBef>
              <a:spcAft>
                <a:spcPts val="0"/>
              </a:spcAft>
              <a:buNone/>
            </a:pPr>
            <a:r>
              <a:rPr lang="en" sz="1800"/>
              <a:t>Traditional Medicine</a:t>
            </a:r>
            <a:endParaRPr sz="1800"/>
          </a:p>
          <a:p>
            <a:pPr indent="0" lvl="0" marL="0" rtl="0" algn="ctr">
              <a:lnSpc>
                <a:spcPct val="100000"/>
              </a:lnSpc>
              <a:spcBef>
                <a:spcPts val="0"/>
              </a:spcBef>
              <a:spcAft>
                <a:spcPts val="0"/>
              </a:spcAft>
              <a:buNone/>
            </a:pPr>
            <a:r>
              <a:rPr lang="en" sz="1800"/>
              <a:t>Spirituality </a:t>
            </a:r>
            <a:endParaRPr sz="1800"/>
          </a:p>
          <a:p>
            <a:pPr indent="0" lvl="0" marL="0" rtl="0" algn="ctr">
              <a:lnSpc>
                <a:spcPct val="100000"/>
              </a:lnSpc>
              <a:spcBef>
                <a:spcPts val="0"/>
              </a:spcBef>
              <a:spcAft>
                <a:spcPts val="0"/>
              </a:spcAft>
              <a:buNone/>
            </a:pPr>
            <a:r>
              <a:rPr lang="en" sz="1800"/>
              <a:t>Work/Home duties </a:t>
            </a:r>
            <a:endParaRPr sz="1800"/>
          </a:p>
          <a:p>
            <a:pPr indent="0" lvl="0" marL="0" rtl="0" algn="ctr">
              <a:lnSpc>
                <a:spcPct val="100000"/>
              </a:lnSpc>
              <a:spcBef>
                <a:spcPts val="0"/>
              </a:spcBef>
              <a:spcAft>
                <a:spcPts val="0"/>
              </a:spcAft>
              <a:buNone/>
            </a:pPr>
            <a:r>
              <a:rPr lang="en" sz="1800"/>
              <a:t>Stigma</a:t>
            </a:r>
            <a:endParaRPr sz="1800"/>
          </a:p>
        </p:txBody>
      </p:sp>
      <p:sp>
        <p:nvSpPr>
          <p:cNvPr id="688" name="Google Shape;688;p5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687"/>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92" name="Shape 692"/>
        <p:cNvGrpSpPr/>
        <p:nvPr/>
      </p:nvGrpSpPr>
      <p:grpSpPr>
        <a:xfrm>
          <a:off x="0" y="0"/>
          <a:ext cx="0" cy="0"/>
          <a:chOff x="0" y="0"/>
          <a:chExt cx="0" cy="0"/>
        </a:xfrm>
      </p:grpSpPr>
      <p:sp>
        <p:nvSpPr>
          <p:cNvPr id="693" name="Google Shape;693;p53"/>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Leila</a:t>
            </a:r>
            <a:endParaRPr/>
          </a:p>
        </p:txBody>
      </p:sp>
      <p:sp>
        <p:nvSpPr>
          <p:cNvPr id="694" name="Google Shape;694;p53"/>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1200"/>
              </a:spcAft>
              <a:buNone/>
            </a:pPr>
            <a:r>
              <a:rPr lang="en" sz="1800"/>
              <a:t>Leila reports feeling </a:t>
            </a:r>
            <a:r>
              <a:rPr b="1" lang="en" sz="1800"/>
              <a:t>increasingly tired</a:t>
            </a:r>
            <a:r>
              <a:rPr lang="en" sz="1800"/>
              <a:t> and </a:t>
            </a:r>
            <a:r>
              <a:rPr b="1" lang="en" sz="1800"/>
              <a:t>lacking energy</a:t>
            </a:r>
            <a:r>
              <a:rPr lang="en" sz="1800"/>
              <a:t> for the past year. She describes </a:t>
            </a:r>
            <a:r>
              <a:rPr b="1" lang="en" sz="1800"/>
              <a:t>persistent headaches, body aches, and digestive issues </a:t>
            </a:r>
            <a:r>
              <a:rPr lang="en" sz="1800"/>
              <a:t>such as loss of appetite and occasional stomach discomfort. She also mentions feeling </a:t>
            </a:r>
            <a:r>
              <a:rPr b="1" lang="en" sz="1800"/>
              <a:t>"down" and less interested in social activities or hobbies she once enjoyed</a:t>
            </a:r>
            <a:r>
              <a:rPr lang="en" sz="1800"/>
              <a:t>. Leila initially attributed these symptoms to work stress and to her “menopause” but is now concerned as they have persisted for over a year despite trying to rest and manage her workload better.</a:t>
            </a:r>
            <a:endParaRPr/>
          </a:p>
        </p:txBody>
      </p:sp>
      <p:sp>
        <p:nvSpPr>
          <p:cNvPr id="695" name="Google Shape;695;p5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3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99" name="Shape 699"/>
        <p:cNvGrpSpPr/>
        <p:nvPr/>
      </p:nvGrpSpPr>
      <p:grpSpPr>
        <a:xfrm>
          <a:off x="0" y="0"/>
          <a:ext cx="0" cy="0"/>
          <a:chOff x="0" y="0"/>
          <a:chExt cx="0" cy="0"/>
        </a:xfrm>
      </p:grpSpPr>
      <p:sp>
        <p:nvSpPr>
          <p:cNvPr id="700" name="Google Shape;700;p54"/>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What would you want to get a better sense of next?</a:t>
            </a:r>
            <a:endParaRPr/>
          </a:p>
        </p:txBody>
      </p:sp>
      <p:sp>
        <p:nvSpPr>
          <p:cNvPr id="701" name="Google Shape;701;p54"/>
          <p:cNvSpPr txBox="1"/>
          <p:nvPr>
            <p:ph idx="1" type="body"/>
          </p:nvPr>
        </p:nvSpPr>
        <p:spPr>
          <a:xfrm>
            <a:off x="720000" y="1215750"/>
            <a:ext cx="18990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t/>
            </a:r>
            <a:endParaRPr b="1" sz="1800"/>
          </a:p>
          <a:p>
            <a:pPr indent="0" lvl="0" marL="0" rtl="0" algn="l">
              <a:spcBef>
                <a:spcPts val="1200"/>
              </a:spcBef>
              <a:spcAft>
                <a:spcPts val="0"/>
              </a:spcAft>
              <a:buNone/>
            </a:pPr>
            <a:r>
              <a:rPr b="1" lang="en" sz="1800"/>
              <a:t>Social History</a:t>
            </a:r>
            <a:endParaRPr b="1" sz="1800"/>
          </a:p>
          <a:p>
            <a:pPr indent="0" lvl="0" marL="0" rtl="0" algn="l">
              <a:spcBef>
                <a:spcPts val="1200"/>
              </a:spcBef>
              <a:spcAft>
                <a:spcPts val="0"/>
              </a:spcAft>
              <a:buNone/>
            </a:pPr>
            <a:r>
              <a:t/>
            </a:r>
            <a:endParaRPr b="1" sz="1800"/>
          </a:p>
          <a:p>
            <a:pPr indent="0" lvl="0" marL="0" rtl="0" algn="l">
              <a:spcBef>
                <a:spcPts val="1200"/>
              </a:spcBef>
              <a:spcAft>
                <a:spcPts val="1200"/>
              </a:spcAft>
              <a:buNone/>
            </a:pPr>
            <a:r>
              <a:t/>
            </a:r>
            <a:endParaRPr b="1" sz="1800"/>
          </a:p>
        </p:txBody>
      </p:sp>
      <p:sp>
        <p:nvSpPr>
          <p:cNvPr id="702" name="Google Shape;702;p5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703" name="Google Shape;703;p54"/>
          <p:cNvSpPr txBox="1"/>
          <p:nvPr>
            <p:ph idx="1" type="body"/>
          </p:nvPr>
        </p:nvSpPr>
        <p:spPr>
          <a:xfrm>
            <a:off x="818675" y="2260800"/>
            <a:ext cx="4729800" cy="2127600"/>
          </a:xfrm>
          <a:prstGeom prst="rect">
            <a:avLst/>
          </a:prstGeom>
          <a:ln cap="flat" cmpd="sng" w="19050">
            <a:solidFill>
              <a:schemeClr val="lt1"/>
            </a:solidFill>
            <a:prstDash val="dash"/>
            <a:round/>
            <a:headEnd len="sm" w="sm" type="none"/>
            <a:tailEnd len="sm" w="sm" type="none"/>
          </a:ln>
        </p:spPr>
        <p:txBody>
          <a:bodyPr anchorCtr="0" anchor="t" bIns="91425" lIns="91425" spcFirstLastPara="1" rIns="91425" wrap="square" tIns="91425">
            <a:normAutofit lnSpcReduction="10000"/>
          </a:bodyPr>
          <a:lstStyle/>
          <a:p>
            <a:pPr indent="0" lvl="0" marL="0" rtl="0" algn="l">
              <a:spcBef>
                <a:spcPts val="0"/>
              </a:spcBef>
              <a:spcAft>
                <a:spcPts val="0"/>
              </a:spcAft>
              <a:buNone/>
            </a:pPr>
            <a:r>
              <a:rPr lang="en" sz="1600"/>
              <a:t>What social determinants of health to keep in mind?:</a:t>
            </a:r>
            <a:endParaRPr sz="1600"/>
          </a:p>
          <a:p>
            <a:pPr indent="-330200" lvl="0" marL="457200" rtl="0" algn="l">
              <a:spcBef>
                <a:spcPts val="1200"/>
              </a:spcBef>
              <a:spcAft>
                <a:spcPts val="0"/>
              </a:spcAft>
              <a:buSzPts val="1600"/>
              <a:buChar char="●"/>
            </a:pPr>
            <a:r>
              <a:rPr lang="en" sz="1600"/>
              <a:t>Economic Stability</a:t>
            </a:r>
            <a:endParaRPr sz="1600"/>
          </a:p>
          <a:p>
            <a:pPr indent="-330200" lvl="0" marL="457200" rtl="0" algn="l">
              <a:spcBef>
                <a:spcPts val="0"/>
              </a:spcBef>
              <a:spcAft>
                <a:spcPts val="0"/>
              </a:spcAft>
              <a:buSzPts val="1600"/>
              <a:buChar char="●"/>
            </a:pPr>
            <a:r>
              <a:rPr lang="en" sz="1600"/>
              <a:t>Education Access and Quality</a:t>
            </a:r>
            <a:endParaRPr sz="1600"/>
          </a:p>
          <a:p>
            <a:pPr indent="-330200" lvl="0" marL="457200" rtl="0" algn="l">
              <a:spcBef>
                <a:spcPts val="0"/>
              </a:spcBef>
              <a:spcAft>
                <a:spcPts val="0"/>
              </a:spcAft>
              <a:buSzPts val="1600"/>
              <a:buChar char="●"/>
            </a:pPr>
            <a:r>
              <a:rPr lang="en" sz="1600"/>
              <a:t>Health Care Access and Quality</a:t>
            </a:r>
            <a:endParaRPr sz="1600"/>
          </a:p>
          <a:p>
            <a:pPr indent="-330200" lvl="0" marL="457200" rtl="0" algn="l">
              <a:spcBef>
                <a:spcPts val="0"/>
              </a:spcBef>
              <a:spcAft>
                <a:spcPts val="0"/>
              </a:spcAft>
              <a:buSzPts val="1600"/>
              <a:buChar char="●"/>
            </a:pPr>
            <a:r>
              <a:rPr lang="en" sz="1600"/>
              <a:t>Neighborhood and Built Environment</a:t>
            </a:r>
            <a:endParaRPr sz="1600"/>
          </a:p>
          <a:p>
            <a:pPr indent="-330200" lvl="0" marL="457200" rtl="0" algn="l">
              <a:spcBef>
                <a:spcPts val="0"/>
              </a:spcBef>
              <a:spcAft>
                <a:spcPts val="0"/>
              </a:spcAft>
              <a:buSzPts val="1600"/>
              <a:buChar char="●"/>
            </a:pPr>
            <a:r>
              <a:rPr lang="en" sz="1600"/>
              <a:t>Social and Community Context.</a:t>
            </a:r>
            <a:endParaRPr sz="1600"/>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701"/>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703"/>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07" name="Shape 707"/>
        <p:cNvGrpSpPr/>
        <p:nvPr/>
      </p:nvGrpSpPr>
      <p:grpSpPr>
        <a:xfrm>
          <a:off x="0" y="0"/>
          <a:ext cx="0" cy="0"/>
          <a:chOff x="0" y="0"/>
          <a:chExt cx="0" cy="0"/>
        </a:xfrm>
      </p:grpSpPr>
      <p:sp>
        <p:nvSpPr>
          <p:cNvPr id="708" name="Google Shape;708;p55"/>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Social History</a:t>
            </a:r>
            <a:endParaRPr/>
          </a:p>
        </p:txBody>
      </p:sp>
      <p:sp>
        <p:nvSpPr>
          <p:cNvPr id="709" name="Google Shape;709;p55"/>
          <p:cNvSpPr txBox="1"/>
          <p:nvPr>
            <p:ph idx="1" type="body"/>
          </p:nvPr>
        </p:nvSpPr>
        <p:spPr>
          <a:xfrm>
            <a:off x="311700" y="1152475"/>
            <a:ext cx="8520600" cy="3416400"/>
          </a:xfrm>
          <a:prstGeom prst="rect">
            <a:avLst/>
          </a:prstGeom>
        </p:spPr>
        <p:txBody>
          <a:bodyPr anchorCtr="0" anchor="t" bIns="91425" lIns="91425" spcFirstLastPara="1" rIns="91425" wrap="square" tIns="91425">
            <a:normAutofit lnSpcReduction="20000"/>
          </a:bodyPr>
          <a:lstStyle/>
          <a:p>
            <a:pPr indent="0" lvl="0" marL="0" rtl="0" algn="l">
              <a:spcBef>
                <a:spcPts val="0"/>
              </a:spcBef>
              <a:spcAft>
                <a:spcPts val="0"/>
              </a:spcAft>
              <a:buNone/>
            </a:pPr>
            <a:r>
              <a:rPr lang="en" sz="1800"/>
              <a:t>Leila currently lives with her </a:t>
            </a:r>
            <a:r>
              <a:rPr b="1" lang="en" sz="1800"/>
              <a:t>husband and her elderly parents</a:t>
            </a:r>
            <a:r>
              <a:rPr lang="en" sz="1800"/>
              <a:t>, who are very involved in her life. She has not brought up her feelings to them because she thinks they “</a:t>
            </a:r>
            <a:r>
              <a:rPr b="1" lang="en" sz="1800"/>
              <a:t>would not be happy.</a:t>
            </a:r>
            <a:r>
              <a:rPr lang="en" sz="1800"/>
              <a:t>”</a:t>
            </a:r>
            <a:endParaRPr sz="1800"/>
          </a:p>
          <a:p>
            <a:pPr indent="0" lvl="0" marL="0" rtl="0" algn="l">
              <a:spcBef>
                <a:spcPts val="1200"/>
              </a:spcBef>
              <a:spcAft>
                <a:spcPts val="0"/>
              </a:spcAft>
              <a:buNone/>
            </a:pPr>
            <a:r>
              <a:rPr lang="en" sz="1800"/>
              <a:t>As a practicing </a:t>
            </a:r>
            <a:r>
              <a:rPr b="1" lang="en" sz="1800"/>
              <a:t>Hindu</a:t>
            </a:r>
            <a:r>
              <a:rPr lang="en" sz="1800"/>
              <a:t>, Leila engages in daily </a:t>
            </a:r>
            <a:r>
              <a:rPr b="1" lang="en" sz="1800"/>
              <a:t>prayers and meditation</a:t>
            </a:r>
            <a:r>
              <a:rPr lang="en" sz="1800"/>
              <a:t>, which are integral to her routine and </a:t>
            </a:r>
            <a:r>
              <a:rPr b="1" lang="en" sz="1800"/>
              <a:t>coping mechanisms.</a:t>
            </a:r>
            <a:endParaRPr b="1" sz="1800"/>
          </a:p>
          <a:p>
            <a:pPr indent="0" lvl="0" marL="0" rtl="0" algn="l">
              <a:spcBef>
                <a:spcPts val="1200"/>
              </a:spcBef>
              <a:spcAft>
                <a:spcPts val="0"/>
              </a:spcAft>
              <a:buNone/>
            </a:pPr>
            <a:r>
              <a:rPr lang="en" sz="1800"/>
              <a:t>Leila balances a demanding </a:t>
            </a:r>
            <a:r>
              <a:rPr b="1" lang="en" sz="1800"/>
              <a:t>job</a:t>
            </a:r>
            <a:r>
              <a:rPr lang="en" sz="1800"/>
              <a:t> with </a:t>
            </a:r>
            <a:r>
              <a:rPr b="1" lang="en" sz="1800"/>
              <a:t>household responsibilities</a:t>
            </a:r>
            <a:r>
              <a:rPr lang="en" sz="1800"/>
              <a:t>, feeling pressure to perform well in both areas.</a:t>
            </a:r>
            <a:endParaRPr sz="1800"/>
          </a:p>
          <a:p>
            <a:pPr indent="0" lvl="0" marL="0" rtl="0" algn="l">
              <a:spcBef>
                <a:spcPts val="1200"/>
              </a:spcBef>
              <a:spcAft>
                <a:spcPts val="0"/>
              </a:spcAft>
              <a:buNone/>
            </a:pPr>
            <a:r>
              <a:rPr lang="en" sz="1800"/>
              <a:t>When you mention </a:t>
            </a:r>
            <a:r>
              <a:rPr b="1" lang="en" sz="1800"/>
              <a:t>depression</a:t>
            </a:r>
            <a:r>
              <a:rPr lang="en" sz="1800"/>
              <a:t>, Leila becomes </a:t>
            </a:r>
            <a:r>
              <a:rPr b="1" lang="en" sz="1800"/>
              <a:t>nervous and apprehensive</a:t>
            </a:r>
            <a:r>
              <a:rPr lang="en" sz="1800"/>
              <a:t>. </a:t>
            </a:r>
            <a:br>
              <a:rPr lang="en" sz="1800"/>
            </a:br>
            <a:endParaRPr sz="1800"/>
          </a:p>
          <a:p>
            <a:pPr indent="0" lvl="0" marL="0" rtl="0" algn="l">
              <a:spcBef>
                <a:spcPts val="0"/>
              </a:spcBef>
              <a:spcAft>
                <a:spcPts val="0"/>
              </a:spcAft>
              <a:buNone/>
            </a:pPr>
            <a:r>
              <a:rPr b="1" lang="en" sz="2000"/>
              <a:t>What would you say next?</a:t>
            </a:r>
            <a:endParaRPr b="1" sz="2000"/>
          </a:p>
        </p:txBody>
      </p:sp>
      <p:sp>
        <p:nvSpPr>
          <p:cNvPr id="710" name="Google Shape;710;p5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3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14" name="Shape 714"/>
        <p:cNvGrpSpPr/>
        <p:nvPr/>
      </p:nvGrpSpPr>
      <p:grpSpPr>
        <a:xfrm>
          <a:off x="0" y="0"/>
          <a:ext cx="0" cy="0"/>
          <a:chOff x="0" y="0"/>
          <a:chExt cx="0" cy="0"/>
        </a:xfrm>
      </p:grpSpPr>
      <p:sp>
        <p:nvSpPr>
          <p:cNvPr id="715" name="Google Shape;715;p56"/>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Resolution</a:t>
            </a:r>
            <a:endParaRPr/>
          </a:p>
        </p:txBody>
      </p:sp>
      <p:sp>
        <p:nvSpPr>
          <p:cNvPr id="716" name="Google Shape;716;p56"/>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1200"/>
              </a:spcAft>
              <a:buNone/>
            </a:pPr>
            <a:r>
              <a:rPr lang="en" sz="1800"/>
              <a:t>After having a thoughtful and respectful </a:t>
            </a:r>
            <a:r>
              <a:rPr b="1" lang="en" sz="1800"/>
              <a:t>conversation</a:t>
            </a:r>
            <a:r>
              <a:rPr lang="en" sz="1800"/>
              <a:t> about depression with Leila, she begins to open up to the possibility about having a </a:t>
            </a:r>
            <a:r>
              <a:rPr b="1" lang="en" sz="1800"/>
              <a:t>conversation</a:t>
            </a:r>
            <a:r>
              <a:rPr lang="en" sz="1800"/>
              <a:t> with her husband and family regarding </a:t>
            </a:r>
            <a:r>
              <a:rPr b="1" lang="en" sz="1800"/>
              <a:t>social </a:t>
            </a:r>
            <a:r>
              <a:rPr b="1" lang="en" sz="1800"/>
              <a:t>supports</a:t>
            </a:r>
            <a:r>
              <a:rPr lang="en" sz="1800"/>
              <a:t> and </a:t>
            </a:r>
            <a:r>
              <a:rPr b="1" lang="en" sz="1800"/>
              <a:t>balancing</a:t>
            </a:r>
            <a:r>
              <a:rPr lang="en" sz="1800"/>
              <a:t> her work and home life. </a:t>
            </a:r>
            <a:endParaRPr sz="1800"/>
          </a:p>
        </p:txBody>
      </p:sp>
      <p:sp>
        <p:nvSpPr>
          <p:cNvPr id="717" name="Google Shape;717;p5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8" name="Shape 248"/>
        <p:cNvGrpSpPr/>
        <p:nvPr/>
      </p:nvGrpSpPr>
      <p:grpSpPr>
        <a:xfrm>
          <a:off x="0" y="0"/>
          <a:ext cx="0" cy="0"/>
          <a:chOff x="0" y="0"/>
          <a:chExt cx="0" cy="0"/>
        </a:xfrm>
      </p:grpSpPr>
      <p:sp>
        <p:nvSpPr>
          <p:cNvPr id="249" name="Google Shape;249;p21"/>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Reflection</a:t>
            </a:r>
            <a:endParaRPr/>
          </a:p>
        </p:txBody>
      </p:sp>
      <p:sp>
        <p:nvSpPr>
          <p:cNvPr id="250" name="Google Shape;250;p21"/>
          <p:cNvSpPr txBox="1"/>
          <p:nvPr>
            <p:ph idx="1" type="body"/>
          </p:nvPr>
        </p:nvSpPr>
        <p:spPr>
          <a:xfrm>
            <a:off x="2360250" y="1977000"/>
            <a:ext cx="4423500" cy="1189500"/>
          </a:xfrm>
          <a:prstGeom prst="rect">
            <a:avLst/>
          </a:prstGeom>
        </p:spPr>
        <p:txBody>
          <a:bodyPr anchorCtr="0" anchor="t" bIns="91425" lIns="91425" spcFirstLastPara="1" rIns="91425" wrap="square" tIns="91425">
            <a:normAutofit fontScale="92500" lnSpcReduction="20000"/>
          </a:bodyPr>
          <a:lstStyle/>
          <a:p>
            <a:pPr indent="0" lvl="0" marL="0" rtl="0" algn="ctr">
              <a:spcBef>
                <a:spcPts val="0"/>
              </a:spcBef>
              <a:spcAft>
                <a:spcPts val="1200"/>
              </a:spcAft>
              <a:buNone/>
            </a:pPr>
            <a:r>
              <a:rPr b="1" lang="en" sz="3600"/>
              <a:t>What does mental health mean to you?</a:t>
            </a:r>
            <a:endParaRPr b="1" sz="3600"/>
          </a:p>
        </p:txBody>
      </p:sp>
      <p:sp>
        <p:nvSpPr>
          <p:cNvPr id="251" name="Google Shape;251;p2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21" name="Shape 721"/>
        <p:cNvGrpSpPr/>
        <p:nvPr/>
      </p:nvGrpSpPr>
      <p:grpSpPr>
        <a:xfrm>
          <a:off x="0" y="0"/>
          <a:ext cx="0" cy="0"/>
          <a:chOff x="0" y="0"/>
          <a:chExt cx="0" cy="0"/>
        </a:xfrm>
      </p:grpSpPr>
      <p:sp>
        <p:nvSpPr>
          <p:cNvPr id="722" name="Google Shape;722;p57"/>
          <p:cNvSpPr txBox="1"/>
          <p:nvPr>
            <p:ph type="title"/>
          </p:nvPr>
        </p:nvSpPr>
        <p:spPr>
          <a:xfrm>
            <a:off x="289300" y="624325"/>
            <a:ext cx="8114400" cy="2445900"/>
          </a:xfrm>
          <a:prstGeom prst="rect">
            <a:avLst/>
          </a:prstGeom>
        </p:spPr>
        <p:txBody>
          <a:bodyPr anchorCtr="0" anchor="b" bIns="91425" lIns="91425" spcFirstLastPara="1" rIns="91425" wrap="square" tIns="91425">
            <a:normAutofit/>
          </a:bodyPr>
          <a:lstStyle/>
          <a:p>
            <a:pPr indent="0" lvl="0" marL="0" rtl="0" algn="l">
              <a:spcBef>
                <a:spcPts val="0"/>
              </a:spcBef>
              <a:spcAft>
                <a:spcPts val="0"/>
              </a:spcAft>
              <a:buNone/>
            </a:pPr>
            <a:r>
              <a:rPr lang="en" sz="4000"/>
              <a:t>Case Study: Michael, 25 y/o M</a:t>
            </a:r>
            <a:endParaRPr sz="4000"/>
          </a:p>
        </p:txBody>
      </p:sp>
      <p:sp>
        <p:nvSpPr>
          <p:cNvPr id="723" name="Google Shape;723;p5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27" name="Shape 727"/>
        <p:cNvGrpSpPr/>
        <p:nvPr/>
      </p:nvGrpSpPr>
      <p:grpSpPr>
        <a:xfrm>
          <a:off x="0" y="0"/>
          <a:ext cx="0" cy="0"/>
          <a:chOff x="0" y="0"/>
          <a:chExt cx="0" cy="0"/>
        </a:xfrm>
      </p:grpSpPr>
      <p:sp>
        <p:nvSpPr>
          <p:cNvPr id="728" name="Google Shape;728;p58"/>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Michael</a:t>
            </a:r>
            <a:endParaRPr/>
          </a:p>
        </p:txBody>
      </p:sp>
      <p:sp>
        <p:nvSpPr>
          <p:cNvPr id="729" name="Google Shape;729;p58"/>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800"/>
              <a:t>While on your psych rotation, you are asked to interview a 25-year-old patient, Michael Chen, who was </a:t>
            </a:r>
            <a:r>
              <a:rPr b="1" lang="en" sz="1800"/>
              <a:t>brought in by law enforcement </a:t>
            </a:r>
            <a:r>
              <a:rPr lang="en" sz="1800"/>
              <a:t>after he was found wandering at night and </a:t>
            </a:r>
            <a:r>
              <a:rPr b="1" lang="en" sz="1800"/>
              <a:t>shouting “leave me alone!” to no discernible persons. </a:t>
            </a:r>
            <a:endParaRPr b="1" sz="1800"/>
          </a:p>
          <a:p>
            <a:pPr indent="0" lvl="0" marL="0" rtl="0" algn="l">
              <a:spcBef>
                <a:spcPts val="1200"/>
              </a:spcBef>
              <a:spcAft>
                <a:spcPts val="1200"/>
              </a:spcAft>
              <a:buNone/>
            </a:pPr>
            <a:r>
              <a:rPr lang="en" sz="1800"/>
              <a:t>Michael </a:t>
            </a:r>
            <a:r>
              <a:rPr b="1" lang="en" sz="1800"/>
              <a:t>moved to the U.S. from Hunan province in China </a:t>
            </a:r>
            <a:r>
              <a:rPr lang="en" sz="1800"/>
              <a:t>when he was five years old and was </a:t>
            </a:r>
            <a:r>
              <a:rPr b="1" lang="en" sz="1800"/>
              <a:t>diagnosed with schizophrenia two years ago</a:t>
            </a:r>
            <a:r>
              <a:rPr lang="en" sz="1800"/>
              <a:t>. He reports hearing voices in the walls threatening him, which caused him to run away from home. Michael </a:t>
            </a:r>
            <a:r>
              <a:rPr b="1" lang="en" sz="1800"/>
              <a:t>lives with his parents </a:t>
            </a:r>
            <a:r>
              <a:rPr lang="en" sz="1800"/>
              <a:t>and describes having very few friends. He is </a:t>
            </a:r>
            <a:r>
              <a:rPr b="1" lang="en" sz="1800"/>
              <a:t>interested in learning about medications</a:t>
            </a:r>
            <a:r>
              <a:rPr lang="en" sz="1800"/>
              <a:t> that might help his symptoms.</a:t>
            </a:r>
            <a:endParaRPr sz="1800"/>
          </a:p>
        </p:txBody>
      </p:sp>
      <p:sp>
        <p:nvSpPr>
          <p:cNvPr id="730" name="Google Shape;730;p5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34" name="Shape 734"/>
        <p:cNvGrpSpPr/>
        <p:nvPr/>
      </p:nvGrpSpPr>
      <p:grpSpPr>
        <a:xfrm>
          <a:off x="0" y="0"/>
          <a:ext cx="0" cy="0"/>
          <a:chOff x="0" y="0"/>
          <a:chExt cx="0" cy="0"/>
        </a:xfrm>
      </p:grpSpPr>
      <p:sp>
        <p:nvSpPr>
          <p:cNvPr id="735" name="Google Shape;735;p59"/>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Michael</a:t>
            </a:r>
            <a:endParaRPr/>
          </a:p>
        </p:txBody>
      </p:sp>
      <p:sp>
        <p:nvSpPr>
          <p:cNvPr id="736" name="Google Shape;736;p59"/>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1200"/>
              </a:spcAft>
              <a:buNone/>
            </a:pPr>
            <a:r>
              <a:rPr lang="en" sz="1800"/>
              <a:t>What are some </a:t>
            </a:r>
            <a:r>
              <a:rPr b="1" lang="en" sz="1800"/>
              <a:t>cultural considerations </a:t>
            </a:r>
            <a:r>
              <a:rPr lang="en" sz="1800"/>
              <a:t>to keep in mind when treating a Chinese patient with schizophrenia?  </a:t>
            </a:r>
            <a:endParaRPr sz="1800"/>
          </a:p>
        </p:txBody>
      </p:sp>
      <p:sp>
        <p:nvSpPr>
          <p:cNvPr id="737" name="Google Shape;737;p5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pic>
        <p:nvPicPr>
          <p:cNvPr descr="Mental health care concept. Vector flat people character illustration. Man patient lying on sofa and woman therapist meeting in psychotherapy office room. Psychological therapy and psychiatry. (Provided by Getty Images)" id="738" name="Google Shape;738;p59"/>
          <p:cNvPicPr preferRelativeResize="0"/>
          <p:nvPr/>
        </p:nvPicPr>
        <p:blipFill rotWithShape="1">
          <a:blip r:embed="rId3">
            <a:alphaModFix/>
          </a:blip>
          <a:srcRect b="0" l="0" r="10153" t="0"/>
          <a:stretch/>
        </p:blipFill>
        <p:spPr>
          <a:xfrm>
            <a:off x="4088764" y="1640425"/>
            <a:ext cx="4383688" cy="3416401"/>
          </a:xfrm>
          <a:prstGeom prst="rect">
            <a:avLst/>
          </a:prstGeom>
          <a:noFill/>
          <a:ln>
            <a:noFill/>
          </a:ln>
        </p:spPr>
      </p:pic>
    </p:spTree>
  </p:cSld>
  <p:clrMapOvr>
    <a:masterClrMapping/>
  </p:clrMapOvr>
</p:sld>
</file>

<file path=ppt/slides/slide4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42" name="Shape 742"/>
        <p:cNvGrpSpPr/>
        <p:nvPr/>
      </p:nvGrpSpPr>
      <p:grpSpPr>
        <a:xfrm>
          <a:off x="0" y="0"/>
          <a:ext cx="0" cy="0"/>
          <a:chOff x="0" y="0"/>
          <a:chExt cx="0" cy="0"/>
        </a:xfrm>
      </p:grpSpPr>
      <p:sp>
        <p:nvSpPr>
          <p:cNvPr id="743" name="Google Shape;743;p60"/>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Michael</a:t>
            </a:r>
            <a:endParaRPr/>
          </a:p>
        </p:txBody>
      </p:sp>
      <p:sp>
        <p:nvSpPr>
          <p:cNvPr id="744" name="Google Shape;744;p60"/>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800"/>
              <a:t>Michael</a:t>
            </a:r>
            <a:r>
              <a:rPr lang="en" sz="1800"/>
              <a:t>’s parents arrive in the ED, and you can see both </a:t>
            </a:r>
            <a:r>
              <a:rPr b="1" lang="en" sz="1800"/>
              <a:t>his mother and father appear irritated</a:t>
            </a:r>
            <a:r>
              <a:rPr lang="en" sz="1800"/>
              <a:t>. When you ask them what they know about </a:t>
            </a:r>
            <a:r>
              <a:rPr lang="en" sz="1800"/>
              <a:t>Michael</a:t>
            </a:r>
            <a:r>
              <a:rPr lang="en" sz="1800"/>
              <a:t>’s condition, his mother responds that he has a</a:t>
            </a:r>
            <a:r>
              <a:rPr b="1" lang="en" sz="1800"/>
              <a:t> “personality problem”</a:t>
            </a:r>
            <a:r>
              <a:rPr lang="en" sz="1800"/>
              <a:t> that they are managing as a family.</a:t>
            </a:r>
            <a:endParaRPr sz="1800"/>
          </a:p>
          <a:p>
            <a:pPr indent="0" lvl="0" marL="0" rtl="0" algn="l">
              <a:spcBef>
                <a:spcPts val="1200"/>
              </a:spcBef>
              <a:spcAft>
                <a:spcPts val="0"/>
              </a:spcAft>
              <a:buNone/>
            </a:pPr>
            <a:r>
              <a:t/>
            </a:r>
            <a:endParaRPr b="1" sz="1800"/>
          </a:p>
          <a:p>
            <a:pPr indent="0" lvl="0" marL="0" rtl="0" algn="l">
              <a:spcBef>
                <a:spcPts val="1200"/>
              </a:spcBef>
              <a:spcAft>
                <a:spcPts val="1200"/>
              </a:spcAft>
              <a:buNone/>
            </a:pPr>
            <a:r>
              <a:rPr b="1" lang="en" sz="1800"/>
              <a:t>What would you say next?</a:t>
            </a:r>
            <a:endParaRPr b="1" sz="1800"/>
          </a:p>
        </p:txBody>
      </p:sp>
      <p:sp>
        <p:nvSpPr>
          <p:cNvPr id="745" name="Google Shape;745;p6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49" name="Shape 749"/>
        <p:cNvGrpSpPr/>
        <p:nvPr/>
      </p:nvGrpSpPr>
      <p:grpSpPr>
        <a:xfrm>
          <a:off x="0" y="0"/>
          <a:ext cx="0" cy="0"/>
          <a:chOff x="0" y="0"/>
          <a:chExt cx="0" cy="0"/>
        </a:xfrm>
      </p:grpSpPr>
      <p:sp>
        <p:nvSpPr>
          <p:cNvPr id="750" name="Google Shape;750;p61"/>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Michael</a:t>
            </a:r>
            <a:endParaRPr/>
          </a:p>
        </p:txBody>
      </p:sp>
      <p:sp>
        <p:nvSpPr>
          <p:cNvPr id="751" name="Google Shape;751;p61"/>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800"/>
              <a:t>After asking questions to understand more about their beliefs, Michael’s father inquires why you think he has a </a:t>
            </a:r>
            <a:r>
              <a:rPr b="1" lang="en" sz="1800"/>
              <a:t>"personality problem." </a:t>
            </a:r>
            <a:r>
              <a:rPr lang="en" sz="1800"/>
              <a:t>You explain that researchers have identified </a:t>
            </a:r>
            <a:r>
              <a:rPr b="1" lang="en" sz="1800"/>
              <a:t>biological pathways that may cause schizophrenia </a:t>
            </a:r>
            <a:r>
              <a:rPr lang="en" sz="1800"/>
              <a:t>and reassure them that Michael’s condition is not his fault. You mention that there are </a:t>
            </a:r>
            <a:r>
              <a:rPr b="1" lang="en" sz="1800"/>
              <a:t>medications</a:t>
            </a:r>
            <a:r>
              <a:rPr lang="en" sz="1800"/>
              <a:t> that could help alleviate Michael’s symptoms and that </a:t>
            </a:r>
            <a:r>
              <a:rPr b="1" lang="en" sz="1800"/>
              <a:t>Michael is interested in trying them. </a:t>
            </a:r>
            <a:endParaRPr b="1" sz="1800"/>
          </a:p>
          <a:p>
            <a:pPr indent="0" lvl="0" marL="0" rtl="0" algn="l">
              <a:spcBef>
                <a:spcPts val="1200"/>
              </a:spcBef>
              <a:spcAft>
                <a:spcPts val="0"/>
              </a:spcAft>
              <a:buNone/>
            </a:pPr>
            <a:r>
              <a:rPr lang="en" sz="1800"/>
              <a:t>Michael’s </a:t>
            </a:r>
            <a:r>
              <a:rPr b="1" lang="en" sz="1800"/>
              <a:t>parents strongly decline</a:t>
            </a:r>
            <a:r>
              <a:rPr lang="en" sz="1800"/>
              <a:t> any treatment, stating they would like to take Michael home now. </a:t>
            </a:r>
            <a:endParaRPr b="1" sz="1800"/>
          </a:p>
          <a:p>
            <a:pPr indent="0" lvl="0" marL="0" rtl="0" algn="l">
              <a:spcBef>
                <a:spcPts val="1200"/>
              </a:spcBef>
              <a:spcAft>
                <a:spcPts val="1200"/>
              </a:spcAft>
              <a:buNone/>
            </a:pPr>
            <a:r>
              <a:rPr b="1" lang="en" sz="1800"/>
              <a:t>What could you do next?</a:t>
            </a:r>
            <a:endParaRPr b="1" sz="1800"/>
          </a:p>
        </p:txBody>
      </p:sp>
      <p:sp>
        <p:nvSpPr>
          <p:cNvPr id="752" name="Google Shape;752;p6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56" name="Shape 756"/>
        <p:cNvGrpSpPr/>
        <p:nvPr/>
      </p:nvGrpSpPr>
      <p:grpSpPr>
        <a:xfrm>
          <a:off x="0" y="0"/>
          <a:ext cx="0" cy="0"/>
          <a:chOff x="0" y="0"/>
          <a:chExt cx="0" cy="0"/>
        </a:xfrm>
      </p:grpSpPr>
      <p:sp>
        <p:nvSpPr>
          <p:cNvPr id="757" name="Google Shape;757;p62"/>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Clinical Case: </a:t>
            </a:r>
            <a:r>
              <a:rPr lang="en"/>
              <a:t>Michael</a:t>
            </a:r>
            <a:endParaRPr/>
          </a:p>
        </p:txBody>
      </p:sp>
      <p:sp>
        <p:nvSpPr>
          <p:cNvPr id="758" name="Google Shape;758;p62"/>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1800"/>
              <a:t>After having a </a:t>
            </a:r>
            <a:r>
              <a:rPr b="1" lang="en" sz="1800"/>
              <a:t>thoughtful and respectful conversation </a:t>
            </a:r>
            <a:r>
              <a:rPr lang="en" sz="1800"/>
              <a:t>ab</a:t>
            </a:r>
            <a:r>
              <a:rPr lang="en" sz="1800"/>
              <a:t>out schizophrenia and how the medication may help, </a:t>
            </a:r>
            <a:r>
              <a:rPr lang="en" sz="1800"/>
              <a:t>Michael</a:t>
            </a:r>
            <a:r>
              <a:rPr lang="en" sz="1800"/>
              <a:t>’s parents are still slightly skeptical, but</a:t>
            </a:r>
            <a:r>
              <a:rPr b="1" lang="en" sz="1800"/>
              <a:t> willing to let </a:t>
            </a:r>
            <a:r>
              <a:rPr b="1" lang="en" sz="1800"/>
              <a:t>Michael</a:t>
            </a:r>
            <a:r>
              <a:rPr b="1" lang="en" sz="1800"/>
              <a:t> try </a:t>
            </a:r>
            <a:r>
              <a:rPr b="1" lang="en" sz="1800"/>
              <a:t>medication</a:t>
            </a:r>
            <a:r>
              <a:rPr b="1" lang="en" sz="1800"/>
              <a:t>.</a:t>
            </a:r>
            <a:endParaRPr b="1" sz="1800"/>
          </a:p>
          <a:p>
            <a:pPr indent="0" lvl="0" marL="0" rtl="0" algn="l">
              <a:spcBef>
                <a:spcPts val="1200"/>
              </a:spcBef>
              <a:spcAft>
                <a:spcPts val="1200"/>
              </a:spcAft>
              <a:buNone/>
            </a:pPr>
            <a:r>
              <a:rPr lang="en" sz="1800"/>
              <a:t>The medical team starts </a:t>
            </a:r>
            <a:r>
              <a:rPr lang="en" sz="1800"/>
              <a:t>Michael</a:t>
            </a:r>
            <a:r>
              <a:rPr lang="en" sz="1800"/>
              <a:t> on </a:t>
            </a:r>
            <a:r>
              <a:rPr b="1" lang="en" sz="1800"/>
              <a:t>risperidone</a:t>
            </a:r>
            <a:r>
              <a:rPr lang="en" sz="1800"/>
              <a:t>, and he begins to see some </a:t>
            </a:r>
            <a:r>
              <a:rPr b="1" lang="en" sz="1800"/>
              <a:t>improvement of symptoms </a:t>
            </a:r>
            <a:r>
              <a:rPr lang="en" sz="1800"/>
              <a:t>at his follow up 6 weeks later. Great job!</a:t>
            </a:r>
            <a:endParaRPr sz="1800"/>
          </a:p>
        </p:txBody>
      </p:sp>
      <p:sp>
        <p:nvSpPr>
          <p:cNvPr id="759" name="Google Shape;759;p6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63" name="Shape 763"/>
        <p:cNvGrpSpPr/>
        <p:nvPr/>
      </p:nvGrpSpPr>
      <p:grpSpPr>
        <a:xfrm>
          <a:off x="0" y="0"/>
          <a:ext cx="0" cy="0"/>
          <a:chOff x="0" y="0"/>
          <a:chExt cx="0" cy="0"/>
        </a:xfrm>
      </p:grpSpPr>
      <p:sp>
        <p:nvSpPr>
          <p:cNvPr id="764" name="Google Shape;764;p63"/>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Takeaways</a:t>
            </a:r>
            <a:endParaRPr/>
          </a:p>
        </p:txBody>
      </p:sp>
      <p:sp>
        <p:nvSpPr>
          <p:cNvPr id="765" name="Google Shape;765;p63"/>
          <p:cNvSpPr txBox="1"/>
          <p:nvPr>
            <p:ph idx="1" type="body"/>
          </p:nvPr>
        </p:nvSpPr>
        <p:spPr>
          <a:xfrm>
            <a:off x="720000" y="1215750"/>
            <a:ext cx="6221700" cy="3416400"/>
          </a:xfrm>
          <a:prstGeom prst="rect">
            <a:avLst/>
          </a:prstGeom>
        </p:spPr>
        <p:txBody>
          <a:bodyPr anchorCtr="0" anchor="t" bIns="91425" lIns="91425" spcFirstLastPara="1" rIns="91425" wrap="square" tIns="91425">
            <a:normAutofit lnSpcReduction="20000"/>
          </a:bodyPr>
          <a:lstStyle/>
          <a:p>
            <a:pPr indent="-336550" lvl="0" marL="457200" rtl="0" algn="l">
              <a:spcBef>
                <a:spcPts val="0"/>
              </a:spcBef>
              <a:spcAft>
                <a:spcPts val="0"/>
              </a:spcAft>
              <a:buSzPts val="1700"/>
              <a:buChar char="●"/>
            </a:pPr>
            <a:r>
              <a:rPr b="1" lang="en" sz="1700"/>
              <a:t>Diversity: </a:t>
            </a:r>
            <a:r>
              <a:rPr lang="en" sz="1700"/>
              <a:t>Recognize the unique cultural practices and backgrounds of AANHPI populations. </a:t>
            </a:r>
            <a:endParaRPr sz="1700"/>
          </a:p>
          <a:p>
            <a:pPr indent="-336550" lvl="0" marL="457200" rtl="0" algn="l">
              <a:spcBef>
                <a:spcPts val="0"/>
              </a:spcBef>
              <a:spcAft>
                <a:spcPts val="0"/>
              </a:spcAft>
              <a:buSzPts val="1700"/>
              <a:buChar char="●"/>
            </a:pPr>
            <a:r>
              <a:rPr b="1" lang="en" sz="1700"/>
              <a:t>Cultural Beliefs: </a:t>
            </a:r>
            <a:r>
              <a:rPr lang="en" sz="1700"/>
              <a:t>Understand how cultural beliefs influence the manifestation of psychological distress. </a:t>
            </a:r>
            <a:endParaRPr sz="1700"/>
          </a:p>
          <a:p>
            <a:pPr indent="-336550" lvl="0" marL="457200" rtl="0" algn="l">
              <a:spcBef>
                <a:spcPts val="0"/>
              </a:spcBef>
              <a:spcAft>
                <a:spcPts val="0"/>
              </a:spcAft>
              <a:buSzPts val="1700"/>
              <a:buChar char="●"/>
            </a:pPr>
            <a:r>
              <a:rPr b="1" lang="en" sz="1700"/>
              <a:t>Barriers: </a:t>
            </a:r>
            <a:r>
              <a:rPr lang="en" sz="1700"/>
              <a:t>Address stigma, language challenges, and lack of resources in mental health care. </a:t>
            </a:r>
            <a:endParaRPr sz="1700"/>
          </a:p>
          <a:p>
            <a:pPr indent="-336550" lvl="0" marL="457200" rtl="0" algn="l">
              <a:spcBef>
                <a:spcPts val="0"/>
              </a:spcBef>
              <a:spcAft>
                <a:spcPts val="0"/>
              </a:spcAft>
              <a:buSzPts val="1700"/>
              <a:buChar char="●"/>
            </a:pPr>
            <a:r>
              <a:rPr b="1" lang="en" sz="1700"/>
              <a:t>Family Dynamics: </a:t>
            </a:r>
            <a:r>
              <a:rPr lang="en" sz="1700"/>
              <a:t>Consider the impact of family and traditional practices on treatment adherence. </a:t>
            </a:r>
            <a:endParaRPr sz="1700"/>
          </a:p>
          <a:p>
            <a:pPr indent="-336550" lvl="0" marL="457200" rtl="0" algn="l">
              <a:spcBef>
                <a:spcPts val="0"/>
              </a:spcBef>
              <a:spcAft>
                <a:spcPts val="0"/>
              </a:spcAft>
              <a:buSzPts val="1700"/>
              <a:buChar char="●"/>
            </a:pPr>
            <a:r>
              <a:rPr b="1" lang="en" sz="1700"/>
              <a:t>Clinical Strategies: </a:t>
            </a:r>
            <a:r>
              <a:rPr lang="en" sz="1700"/>
              <a:t>Apply culturally informed care, as shown in the cases of Leila and Michael. These principles enhance culturally competent care for AANHPI patients.</a:t>
            </a:r>
            <a:endParaRPr sz="1700"/>
          </a:p>
          <a:p>
            <a:pPr indent="0" lvl="0" marL="457200" rtl="0" algn="l">
              <a:spcBef>
                <a:spcPts val="1200"/>
              </a:spcBef>
              <a:spcAft>
                <a:spcPts val="1200"/>
              </a:spcAft>
              <a:buNone/>
            </a:pPr>
            <a:r>
              <a:t/>
            </a:r>
            <a:endParaRPr sz="1500"/>
          </a:p>
        </p:txBody>
      </p:sp>
      <p:sp>
        <p:nvSpPr>
          <p:cNvPr id="766" name="Google Shape;766;p6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0" name="Shape 770"/>
        <p:cNvGrpSpPr/>
        <p:nvPr/>
      </p:nvGrpSpPr>
      <p:grpSpPr>
        <a:xfrm>
          <a:off x="0" y="0"/>
          <a:ext cx="0" cy="0"/>
          <a:chOff x="0" y="0"/>
          <a:chExt cx="0" cy="0"/>
        </a:xfrm>
      </p:grpSpPr>
      <p:sp>
        <p:nvSpPr>
          <p:cNvPr id="771" name="Google Shape;771;p64"/>
          <p:cNvSpPr txBox="1"/>
          <p:nvPr>
            <p:ph type="title"/>
          </p:nvPr>
        </p:nvSpPr>
        <p:spPr>
          <a:xfrm>
            <a:off x="772250" y="1866800"/>
            <a:ext cx="7704000" cy="8304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Post Workshop Evaluation Survey</a:t>
            </a:r>
            <a:endParaRPr/>
          </a:p>
          <a:p>
            <a:pPr indent="0" lvl="0" marL="0" rtl="0" algn="l">
              <a:spcBef>
                <a:spcPts val="0"/>
              </a:spcBef>
              <a:spcAft>
                <a:spcPts val="0"/>
              </a:spcAft>
              <a:buNone/>
            </a:pPr>
            <a:r>
              <a:t/>
            </a:r>
            <a:endParaRPr sz="2400"/>
          </a:p>
          <a:p>
            <a:pPr indent="0" lvl="0" marL="0" rtl="0" algn="l">
              <a:spcBef>
                <a:spcPts val="0"/>
              </a:spcBef>
              <a:spcAft>
                <a:spcPts val="0"/>
              </a:spcAft>
              <a:buNone/>
            </a:pPr>
            <a:r>
              <a:t/>
            </a:r>
            <a:endParaRPr sz="2400"/>
          </a:p>
          <a:p>
            <a:pPr indent="0" lvl="0" marL="0" rtl="0" algn="l">
              <a:spcBef>
                <a:spcPts val="0"/>
              </a:spcBef>
              <a:spcAft>
                <a:spcPts val="0"/>
              </a:spcAft>
              <a:buNone/>
            </a:pPr>
            <a:r>
              <a:t/>
            </a:r>
            <a:endParaRPr sz="2400"/>
          </a:p>
        </p:txBody>
      </p:sp>
      <p:sp>
        <p:nvSpPr>
          <p:cNvPr id="772" name="Google Shape;772;p6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4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6" name="Shape 776"/>
        <p:cNvGrpSpPr/>
        <p:nvPr/>
      </p:nvGrpSpPr>
      <p:grpSpPr>
        <a:xfrm>
          <a:off x="0" y="0"/>
          <a:ext cx="0" cy="0"/>
          <a:chOff x="0" y="0"/>
          <a:chExt cx="0" cy="0"/>
        </a:xfrm>
      </p:grpSpPr>
      <p:sp>
        <p:nvSpPr>
          <p:cNvPr id="777" name="Google Shape;777;p65"/>
          <p:cNvSpPr txBox="1"/>
          <p:nvPr>
            <p:ph idx="4294967295" type="title"/>
          </p:nvPr>
        </p:nvSpPr>
        <p:spPr>
          <a:xfrm>
            <a:off x="4275950" y="1407050"/>
            <a:ext cx="4961700" cy="6294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200"/>
              <a:t>AANHPI</a:t>
            </a:r>
            <a:r>
              <a:rPr lang="en" sz="3200"/>
              <a:t> mental health is an unmet need.</a:t>
            </a:r>
            <a:endParaRPr sz="3200"/>
          </a:p>
          <a:p>
            <a:pPr indent="0" lvl="0" marL="0" rtl="0" algn="l">
              <a:spcBef>
                <a:spcPts val="0"/>
              </a:spcBef>
              <a:spcAft>
                <a:spcPts val="0"/>
              </a:spcAft>
              <a:buNone/>
            </a:pPr>
            <a:r>
              <a:t/>
            </a:r>
            <a:endParaRPr sz="3200"/>
          </a:p>
        </p:txBody>
      </p:sp>
      <p:sp>
        <p:nvSpPr>
          <p:cNvPr id="778" name="Google Shape;778;p65"/>
          <p:cNvSpPr txBox="1"/>
          <p:nvPr>
            <p:ph idx="4294967295" type="subTitle"/>
          </p:nvPr>
        </p:nvSpPr>
        <p:spPr>
          <a:xfrm>
            <a:off x="4275950" y="2529375"/>
            <a:ext cx="4070700" cy="1676100"/>
          </a:xfrm>
          <a:prstGeom prst="rect">
            <a:avLst/>
          </a:prstGeom>
        </p:spPr>
        <p:txBody>
          <a:bodyPr anchorCtr="0" anchor="t" bIns="91425" lIns="274300" spcFirstLastPara="1" rIns="274300" wrap="square" tIns="91425">
            <a:normAutofit/>
          </a:bodyPr>
          <a:lstStyle/>
          <a:p>
            <a:pPr indent="0" lvl="0" marL="0" rtl="0" algn="l">
              <a:spcBef>
                <a:spcPts val="0"/>
              </a:spcBef>
              <a:spcAft>
                <a:spcPts val="1200"/>
              </a:spcAft>
              <a:buNone/>
            </a:pPr>
            <a:r>
              <a:rPr lang="en" sz="1800">
                <a:solidFill>
                  <a:schemeClr val="accent1"/>
                </a:solidFill>
              </a:rPr>
              <a:t>Stigma surrounding mental health remains a significant barrier to seeking help and treatment in many AANHPI cultures. </a:t>
            </a:r>
            <a:endParaRPr b="1" sz="1800">
              <a:solidFill>
                <a:schemeClr val="accent1"/>
              </a:solidFill>
            </a:endParaRPr>
          </a:p>
        </p:txBody>
      </p:sp>
      <p:sp>
        <p:nvSpPr>
          <p:cNvPr id="779" name="Google Shape;779;p6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t>‹#›</a:t>
            </a:fld>
            <a:endParaRPr/>
          </a:p>
        </p:txBody>
      </p:sp>
      <p:pic>
        <p:nvPicPr>
          <p:cNvPr descr="Mental health care treatment. Doctor stands on stairs with watering can. Group of neurologists treat patient (Provided by Getty Images)" id="780" name="Google Shape;780;p65"/>
          <p:cNvPicPr preferRelativeResize="0"/>
          <p:nvPr/>
        </p:nvPicPr>
        <p:blipFill rotWithShape="1">
          <a:blip r:embed="rId3">
            <a:alphaModFix/>
          </a:blip>
          <a:srcRect b="0" l="32912" r="16756" t="0"/>
          <a:stretch/>
        </p:blipFill>
        <p:spPr>
          <a:xfrm>
            <a:off x="987225" y="407225"/>
            <a:ext cx="3058202" cy="4058552"/>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5" name="Shape 255"/>
        <p:cNvGrpSpPr/>
        <p:nvPr/>
      </p:nvGrpSpPr>
      <p:grpSpPr>
        <a:xfrm>
          <a:off x="0" y="0"/>
          <a:ext cx="0" cy="0"/>
          <a:chOff x="0" y="0"/>
          <a:chExt cx="0" cy="0"/>
        </a:xfrm>
      </p:grpSpPr>
      <p:sp>
        <p:nvSpPr>
          <p:cNvPr id="256" name="Google Shape;256;p22"/>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b="1" lang="en"/>
              <a:t>Mental Health</a:t>
            </a:r>
            <a:endParaRPr b="1"/>
          </a:p>
        </p:txBody>
      </p:sp>
      <p:sp>
        <p:nvSpPr>
          <p:cNvPr id="257" name="Google Shape;257;p22"/>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sz="2000"/>
              <a:t>According to the WHO, </a:t>
            </a:r>
            <a:r>
              <a:rPr b="1" lang="en" sz="2000"/>
              <a:t>mental health</a:t>
            </a:r>
            <a:r>
              <a:rPr lang="en" sz="2000"/>
              <a:t> is:</a:t>
            </a:r>
            <a:endParaRPr sz="2000"/>
          </a:p>
          <a:p>
            <a:pPr indent="-355600" lvl="0" marL="457200" rtl="0" algn="l">
              <a:spcBef>
                <a:spcPts val="1200"/>
              </a:spcBef>
              <a:spcAft>
                <a:spcPts val="0"/>
              </a:spcAft>
              <a:buSzPts val="2000"/>
              <a:buChar char="-"/>
            </a:pPr>
            <a:r>
              <a:rPr lang="en" sz="2000"/>
              <a:t>A state of mental wellbeing that enables people to </a:t>
            </a:r>
            <a:r>
              <a:rPr lang="en" sz="2000"/>
              <a:t>cope with the stresses of life, realize their abilities, learn well and work well, and contribute to their community</a:t>
            </a:r>
            <a:br>
              <a:rPr lang="en" sz="2000"/>
            </a:br>
            <a:endParaRPr sz="2000"/>
          </a:p>
          <a:p>
            <a:pPr indent="-355600" lvl="0" marL="457200" rtl="0" algn="l">
              <a:spcBef>
                <a:spcPts val="0"/>
              </a:spcBef>
              <a:spcAft>
                <a:spcPts val="0"/>
              </a:spcAft>
              <a:buSzPts val="2000"/>
              <a:buChar char="-"/>
            </a:pPr>
            <a:r>
              <a:rPr lang="en" sz="2000"/>
              <a:t>More than the absence of mental disorders</a:t>
            </a:r>
            <a:br>
              <a:rPr lang="en" sz="2000"/>
            </a:br>
            <a:endParaRPr sz="2000"/>
          </a:p>
          <a:p>
            <a:pPr indent="-355600" lvl="0" marL="457200" rtl="0" algn="l">
              <a:spcBef>
                <a:spcPts val="0"/>
              </a:spcBef>
              <a:spcAft>
                <a:spcPts val="0"/>
              </a:spcAft>
              <a:buSzPts val="2000"/>
              <a:buChar char="-"/>
            </a:pPr>
            <a:r>
              <a:rPr b="1" lang="en" sz="2000"/>
              <a:t>A </a:t>
            </a:r>
            <a:r>
              <a:rPr b="1" lang="en" sz="2000"/>
              <a:t>basic human right</a:t>
            </a:r>
            <a:endParaRPr sz="2000"/>
          </a:p>
        </p:txBody>
      </p:sp>
      <p:sp>
        <p:nvSpPr>
          <p:cNvPr id="258" name="Google Shape;258;p2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2" name="Shape 262"/>
        <p:cNvGrpSpPr/>
        <p:nvPr/>
      </p:nvGrpSpPr>
      <p:grpSpPr>
        <a:xfrm>
          <a:off x="0" y="0"/>
          <a:ext cx="0" cy="0"/>
          <a:chOff x="0" y="0"/>
          <a:chExt cx="0" cy="0"/>
        </a:xfrm>
      </p:grpSpPr>
      <p:sp>
        <p:nvSpPr>
          <p:cNvPr id="263" name="Google Shape;263;p23"/>
          <p:cNvSpPr txBox="1"/>
          <p:nvPr>
            <p:ph type="title"/>
          </p:nvPr>
        </p:nvSpPr>
        <p:spPr>
          <a:xfrm>
            <a:off x="975450" y="1027275"/>
            <a:ext cx="7193100" cy="2529300"/>
          </a:xfrm>
          <a:prstGeom prst="rect">
            <a:avLst/>
          </a:prstGeom>
        </p:spPr>
        <p:txBody>
          <a:bodyPr anchorCtr="0" anchor="ctr" bIns="91425" lIns="91425" spcFirstLastPara="1" rIns="91425" wrap="square" tIns="91425">
            <a:normAutofit fontScale="90000"/>
          </a:bodyPr>
          <a:lstStyle/>
          <a:p>
            <a:pPr indent="0" lvl="0" marL="0" rtl="0" algn="l">
              <a:lnSpc>
                <a:spcPct val="100000"/>
              </a:lnSpc>
              <a:spcBef>
                <a:spcPts val="0"/>
              </a:spcBef>
              <a:spcAft>
                <a:spcPts val="1600"/>
              </a:spcAft>
              <a:buNone/>
            </a:pPr>
            <a:r>
              <a:rPr b="0" lang="en" sz="3000">
                <a:solidFill>
                  <a:srgbClr val="434343"/>
                </a:solidFill>
                <a:latin typeface="Hind"/>
                <a:ea typeface="Hind"/>
                <a:cs typeface="Hind"/>
                <a:sym typeface="Hind"/>
              </a:rPr>
              <a:t>“Medical schools, like many institutions, are need to evolve in their efforts to recognize and address the nuanced needs of AANHPI patients, even as the number of AANHPI medical students continues to grow.”</a:t>
            </a:r>
            <a:endParaRPr sz="9000"/>
          </a:p>
        </p:txBody>
      </p:sp>
      <p:sp>
        <p:nvSpPr>
          <p:cNvPr id="264" name="Google Shape;264;p2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265" name="Google Shape;265;p23"/>
          <p:cNvSpPr txBox="1"/>
          <p:nvPr/>
        </p:nvSpPr>
        <p:spPr>
          <a:xfrm>
            <a:off x="0" y="4835700"/>
            <a:ext cx="1317000" cy="3078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latin typeface="Hind"/>
                <a:ea typeface="Hind"/>
                <a:cs typeface="Hind"/>
                <a:sym typeface="Hind"/>
              </a:rPr>
              <a:t>Kim et al. </a:t>
            </a:r>
            <a:r>
              <a:rPr i="1" lang="en" sz="800">
                <a:solidFill>
                  <a:schemeClr val="dk1"/>
                </a:solidFill>
                <a:latin typeface="Hind"/>
                <a:ea typeface="Hind"/>
                <a:cs typeface="Hind"/>
                <a:sym typeface="Hind"/>
              </a:rPr>
              <a:t>Acad Med.</a:t>
            </a:r>
            <a:r>
              <a:rPr lang="en" sz="800">
                <a:solidFill>
                  <a:schemeClr val="dk1"/>
                </a:solidFill>
                <a:latin typeface="Hind"/>
                <a:ea typeface="Hind"/>
                <a:cs typeface="Hind"/>
                <a:sym typeface="Hind"/>
              </a:rPr>
              <a:t> 2022.</a:t>
            </a:r>
            <a:endParaRPr sz="800">
              <a:solidFill>
                <a:schemeClr val="dk1"/>
              </a:solidFill>
              <a:latin typeface="Hind"/>
              <a:ea typeface="Hind"/>
              <a:cs typeface="Hind"/>
              <a:sym typeface="Hind"/>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9" name="Shape 269"/>
        <p:cNvGrpSpPr/>
        <p:nvPr/>
      </p:nvGrpSpPr>
      <p:grpSpPr>
        <a:xfrm>
          <a:off x="0" y="0"/>
          <a:ext cx="0" cy="0"/>
          <a:chOff x="0" y="0"/>
          <a:chExt cx="0" cy="0"/>
        </a:xfrm>
      </p:grpSpPr>
      <p:sp>
        <p:nvSpPr>
          <p:cNvPr id="270" name="Google Shape;270;p24"/>
          <p:cNvSpPr txBox="1"/>
          <p:nvPr>
            <p:ph type="title"/>
          </p:nvPr>
        </p:nvSpPr>
        <p:spPr>
          <a:xfrm>
            <a:off x="117975" y="180475"/>
            <a:ext cx="8835900" cy="11673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sz="3000"/>
              <a:t>Shortcomings in </a:t>
            </a:r>
            <a:r>
              <a:rPr lang="en" sz="3000"/>
              <a:t>medical</a:t>
            </a:r>
            <a:r>
              <a:rPr lang="en" sz="3000"/>
              <a:t> education with AANHPI populations</a:t>
            </a:r>
            <a:endParaRPr sz="3000"/>
          </a:p>
          <a:p>
            <a:pPr indent="0" lvl="0" marL="0" rtl="0" algn="l">
              <a:spcBef>
                <a:spcPts val="0"/>
              </a:spcBef>
              <a:spcAft>
                <a:spcPts val="0"/>
              </a:spcAft>
              <a:buNone/>
            </a:pPr>
            <a:r>
              <a:t/>
            </a:r>
            <a:endParaRPr sz="3000"/>
          </a:p>
        </p:txBody>
      </p:sp>
      <p:sp>
        <p:nvSpPr>
          <p:cNvPr id="271" name="Google Shape;271;p24"/>
          <p:cNvSpPr txBox="1"/>
          <p:nvPr>
            <p:ph idx="1" type="body"/>
          </p:nvPr>
        </p:nvSpPr>
        <p:spPr>
          <a:xfrm>
            <a:off x="52400" y="1236180"/>
            <a:ext cx="9144000" cy="1217700"/>
          </a:xfrm>
          <a:prstGeom prst="rect">
            <a:avLst/>
          </a:prstGeom>
        </p:spPr>
        <p:txBody>
          <a:bodyPr anchorCtr="0" anchor="t" bIns="91425" lIns="91425" spcFirstLastPara="1" rIns="91425" wrap="square" tIns="91425">
            <a:normAutofit lnSpcReduction="20000"/>
          </a:bodyPr>
          <a:lstStyle/>
          <a:p>
            <a:pPr indent="-317500" lvl="0" marL="457200" rtl="0" algn="l">
              <a:spcBef>
                <a:spcPts val="0"/>
              </a:spcBef>
              <a:spcAft>
                <a:spcPts val="0"/>
              </a:spcAft>
              <a:buSzPts val="1400"/>
              <a:buAutoNum type="arabicPeriod"/>
            </a:pPr>
            <a:r>
              <a:rPr lang="en" sz="1400"/>
              <a:t>AANHPI populations are</a:t>
            </a:r>
            <a:r>
              <a:rPr b="1" lang="en" sz="1400"/>
              <a:t> incredibly unrecognized</a:t>
            </a:r>
            <a:r>
              <a:rPr lang="en" sz="1400"/>
              <a:t> in medical education, with only </a:t>
            </a:r>
            <a:r>
              <a:rPr b="1" lang="en" sz="1400"/>
              <a:t>0.01% of studies found on MEDLINE</a:t>
            </a:r>
            <a:r>
              <a:rPr lang="en" sz="1400"/>
              <a:t> even mentioning it as a studied subgroup</a:t>
            </a:r>
            <a:endParaRPr sz="1400"/>
          </a:p>
          <a:p>
            <a:pPr indent="-317500" lvl="0" marL="457200" rtl="0" algn="l">
              <a:spcBef>
                <a:spcPts val="0"/>
              </a:spcBef>
              <a:spcAft>
                <a:spcPts val="0"/>
              </a:spcAft>
              <a:buSzPts val="1400"/>
              <a:buAutoNum type="arabicPeriod"/>
            </a:pPr>
            <a:r>
              <a:rPr lang="en" sz="1400"/>
              <a:t>T</a:t>
            </a:r>
            <a:r>
              <a:rPr lang="en" sz="1400"/>
              <a:t>here are currently </a:t>
            </a:r>
            <a:r>
              <a:rPr b="1" lang="en" sz="1400"/>
              <a:t>no publications in MEDLINE</a:t>
            </a:r>
            <a:r>
              <a:rPr lang="en" sz="1400"/>
              <a:t> that focus on </a:t>
            </a:r>
            <a:r>
              <a:rPr b="1" lang="en" sz="1400"/>
              <a:t>destigmatizing mental health in AANHPI communities</a:t>
            </a:r>
            <a:r>
              <a:rPr lang="en" sz="1400"/>
              <a:t> and in the general population to our knowledge.</a:t>
            </a:r>
            <a:endParaRPr sz="1400"/>
          </a:p>
          <a:p>
            <a:pPr indent="0" lvl="0" marL="0" rtl="0" algn="l">
              <a:spcBef>
                <a:spcPts val="0"/>
              </a:spcBef>
              <a:spcAft>
                <a:spcPts val="1200"/>
              </a:spcAft>
              <a:buNone/>
            </a:pPr>
            <a:r>
              <a:t/>
            </a:r>
            <a:endParaRPr sz="1400"/>
          </a:p>
        </p:txBody>
      </p:sp>
      <p:sp>
        <p:nvSpPr>
          <p:cNvPr id="272" name="Google Shape;272;p2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graphicFrame>
        <p:nvGraphicFramePr>
          <p:cNvPr id="273" name="Google Shape;273;p24"/>
          <p:cNvGraphicFramePr/>
          <p:nvPr/>
        </p:nvGraphicFramePr>
        <p:xfrm>
          <a:off x="52388" y="2430850"/>
          <a:ext cx="3000000" cy="3000000"/>
        </p:xfrm>
        <a:graphic>
          <a:graphicData uri="http://schemas.openxmlformats.org/drawingml/2006/table">
            <a:tbl>
              <a:tblPr>
                <a:noFill/>
                <a:tableStyleId>{F59E6EC8-69AF-4ADF-80BC-D3E07FA3DD24}</a:tableStyleId>
              </a:tblPr>
              <a:tblGrid>
                <a:gridCol w="2828925"/>
                <a:gridCol w="1047750"/>
                <a:gridCol w="2619375"/>
                <a:gridCol w="2543175"/>
              </a:tblGrid>
              <a:tr h="200025">
                <a:tc>
                  <a:txBody>
                    <a:bodyPr/>
                    <a:lstStyle/>
                    <a:p>
                      <a:pPr indent="0" lvl="0" marL="0" rtl="0" algn="ctr">
                        <a:lnSpc>
                          <a:spcPct val="115000"/>
                        </a:lnSpc>
                        <a:spcBef>
                          <a:spcPts val="0"/>
                        </a:spcBef>
                        <a:spcAft>
                          <a:spcPts val="0"/>
                        </a:spcAft>
                        <a:buNone/>
                      </a:pPr>
                      <a:r>
                        <a:rPr b="1" lang="en" sz="1100">
                          <a:latin typeface="Hind"/>
                          <a:ea typeface="Hind"/>
                          <a:cs typeface="Hind"/>
                          <a:sym typeface="Hind"/>
                        </a:rPr>
                        <a:t>Source</a:t>
                      </a:r>
                      <a:endParaRPr b="1"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ctr">
                        <a:lnSpc>
                          <a:spcPct val="115000"/>
                        </a:lnSpc>
                        <a:spcBef>
                          <a:spcPts val="0"/>
                        </a:spcBef>
                        <a:spcAft>
                          <a:spcPts val="0"/>
                        </a:spcAft>
                        <a:buNone/>
                      </a:pPr>
                      <a:r>
                        <a:rPr b="1" lang="en" sz="1100">
                          <a:latin typeface="Hind"/>
                          <a:ea typeface="Hind"/>
                          <a:cs typeface="Hind"/>
                          <a:sym typeface="Hind"/>
                        </a:rPr>
                        <a:t>Type</a:t>
                      </a:r>
                      <a:endParaRPr b="1"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ctr">
                        <a:lnSpc>
                          <a:spcPct val="115000"/>
                        </a:lnSpc>
                        <a:spcBef>
                          <a:spcPts val="0"/>
                        </a:spcBef>
                        <a:spcAft>
                          <a:spcPts val="0"/>
                        </a:spcAft>
                        <a:buNone/>
                      </a:pPr>
                      <a:r>
                        <a:rPr b="1" lang="en" sz="1100">
                          <a:latin typeface="Hind"/>
                          <a:ea typeface="Hind"/>
                          <a:cs typeface="Hind"/>
                          <a:sym typeface="Hind"/>
                        </a:rPr>
                        <a:t>Key Contributions</a:t>
                      </a:r>
                      <a:endParaRPr b="1"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ctr">
                        <a:lnSpc>
                          <a:spcPct val="115000"/>
                        </a:lnSpc>
                        <a:spcBef>
                          <a:spcPts val="0"/>
                        </a:spcBef>
                        <a:spcAft>
                          <a:spcPts val="0"/>
                        </a:spcAft>
                        <a:buNone/>
                      </a:pPr>
                      <a:r>
                        <a:rPr b="1" lang="en" sz="1100">
                          <a:latin typeface="Hind"/>
                          <a:ea typeface="Hind"/>
                          <a:cs typeface="Hind"/>
                          <a:sym typeface="Hind"/>
                        </a:rPr>
                        <a:t>Why It Matters</a:t>
                      </a:r>
                      <a:endParaRPr b="1"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r>
              <a:tr h="552450">
                <a:tc>
                  <a:txBody>
                    <a:bodyPr/>
                    <a:lstStyle/>
                    <a:p>
                      <a:pPr indent="0" lvl="0" marL="0" rtl="0" algn="l">
                        <a:spcBef>
                          <a:spcPts val="0"/>
                        </a:spcBef>
                        <a:spcAft>
                          <a:spcPts val="0"/>
                        </a:spcAft>
                        <a:buNone/>
                      </a:pPr>
                      <a:r>
                        <a:rPr b="1" lang="en" sz="1100">
                          <a:latin typeface="Hind"/>
                          <a:ea typeface="Hind"/>
                          <a:cs typeface="Hind"/>
                          <a:sym typeface="Hind"/>
                        </a:rPr>
                        <a:t>AAPI Data &amp; UCLA CHPR (2024)</a:t>
                      </a:r>
                      <a:r>
                        <a:rPr lang="en" sz="1100">
                          <a:latin typeface="Hind"/>
                          <a:ea typeface="Hind"/>
                          <a:cs typeface="Hind"/>
                          <a:sym typeface="Hind"/>
                        </a:rPr>
                        <a:t> </a:t>
                      </a:r>
                      <a:endParaRPr sz="1100">
                        <a:latin typeface="Hind"/>
                        <a:ea typeface="Hind"/>
                        <a:cs typeface="Hind"/>
                        <a:sym typeface="Hind"/>
                      </a:endParaRPr>
                    </a:p>
                    <a:p>
                      <a:pPr indent="0" lvl="0" marL="0" rtl="0" algn="l">
                        <a:spcBef>
                          <a:spcPts val="0"/>
                        </a:spcBef>
                        <a:spcAft>
                          <a:spcPts val="0"/>
                        </a:spcAft>
                        <a:buNone/>
                      </a:pPr>
                      <a:r>
                        <a:rPr lang="en" sz="1100">
                          <a:latin typeface="Hind"/>
                          <a:ea typeface="Hind"/>
                          <a:cs typeface="Hind"/>
                          <a:sym typeface="Hind"/>
                        </a:rPr>
                        <a:t>Piecing the Puzzle of AANHPI Mental Health</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Community-based report</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Disaggregated data across ethnic subgroups; highlights stigma, access barriers, and policy gaps</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Moves beyond aggregated statistics to reveal subgroup-specific disparities and lived experiences</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r>
              <a:tr h="723900">
                <a:tc>
                  <a:txBody>
                    <a:bodyPr/>
                    <a:lstStyle/>
                    <a:p>
                      <a:pPr indent="0" lvl="0" marL="0" rtl="0" algn="l">
                        <a:spcBef>
                          <a:spcPts val="0"/>
                        </a:spcBef>
                        <a:spcAft>
                          <a:spcPts val="0"/>
                        </a:spcAft>
                        <a:buNone/>
                      </a:pPr>
                      <a:r>
                        <a:rPr b="1" lang="en" sz="1100">
                          <a:latin typeface="Hind"/>
                          <a:ea typeface="Hind"/>
                          <a:cs typeface="Hind"/>
                          <a:sym typeface="Hind"/>
                        </a:rPr>
                        <a:t>Psychological Services Special Issue (2023)</a:t>
                      </a:r>
                      <a:endParaRPr sz="1100">
                        <a:latin typeface="Hind"/>
                        <a:ea typeface="Hind"/>
                        <a:cs typeface="Hind"/>
                        <a:sym typeface="Hind"/>
                      </a:endParaRPr>
                    </a:p>
                    <a:p>
                      <a:pPr indent="0" lvl="0" marL="0" rtl="0" algn="l">
                        <a:spcBef>
                          <a:spcPts val="0"/>
                        </a:spcBef>
                        <a:spcAft>
                          <a:spcPts val="0"/>
                        </a:spcAft>
                        <a:buNone/>
                      </a:pPr>
                      <a:r>
                        <a:rPr lang="en" sz="1100">
                          <a:latin typeface="Hind"/>
                          <a:ea typeface="Hind"/>
                          <a:cs typeface="Hind"/>
                          <a:sym typeface="Hind"/>
                        </a:rPr>
                        <a:t>Improving Access and Quality of Mental Health Care</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Peer-reviewed journal</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Culturally tailored interventions; systemic reform strategies for diverse populations</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Offers practice-based evidence and clinician training models relevant to AANHPI care</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r>
              <a:tr h="100000">
                <a:tc>
                  <a:txBody>
                    <a:bodyPr/>
                    <a:lstStyle/>
                    <a:p>
                      <a:pPr indent="0" lvl="0" marL="0" rtl="0" algn="l">
                        <a:spcBef>
                          <a:spcPts val="0"/>
                        </a:spcBef>
                        <a:spcAft>
                          <a:spcPts val="0"/>
                        </a:spcAft>
                        <a:buNone/>
                      </a:pPr>
                      <a:r>
                        <a:rPr b="1" lang="en" sz="1100">
                          <a:latin typeface="Hind"/>
                          <a:ea typeface="Hind"/>
                          <a:cs typeface="Hind"/>
                          <a:sym typeface="Hind"/>
                        </a:rPr>
                        <a:t>Asian American Psychological Association (AAPA)</a:t>
                      </a:r>
                      <a:endParaRPr sz="1100">
                        <a:latin typeface="Hind"/>
                        <a:ea typeface="Hind"/>
                        <a:cs typeface="Hind"/>
                        <a:sym typeface="Hind"/>
                      </a:endParaRPr>
                    </a:p>
                    <a:p>
                      <a:pPr indent="0" lvl="0" marL="0" rtl="0" algn="l">
                        <a:spcBef>
                          <a:spcPts val="0"/>
                        </a:spcBef>
                        <a:spcAft>
                          <a:spcPts val="0"/>
                        </a:spcAft>
                        <a:buNone/>
                      </a:pPr>
                      <a:r>
                        <a:rPr lang="en" sz="1100">
                          <a:latin typeface="Hind"/>
                          <a:ea typeface="Hind"/>
                          <a:cs typeface="Hind"/>
                          <a:sym typeface="Hind"/>
                        </a:rPr>
                        <a:t>AAPA Publications</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Professional organization</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Research on identity, acculturation, and culturally responsive practice</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c>
                  <a:txBody>
                    <a:bodyPr/>
                    <a:lstStyle/>
                    <a:p>
                      <a:pPr indent="0" lvl="0" marL="0" rtl="0" algn="l">
                        <a:spcBef>
                          <a:spcPts val="0"/>
                        </a:spcBef>
                        <a:spcAft>
                          <a:spcPts val="0"/>
                        </a:spcAft>
                        <a:buNone/>
                      </a:pPr>
                      <a:r>
                        <a:rPr lang="en" sz="1100">
                          <a:latin typeface="Hind"/>
                          <a:ea typeface="Hind"/>
                          <a:cs typeface="Hind"/>
                          <a:sym typeface="Hind"/>
                        </a:rPr>
                        <a:t>Provides clinician-facing resources and frameworks rooted in AANHPI psychology</a:t>
                      </a:r>
                      <a:endParaRPr sz="1100">
                        <a:latin typeface="Hind"/>
                        <a:ea typeface="Hind"/>
                        <a:cs typeface="Hind"/>
                        <a:sym typeface="Hind"/>
                      </a:endParaRPr>
                    </a:p>
                  </a:txBody>
                  <a:tcPr marT="91425" marB="91425" marR="91425" marL="91425">
                    <a:lnL cap="flat" cmpd="sng" w="9525">
                      <a:solidFill>
                        <a:srgbClr val="000000"/>
                      </a:solidFill>
                      <a:prstDash val="dash"/>
                      <a:round/>
                      <a:headEnd len="sm" w="sm" type="none"/>
                      <a:tailEnd len="sm" w="sm" type="none"/>
                    </a:lnL>
                    <a:lnR cap="flat" cmpd="sng" w="9525">
                      <a:solidFill>
                        <a:srgbClr val="000000"/>
                      </a:solidFill>
                      <a:prstDash val="dash"/>
                      <a:round/>
                      <a:headEnd len="sm" w="sm" type="none"/>
                      <a:tailEnd len="sm" w="sm" type="none"/>
                    </a:lnR>
                    <a:lnT cap="flat" cmpd="sng" w="9525">
                      <a:solidFill>
                        <a:srgbClr val="000000"/>
                      </a:solidFill>
                      <a:prstDash val="dash"/>
                      <a:round/>
                      <a:headEnd len="sm" w="sm" type="none"/>
                      <a:tailEnd len="sm" w="sm" type="none"/>
                    </a:lnT>
                    <a:lnB cap="flat" cmpd="sng" w="9525">
                      <a:solidFill>
                        <a:srgbClr val="000000"/>
                      </a:solidFill>
                      <a:prstDash val="dash"/>
                      <a:round/>
                      <a:headEnd len="sm" w="sm" type="none"/>
                      <a:tailEnd len="sm" w="sm" type="none"/>
                    </a:lnB>
                    <a:solidFill>
                      <a:schemeClr val="lt2"/>
                    </a:solidFill>
                  </a:tcPr>
                </a:tc>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7" name="Shape 277"/>
        <p:cNvGrpSpPr/>
        <p:nvPr/>
      </p:nvGrpSpPr>
      <p:grpSpPr>
        <a:xfrm>
          <a:off x="0" y="0"/>
          <a:ext cx="0" cy="0"/>
          <a:chOff x="0" y="0"/>
          <a:chExt cx="0" cy="0"/>
        </a:xfrm>
      </p:grpSpPr>
      <p:sp>
        <p:nvSpPr>
          <p:cNvPr id="278" name="Google Shape;278;p25"/>
          <p:cNvSpPr txBox="1"/>
          <p:nvPr>
            <p:ph type="title"/>
          </p:nvPr>
        </p:nvSpPr>
        <p:spPr>
          <a:xfrm>
            <a:off x="1526545" y="2285400"/>
            <a:ext cx="60909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Part 1: AANHPI Mental Health Burdens</a:t>
            </a:r>
            <a:endParaRPr/>
          </a:p>
        </p:txBody>
      </p:sp>
      <p:sp>
        <p:nvSpPr>
          <p:cNvPr id="279" name="Google Shape;279;p2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3" name="Shape 283"/>
        <p:cNvGrpSpPr/>
        <p:nvPr/>
      </p:nvGrpSpPr>
      <p:grpSpPr>
        <a:xfrm>
          <a:off x="0" y="0"/>
          <a:ext cx="0" cy="0"/>
          <a:chOff x="0" y="0"/>
          <a:chExt cx="0" cy="0"/>
        </a:xfrm>
      </p:grpSpPr>
      <p:sp>
        <p:nvSpPr>
          <p:cNvPr id="284" name="Google Shape;284;p26"/>
          <p:cNvSpPr txBox="1"/>
          <p:nvPr>
            <p:ph type="title"/>
          </p:nvPr>
        </p:nvSpPr>
        <p:spPr>
          <a:xfrm>
            <a:off x="311700" y="445025"/>
            <a:ext cx="8520600" cy="572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Question</a:t>
            </a:r>
            <a:endParaRPr/>
          </a:p>
        </p:txBody>
      </p:sp>
      <p:sp>
        <p:nvSpPr>
          <p:cNvPr id="285" name="Google Shape;285;p26"/>
          <p:cNvSpPr txBox="1"/>
          <p:nvPr>
            <p:ph idx="1" type="body"/>
          </p:nvPr>
        </p:nvSpPr>
        <p:spPr>
          <a:xfrm>
            <a:off x="1351050" y="1255050"/>
            <a:ext cx="6441900" cy="2328600"/>
          </a:xfrm>
          <a:prstGeom prst="rect">
            <a:avLst/>
          </a:prstGeom>
        </p:spPr>
        <p:txBody>
          <a:bodyPr anchorCtr="0" anchor="t" bIns="91425" lIns="91425" spcFirstLastPara="1" rIns="91425" wrap="square" tIns="91425">
            <a:normAutofit lnSpcReduction="20000"/>
          </a:bodyPr>
          <a:lstStyle/>
          <a:p>
            <a:pPr indent="0" lvl="0" marL="0" rtl="0" algn="l">
              <a:spcBef>
                <a:spcPts val="0"/>
              </a:spcBef>
              <a:spcAft>
                <a:spcPts val="0"/>
              </a:spcAft>
              <a:buNone/>
            </a:pPr>
            <a:r>
              <a:rPr lang="en" sz="2000">
                <a:solidFill>
                  <a:srgbClr val="000000"/>
                </a:solidFill>
              </a:rPr>
              <a:t>AANHPI individuals are ________</a:t>
            </a:r>
            <a:r>
              <a:rPr b="1" lang="en" sz="2000">
                <a:solidFill>
                  <a:srgbClr val="000000"/>
                </a:solidFill>
              </a:rPr>
              <a:t> </a:t>
            </a:r>
            <a:r>
              <a:rPr lang="en" sz="2000">
                <a:solidFill>
                  <a:srgbClr val="000000"/>
                </a:solidFill>
              </a:rPr>
              <a:t>to seek out mental</a:t>
            </a:r>
            <a:r>
              <a:rPr lang="en" sz="2000">
                <a:solidFill>
                  <a:srgbClr val="000000"/>
                </a:solidFill>
              </a:rPr>
              <a:t> </a:t>
            </a:r>
            <a:r>
              <a:rPr lang="en" sz="2000">
                <a:solidFill>
                  <a:srgbClr val="000000"/>
                </a:solidFill>
              </a:rPr>
              <a:t>health services compared to their White peers.</a:t>
            </a:r>
            <a:endParaRPr sz="2000">
              <a:solidFill>
                <a:srgbClr val="000000"/>
              </a:solidFill>
            </a:endParaRPr>
          </a:p>
          <a:p>
            <a:pPr indent="0" lvl="0" marL="0" rtl="0" algn="l">
              <a:spcBef>
                <a:spcPts val="0"/>
              </a:spcBef>
              <a:spcAft>
                <a:spcPts val="0"/>
              </a:spcAft>
              <a:buNone/>
            </a:pPr>
            <a:r>
              <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2x more likely</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2x less likely</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5x less likely</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7x more likely</a:t>
            </a:r>
            <a:endParaRPr sz="2000">
              <a:solidFill>
                <a:srgbClr val="000000"/>
              </a:solidFill>
            </a:endParaRPr>
          </a:p>
        </p:txBody>
      </p:sp>
      <p:sp>
        <p:nvSpPr>
          <p:cNvPr id="286" name="Google Shape;286;p2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p>
            <a:pPr indent="0" lvl="0" marL="0" rtl="0" algn="r">
              <a:spcBef>
                <a:spcPts val="0"/>
              </a:spcBef>
              <a:spcAft>
                <a:spcPts val="0"/>
              </a:spcAft>
              <a:buNone/>
            </a:pPr>
            <a:fld id="{00000000-1234-1234-1234-123412341234}" type="slidenum">
              <a:rPr lang="en">
                <a:latin typeface="Arial"/>
                <a:ea typeface="Arial"/>
                <a:cs typeface="Arial"/>
                <a:sym typeface="Arial"/>
              </a:rPr>
              <a:t>‹#›</a:t>
            </a:fld>
            <a:endParaRPr>
              <a:latin typeface="Arial"/>
              <a:ea typeface="Arial"/>
              <a:cs typeface="Arial"/>
              <a:sym typeface="Arial"/>
            </a:endParaRPr>
          </a:p>
        </p:txBody>
      </p:sp>
      <p:sp>
        <p:nvSpPr>
          <p:cNvPr id="287" name="Google Shape;287;p26"/>
          <p:cNvSpPr txBox="1"/>
          <p:nvPr>
            <p:ph idx="1" type="body"/>
          </p:nvPr>
        </p:nvSpPr>
        <p:spPr>
          <a:xfrm>
            <a:off x="1351050" y="1255050"/>
            <a:ext cx="6441900" cy="2328600"/>
          </a:xfrm>
          <a:prstGeom prst="rect">
            <a:avLst/>
          </a:prstGeom>
        </p:spPr>
        <p:txBody>
          <a:bodyPr anchorCtr="0" anchor="t" bIns="91425" lIns="91425" spcFirstLastPara="1" rIns="91425" wrap="square" tIns="91425">
            <a:normAutofit lnSpcReduction="20000"/>
          </a:bodyPr>
          <a:lstStyle/>
          <a:p>
            <a:pPr indent="0" lvl="0" marL="0" rtl="0" algn="l">
              <a:spcBef>
                <a:spcPts val="0"/>
              </a:spcBef>
              <a:spcAft>
                <a:spcPts val="0"/>
              </a:spcAft>
              <a:buNone/>
            </a:pPr>
            <a:r>
              <a:rPr lang="en" sz="2000">
                <a:solidFill>
                  <a:srgbClr val="000000"/>
                </a:solidFill>
              </a:rPr>
              <a:t>AANHPI individuals are ________</a:t>
            </a:r>
            <a:r>
              <a:rPr b="1" lang="en" sz="2000">
                <a:solidFill>
                  <a:srgbClr val="000000"/>
                </a:solidFill>
              </a:rPr>
              <a:t> </a:t>
            </a:r>
            <a:r>
              <a:rPr lang="en" sz="2000">
                <a:solidFill>
                  <a:srgbClr val="000000"/>
                </a:solidFill>
              </a:rPr>
              <a:t>to seek out mental health services compared to their White peers.</a:t>
            </a:r>
            <a:endParaRPr sz="2000">
              <a:solidFill>
                <a:srgbClr val="000000"/>
              </a:solidFill>
            </a:endParaRPr>
          </a:p>
          <a:p>
            <a:pPr indent="0" lvl="0" marL="0" rtl="0" algn="l">
              <a:spcBef>
                <a:spcPts val="0"/>
              </a:spcBef>
              <a:spcAft>
                <a:spcPts val="0"/>
              </a:spcAft>
              <a:buNone/>
            </a:pPr>
            <a:r>
              <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2x more likely</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2x less likely</a:t>
            </a:r>
            <a:endParaRPr sz="2000">
              <a:solidFill>
                <a:srgbClr val="000000"/>
              </a:solidFill>
            </a:endParaRPr>
          </a:p>
          <a:p>
            <a:pPr indent="-355600" lvl="0" marL="914400" rtl="0" algn="l">
              <a:spcBef>
                <a:spcPts val="0"/>
              </a:spcBef>
              <a:spcAft>
                <a:spcPts val="0"/>
              </a:spcAft>
              <a:buClr>
                <a:srgbClr val="000000"/>
              </a:buClr>
              <a:buSzPts val="2000"/>
              <a:buAutoNum type="alphaLcPeriod"/>
            </a:pPr>
            <a:r>
              <a:rPr lang="en" sz="2000" u="sng">
                <a:solidFill>
                  <a:srgbClr val="000000"/>
                </a:solidFill>
              </a:rPr>
              <a:t>5x less likely</a:t>
            </a:r>
            <a:endParaRPr sz="2000" u="sng">
              <a:solidFill>
                <a:srgbClr val="000000"/>
              </a:solidFill>
            </a:endParaRPr>
          </a:p>
          <a:p>
            <a:pPr indent="-355600" lvl="0" marL="914400" rtl="0" algn="l">
              <a:spcBef>
                <a:spcPts val="0"/>
              </a:spcBef>
              <a:spcAft>
                <a:spcPts val="0"/>
              </a:spcAft>
              <a:buClr>
                <a:srgbClr val="000000"/>
              </a:buClr>
              <a:buSzPts val="2000"/>
              <a:buAutoNum type="alphaLcPeriod"/>
            </a:pPr>
            <a:r>
              <a:rPr lang="en" sz="2000">
                <a:solidFill>
                  <a:srgbClr val="000000"/>
                </a:solidFill>
              </a:rPr>
              <a:t>7x more likely</a:t>
            </a:r>
            <a:endParaRPr sz="2000">
              <a:solidFill>
                <a:srgbClr val="000000"/>
              </a:solidFill>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287"/>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